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ppt/drawings/drawing3.xml" ContentType="application/vnd.openxmlformats-officedocument.drawingml.chartshapes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6858000" cy="9144000" type="screen4x3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76"/>
  </p:normalViewPr>
  <p:slideViewPr>
    <p:cSldViewPr>
      <p:cViewPr varScale="1">
        <p:scale>
          <a:sx n="76" d="100"/>
          <a:sy n="76" d="100"/>
        </p:scale>
        <p:origin x="4518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package" Target="../embeddings/Microsoft_Excel_Worksheet3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marker>
            <c:symbol val="none"/>
          </c:marker>
          <c:xVal>
            <c:numRef>
              <c:f>Curves!$A$4:$A$1445</c:f>
              <c:numCache>
                <c:formatCode>###0.00</c:formatCode>
                <c:ptCount val="1442"/>
                <c:pt idx="0">
                  <c:v>0</c:v>
                </c:pt>
                <c:pt idx="1">
                  <c:v>1.6565268438467284E-2</c:v>
                </c:pt>
                <c:pt idx="2">
                  <c:v>3.3130536876934569E-2</c:v>
                </c:pt>
                <c:pt idx="3">
                  <c:v>4.9695805315401853E-2</c:v>
                </c:pt>
                <c:pt idx="4">
                  <c:v>6.6261073753869137E-2</c:v>
                </c:pt>
                <c:pt idx="5">
                  <c:v>8.2826342192336422E-2</c:v>
                </c:pt>
                <c:pt idx="6">
                  <c:v>9.9391610630803706E-2</c:v>
                </c:pt>
                <c:pt idx="7">
                  <c:v>0.11595687906927099</c:v>
                </c:pt>
                <c:pt idx="8">
                  <c:v>0.13252214750773827</c:v>
                </c:pt>
                <c:pt idx="9">
                  <c:v>0.14908741594620556</c:v>
                </c:pt>
                <c:pt idx="10">
                  <c:v>0.16565268438467284</c:v>
                </c:pt>
                <c:pt idx="11">
                  <c:v>0.18221795282314013</c:v>
                </c:pt>
                <c:pt idx="12">
                  <c:v>0.19878322126160741</c:v>
                </c:pt>
                <c:pt idx="13">
                  <c:v>0.2153484897000747</c:v>
                </c:pt>
                <c:pt idx="14">
                  <c:v>0.23191375813854198</c:v>
                </c:pt>
                <c:pt idx="15">
                  <c:v>0.24847902657700927</c:v>
                </c:pt>
                <c:pt idx="16">
                  <c:v>0.26504429501547655</c:v>
                </c:pt>
                <c:pt idx="17">
                  <c:v>0.28160956345394383</c:v>
                </c:pt>
                <c:pt idx="18">
                  <c:v>0.29817483189241112</c:v>
                </c:pt>
                <c:pt idx="19">
                  <c:v>0.3147401003308784</c:v>
                </c:pt>
                <c:pt idx="20">
                  <c:v>0.33130536876934569</c:v>
                </c:pt>
                <c:pt idx="21">
                  <c:v>0.34787063720781297</c:v>
                </c:pt>
                <c:pt idx="22">
                  <c:v>0.36443590564628026</c:v>
                </c:pt>
                <c:pt idx="23">
                  <c:v>0.38100117408474754</c:v>
                </c:pt>
                <c:pt idx="24">
                  <c:v>0.39756644252321482</c:v>
                </c:pt>
                <c:pt idx="25">
                  <c:v>0.41413171096168211</c:v>
                </c:pt>
                <c:pt idx="26">
                  <c:v>0.43069697940014939</c:v>
                </c:pt>
                <c:pt idx="27">
                  <c:v>0.44726224783861668</c:v>
                </c:pt>
                <c:pt idx="28">
                  <c:v>0.46382751627708396</c:v>
                </c:pt>
                <c:pt idx="29">
                  <c:v>0.48039278471555125</c:v>
                </c:pt>
                <c:pt idx="30">
                  <c:v>0.49695805315401853</c:v>
                </c:pt>
                <c:pt idx="31">
                  <c:v>0.51352332159248582</c:v>
                </c:pt>
                <c:pt idx="32">
                  <c:v>0.5300885900309531</c:v>
                </c:pt>
                <c:pt idx="33">
                  <c:v>0.54665385846942038</c:v>
                </c:pt>
                <c:pt idx="34">
                  <c:v>0.56321912690788767</c:v>
                </c:pt>
                <c:pt idx="35">
                  <c:v>0.57978439534635495</c:v>
                </c:pt>
                <c:pt idx="36">
                  <c:v>0.59634966378482224</c:v>
                </c:pt>
                <c:pt idx="37">
                  <c:v>0.61291493222328952</c:v>
                </c:pt>
                <c:pt idx="38">
                  <c:v>0.62948020066175681</c:v>
                </c:pt>
                <c:pt idx="39">
                  <c:v>0.64604546910022409</c:v>
                </c:pt>
                <c:pt idx="40">
                  <c:v>0.66261073753869137</c:v>
                </c:pt>
                <c:pt idx="41">
                  <c:v>0.67917600597715866</c:v>
                </c:pt>
                <c:pt idx="42">
                  <c:v>0.69574127441562594</c:v>
                </c:pt>
                <c:pt idx="43">
                  <c:v>0.71230654285409323</c:v>
                </c:pt>
                <c:pt idx="44">
                  <c:v>0.72887181129256051</c:v>
                </c:pt>
                <c:pt idx="45">
                  <c:v>0.7454370797310278</c:v>
                </c:pt>
                <c:pt idx="46">
                  <c:v>0.76200234816949508</c:v>
                </c:pt>
                <c:pt idx="47">
                  <c:v>0.77856761660796237</c:v>
                </c:pt>
                <c:pt idx="48">
                  <c:v>0.79513288504642965</c:v>
                </c:pt>
                <c:pt idx="49">
                  <c:v>0.81169815348489693</c:v>
                </c:pt>
                <c:pt idx="50">
                  <c:v>0.82826342192336422</c:v>
                </c:pt>
                <c:pt idx="51">
                  <c:v>0.8448286903618315</c:v>
                </c:pt>
                <c:pt idx="52">
                  <c:v>0.86139395880029879</c:v>
                </c:pt>
                <c:pt idx="53">
                  <c:v>0.87795922723876607</c:v>
                </c:pt>
                <c:pt idx="54">
                  <c:v>0.89452449567723336</c:v>
                </c:pt>
                <c:pt idx="55">
                  <c:v>0.91108976411570064</c:v>
                </c:pt>
                <c:pt idx="56">
                  <c:v>0.92765503255416792</c:v>
                </c:pt>
                <c:pt idx="57">
                  <c:v>0.94422030099263521</c:v>
                </c:pt>
                <c:pt idx="58">
                  <c:v>0.96078556943110249</c:v>
                </c:pt>
                <c:pt idx="59">
                  <c:v>0.97735083786956978</c:v>
                </c:pt>
                <c:pt idx="60">
                  <c:v>0.99391610630803706</c:v>
                </c:pt>
                <c:pt idx="61">
                  <c:v>1.0104813747465045</c:v>
                </c:pt>
                <c:pt idx="62">
                  <c:v>1.0270466431849716</c:v>
                </c:pt>
                <c:pt idx="63">
                  <c:v>1.043611911623439</c:v>
                </c:pt>
                <c:pt idx="64">
                  <c:v>1.0601771800619062</c:v>
                </c:pt>
                <c:pt idx="65">
                  <c:v>1.0767424485003736</c:v>
                </c:pt>
                <c:pt idx="66">
                  <c:v>1.0933077169388408</c:v>
                </c:pt>
                <c:pt idx="67">
                  <c:v>1.1098729853773082</c:v>
                </c:pt>
                <c:pt idx="68">
                  <c:v>1.1264382538157753</c:v>
                </c:pt>
                <c:pt idx="69">
                  <c:v>1.1430035222542427</c:v>
                </c:pt>
                <c:pt idx="70">
                  <c:v>1.1595687906927099</c:v>
                </c:pt>
                <c:pt idx="71">
                  <c:v>1.1761340591311773</c:v>
                </c:pt>
                <c:pt idx="72">
                  <c:v>1.1926993275696445</c:v>
                </c:pt>
                <c:pt idx="73">
                  <c:v>1.2092645960081119</c:v>
                </c:pt>
                <c:pt idx="74">
                  <c:v>1.225829864446579</c:v>
                </c:pt>
                <c:pt idx="75">
                  <c:v>1.2423951328850464</c:v>
                </c:pt>
                <c:pt idx="76">
                  <c:v>1.2589604013235136</c:v>
                </c:pt>
                <c:pt idx="77">
                  <c:v>1.275525669761981</c:v>
                </c:pt>
                <c:pt idx="78">
                  <c:v>1.2920909382004482</c:v>
                </c:pt>
                <c:pt idx="79">
                  <c:v>1.3086562066389156</c:v>
                </c:pt>
                <c:pt idx="80">
                  <c:v>1.3252214750773827</c:v>
                </c:pt>
                <c:pt idx="81">
                  <c:v>1.3417867435158501</c:v>
                </c:pt>
                <c:pt idx="82">
                  <c:v>1.3583520119543173</c:v>
                </c:pt>
                <c:pt idx="83">
                  <c:v>1.3749172803927847</c:v>
                </c:pt>
                <c:pt idx="84">
                  <c:v>1.3914825488312519</c:v>
                </c:pt>
                <c:pt idx="85">
                  <c:v>1.4080478172697193</c:v>
                </c:pt>
                <c:pt idx="86">
                  <c:v>1.4246130857081865</c:v>
                </c:pt>
                <c:pt idx="87">
                  <c:v>1.4411783541466539</c:v>
                </c:pt>
                <c:pt idx="88">
                  <c:v>1.457743622585121</c:v>
                </c:pt>
                <c:pt idx="89">
                  <c:v>1.4743088910235884</c:v>
                </c:pt>
                <c:pt idx="90">
                  <c:v>1.4908741594620556</c:v>
                </c:pt>
                <c:pt idx="91">
                  <c:v>1.507439427900523</c:v>
                </c:pt>
                <c:pt idx="92">
                  <c:v>1.5240046963389902</c:v>
                </c:pt>
                <c:pt idx="93">
                  <c:v>1.5405699647774576</c:v>
                </c:pt>
                <c:pt idx="94">
                  <c:v>1.5571352332159247</c:v>
                </c:pt>
                <c:pt idx="95">
                  <c:v>1.5737005016543921</c:v>
                </c:pt>
                <c:pt idx="96">
                  <c:v>1.5902657700928593</c:v>
                </c:pt>
                <c:pt idx="97">
                  <c:v>1.6068310385313267</c:v>
                </c:pt>
                <c:pt idx="98">
                  <c:v>1.6233963069697939</c:v>
                </c:pt>
                <c:pt idx="99">
                  <c:v>1.6399615754082613</c:v>
                </c:pt>
                <c:pt idx="100">
                  <c:v>1.6565268438467284</c:v>
                </c:pt>
                <c:pt idx="101">
                  <c:v>1.6730921122851958</c:v>
                </c:pt>
                <c:pt idx="102">
                  <c:v>1.689657380723663</c:v>
                </c:pt>
                <c:pt idx="103">
                  <c:v>1.7062226491621304</c:v>
                </c:pt>
                <c:pt idx="104">
                  <c:v>1.7227879176005976</c:v>
                </c:pt>
                <c:pt idx="105">
                  <c:v>1.739353186039065</c:v>
                </c:pt>
                <c:pt idx="106">
                  <c:v>1.7559184544775321</c:v>
                </c:pt>
                <c:pt idx="107">
                  <c:v>1.7724837229159995</c:v>
                </c:pt>
                <c:pt idx="108">
                  <c:v>1.7890489913544667</c:v>
                </c:pt>
                <c:pt idx="109">
                  <c:v>1.8056142597929341</c:v>
                </c:pt>
                <c:pt idx="110">
                  <c:v>1.8221795282314013</c:v>
                </c:pt>
                <c:pt idx="111">
                  <c:v>1.8387447966698687</c:v>
                </c:pt>
                <c:pt idx="112">
                  <c:v>1.8553100651083358</c:v>
                </c:pt>
                <c:pt idx="113">
                  <c:v>1.8718753335468032</c:v>
                </c:pt>
                <c:pt idx="114">
                  <c:v>1.8884406019852704</c:v>
                </c:pt>
                <c:pt idx="115">
                  <c:v>1.9050058704237378</c:v>
                </c:pt>
                <c:pt idx="116">
                  <c:v>1.921571138862205</c:v>
                </c:pt>
                <c:pt idx="117">
                  <c:v>1.9381364073006724</c:v>
                </c:pt>
                <c:pt idx="118">
                  <c:v>1.9547016757391396</c:v>
                </c:pt>
                <c:pt idx="119">
                  <c:v>1.971266944177607</c:v>
                </c:pt>
                <c:pt idx="120">
                  <c:v>1.9878322126160741</c:v>
                </c:pt>
                <c:pt idx="121">
                  <c:v>2.0043974810545415</c:v>
                </c:pt>
                <c:pt idx="122">
                  <c:v>2.0209627494930089</c:v>
                </c:pt>
                <c:pt idx="123">
                  <c:v>2.0375280179314759</c:v>
                </c:pt>
                <c:pt idx="124">
                  <c:v>2.0540932863699433</c:v>
                </c:pt>
                <c:pt idx="125">
                  <c:v>2.0706585548084107</c:v>
                </c:pt>
                <c:pt idx="126">
                  <c:v>2.0872238232468781</c:v>
                </c:pt>
                <c:pt idx="127">
                  <c:v>2.103789091685345</c:v>
                </c:pt>
                <c:pt idx="128">
                  <c:v>2.1203543601238124</c:v>
                </c:pt>
                <c:pt idx="129">
                  <c:v>2.1369196285622798</c:v>
                </c:pt>
                <c:pt idx="130">
                  <c:v>2.1534848970007472</c:v>
                </c:pt>
                <c:pt idx="131">
                  <c:v>2.1700501654392141</c:v>
                </c:pt>
                <c:pt idx="132">
                  <c:v>2.1866154338776815</c:v>
                </c:pt>
                <c:pt idx="133">
                  <c:v>2.2031807023161489</c:v>
                </c:pt>
                <c:pt idx="134">
                  <c:v>2.2197459707546163</c:v>
                </c:pt>
                <c:pt idx="135">
                  <c:v>2.2363112391930833</c:v>
                </c:pt>
                <c:pt idx="136">
                  <c:v>2.2528765076315507</c:v>
                </c:pt>
                <c:pt idx="137">
                  <c:v>2.2694417760700181</c:v>
                </c:pt>
                <c:pt idx="138">
                  <c:v>2.2860070445084855</c:v>
                </c:pt>
                <c:pt idx="139">
                  <c:v>2.3025723129469524</c:v>
                </c:pt>
                <c:pt idx="140">
                  <c:v>2.3191375813854198</c:v>
                </c:pt>
                <c:pt idx="141">
                  <c:v>2.3357028498238872</c:v>
                </c:pt>
                <c:pt idx="142">
                  <c:v>2.3522681182623546</c:v>
                </c:pt>
                <c:pt idx="143">
                  <c:v>2.3688333867008216</c:v>
                </c:pt>
                <c:pt idx="144">
                  <c:v>2.3853986551392889</c:v>
                </c:pt>
                <c:pt idx="145">
                  <c:v>2.4019639235777563</c:v>
                </c:pt>
                <c:pt idx="146">
                  <c:v>2.4185291920162237</c:v>
                </c:pt>
                <c:pt idx="147">
                  <c:v>2.4350944604546907</c:v>
                </c:pt>
                <c:pt idx="148">
                  <c:v>2.4516597288931581</c:v>
                </c:pt>
                <c:pt idx="149">
                  <c:v>2.4682249973316255</c:v>
                </c:pt>
                <c:pt idx="150">
                  <c:v>2.4847902657700929</c:v>
                </c:pt>
                <c:pt idx="151">
                  <c:v>2.5013555342085598</c:v>
                </c:pt>
                <c:pt idx="152">
                  <c:v>2.5179208026470272</c:v>
                </c:pt>
                <c:pt idx="153">
                  <c:v>2.5344860710854946</c:v>
                </c:pt>
                <c:pt idx="154">
                  <c:v>2.551051339523962</c:v>
                </c:pt>
                <c:pt idx="155">
                  <c:v>2.567616607962429</c:v>
                </c:pt>
                <c:pt idx="156">
                  <c:v>2.5841818764008964</c:v>
                </c:pt>
                <c:pt idx="157">
                  <c:v>2.6007471448393638</c:v>
                </c:pt>
                <c:pt idx="158">
                  <c:v>2.6173124132778312</c:v>
                </c:pt>
                <c:pt idx="159">
                  <c:v>2.6338776817162981</c:v>
                </c:pt>
                <c:pt idx="160">
                  <c:v>2.6504429501547655</c:v>
                </c:pt>
                <c:pt idx="161">
                  <c:v>2.6670082185932329</c:v>
                </c:pt>
                <c:pt idx="162">
                  <c:v>2.6835734870317003</c:v>
                </c:pt>
                <c:pt idx="163">
                  <c:v>2.7001387554701672</c:v>
                </c:pt>
                <c:pt idx="164">
                  <c:v>2.7167040239086346</c:v>
                </c:pt>
                <c:pt idx="165">
                  <c:v>2.733269292347102</c:v>
                </c:pt>
                <c:pt idx="166">
                  <c:v>2.7498345607855694</c:v>
                </c:pt>
                <c:pt idx="167">
                  <c:v>2.7663998292240364</c:v>
                </c:pt>
                <c:pt idx="168">
                  <c:v>2.7829650976625038</c:v>
                </c:pt>
                <c:pt idx="169">
                  <c:v>2.7995303661009712</c:v>
                </c:pt>
                <c:pt idx="170">
                  <c:v>2.8160956345394386</c:v>
                </c:pt>
                <c:pt idx="171">
                  <c:v>2.8326609029779055</c:v>
                </c:pt>
                <c:pt idx="172">
                  <c:v>2.8492261714163729</c:v>
                </c:pt>
                <c:pt idx="173">
                  <c:v>2.8657914398548403</c:v>
                </c:pt>
                <c:pt idx="174">
                  <c:v>2.8823567082933077</c:v>
                </c:pt>
                <c:pt idx="175">
                  <c:v>2.8989219767317747</c:v>
                </c:pt>
                <c:pt idx="176">
                  <c:v>2.915487245170242</c:v>
                </c:pt>
                <c:pt idx="177">
                  <c:v>2.9320525136087094</c:v>
                </c:pt>
                <c:pt idx="178">
                  <c:v>2.9486177820471768</c:v>
                </c:pt>
                <c:pt idx="179">
                  <c:v>2.9651830504856438</c:v>
                </c:pt>
                <c:pt idx="180">
                  <c:v>2.9817483189241112</c:v>
                </c:pt>
                <c:pt idx="181">
                  <c:v>2.9983135873625786</c:v>
                </c:pt>
                <c:pt idx="182">
                  <c:v>3.014878855801046</c:v>
                </c:pt>
                <c:pt idx="183">
                  <c:v>3.0314441242395129</c:v>
                </c:pt>
                <c:pt idx="184">
                  <c:v>3.0480093926779803</c:v>
                </c:pt>
                <c:pt idx="185">
                  <c:v>3.0645746611164477</c:v>
                </c:pt>
                <c:pt idx="186">
                  <c:v>3.0811399295549151</c:v>
                </c:pt>
                <c:pt idx="187">
                  <c:v>3.0977051979933821</c:v>
                </c:pt>
                <c:pt idx="188">
                  <c:v>3.1142704664318495</c:v>
                </c:pt>
                <c:pt idx="189">
                  <c:v>3.1308357348703169</c:v>
                </c:pt>
                <c:pt idx="190">
                  <c:v>3.1474010033087843</c:v>
                </c:pt>
                <c:pt idx="191">
                  <c:v>3.1639662717472512</c:v>
                </c:pt>
                <c:pt idx="192">
                  <c:v>3.1805315401857186</c:v>
                </c:pt>
                <c:pt idx="193">
                  <c:v>3.197096808624186</c:v>
                </c:pt>
                <c:pt idx="194">
                  <c:v>3.2136620770626534</c:v>
                </c:pt>
                <c:pt idx="195">
                  <c:v>3.2302273455011203</c:v>
                </c:pt>
                <c:pt idx="196">
                  <c:v>3.2467926139395877</c:v>
                </c:pt>
                <c:pt idx="197">
                  <c:v>3.2633578823780551</c:v>
                </c:pt>
                <c:pt idx="198">
                  <c:v>3.2799231508165225</c:v>
                </c:pt>
                <c:pt idx="199">
                  <c:v>3.2964884192549895</c:v>
                </c:pt>
                <c:pt idx="200">
                  <c:v>3.3130536876934569</c:v>
                </c:pt>
                <c:pt idx="201">
                  <c:v>3.3296189561319243</c:v>
                </c:pt>
                <c:pt idx="202">
                  <c:v>3.3461842245703917</c:v>
                </c:pt>
                <c:pt idx="203">
                  <c:v>3.3627494930088586</c:v>
                </c:pt>
                <c:pt idx="204">
                  <c:v>3.379314761447326</c:v>
                </c:pt>
                <c:pt idx="205">
                  <c:v>3.3958800298857934</c:v>
                </c:pt>
                <c:pt idx="206">
                  <c:v>3.4124452983242608</c:v>
                </c:pt>
                <c:pt idx="207">
                  <c:v>3.4290105667627278</c:v>
                </c:pt>
                <c:pt idx="208">
                  <c:v>3.4455758352011951</c:v>
                </c:pt>
                <c:pt idx="209">
                  <c:v>3.4621411036396625</c:v>
                </c:pt>
                <c:pt idx="210">
                  <c:v>3.4787063720781299</c:v>
                </c:pt>
                <c:pt idx="211">
                  <c:v>3.4952716405165973</c:v>
                </c:pt>
                <c:pt idx="212">
                  <c:v>3.5118369089550643</c:v>
                </c:pt>
                <c:pt idx="213">
                  <c:v>3.5284021773935317</c:v>
                </c:pt>
                <c:pt idx="214">
                  <c:v>3.5449674458319991</c:v>
                </c:pt>
                <c:pt idx="215">
                  <c:v>3.5615327142704665</c:v>
                </c:pt>
                <c:pt idx="216">
                  <c:v>3.5780979827089334</c:v>
                </c:pt>
                <c:pt idx="217">
                  <c:v>3.5946632511474008</c:v>
                </c:pt>
                <c:pt idx="218">
                  <c:v>3.6112285195858682</c:v>
                </c:pt>
                <c:pt idx="219">
                  <c:v>3.6277937880243356</c:v>
                </c:pt>
                <c:pt idx="220">
                  <c:v>3.6443590564628026</c:v>
                </c:pt>
                <c:pt idx="221">
                  <c:v>3.66092432490127</c:v>
                </c:pt>
                <c:pt idx="222">
                  <c:v>3.6774895933397374</c:v>
                </c:pt>
                <c:pt idx="223">
                  <c:v>3.6940548617782047</c:v>
                </c:pt>
                <c:pt idx="224">
                  <c:v>3.7106201302166717</c:v>
                </c:pt>
                <c:pt idx="225">
                  <c:v>3.7271853986551391</c:v>
                </c:pt>
                <c:pt idx="226">
                  <c:v>3.7437506670936065</c:v>
                </c:pt>
                <c:pt idx="227">
                  <c:v>3.7603159355320739</c:v>
                </c:pt>
                <c:pt idx="228">
                  <c:v>3.7768812039705408</c:v>
                </c:pt>
                <c:pt idx="229">
                  <c:v>3.7934464724090082</c:v>
                </c:pt>
                <c:pt idx="230">
                  <c:v>3.8100117408474756</c:v>
                </c:pt>
                <c:pt idx="231">
                  <c:v>3.826577009285943</c:v>
                </c:pt>
                <c:pt idx="232">
                  <c:v>3.84314227772441</c:v>
                </c:pt>
                <c:pt idx="233">
                  <c:v>3.8597075461628774</c:v>
                </c:pt>
                <c:pt idx="234">
                  <c:v>3.8762728146013448</c:v>
                </c:pt>
                <c:pt idx="235">
                  <c:v>3.8928380830398122</c:v>
                </c:pt>
                <c:pt idx="236">
                  <c:v>3.9094033514782791</c:v>
                </c:pt>
                <c:pt idx="237">
                  <c:v>3.9259686199167465</c:v>
                </c:pt>
                <c:pt idx="238">
                  <c:v>3.9425338883552139</c:v>
                </c:pt>
                <c:pt idx="239">
                  <c:v>3.9590991567936813</c:v>
                </c:pt>
                <c:pt idx="240">
                  <c:v>3.9756644252321482</c:v>
                </c:pt>
                <c:pt idx="241">
                  <c:v>3.9922296936706156</c:v>
                </c:pt>
                <c:pt idx="242">
                  <c:v>4.008794962109083</c:v>
                </c:pt>
                <c:pt idx="243">
                  <c:v>4.02536023054755</c:v>
                </c:pt>
                <c:pt idx="244">
                  <c:v>4.0419254989860178</c:v>
                </c:pt>
                <c:pt idx="245">
                  <c:v>4.0584907674244848</c:v>
                </c:pt>
                <c:pt idx="246">
                  <c:v>4.0750560358629517</c:v>
                </c:pt>
                <c:pt idx="247">
                  <c:v>4.0916213043014196</c:v>
                </c:pt>
                <c:pt idx="248">
                  <c:v>4.1081865727398865</c:v>
                </c:pt>
                <c:pt idx="249">
                  <c:v>4.1247518411783544</c:v>
                </c:pt>
                <c:pt idx="250">
                  <c:v>4.1413171096168213</c:v>
                </c:pt>
                <c:pt idx="251">
                  <c:v>4.1578823780552883</c:v>
                </c:pt>
                <c:pt idx="252">
                  <c:v>4.1744476464937561</c:v>
                </c:pt>
                <c:pt idx="253">
                  <c:v>4.1910129149322231</c:v>
                </c:pt>
                <c:pt idx="254">
                  <c:v>4.20757818337069</c:v>
                </c:pt>
                <c:pt idx="255">
                  <c:v>4.2241434518091578</c:v>
                </c:pt>
                <c:pt idx="256">
                  <c:v>4.2407087202476248</c:v>
                </c:pt>
                <c:pt idx="257">
                  <c:v>4.2572739886860926</c:v>
                </c:pt>
                <c:pt idx="258">
                  <c:v>4.2738392571245596</c:v>
                </c:pt>
                <c:pt idx="259">
                  <c:v>4.2904045255630265</c:v>
                </c:pt>
                <c:pt idx="260">
                  <c:v>4.3069697940014944</c:v>
                </c:pt>
                <c:pt idx="261">
                  <c:v>4.3235350624399613</c:v>
                </c:pt>
                <c:pt idx="262">
                  <c:v>4.3401003308784283</c:v>
                </c:pt>
                <c:pt idx="263">
                  <c:v>4.3566655993168961</c:v>
                </c:pt>
                <c:pt idx="264">
                  <c:v>4.3732308677553631</c:v>
                </c:pt>
                <c:pt idx="265">
                  <c:v>4.3897961361938309</c:v>
                </c:pt>
                <c:pt idx="266">
                  <c:v>4.4063614046322979</c:v>
                </c:pt>
                <c:pt idx="267">
                  <c:v>4.4229266730707648</c:v>
                </c:pt>
                <c:pt idx="268">
                  <c:v>4.4394919415092327</c:v>
                </c:pt>
                <c:pt idx="269">
                  <c:v>4.4560572099476996</c:v>
                </c:pt>
                <c:pt idx="270">
                  <c:v>4.4726224783861666</c:v>
                </c:pt>
                <c:pt idx="271">
                  <c:v>4.4891877468246344</c:v>
                </c:pt>
                <c:pt idx="272">
                  <c:v>4.5057530152631013</c:v>
                </c:pt>
                <c:pt idx="273">
                  <c:v>4.5223182837015692</c:v>
                </c:pt>
                <c:pt idx="274">
                  <c:v>4.5388835521400361</c:v>
                </c:pt>
                <c:pt idx="275">
                  <c:v>4.5554488205785031</c:v>
                </c:pt>
                <c:pt idx="276">
                  <c:v>4.5720140890169709</c:v>
                </c:pt>
                <c:pt idx="277">
                  <c:v>4.5885793574554379</c:v>
                </c:pt>
                <c:pt idx="278">
                  <c:v>4.6051446258939048</c:v>
                </c:pt>
                <c:pt idx="279">
                  <c:v>4.6217098943323727</c:v>
                </c:pt>
                <c:pt idx="280">
                  <c:v>4.6382751627708396</c:v>
                </c:pt>
                <c:pt idx="281">
                  <c:v>4.6548404312093075</c:v>
                </c:pt>
                <c:pt idx="282">
                  <c:v>4.6714056996477744</c:v>
                </c:pt>
                <c:pt idx="283">
                  <c:v>4.6879709680862414</c:v>
                </c:pt>
                <c:pt idx="284">
                  <c:v>4.7045362365247092</c:v>
                </c:pt>
                <c:pt idx="285">
                  <c:v>4.7211015049631762</c:v>
                </c:pt>
                <c:pt idx="286">
                  <c:v>4.7376667734016431</c:v>
                </c:pt>
                <c:pt idx="287">
                  <c:v>4.7542320418401109</c:v>
                </c:pt>
                <c:pt idx="288">
                  <c:v>4.7707973102785779</c:v>
                </c:pt>
                <c:pt idx="289">
                  <c:v>4.7873625787170457</c:v>
                </c:pt>
                <c:pt idx="290">
                  <c:v>4.8039278471555127</c:v>
                </c:pt>
                <c:pt idx="291">
                  <c:v>4.8204931155939796</c:v>
                </c:pt>
                <c:pt idx="292">
                  <c:v>4.8370583840324475</c:v>
                </c:pt>
                <c:pt idx="293">
                  <c:v>4.8536236524709144</c:v>
                </c:pt>
                <c:pt idx="294">
                  <c:v>4.8701889209093814</c:v>
                </c:pt>
                <c:pt idx="295">
                  <c:v>4.8867541893478492</c:v>
                </c:pt>
                <c:pt idx="296">
                  <c:v>4.9033194577863162</c:v>
                </c:pt>
                <c:pt idx="297">
                  <c:v>4.919884726224784</c:v>
                </c:pt>
                <c:pt idx="298">
                  <c:v>4.936449994663251</c:v>
                </c:pt>
                <c:pt idx="299">
                  <c:v>4.9530152631017179</c:v>
                </c:pt>
                <c:pt idx="300">
                  <c:v>4.9695805315401858</c:v>
                </c:pt>
                <c:pt idx="301">
                  <c:v>4.9861457999786527</c:v>
                </c:pt>
                <c:pt idx="302">
                  <c:v>5.0027110684171197</c:v>
                </c:pt>
                <c:pt idx="303">
                  <c:v>5.0192763368555875</c:v>
                </c:pt>
                <c:pt idx="304">
                  <c:v>5.0358416052940544</c:v>
                </c:pt>
                <c:pt idx="305">
                  <c:v>5.0524068737325223</c:v>
                </c:pt>
                <c:pt idx="306">
                  <c:v>5.0689721421709892</c:v>
                </c:pt>
                <c:pt idx="307">
                  <c:v>5.0855374106094562</c:v>
                </c:pt>
                <c:pt idx="308">
                  <c:v>5.102102679047924</c:v>
                </c:pt>
                <c:pt idx="309">
                  <c:v>5.118667947486391</c:v>
                </c:pt>
                <c:pt idx="310">
                  <c:v>5.1352332159248579</c:v>
                </c:pt>
                <c:pt idx="311">
                  <c:v>5.1517984843633258</c:v>
                </c:pt>
                <c:pt idx="312">
                  <c:v>5.1683637528017927</c:v>
                </c:pt>
                <c:pt idx="313">
                  <c:v>5.1849290212402606</c:v>
                </c:pt>
                <c:pt idx="314">
                  <c:v>5.2014942896787275</c:v>
                </c:pt>
                <c:pt idx="315">
                  <c:v>5.2180595581171945</c:v>
                </c:pt>
                <c:pt idx="316">
                  <c:v>5.2346248265556623</c:v>
                </c:pt>
                <c:pt idx="317">
                  <c:v>5.2511900949941293</c:v>
                </c:pt>
                <c:pt idx="318">
                  <c:v>5.2677553634325962</c:v>
                </c:pt>
                <c:pt idx="319">
                  <c:v>5.284320631871064</c:v>
                </c:pt>
                <c:pt idx="320">
                  <c:v>5.300885900309531</c:v>
                </c:pt>
                <c:pt idx="321">
                  <c:v>5.3174511687479988</c:v>
                </c:pt>
                <c:pt idx="322">
                  <c:v>5.3340164371864658</c:v>
                </c:pt>
                <c:pt idx="323">
                  <c:v>5.3505817056249327</c:v>
                </c:pt>
                <c:pt idx="324">
                  <c:v>5.3671469740634006</c:v>
                </c:pt>
                <c:pt idx="325">
                  <c:v>5.3837122425018675</c:v>
                </c:pt>
                <c:pt idx="326">
                  <c:v>5.4002775109403345</c:v>
                </c:pt>
                <c:pt idx="327">
                  <c:v>5.4168427793788023</c:v>
                </c:pt>
                <c:pt idx="328">
                  <c:v>5.4334080478172693</c:v>
                </c:pt>
                <c:pt idx="329">
                  <c:v>5.4499733162557371</c:v>
                </c:pt>
                <c:pt idx="330">
                  <c:v>5.4665385846942041</c:v>
                </c:pt>
                <c:pt idx="331">
                  <c:v>5.483103853132671</c:v>
                </c:pt>
                <c:pt idx="332">
                  <c:v>5.4996691215711389</c:v>
                </c:pt>
                <c:pt idx="333">
                  <c:v>5.5162343900096058</c:v>
                </c:pt>
                <c:pt idx="334">
                  <c:v>5.5327996584480728</c:v>
                </c:pt>
                <c:pt idx="335">
                  <c:v>5.5493649268865406</c:v>
                </c:pt>
                <c:pt idx="336">
                  <c:v>5.5659301953250075</c:v>
                </c:pt>
                <c:pt idx="337">
                  <c:v>5.5824954637634754</c:v>
                </c:pt>
                <c:pt idx="338">
                  <c:v>5.5990607322019423</c:v>
                </c:pt>
                <c:pt idx="339">
                  <c:v>5.6156260006404093</c:v>
                </c:pt>
                <c:pt idx="340">
                  <c:v>5.6321912690788771</c:v>
                </c:pt>
                <c:pt idx="341">
                  <c:v>5.6487565375173441</c:v>
                </c:pt>
                <c:pt idx="342">
                  <c:v>5.665321805955811</c:v>
                </c:pt>
                <c:pt idx="343">
                  <c:v>5.6818870743942789</c:v>
                </c:pt>
                <c:pt idx="344">
                  <c:v>5.6984523428327458</c:v>
                </c:pt>
                <c:pt idx="345">
                  <c:v>5.7150176112712137</c:v>
                </c:pt>
                <c:pt idx="346">
                  <c:v>5.7315828797096806</c:v>
                </c:pt>
                <c:pt idx="347">
                  <c:v>5.7481481481481476</c:v>
                </c:pt>
                <c:pt idx="348">
                  <c:v>5.7647134165866154</c:v>
                </c:pt>
                <c:pt idx="349">
                  <c:v>5.7812786850250824</c:v>
                </c:pt>
                <c:pt idx="350">
                  <c:v>5.7978439534635493</c:v>
                </c:pt>
                <c:pt idx="351">
                  <c:v>5.8144092219020171</c:v>
                </c:pt>
                <c:pt idx="352">
                  <c:v>5.8309744903404841</c:v>
                </c:pt>
                <c:pt idx="353">
                  <c:v>5.8475397587789519</c:v>
                </c:pt>
                <c:pt idx="354">
                  <c:v>5.8641050272174189</c:v>
                </c:pt>
                <c:pt idx="355">
                  <c:v>5.8806702956558858</c:v>
                </c:pt>
                <c:pt idx="356">
                  <c:v>5.8972355640943537</c:v>
                </c:pt>
                <c:pt idx="357">
                  <c:v>5.9138008325328206</c:v>
                </c:pt>
                <c:pt idx="358">
                  <c:v>5.9303661009712876</c:v>
                </c:pt>
                <c:pt idx="359">
                  <c:v>5.9469313694097554</c:v>
                </c:pt>
                <c:pt idx="360">
                  <c:v>5.9634966378482224</c:v>
                </c:pt>
                <c:pt idx="361">
                  <c:v>5.9800619062866902</c:v>
                </c:pt>
                <c:pt idx="362">
                  <c:v>5.9966271747251572</c:v>
                </c:pt>
                <c:pt idx="363">
                  <c:v>6.0131924431636241</c:v>
                </c:pt>
                <c:pt idx="364">
                  <c:v>6.029757711602092</c:v>
                </c:pt>
                <c:pt idx="365">
                  <c:v>6.0463229800405589</c:v>
                </c:pt>
                <c:pt idx="366">
                  <c:v>6.0628882484790259</c:v>
                </c:pt>
                <c:pt idx="367">
                  <c:v>6.0794535169174937</c:v>
                </c:pt>
                <c:pt idx="368">
                  <c:v>6.0960187853559606</c:v>
                </c:pt>
                <c:pt idx="369">
                  <c:v>6.1125840537944285</c:v>
                </c:pt>
                <c:pt idx="370">
                  <c:v>6.1291493222328954</c:v>
                </c:pt>
                <c:pt idx="371">
                  <c:v>6.1457145906713624</c:v>
                </c:pt>
                <c:pt idx="372">
                  <c:v>6.1622798591098302</c:v>
                </c:pt>
                <c:pt idx="373">
                  <c:v>6.1788451275482972</c:v>
                </c:pt>
                <c:pt idx="374">
                  <c:v>6.1954103959867641</c:v>
                </c:pt>
                <c:pt idx="375">
                  <c:v>6.211975664425232</c:v>
                </c:pt>
                <c:pt idx="376">
                  <c:v>6.2285409328636989</c:v>
                </c:pt>
                <c:pt idx="377">
                  <c:v>6.2451062013021668</c:v>
                </c:pt>
                <c:pt idx="378">
                  <c:v>6.2616714697406337</c:v>
                </c:pt>
                <c:pt idx="379">
                  <c:v>6.2782367381791007</c:v>
                </c:pt>
                <c:pt idx="380">
                  <c:v>6.2948020066175685</c:v>
                </c:pt>
                <c:pt idx="381">
                  <c:v>6.3113672750560355</c:v>
                </c:pt>
                <c:pt idx="382">
                  <c:v>6.3279325434945024</c:v>
                </c:pt>
                <c:pt idx="383">
                  <c:v>6.3444978119329702</c:v>
                </c:pt>
                <c:pt idx="384">
                  <c:v>6.3610630803714372</c:v>
                </c:pt>
                <c:pt idx="385">
                  <c:v>6.377628348809905</c:v>
                </c:pt>
                <c:pt idx="386">
                  <c:v>6.394193617248372</c:v>
                </c:pt>
                <c:pt idx="387">
                  <c:v>6.4107588856868389</c:v>
                </c:pt>
                <c:pt idx="388">
                  <c:v>6.4273241541253068</c:v>
                </c:pt>
                <c:pt idx="389">
                  <c:v>6.4438894225637737</c:v>
                </c:pt>
                <c:pt idx="390">
                  <c:v>6.4604546910022407</c:v>
                </c:pt>
                <c:pt idx="391">
                  <c:v>6.4770199594407085</c:v>
                </c:pt>
                <c:pt idx="392">
                  <c:v>6.4935852278791755</c:v>
                </c:pt>
                <c:pt idx="393">
                  <c:v>6.5101504963176433</c:v>
                </c:pt>
                <c:pt idx="394">
                  <c:v>6.5267157647561103</c:v>
                </c:pt>
                <c:pt idx="395">
                  <c:v>6.5432810331945772</c:v>
                </c:pt>
                <c:pt idx="396">
                  <c:v>6.5598463016330451</c:v>
                </c:pt>
                <c:pt idx="397">
                  <c:v>6.576411570071512</c:v>
                </c:pt>
                <c:pt idx="398">
                  <c:v>6.592976838509979</c:v>
                </c:pt>
                <c:pt idx="399">
                  <c:v>6.6095421069484468</c:v>
                </c:pt>
                <c:pt idx="400">
                  <c:v>6.6261073753869137</c:v>
                </c:pt>
                <c:pt idx="401">
                  <c:v>6.6426726438253816</c:v>
                </c:pt>
                <c:pt idx="402">
                  <c:v>6.6592379122638485</c:v>
                </c:pt>
                <c:pt idx="403">
                  <c:v>6.6758031807023155</c:v>
                </c:pt>
                <c:pt idx="404">
                  <c:v>6.6923684491407833</c:v>
                </c:pt>
                <c:pt idx="405">
                  <c:v>6.7089337175792503</c:v>
                </c:pt>
                <c:pt idx="406">
                  <c:v>6.7254989860177172</c:v>
                </c:pt>
                <c:pt idx="407">
                  <c:v>6.7420642544561851</c:v>
                </c:pt>
                <c:pt idx="408">
                  <c:v>6.758629522894652</c:v>
                </c:pt>
                <c:pt idx="409">
                  <c:v>6.7751947913331199</c:v>
                </c:pt>
                <c:pt idx="410">
                  <c:v>6.7917600597715868</c:v>
                </c:pt>
                <c:pt idx="411">
                  <c:v>6.8083253282100538</c:v>
                </c:pt>
                <c:pt idx="412">
                  <c:v>6.8248905966485216</c:v>
                </c:pt>
                <c:pt idx="413">
                  <c:v>6.8414558650869886</c:v>
                </c:pt>
                <c:pt idx="414">
                  <c:v>6.8580211335254555</c:v>
                </c:pt>
                <c:pt idx="415">
                  <c:v>6.8745864019639233</c:v>
                </c:pt>
                <c:pt idx="416">
                  <c:v>6.8911516704023903</c:v>
                </c:pt>
                <c:pt idx="417">
                  <c:v>6.9077169388408581</c:v>
                </c:pt>
                <c:pt idx="418">
                  <c:v>6.9242822072793251</c:v>
                </c:pt>
                <c:pt idx="419">
                  <c:v>6.940847475717792</c:v>
                </c:pt>
                <c:pt idx="420">
                  <c:v>6.9574127441562599</c:v>
                </c:pt>
                <c:pt idx="421">
                  <c:v>6.9739780125947268</c:v>
                </c:pt>
                <c:pt idx="422">
                  <c:v>6.9905432810331947</c:v>
                </c:pt>
                <c:pt idx="423">
                  <c:v>7.0071085494716616</c:v>
                </c:pt>
                <c:pt idx="424">
                  <c:v>7.0236738179101286</c:v>
                </c:pt>
                <c:pt idx="425">
                  <c:v>7.0402390863485964</c:v>
                </c:pt>
                <c:pt idx="426">
                  <c:v>7.0568043547870634</c:v>
                </c:pt>
                <c:pt idx="427">
                  <c:v>7.0733696232255303</c:v>
                </c:pt>
                <c:pt idx="428">
                  <c:v>7.0899348916639982</c:v>
                </c:pt>
                <c:pt idx="429">
                  <c:v>7.1065001601024651</c:v>
                </c:pt>
                <c:pt idx="430">
                  <c:v>7.1230654285409329</c:v>
                </c:pt>
                <c:pt idx="431">
                  <c:v>7.1396306969793999</c:v>
                </c:pt>
                <c:pt idx="432">
                  <c:v>7.1561959654178668</c:v>
                </c:pt>
                <c:pt idx="433">
                  <c:v>7.1727612338563347</c:v>
                </c:pt>
                <c:pt idx="434">
                  <c:v>7.1893265022948016</c:v>
                </c:pt>
                <c:pt idx="435">
                  <c:v>7.2058917707332686</c:v>
                </c:pt>
                <c:pt idx="436">
                  <c:v>7.2224570391717364</c:v>
                </c:pt>
                <c:pt idx="437">
                  <c:v>7.2390223076102034</c:v>
                </c:pt>
                <c:pt idx="438">
                  <c:v>7.2555875760486712</c:v>
                </c:pt>
                <c:pt idx="439">
                  <c:v>7.2721528444871382</c:v>
                </c:pt>
                <c:pt idx="440">
                  <c:v>7.2887181129256051</c:v>
                </c:pt>
                <c:pt idx="441">
                  <c:v>7.305283381364073</c:v>
                </c:pt>
                <c:pt idx="442">
                  <c:v>7.3218486498025399</c:v>
                </c:pt>
                <c:pt idx="443">
                  <c:v>7.3384139182410069</c:v>
                </c:pt>
                <c:pt idx="444">
                  <c:v>7.3549791866794747</c:v>
                </c:pt>
                <c:pt idx="445">
                  <c:v>7.3715444551179417</c:v>
                </c:pt>
                <c:pt idx="446">
                  <c:v>7.3881097235564095</c:v>
                </c:pt>
                <c:pt idx="447">
                  <c:v>7.4046749919948764</c:v>
                </c:pt>
                <c:pt idx="448">
                  <c:v>7.4212402604333434</c:v>
                </c:pt>
                <c:pt idx="449">
                  <c:v>7.4378055288718112</c:v>
                </c:pt>
                <c:pt idx="450">
                  <c:v>7.4543707973102782</c:v>
                </c:pt>
                <c:pt idx="451">
                  <c:v>7.4709360657487451</c:v>
                </c:pt>
                <c:pt idx="452">
                  <c:v>7.487501334187213</c:v>
                </c:pt>
                <c:pt idx="453">
                  <c:v>7.5040666026256799</c:v>
                </c:pt>
                <c:pt idx="454">
                  <c:v>7.5206318710641478</c:v>
                </c:pt>
                <c:pt idx="455">
                  <c:v>7.5371971395026147</c:v>
                </c:pt>
                <c:pt idx="456">
                  <c:v>7.5537624079410817</c:v>
                </c:pt>
                <c:pt idx="457">
                  <c:v>7.5703276763795495</c:v>
                </c:pt>
                <c:pt idx="458">
                  <c:v>7.5868929448180165</c:v>
                </c:pt>
                <c:pt idx="459">
                  <c:v>7.6034582132564834</c:v>
                </c:pt>
                <c:pt idx="460">
                  <c:v>7.6200234816949513</c:v>
                </c:pt>
                <c:pt idx="461">
                  <c:v>7.6365887501334182</c:v>
                </c:pt>
                <c:pt idx="462">
                  <c:v>7.653154018571886</c:v>
                </c:pt>
                <c:pt idx="463">
                  <c:v>7.669719287010353</c:v>
                </c:pt>
                <c:pt idx="464">
                  <c:v>7.6862845554488199</c:v>
                </c:pt>
                <c:pt idx="465">
                  <c:v>7.7028498238872878</c:v>
                </c:pt>
                <c:pt idx="466">
                  <c:v>7.7194150923257547</c:v>
                </c:pt>
                <c:pt idx="467">
                  <c:v>7.7359803607642217</c:v>
                </c:pt>
                <c:pt idx="468">
                  <c:v>7.7525456292026895</c:v>
                </c:pt>
                <c:pt idx="469">
                  <c:v>7.7691108976411565</c:v>
                </c:pt>
                <c:pt idx="470">
                  <c:v>7.7856761660796243</c:v>
                </c:pt>
                <c:pt idx="471">
                  <c:v>7.8022414345180913</c:v>
                </c:pt>
                <c:pt idx="472">
                  <c:v>7.8188067029565582</c:v>
                </c:pt>
                <c:pt idx="473">
                  <c:v>7.8353719713950261</c:v>
                </c:pt>
                <c:pt idx="474">
                  <c:v>7.851937239833493</c:v>
                </c:pt>
                <c:pt idx="475">
                  <c:v>7.86850250827196</c:v>
                </c:pt>
                <c:pt idx="476">
                  <c:v>7.8850677767104278</c:v>
                </c:pt>
                <c:pt idx="477">
                  <c:v>7.9016330451488948</c:v>
                </c:pt>
                <c:pt idx="478">
                  <c:v>7.9181983135873626</c:v>
                </c:pt>
                <c:pt idx="479">
                  <c:v>7.9347635820258295</c:v>
                </c:pt>
                <c:pt idx="480">
                  <c:v>7.9513288504642965</c:v>
                </c:pt>
                <c:pt idx="481">
                  <c:v>7.9678941189027643</c:v>
                </c:pt>
                <c:pt idx="482">
                  <c:v>7.9844593873412313</c:v>
                </c:pt>
                <c:pt idx="483">
                  <c:v>8.0010246557796982</c:v>
                </c:pt>
                <c:pt idx="484">
                  <c:v>8.0175899242181661</c:v>
                </c:pt>
                <c:pt idx="485">
                  <c:v>8.0341551926566339</c:v>
                </c:pt>
                <c:pt idx="486">
                  <c:v>8.0507204610951</c:v>
                </c:pt>
                <c:pt idx="487">
                  <c:v>8.0672857295335678</c:v>
                </c:pt>
                <c:pt idx="488">
                  <c:v>8.0838509979720357</c:v>
                </c:pt>
                <c:pt idx="489">
                  <c:v>8.1004162664105017</c:v>
                </c:pt>
                <c:pt idx="490">
                  <c:v>8.1169815348489696</c:v>
                </c:pt>
                <c:pt idx="491">
                  <c:v>8.1335468032874374</c:v>
                </c:pt>
                <c:pt idx="492">
                  <c:v>8.1501120717259035</c:v>
                </c:pt>
                <c:pt idx="493">
                  <c:v>8.1666773401643713</c:v>
                </c:pt>
                <c:pt idx="494">
                  <c:v>8.1832426086028391</c:v>
                </c:pt>
                <c:pt idx="495">
                  <c:v>8.1998078770413052</c:v>
                </c:pt>
                <c:pt idx="496">
                  <c:v>8.216373145479773</c:v>
                </c:pt>
                <c:pt idx="497">
                  <c:v>8.2329384139182409</c:v>
                </c:pt>
                <c:pt idx="498">
                  <c:v>8.2495036823567087</c:v>
                </c:pt>
                <c:pt idx="499">
                  <c:v>8.2660689507951748</c:v>
                </c:pt>
                <c:pt idx="500">
                  <c:v>8.2826342192336426</c:v>
                </c:pt>
                <c:pt idx="501">
                  <c:v>8.2991994876721105</c:v>
                </c:pt>
                <c:pt idx="502">
                  <c:v>8.3157647561105765</c:v>
                </c:pt>
                <c:pt idx="503">
                  <c:v>8.3323300245490444</c:v>
                </c:pt>
                <c:pt idx="504">
                  <c:v>8.3488952929875122</c:v>
                </c:pt>
                <c:pt idx="505">
                  <c:v>8.3654605614259783</c:v>
                </c:pt>
                <c:pt idx="506">
                  <c:v>8.3820258298644461</c:v>
                </c:pt>
                <c:pt idx="507">
                  <c:v>8.3985910983029139</c:v>
                </c:pt>
                <c:pt idx="508">
                  <c:v>8.41515636674138</c:v>
                </c:pt>
                <c:pt idx="509">
                  <c:v>8.4317216351798479</c:v>
                </c:pt>
                <c:pt idx="510">
                  <c:v>8.4482869036183157</c:v>
                </c:pt>
                <c:pt idx="511">
                  <c:v>8.4648521720567818</c:v>
                </c:pt>
                <c:pt idx="512">
                  <c:v>8.4814174404952496</c:v>
                </c:pt>
                <c:pt idx="513">
                  <c:v>8.4979827089337174</c:v>
                </c:pt>
                <c:pt idx="514">
                  <c:v>8.5145479773721853</c:v>
                </c:pt>
                <c:pt idx="515">
                  <c:v>8.5311132458106513</c:v>
                </c:pt>
                <c:pt idx="516">
                  <c:v>8.5476785142491192</c:v>
                </c:pt>
                <c:pt idx="517">
                  <c:v>8.564243782687587</c:v>
                </c:pt>
                <c:pt idx="518">
                  <c:v>8.5808090511260531</c:v>
                </c:pt>
                <c:pt idx="519">
                  <c:v>8.5973743195645209</c:v>
                </c:pt>
                <c:pt idx="520">
                  <c:v>8.6139395880029888</c:v>
                </c:pt>
                <c:pt idx="521">
                  <c:v>8.6305048564414548</c:v>
                </c:pt>
                <c:pt idx="522">
                  <c:v>8.6470701248799227</c:v>
                </c:pt>
                <c:pt idx="523">
                  <c:v>8.6636353933183905</c:v>
                </c:pt>
                <c:pt idx="524">
                  <c:v>8.6802006617568566</c:v>
                </c:pt>
                <c:pt idx="525">
                  <c:v>8.6967659301953244</c:v>
                </c:pt>
                <c:pt idx="526">
                  <c:v>8.7133311986337922</c:v>
                </c:pt>
                <c:pt idx="527">
                  <c:v>8.7298964670722583</c:v>
                </c:pt>
                <c:pt idx="528">
                  <c:v>8.7464617355107261</c:v>
                </c:pt>
                <c:pt idx="529">
                  <c:v>8.763027003949194</c:v>
                </c:pt>
                <c:pt idx="530">
                  <c:v>8.7795922723876618</c:v>
                </c:pt>
                <c:pt idx="531">
                  <c:v>8.7961575408261279</c:v>
                </c:pt>
                <c:pt idx="532">
                  <c:v>8.8127228092645957</c:v>
                </c:pt>
                <c:pt idx="533">
                  <c:v>8.8292880777030636</c:v>
                </c:pt>
                <c:pt idx="534">
                  <c:v>8.8458533461415296</c:v>
                </c:pt>
                <c:pt idx="535">
                  <c:v>8.8624186145799975</c:v>
                </c:pt>
                <c:pt idx="536">
                  <c:v>8.8789838830184653</c:v>
                </c:pt>
                <c:pt idx="537">
                  <c:v>8.8955491514569314</c:v>
                </c:pt>
                <c:pt idx="538">
                  <c:v>8.9121144198953992</c:v>
                </c:pt>
                <c:pt idx="539">
                  <c:v>8.928679688333867</c:v>
                </c:pt>
                <c:pt idx="540">
                  <c:v>8.9452449567723331</c:v>
                </c:pt>
                <c:pt idx="541">
                  <c:v>8.961810225210801</c:v>
                </c:pt>
                <c:pt idx="542">
                  <c:v>8.9783754936492688</c:v>
                </c:pt>
                <c:pt idx="543">
                  <c:v>8.9949407620877349</c:v>
                </c:pt>
                <c:pt idx="544">
                  <c:v>9.0115060305262027</c:v>
                </c:pt>
                <c:pt idx="545">
                  <c:v>9.0280712989646705</c:v>
                </c:pt>
                <c:pt idx="546">
                  <c:v>9.0446365674031384</c:v>
                </c:pt>
                <c:pt idx="547">
                  <c:v>9.0612018358416044</c:v>
                </c:pt>
                <c:pt idx="548">
                  <c:v>9.0777671042800723</c:v>
                </c:pt>
                <c:pt idx="549">
                  <c:v>9.0943323727185401</c:v>
                </c:pt>
                <c:pt idx="550">
                  <c:v>9.1108976411570062</c:v>
                </c:pt>
                <c:pt idx="551">
                  <c:v>9.127462909595474</c:v>
                </c:pt>
                <c:pt idx="552">
                  <c:v>9.1440281780339419</c:v>
                </c:pt>
                <c:pt idx="553">
                  <c:v>9.1605934464724079</c:v>
                </c:pt>
                <c:pt idx="554">
                  <c:v>9.1771587149108758</c:v>
                </c:pt>
                <c:pt idx="555">
                  <c:v>9.1937239833493436</c:v>
                </c:pt>
                <c:pt idx="556">
                  <c:v>9.2102892517878097</c:v>
                </c:pt>
                <c:pt idx="557">
                  <c:v>9.2268545202262775</c:v>
                </c:pt>
                <c:pt idx="558">
                  <c:v>9.2434197886647453</c:v>
                </c:pt>
                <c:pt idx="559">
                  <c:v>9.2599850571032114</c:v>
                </c:pt>
                <c:pt idx="560">
                  <c:v>9.2765503255416792</c:v>
                </c:pt>
                <c:pt idx="561">
                  <c:v>9.2931155939801471</c:v>
                </c:pt>
                <c:pt idx="562">
                  <c:v>9.3096808624186149</c:v>
                </c:pt>
                <c:pt idx="563">
                  <c:v>9.326246130857081</c:v>
                </c:pt>
                <c:pt idx="564">
                  <c:v>9.3428113992955488</c:v>
                </c:pt>
                <c:pt idx="565">
                  <c:v>9.3593766677340167</c:v>
                </c:pt>
                <c:pt idx="566">
                  <c:v>9.3759419361724827</c:v>
                </c:pt>
                <c:pt idx="567">
                  <c:v>9.3925072046109506</c:v>
                </c:pt>
                <c:pt idx="568">
                  <c:v>9.4090724730494184</c:v>
                </c:pt>
                <c:pt idx="569">
                  <c:v>9.4256377414878845</c:v>
                </c:pt>
                <c:pt idx="570">
                  <c:v>9.4422030099263523</c:v>
                </c:pt>
                <c:pt idx="571">
                  <c:v>9.4587682783648201</c:v>
                </c:pt>
                <c:pt idx="572">
                  <c:v>9.4753335468032862</c:v>
                </c:pt>
                <c:pt idx="573">
                  <c:v>9.4918988152417541</c:v>
                </c:pt>
                <c:pt idx="574">
                  <c:v>9.5084640836802219</c:v>
                </c:pt>
                <c:pt idx="575">
                  <c:v>9.525029352118688</c:v>
                </c:pt>
                <c:pt idx="576">
                  <c:v>9.5415946205571558</c:v>
                </c:pt>
                <c:pt idx="577">
                  <c:v>9.5581598889956236</c:v>
                </c:pt>
                <c:pt idx="578">
                  <c:v>9.5747251574340915</c:v>
                </c:pt>
                <c:pt idx="579">
                  <c:v>9.5912904258725575</c:v>
                </c:pt>
                <c:pt idx="580">
                  <c:v>9.6078556943110254</c:v>
                </c:pt>
                <c:pt idx="581">
                  <c:v>9.6244209627494932</c:v>
                </c:pt>
                <c:pt idx="582">
                  <c:v>9.6409862311879593</c:v>
                </c:pt>
                <c:pt idx="583">
                  <c:v>9.6575514996264271</c:v>
                </c:pt>
                <c:pt idx="584">
                  <c:v>9.674116768064895</c:v>
                </c:pt>
                <c:pt idx="585">
                  <c:v>9.690682036503361</c:v>
                </c:pt>
                <c:pt idx="586">
                  <c:v>9.7072473049418289</c:v>
                </c:pt>
                <c:pt idx="587">
                  <c:v>9.7238125733802967</c:v>
                </c:pt>
                <c:pt idx="588">
                  <c:v>9.7403778418187628</c:v>
                </c:pt>
                <c:pt idx="589">
                  <c:v>9.7569431102572306</c:v>
                </c:pt>
                <c:pt idx="590">
                  <c:v>9.7735083786956984</c:v>
                </c:pt>
                <c:pt idx="591">
                  <c:v>9.7900736471341645</c:v>
                </c:pt>
                <c:pt idx="592">
                  <c:v>9.8066389155726323</c:v>
                </c:pt>
                <c:pt idx="593">
                  <c:v>9.8232041840111002</c:v>
                </c:pt>
                <c:pt idx="594">
                  <c:v>9.839769452449568</c:v>
                </c:pt>
                <c:pt idx="595">
                  <c:v>9.8563347208880341</c:v>
                </c:pt>
                <c:pt idx="596">
                  <c:v>9.8728999893265019</c:v>
                </c:pt>
                <c:pt idx="597">
                  <c:v>9.8894652577649698</c:v>
                </c:pt>
                <c:pt idx="598">
                  <c:v>9.9060305262034358</c:v>
                </c:pt>
                <c:pt idx="599">
                  <c:v>9.9225957946419037</c:v>
                </c:pt>
                <c:pt idx="600">
                  <c:v>9.9391610630803715</c:v>
                </c:pt>
                <c:pt idx="601">
                  <c:v>9.9557263315188376</c:v>
                </c:pt>
                <c:pt idx="602">
                  <c:v>9.9722915999573054</c:v>
                </c:pt>
                <c:pt idx="603">
                  <c:v>9.9888568683957732</c:v>
                </c:pt>
                <c:pt idx="604">
                  <c:v>10.005422136834239</c:v>
                </c:pt>
                <c:pt idx="605">
                  <c:v>10.021987405272707</c:v>
                </c:pt>
                <c:pt idx="606">
                  <c:v>10.038552673711175</c:v>
                </c:pt>
                <c:pt idx="607">
                  <c:v>10.055117942149641</c:v>
                </c:pt>
                <c:pt idx="608">
                  <c:v>10.071683210588109</c:v>
                </c:pt>
                <c:pt idx="609">
                  <c:v>10.088248479026577</c:v>
                </c:pt>
                <c:pt idx="610">
                  <c:v>10.104813747465045</c:v>
                </c:pt>
                <c:pt idx="611">
                  <c:v>10.121379015903511</c:v>
                </c:pt>
                <c:pt idx="612">
                  <c:v>10.137944284341978</c:v>
                </c:pt>
                <c:pt idx="613">
                  <c:v>10.154509552780446</c:v>
                </c:pt>
                <c:pt idx="614">
                  <c:v>10.171074821218912</c:v>
                </c:pt>
                <c:pt idx="615">
                  <c:v>10.18764008965738</c:v>
                </c:pt>
                <c:pt idx="616">
                  <c:v>10.204205358095848</c:v>
                </c:pt>
                <c:pt idx="617">
                  <c:v>10.220770626534314</c:v>
                </c:pt>
                <c:pt idx="618">
                  <c:v>10.237335894972782</c:v>
                </c:pt>
                <c:pt idx="619">
                  <c:v>10.25390116341125</c:v>
                </c:pt>
                <c:pt idx="620">
                  <c:v>10.270466431849716</c:v>
                </c:pt>
                <c:pt idx="621">
                  <c:v>10.287031700288184</c:v>
                </c:pt>
                <c:pt idx="622">
                  <c:v>10.303596968726652</c:v>
                </c:pt>
                <c:pt idx="623">
                  <c:v>10.320162237165118</c:v>
                </c:pt>
                <c:pt idx="624">
                  <c:v>10.336727505603585</c:v>
                </c:pt>
                <c:pt idx="625">
                  <c:v>10.353292774042053</c:v>
                </c:pt>
                <c:pt idx="626">
                  <c:v>10.369858042480521</c:v>
                </c:pt>
                <c:pt idx="627">
                  <c:v>10.386423310918987</c:v>
                </c:pt>
                <c:pt idx="628">
                  <c:v>10.402988579357455</c:v>
                </c:pt>
                <c:pt idx="629">
                  <c:v>10.419553847795923</c:v>
                </c:pt>
                <c:pt idx="630">
                  <c:v>10.436119116234389</c:v>
                </c:pt>
                <c:pt idx="631">
                  <c:v>10.452684384672857</c:v>
                </c:pt>
                <c:pt idx="632">
                  <c:v>10.469249653111325</c:v>
                </c:pt>
                <c:pt idx="633">
                  <c:v>10.485814921549791</c:v>
                </c:pt>
                <c:pt idx="634">
                  <c:v>10.502380189988259</c:v>
                </c:pt>
                <c:pt idx="635">
                  <c:v>10.518945458426726</c:v>
                </c:pt>
                <c:pt idx="636">
                  <c:v>10.535510726865192</c:v>
                </c:pt>
                <c:pt idx="637">
                  <c:v>10.55207599530366</c:v>
                </c:pt>
                <c:pt idx="638">
                  <c:v>10.568641263742128</c:v>
                </c:pt>
                <c:pt idx="639">
                  <c:v>10.585206532180596</c:v>
                </c:pt>
                <c:pt idx="640">
                  <c:v>10.601771800619062</c:v>
                </c:pt>
                <c:pt idx="641">
                  <c:v>10.61833706905753</c:v>
                </c:pt>
                <c:pt idx="642">
                  <c:v>10.634902337495998</c:v>
                </c:pt>
                <c:pt idx="643">
                  <c:v>10.651467605934464</c:v>
                </c:pt>
                <c:pt idx="644">
                  <c:v>10.668032874372932</c:v>
                </c:pt>
                <c:pt idx="645">
                  <c:v>10.684598142811399</c:v>
                </c:pt>
                <c:pt idx="646">
                  <c:v>10.701163411249865</c:v>
                </c:pt>
                <c:pt idx="647">
                  <c:v>10.717728679688333</c:v>
                </c:pt>
                <c:pt idx="648">
                  <c:v>10.734293948126801</c:v>
                </c:pt>
                <c:pt idx="649">
                  <c:v>10.750859216565267</c:v>
                </c:pt>
                <c:pt idx="650">
                  <c:v>10.767424485003735</c:v>
                </c:pt>
                <c:pt idx="651">
                  <c:v>10.783989753442203</c:v>
                </c:pt>
                <c:pt idx="652">
                  <c:v>10.800555021880669</c:v>
                </c:pt>
                <c:pt idx="653">
                  <c:v>10.817120290319137</c:v>
                </c:pt>
                <c:pt idx="654">
                  <c:v>10.833685558757605</c:v>
                </c:pt>
                <c:pt idx="655">
                  <c:v>10.850250827196072</c:v>
                </c:pt>
                <c:pt idx="656">
                  <c:v>10.866816095634539</c:v>
                </c:pt>
                <c:pt idx="657">
                  <c:v>10.883381364073006</c:v>
                </c:pt>
                <c:pt idx="658">
                  <c:v>10.899946632511474</c:v>
                </c:pt>
                <c:pt idx="659">
                  <c:v>10.91651190094994</c:v>
                </c:pt>
                <c:pt idx="660">
                  <c:v>10.933077169388408</c:v>
                </c:pt>
                <c:pt idx="661">
                  <c:v>10.949642437826876</c:v>
                </c:pt>
                <c:pt idx="662">
                  <c:v>10.966207706265342</c:v>
                </c:pt>
                <c:pt idx="663">
                  <c:v>10.98277297470381</c:v>
                </c:pt>
                <c:pt idx="664">
                  <c:v>10.999338243142278</c:v>
                </c:pt>
                <c:pt idx="665">
                  <c:v>11.015903511580744</c:v>
                </c:pt>
                <c:pt idx="666">
                  <c:v>11.032468780019212</c:v>
                </c:pt>
                <c:pt idx="667">
                  <c:v>11.049034048457679</c:v>
                </c:pt>
                <c:pt idx="668">
                  <c:v>11.065599316896146</c:v>
                </c:pt>
                <c:pt idx="669">
                  <c:v>11.082164585334613</c:v>
                </c:pt>
                <c:pt idx="670">
                  <c:v>11.098729853773081</c:v>
                </c:pt>
                <c:pt idx="671">
                  <c:v>11.115295122211549</c:v>
                </c:pt>
                <c:pt idx="672">
                  <c:v>11.131860390650015</c:v>
                </c:pt>
                <c:pt idx="673">
                  <c:v>11.148425659088483</c:v>
                </c:pt>
                <c:pt idx="674">
                  <c:v>11.164990927526951</c:v>
                </c:pt>
                <c:pt idx="675">
                  <c:v>11.181556195965417</c:v>
                </c:pt>
                <c:pt idx="676">
                  <c:v>11.198121464403885</c:v>
                </c:pt>
                <c:pt idx="677">
                  <c:v>11.214686732842353</c:v>
                </c:pt>
                <c:pt idx="678">
                  <c:v>11.231252001280819</c:v>
                </c:pt>
                <c:pt idx="679">
                  <c:v>11.247817269719286</c:v>
                </c:pt>
                <c:pt idx="680">
                  <c:v>11.264382538157754</c:v>
                </c:pt>
                <c:pt idx="681">
                  <c:v>11.28094780659622</c:v>
                </c:pt>
                <c:pt idx="682">
                  <c:v>11.297513075034688</c:v>
                </c:pt>
                <c:pt idx="683">
                  <c:v>11.314078343473156</c:v>
                </c:pt>
                <c:pt idx="684">
                  <c:v>11.330643611911622</c:v>
                </c:pt>
                <c:pt idx="685">
                  <c:v>11.34720888035009</c:v>
                </c:pt>
                <c:pt idx="686">
                  <c:v>11.363774148788558</c:v>
                </c:pt>
                <c:pt idx="687">
                  <c:v>11.380339417227026</c:v>
                </c:pt>
                <c:pt idx="688">
                  <c:v>11.396904685665492</c:v>
                </c:pt>
                <c:pt idx="689">
                  <c:v>11.413469954103959</c:v>
                </c:pt>
                <c:pt idx="690">
                  <c:v>11.430035222542427</c:v>
                </c:pt>
                <c:pt idx="691">
                  <c:v>11.446600490980893</c:v>
                </c:pt>
                <c:pt idx="692">
                  <c:v>11.463165759419361</c:v>
                </c:pt>
                <c:pt idx="693">
                  <c:v>11.479731027857829</c:v>
                </c:pt>
                <c:pt idx="694">
                  <c:v>11.496296296296295</c:v>
                </c:pt>
                <c:pt idx="695">
                  <c:v>11.512861564734763</c:v>
                </c:pt>
                <c:pt idx="696">
                  <c:v>11.529426833173231</c:v>
                </c:pt>
                <c:pt idx="697">
                  <c:v>11.545992101611697</c:v>
                </c:pt>
                <c:pt idx="698">
                  <c:v>11.562557370050165</c:v>
                </c:pt>
                <c:pt idx="699">
                  <c:v>11.579122638488633</c:v>
                </c:pt>
                <c:pt idx="700">
                  <c:v>11.595687906927099</c:v>
                </c:pt>
                <c:pt idx="701">
                  <c:v>11.612253175365566</c:v>
                </c:pt>
                <c:pt idx="702">
                  <c:v>11.628818443804034</c:v>
                </c:pt>
                <c:pt idx="703">
                  <c:v>11.645383712242502</c:v>
                </c:pt>
                <c:pt idx="704">
                  <c:v>11.661948980680968</c:v>
                </c:pt>
                <c:pt idx="705">
                  <c:v>11.678514249119436</c:v>
                </c:pt>
                <c:pt idx="706">
                  <c:v>11.695079517557904</c:v>
                </c:pt>
                <c:pt idx="707">
                  <c:v>11.71164478599637</c:v>
                </c:pt>
                <c:pt idx="708">
                  <c:v>11.728210054434838</c:v>
                </c:pt>
                <c:pt idx="709">
                  <c:v>11.744775322873306</c:v>
                </c:pt>
                <c:pt idx="710">
                  <c:v>11.761340591311772</c:v>
                </c:pt>
                <c:pt idx="711">
                  <c:v>11.77790585975024</c:v>
                </c:pt>
                <c:pt idx="712">
                  <c:v>11.794471128188707</c:v>
                </c:pt>
                <c:pt idx="713">
                  <c:v>11.811036396627173</c:v>
                </c:pt>
                <c:pt idx="714">
                  <c:v>11.827601665065641</c:v>
                </c:pt>
                <c:pt idx="715">
                  <c:v>11.844166933504109</c:v>
                </c:pt>
                <c:pt idx="716">
                  <c:v>11.860732201942575</c:v>
                </c:pt>
                <c:pt idx="717">
                  <c:v>11.877297470381043</c:v>
                </c:pt>
                <c:pt idx="718">
                  <c:v>11.893862738819511</c:v>
                </c:pt>
                <c:pt idx="719">
                  <c:v>11.910428007257979</c:v>
                </c:pt>
                <c:pt idx="720">
                  <c:v>11.926993275696445</c:v>
                </c:pt>
                <c:pt idx="721">
                  <c:v>11.943558544134913</c:v>
                </c:pt>
                <c:pt idx="722">
                  <c:v>11.96012381257338</c:v>
                </c:pt>
                <c:pt idx="723">
                  <c:v>11.976689081011846</c:v>
                </c:pt>
                <c:pt idx="724">
                  <c:v>11.993254349450314</c:v>
                </c:pt>
                <c:pt idx="725">
                  <c:v>12.009819617888782</c:v>
                </c:pt>
                <c:pt idx="726">
                  <c:v>12.026384886327248</c:v>
                </c:pt>
                <c:pt idx="727">
                  <c:v>12.042950154765716</c:v>
                </c:pt>
                <c:pt idx="728">
                  <c:v>12.059515423204184</c:v>
                </c:pt>
                <c:pt idx="729">
                  <c:v>12.07608069164265</c:v>
                </c:pt>
                <c:pt idx="730">
                  <c:v>12.092645960081118</c:v>
                </c:pt>
                <c:pt idx="731">
                  <c:v>12.109211228519586</c:v>
                </c:pt>
                <c:pt idx="732">
                  <c:v>12.125776496958052</c:v>
                </c:pt>
                <c:pt idx="733">
                  <c:v>12.14234176539652</c:v>
                </c:pt>
                <c:pt idx="734">
                  <c:v>12.158907033834987</c:v>
                </c:pt>
                <c:pt idx="735">
                  <c:v>12.175472302273455</c:v>
                </c:pt>
                <c:pt idx="736">
                  <c:v>12.192037570711921</c:v>
                </c:pt>
                <c:pt idx="737">
                  <c:v>12.208602839150389</c:v>
                </c:pt>
                <c:pt idx="738">
                  <c:v>12.225168107588857</c:v>
                </c:pt>
                <c:pt idx="739">
                  <c:v>12.241733376027323</c:v>
                </c:pt>
                <c:pt idx="740">
                  <c:v>12.258298644465791</c:v>
                </c:pt>
                <c:pt idx="741">
                  <c:v>12.274863912904259</c:v>
                </c:pt>
                <c:pt idx="742">
                  <c:v>12.291429181342725</c:v>
                </c:pt>
                <c:pt idx="743">
                  <c:v>12.307994449781193</c:v>
                </c:pt>
                <c:pt idx="744">
                  <c:v>12.32455971821966</c:v>
                </c:pt>
                <c:pt idx="745">
                  <c:v>12.341124986658127</c:v>
                </c:pt>
                <c:pt idx="746">
                  <c:v>12.357690255096594</c:v>
                </c:pt>
                <c:pt idx="747">
                  <c:v>12.374255523535062</c:v>
                </c:pt>
                <c:pt idx="748">
                  <c:v>12.390820791973528</c:v>
                </c:pt>
                <c:pt idx="749">
                  <c:v>12.407386060411996</c:v>
                </c:pt>
                <c:pt idx="750">
                  <c:v>12.423951328850464</c:v>
                </c:pt>
                <c:pt idx="751">
                  <c:v>12.440516597288932</c:v>
                </c:pt>
                <c:pt idx="752">
                  <c:v>12.457081865727398</c:v>
                </c:pt>
                <c:pt idx="753">
                  <c:v>12.473647134165866</c:v>
                </c:pt>
                <c:pt idx="754">
                  <c:v>12.490212402604334</c:v>
                </c:pt>
                <c:pt idx="755">
                  <c:v>12.5067776710428</c:v>
                </c:pt>
                <c:pt idx="756">
                  <c:v>12.523342939481267</c:v>
                </c:pt>
                <c:pt idx="757">
                  <c:v>12.539908207919735</c:v>
                </c:pt>
                <c:pt idx="758">
                  <c:v>12.556473476358201</c:v>
                </c:pt>
                <c:pt idx="759">
                  <c:v>12.573038744796669</c:v>
                </c:pt>
                <c:pt idx="760">
                  <c:v>12.589604013235137</c:v>
                </c:pt>
                <c:pt idx="761">
                  <c:v>12.606169281673603</c:v>
                </c:pt>
                <c:pt idx="762">
                  <c:v>12.622734550112071</c:v>
                </c:pt>
                <c:pt idx="763">
                  <c:v>12.639299818550539</c:v>
                </c:pt>
                <c:pt idx="764">
                  <c:v>12.655865086989005</c:v>
                </c:pt>
                <c:pt idx="765">
                  <c:v>12.672430355427473</c:v>
                </c:pt>
                <c:pt idx="766">
                  <c:v>12.68899562386594</c:v>
                </c:pt>
                <c:pt idx="767">
                  <c:v>12.705560892304408</c:v>
                </c:pt>
                <c:pt idx="768">
                  <c:v>12.722126160742874</c:v>
                </c:pt>
                <c:pt idx="769">
                  <c:v>12.738691429181342</c:v>
                </c:pt>
                <c:pt idx="770">
                  <c:v>12.75525669761981</c:v>
                </c:pt>
                <c:pt idx="771">
                  <c:v>12.771821966058276</c:v>
                </c:pt>
                <c:pt idx="772">
                  <c:v>12.788387234496744</c:v>
                </c:pt>
                <c:pt idx="773">
                  <c:v>12.804952502935212</c:v>
                </c:pt>
                <c:pt idx="774">
                  <c:v>12.821517771373678</c:v>
                </c:pt>
                <c:pt idx="775">
                  <c:v>12.838083039812146</c:v>
                </c:pt>
                <c:pt idx="776">
                  <c:v>12.854648308250614</c:v>
                </c:pt>
                <c:pt idx="777">
                  <c:v>12.87121357668908</c:v>
                </c:pt>
                <c:pt idx="778">
                  <c:v>12.887778845127547</c:v>
                </c:pt>
                <c:pt idx="779">
                  <c:v>12.904344113566015</c:v>
                </c:pt>
                <c:pt idx="780">
                  <c:v>12.920909382004481</c:v>
                </c:pt>
                <c:pt idx="781">
                  <c:v>12.937474650442949</c:v>
                </c:pt>
                <c:pt idx="782">
                  <c:v>12.954039918881417</c:v>
                </c:pt>
                <c:pt idx="783">
                  <c:v>12.970605187319885</c:v>
                </c:pt>
                <c:pt idx="784">
                  <c:v>12.987170455758351</c:v>
                </c:pt>
                <c:pt idx="785">
                  <c:v>13.003735724196819</c:v>
                </c:pt>
                <c:pt idx="786">
                  <c:v>13.020300992635287</c:v>
                </c:pt>
                <c:pt idx="787">
                  <c:v>13.036866261073753</c:v>
                </c:pt>
                <c:pt idx="788">
                  <c:v>13.053431529512221</c:v>
                </c:pt>
                <c:pt idx="789">
                  <c:v>13.069996797950688</c:v>
                </c:pt>
                <c:pt idx="790">
                  <c:v>13.086562066389154</c:v>
                </c:pt>
                <c:pt idx="791">
                  <c:v>13.103127334827622</c:v>
                </c:pt>
                <c:pt idx="792">
                  <c:v>13.11969260326609</c:v>
                </c:pt>
                <c:pt idx="793">
                  <c:v>13.136257871704556</c:v>
                </c:pt>
                <c:pt idx="794">
                  <c:v>13.152823140143024</c:v>
                </c:pt>
                <c:pt idx="795">
                  <c:v>13.169388408581492</c:v>
                </c:pt>
                <c:pt idx="796">
                  <c:v>13.185953677019958</c:v>
                </c:pt>
                <c:pt idx="797">
                  <c:v>13.202518945458426</c:v>
                </c:pt>
                <c:pt idx="798">
                  <c:v>13.219084213896894</c:v>
                </c:pt>
                <c:pt idx="799">
                  <c:v>13.235649482335361</c:v>
                </c:pt>
                <c:pt idx="800">
                  <c:v>13.252214750773827</c:v>
                </c:pt>
                <c:pt idx="801">
                  <c:v>13.268780019212295</c:v>
                </c:pt>
                <c:pt idx="802">
                  <c:v>13.285345287650763</c:v>
                </c:pt>
                <c:pt idx="803">
                  <c:v>13.301910556089229</c:v>
                </c:pt>
                <c:pt idx="804">
                  <c:v>13.318475824527697</c:v>
                </c:pt>
                <c:pt idx="805">
                  <c:v>13.335041092966165</c:v>
                </c:pt>
                <c:pt idx="806">
                  <c:v>13.351606361404631</c:v>
                </c:pt>
                <c:pt idx="807">
                  <c:v>13.368171629843099</c:v>
                </c:pt>
                <c:pt idx="808">
                  <c:v>13.384736898281567</c:v>
                </c:pt>
                <c:pt idx="809">
                  <c:v>13.401302166720033</c:v>
                </c:pt>
                <c:pt idx="810">
                  <c:v>13.417867435158501</c:v>
                </c:pt>
                <c:pt idx="811">
                  <c:v>13.434432703596968</c:v>
                </c:pt>
                <c:pt idx="812">
                  <c:v>13.450997972035434</c:v>
                </c:pt>
                <c:pt idx="813">
                  <c:v>13.467563240473902</c:v>
                </c:pt>
                <c:pt idx="814">
                  <c:v>13.48412850891237</c:v>
                </c:pt>
                <c:pt idx="815">
                  <c:v>13.500693777350838</c:v>
                </c:pt>
                <c:pt idx="816">
                  <c:v>13.517259045789304</c:v>
                </c:pt>
                <c:pt idx="817">
                  <c:v>13.533824314227772</c:v>
                </c:pt>
                <c:pt idx="818">
                  <c:v>13.55038958266624</c:v>
                </c:pt>
                <c:pt idx="819">
                  <c:v>13.566954851104706</c:v>
                </c:pt>
                <c:pt idx="820">
                  <c:v>13.583520119543174</c:v>
                </c:pt>
                <c:pt idx="821">
                  <c:v>13.600085387981641</c:v>
                </c:pt>
                <c:pt idx="822">
                  <c:v>13.616650656420108</c:v>
                </c:pt>
                <c:pt idx="823">
                  <c:v>13.633215924858575</c:v>
                </c:pt>
                <c:pt idx="824">
                  <c:v>13.649781193297043</c:v>
                </c:pt>
                <c:pt idx="825">
                  <c:v>13.666346461735509</c:v>
                </c:pt>
                <c:pt idx="826">
                  <c:v>13.682911730173977</c:v>
                </c:pt>
                <c:pt idx="827">
                  <c:v>13.699476998612445</c:v>
                </c:pt>
                <c:pt idx="828">
                  <c:v>13.716042267050911</c:v>
                </c:pt>
                <c:pt idx="829">
                  <c:v>13.732607535489379</c:v>
                </c:pt>
                <c:pt idx="830">
                  <c:v>13.749172803927847</c:v>
                </c:pt>
                <c:pt idx="831">
                  <c:v>13.765738072366315</c:v>
                </c:pt>
                <c:pt idx="832">
                  <c:v>13.782303340804781</c:v>
                </c:pt>
                <c:pt idx="833">
                  <c:v>13.798868609243248</c:v>
                </c:pt>
                <c:pt idx="834">
                  <c:v>13.815433877681716</c:v>
                </c:pt>
                <c:pt idx="835">
                  <c:v>13.831999146120182</c:v>
                </c:pt>
                <c:pt idx="836">
                  <c:v>13.84856441455865</c:v>
                </c:pt>
                <c:pt idx="837">
                  <c:v>13.865129682997118</c:v>
                </c:pt>
                <c:pt idx="838">
                  <c:v>13.881694951435584</c:v>
                </c:pt>
                <c:pt idx="839">
                  <c:v>13.898260219874052</c:v>
                </c:pt>
                <c:pt idx="840">
                  <c:v>13.91482548831252</c:v>
                </c:pt>
                <c:pt idx="841">
                  <c:v>13.931390756750986</c:v>
                </c:pt>
                <c:pt idx="842">
                  <c:v>13.947956025189454</c:v>
                </c:pt>
                <c:pt idx="843">
                  <c:v>13.964521293627921</c:v>
                </c:pt>
                <c:pt idx="844">
                  <c:v>13.981086562066389</c:v>
                </c:pt>
                <c:pt idx="845">
                  <c:v>13.997651830504855</c:v>
                </c:pt>
                <c:pt idx="846">
                  <c:v>14.014217098943323</c:v>
                </c:pt>
                <c:pt idx="847">
                  <c:v>14.030782367381791</c:v>
                </c:pt>
                <c:pt idx="848">
                  <c:v>14.047347635820257</c:v>
                </c:pt>
                <c:pt idx="849">
                  <c:v>14.063912904258725</c:v>
                </c:pt>
                <c:pt idx="850">
                  <c:v>14.080478172697193</c:v>
                </c:pt>
                <c:pt idx="851">
                  <c:v>14.097043441135659</c:v>
                </c:pt>
                <c:pt idx="852">
                  <c:v>14.113608709574127</c:v>
                </c:pt>
                <c:pt idx="853">
                  <c:v>14.130173978012595</c:v>
                </c:pt>
                <c:pt idx="854">
                  <c:v>14.146739246451061</c:v>
                </c:pt>
                <c:pt idx="855">
                  <c:v>14.163304514889528</c:v>
                </c:pt>
                <c:pt idx="856">
                  <c:v>14.179869783327996</c:v>
                </c:pt>
                <c:pt idx="857">
                  <c:v>14.196435051766462</c:v>
                </c:pt>
                <c:pt idx="858">
                  <c:v>14.21300032020493</c:v>
                </c:pt>
                <c:pt idx="859">
                  <c:v>14.229565588643398</c:v>
                </c:pt>
                <c:pt idx="860">
                  <c:v>14.246130857081866</c:v>
                </c:pt>
                <c:pt idx="861">
                  <c:v>14.262696125520332</c:v>
                </c:pt>
                <c:pt idx="862">
                  <c:v>14.2792613939588</c:v>
                </c:pt>
                <c:pt idx="863">
                  <c:v>14.295826662397268</c:v>
                </c:pt>
                <c:pt idx="864">
                  <c:v>14.312391930835734</c:v>
                </c:pt>
                <c:pt idx="865">
                  <c:v>14.328957199274202</c:v>
                </c:pt>
                <c:pt idx="866">
                  <c:v>14.345522467712669</c:v>
                </c:pt>
                <c:pt idx="867">
                  <c:v>14.362087736151135</c:v>
                </c:pt>
                <c:pt idx="868">
                  <c:v>14.378653004589603</c:v>
                </c:pt>
                <c:pt idx="869">
                  <c:v>14.395218273028071</c:v>
                </c:pt>
                <c:pt idx="870">
                  <c:v>14.411783541466537</c:v>
                </c:pt>
                <c:pt idx="871">
                  <c:v>14.428348809905005</c:v>
                </c:pt>
                <c:pt idx="872">
                  <c:v>14.444914078343473</c:v>
                </c:pt>
                <c:pt idx="873">
                  <c:v>14.461479346781939</c:v>
                </c:pt>
                <c:pt idx="874">
                  <c:v>14.478044615220407</c:v>
                </c:pt>
                <c:pt idx="875">
                  <c:v>14.494609883658875</c:v>
                </c:pt>
                <c:pt idx="876">
                  <c:v>14.511175152097342</c:v>
                </c:pt>
                <c:pt idx="877">
                  <c:v>14.527740420535808</c:v>
                </c:pt>
                <c:pt idx="878">
                  <c:v>14.544305688974276</c:v>
                </c:pt>
                <c:pt idx="879">
                  <c:v>14.560870957412744</c:v>
                </c:pt>
                <c:pt idx="880">
                  <c:v>14.57743622585121</c:v>
                </c:pt>
                <c:pt idx="881">
                  <c:v>14.594001494289678</c:v>
                </c:pt>
                <c:pt idx="882">
                  <c:v>14.610566762728146</c:v>
                </c:pt>
                <c:pt idx="883">
                  <c:v>14.627132031166612</c:v>
                </c:pt>
                <c:pt idx="884">
                  <c:v>14.64369729960508</c:v>
                </c:pt>
                <c:pt idx="885">
                  <c:v>14.660262568043548</c:v>
                </c:pt>
                <c:pt idx="886">
                  <c:v>14.676827836482014</c:v>
                </c:pt>
                <c:pt idx="887">
                  <c:v>14.693393104920482</c:v>
                </c:pt>
                <c:pt idx="888">
                  <c:v>14.709958373358949</c:v>
                </c:pt>
                <c:pt idx="889">
                  <c:v>14.726523641797415</c:v>
                </c:pt>
                <c:pt idx="890">
                  <c:v>14.743088910235883</c:v>
                </c:pt>
                <c:pt idx="891">
                  <c:v>14.759654178674351</c:v>
                </c:pt>
                <c:pt idx="892">
                  <c:v>14.776219447112819</c:v>
                </c:pt>
                <c:pt idx="893">
                  <c:v>14.792784715551285</c:v>
                </c:pt>
                <c:pt idx="894">
                  <c:v>14.809349983989753</c:v>
                </c:pt>
                <c:pt idx="895">
                  <c:v>14.825915252428221</c:v>
                </c:pt>
                <c:pt idx="896">
                  <c:v>14.842480520866687</c:v>
                </c:pt>
                <c:pt idx="897">
                  <c:v>14.859045789305155</c:v>
                </c:pt>
                <c:pt idx="898">
                  <c:v>14.875611057743622</c:v>
                </c:pt>
                <c:pt idx="899">
                  <c:v>14.892176326182089</c:v>
                </c:pt>
                <c:pt idx="900">
                  <c:v>14.908741594620556</c:v>
                </c:pt>
                <c:pt idx="901">
                  <c:v>14.925306863059024</c:v>
                </c:pt>
                <c:pt idx="902">
                  <c:v>14.94187213149749</c:v>
                </c:pt>
                <c:pt idx="903">
                  <c:v>14.958437399935958</c:v>
                </c:pt>
                <c:pt idx="904">
                  <c:v>14.975002668374426</c:v>
                </c:pt>
                <c:pt idx="905">
                  <c:v>14.991567936812892</c:v>
                </c:pt>
                <c:pt idx="906">
                  <c:v>15.00813320525136</c:v>
                </c:pt>
                <c:pt idx="907">
                  <c:v>15.024698473689828</c:v>
                </c:pt>
                <c:pt idx="908">
                  <c:v>15.041263742128296</c:v>
                </c:pt>
                <c:pt idx="909">
                  <c:v>15.057829010566762</c:v>
                </c:pt>
                <c:pt idx="910">
                  <c:v>15.074394279005229</c:v>
                </c:pt>
                <c:pt idx="911">
                  <c:v>15.090959547443697</c:v>
                </c:pt>
                <c:pt idx="912">
                  <c:v>15.107524815882163</c:v>
                </c:pt>
                <c:pt idx="913">
                  <c:v>15.124090084320631</c:v>
                </c:pt>
                <c:pt idx="914">
                  <c:v>15.140655352759099</c:v>
                </c:pt>
                <c:pt idx="915">
                  <c:v>15.157220621197565</c:v>
                </c:pt>
                <c:pt idx="916">
                  <c:v>15.173785889636033</c:v>
                </c:pt>
                <c:pt idx="917">
                  <c:v>15.190351158074501</c:v>
                </c:pt>
                <c:pt idx="918">
                  <c:v>15.206916426512967</c:v>
                </c:pt>
                <c:pt idx="919">
                  <c:v>15.223481694951435</c:v>
                </c:pt>
                <c:pt idx="920">
                  <c:v>15.240046963389903</c:v>
                </c:pt>
                <c:pt idx="921">
                  <c:v>15.256612231828369</c:v>
                </c:pt>
                <c:pt idx="922">
                  <c:v>15.273177500266836</c:v>
                </c:pt>
                <c:pt idx="923">
                  <c:v>15.289742768705304</c:v>
                </c:pt>
                <c:pt idx="924">
                  <c:v>15.306308037143772</c:v>
                </c:pt>
                <c:pt idx="925">
                  <c:v>15.322873305582238</c:v>
                </c:pt>
                <c:pt idx="926">
                  <c:v>15.339438574020706</c:v>
                </c:pt>
                <c:pt idx="927">
                  <c:v>15.356003842459174</c:v>
                </c:pt>
                <c:pt idx="928">
                  <c:v>15.37256911089764</c:v>
                </c:pt>
                <c:pt idx="929">
                  <c:v>15.389134379336108</c:v>
                </c:pt>
                <c:pt idx="930">
                  <c:v>15.405699647774576</c:v>
                </c:pt>
                <c:pt idx="931">
                  <c:v>15.422264916213042</c:v>
                </c:pt>
                <c:pt idx="932">
                  <c:v>15.438830184651509</c:v>
                </c:pt>
                <c:pt idx="933">
                  <c:v>15.455395453089977</c:v>
                </c:pt>
                <c:pt idx="934">
                  <c:v>15.471960721528443</c:v>
                </c:pt>
                <c:pt idx="935">
                  <c:v>15.488525989966911</c:v>
                </c:pt>
                <c:pt idx="936">
                  <c:v>15.528266008839552</c:v>
                </c:pt>
                <c:pt idx="937">
                  <c:v>15.561517113783534</c:v>
                </c:pt>
                <c:pt idx="938">
                  <c:v>15.594768218727515</c:v>
                </c:pt>
                <c:pt idx="939">
                  <c:v>15.628019323671497</c:v>
                </c:pt>
                <c:pt idx="940">
                  <c:v>15.661270428615479</c:v>
                </c:pt>
                <c:pt idx="941">
                  <c:v>15.694521533559461</c:v>
                </c:pt>
                <c:pt idx="942">
                  <c:v>15.727772638503442</c:v>
                </c:pt>
                <c:pt idx="943">
                  <c:v>15.761023743447424</c:v>
                </c:pt>
                <c:pt idx="944">
                  <c:v>15.794274848391407</c:v>
                </c:pt>
                <c:pt idx="945">
                  <c:v>15.827525953335389</c:v>
                </c:pt>
                <c:pt idx="946">
                  <c:v>15.860777058279371</c:v>
                </c:pt>
                <c:pt idx="947">
                  <c:v>15.894028163223352</c:v>
                </c:pt>
                <c:pt idx="948">
                  <c:v>15.927279268167334</c:v>
                </c:pt>
                <c:pt idx="949">
                  <c:v>15.960530373111316</c:v>
                </c:pt>
                <c:pt idx="950">
                  <c:v>15.993781478055299</c:v>
                </c:pt>
                <c:pt idx="951">
                  <c:v>16.027032582999279</c:v>
                </c:pt>
                <c:pt idx="952">
                  <c:v>16.060283687943262</c:v>
                </c:pt>
                <c:pt idx="953">
                  <c:v>16.093534792887244</c:v>
                </c:pt>
                <c:pt idx="954">
                  <c:v>16.126785897831226</c:v>
                </c:pt>
                <c:pt idx="955">
                  <c:v>16.160037002775208</c:v>
                </c:pt>
                <c:pt idx="956">
                  <c:v>16.193288107719191</c:v>
                </c:pt>
                <c:pt idx="957">
                  <c:v>16.226539212663173</c:v>
                </c:pt>
                <c:pt idx="958">
                  <c:v>16.259790317607152</c:v>
                </c:pt>
                <c:pt idx="959">
                  <c:v>16.293041422551134</c:v>
                </c:pt>
                <c:pt idx="960">
                  <c:v>16.326292527495117</c:v>
                </c:pt>
                <c:pt idx="961">
                  <c:v>16.359543632439099</c:v>
                </c:pt>
                <c:pt idx="962">
                  <c:v>16.392794737383081</c:v>
                </c:pt>
                <c:pt idx="963">
                  <c:v>16.426045842327063</c:v>
                </c:pt>
                <c:pt idx="964">
                  <c:v>16.459296947271046</c:v>
                </c:pt>
                <c:pt idx="965">
                  <c:v>16.492548052215028</c:v>
                </c:pt>
                <c:pt idx="966">
                  <c:v>16.52579915715901</c:v>
                </c:pt>
                <c:pt idx="967">
                  <c:v>16.559050262102989</c:v>
                </c:pt>
                <c:pt idx="968">
                  <c:v>16.592301367046971</c:v>
                </c:pt>
                <c:pt idx="969">
                  <c:v>16.625552471990954</c:v>
                </c:pt>
                <c:pt idx="970">
                  <c:v>16.658803576934936</c:v>
                </c:pt>
                <c:pt idx="971">
                  <c:v>16.692054681878918</c:v>
                </c:pt>
                <c:pt idx="972">
                  <c:v>16.725305786822901</c:v>
                </c:pt>
                <c:pt idx="973">
                  <c:v>16.758556891766883</c:v>
                </c:pt>
                <c:pt idx="974">
                  <c:v>16.791807996710865</c:v>
                </c:pt>
                <c:pt idx="975">
                  <c:v>16.825059101654844</c:v>
                </c:pt>
                <c:pt idx="976">
                  <c:v>16.858310206598826</c:v>
                </c:pt>
                <c:pt idx="977">
                  <c:v>16.891561311542809</c:v>
                </c:pt>
                <c:pt idx="978">
                  <c:v>16.924812416486791</c:v>
                </c:pt>
                <c:pt idx="979">
                  <c:v>16.958063521430773</c:v>
                </c:pt>
                <c:pt idx="980">
                  <c:v>16.991314626374756</c:v>
                </c:pt>
                <c:pt idx="981">
                  <c:v>17.024565731318738</c:v>
                </c:pt>
                <c:pt idx="982">
                  <c:v>17.05781683626272</c:v>
                </c:pt>
                <c:pt idx="983">
                  <c:v>17.091067941206703</c:v>
                </c:pt>
                <c:pt idx="984">
                  <c:v>17.124319046150681</c:v>
                </c:pt>
                <c:pt idx="985">
                  <c:v>17.157570151094664</c:v>
                </c:pt>
                <c:pt idx="986">
                  <c:v>17.190821256038646</c:v>
                </c:pt>
                <c:pt idx="987">
                  <c:v>17.224072360982628</c:v>
                </c:pt>
                <c:pt idx="988">
                  <c:v>17.257323465926611</c:v>
                </c:pt>
                <c:pt idx="989">
                  <c:v>17.290574570870593</c:v>
                </c:pt>
                <c:pt idx="990">
                  <c:v>17.323825675814575</c:v>
                </c:pt>
                <c:pt idx="991">
                  <c:v>17.357076780758558</c:v>
                </c:pt>
                <c:pt idx="992">
                  <c:v>17.39032788570254</c:v>
                </c:pt>
                <c:pt idx="993">
                  <c:v>17.423578990646519</c:v>
                </c:pt>
                <c:pt idx="994">
                  <c:v>17.456830095590501</c:v>
                </c:pt>
                <c:pt idx="995">
                  <c:v>17.490081200534483</c:v>
                </c:pt>
                <c:pt idx="996">
                  <c:v>17.523332305478466</c:v>
                </c:pt>
                <c:pt idx="997">
                  <c:v>17.556583410422448</c:v>
                </c:pt>
                <c:pt idx="998">
                  <c:v>17.58983451536643</c:v>
                </c:pt>
                <c:pt idx="999">
                  <c:v>17.623085620310412</c:v>
                </c:pt>
                <c:pt idx="1000">
                  <c:v>17.656336725254395</c:v>
                </c:pt>
                <c:pt idx="1001">
                  <c:v>17.689587830198377</c:v>
                </c:pt>
                <c:pt idx="1002">
                  <c:v>17.722838935142356</c:v>
                </c:pt>
                <c:pt idx="1003">
                  <c:v>17.756090040086338</c:v>
                </c:pt>
                <c:pt idx="1004">
                  <c:v>17.78934114503032</c:v>
                </c:pt>
                <c:pt idx="1005">
                  <c:v>17.822592249974303</c:v>
                </c:pt>
                <c:pt idx="1006">
                  <c:v>17.855843354918285</c:v>
                </c:pt>
                <c:pt idx="1007">
                  <c:v>17.889094459862267</c:v>
                </c:pt>
                <c:pt idx="1008">
                  <c:v>17.92234556480625</c:v>
                </c:pt>
                <c:pt idx="1009">
                  <c:v>17.955596669750232</c:v>
                </c:pt>
                <c:pt idx="1010">
                  <c:v>17.988847774694214</c:v>
                </c:pt>
                <c:pt idx="1011">
                  <c:v>18.022098879638193</c:v>
                </c:pt>
                <c:pt idx="1012">
                  <c:v>18.055349984582175</c:v>
                </c:pt>
                <c:pt idx="1013">
                  <c:v>18.088601089526158</c:v>
                </c:pt>
                <c:pt idx="1014">
                  <c:v>18.12185219447014</c:v>
                </c:pt>
                <c:pt idx="1015">
                  <c:v>18.155103299414122</c:v>
                </c:pt>
                <c:pt idx="1016">
                  <c:v>18.188354404358105</c:v>
                </c:pt>
                <c:pt idx="1017">
                  <c:v>18.221605509302087</c:v>
                </c:pt>
                <c:pt idx="1018">
                  <c:v>18.254856614246069</c:v>
                </c:pt>
                <c:pt idx="1019">
                  <c:v>18.288107719190048</c:v>
                </c:pt>
                <c:pt idx="1020">
                  <c:v>18.32135882413403</c:v>
                </c:pt>
                <c:pt idx="1021">
                  <c:v>18.354609929078013</c:v>
                </c:pt>
                <c:pt idx="1022">
                  <c:v>18.387861034021995</c:v>
                </c:pt>
                <c:pt idx="1023">
                  <c:v>18.421112138965977</c:v>
                </c:pt>
                <c:pt idx="1024">
                  <c:v>18.45436324390996</c:v>
                </c:pt>
                <c:pt idx="1025">
                  <c:v>18.487614348853942</c:v>
                </c:pt>
                <c:pt idx="1026">
                  <c:v>18.520865453797924</c:v>
                </c:pt>
                <c:pt idx="1027">
                  <c:v>18.554116558741907</c:v>
                </c:pt>
                <c:pt idx="1028">
                  <c:v>18.587367663685885</c:v>
                </c:pt>
                <c:pt idx="1029">
                  <c:v>18.620618768629868</c:v>
                </c:pt>
                <c:pt idx="1030">
                  <c:v>18.65386987357385</c:v>
                </c:pt>
                <c:pt idx="1031">
                  <c:v>18.687120978517832</c:v>
                </c:pt>
                <c:pt idx="1032">
                  <c:v>18.720372083461815</c:v>
                </c:pt>
                <c:pt idx="1033">
                  <c:v>18.753623188405797</c:v>
                </c:pt>
                <c:pt idx="1034">
                  <c:v>18.786874293349779</c:v>
                </c:pt>
                <c:pt idx="1035">
                  <c:v>18.820125398293762</c:v>
                </c:pt>
                <c:pt idx="1036">
                  <c:v>18.853376503237744</c:v>
                </c:pt>
                <c:pt idx="1037">
                  <c:v>18.886627608181723</c:v>
                </c:pt>
                <c:pt idx="1038">
                  <c:v>18.919878713125705</c:v>
                </c:pt>
                <c:pt idx="1039">
                  <c:v>18.953129818069687</c:v>
                </c:pt>
                <c:pt idx="1040">
                  <c:v>18.98638092301367</c:v>
                </c:pt>
                <c:pt idx="1041">
                  <c:v>19.019632027957652</c:v>
                </c:pt>
                <c:pt idx="1042">
                  <c:v>19.052883132901634</c:v>
                </c:pt>
                <c:pt idx="1043">
                  <c:v>19.086134237845616</c:v>
                </c:pt>
                <c:pt idx="1044">
                  <c:v>19.119385342789599</c:v>
                </c:pt>
                <c:pt idx="1045">
                  <c:v>19.152636447733581</c:v>
                </c:pt>
                <c:pt idx="1046">
                  <c:v>19.18588755267756</c:v>
                </c:pt>
                <c:pt idx="1047">
                  <c:v>19.219138657621542</c:v>
                </c:pt>
                <c:pt idx="1048">
                  <c:v>19.252389762565524</c:v>
                </c:pt>
                <c:pt idx="1049">
                  <c:v>19.285640867509507</c:v>
                </c:pt>
                <c:pt idx="1050">
                  <c:v>19.318891972453489</c:v>
                </c:pt>
                <c:pt idx="1051">
                  <c:v>19.352143077397471</c:v>
                </c:pt>
                <c:pt idx="1052">
                  <c:v>19.385394182341454</c:v>
                </c:pt>
                <c:pt idx="1053">
                  <c:v>19.418645287285436</c:v>
                </c:pt>
                <c:pt idx="1054">
                  <c:v>19.451896392229418</c:v>
                </c:pt>
                <c:pt idx="1055">
                  <c:v>19.485147497173397</c:v>
                </c:pt>
                <c:pt idx="1056">
                  <c:v>19.518398602117379</c:v>
                </c:pt>
                <c:pt idx="1057">
                  <c:v>19.551649707061362</c:v>
                </c:pt>
                <c:pt idx="1058">
                  <c:v>19.584900812005344</c:v>
                </c:pt>
                <c:pt idx="1059">
                  <c:v>19.618151916949326</c:v>
                </c:pt>
                <c:pt idx="1060">
                  <c:v>19.651403021893309</c:v>
                </c:pt>
                <c:pt idx="1061">
                  <c:v>19.684654126837291</c:v>
                </c:pt>
                <c:pt idx="1062">
                  <c:v>19.717905231781273</c:v>
                </c:pt>
                <c:pt idx="1063">
                  <c:v>19.751156336725252</c:v>
                </c:pt>
                <c:pt idx="1064">
                  <c:v>19.784407441669234</c:v>
                </c:pt>
                <c:pt idx="1065">
                  <c:v>19.817658546613217</c:v>
                </c:pt>
                <c:pt idx="1066">
                  <c:v>19.850909651557199</c:v>
                </c:pt>
                <c:pt idx="1067">
                  <c:v>19.884160756501181</c:v>
                </c:pt>
                <c:pt idx="1068">
                  <c:v>19.917411861445164</c:v>
                </c:pt>
                <c:pt idx="1069">
                  <c:v>19.950662966389146</c:v>
                </c:pt>
                <c:pt idx="1070">
                  <c:v>19.983914071333128</c:v>
                </c:pt>
                <c:pt idx="1071">
                  <c:v>20.017165176277111</c:v>
                </c:pt>
                <c:pt idx="1072">
                  <c:v>20.050416281221089</c:v>
                </c:pt>
                <c:pt idx="1073">
                  <c:v>20.083667386165072</c:v>
                </c:pt>
                <c:pt idx="1074">
                  <c:v>20.116918491109054</c:v>
                </c:pt>
                <c:pt idx="1075">
                  <c:v>20.150169596053036</c:v>
                </c:pt>
                <c:pt idx="1076">
                  <c:v>20.183420700997019</c:v>
                </c:pt>
                <c:pt idx="1077">
                  <c:v>20.216671805941001</c:v>
                </c:pt>
                <c:pt idx="1078">
                  <c:v>20.249922910884983</c:v>
                </c:pt>
                <c:pt idx="1079">
                  <c:v>20.283174015828966</c:v>
                </c:pt>
                <c:pt idx="1080">
                  <c:v>20.316425120772948</c:v>
                </c:pt>
                <c:pt idx="1081">
                  <c:v>20.349676225716927</c:v>
                </c:pt>
                <c:pt idx="1082">
                  <c:v>20.382927330660909</c:v>
                </c:pt>
                <c:pt idx="1083">
                  <c:v>20.416178435604891</c:v>
                </c:pt>
                <c:pt idx="1084">
                  <c:v>20.449429540548874</c:v>
                </c:pt>
                <c:pt idx="1085">
                  <c:v>20.482680645492856</c:v>
                </c:pt>
                <c:pt idx="1086">
                  <c:v>20.515931750436838</c:v>
                </c:pt>
                <c:pt idx="1087">
                  <c:v>20.54918285538082</c:v>
                </c:pt>
                <c:pt idx="1088">
                  <c:v>20.582433960324803</c:v>
                </c:pt>
                <c:pt idx="1089">
                  <c:v>20.615685065268785</c:v>
                </c:pt>
                <c:pt idx="1090">
                  <c:v>20.648936170212764</c:v>
                </c:pt>
                <c:pt idx="1091">
                  <c:v>20.682187275156746</c:v>
                </c:pt>
                <c:pt idx="1092">
                  <c:v>20.715438380100728</c:v>
                </c:pt>
                <c:pt idx="1093">
                  <c:v>20.748689485044711</c:v>
                </c:pt>
                <c:pt idx="1094">
                  <c:v>20.781940589988693</c:v>
                </c:pt>
                <c:pt idx="1095">
                  <c:v>20.815191694932675</c:v>
                </c:pt>
                <c:pt idx="1096">
                  <c:v>20.848442799876658</c:v>
                </c:pt>
                <c:pt idx="1097">
                  <c:v>20.88169390482064</c:v>
                </c:pt>
                <c:pt idx="1098">
                  <c:v>20.914945009764622</c:v>
                </c:pt>
                <c:pt idx="1099">
                  <c:v>20.948196114708601</c:v>
                </c:pt>
                <c:pt idx="1100">
                  <c:v>20.981447219652583</c:v>
                </c:pt>
                <c:pt idx="1101">
                  <c:v>21.014698324596566</c:v>
                </c:pt>
                <c:pt idx="1102">
                  <c:v>21.047949429540548</c:v>
                </c:pt>
                <c:pt idx="1103">
                  <c:v>21.08120053448453</c:v>
                </c:pt>
                <c:pt idx="1104">
                  <c:v>21.114451639428513</c:v>
                </c:pt>
                <c:pt idx="1105">
                  <c:v>21.147702744372495</c:v>
                </c:pt>
                <c:pt idx="1106">
                  <c:v>21.180953849316477</c:v>
                </c:pt>
                <c:pt idx="1107">
                  <c:v>21.214204954260456</c:v>
                </c:pt>
                <c:pt idx="1108">
                  <c:v>21.247456059204438</c:v>
                </c:pt>
                <c:pt idx="1109">
                  <c:v>21.280707164148421</c:v>
                </c:pt>
                <c:pt idx="1110">
                  <c:v>21.313958269092403</c:v>
                </c:pt>
                <c:pt idx="1111">
                  <c:v>21.347209374036385</c:v>
                </c:pt>
                <c:pt idx="1112">
                  <c:v>21.380460478980368</c:v>
                </c:pt>
                <c:pt idx="1113">
                  <c:v>21.41371158392435</c:v>
                </c:pt>
                <c:pt idx="1114">
                  <c:v>21.446962688868332</c:v>
                </c:pt>
                <c:pt idx="1115">
                  <c:v>21.480213793812315</c:v>
                </c:pt>
                <c:pt idx="1116">
                  <c:v>21.513464898756293</c:v>
                </c:pt>
                <c:pt idx="1117">
                  <c:v>21.546716003700276</c:v>
                </c:pt>
                <c:pt idx="1118">
                  <c:v>21.579967108644258</c:v>
                </c:pt>
                <c:pt idx="1119">
                  <c:v>21.61321821358824</c:v>
                </c:pt>
                <c:pt idx="1120">
                  <c:v>21.646469318532223</c:v>
                </c:pt>
                <c:pt idx="1121">
                  <c:v>21.679720423476205</c:v>
                </c:pt>
                <c:pt idx="1122">
                  <c:v>21.712971528420187</c:v>
                </c:pt>
                <c:pt idx="1123">
                  <c:v>21.746222633364169</c:v>
                </c:pt>
                <c:pt idx="1124">
                  <c:v>21.779473738308152</c:v>
                </c:pt>
                <c:pt idx="1125">
                  <c:v>21.812724843252131</c:v>
                </c:pt>
                <c:pt idx="1126">
                  <c:v>21.845975948196113</c:v>
                </c:pt>
                <c:pt idx="1127">
                  <c:v>21.879227053140095</c:v>
                </c:pt>
                <c:pt idx="1128">
                  <c:v>21.912478158084078</c:v>
                </c:pt>
                <c:pt idx="1129">
                  <c:v>21.94572926302806</c:v>
                </c:pt>
                <c:pt idx="1130">
                  <c:v>21.978980367972042</c:v>
                </c:pt>
                <c:pt idx="1131">
                  <c:v>22.012231472916024</c:v>
                </c:pt>
                <c:pt idx="1132">
                  <c:v>22.045482577860007</c:v>
                </c:pt>
                <c:pt idx="1133">
                  <c:v>22.078733682803989</c:v>
                </c:pt>
                <c:pt idx="1134">
                  <c:v>22.111984787747968</c:v>
                </c:pt>
                <c:pt idx="1135">
                  <c:v>22.14523589269195</c:v>
                </c:pt>
                <c:pt idx="1136">
                  <c:v>22.178486997635932</c:v>
                </c:pt>
                <c:pt idx="1137">
                  <c:v>22.211738102579915</c:v>
                </c:pt>
                <c:pt idx="1138">
                  <c:v>22.244989207523897</c:v>
                </c:pt>
                <c:pt idx="1139">
                  <c:v>22.278240312467879</c:v>
                </c:pt>
                <c:pt idx="1140">
                  <c:v>22.311491417411862</c:v>
                </c:pt>
                <c:pt idx="1141">
                  <c:v>22.344742522355844</c:v>
                </c:pt>
                <c:pt idx="1142">
                  <c:v>22.377993627299826</c:v>
                </c:pt>
                <c:pt idx="1143">
                  <c:v>22.411244732243805</c:v>
                </c:pt>
                <c:pt idx="1144">
                  <c:v>22.444495837187787</c:v>
                </c:pt>
                <c:pt idx="1145">
                  <c:v>22.47774694213177</c:v>
                </c:pt>
                <c:pt idx="1146">
                  <c:v>22.510998047075752</c:v>
                </c:pt>
                <c:pt idx="1147">
                  <c:v>22.544249152019734</c:v>
                </c:pt>
                <c:pt idx="1148">
                  <c:v>22.577500256963717</c:v>
                </c:pt>
                <c:pt idx="1149">
                  <c:v>22.610751361907699</c:v>
                </c:pt>
                <c:pt idx="1150">
                  <c:v>22.644002466851681</c:v>
                </c:pt>
                <c:pt idx="1151">
                  <c:v>22.67725357179566</c:v>
                </c:pt>
                <c:pt idx="1152">
                  <c:v>22.710504676739642</c:v>
                </c:pt>
                <c:pt idx="1153">
                  <c:v>22.743755781683625</c:v>
                </c:pt>
                <c:pt idx="1154">
                  <c:v>22.777006886627607</c:v>
                </c:pt>
                <c:pt idx="1155">
                  <c:v>22.810257991571589</c:v>
                </c:pt>
                <c:pt idx="1156">
                  <c:v>22.843509096515572</c:v>
                </c:pt>
                <c:pt idx="1157">
                  <c:v>22.876760201459554</c:v>
                </c:pt>
                <c:pt idx="1158">
                  <c:v>22.910011306403536</c:v>
                </c:pt>
                <c:pt idx="1159">
                  <c:v>22.943262411347519</c:v>
                </c:pt>
                <c:pt idx="1160">
                  <c:v>22.976513516291497</c:v>
                </c:pt>
                <c:pt idx="1161">
                  <c:v>23.00976462123548</c:v>
                </c:pt>
                <c:pt idx="1162">
                  <c:v>23.043015726179462</c:v>
                </c:pt>
                <c:pt idx="1163">
                  <c:v>23.076266831123444</c:v>
                </c:pt>
                <c:pt idx="1164">
                  <c:v>23.109517936067427</c:v>
                </c:pt>
                <c:pt idx="1165">
                  <c:v>23.142769041011409</c:v>
                </c:pt>
                <c:pt idx="1166">
                  <c:v>23.176020145955391</c:v>
                </c:pt>
                <c:pt idx="1167">
                  <c:v>23.209271250899373</c:v>
                </c:pt>
                <c:pt idx="1168">
                  <c:v>23.242522355843356</c:v>
                </c:pt>
                <c:pt idx="1169">
                  <c:v>23.275773460787335</c:v>
                </c:pt>
                <c:pt idx="1170">
                  <c:v>23.309024565731317</c:v>
                </c:pt>
                <c:pt idx="1171">
                  <c:v>23.342275670675299</c:v>
                </c:pt>
                <c:pt idx="1172">
                  <c:v>23.375526775619281</c:v>
                </c:pt>
                <c:pt idx="1173">
                  <c:v>23.408777880563264</c:v>
                </c:pt>
                <c:pt idx="1174">
                  <c:v>23.442028985507246</c:v>
                </c:pt>
                <c:pt idx="1175">
                  <c:v>23.475280090451228</c:v>
                </c:pt>
                <c:pt idx="1176">
                  <c:v>23.508531195395211</c:v>
                </c:pt>
                <c:pt idx="1177">
                  <c:v>23.541782300339193</c:v>
                </c:pt>
                <c:pt idx="1178">
                  <c:v>23.575033405283172</c:v>
                </c:pt>
                <c:pt idx="1179">
                  <c:v>23.608284510227154</c:v>
                </c:pt>
                <c:pt idx="1180">
                  <c:v>23.641535615171136</c:v>
                </c:pt>
                <c:pt idx="1181">
                  <c:v>23.674786720115119</c:v>
                </c:pt>
                <c:pt idx="1182">
                  <c:v>23.708037825059101</c:v>
                </c:pt>
                <c:pt idx="1183">
                  <c:v>23.741288930003083</c:v>
                </c:pt>
                <c:pt idx="1184">
                  <c:v>23.774540034947066</c:v>
                </c:pt>
                <c:pt idx="1185">
                  <c:v>23.807791139891048</c:v>
                </c:pt>
                <c:pt idx="1186">
                  <c:v>23.84104224483503</c:v>
                </c:pt>
                <c:pt idx="1187">
                  <c:v>23.874293349779009</c:v>
                </c:pt>
                <c:pt idx="1188">
                  <c:v>23.907544454722991</c:v>
                </c:pt>
                <c:pt idx="1189">
                  <c:v>23.940795559666974</c:v>
                </c:pt>
                <c:pt idx="1190">
                  <c:v>23.974046664610956</c:v>
                </c:pt>
                <c:pt idx="1191">
                  <c:v>24.007297769554938</c:v>
                </c:pt>
                <c:pt idx="1192">
                  <c:v>24.040548874498921</c:v>
                </c:pt>
                <c:pt idx="1193">
                  <c:v>24.073799979442903</c:v>
                </c:pt>
                <c:pt idx="1194">
                  <c:v>24.107051084386885</c:v>
                </c:pt>
                <c:pt idx="1195">
                  <c:v>24.140302189330864</c:v>
                </c:pt>
                <c:pt idx="1196">
                  <c:v>24.173553294274846</c:v>
                </c:pt>
                <c:pt idx="1197">
                  <c:v>24.206804399218829</c:v>
                </c:pt>
                <c:pt idx="1198">
                  <c:v>24.240055504162811</c:v>
                </c:pt>
                <c:pt idx="1199">
                  <c:v>24.273306609106793</c:v>
                </c:pt>
                <c:pt idx="1200">
                  <c:v>24.306557714050776</c:v>
                </c:pt>
                <c:pt idx="1201">
                  <c:v>24.339808818994758</c:v>
                </c:pt>
                <c:pt idx="1202">
                  <c:v>24.37305992393874</c:v>
                </c:pt>
                <c:pt idx="1203">
                  <c:v>24.406311028882723</c:v>
                </c:pt>
                <c:pt idx="1204">
                  <c:v>24.439562133826701</c:v>
                </c:pt>
                <c:pt idx="1205">
                  <c:v>24.472813238770684</c:v>
                </c:pt>
                <c:pt idx="1206">
                  <c:v>24.506064343714666</c:v>
                </c:pt>
                <c:pt idx="1207">
                  <c:v>24.539315448658648</c:v>
                </c:pt>
                <c:pt idx="1208">
                  <c:v>24.572566553602631</c:v>
                </c:pt>
                <c:pt idx="1209">
                  <c:v>24.605817658546613</c:v>
                </c:pt>
                <c:pt idx="1210">
                  <c:v>24.639068763490595</c:v>
                </c:pt>
                <c:pt idx="1211">
                  <c:v>24.672319868434577</c:v>
                </c:pt>
                <c:pt idx="1212">
                  <c:v>24.70557097337856</c:v>
                </c:pt>
                <c:pt idx="1213">
                  <c:v>24.738822078322539</c:v>
                </c:pt>
                <c:pt idx="1214">
                  <c:v>24.772073183266521</c:v>
                </c:pt>
                <c:pt idx="1215">
                  <c:v>24.805324288210503</c:v>
                </c:pt>
                <c:pt idx="1216">
                  <c:v>24.838575393154485</c:v>
                </c:pt>
                <c:pt idx="1217">
                  <c:v>24.871826498098468</c:v>
                </c:pt>
                <c:pt idx="1218">
                  <c:v>24.90507760304245</c:v>
                </c:pt>
                <c:pt idx="1219">
                  <c:v>24.938328707986432</c:v>
                </c:pt>
                <c:pt idx="1220">
                  <c:v>24.971579812930415</c:v>
                </c:pt>
                <c:pt idx="1221">
                  <c:v>25.004830917874397</c:v>
                </c:pt>
                <c:pt idx="1222">
                  <c:v>25.038082022818376</c:v>
                </c:pt>
                <c:pt idx="1223">
                  <c:v>25.071333127762358</c:v>
                </c:pt>
                <c:pt idx="1224">
                  <c:v>25.10458423270634</c:v>
                </c:pt>
                <c:pt idx="1225">
                  <c:v>25.137835337650323</c:v>
                </c:pt>
                <c:pt idx="1226">
                  <c:v>25.171086442594305</c:v>
                </c:pt>
                <c:pt idx="1227">
                  <c:v>25.204337547538287</c:v>
                </c:pt>
                <c:pt idx="1228">
                  <c:v>25.23758865248227</c:v>
                </c:pt>
                <c:pt idx="1229">
                  <c:v>25.270839757426252</c:v>
                </c:pt>
                <c:pt idx="1230">
                  <c:v>25.304090862370234</c:v>
                </c:pt>
                <c:pt idx="1231">
                  <c:v>25.337341967314213</c:v>
                </c:pt>
                <c:pt idx="1232">
                  <c:v>25.370593072258195</c:v>
                </c:pt>
                <c:pt idx="1233">
                  <c:v>25.403844177202178</c:v>
                </c:pt>
                <c:pt idx="1234">
                  <c:v>25.43709528214616</c:v>
                </c:pt>
                <c:pt idx="1235">
                  <c:v>25.470346387090142</c:v>
                </c:pt>
                <c:pt idx="1236">
                  <c:v>25.503597492034125</c:v>
                </c:pt>
                <c:pt idx="1237">
                  <c:v>25.536848596978107</c:v>
                </c:pt>
                <c:pt idx="1238">
                  <c:v>25.570099701922089</c:v>
                </c:pt>
                <c:pt idx="1239">
                  <c:v>25.603350806866068</c:v>
                </c:pt>
                <c:pt idx="1240">
                  <c:v>25.63660191181005</c:v>
                </c:pt>
                <c:pt idx="1241">
                  <c:v>25.669853016754033</c:v>
                </c:pt>
                <c:pt idx="1242">
                  <c:v>25.703104121698015</c:v>
                </c:pt>
                <c:pt idx="1243">
                  <c:v>25.736355226641997</c:v>
                </c:pt>
                <c:pt idx="1244">
                  <c:v>25.76960633158598</c:v>
                </c:pt>
                <c:pt idx="1245">
                  <c:v>25.802857436529962</c:v>
                </c:pt>
                <c:pt idx="1246">
                  <c:v>25.836108541473944</c:v>
                </c:pt>
                <c:pt idx="1247">
                  <c:v>25.869359646417927</c:v>
                </c:pt>
                <c:pt idx="1248">
                  <c:v>25.902610751361905</c:v>
                </c:pt>
                <c:pt idx="1249">
                  <c:v>25.935861856305888</c:v>
                </c:pt>
                <c:pt idx="1250">
                  <c:v>25.96911296124987</c:v>
                </c:pt>
                <c:pt idx="1251">
                  <c:v>26.002364066193852</c:v>
                </c:pt>
                <c:pt idx="1252">
                  <c:v>26.035615171137835</c:v>
                </c:pt>
                <c:pt idx="1253">
                  <c:v>26.068866276081817</c:v>
                </c:pt>
                <c:pt idx="1254">
                  <c:v>26.102117381025799</c:v>
                </c:pt>
                <c:pt idx="1255">
                  <c:v>26.135368485969781</c:v>
                </c:pt>
                <c:pt idx="1256">
                  <c:v>26.168619590913764</c:v>
                </c:pt>
                <c:pt idx="1257">
                  <c:v>26.201870695857743</c:v>
                </c:pt>
                <c:pt idx="1258">
                  <c:v>26.235121800801725</c:v>
                </c:pt>
                <c:pt idx="1259">
                  <c:v>26.268372905745707</c:v>
                </c:pt>
                <c:pt idx="1260">
                  <c:v>26.301624010689689</c:v>
                </c:pt>
                <c:pt idx="1261">
                  <c:v>26.334875115633672</c:v>
                </c:pt>
                <c:pt idx="1262">
                  <c:v>26.368126220577654</c:v>
                </c:pt>
                <c:pt idx="1263">
                  <c:v>26.401377325521636</c:v>
                </c:pt>
                <c:pt idx="1264">
                  <c:v>26.434628430465619</c:v>
                </c:pt>
                <c:pt idx="1265">
                  <c:v>26.467879535409601</c:v>
                </c:pt>
                <c:pt idx="1266">
                  <c:v>26.50113064035358</c:v>
                </c:pt>
                <c:pt idx="1267">
                  <c:v>26.534381745297562</c:v>
                </c:pt>
                <c:pt idx="1268">
                  <c:v>26.567632850241544</c:v>
                </c:pt>
                <c:pt idx="1269">
                  <c:v>26.600883955185527</c:v>
                </c:pt>
                <c:pt idx="1270">
                  <c:v>26.634135060129509</c:v>
                </c:pt>
                <c:pt idx="1271">
                  <c:v>26.667386165073491</c:v>
                </c:pt>
                <c:pt idx="1272">
                  <c:v>26.700637270017474</c:v>
                </c:pt>
                <c:pt idx="1273">
                  <c:v>26.733888374961456</c:v>
                </c:pt>
                <c:pt idx="1274">
                  <c:v>26.767139479905438</c:v>
                </c:pt>
                <c:pt idx="1275">
                  <c:v>26.800390584849417</c:v>
                </c:pt>
                <c:pt idx="1276">
                  <c:v>26.833641689793399</c:v>
                </c:pt>
                <c:pt idx="1277">
                  <c:v>26.866892794737382</c:v>
                </c:pt>
                <c:pt idx="1278">
                  <c:v>26.900143899681364</c:v>
                </c:pt>
                <c:pt idx="1279">
                  <c:v>26.933395004625346</c:v>
                </c:pt>
                <c:pt idx="1280">
                  <c:v>26.966646109569329</c:v>
                </c:pt>
                <c:pt idx="1281">
                  <c:v>26.999897214513311</c:v>
                </c:pt>
                <c:pt idx="1282">
                  <c:v>27.033148319457293</c:v>
                </c:pt>
                <c:pt idx="1283">
                  <c:v>27.066399424401272</c:v>
                </c:pt>
                <c:pt idx="1284">
                  <c:v>27.099650529345254</c:v>
                </c:pt>
                <c:pt idx="1285">
                  <c:v>27.132901634289237</c:v>
                </c:pt>
                <c:pt idx="1286">
                  <c:v>27.166152739233219</c:v>
                </c:pt>
                <c:pt idx="1287">
                  <c:v>27.199403844177201</c:v>
                </c:pt>
                <c:pt idx="1288">
                  <c:v>27.232654949121184</c:v>
                </c:pt>
                <c:pt idx="1289">
                  <c:v>27.265906054065166</c:v>
                </c:pt>
                <c:pt idx="1290">
                  <c:v>27.299157159009148</c:v>
                </c:pt>
                <c:pt idx="1291">
                  <c:v>27.332408263953131</c:v>
                </c:pt>
                <c:pt idx="1292">
                  <c:v>27.365659368897109</c:v>
                </c:pt>
                <c:pt idx="1293">
                  <c:v>27.398910473841092</c:v>
                </c:pt>
                <c:pt idx="1294">
                  <c:v>27.432161578785074</c:v>
                </c:pt>
                <c:pt idx="1295">
                  <c:v>27.465412683729056</c:v>
                </c:pt>
                <c:pt idx="1296">
                  <c:v>27.498663788673039</c:v>
                </c:pt>
                <c:pt idx="1297">
                  <c:v>27.531914893617021</c:v>
                </c:pt>
                <c:pt idx="1298">
                  <c:v>27.565165998561003</c:v>
                </c:pt>
                <c:pt idx="1299">
                  <c:v>27.598417103504985</c:v>
                </c:pt>
                <c:pt idx="1300">
                  <c:v>27.631668208448968</c:v>
                </c:pt>
                <c:pt idx="1301">
                  <c:v>27.664919313392947</c:v>
                </c:pt>
                <c:pt idx="1302">
                  <c:v>27.698170418336929</c:v>
                </c:pt>
                <c:pt idx="1303">
                  <c:v>27.731421523280911</c:v>
                </c:pt>
                <c:pt idx="1304">
                  <c:v>27.764672628224893</c:v>
                </c:pt>
                <c:pt idx="1305">
                  <c:v>27.797923733168876</c:v>
                </c:pt>
                <c:pt idx="1306">
                  <c:v>27.831174838112858</c:v>
                </c:pt>
                <c:pt idx="1307">
                  <c:v>27.86442594305684</c:v>
                </c:pt>
                <c:pt idx="1308">
                  <c:v>27.897677048000823</c:v>
                </c:pt>
                <c:pt idx="1309">
                  <c:v>27.930928152944805</c:v>
                </c:pt>
                <c:pt idx="1310">
                  <c:v>27.964179257888784</c:v>
                </c:pt>
                <c:pt idx="1311">
                  <c:v>27.997430362832766</c:v>
                </c:pt>
                <c:pt idx="1312">
                  <c:v>28.030681467776748</c:v>
                </c:pt>
                <c:pt idx="1313">
                  <c:v>28.063932572720731</c:v>
                </c:pt>
                <c:pt idx="1314">
                  <c:v>28.097183677664713</c:v>
                </c:pt>
                <c:pt idx="1315">
                  <c:v>28.130434782608695</c:v>
                </c:pt>
                <c:pt idx="1316">
                  <c:v>28.163685887552678</c:v>
                </c:pt>
                <c:pt idx="1317">
                  <c:v>28.19693699249666</c:v>
                </c:pt>
                <c:pt idx="1318">
                  <c:v>28.230188097440642</c:v>
                </c:pt>
                <c:pt idx="1319">
                  <c:v>28.263439202384621</c:v>
                </c:pt>
                <c:pt idx="1320">
                  <c:v>28.296690307328603</c:v>
                </c:pt>
                <c:pt idx="1321">
                  <c:v>28.329941412272586</c:v>
                </c:pt>
                <c:pt idx="1322">
                  <c:v>28.363192517216568</c:v>
                </c:pt>
                <c:pt idx="1323">
                  <c:v>28.39644362216055</c:v>
                </c:pt>
                <c:pt idx="1324">
                  <c:v>28.429694727104533</c:v>
                </c:pt>
                <c:pt idx="1325">
                  <c:v>28.462945832048515</c:v>
                </c:pt>
                <c:pt idx="1326">
                  <c:v>28.496196936992497</c:v>
                </c:pt>
                <c:pt idx="1327">
                  <c:v>28.529448041936476</c:v>
                </c:pt>
                <c:pt idx="1328">
                  <c:v>28.562699146880458</c:v>
                </c:pt>
                <c:pt idx="1329">
                  <c:v>28.595950251824441</c:v>
                </c:pt>
                <c:pt idx="1330">
                  <c:v>28.629201356768423</c:v>
                </c:pt>
                <c:pt idx="1331">
                  <c:v>28.662452461712405</c:v>
                </c:pt>
                <c:pt idx="1332">
                  <c:v>28.695703566656388</c:v>
                </c:pt>
                <c:pt idx="1333">
                  <c:v>28.72895467160037</c:v>
                </c:pt>
                <c:pt idx="1334">
                  <c:v>28.762205776544352</c:v>
                </c:pt>
                <c:pt idx="1335">
                  <c:v>28.795456881488334</c:v>
                </c:pt>
                <c:pt idx="1336">
                  <c:v>28.828707986432313</c:v>
                </c:pt>
                <c:pt idx="1337">
                  <c:v>28.861959091376296</c:v>
                </c:pt>
                <c:pt idx="1338">
                  <c:v>28.895210196320278</c:v>
                </c:pt>
                <c:pt idx="1339">
                  <c:v>28.92846130126426</c:v>
                </c:pt>
                <c:pt idx="1340">
                  <c:v>28.961712406208242</c:v>
                </c:pt>
                <c:pt idx="1341">
                  <c:v>28.994963511152225</c:v>
                </c:pt>
                <c:pt idx="1342">
                  <c:v>29.028214616096207</c:v>
                </c:pt>
                <c:pt idx="1343">
                  <c:v>29.061465721040189</c:v>
                </c:pt>
                <c:pt idx="1344">
                  <c:v>29.094716825984172</c:v>
                </c:pt>
                <c:pt idx="1345">
                  <c:v>29.127967930928151</c:v>
                </c:pt>
                <c:pt idx="1346">
                  <c:v>29.161219035872133</c:v>
                </c:pt>
                <c:pt idx="1347">
                  <c:v>29.194470140816115</c:v>
                </c:pt>
                <c:pt idx="1348">
                  <c:v>29.227721245760097</c:v>
                </c:pt>
                <c:pt idx="1349">
                  <c:v>29.26097235070408</c:v>
                </c:pt>
                <c:pt idx="1350">
                  <c:v>29.294223455648062</c:v>
                </c:pt>
                <c:pt idx="1351">
                  <c:v>29.327474560592044</c:v>
                </c:pt>
                <c:pt idx="1352">
                  <c:v>29.360725665536027</c:v>
                </c:pt>
                <c:pt idx="1353">
                  <c:v>29.393976770480009</c:v>
                </c:pt>
                <c:pt idx="1354">
                  <c:v>29.427227875423988</c:v>
                </c:pt>
                <c:pt idx="1355">
                  <c:v>29.46047898036797</c:v>
                </c:pt>
                <c:pt idx="1356">
                  <c:v>29.493730085311952</c:v>
                </c:pt>
                <c:pt idx="1357">
                  <c:v>29.526981190255935</c:v>
                </c:pt>
                <c:pt idx="1358">
                  <c:v>29.560232295199917</c:v>
                </c:pt>
                <c:pt idx="1359">
                  <c:v>29.593483400143899</c:v>
                </c:pt>
                <c:pt idx="1360">
                  <c:v>29.626734505087882</c:v>
                </c:pt>
                <c:pt idx="1361">
                  <c:v>29.659985610031864</c:v>
                </c:pt>
                <c:pt idx="1362">
                  <c:v>29.693236714975846</c:v>
                </c:pt>
                <c:pt idx="1363">
                  <c:v>29.726487819919825</c:v>
                </c:pt>
                <c:pt idx="1364">
                  <c:v>29.759738924863807</c:v>
                </c:pt>
                <c:pt idx="1365">
                  <c:v>29.79299002980779</c:v>
                </c:pt>
                <c:pt idx="1366">
                  <c:v>29.826241134751772</c:v>
                </c:pt>
                <c:pt idx="1367">
                  <c:v>29.859492239695754</c:v>
                </c:pt>
                <c:pt idx="1368">
                  <c:v>29.892743344639737</c:v>
                </c:pt>
                <c:pt idx="1369">
                  <c:v>29.925994449583719</c:v>
                </c:pt>
                <c:pt idx="1370">
                  <c:v>29.959245554527701</c:v>
                </c:pt>
                <c:pt idx="1371">
                  <c:v>29.99249665947168</c:v>
                </c:pt>
                <c:pt idx="1372">
                  <c:v>30.025747764415662</c:v>
                </c:pt>
                <c:pt idx="1373">
                  <c:v>30.058998869359645</c:v>
                </c:pt>
                <c:pt idx="1374">
                  <c:v>30.092249974303627</c:v>
                </c:pt>
                <c:pt idx="1375">
                  <c:v>30.125501079247609</c:v>
                </c:pt>
                <c:pt idx="1376">
                  <c:v>30.158752184191592</c:v>
                </c:pt>
                <c:pt idx="1377">
                  <c:v>30.192003289135574</c:v>
                </c:pt>
                <c:pt idx="1378">
                  <c:v>30.225254394079556</c:v>
                </c:pt>
                <c:pt idx="1379">
                  <c:v>30.258505499023538</c:v>
                </c:pt>
                <c:pt idx="1380">
                  <c:v>30.291756603967517</c:v>
                </c:pt>
                <c:pt idx="1381">
                  <c:v>30.3250077089115</c:v>
                </c:pt>
                <c:pt idx="1382">
                  <c:v>30.358258813855482</c:v>
                </c:pt>
                <c:pt idx="1383">
                  <c:v>30.391509918799464</c:v>
                </c:pt>
                <c:pt idx="1384">
                  <c:v>30.424761023743446</c:v>
                </c:pt>
                <c:pt idx="1385">
                  <c:v>30.458012128687429</c:v>
                </c:pt>
                <c:pt idx="1386">
                  <c:v>30.491263233631411</c:v>
                </c:pt>
                <c:pt idx="1387">
                  <c:v>30.524514338575393</c:v>
                </c:pt>
                <c:pt idx="1388">
                  <c:v>30.557765443519376</c:v>
                </c:pt>
                <c:pt idx="1389">
                  <c:v>30.591016548463354</c:v>
                </c:pt>
                <c:pt idx="1390">
                  <c:v>30.624267653407337</c:v>
                </c:pt>
                <c:pt idx="1391">
                  <c:v>30.657518758351319</c:v>
                </c:pt>
                <c:pt idx="1392">
                  <c:v>30.690769863295301</c:v>
                </c:pt>
                <c:pt idx="1393">
                  <c:v>30.724020968239284</c:v>
                </c:pt>
                <c:pt idx="1394">
                  <c:v>30.757272073183266</c:v>
                </c:pt>
                <c:pt idx="1395">
                  <c:v>30.790523178127248</c:v>
                </c:pt>
                <c:pt idx="1396">
                  <c:v>30.823774283071231</c:v>
                </c:pt>
                <c:pt idx="1397">
                  <c:v>30.857025388015213</c:v>
                </c:pt>
                <c:pt idx="1398">
                  <c:v>30.890276492959192</c:v>
                </c:pt>
                <c:pt idx="1399">
                  <c:v>30.923527597903174</c:v>
                </c:pt>
                <c:pt idx="1400">
                  <c:v>30.956778702847156</c:v>
                </c:pt>
                <c:pt idx="1401">
                  <c:v>30.990029807791139</c:v>
                </c:pt>
                <c:pt idx="1402">
                  <c:v>31.023280912735121</c:v>
                </c:pt>
                <c:pt idx="1403">
                  <c:v>31.056532017679103</c:v>
                </c:pt>
                <c:pt idx="1404">
                  <c:v>31.089783122623086</c:v>
                </c:pt>
                <c:pt idx="1405">
                  <c:v>31.123034227567068</c:v>
                </c:pt>
                <c:pt idx="1406">
                  <c:v>31.15628533251105</c:v>
                </c:pt>
                <c:pt idx="1407">
                  <c:v>31.189536437455029</c:v>
                </c:pt>
                <c:pt idx="1408">
                  <c:v>31.222787542399011</c:v>
                </c:pt>
                <c:pt idx="1409">
                  <c:v>31.256038647342994</c:v>
                </c:pt>
                <c:pt idx="1410">
                  <c:v>31.289289752286976</c:v>
                </c:pt>
                <c:pt idx="1411">
                  <c:v>31.322540857230958</c:v>
                </c:pt>
                <c:pt idx="1412">
                  <c:v>31.355791962174941</c:v>
                </c:pt>
                <c:pt idx="1413">
                  <c:v>31.389043067118923</c:v>
                </c:pt>
                <c:pt idx="1414">
                  <c:v>31.422294172062905</c:v>
                </c:pt>
                <c:pt idx="1415">
                  <c:v>31.455545277006884</c:v>
                </c:pt>
                <c:pt idx="1416">
                  <c:v>31.488796381950866</c:v>
                </c:pt>
                <c:pt idx="1417">
                  <c:v>31.522047486894849</c:v>
                </c:pt>
                <c:pt idx="1418">
                  <c:v>31.555298591838831</c:v>
                </c:pt>
                <c:pt idx="1419">
                  <c:v>31.588549696782813</c:v>
                </c:pt>
                <c:pt idx="1420">
                  <c:v>31.621800801726796</c:v>
                </c:pt>
                <c:pt idx="1421">
                  <c:v>31.655051906670778</c:v>
                </c:pt>
                <c:pt idx="1422">
                  <c:v>31.68830301161476</c:v>
                </c:pt>
                <c:pt idx="1423">
                  <c:v>31.721554116558742</c:v>
                </c:pt>
                <c:pt idx="1424">
                  <c:v>31.754805221502721</c:v>
                </c:pt>
                <c:pt idx="1425">
                  <c:v>31.788056326446704</c:v>
                </c:pt>
                <c:pt idx="1426">
                  <c:v>31.821307431390686</c:v>
                </c:pt>
                <c:pt idx="1427">
                  <c:v>31.854558536334668</c:v>
                </c:pt>
                <c:pt idx="1428">
                  <c:v>31.88780964127865</c:v>
                </c:pt>
                <c:pt idx="1429">
                  <c:v>31.921060746222633</c:v>
                </c:pt>
                <c:pt idx="1430">
                  <c:v>31.954311851166615</c:v>
                </c:pt>
                <c:pt idx="1431">
                  <c:v>31.987562956110597</c:v>
                </c:pt>
                <c:pt idx="1432">
                  <c:v>32.02081406105458</c:v>
                </c:pt>
                <c:pt idx="1433">
                  <c:v>32.054065165998558</c:v>
                </c:pt>
                <c:pt idx="1434">
                  <c:v>32.087316270942544</c:v>
                </c:pt>
                <c:pt idx="1435">
                  <c:v>32.120567375886523</c:v>
                </c:pt>
                <c:pt idx="1436">
                  <c:v>32.153818480830509</c:v>
                </c:pt>
                <c:pt idx="1437">
                  <c:v>32.187069585774488</c:v>
                </c:pt>
                <c:pt idx="1438">
                  <c:v>32.220320690718466</c:v>
                </c:pt>
                <c:pt idx="1439">
                  <c:v>32.253571795662452</c:v>
                </c:pt>
                <c:pt idx="1440">
                  <c:v>32.286822900606431</c:v>
                </c:pt>
                <c:pt idx="1441">
                  <c:v>32.320074005550417</c:v>
                </c:pt>
              </c:numCache>
            </c:numRef>
          </c:xVal>
          <c:yVal>
            <c:numRef>
              <c:f>Curves!$B$4:$B$1445</c:f>
              <c:numCache>
                <c:formatCode>###0.00</c:formatCode>
                <c:ptCount val="1442"/>
                <c:pt idx="0">
                  <c:v>5.0000000000000001E-3</c:v>
                </c:pt>
                <c:pt idx="1">
                  <c:v>0</c:v>
                </c:pt>
                <c:pt idx="2">
                  <c:v>-4.0000000000000001E-3</c:v>
                </c:pt>
                <c:pt idx="3">
                  <c:v>-4.0000000000000001E-3</c:v>
                </c:pt>
                <c:pt idx="4">
                  <c:v>-8.0000000000000002E-3</c:v>
                </c:pt>
                <c:pt idx="5">
                  <c:v>-1.2999999999999999E-2</c:v>
                </c:pt>
                <c:pt idx="6">
                  <c:v>-1.7000000000000001E-2</c:v>
                </c:pt>
                <c:pt idx="7">
                  <c:v>1E-3</c:v>
                </c:pt>
                <c:pt idx="8">
                  <c:v>7.8E-2</c:v>
                </c:pt>
                <c:pt idx="9">
                  <c:v>0.23200000000000001</c:v>
                </c:pt>
                <c:pt idx="10">
                  <c:v>0.40699999999999997</c:v>
                </c:pt>
                <c:pt idx="11">
                  <c:v>0.56000000000000005</c:v>
                </c:pt>
                <c:pt idx="12">
                  <c:v>0.67600000000000005</c:v>
                </c:pt>
                <c:pt idx="13">
                  <c:v>0.73399999999999999</c:v>
                </c:pt>
                <c:pt idx="14">
                  <c:v>0.70399999999999996</c:v>
                </c:pt>
                <c:pt idx="15">
                  <c:v>0.59</c:v>
                </c:pt>
                <c:pt idx="16">
                  <c:v>0.48</c:v>
                </c:pt>
                <c:pt idx="17">
                  <c:v>0.38900000000000001</c:v>
                </c:pt>
                <c:pt idx="18">
                  <c:v>0.317</c:v>
                </c:pt>
                <c:pt idx="19">
                  <c:v>0.25900000000000001</c:v>
                </c:pt>
                <c:pt idx="20">
                  <c:v>0.215</c:v>
                </c:pt>
                <c:pt idx="21">
                  <c:v>0.17299999999999999</c:v>
                </c:pt>
                <c:pt idx="22">
                  <c:v>0.13600000000000001</c:v>
                </c:pt>
                <c:pt idx="23">
                  <c:v>0.105</c:v>
                </c:pt>
                <c:pt idx="24">
                  <c:v>7.9000000000000001E-2</c:v>
                </c:pt>
                <c:pt idx="25">
                  <c:v>5.2999999999999999E-2</c:v>
                </c:pt>
                <c:pt idx="26">
                  <c:v>2.8000000000000001E-2</c:v>
                </c:pt>
                <c:pt idx="27">
                  <c:v>8.9999999999999993E-3</c:v>
                </c:pt>
                <c:pt idx="28">
                  <c:v>-5.0000000000000001E-3</c:v>
                </c:pt>
                <c:pt idx="29">
                  <c:v>-0.02</c:v>
                </c:pt>
                <c:pt idx="30">
                  <c:v>-0.03</c:v>
                </c:pt>
                <c:pt idx="31">
                  <c:v>-3.9E-2</c:v>
                </c:pt>
                <c:pt idx="32">
                  <c:v>-4.5999999999999999E-2</c:v>
                </c:pt>
                <c:pt idx="33">
                  <c:v>-5.5E-2</c:v>
                </c:pt>
                <c:pt idx="34">
                  <c:v>-6.4000000000000001E-2</c:v>
                </c:pt>
                <c:pt idx="35">
                  <c:v>-7.4999999999999997E-2</c:v>
                </c:pt>
                <c:pt idx="36">
                  <c:v>-8.4000000000000005E-2</c:v>
                </c:pt>
                <c:pt idx="37">
                  <c:v>-8.7999999999999995E-2</c:v>
                </c:pt>
                <c:pt idx="38">
                  <c:v>-9.1999999999999998E-2</c:v>
                </c:pt>
                <c:pt idx="39">
                  <c:v>-9.2999999999999999E-2</c:v>
                </c:pt>
                <c:pt idx="40">
                  <c:v>-9.7000000000000003E-2</c:v>
                </c:pt>
                <c:pt idx="41">
                  <c:v>-9.7000000000000003E-2</c:v>
                </c:pt>
                <c:pt idx="42">
                  <c:v>-9.9000000000000005E-2</c:v>
                </c:pt>
                <c:pt idx="43">
                  <c:v>-0.10100000000000001</c:v>
                </c:pt>
                <c:pt idx="44">
                  <c:v>-0.107</c:v>
                </c:pt>
                <c:pt idx="45">
                  <c:v>-0.112</c:v>
                </c:pt>
                <c:pt idx="46">
                  <c:v>-0.11600000000000001</c:v>
                </c:pt>
                <c:pt idx="47">
                  <c:v>-0.11799999999999999</c:v>
                </c:pt>
                <c:pt idx="48">
                  <c:v>-0.125</c:v>
                </c:pt>
                <c:pt idx="49">
                  <c:v>-0.129</c:v>
                </c:pt>
                <c:pt idx="50">
                  <c:v>-0.13200000000000001</c:v>
                </c:pt>
                <c:pt idx="51">
                  <c:v>-0.13500000000000001</c:v>
                </c:pt>
                <c:pt idx="52">
                  <c:v>-0.13400000000000001</c:v>
                </c:pt>
                <c:pt idx="53">
                  <c:v>-0.13700000000000001</c:v>
                </c:pt>
                <c:pt idx="54">
                  <c:v>-0.14000000000000001</c:v>
                </c:pt>
                <c:pt idx="55">
                  <c:v>-0.13900000000000001</c:v>
                </c:pt>
                <c:pt idx="56">
                  <c:v>-0.14000000000000001</c:v>
                </c:pt>
                <c:pt idx="57">
                  <c:v>-0.14099999999999999</c:v>
                </c:pt>
                <c:pt idx="58">
                  <c:v>-0.14399999999999999</c:v>
                </c:pt>
                <c:pt idx="59">
                  <c:v>-0.14499999999999999</c:v>
                </c:pt>
                <c:pt idx="60">
                  <c:v>-0.14499999999999999</c:v>
                </c:pt>
                <c:pt idx="61">
                  <c:v>-0.14599999999999999</c:v>
                </c:pt>
                <c:pt idx="62">
                  <c:v>-0.14399999999999999</c:v>
                </c:pt>
                <c:pt idx="63">
                  <c:v>-0.14299999999999999</c:v>
                </c:pt>
                <c:pt idx="64">
                  <c:v>-0.14399999999999999</c:v>
                </c:pt>
                <c:pt idx="65">
                  <c:v>-0.14899999999999999</c:v>
                </c:pt>
                <c:pt idx="66">
                  <c:v>-0.14799999999999999</c:v>
                </c:pt>
                <c:pt idx="67">
                  <c:v>-0.14899999999999999</c:v>
                </c:pt>
                <c:pt idx="68">
                  <c:v>-0.153</c:v>
                </c:pt>
                <c:pt idx="69">
                  <c:v>-0.154</c:v>
                </c:pt>
                <c:pt idx="70">
                  <c:v>-0.153</c:v>
                </c:pt>
                <c:pt idx="71">
                  <c:v>-0.14799999999999999</c:v>
                </c:pt>
                <c:pt idx="72">
                  <c:v>-0.14599999999999999</c:v>
                </c:pt>
                <c:pt idx="73">
                  <c:v>-0.14499999999999999</c:v>
                </c:pt>
                <c:pt idx="74">
                  <c:v>-0.14499999999999999</c:v>
                </c:pt>
                <c:pt idx="75">
                  <c:v>-0.14199999999999999</c:v>
                </c:pt>
                <c:pt idx="76">
                  <c:v>-0.14399999999999999</c:v>
                </c:pt>
                <c:pt idx="77">
                  <c:v>-0.14399999999999999</c:v>
                </c:pt>
                <c:pt idx="78">
                  <c:v>-0.14499999999999999</c:v>
                </c:pt>
                <c:pt idx="79">
                  <c:v>-0.14399999999999999</c:v>
                </c:pt>
                <c:pt idx="80">
                  <c:v>-0.14499999999999999</c:v>
                </c:pt>
                <c:pt idx="81">
                  <c:v>-0.14499999999999999</c:v>
                </c:pt>
                <c:pt idx="82">
                  <c:v>-0.14399999999999999</c:v>
                </c:pt>
                <c:pt idx="83">
                  <c:v>-0.14199999999999999</c:v>
                </c:pt>
                <c:pt idx="84">
                  <c:v>-0.14099999999999999</c:v>
                </c:pt>
                <c:pt idx="85">
                  <c:v>-0.14199999999999999</c:v>
                </c:pt>
                <c:pt idx="86">
                  <c:v>-0.14399999999999999</c:v>
                </c:pt>
                <c:pt idx="87">
                  <c:v>-0.14699999999999999</c:v>
                </c:pt>
                <c:pt idx="88">
                  <c:v>-0.14899999999999999</c:v>
                </c:pt>
                <c:pt idx="89">
                  <c:v>-0.14799999999999999</c:v>
                </c:pt>
                <c:pt idx="90">
                  <c:v>-0.14699999999999999</c:v>
                </c:pt>
                <c:pt idx="91">
                  <c:v>-0.14299999999999999</c:v>
                </c:pt>
                <c:pt idx="92">
                  <c:v>-0.14099999999999999</c:v>
                </c:pt>
                <c:pt idx="93">
                  <c:v>-0.14000000000000001</c:v>
                </c:pt>
                <c:pt idx="94">
                  <c:v>-0.13900000000000001</c:v>
                </c:pt>
                <c:pt idx="95">
                  <c:v>-0.14199999999999999</c:v>
                </c:pt>
                <c:pt idx="96">
                  <c:v>-0.14000000000000001</c:v>
                </c:pt>
                <c:pt idx="97">
                  <c:v>-0.13800000000000001</c:v>
                </c:pt>
                <c:pt idx="98">
                  <c:v>-0.13600000000000001</c:v>
                </c:pt>
                <c:pt idx="99">
                  <c:v>-0.13400000000000001</c:v>
                </c:pt>
                <c:pt idx="100">
                  <c:v>-0.13</c:v>
                </c:pt>
                <c:pt idx="101">
                  <c:v>-0.128</c:v>
                </c:pt>
                <c:pt idx="102">
                  <c:v>-0.13</c:v>
                </c:pt>
                <c:pt idx="103">
                  <c:v>-0.129</c:v>
                </c:pt>
                <c:pt idx="104">
                  <c:v>-0.13400000000000001</c:v>
                </c:pt>
                <c:pt idx="105">
                  <c:v>-0.13600000000000001</c:v>
                </c:pt>
                <c:pt idx="106">
                  <c:v>-0.13600000000000001</c:v>
                </c:pt>
                <c:pt idx="107">
                  <c:v>-0.13600000000000001</c:v>
                </c:pt>
                <c:pt idx="108">
                  <c:v>-0.13600000000000001</c:v>
                </c:pt>
                <c:pt idx="109">
                  <c:v>-0.13600000000000001</c:v>
                </c:pt>
                <c:pt idx="110">
                  <c:v>-0.13300000000000001</c:v>
                </c:pt>
                <c:pt idx="111">
                  <c:v>-0.128</c:v>
                </c:pt>
                <c:pt idx="112">
                  <c:v>-0.13100000000000001</c:v>
                </c:pt>
                <c:pt idx="113">
                  <c:v>-0.13500000000000001</c:v>
                </c:pt>
                <c:pt idx="114">
                  <c:v>-0.13300000000000001</c:v>
                </c:pt>
                <c:pt idx="115">
                  <c:v>-0.13300000000000001</c:v>
                </c:pt>
                <c:pt idx="116">
                  <c:v>-0.13400000000000001</c:v>
                </c:pt>
                <c:pt idx="117">
                  <c:v>-0.13500000000000001</c:v>
                </c:pt>
                <c:pt idx="118">
                  <c:v>-0.13300000000000001</c:v>
                </c:pt>
                <c:pt idx="119">
                  <c:v>-0.13200000000000001</c:v>
                </c:pt>
                <c:pt idx="120">
                  <c:v>-0.13100000000000001</c:v>
                </c:pt>
                <c:pt idx="121">
                  <c:v>-0.13400000000000001</c:v>
                </c:pt>
                <c:pt idx="122">
                  <c:v>-0.13400000000000001</c:v>
                </c:pt>
                <c:pt idx="123">
                  <c:v>-0.13500000000000001</c:v>
                </c:pt>
                <c:pt idx="124">
                  <c:v>-0.13900000000000001</c:v>
                </c:pt>
                <c:pt idx="125">
                  <c:v>-0.14199999999999999</c:v>
                </c:pt>
                <c:pt idx="126">
                  <c:v>-0.14299999999999999</c:v>
                </c:pt>
                <c:pt idx="127">
                  <c:v>-0.14199999999999999</c:v>
                </c:pt>
                <c:pt idx="128">
                  <c:v>-0.14199999999999999</c:v>
                </c:pt>
                <c:pt idx="129">
                  <c:v>-0.14000000000000001</c:v>
                </c:pt>
                <c:pt idx="130">
                  <c:v>-0.13500000000000001</c:v>
                </c:pt>
                <c:pt idx="131">
                  <c:v>-0.13500000000000001</c:v>
                </c:pt>
                <c:pt idx="132">
                  <c:v>-0.13400000000000001</c:v>
                </c:pt>
                <c:pt idx="133">
                  <c:v>-0.13300000000000001</c:v>
                </c:pt>
                <c:pt idx="134">
                  <c:v>-0.13500000000000001</c:v>
                </c:pt>
                <c:pt idx="135">
                  <c:v>-0.13500000000000001</c:v>
                </c:pt>
                <c:pt idx="136">
                  <c:v>-0.13600000000000001</c:v>
                </c:pt>
                <c:pt idx="137">
                  <c:v>-0.13200000000000001</c:v>
                </c:pt>
                <c:pt idx="138">
                  <c:v>-0.13200000000000001</c:v>
                </c:pt>
                <c:pt idx="139">
                  <c:v>-0.13400000000000001</c:v>
                </c:pt>
                <c:pt idx="140">
                  <c:v>-0.13300000000000001</c:v>
                </c:pt>
                <c:pt idx="141">
                  <c:v>-0.13200000000000001</c:v>
                </c:pt>
                <c:pt idx="142">
                  <c:v>-0.13</c:v>
                </c:pt>
                <c:pt idx="143">
                  <c:v>-0.13</c:v>
                </c:pt>
                <c:pt idx="144">
                  <c:v>-0.129</c:v>
                </c:pt>
                <c:pt idx="145">
                  <c:v>-0.13100000000000001</c:v>
                </c:pt>
                <c:pt idx="146">
                  <c:v>-0.13</c:v>
                </c:pt>
                <c:pt idx="147">
                  <c:v>-0.128</c:v>
                </c:pt>
                <c:pt idx="148">
                  <c:v>-0.11899999999999999</c:v>
                </c:pt>
                <c:pt idx="149">
                  <c:v>-0.11600000000000001</c:v>
                </c:pt>
                <c:pt idx="150">
                  <c:v>-0.11700000000000001</c:v>
                </c:pt>
                <c:pt idx="151">
                  <c:v>-0.112</c:v>
                </c:pt>
                <c:pt idx="152">
                  <c:v>-0.109</c:v>
                </c:pt>
                <c:pt idx="153">
                  <c:v>-0.112</c:v>
                </c:pt>
                <c:pt idx="154">
                  <c:v>-0.11700000000000001</c:v>
                </c:pt>
                <c:pt idx="155">
                  <c:v>-0.113</c:v>
                </c:pt>
                <c:pt idx="156">
                  <c:v>-0.114</c:v>
                </c:pt>
                <c:pt idx="157">
                  <c:v>-0.113</c:v>
                </c:pt>
                <c:pt idx="158">
                  <c:v>-0.112</c:v>
                </c:pt>
                <c:pt idx="159">
                  <c:v>-0.11</c:v>
                </c:pt>
                <c:pt idx="160">
                  <c:v>-0.108</c:v>
                </c:pt>
                <c:pt idx="161">
                  <c:v>-0.109</c:v>
                </c:pt>
                <c:pt idx="162">
                  <c:v>-0.105</c:v>
                </c:pt>
                <c:pt idx="163">
                  <c:v>-0.106</c:v>
                </c:pt>
                <c:pt idx="164">
                  <c:v>-0.104</c:v>
                </c:pt>
                <c:pt idx="165">
                  <c:v>-0.105</c:v>
                </c:pt>
                <c:pt idx="166">
                  <c:v>-0.105</c:v>
                </c:pt>
                <c:pt idx="167">
                  <c:v>-0.104</c:v>
                </c:pt>
                <c:pt idx="168">
                  <c:v>-0.10299999999999999</c:v>
                </c:pt>
                <c:pt idx="169">
                  <c:v>-0.10199999999999999</c:v>
                </c:pt>
                <c:pt idx="170">
                  <c:v>-0.10299999999999999</c:v>
                </c:pt>
                <c:pt idx="171">
                  <c:v>-9.8000000000000004E-2</c:v>
                </c:pt>
                <c:pt idx="172">
                  <c:v>-9.8000000000000004E-2</c:v>
                </c:pt>
                <c:pt idx="173">
                  <c:v>-9.4E-2</c:v>
                </c:pt>
                <c:pt idx="174">
                  <c:v>-9.1999999999999998E-2</c:v>
                </c:pt>
                <c:pt idx="175">
                  <c:v>-8.6999999999999994E-2</c:v>
                </c:pt>
                <c:pt idx="176">
                  <c:v>-8.8999999999999996E-2</c:v>
                </c:pt>
                <c:pt idx="177">
                  <c:v>-8.5000000000000006E-2</c:v>
                </c:pt>
                <c:pt idx="178">
                  <c:v>-0.08</c:v>
                </c:pt>
                <c:pt idx="179">
                  <c:v>-8.4000000000000005E-2</c:v>
                </c:pt>
                <c:pt idx="180">
                  <c:v>-8.6999999999999994E-2</c:v>
                </c:pt>
                <c:pt idx="181">
                  <c:v>-8.4000000000000005E-2</c:v>
                </c:pt>
                <c:pt idx="182">
                  <c:v>-8.2000000000000003E-2</c:v>
                </c:pt>
                <c:pt idx="183">
                  <c:v>-8.1000000000000003E-2</c:v>
                </c:pt>
                <c:pt idx="184">
                  <c:v>-8.2000000000000003E-2</c:v>
                </c:pt>
                <c:pt idx="185">
                  <c:v>-7.9000000000000001E-2</c:v>
                </c:pt>
                <c:pt idx="186">
                  <c:v>-7.6999999999999999E-2</c:v>
                </c:pt>
                <c:pt idx="187">
                  <c:v>-7.9000000000000001E-2</c:v>
                </c:pt>
                <c:pt idx="188">
                  <c:v>-7.8E-2</c:v>
                </c:pt>
                <c:pt idx="189">
                  <c:v>-0.08</c:v>
                </c:pt>
                <c:pt idx="190">
                  <c:v>-7.5999999999999998E-2</c:v>
                </c:pt>
                <c:pt idx="191">
                  <c:v>-7.0999999999999994E-2</c:v>
                </c:pt>
                <c:pt idx="192">
                  <c:v>-6.9000000000000006E-2</c:v>
                </c:pt>
                <c:pt idx="193">
                  <c:v>-7.2999999999999995E-2</c:v>
                </c:pt>
                <c:pt idx="194">
                  <c:v>-7.2999999999999995E-2</c:v>
                </c:pt>
                <c:pt idx="195">
                  <c:v>-7.4999999999999997E-2</c:v>
                </c:pt>
                <c:pt idx="196">
                  <c:v>-7.6999999999999999E-2</c:v>
                </c:pt>
                <c:pt idx="197">
                  <c:v>-7.2999999999999995E-2</c:v>
                </c:pt>
                <c:pt idx="198">
                  <c:v>-7.1999999999999995E-2</c:v>
                </c:pt>
                <c:pt idx="199">
                  <c:v>-6.9000000000000006E-2</c:v>
                </c:pt>
                <c:pt idx="200">
                  <c:v>-6.5000000000000002E-2</c:v>
                </c:pt>
                <c:pt idx="201">
                  <c:v>-6.5000000000000002E-2</c:v>
                </c:pt>
                <c:pt idx="202">
                  <c:v>-6.6000000000000003E-2</c:v>
                </c:pt>
                <c:pt idx="203">
                  <c:v>-6.6000000000000003E-2</c:v>
                </c:pt>
                <c:pt idx="204">
                  <c:v>-6.4000000000000001E-2</c:v>
                </c:pt>
                <c:pt idx="205">
                  <c:v>-6.6000000000000003E-2</c:v>
                </c:pt>
                <c:pt idx="206">
                  <c:v>-6.6000000000000003E-2</c:v>
                </c:pt>
                <c:pt idx="207">
                  <c:v>-6.4000000000000001E-2</c:v>
                </c:pt>
                <c:pt idx="208">
                  <c:v>-6.2E-2</c:v>
                </c:pt>
                <c:pt idx="209">
                  <c:v>-6.0999999999999999E-2</c:v>
                </c:pt>
                <c:pt idx="210">
                  <c:v>-0.06</c:v>
                </c:pt>
                <c:pt idx="211">
                  <c:v>-5.6000000000000001E-2</c:v>
                </c:pt>
                <c:pt idx="212">
                  <c:v>-5.3999999999999999E-2</c:v>
                </c:pt>
                <c:pt idx="213">
                  <c:v>-5.1999999999999998E-2</c:v>
                </c:pt>
                <c:pt idx="214">
                  <c:v>-0.05</c:v>
                </c:pt>
                <c:pt idx="215">
                  <c:v>-5.0999999999999997E-2</c:v>
                </c:pt>
                <c:pt idx="216">
                  <c:v>-0.05</c:v>
                </c:pt>
                <c:pt idx="217">
                  <c:v>-4.9000000000000002E-2</c:v>
                </c:pt>
                <c:pt idx="218">
                  <c:v>-4.8000000000000001E-2</c:v>
                </c:pt>
                <c:pt idx="219">
                  <c:v>-4.9000000000000002E-2</c:v>
                </c:pt>
                <c:pt idx="220">
                  <c:v>-4.4999999999999998E-2</c:v>
                </c:pt>
                <c:pt idx="221">
                  <c:v>-4.1000000000000002E-2</c:v>
                </c:pt>
                <c:pt idx="222">
                  <c:v>-3.6999999999999998E-2</c:v>
                </c:pt>
                <c:pt idx="223">
                  <c:v>-3.6999999999999998E-2</c:v>
                </c:pt>
                <c:pt idx="224">
                  <c:v>-0.03</c:v>
                </c:pt>
                <c:pt idx="225">
                  <c:v>-2.9000000000000001E-2</c:v>
                </c:pt>
                <c:pt idx="226">
                  <c:v>-2.7E-2</c:v>
                </c:pt>
                <c:pt idx="227">
                  <c:v>-2.9000000000000001E-2</c:v>
                </c:pt>
                <c:pt idx="228">
                  <c:v>-2.9000000000000001E-2</c:v>
                </c:pt>
                <c:pt idx="229">
                  <c:v>-2.9000000000000001E-2</c:v>
                </c:pt>
                <c:pt idx="230">
                  <c:v>-0.03</c:v>
                </c:pt>
                <c:pt idx="231">
                  <c:v>-0.03</c:v>
                </c:pt>
                <c:pt idx="232">
                  <c:v>-2.8000000000000001E-2</c:v>
                </c:pt>
                <c:pt idx="233">
                  <c:v>-2.3E-2</c:v>
                </c:pt>
                <c:pt idx="234">
                  <c:v>-2.4E-2</c:v>
                </c:pt>
                <c:pt idx="235">
                  <c:v>-0.02</c:v>
                </c:pt>
                <c:pt idx="236">
                  <c:v>-1.6E-2</c:v>
                </c:pt>
                <c:pt idx="237">
                  <c:v>-1.2999999999999999E-2</c:v>
                </c:pt>
                <c:pt idx="238">
                  <c:v>-1.2E-2</c:v>
                </c:pt>
                <c:pt idx="239">
                  <c:v>-0.01</c:v>
                </c:pt>
                <c:pt idx="240">
                  <c:v>-8.0000000000000002E-3</c:v>
                </c:pt>
                <c:pt idx="241">
                  <c:v>-6.0000000000000001E-3</c:v>
                </c:pt>
                <c:pt idx="242">
                  <c:v>-5.0000000000000001E-3</c:v>
                </c:pt>
                <c:pt idx="243">
                  <c:v>-7.0000000000000001E-3</c:v>
                </c:pt>
                <c:pt idx="244">
                  <c:v>-8.0000000000000002E-3</c:v>
                </c:pt>
                <c:pt idx="245">
                  <c:v>-7.0000000000000001E-3</c:v>
                </c:pt>
                <c:pt idx="246">
                  <c:v>-5.0000000000000001E-3</c:v>
                </c:pt>
                <c:pt idx="247">
                  <c:v>-5.0000000000000001E-3</c:v>
                </c:pt>
                <c:pt idx="248">
                  <c:v>-5.0000000000000001E-3</c:v>
                </c:pt>
                <c:pt idx="249">
                  <c:v>-3.0000000000000001E-3</c:v>
                </c:pt>
                <c:pt idx="250">
                  <c:v>-2E-3</c:v>
                </c:pt>
                <c:pt idx="251">
                  <c:v>-1E-3</c:v>
                </c:pt>
                <c:pt idx="252">
                  <c:v>-1E-3</c:v>
                </c:pt>
                <c:pt idx="253">
                  <c:v>0</c:v>
                </c:pt>
                <c:pt idx="254">
                  <c:v>1E-3</c:v>
                </c:pt>
                <c:pt idx="255">
                  <c:v>3.0000000000000001E-3</c:v>
                </c:pt>
                <c:pt idx="256">
                  <c:v>8.9999999999999993E-3</c:v>
                </c:pt>
                <c:pt idx="257">
                  <c:v>1.2E-2</c:v>
                </c:pt>
                <c:pt idx="258">
                  <c:v>1.6E-2</c:v>
                </c:pt>
                <c:pt idx="259">
                  <c:v>0.02</c:v>
                </c:pt>
                <c:pt idx="260">
                  <c:v>2.5000000000000001E-2</c:v>
                </c:pt>
                <c:pt idx="261">
                  <c:v>2.9000000000000001E-2</c:v>
                </c:pt>
                <c:pt idx="262">
                  <c:v>0.03</c:v>
                </c:pt>
                <c:pt idx="263">
                  <c:v>3.3000000000000002E-2</c:v>
                </c:pt>
                <c:pt idx="264">
                  <c:v>3.5000000000000003E-2</c:v>
                </c:pt>
                <c:pt idx="265">
                  <c:v>3.4000000000000002E-2</c:v>
                </c:pt>
                <c:pt idx="266">
                  <c:v>3.4000000000000002E-2</c:v>
                </c:pt>
                <c:pt idx="267">
                  <c:v>3.7999999999999999E-2</c:v>
                </c:pt>
                <c:pt idx="268">
                  <c:v>0.04</c:v>
                </c:pt>
                <c:pt idx="269">
                  <c:v>3.9E-2</c:v>
                </c:pt>
                <c:pt idx="270">
                  <c:v>4.2000000000000003E-2</c:v>
                </c:pt>
                <c:pt idx="271">
                  <c:v>4.5999999999999999E-2</c:v>
                </c:pt>
                <c:pt idx="272">
                  <c:v>4.9000000000000002E-2</c:v>
                </c:pt>
                <c:pt idx="273">
                  <c:v>5.5E-2</c:v>
                </c:pt>
                <c:pt idx="274">
                  <c:v>5.7000000000000002E-2</c:v>
                </c:pt>
                <c:pt idx="275">
                  <c:v>5.8999999999999997E-2</c:v>
                </c:pt>
                <c:pt idx="276">
                  <c:v>6.3E-2</c:v>
                </c:pt>
                <c:pt idx="277">
                  <c:v>6.7000000000000004E-2</c:v>
                </c:pt>
                <c:pt idx="278">
                  <c:v>6.5000000000000002E-2</c:v>
                </c:pt>
                <c:pt idx="279">
                  <c:v>6.8000000000000005E-2</c:v>
                </c:pt>
                <c:pt idx="280">
                  <c:v>7.0999999999999994E-2</c:v>
                </c:pt>
                <c:pt idx="281">
                  <c:v>7.2999999999999995E-2</c:v>
                </c:pt>
                <c:pt idx="282">
                  <c:v>7.1999999999999995E-2</c:v>
                </c:pt>
                <c:pt idx="283">
                  <c:v>7.3999999999999996E-2</c:v>
                </c:pt>
                <c:pt idx="284">
                  <c:v>7.3999999999999996E-2</c:v>
                </c:pt>
                <c:pt idx="285">
                  <c:v>7.0999999999999994E-2</c:v>
                </c:pt>
                <c:pt idx="286">
                  <c:v>7.3999999999999996E-2</c:v>
                </c:pt>
                <c:pt idx="287">
                  <c:v>7.4999999999999997E-2</c:v>
                </c:pt>
                <c:pt idx="288">
                  <c:v>7.5999999999999998E-2</c:v>
                </c:pt>
                <c:pt idx="289">
                  <c:v>7.6999999999999999E-2</c:v>
                </c:pt>
                <c:pt idx="290">
                  <c:v>7.9000000000000001E-2</c:v>
                </c:pt>
                <c:pt idx="291">
                  <c:v>7.9000000000000001E-2</c:v>
                </c:pt>
                <c:pt idx="292">
                  <c:v>7.9000000000000001E-2</c:v>
                </c:pt>
                <c:pt idx="293">
                  <c:v>7.9000000000000001E-2</c:v>
                </c:pt>
                <c:pt idx="294">
                  <c:v>0.08</c:v>
                </c:pt>
                <c:pt idx="295">
                  <c:v>8.2000000000000003E-2</c:v>
                </c:pt>
                <c:pt idx="296">
                  <c:v>8.6999999999999994E-2</c:v>
                </c:pt>
                <c:pt idx="297">
                  <c:v>8.8999999999999996E-2</c:v>
                </c:pt>
                <c:pt idx="298">
                  <c:v>8.8999999999999996E-2</c:v>
                </c:pt>
                <c:pt idx="299">
                  <c:v>9.0999999999999998E-2</c:v>
                </c:pt>
                <c:pt idx="300">
                  <c:v>9.6000000000000002E-2</c:v>
                </c:pt>
                <c:pt idx="301">
                  <c:v>9.6000000000000002E-2</c:v>
                </c:pt>
                <c:pt idx="302">
                  <c:v>9.7000000000000003E-2</c:v>
                </c:pt>
                <c:pt idx="303">
                  <c:v>0.10100000000000001</c:v>
                </c:pt>
                <c:pt idx="304">
                  <c:v>0.104</c:v>
                </c:pt>
                <c:pt idx="305">
                  <c:v>0.106</c:v>
                </c:pt>
                <c:pt idx="306">
                  <c:v>0.109</c:v>
                </c:pt>
                <c:pt idx="307">
                  <c:v>0.11799999999999999</c:v>
                </c:pt>
                <c:pt idx="308">
                  <c:v>0.128</c:v>
                </c:pt>
                <c:pt idx="309">
                  <c:v>0.13900000000000001</c:v>
                </c:pt>
                <c:pt idx="310">
                  <c:v>0.152</c:v>
                </c:pt>
                <c:pt idx="311">
                  <c:v>0.17199999999999999</c:v>
                </c:pt>
                <c:pt idx="312">
                  <c:v>0.186</c:v>
                </c:pt>
                <c:pt idx="313">
                  <c:v>0.19600000000000001</c:v>
                </c:pt>
                <c:pt idx="314">
                  <c:v>0.20799999999999999</c:v>
                </c:pt>
                <c:pt idx="315">
                  <c:v>0.216</c:v>
                </c:pt>
                <c:pt idx="316">
                  <c:v>0.223</c:v>
                </c:pt>
                <c:pt idx="317">
                  <c:v>0.22700000000000001</c:v>
                </c:pt>
                <c:pt idx="318">
                  <c:v>0.23100000000000001</c:v>
                </c:pt>
                <c:pt idx="319">
                  <c:v>0.23100000000000001</c:v>
                </c:pt>
                <c:pt idx="320">
                  <c:v>0.23100000000000001</c:v>
                </c:pt>
                <c:pt idx="321">
                  <c:v>0.22600000000000001</c:v>
                </c:pt>
                <c:pt idx="322">
                  <c:v>0.216</c:v>
                </c:pt>
                <c:pt idx="323">
                  <c:v>0.20899999999999999</c:v>
                </c:pt>
                <c:pt idx="324">
                  <c:v>0.19800000000000001</c:v>
                </c:pt>
                <c:pt idx="325">
                  <c:v>0.19</c:v>
                </c:pt>
                <c:pt idx="326">
                  <c:v>0.183</c:v>
                </c:pt>
                <c:pt idx="327">
                  <c:v>0.17699999999999999</c:v>
                </c:pt>
                <c:pt idx="328">
                  <c:v>0.16900000000000001</c:v>
                </c:pt>
                <c:pt idx="329">
                  <c:v>0.16400000000000001</c:v>
                </c:pt>
                <c:pt idx="330">
                  <c:v>0.158</c:v>
                </c:pt>
                <c:pt idx="331">
                  <c:v>0.151</c:v>
                </c:pt>
                <c:pt idx="332">
                  <c:v>0.14699999999999999</c:v>
                </c:pt>
                <c:pt idx="333">
                  <c:v>0.14099999999999999</c:v>
                </c:pt>
                <c:pt idx="334">
                  <c:v>0.13900000000000001</c:v>
                </c:pt>
                <c:pt idx="335">
                  <c:v>0.13400000000000001</c:v>
                </c:pt>
                <c:pt idx="336">
                  <c:v>0.13</c:v>
                </c:pt>
                <c:pt idx="337">
                  <c:v>0.128</c:v>
                </c:pt>
                <c:pt idx="338">
                  <c:v>0.126</c:v>
                </c:pt>
                <c:pt idx="339">
                  <c:v>0.12</c:v>
                </c:pt>
                <c:pt idx="340">
                  <c:v>0.11899999999999999</c:v>
                </c:pt>
                <c:pt idx="341">
                  <c:v>0.11799999999999999</c:v>
                </c:pt>
                <c:pt idx="342">
                  <c:v>0.11600000000000001</c:v>
                </c:pt>
                <c:pt idx="343">
                  <c:v>0.112</c:v>
                </c:pt>
                <c:pt idx="344">
                  <c:v>0.108</c:v>
                </c:pt>
                <c:pt idx="345">
                  <c:v>0.111</c:v>
                </c:pt>
                <c:pt idx="346">
                  <c:v>0.107</c:v>
                </c:pt>
                <c:pt idx="347">
                  <c:v>0.106</c:v>
                </c:pt>
                <c:pt idx="348">
                  <c:v>0.106</c:v>
                </c:pt>
                <c:pt idx="349">
                  <c:v>0.10199999999999999</c:v>
                </c:pt>
                <c:pt idx="350">
                  <c:v>0.10199999999999999</c:v>
                </c:pt>
                <c:pt idx="351">
                  <c:v>9.9000000000000005E-2</c:v>
                </c:pt>
                <c:pt idx="352">
                  <c:v>9.8000000000000004E-2</c:v>
                </c:pt>
                <c:pt idx="353">
                  <c:v>9.8000000000000004E-2</c:v>
                </c:pt>
                <c:pt idx="354">
                  <c:v>9.5000000000000001E-2</c:v>
                </c:pt>
                <c:pt idx="355">
                  <c:v>9.9000000000000005E-2</c:v>
                </c:pt>
                <c:pt idx="356">
                  <c:v>9.9000000000000005E-2</c:v>
                </c:pt>
                <c:pt idx="357">
                  <c:v>0.10199999999999999</c:v>
                </c:pt>
                <c:pt idx="358">
                  <c:v>0.10100000000000001</c:v>
                </c:pt>
                <c:pt idx="359">
                  <c:v>0.10100000000000001</c:v>
                </c:pt>
                <c:pt idx="360">
                  <c:v>0.10100000000000001</c:v>
                </c:pt>
                <c:pt idx="361">
                  <c:v>9.9000000000000005E-2</c:v>
                </c:pt>
                <c:pt idx="362">
                  <c:v>0.1</c:v>
                </c:pt>
                <c:pt idx="363">
                  <c:v>9.7000000000000003E-2</c:v>
                </c:pt>
                <c:pt idx="364">
                  <c:v>9.5000000000000001E-2</c:v>
                </c:pt>
                <c:pt idx="365">
                  <c:v>9.5000000000000001E-2</c:v>
                </c:pt>
                <c:pt idx="366">
                  <c:v>9.7000000000000003E-2</c:v>
                </c:pt>
                <c:pt idx="367">
                  <c:v>9.8000000000000004E-2</c:v>
                </c:pt>
                <c:pt idx="368">
                  <c:v>9.2999999999999999E-2</c:v>
                </c:pt>
                <c:pt idx="369">
                  <c:v>9.2999999999999999E-2</c:v>
                </c:pt>
                <c:pt idx="370">
                  <c:v>9.0999999999999998E-2</c:v>
                </c:pt>
                <c:pt idx="371">
                  <c:v>8.8999999999999996E-2</c:v>
                </c:pt>
                <c:pt idx="372">
                  <c:v>8.5000000000000006E-2</c:v>
                </c:pt>
                <c:pt idx="373">
                  <c:v>8.6999999999999994E-2</c:v>
                </c:pt>
                <c:pt idx="374">
                  <c:v>8.7999999999999995E-2</c:v>
                </c:pt>
                <c:pt idx="375">
                  <c:v>8.6999999999999994E-2</c:v>
                </c:pt>
                <c:pt idx="376">
                  <c:v>0.09</c:v>
                </c:pt>
                <c:pt idx="377">
                  <c:v>8.8999999999999996E-2</c:v>
                </c:pt>
                <c:pt idx="378">
                  <c:v>8.7999999999999995E-2</c:v>
                </c:pt>
                <c:pt idx="379">
                  <c:v>8.5999999999999993E-2</c:v>
                </c:pt>
                <c:pt idx="380">
                  <c:v>8.5999999999999993E-2</c:v>
                </c:pt>
                <c:pt idx="381">
                  <c:v>8.5999999999999993E-2</c:v>
                </c:pt>
                <c:pt idx="382">
                  <c:v>8.1000000000000003E-2</c:v>
                </c:pt>
                <c:pt idx="383">
                  <c:v>7.8E-2</c:v>
                </c:pt>
                <c:pt idx="384">
                  <c:v>7.4999999999999997E-2</c:v>
                </c:pt>
                <c:pt idx="385">
                  <c:v>7.5999999999999998E-2</c:v>
                </c:pt>
                <c:pt idx="386">
                  <c:v>7.6999999999999999E-2</c:v>
                </c:pt>
                <c:pt idx="387">
                  <c:v>7.9000000000000001E-2</c:v>
                </c:pt>
                <c:pt idx="388">
                  <c:v>7.6999999999999999E-2</c:v>
                </c:pt>
                <c:pt idx="389">
                  <c:v>7.8E-2</c:v>
                </c:pt>
                <c:pt idx="390">
                  <c:v>7.6999999999999999E-2</c:v>
                </c:pt>
                <c:pt idx="391">
                  <c:v>7.5999999999999998E-2</c:v>
                </c:pt>
                <c:pt idx="392">
                  <c:v>6.8000000000000005E-2</c:v>
                </c:pt>
                <c:pt idx="393">
                  <c:v>7.1999999999999995E-2</c:v>
                </c:pt>
                <c:pt idx="394">
                  <c:v>7.1999999999999995E-2</c:v>
                </c:pt>
                <c:pt idx="395">
                  <c:v>7.3999999999999996E-2</c:v>
                </c:pt>
                <c:pt idx="396">
                  <c:v>7.4999999999999997E-2</c:v>
                </c:pt>
                <c:pt idx="397">
                  <c:v>7.8E-2</c:v>
                </c:pt>
                <c:pt idx="398">
                  <c:v>7.3999999999999996E-2</c:v>
                </c:pt>
                <c:pt idx="399">
                  <c:v>7.6999999999999999E-2</c:v>
                </c:pt>
                <c:pt idx="400">
                  <c:v>7.6999999999999999E-2</c:v>
                </c:pt>
                <c:pt idx="401">
                  <c:v>7.6999999999999999E-2</c:v>
                </c:pt>
                <c:pt idx="402">
                  <c:v>7.5999999999999998E-2</c:v>
                </c:pt>
                <c:pt idx="403">
                  <c:v>7.6999999999999999E-2</c:v>
                </c:pt>
                <c:pt idx="404">
                  <c:v>7.8E-2</c:v>
                </c:pt>
                <c:pt idx="405">
                  <c:v>7.1999999999999995E-2</c:v>
                </c:pt>
                <c:pt idx="406">
                  <c:v>6.8000000000000005E-2</c:v>
                </c:pt>
                <c:pt idx="407">
                  <c:v>6.5000000000000002E-2</c:v>
                </c:pt>
                <c:pt idx="408">
                  <c:v>6.5000000000000002E-2</c:v>
                </c:pt>
                <c:pt idx="409">
                  <c:v>6.4000000000000001E-2</c:v>
                </c:pt>
                <c:pt idx="410">
                  <c:v>6.5000000000000002E-2</c:v>
                </c:pt>
                <c:pt idx="411">
                  <c:v>6.5000000000000002E-2</c:v>
                </c:pt>
                <c:pt idx="412">
                  <c:v>6.4000000000000001E-2</c:v>
                </c:pt>
                <c:pt idx="413">
                  <c:v>6.4000000000000001E-2</c:v>
                </c:pt>
                <c:pt idx="414">
                  <c:v>6.6000000000000003E-2</c:v>
                </c:pt>
                <c:pt idx="415">
                  <c:v>6.7000000000000004E-2</c:v>
                </c:pt>
                <c:pt idx="416">
                  <c:v>7.0000000000000007E-2</c:v>
                </c:pt>
                <c:pt idx="417">
                  <c:v>7.0999999999999994E-2</c:v>
                </c:pt>
                <c:pt idx="418">
                  <c:v>6.9000000000000006E-2</c:v>
                </c:pt>
                <c:pt idx="419">
                  <c:v>7.2999999999999995E-2</c:v>
                </c:pt>
                <c:pt idx="420">
                  <c:v>7.2999999999999995E-2</c:v>
                </c:pt>
                <c:pt idx="421">
                  <c:v>7.3999999999999996E-2</c:v>
                </c:pt>
                <c:pt idx="422">
                  <c:v>7.2999999999999995E-2</c:v>
                </c:pt>
                <c:pt idx="423">
                  <c:v>7.3999999999999996E-2</c:v>
                </c:pt>
                <c:pt idx="424">
                  <c:v>7.3999999999999996E-2</c:v>
                </c:pt>
                <c:pt idx="425">
                  <c:v>6.9000000000000006E-2</c:v>
                </c:pt>
                <c:pt idx="426">
                  <c:v>6.7000000000000004E-2</c:v>
                </c:pt>
                <c:pt idx="427">
                  <c:v>6.6000000000000003E-2</c:v>
                </c:pt>
                <c:pt idx="428">
                  <c:v>6.3E-2</c:v>
                </c:pt>
                <c:pt idx="429">
                  <c:v>6.5000000000000002E-2</c:v>
                </c:pt>
                <c:pt idx="430">
                  <c:v>0.06</c:v>
                </c:pt>
                <c:pt idx="431">
                  <c:v>6.0999999999999999E-2</c:v>
                </c:pt>
                <c:pt idx="432">
                  <c:v>6.0999999999999999E-2</c:v>
                </c:pt>
                <c:pt idx="433">
                  <c:v>0.06</c:v>
                </c:pt>
                <c:pt idx="434">
                  <c:v>5.5E-2</c:v>
                </c:pt>
                <c:pt idx="435">
                  <c:v>5.3999999999999999E-2</c:v>
                </c:pt>
                <c:pt idx="436">
                  <c:v>5.5E-2</c:v>
                </c:pt>
                <c:pt idx="437">
                  <c:v>5.7000000000000002E-2</c:v>
                </c:pt>
                <c:pt idx="438">
                  <c:v>6.0999999999999999E-2</c:v>
                </c:pt>
                <c:pt idx="439">
                  <c:v>6.7000000000000004E-2</c:v>
                </c:pt>
                <c:pt idx="440">
                  <c:v>7.6999999999999999E-2</c:v>
                </c:pt>
                <c:pt idx="441">
                  <c:v>8.7999999999999995E-2</c:v>
                </c:pt>
                <c:pt idx="442">
                  <c:v>0.10199999999999999</c:v>
                </c:pt>
                <c:pt idx="443">
                  <c:v>0.126</c:v>
                </c:pt>
                <c:pt idx="444">
                  <c:v>0.151</c:v>
                </c:pt>
                <c:pt idx="445">
                  <c:v>0.18099999999999999</c:v>
                </c:pt>
                <c:pt idx="446">
                  <c:v>0.224</c:v>
                </c:pt>
                <c:pt idx="447">
                  <c:v>0.27900000000000003</c:v>
                </c:pt>
                <c:pt idx="448">
                  <c:v>0.34300000000000003</c:v>
                </c:pt>
                <c:pt idx="449">
                  <c:v>0.41899999999999998</c:v>
                </c:pt>
                <c:pt idx="450">
                  <c:v>0.51900000000000002</c:v>
                </c:pt>
                <c:pt idx="451">
                  <c:v>0.63</c:v>
                </c:pt>
                <c:pt idx="452">
                  <c:v>0.76800000000000002</c:v>
                </c:pt>
                <c:pt idx="453">
                  <c:v>0.92100000000000004</c:v>
                </c:pt>
                <c:pt idx="454">
                  <c:v>1.103</c:v>
                </c:pt>
                <c:pt idx="455">
                  <c:v>1.319</c:v>
                </c:pt>
                <c:pt idx="456">
                  <c:v>1.5720000000000001</c:v>
                </c:pt>
                <c:pt idx="457">
                  <c:v>1.8440000000000001</c:v>
                </c:pt>
                <c:pt idx="458">
                  <c:v>2.1669999999999998</c:v>
                </c:pt>
                <c:pt idx="459">
                  <c:v>2.5499999999999998</c:v>
                </c:pt>
                <c:pt idx="460">
                  <c:v>2.9860000000000002</c:v>
                </c:pt>
                <c:pt idx="461">
                  <c:v>3.4369999999999998</c:v>
                </c:pt>
                <c:pt idx="462">
                  <c:v>3.9940000000000002</c:v>
                </c:pt>
                <c:pt idx="463">
                  <c:v>4.625</c:v>
                </c:pt>
                <c:pt idx="464">
                  <c:v>5.2869999999999999</c:v>
                </c:pt>
                <c:pt idx="465">
                  <c:v>6.0570000000000004</c:v>
                </c:pt>
                <c:pt idx="466">
                  <c:v>6.9470000000000001</c:v>
                </c:pt>
                <c:pt idx="467">
                  <c:v>7.9279999999999999</c:v>
                </c:pt>
                <c:pt idx="468">
                  <c:v>9.01</c:v>
                </c:pt>
                <c:pt idx="469">
                  <c:v>10.201000000000001</c:v>
                </c:pt>
                <c:pt idx="470">
                  <c:v>11.574999999999999</c:v>
                </c:pt>
                <c:pt idx="471">
                  <c:v>13.06</c:v>
                </c:pt>
                <c:pt idx="472">
                  <c:v>14.664999999999999</c:v>
                </c:pt>
                <c:pt idx="473">
                  <c:v>16.515999999999998</c:v>
                </c:pt>
                <c:pt idx="474">
                  <c:v>18.466000000000001</c:v>
                </c:pt>
                <c:pt idx="475">
                  <c:v>20.692</c:v>
                </c:pt>
                <c:pt idx="476">
                  <c:v>23.062000000000001</c:v>
                </c:pt>
                <c:pt idx="477">
                  <c:v>25.56</c:v>
                </c:pt>
                <c:pt idx="478">
                  <c:v>28.367000000000001</c:v>
                </c:pt>
                <c:pt idx="479">
                  <c:v>31.449000000000002</c:v>
                </c:pt>
                <c:pt idx="480">
                  <c:v>34.566000000000003</c:v>
                </c:pt>
                <c:pt idx="481">
                  <c:v>37.982999999999997</c:v>
                </c:pt>
                <c:pt idx="482">
                  <c:v>41.783000000000001</c:v>
                </c:pt>
                <c:pt idx="483">
                  <c:v>45.805999999999997</c:v>
                </c:pt>
                <c:pt idx="484">
                  <c:v>49.774000000000001</c:v>
                </c:pt>
                <c:pt idx="485">
                  <c:v>54.279000000000003</c:v>
                </c:pt>
                <c:pt idx="486">
                  <c:v>59.076999999999998</c:v>
                </c:pt>
                <c:pt idx="487">
                  <c:v>63.978000000000002</c:v>
                </c:pt>
                <c:pt idx="488">
                  <c:v>68.998999999999995</c:v>
                </c:pt>
                <c:pt idx="489">
                  <c:v>74.593999999999994</c:v>
                </c:pt>
                <c:pt idx="490">
                  <c:v>80.301000000000002</c:v>
                </c:pt>
                <c:pt idx="491">
                  <c:v>86.361999999999995</c:v>
                </c:pt>
                <c:pt idx="492">
                  <c:v>92.414000000000001</c:v>
                </c:pt>
                <c:pt idx="493">
                  <c:v>98.992000000000004</c:v>
                </c:pt>
                <c:pt idx="494">
                  <c:v>105.68600000000001</c:v>
                </c:pt>
                <c:pt idx="495">
                  <c:v>112.77</c:v>
                </c:pt>
                <c:pt idx="496">
                  <c:v>119.651</c:v>
                </c:pt>
                <c:pt idx="497">
                  <c:v>126.739</c:v>
                </c:pt>
                <c:pt idx="498">
                  <c:v>134.23400000000001</c:v>
                </c:pt>
                <c:pt idx="499">
                  <c:v>141.54599999999999</c:v>
                </c:pt>
                <c:pt idx="500">
                  <c:v>148.76599999999999</c:v>
                </c:pt>
                <c:pt idx="501">
                  <c:v>156.209</c:v>
                </c:pt>
                <c:pt idx="502">
                  <c:v>163.63399999999999</c:v>
                </c:pt>
                <c:pt idx="503">
                  <c:v>170.63399999999999</c:v>
                </c:pt>
                <c:pt idx="504">
                  <c:v>177.315</c:v>
                </c:pt>
                <c:pt idx="505">
                  <c:v>184.13499999999999</c:v>
                </c:pt>
                <c:pt idx="506">
                  <c:v>190.61199999999999</c:v>
                </c:pt>
                <c:pt idx="507">
                  <c:v>196.32300000000001</c:v>
                </c:pt>
                <c:pt idx="508">
                  <c:v>202.16399999999999</c:v>
                </c:pt>
                <c:pt idx="509">
                  <c:v>207.697</c:v>
                </c:pt>
                <c:pt idx="510">
                  <c:v>212.68</c:v>
                </c:pt>
                <c:pt idx="511">
                  <c:v>217.33799999999999</c:v>
                </c:pt>
                <c:pt idx="512">
                  <c:v>221.68</c:v>
                </c:pt>
                <c:pt idx="513">
                  <c:v>225.66800000000001</c:v>
                </c:pt>
                <c:pt idx="514">
                  <c:v>229.43600000000001</c:v>
                </c:pt>
                <c:pt idx="515">
                  <c:v>232.76</c:v>
                </c:pt>
                <c:pt idx="516">
                  <c:v>235.934</c:v>
                </c:pt>
                <c:pt idx="517">
                  <c:v>238.82499999999999</c:v>
                </c:pt>
                <c:pt idx="518">
                  <c:v>241.536</c:v>
                </c:pt>
                <c:pt idx="519">
                  <c:v>243.876</c:v>
                </c:pt>
                <c:pt idx="520">
                  <c:v>246.02699999999999</c:v>
                </c:pt>
                <c:pt idx="521">
                  <c:v>248.07400000000001</c:v>
                </c:pt>
                <c:pt idx="522">
                  <c:v>249.85300000000001</c:v>
                </c:pt>
                <c:pt idx="523">
                  <c:v>251.459</c:v>
                </c:pt>
                <c:pt idx="524">
                  <c:v>252.97399999999999</c:v>
                </c:pt>
                <c:pt idx="525">
                  <c:v>254.352</c:v>
                </c:pt>
                <c:pt idx="526">
                  <c:v>255.56200000000001</c:v>
                </c:pt>
                <c:pt idx="527">
                  <c:v>256.60500000000002</c:v>
                </c:pt>
                <c:pt idx="528">
                  <c:v>257.58</c:v>
                </c:pt>
                <c:pt idx="529">
                  <c:v>258.423</c:v>
                </c:pt>
                <c:pt idx="530">
                  <c:v>259.13299999999998</c:v>
                </c:pt>
                <c:pt idx="531">
                  <c:v>259.71100000000001</c:v>
                </c:pt>
                <c:pt idx="532">
                  <c:v>260.21499999999997</c:v>
                </c:pt>
                <c:pt idx="533">
                  <c:v>260.61</c:v>
                </c:pt>
                <c:pt idx="534">
                  <c:v>260.90100000000001</c:v>
                </c:pt>
                <c:pt idx="535">
                  <c:v>261.08600000000001</c:v>
                </c:pt>
                <c:pt idx="536">
                  <c:v>261.18799999999999</c:v>
                </c:pt>
                <c:pt idx="537">
                  <c:v>261.2</c:v>
                </c:pt>
                <c:pt idx="538">
                  <c:v>261.12900000000002</c:v>
                </c:pt>
                <c:pt idx="539">
                  <c:v>260.97899999999998</c:v>
                </c:pt>
                <c:pt idx="540">
                  <c:v>260.75099999999998</c:v>
                </c:pt>
                <c:pt idx="541">
                  <c:v>260.44400000000002</c:v>
                </c:pt>
                <c:pt idx="542">
                  <c:v>260.07900000000001</c:v>
                </c:pt>
                <c:pt idx="543">
                  <c:v>259.64600000000002</c:v>
                </c:pt>
                <c:pt idx="544">
                  <c:v>259.11900000000003</c:v>
                </c:pt>
                <c:pt idx="545">
                  <c:v>258.51499999999999</c:v>
                </c:pt>
                <c:pt idx="546">
                  <c:v>257.88799999999998</c:v>
                </c:pt>
                <c:pt idx="547">
                  <c:v>257.14299999999997</c:v>
                </c:pt>
                <c:pt idx="548">
                  <c:v>256.31</c:v>
                </c:pt>
                <c:pt idx="549">
                  <c:v>255.43100000000001</c:v>
                </c:pt>
                <c:pt idx="550">
                  <c:v>254.50899999999999</c:v>
                </c:pt>
                <c:pt idx="551">
                  <c:v>253.43899999999999</c:v>
                </c:pt>
                <c:pt idx="552">
                  <c:v>252.297</c:v>
                </c:pt>
                <c:pt idx="553">
                  <c:v>251.07900000000001</c:v>
                </c:pt>
                <c:pt idx="554">
                  <c:v>249.797</c:v>
                </c:pt>
                <c:pt idx="555">
                  <c:v>248.35</c:v>
                </c:pt>
                <c:pt idx="556">
                  <c:v>246.84</c:v>
                </c:pt>
                <c:pt idx="557">
                  <c:v>245.155</c:v>
                </c:pt>
                <c:pt idx="558">
                  <c:v>243.44800000000001</c:v>
                </c:pt>
                <c:pt idx="559">
                  <c:v>241.60300000000001</c:v>
                </c:pt>
                <c:pt idx="560">
                  <c:v>239.53200000000001</c:v>
                </c:pt>
                <c:pt idx="561">
                  <c:v>237.36</c:v>
                </c:pt>
                <c:pt idx="562">
                  <c:v>235.13900000000001</c:v>
                </c:pt>
                <c:pt idx="563">
                  <c:v>232.66399999999999</c:v>
                </c:pt>
                <c:pt idx="564">
                  <c:v>229.976</c:v>
                </c:pt>
                <c:pt idx="565">
                  <c:v>227.16</c:v>
                </c:pt>
                <c:pt idx="566">
                  <c:v>224.32499999999999</c:v>
                </c:pt>
                <c:pt idx="567">
                  <c:v>221.03</c:v>
                </c:pt>
                <c:pt idx="568">
                  <c:v>217.43600000000001</c:v>
                </c:pt>
                <c:pt idx="569">
                  <c:v>213.875</c:v>
                </c:pt>
                <c:pt idx="570">
                  <c:v>209.98699999999999</c:v>
                </c:pt>
                <c:pt idx="571">
                  <c:v>205.773</c:v>
                </c:pt>
                <c:pt idx="572">
                  <c:v>201.422</c:v>
                </c:pt>
                <c:pt idx="573">
                  <c:v>196.87200000000001</c:v>
                </c:pt>
                <c:pt idx="574">
                  <c:v>192.24700000000001</c:v>
                </c:pt>
                <c:pt idx="575">
                  <c:v>187.21199999999999</c:v>
                </c:pt>
                <c:pt idx="576">
                  <c:v>181.904</c:v>
                </c:pt>
                <c:pt idx="577">
                  <c:v>176.51900000000001</c:v>
                </c:pt>
                <c:pt idx="578">
                  <c:v>170.81</c:v>
                </c:pt>
                <c:pt idx="579">
                  <c:v>164.97900000000001</c:v>
                </c:pt>
                <c:pt idx="580">
                  <c:v>158.78899999999999</c:v>
                </c:pt>
                <c:pt idx="581">
                  <c:v>152.60599999999999</c:v>
                </c:pt>
                <c:pt idx="582">
                  <c:v>146.625</c:v>
                </c:pt>
                <c:pt idx="583">
                  <c:v>140.078</c:v>
                </c:pt>
                <c:pt idx="584">
                  <c:v>133.49600000000001</c:v>
                </c:pt>
                <c:pt idx="585">
                  <c:v>127.41800000000001</c:v>
                </c:pt>
                <c:pt idx="586">
                  <c:v>121.056</c:v>
                </c:pt>
                <c:pt idx="587">
                  <c:v>114.724</c:v>
                </c:pt>
                <c:pt idx="588">
                  <c:v>108.724</c:v>
                </c:pt>
                <c:pt idx="589">
                  <c:v>103.173</c:v>
                </c:pt>
                <c:pt idx="590">
                  <c:v>97.683999999999997</c:v>
                </c:pt>
                <c:pt idx="591">
                  <c:v>92.433999999999997</c:v>
                </c:pt>
                <c:pt idx="592">
                  <c:v>87.768000000000001</c:v>
                </c:pt>
                <c:pt idx="593">
                  <c:v>83.474999999999994</c:v>
                </c:pt>
                <c:pt idx="594">
                  <c:v>79.311999999999998</c:v>
                </c:pt>
                <c:pt idx="595">
                  <c:v>75.688000000000002</c:v>
                </c:pt>
                <c:pt idx="596">
                  <c:v>72.296000000000006</c:v>
                </c:pt>
                <c:pt idx="597">
                  <c:v>69.356999999999999</c:v>
                </c:pt>
                <c:pt idx="598">
                  <c:v>66.677999999999997</c:v>
                </c:pt>
                <c:pt idx="599">
                  <c:v>64.22</c:v>
                </c:pt>
                <c:pt idx="600">
                  <c:v>61.966000000000001</c:v>
                </c:pt>
                <c:pt idx="601">
                  <c:v>60.088999999999999</c:v>
                </c:pt>
                <c:pt idx="602">
                  <c:v>58.326999999999998</c:v>
                </c:pt>
                <c:pt idx="603">
                  <c:v>56.679000000000002</c:v>
                </c:pt>
                <c:pt idx="604">
                  <c:v>55.209000000000003</c:v>
                </c:pt>
                <c:pt idx="605">
                  <c:v>53.973999999999997</c:v>
                </c:pt>
                <c:pt idx="606">
                  <c:v>52.734000000000002</c:v>
                </c:pt>
                <c:pt idx="607">
                  <c:v>51.588000000000001</c:v>
                </c:pt>
                <c:pt idx="608">
                  <c:v>50.576000000000001</c:v>
                </c:pt>
                <c:pt idx="609">
                  <c:v>49.631999999999998</c:v>
                </c:pt>
                <c:pt idx="610">
                  <c:v>48.71</c:v>
                </c:pt>
                <c:pt idx="611">
                  <c:v>47.863</c:v>
                </c:pt>
                <c:pt idx="612">
                  <c:v>47.097999999999999</c:v>
                </c:pt>
                <c:pt idx="613">
                  <c:v>46.347999999999999</c:v>
                </c:pt>
                <c:pt idx="614">
                  <c:v>45.637</c:v>
                </c:pt>
                <c:pt idx="615">
                  <c:v>44.988999999999997</c:v>
                </c:pt>
                <c:pt idx="616">
                  <c:v>44.383000000000003</c:v>
                </c:pt>
                <c:pt idx="617">
                  <c:v>43.777999999999999</c:v>
                </c:pt>
                <c:pt idx="618">
                  <c:v>43.220999999999997</c:v>
                </c:pt>
                <c:pt idx="619">
                  <c:v>42.677</c:v>
                </c:pt>
                <c:pt idx="620">
                  <c:v>42.177999999999997</c:v>
                </c:pt>
                <c:pt idx="621">
                  <c:v>41.694000000000003</c:v>
                </c:pt>
                <c:pt idx="622">
                  <c:v>41.222999999999999</c:v>
                </c:pt>
                <c:pt idx="623">
                  <c:v>40.764000000000003</c:v>
                </c:pt>
                <c:pt idx="624">
                  <c:v>40.353999999999999</c:v>
                </c:pt>
                <c:pt idx="625">
                  <c:v>39.948</c:v>
                </c:pt>
                <c:pt idx="626">
                  <c:v>39.548999999999999</c:v>
                </c:pt>
                <c:pt idx="627">
                  <c:v>39.173000000000002</c:v>
                </c:pt>
                <c:pt idx="628">
                  <c:v>38.841000000000001</c:v>
                </c:pt>
                <c:pt idx="629">
                  <c:v>38.494</c:v>
                </c:pt>
                <c:pt idx="630">
                  <c:v>38.164999999999999</c:v>
                </c:pt>
                <c:pt idx="631">
                  <c:v>37.863999999999997</c:v>
                </c:pt>
                <c:pt idx="632">
                  <c:v>37.57</c:v>
                </c:pt>
                <c:pt idx="633">
                  <c:v>37.274999999999999</c:v>
                </c:pt>
                <c:pt idx="634">
                  <c:v>36.996000000000002</c:v>
                </c:pt>
                <c:pt idx="635">
                  <c:v>36.725000000000001</c:v>
                </c:pt>
                <c:pt idx="636">
                  <c:v>36.478999999999999</c:v>
                </c:pt>
                <c:pt idx="637">
                  <c:v>36.226999999999997</c:v>
                </c:pt>
                <c:pt idx="638">
                  <c:v>35.997</c:v>
                </c:pt>
                <c:pt idx="639">
                  <c:v>35.768999999999998</c:v>
                </c:pt>
                <c:pt idx="640">
                  <c:v>35.552</c:v>
                </c:pt>
                <c:pt idx="641">
                  <c:v>35.345999999999997</c:v>
                </c:pt>
                <c:pt idx="642">
                  <c:v>35.139000000000003</c:v>
                </c:pt>
                <c:pt idx="643">
                  <c:v>34.942999999999998</c:v>
                </c:pt>
                <c:pt idx="644">
                  <c:v>34.765999999999998</c:v>
                </c:pt>
                <c:pt idx="645">
                  <c:v>34.587000000000003</c:v>
                </c:pt>
                <c:pt idx="646">
                  <c:v>34.411000000000001</c:v>
                </c:pt>
                <c:pt idx="647">
                  <c:v>34.247999999999998</c:v>
                </c:pt>
                <c:pt idx="648">
                  <c:v>34.088000000000001</c:v>
                </c:pt>
                <c:pt idx="649">
                  <c:v>33.927999999999997</c:v>
                </c:pt>
                <c:pt idx="650">
                  <c:v>33.771999999999998</c:v>
                </c:pt>
                <c:pt idx="651">
                  <c:v>33.630000000000003</c:v>
                </c:pt>
                <c:pt idx="652">
                  <c:v>33.484999999999999</c:v>
                </c:pt>
                <c:pt idx="653">
                  <c:v>33.343000000000004</c:v>
                </c:pt>
                <c:pt idx="654">
                  <c:v>33.207999999999998</c:v>
                </c:pt>
                <c:pt idx="655">
                  <c:v>33.079000000000001</c:v>
                </c:pt>
                <c:pt idx="656">
                  <c:v>32.947000000000003</c:v>
                </c:pt>
                <c:pt idx="657">
                  <c:v>32.820999999999998</c:v>
                </c:pt>
                <c:pt idx="658">
                  <c:v>32.698</c:v>
                </c:pt>
                <c:pt idx="659">
                  <c:v>32.578000000000003</c:v>
                </c:pt>
                <c:pt idx="660">
                  <c:v>32.463000000000001</c:v>
                </c:pt>
                <c:pt idx="661">
                  <c:v>32.351999999999997</c:v>
                </c:pt>
                <c:pt idx="662">
                  <c:v>32.238999999999997</c:v>
                </c:pt>
                <c:pt idx="663">
                  <c:v>32.128</c:v>
                </c:pt>
                <c:pt idx="664">
                  <c:v>32.020000000000003</c:v>
                </c:pt>
                <c:pt idx="665">
                  <c:v>31.911999999999999</c:v>
                </c:pt>
                <c:pt idx="666">
                  <c:v>31.803000000000001</c:v>
                </c:pt>
                <c:pt idx="667">
                  <c:v>31.7</c:v>
                </c:pt>
                <c:pt idx="668">
                  <c:v>31.596</c:v>
                </c:pt>
                <c:pt idx="669">
                  <c:v>31.497</c:v>
                </c:pt>
                <c:pt idx="670">
                  <c:v>31.395</c:v>
                </c:pt>
                <c:pt idx="671">
                  <c:v>31.3</c:v>
                </c:pt>
                <c:pt idx="672">
                  <c:v>31.195</c:v>
                </c:pt>
                <c:pt idx="673">
                  <c:v>31.097000000000001</c:v>
                </c:pt>
                <c:pt idx="674">
                  <c:v>30.998000000000001</c:v>
                </c:pt>
                <c:pt idx="675">
                  <c:v>30.904</c:v>
                </c:pt>
                <c:pt idx="676">
                  <c:v>30.806000000000001</c:v>
                </c:pt>
                <c:pt idx="677">
                  <c:v>30.716000000000001</c:v>
                </c:pt>
                <c:pt idx="678">
                  <c:v>30.626000000000001</c:v>
                </c:pt>
                <c:pt idx="679">
                  <c:v>30.535</c:v>
                </c:pt>
                <c:pt idx="680">
                  <c:v>30.440999999999999</c:v>
                </c:pt>
                <c:pt idx="681">
                  <c:v>30.347999999999999</c:v>
                </c:pt>
                <c:pt idx="682">
                  <c:v>30.253</c:v>
                </c:pt>
                <c:pt idx="683">
                  <c:v>30.158999999999999</c:v>
                </c:pt>
                <c:pt idx="684">
                  <c:v>30.068000000000001</c:v>
                </c:pt>
                <c:pt idx="685">
                  <c:v>29.969000000000001</c:v>
                </c:pt>
                <c:pt idx="686">
                  <c:v>29.873999999999999</c:v>
                </c:pt>
                <c:pt idx="687">
                  <c:v>29.780999999999999</c:v>
                </c:pt>
                <c:pt idx="688">
                  <c:v>29.681999999999999</c:v>
                </c:pt>
                <c:pt idx="689">
                  <c:v>29.581</c:v>
                </c:pt>
                <c:pt idx="690">
                  <c:v>29.475999999999999</c:v>
                </c:pt>
                <c:pt idx="691">
                  <c:v>29.384</c:v>
                </c:pt>
                <c:pt idx="692">
                  <c:v>29.283999999999999</c:v>
                </c:pt>
                <c:pt idx="693">
                  <c:v>29.184999999999999</c:v>
                </c:pt>
                <c:pt idx="694">
                  <c:v>29.088999999999999</c:v>
                </c:pt>
                <c:pt idx="695">
                  <c:v>28.991</c:v>
                </c:pt>
                <c:pt idx="696">
                  <c:v>28.888000000000002</c:v>
                </c:pt>
                <c:pt idx="697">
                  <c:v>28.786000000000001</c:v>
                </c:pt>
                <c:pt idx="698">
                  <c:v>28.687999999999999</c:v>
                </c:pt>
                <c:pt idx="699">
                  <c:v>28.584</c:v>
                </c:pt>
                <c:pt idx="700">
                  <c:v>28.48</c:v>
                </c:pt>
                <c:pt idx="701">
                  <c:v>28.375</c:v>
                </c:pt>
                <c:pt idx="702">
                  <c:v>28.276</c:v>
                </c:pt>
                <c:pt idx="703">
                  <c:v>28.172999999999998</c:v>
                </c:pt>
                <c:pt idx="704">
                  <c:v>28.07</c:v>
                </c:pt>
                <c:pt idx="705">
                  <c:v>27.963000000000001</c:v>
                </c:pt>
                <c:pt idx="706">
                  <c:v>27.866</c:v>
                </c:pt>
                <c:pt idx="707">
                  <c:v>27.759</c:v>
                </c:pt>
                <c:pt idx="708">
                  <c:v>27.646999999999998</c:v>
                </c:pt>
                <c:pt idx="709">
                  <c:v>27.532</c:v>
                </c:pt>
                <c:pt idx="710">
                  <c:v>27.422999999999998</c:v>
                </c:pt>
                <c:pt idx="711">
                  <c:v>27.302</c:v>
                </c:pt>
                <c:pt idx="712">
                  <c:v>27.184000000000001</c:v>
                </c:pt>
                <c:pt idx="713">
                  <c:v>27.065000000000001</c:v>
                </c:pt>
                <c:pt idx="714">
                  <c:v>26.949000000000002</c:v>
                </c:pt>
                <c:pt idx="715">
                  <c:v>26.827000000000002</c:v>
                </c:pt>
                <c:pt idx="716">
                  <c:v>26.71</c:v>
                </c:pt>
                <c:pt idx="717">
                  <c:v>26.585000000000001</c:v>
                </c:pt>
                <c:pt idx="718">
                  <c:v>26.466999999999999</c:v>
                </c:pt>
                <c:pt idx="719">
                  <c:v>26.346</c:v>
                </c:pt>
                <c:pt idx="720">
                  <c:v>26.22</c:v>
                </c:pt>
                <c:pt idx="721">
                  <c:v>26.097000000000001</c:v>
                </c:pt>
                <c:pt idx="722">
                  <c:v>25.974</c:v>
                </c:pt>
                <c:pt idx="723">
                  <c:v>25.850999999999999</c:v>
                </c:pt>
                <c:pt idx="724">
                  <c:v>25.716000000000001</c:v>
                </c:pt>
                <c:pt idx="725">
                  <c:v>25.588000000000001</c:v>
                </c:pt>
                <c:pt idx="726">
                  <c:v>25.466000000000001</c:v>
                </c:pt>
                <c:pt idx="727">
                  <c:v>25.332000000000001</c:v>
                </c:pt>
                <c:pt idx="728">
                  <c:v>25.2</c:v>
                </c:pt>
                <c:pt idx="729">
                  <c:v>25.074000000000002</c:v>
                </c:pt>
                <c:pt idx="730">
                  <c:v>24.946999999999999</c:v>
                </c:pt>
                <c:pt idx="731">
                  <c:v>24.811</c:v>
                </c:pt>
                <c:pt idx="732">
                  <c:v>24.681000000000001</c:v>
                </c:pt>
                <c:pt idx="733">
                  <c:v>24.555</c:v>
                </c:pt>
                <c:pt idx="734">
                  <c:v>24.416</c:v>
                </c:pt>
                <c:pt idx="735">
                  <c:v>24.277000000000001</c:v>
                </c:pt>
                <c:pt idx="736">
                  <c:v>24.143000000000001</c:v>
                </c:pt>
                <c:pt idx="737">
                  <c:v>24.009</c:v>
                </c:pt>
                <c:pt idx="738">
                  <c:v>23.87</c:v>
                </c:pt>
                <c:pt idx="739">
                  <c:v>23.739000000000001</c:v>
                </c:pt>
                <c:pt idx="740">
                  <c:v>23.599</c:v>
                </c:pt>
                <c:pt idx="741">
                  <c:v>23.468</c:v>
                </c:pt>
                <c:pt idx="742">
                  <c:v>23.332999999999998</c:v>
                </c:pt>
                <c:pt idx="743">
                  <c:v>23.198</c:v>
                </c:pt>
                <c:pt idx="744">
                  <c:v>23.056999999999999</c:v>
                </c:pt>
                <c:pt idx="745">
                  <c:v>22.923999999999999</c:v>
                </c:pt>
                <c:pt idx="746">
                  <c:v>22.79</c:v>
                </c:pt>
                <c:pt idx="747">
                  <c:v>22.648</c:v>
                </c:pt>
                <c:pt idx="748">
                  <c:v>22.504000000000001</c:v>
                </c:pt>
                <c:pt idx="749">
                  <c:v>22.375</c:v>
                </c:pt>
                <c:pt idx="750">
                  <c:v>22.236000000000001</c:v>
                </c:pt>
                <c:pt idx="751">
                  <c:v>22.091000000000001</c:v>
                </c:pt>
                <c:pt idx="752">
                  <c:v>21.954999999999998</c:v>
                </c:pt>
                <c:pt idx="753">
                  <c:v>21.827000000000002</c:v>
                </c:pt>
                <c:pt idx="754">
                  <c:v>21.692</c:v>
                </c:pt>
                <c:pt idx="755">
                  <c:v>21.558</c:v>
                </c:pt>
                <c:pt idx="756">
                  <c:v>21.427</c:v>
                </c:pt>
                <c:pt idx="757">
                  <c:v>21.295999999999999</c:v>
                </c:pt>
                <c:pt idx="758">
                  <c:v>21.161000000000001</c:v>
                </c:pt>
                <c:pt idx="759">
                  <c:v>21.027999999999999</c:v>
                </c:pt>
                <c:pt idx="760">
                  <c:v>20.89</c:v>
                </c:pt>
                <c:pt idx="761">
                  <c:v>20.756</c:v>
                </c:pt>
                <c:pt idx="762">
                  <c:v>20.626000000000001</c:v>
                </c:pt>
                <c:pt idx="763">
                  <c:v>20.488</c:v>
                </c:pt>
                <c:pt idx="764">
                  <c:v>20.356999999999999</c:v>
                </c:pt>
                <c:pt idx="765">
                  <c:v>20.228999999999999</c:v>
                </c:pt>
                <c:pt idx="766">
                  <c:v>20.097999999999999</c:v>
                </c:pt>
                <c:pt idx="767">
                  <c:v>19.966000000000001</c:v>
                </c:pt>
                <c:pt idx="768">
                  <c:v>19.837</c:v>
                </c:pt>
                <c:pt idx="769">
                  <c:v>19.715</c:v>
                </c:pt>
                <c:pt idx="770">
                  <c:v>19.584</c:v>
                </c:pt>
                <c:pt idx="771">
                  <c:v>19.457000000000001</c:v>
                </c:pt>
                <c:pt idx="772">
                  <c:v>19.341999999999999</c:v>
                </c:pt>
                <c:pt idx="773">
                  <c:v>19.219000000000001</c:v>
                </c:pt>
                <c:pt idx="774">
                  <c:v>19.099</c:v>
                </c:pt>
                <c:pt idx="775">
                  <c:v>18.984999999999999</c:v>
                </c:pt>
                <c:pt idx="776">
                  <c:v>18.876000000000001</c:v>
                </c:pt>
                <c:pt idx="777">
                  <c:v>18.757999999999999</c:v>
                </c:pt>
                <c:pt idx="778">
                  <c:v>18.651</c:v>
                </c:pt>
                <c:pt idx="779">
                  <c:v>18.544</c:v>
                </c:pt>
                <c:pt idx="780">
                  <c:v>18.440000000000001</c:v>
                </c:pt>
                <c:pt idx="781">
                  <c:v>18.332000000000001</c:v>
                </c:pt>
                <c:pt idx="782">
                  <c:v>18.231999999999999</c:v>
                </c:pt>
                <c:pt idx="783">
                  <c:v>18.128</c:v>
                </c:pt>
                <c:pt idx="784">
                  <c:v>18.033000000000001</c:v>
                </c:pt>
                <c:pt idx="785">
                  <c:v>17.943000000000001</c:v>
                </c:pt>
                <c:pt idx="786">
                  <c:v>17.850999999999999</c:v>
                </c:pt>
                <c:pt idx="787">
                  <c:v>17.762</c:v>
                </c:pt>
                <c:pt idx="788">
                  <c:v>17.681999999999999</c:v>
                </c:pt>
                <c:pt idx="789">
                  <c:v>17.599</c:v>
                </c:pt>
                <c:pt idx="790">
                  <c:v>17.52</c:v>
                </c:pt>
                <c:pt idx="791">
                  <c:v>17.448</c:v>
                </c:pt>
                <c:pt idx="792">
                  <c:v>17.378</c:v>
                </c:pt>
                <c:pt idx="793">
                  <c:v>17.309999999999999</c:v>
                </c:pt>
                <c:pt idx="794">
                  <c:v>17.245999999999999</c:v>
                </c:pt>
                <c:pt idx="795">
                  <c:v>17.186</c:v>
                </c:pt>
                <c:pt idx="796">
                  <c:v>17.13</c:v>
                </c:pt>
                <c:pt idx="797">
                  <c:v>17.074000000000002</c:v>
                </c:pt>
                <c:pt idx="798">
                  <c:v>17.021000000000001</c:v>
                </c:pt>
                <c:pt idx="799">
                  <c:v>16.975000000000001</c:v>
                </c:pt>
                <c:pt idx="800">
                  <c:v>16.931000000000001</c:v>
                </c:pt>
                <c:pt idx="801">
                  <c:v>16.888000000000002</c:v>
                </c:pt>
                <c:pt idx="802">
                  <c:v>16.847000000000001</c:v>
                </c:pt>
                <c:pt idx="803">
                  <c:v>16.809999999999999</c:v>
                </c:pt>
                <c:pt idx="804">
                  <c:v>16.774999999999999</c:v>
                </c:pt>
                <c:pt idx="805">
                  <c:v>16.741</c:v>
                </c:pt>
                <c:pt idx="806">
                  <c:v>16.707999999999998</c:v>
                </c:pt>
                <c:pt idx="807">
                  <c:v>16.675000000000001</c:v>
                </c:pt>
                <c:pt idx="808">
                  <c:v>16.645</c:v>
                </c:pt>
                <c:pt idx="809">
                  <c:v>16.616</c:v>
                </c:pt>
                <c:pt idx="810">
                  <c:v>16.582999999999998</c:v>
                </c:pt>
                <c:pt idx="811">
                  <c:v>16.556999999999999</c:v>
                </c:pt>
                <c:pt idx="812">
                  <c:v>16.527000000000001</c:v>
                </c:pt>
                <c:pt idx="813">
                  <c:v>16.494</c:v>
                </c:pt>
                <c:pt idx="814">
                  <c:v>16.463000000000001</c:v>
                </c:pt>
                <c:pt idx="815">
                  <c:v>16.43</c:v>
                </c:pt>
                <c:pt idx="816">
                  <c:v>16.396999999999998</c:v>
                </c:pt>
                <c:pt idx="817">
                  <c:v>16.367000000000001</c:v>
                </c:pt>
                <c:pt idx="818">
                  <c:v>16.329000000000001</c:v>
                </c:pt>
                <c:pt idx="819">
                  <c:v>16.3</c:v>
                </c:pt>
                <c:pt idx="820">
                  <c:v>16.263999999999999</c:v>
                </c:pt>
                <c:pt idx="821">
                  <c:v>16.227</c:v>
                </c:pt>
                <c:pt idx="822">
                  <c:v>16.187999999999999</c:v>
                </c:pt>
                <c:pt idx="823">
                  <c:v>16.149999999999999</c:v>
                </c:pt>
                <c:pt idx="824">
                  <c:v>16.114000000000001</c:v>
                </c:pt>
                <c:pt idx="825">
                  <c:v>16.074000000000002</c:v>
                </c:pt>
                <c:pt idx="826">
                  <c:v>16.033999999999999</c:v>
                </c:pt>
                <c:pt idx="827">
                  <c:v>15.993</c:v>
                </c:pt>
                <c:pt idx="828">
                  <c:v>15.945</c:v>
                </c:pt>
                <c:pt idx="829">
                  <c:v>15.897</c:v>
                </c:pt>
                <c:pt idx="830">
                  <c:v>15.85</c:v>
                </c:pt>
                <c:pt idx="831">
                  <c:v>15.798999999999999</c:v>
                </c:pt>
                <c:pt idx="832">
                  <c:v>15.743</c:v>
                </c:pt>
                <c:pt idx="833">
                  <c:v>15.686</c:v>
                </c:pt>
                <c:pt idx="834">
                  <c:v>15.637</c:v>
                </c:pt>
                <c:pt idx="835">
                  <c:v>15.58</c:v>
                </c:pt>
                <c:pt idx="836">
                  <c:v>15.52</c:v>
                </c:pt>
                <c:pt idx="837">
                  <c:v>15.462999999999999</c:v>
                </c:pt>
                <c:pt idx="838">
                  <c:v>15.407999999999999</c:v>
                </c:pt>
                <c:pt idx="839">
                  <c:v>15.35</c:v>
                </c:pt>
                <c:pt idx="840">
                  <c:v>15.292</c:v>
                </c:pt>
                <c:pt idx="841">
                  <c:v>15.236000000000001</c:v>
                </c:pt>
                <c:pt idx="842">
                  <c:v>15.179</c:v>
                </c:pt>
                <c:pt idx="843">
                  <c:v>15.12</c:v>
                </c:pt>
                <c:pt idx="844">
                  <c:v>15.061</c:v>
                </c:pt>
                <c:pt idx="845">
                  <c:v>15.000999999999999</c:v>
                </c:pt>
                <c:pt idx="846">
                  <c:v>14.943</c:v>
                </c:pt>
                <c:pt idx="847">
                  <c:v>14.882999999999999</c:v>
                </c:pt>
                <c:pt idx="848">
                  <c:v>14.824999999999999</c:v>
                </c:pt>
                <c:pt idx="849">
                  <c:v>14.763999999999999</c:v>
                </c:pt>
                <c:pt idx="850">
                  <c:v>14.704000000000001</c:v>
                </c:pt>
                <c:pt idx="851">
                  <c:v>14.646000000000001</c:v>
                </c:pt>
                <c:pt idx="852">
                  <c:v>14.587999999999999</c:v>
                </c:pt>
                <c:pt idx="853">
                  <c:v>14.535</c:v>
                </c:pt>
                <c:pt idx="854">
                  <c:v>14.483000000000001</c:v>
                </c:pt>
                <c:pt idx="855">
                  <c:v>14.43</c:v>
                </c:pt>
                <c:pt idx="856">
                  <c:v>14.38</c:v>
                </c:pt>
                <c:pt idx="857">
                  <c:v>14.327</c:v>
                </c:pt>
                <c:pt idx="858">
                  <c:v>14.278</c:v>
                </c:pt>
                <c:pt idx="859">
                  <c:v>14.225</c:v>
                </c:pt>
                <c:pt idx="860">
                  <c:v>14.173</c:v>
                </c:pt>
                <c:pt idx="861">
                  <c:v>14.124000000000001</c:v>
                </c:pt>
                <c:pt idx="862">
                  <c:v>14.071999999999999</c:v>
                </c:pt>
                <c:pt idx="863">
                  <c:v>14.022</c:v>
                </c:pt>
                <c:pt idx="864">
                  <c:v>13.973000000000001</c:v>
                </c:pt>
                <c:pt idx="865">
                  <c:v>13.92</c:v>
                </c:pt>
                <c:pt idx="866">
                  <c:v>13.875999999999999</c:v>
                </c:pt>
                <c:pt idx="867">
                  <c:v>13.832000000000001</c:v>
                </c:pt>
                <c:pt idx="868">
                  <c:v>13.787000000000001</c:v>
                </c:pt>
                <c:pt idx="869">
                  <c:v>13.738</c:v>
                </c:pt>
                <c:pt idx="870">
                  <c:v>13.69</c:v>
                </c:pt>
                <c:pt idx="871">
                  <c:v>13.635999999999999</c:v>
                </c:pt>
                <c:pt idx="872">
                  <c:v>13.582000000000001</c:v>
                </c:pt>
                <c:pt idx="873">
                  <c:v>13.531000000000001</c:v>
                </c:pt>
                <c:pt idx="874">
                  <c:v>13.476000000000001</c:v>
                </c:pt>
                <c:pt idx="875">
                  <c:v>13.420999999999999</c:v>
                </c:pt>
                <c:pt idx="876">
                  <c:v>13.365</c:v>
                </c:pt>
                <c:pt idx="877">
                  <c:v>13.311</c:v>
                </c:pt>
                <c:pt idx="878">
                  <c:v>13.247</c:v>
                </c:pt>
                <c:pt idx="879">
                  <c:v>13.183999999999999</c:v>
                </c:pt>
                <c:pt idx="880">
                  <c:v>13.121</c:v>
                </c:pt>
                <c:pt idx="881">
                  <c:v>13.051</c:v>
                </c:pt>
                <c:pt idx="882">
                  <c:v>12.984999999999999</c:v>
                </c:pt>
                <c:pt idx="883">
                  <c:v>12.914999999999999</c:v>
                </c:pt>
                <c:pt idx="884">
                  <c:v>12.845000000000001</c:v>
                </c:pt>
                <c:pt idx="885">
                  <c:v>12.773999999999999</c:v>
                </c:pt>
                <c:pt idx="886">
                  <c:v>12.702999999999999</c:v>
                </c:pt>
                <c:pt idx="887">
                  <c:v>12.629</c:v>
                </c:pt>
                <c:pt idx="888">
                  <c:v>12.551</c:v>
                </c:pt>
                <c:pt idx="889">
                  <c:v>12.481999999999999</c:v>
                </c:pt>
                <c:pt idx="890">
                  <c:v>12.404999999999999</c:v>
                </c:pt>
                <c:pt idx="891">
                  <c:v>12.324</c:v>
                </c:pt>
                <c:pt idx="892">
                  <c:v>12.25</c:v>
                </c:pt>
                <c:pt idx="893">
                  <c:v>12.173</c:v>
                </c:pt>
                <c:pt idx="894">
                  <c:v>12.09</c:v>
                </c:pt>
                <c:pt idx="895">
                  <c:v>12.007</c:v>
                </c:pt>
                <c:pt idx="896">
                  <c:v>11.932</c:v>
                </c:pt>
                <c:pt idx="897">
                  <c:v>11.853999999999999</c:v>
                </c:pt>
                <c:pt idx="898">
                  <c:v>11.769</c:v>
                </c:pt>
                <c:pt idx="899">
                  <c:v>11.693</c:v>
                </c:pt>
                <c:pt idx="900">
                  <c:v>11.618</c:v>
                </c:pt>
                <c:pt idx="901">
                  <c:v>11.538</c:v>
                </c:pt>
                <c:pt idx="902">
                  <c:v>11.459</c:v>
                </c:pt>
                <c:pt idx="903">
                  <c:v>11.388999999999999</c:v>
                </c:pt>
                <c:pt idx="904">
                  <c:v>11.317</c:v>
                </c:pt>
                <c:pt idx="905">
                  <c:v>11.249000000000001</c:v>
                </c:pt>
                <c:pt idx="906">
                  <c:v>11.18</c:v>
                </c:pt>
                <c:pt idx="907">
                  <c:v>11.111000000000001</c:v>
                </c:pt>
                <c:pt idx="908">
                  <c:v>11.047000000000001</c:v>
                </c:pt>
                <c:pt idx="909">
                  <c:v>10.983000000000001</c:v>
                </c:pt>
                <c:pt idx="910">
                  <c:v>10.919</c:v>
                </c:pt>
                <c:pt idx="911">
                  <c:v>10.856999999999999</c:v>
                </c:pt>
                <c:pt idx="912">
                  <c:v>10.8</c:v>
                </c:pt>
                <c:pt idx="913">
                  <c:v>10.75</c:v>
                </c:pt>
                <c:pt idx="914">
                  <c:v>10.694000000000001</c:v>
                </c:pt>
                <c:pt idx="915">
                  <c:v>10.645</c:v>
                </c:pt>
                <c:pt idx="916">
                  <c:v>10.599</c:v>
                </c:pt>
                <c:pt idx="917">
                  <c:v>10.551</c:v>
                </c:pt>
                <c:pt idx="918">
                  <c:v>10.500999999999999</c:v>
                </c:pt>
                <c:pt idx="919">
                  <c:v>10.459</c:v>
                </c:pt>
                <c:pt idx="920">
                  <c:v>10.417</c:v>
                </c:pt>
                <c:pt idx="921">
                  <c:v>10.372999999999999</c:v>
                </c:pt>
                <c:pt idx="922">
                  <c:v>10.334</c:v>
                </c:pt>
                <c:pt idx="923">
                  <c:v>10.294</c:v>
                </c:pt>
                <c:pt idx="924">
                  <c:v>10.256</c:v>
                </c:pt>
                <c:pt idx="925">
                  <c:v>10.214</c:v>
                </c:pt>
                <c:pt idx="926">
                  <c:v>10.177</c:v>
                </c:pt>
                <c:pt idx="927">
                  <c:v>10.14</c:v>
                </c:pt>
                <c:pt idx="928">
                  <c:v>10.108000000000001</c:v>
                </c:pt>
                <c:pt idx="929">
                  <c:v>10.076000000000001</c:v>
                </c:pt>
                <c:pt idx="930">
                  <c:v>10.044</c:v>
                </c:pt>
                <c:pt idx="931">
                  <c:v>10.01</c:v>
                </c:pt>
                <c:pt idx="932">
                  <c:v>9.9809999999999999</c:v>
                </c:pt>
                <c:pt idx="933">
                  <c:v>9.9540000000000006</c:v>
                </c:pt>
                <c:pt idx="934">
                  <c:v>9.9269999999999996</c:v>
                </c:pt>
                <c:pt idx="935">
                  <c:v>9.9</c:v>
                </c:pt>
                <c:pt idx="936">
                  <c:v>9.9809999999999999</c:v>
                </c:pt>
                <c:pt idx="937">
                  <c:v>9.9540000000000006</c:v>
                </c:pt>
                <c:pt idx="938">
                  <c:v>9.9269999999999996</c:v>
                </c:pt>
                <c:pt idx="939">
                  <c:v>9.9</c:v>
                </c:pt>
                <c:pt idx="940">
                  <c:v>9.9269999999999996</c:v>
                </c:pt>
                <c:pt idx="941">
                  <c:v>9.9269999999999996</c:v>
                </c:pt>
                <c:pt idx="942">
                  <c:v>9.9269999999999996</c:v>
                </c:pt>
                <c:pt idx="943">
                  <c:v>9.9269999999999996</c:v>
                </c:pt>
                <c:pt idx="944">
                  <c:v>9.9269999999999996</c:v>
                </c:pt>
                <c:pt idx="945">
                  <c:v>9.9269999999999996</c:v>
                </c:pt>
                <c:pt idx="946">
                  <c:v>9.9269999999999996</c:v>
                </c:pt>
                <c:pt idx="947">
                  <c:v>9.9269999999999996</c:v>
                </c:pt>
                <c:pt idx="948">
                  <c:v>9.9269999999999996</c:v>
                </c:pt>
                <c:pt idx="949">
                  <c:v>9.9269999999999996</c:v>
                </c:pt>
                <c:pt idx="950">
                  <c:v>9.9269999999999996</c:v>
                </c:pt>
                <c:pt idx="951">
                  <c:v>9.9269999999999996</c:v>
                </c:pt>
                <c:pt idx="952">
                  <c:v>9.9269999999999996</c:v>
                </c:pt>
                <c:pt idx="953">
                  <c:v>9.9269999999999996</c:v>
                </c:pt>
                <c:pt idx="954">
                  <c:v>9.9269999999999996</c:v>
                </c:pt>
                <c:pt idx="955">
                  <c:v>9.9269999999999996</c:v>
                </c:pt>
                <c:pt idx="956">
                  <c:v>9.9269999999999996</c:v>
                </c:pt>
                <c:pt idx="957">
                  <c:v>9.9269999999999996</c:v>
                </c:pt>
                <c:pt idx="958">
                  <c:v>9.9269999999999996</c:v>
                </c:pt>
                <c:pt idx="959">
                  <c:v>9.9269999999999996</c:v>
                </c:pt>
                <c:pt idx="960">
                  <c:v>9.9269999999999996</c:v>
                </c:pt>
                <c:pt idx="961">
                  <c:v>9.9269999999999996</c:v>
                </c:pt>
                <c:pt idx="962">
                  <c:v>9.9269999999999996</c:v>
                </c:pt>
                <c:pt idx="963">
                  <c:v>9.9269999999999996</c:v>
                </c:pt>
                <c:pt idx="964">
                  <c:v>9.9269999999999996</c:v>
                </c:pt>
                <c:pt idx="965">
                  <c:v>9.9269999999999996</c:v>
                </c:pt>
                <c:pt idx="966">
                  <c:v>9.9269999999999996</c:v>
                </c:pt>
                <c:pt idx="967">
                  <c:v>9.9269999999999996</c:v>
                </c:pt>
                <c:pt idx="968">
                  <c:v>9.9269999999999996</c:v>
                </c:pt>
                <c:pt idx="969">
                  <c:v>9.9269999999999996</c:v>
                </c:pt>
                <c:pt idx="970">
                  <c:v>9.9269999999999996</c:v>
                </c:pt>
                <c:pt idx="971">
                  <c:v>9.9269999999999996</c:v>
                </c:pt>
                <c:pt idx="972">
                  <c:v>9.9269999999999996</c:v>
                </c:pt>
                <c:pt idx="973">
                  <c:v>9.9269999999999996</c:v>
                </c:pt>
                <c:pt idx="974">
                  <c:v>9.9269999999999996</c:v>
                </c:pt>
                <c:pt idx="975">
                  <c:v>9.9269999999999996</c:v>
                </c:pt>
                <c:pt idx="976">
                  <c:v>9.9269999999999996</c:v>
                </c:pt>
                <c:pt idx="977">
                  <c:v>9.9269999999999996</c:v>
                </c:pt>
                <c:pt idx="978">
                  <c:v>9.9269999999999996</c:v>
                </c:pt>
                <c:pt idx="979">
                  <c:v>9.9269999999999996</c:v>
                </c:pt>
                <c:pt idx="980">
                  <c:v>9.9269999999999996</c:v>
                </c:pt>
                <c:pt idx="981">
                  <c:v>9.9269999999999996</c:v>
                </c:pt>
                <c:pt idx="982">
                  <c:v>9.9269999999999996</c:v>
                </c:pt>
                <c:pt idx="983">
                  <c:v>9.9269999999999996</c:v>
                </c:pt>
                <c:pt idx="984">
                  <c:v>9.9269999999999996</c:v>
                </c:pt>
                <c:pt idx="985">
                  <c:v>9.9269999999999996</c:v>
                </c:pt>
                <c:pt idx="986">
                  <c:v>9.9269999999999996</c:v>
                </c:pt>
                <c:pt idx="987">
                  <c:v>9.9269999999999996</c:v>
                </c:pt>
                <c:pt idx="988">
                  <c:v>9.9269999999999996</c:v>
                </c:pt>
                <c:pt idx="989">
                  <c:v>9.9269999999999996</c:v>
                </c:pt>
                <c:pt idx="990">
                  <c:v>9.9269999999999996</c:v>
                </c:pt>
                <c:pt idx="991">
                  <c:v>9.9269999999999996</c:v>
                </c:pt>
                <c:pt idx="992">
                  <c:v>9.9269999999999996</c:v>
                </c:pt>
                <c:pt idx="993">
                  <c:v>9.9269999999999996</c:v>
                </c:pt>
                <c:pt idx="994">
                  <c:v>9.9269999999999996</c:v>
                </c:pt>
                <c:pt idx="995">
                  <c:v>9.9269999999999996</c:v>
                </c:pt>
                <c:pt idx="996">
                  <c:v>9.9269999999999996</c:v>
                </c:pt>
                <c:pt idx="997">
                  <c:v>9.9269999999999996</c:v>
                </c:pt>
                <c:pt idx="998">
                  <c:v>9.9269999999999996</c:v>
                </c:pt>
                <c:pt idx="999">
                  <c:v>9.9269999999999996</c:v>
                </c:pt>
                <c:pt idx="1000">
                  <c:v>9.9269999999999996</c:v>
                </c:pt>
                <c:pt idx="1001">
                  <c:v>9.9269999999999996</c:v>
                </c:pt>
                <c:pt idx="1002">
                  <c:v>9.9269999999999996</c:v>
                </c:pt>
                <c:pt idx="1003">
                  <c:v>9.9269999999999996</c:v>
                </c:pt>
                <c:pt idx="1004">
                  <c:v>9.9269999999999996</c:v>
                </c:pt>
                <c:pt idx="1005">
                  <c:v>9.9269999999999996</c:v>
                </c:pt>
                <c:pt idx="1006">
                  <c:v>9.9269999999999996</c:v>
                </c:pt>
                <c:pt idx="1007">
                  <c:v>9.9269999999999996</c:v>
                </c:pt>
                <c:pt idx="1008">
                  <c:v>9.9269999999999996</c:v>
                </c:pt>
                <c:pt idx="1009">
                  <c:v>9.9269999999999996</c:v>
                </c:pt>
                <c:pt idx="1010">
                  <c:v>9.9269999999999996</c:v>
                </c:pt>
                <c:pt idx="1011">
                  <c:v>9.9269999999999996</c:v>
                </c:pt>
                <c:pt idx="1012">
                  <c:v>9.9269999999999996</c:v>
                </c:pt>
                <c:pt idx="1013">
                  <c:v>9.9269999999999996</c:v>
                </c:pt>
                <c:pt idx="1014">
                  <c:v>9.9269999999999996</c:v>
                </c:pt>
                <c:pt idx="1015">
                  <c:v>9.9269999999999996</c:v>
                </c:pt>
                <c:pt idx="1016">
                  <c:v>9.9269999999999996</c:v>
                </c:pt>
                <c:pt idx="1017">
                  <c:v>9.9269999999999996</c:v>
                </c:pt>
                <c:pt idx="1018">
                  <c:v>9.9269999999999996</c:v>
                </c:pt>
                <c:pt idx="1019">
                  <c:v>9.9269999999999996</c:v>
                </c:pt>
                <c:pt idx="1020">
                  <c:v>9.9269999999999996</c:v>
                </c:pt>
                <c:pt idx="1021">
                  <c:v>9.9269999999999996</c:v>
                </c:pt>
                <c:pt idx="1022">
                  <c:v>9.9269999999999996</c:v>
                </c:pt>
                <c:pt idx="1023">
                  <c:v>9.9269999999999996</c:v>
                </c:pt>
                <c:pt idx="1024">
                  <c:v>9.9269999999999996</c:v>
                </c:pt>
                <c:pt idx="1025">
                  <c:v>9.9269999999999996</c:v>
                </c:pt>
                <c:pt idx="1026">
                  <c:v>9.9269999999999996</c:v>
                </c:pt>
                <c:pt idx="1027">
                  <c:v>9.9269999999999996</c:v>
                </c:pt>
                <c:pt idx="1028">
                  <c:v>9.9269999999999996</c:v>
                </c:pt>
                <c:pt idx="1029">
                  <c:v>9.9269999999999996</c:v>
                </c:pt>
                <c:pt idx="1030">
                  <c:v>9.9269999999999996</c:v>
                </c:pt>
                <c:pt idx="1031">
                  <c:v>9.9269999999999996</c:v>
                </c:pt>
                <c:pt idx="1032">
                  <c:v>9.9269999999999996</c:v>
                </c:pt>
                <c:pt idx="1033">
                  <c:v>9.9269999999999996</c:v>
                </c:pt>
                <c:pt idx="1034">
                  <c:v>9.9269999999999996</c:v>
                </c:pt>
                <c:pt idx="1035">
                  <c:v>9.9269999999999996</c:v>
                </c:pt>
                <c:pt idx="1036">
                  <c:v>9.9269999999999996</c:v>
                </c:pt>
                <c:pt idx="1037">
                  <c:v>9.9269999999999996</c:v>
                </c:pt>
                <c:pt idx="1038">
                  <c:v>9.9269999999999996</c:v>
                </c:pt>
                <c:pt idx="1039">
                  <c:v>9.9269999999999996</c:v>
                </c:pt>
                <c:pt idx="1040">
                  <c:v>9.9269999999999996</c:v>
                </c:pt>
                <c:pt idx="1041">
                  <c:v>9.9269999999999996</c:v>
                </c:pt>
                <c:pt idx="1042">
                  <c:v>9.9269999999999996</c:v>
                </c:pt>
                <c:pt idx="1043">
                  <c:v>9.9269999999999996</c:v>
                </c:pt>
                <c:pt idx="1044">
                  <c:v>9.9269999999999996</c:v>
                </c:pt>
                <c:pt idx="1045">
                  <c:v>9.9269999999999996</c:v>
                </c:pt>
                <c:pt idx="1046">
                  <c:v>9.9269999999999996</c:v>
                </c:pt>
                <c:pt idx="1047">
                  <c:v>9.9269999999999996</c:v>
                </c:pt>
                <c:pt idx="1048">
                  <c:v>9.9269999999999996</c:v>
                </c:pt>
                <c:pt idx="1049">
                  <c:v>9.9269999999999996</c:v>
                </c:pt>
                <c:pt idx="1050">
                  <c:v>9.9269999999999996</c:v>
                </c:pt>
                <c:pt idx="1051">
                  <c:v>9.9269999999999996</c:v>
                </c:pt>
                <c:pt idx="1052">
                  <c:v>9.9269999999999996</c:v>
                </c:pt>
                <c:pt idx="1053">
                  <c:v>9.9269999999999996</c:v>
                </c:pt>
                <c:pt idx="1054">
                  <c:v>9.9269999999999996</c:v>
                </c:pt>
                <c:pt idx="1055">
                  <c:v>9.9269999999999996</c:v>
                </c:pt>
                <c:pt idx="1056">
                  <c:v>9.9269999999999996</c:v>
                </c:pt>
                <c:pt idx="1057">
                  <c:v>9.9269999999999996</c:v>
                </c:pt>
                <c:pt idx="1058">
                  <c:v>9.9269999999999996</c:v>
                </c:pt>
                <c:pt idx="1059">
                  <c:v>9.9269999999999996</c:v>
                </c:pt>
                <c:pt idx="1060">
                  <c:v>9.9269999999999996</c:v>
                </c:pt>
                <c:pt idx="1061">
                  <c:v>9.9269999999999996</c:v>
                </c:pt>
                <c:pt idx="1062">
                  <c:v>9.9269999999999996</c:v>
                </c:pt>
                <c:pt idx="1063">
                  <c:v>9.9269999999999996</c:v>
                </c:pt>
                <c:pt idx="1064">
                  <c:v>9.9269999999999996</c:v>
                </c:pt>
                <c:pt idx="1065">
                  <c:v>9.9269999999999996</c:v>
                </c:pt>
                <c:pt idx="1066">
                  <c:v>9.9269999999999996</c:v>
                </c:pt>
                <c:pt idx="1067">
                  <c:v>9.9269999999999996</c:v>
                </c:pt>
                <c:pt idx="1068">
                  <c:v>9.9269999999999996</c:v>
                </c:pt>
                <c:pt idx="1069">
                  <c:v>9.9269999999999996</c:v>
                </c:pt>
                <c:pt idx="1070">
                  <c:v>9.9269999999999996</c:v>
                </c:pt>
                <c:pt idx="1071">
                  <c:v>9.9269999999999996</c:v>
                </c:pt>
                <c:pt idx="1072">
                  <c:v>9.9269999999999996</c:v>
                </c:pt>
                <c:pt idx="1073">
                  <c:v>9.9269999999999996</c:v>
                </c:pt>
                <c:pt idx="1074">
                  <c:v>9.9269999999999996</c:v>
                </c:pt>
                <c:pt idx="1075">
                  <c:v>9.9269999999999996</c:v>
                </c:pt>
                <c:pt idx="1076">
                  <c:v>9.9269999999999996</c:v>
                </c:pt>
                <c:pt idx="1077">
                  <c:v>9.9269999999999996</c:v>
                </c:pt>
                <c:pt idx="1078">
                  <c:v>9.9269999999999996</c:v>
                </c:pt>
                <c:pt idx="1079">
                  <c:v>9.9269999999999996</c:v>
                </c:pt>
                <c:pt idx="1080">
                  <c:v>9.9269999999999996</c:v>
                </c:pt>
                <c:pt idx="1081">
                  <c:v>9.9269999999999996</c:v>
                </c:pt>
                <c:pt idx="1082">
                  <c:v>9.9269999999999996</c:v>
                </c:pt>
                <c:pt idx="1083">
                  <c:v>9.9269999999999996</c:v>
                </c:pt>
                <c:pt idx="1084">
                  <c:v>9.9269999999999996</c:v>
                </c:pt>
                <c:pt idx="1085">
                  <c:v>9.9269999999999996</c:v>
                </c:pt>
                <c:pt idx="1086">
                  <c:v>9.9269999999999996</c:v>
                </c:pt>
                <c:pt idx="1087">
                  <c:v>9.9269999999999996</c:v>
                </c:pt>
                <c:pt idx="1088">
                  <c:v>9.9269999999999996</c:v>
                </c:pt>
                <c:pt idx="1089">
                  <c:v>9.9269999999999996</c:v>
                </c:pt>
                <c:pt idx="1090">
                  <c:v>9.9269999999999996</c:v>
                </c:pt>
                <c:pt idx="1091">
                  <c:v>9.9269999999999996</c:v>
                </c:pt>
                <c:pt idx="1092">
                  <c:v>9.9269999999999996</c:v>
                </c:pt>
                <c:pt idx="1093">
                  <c:v>9.9269999999999996</c:v>
                </c:pt>
                <c:pt idx="1094">
                  <c:v>9.9269999999999996</c:v>
                </c:pt>
                <c:pt idx="1095">
                  <c:v>9.9269999999999996</c:v>
                </c:pt>
                <c:pt idx="1096">
                  <c:v>9.9269999999999996</c:v>
                </c:pt>
                <c:pt idx="1097">
                  <c:v>9.9269999999999996</c:v>
                </c:pt>
                <c:pt idx="1098">
                  <c:v>9.9269999999999996</c:v>
                </c:pt>
                <c:pt idx="1099">
                  <c:v>9.9269999999999996</c:v>
                </c:pt>
                <c:pt idx="1100">
                  <c:v>9.9269999999999996</c:v>
                </c:pt>
                <c:pt idx="1101">
                  <c:v>9.9269999999999996</c:v>
                </c:pt>
                <c:pt idx="1102">
                  <c:v>9.9269999999999996</c:v>
                </c:pt>
                <c:pt idx="1103">
                  <c:v>9.9269999999999996</c:v>
                </c:pt>
                <c:pt idx="1104">
                  <c:v>9.9269999999999996</c:v>
                </c:pt>
                <c:pt idx="1105">
                  <c:v>9.9269999999999996</c:v>
                </c:pt>
                <c:pt idx="1106">
                  <c:v>9.9269999999999996</c:v>
                </c:pt>
                <c:pt idx="1107">
                  <c:v>9.9269999999999996</c:v>
                </c:pt>
                <c:pt idx="1108">
                  <c:v>9.9269999999999996</c:v>
                </c:pt>
                <c:pt idx="1109">
                  <c:v>9.9269999999999996</c:v>
                </c:pt>
                <c:pt idx="1110">
                  <c:v>9.9269999999999996</c:v>
                </c:pt>
                <c:pt idx="1111">
                  <c:v>9.9269999999999996</c:v>
                </c:pt>
                <c:pt idx="1112">
                  <c:v>9.9269999999999996</c:v>
                </c:pt>
                <c:pt idx="1113">
                  <c:v>9.9269999999999996</c:v>
                </c:pt>
                <c:pt idx="1114">
                  <c:v>9.9269999999999996</c:v>
                </c:pt>
                <c:pt idx="1115">
                  <c:v>9.9269999999999996</c:v>
                </c:pt>
                <c:pt idx="1116">
                  <c:v>9.9269999999999996</c:v>
                </c:pt>
                <c:pt idx="1117">
                  <c:v>9.9269999999999996</c:v>
                </c:pt>
                <c:pt idx="1118">
                  <c:v>9.9269999999999996</c:v>
                </c:pt>
                <c:pt idx="1119">
                  <c:v>9.9269999999999996</c:v>
                </c:pt>
                <c:pt idx="1120">
                  <c:v>9.9269999999999996</c:v>
                </c:pt>
                <c:pt idx="1121">
                  <c:v>9.9269999999999996</c:v>
                </c:pt>
                <c:pt idx="1122">
                  <c:v>9.9269999999999996</c:v>
                </c:pt>
                <c:pt idx="1123">
                  <c:v>9.9269999999999996</c:v>
                </c:pt>
                <c:pt idx="1124">
                  <c:v>9.9269999999999996</c:v>
                </c:pt>
                <c:pt idx="1125">
                  <c:v>9.9269999999999996</c:v>
                </c:pt>
                <c:pt idx="1126">
                  <c:v>9.9269999999999996</c:v>
                </c:pt>
                <c:pt idx="1127">
                  <c:v>9.9269999999999996</c:v>
                </c:pt>
                <c:pt idx="1128">
                  <c:v>9.9269999999999996</c:v>
                </c:pt>
                <c:pt idx="1129">
                  <c:v>9.9269999999999996</c:v>
                </c:pt>
                <c:pt idx="1130">
                  <c:v>9.9269999999999996</c:v>
                </c:pt>
                <c:pt idx="1131">
                  <c:v>9.9269999999999996</c:v>
                </c:pt>
                <c:pt idx="1132">
                  <c:v>9.9269999999999996</c:v>
                </c:pt>
                <c:pt idx="1133">
                  <c:v>9.9269999999999996</c:v>
                </c:pt>
                <c:pt idx="1134">
                  <c:v>9.9269999999999996</c:v>
                </c:pt>
                <c:pt idx="1135">
                  <c:v>9.9269999999999996</c:v>
                </c:pt>
                <c:pt idx="1136">
                  <c:v>9.9269999999999996</c:v>
                </c:pt>
                <c:pt idx="1137">
                  <c:v>9.9269999999999996</c:v>
                </c:pt>
                <c:pt idx="1138">
                  <c:v>9.9269999999999996</c:v>
                </c:pt>
                <c:pt idx="1139">
                  <c:v>9.9269999999999996</c:v>
                </c:pt>
                <c:pt idx="1140">
                  <c:v>9.9269999999999996</c:v>
                </c:pt>
                <c:pt idx="1141">
                  <c:v>9.9269999999999996</c:v>
                </c:pt>
                <c:pt idx="1142">
                  <c:v>9.9269999999999996</c:v>
                </c:pt>
                <c:pt idx="1143">
                  <c:v>9.9269999999999996</c:v>
                </c:pt>
                <c:pt idx="1144">
                  <c:v>9.9269999999999996</c:v>
                </c:pt>
                <c:pt idx="1145">
                  <c:v>9.9269999999999996</c:v>
                </c:pt>
                <c:pt idx="1146">
                  <c:v>9.9269999999999996</c:v>
                </c:pt>
                <c:pt idx="1147">
                  <c:v>9.9269999999999996</c:v>
                </c:pt>
                <c:pt idx="1148">
                  <c:v>9.9269999999999996</c:v>
                </c:pt>
                <c:pt idx="1149">
                  <c:v>9.9269999999999996</c:v>
                </c:pt>
                <c:pt idx="1150">
                  <c:v>9.9269999999999996</c:v>
                </c:pt>
                <c:pt idx="1151">
                  <c:v>9.9269999999999996</c:v>
                </c:pt>
                <c:pt idx="1152">
                  <c:v>9.9269999999999996</c:v>
                </c:pt>
                <c:pt idx="1153">
                  <c:v>9.9269999999999996</c:v>
                </c:pt>
                <c:pt idx="1154">
                  <c:v>9.9269999999999996</c:v>
                </c:pt>
                <c:pt idx="1155">
                  <c:v>9.9269999999999996</c:v>
                </c:pt>
                <c:pt idx="1156">
                  <c:v>9.6080000000000005</c:v>
                </c:pt>
                <c:pt idx="1157">
                  <c:v>9.391</c:v>
                </c:pt>
                <c:pt idx="1158">
                  <c:v>9.19</c:v>
                </c:pt>
                <c:pt idx="1159">
                  <c:v>8.9930000000000003</c:v>
                </c:pt>
                <c:pt idx="1160">
                  <c:v>8.8049999999999997</c:v>
                </c:pt>
                <c:pt idx="1161">
                  <c:v>8.6150000000000002</c:v>
                </c:pt>
                <c:pt idx="1162">
                  <c:v>8.4359999999999999</c:v>
                </c:pt>
                <c:pt idx="1163">
                  <c:v>8.2609999999999992</c:v>
                </c:pt>
                <c:pt idx="1164">
                  <c:v>8.1080000000000005</c:v>
                </c:pt>
                <c:pt idx="1165">
                  <c:v>7.9580000000000002</c:v>
                </c:pt>
                <c:pt idx="1166">
                  <c:v>7.8090000000000002</c:v>
                </c:pt>
                <c:pt idx="1167">
                  <c:v>7.6580000000000004</c:v>
                </c:pt>
                <c:pt idx="1168">
                  <c:v>7.52</c:v>
                </c:pt>
                <c:pt idx="1169">
                  <c:v>7.3869999999999996</c:v>
                </c:pt>
                <c:pt idx="1170">
                  <c:v>7.2629999999999999</c:v>
                </c:pt>
                <c:pt idx="1171">
                  <c:v>7.1280000000000001</c:v>
                </c:pt>
                <c:pt idx="1172">
                  <c:v>7.01</c:v>
                </c:pt>
                <c:pt idx="1173">
                  <c:v>6.8920000000000003</c:v>
                </c:pt>
                <c:pt idx="1174">
                  <c:v>6.7830000000000004</c:v>
                </c:pt>
                <c:pt idx="1175">
                  <c:v>6.6749999999999998</c:v>
                </c:pt>
                <c:pt idx="1176">
                  <c:v>6.5720000000000001</c:v>
                </c:pt>
                <c:pt idx="1177">
                  <c:v>6.484</c:v>
                </c:pt>
                <c:pt idx="1178">
                  <c:v>6.3940000000000001</c:v>
                </c:pt>
                <c:pt idx="1179">
                  <c:v>6.306</c:v>
                </c:pt>
                <c:pt idx="1180">
                  <c:v>6.2169999999999996</c:v>
                </c:pt>
                <c:pt idx="1181">
                  <c:v>6.133</c:v>
                </c:pt>
                <c:pt idx="1182">
                  <c:v>6.0510000000000002</c:v>
                </c:pt>
                <c:pt idx="1183">
                  <c:v>5.9690000000000003</c:v>
                </c:pt>
                <c:pt idx="1184">
                  <c:v>5.8920000000000003</c:v>
                </c:pt>
                <c:pt idx="1185">
                  <c:v>5.8170000000000002</c:v>
                </c:pt>
                <c:pt idx="1186">
                  <c:v>5.7469999999999999</c:v>
                </c:pt>
                <c:pt idx="1187">
                  <c:v>5.6790000000000003</c:v>
                </c:pt>
                <c:pt idx="1188">
                  <c:v>5.6059999999999999</c:v>
                </c:pt>
                <c:pt idx="1189">
                  <c:v>5.5330000000000004</c:v>
                </c:pt>
                <c:pt idx="1190">
                  <c:v>5.4539999999999997</c:v>
                </c:pt>
                <c:pt idx="1191">
                  <c:v>5.3710000000000004</c:v>
                </c:pt>
                <c:pt idx="1192">
                  <c:v>5.29</c:v>
                </c:pt>
                <c:pt idx="1193">
                  <c:v>5.2119999999999997</c:v>
                </c:pt>
                <c:pt idx="1194">
                  <c:v>5.1269999999999998</c:v>
                </c:pt>
                <c:pt idx="1195">
                  <c:v>5.0449999999999999</c:v>
                </c:pt>
                <c:pt idx="1196">
                  <c:v>4.9539999999999997</c:v>
                </c:pt>
                <c:pt idx="1197">
                  <c:v>4.8659999999999997</c:v>
                </c:pt>
                <c:pt idx="1198">
                  <c:v>4.7880000000000003</c:v>
                </c:pt>
                <c:pt idx="1199">
                  <c:v>4.7069999999999999</c:v>
                </c:pt>
                <c:pt idx="1200">
                  <c:v>4.6289999999999996</c:v>
                </c:pt>
                <c:pt idx="1201">
                  <c:v>4.55</c:v>
                </c:pt>
                <c:pt idx="1202">
                  <c:v>4.4710000000000001</c:v>
                </c:pt>
                <c:pt idx="1203">
                  <c:v>4.3979999999999997</c:v>
                </c:pt>
                <c:pt idx="1204">
                  <c:v>4.3259999999999996</c:v>
                </c:pt>
                <c:pt idx="1205">
                  <c:v>4.2590000000000003</c:v>
                </c:pt>
                <c:pt idx="1206">
                  <c:v>4.1920000000000002</c:v>
                </c:pt>
                <c:pt idx="1207">
                  <c:v>4.1260000000000003</c:v>
                </c:pt>
                <c:pt idx="1208">
                  <c:v>4.0670000000000002</c:v>
                </c:pt>
                <c:pt idx="1209">
                  <c:v>3.9980000000000002</c:v>
                </c:pt>
                <c:pt idx="1210">
                  <c:v>3.9340000000000002</c:v>
                </c:pt>
                <c:pt idx="1211">
                  <c:v>3.87</c:v>
                </c:pt>
                <c:pt idx="1212">
                  <c:v>3.8130000000000002</c:v>
                </c:pt>
                <c:pt idx="1213">
                  <c:v>3.7530000000000001</c:v>
                </c:pt>
                <c:pt idx="1214">
                  <c:v>3.698</c:v>
                </c:pt>
                <c:pt idx="1215">
                  <c:v>3.641</c:v>
                </c:pt>
                <c:pt idx="1216">
                  <c:v>3.5920000000000001</c:v>
                </c:pt>
                <c:pt idx="1217">
                  <c:v>3.5419999999999998</c:v>
                </c:pt>
                <c:pt idx="1218">
                  <c:v>3.4940000000000002</c:v>
                </c:pt>
                <c:pt idx="1219">
                  <c:v>3.4550000000000001</c:v>
                </c:pt>
                <c:pt idx="1220">
                  <c:v>3.411</c:v>
                </c:pt>
                <c:pt idx="1221">
                  <c:v>3.3730000000000002</c:v>
                </c:pt>
                <c:pt idx="1222">
                  <c:v>3.33</c:v>
                </c:pt>
                <c:pt idx="1223">
                  <c:v>3.2970000000000002</c:v>
                </c:pt>
                <c:pt idx="1224">
                  <c:v>3.2639999999999998</c:v>
                </c:pt>
                <c:pt idx="1225">
                  <c:v>3.2320000000000002</c:v>
                </c:pt>
                <c:pt idx="1226">
                  <c:v>3.2</c:v>
                </c:pt>
                <c:pt idx="1227">
                  <c:v>3.1720000000000002</c:v>
                </c:pt>
                <c:pt idx="1228">
                  <c:v>3.1469999999999998</c:v>
                </c:pt>
                <c:pt idx="1229">
                  <c:v>3.1219999999999999</c:v>
                </c:pt>
                <c:pt idx="1230">
                  <c:v>3.0939999999999999</c:v>
                </c:pt>
                <c:pt idx="1231">
                  <c:v>3.0630000000000002</c:v>
                </c:pt>
                <c:pt idx="1232">
                  <c:v>3.0409999999999999</c:v>
                </c:pt>
                <c:pt idx="1233">
                  <c:v>3.016</c:v>
                </c:pt>
                <c:pt idx="1234">
                  <c:v>2.996</c:v>
                </c:pt>
                <c:pt idx="1235">
                  <c:v>2.9689999999999999</c:v>
                </c:pt>
                <c:pt idx="1236">
                  <c:v>2.9489999999999998</c:v>
                </c:pt>
                <c:pt idx="1237">
                  <c:v>2.9319999999999999</c:v>
                </c:pt>
                <c:pt idx="1238">
                  <c:v>2.9180000000000001</c:v>
                </c:pt>
                <c:pt idx="1239">
                  <c:v>2.899</c:v>
                </c:pt>
                <c:pt idx="1240">
                  <c:v>2.8849999999999998</c:v>
                </c:pt>
                <c:pt idx="1241">
                  <c:v>2.8639999999999999</c:v>
                </c:pt>
                <c:pt idx="1242">
                  <c:v>2.8479999999999999</c:v>
                </c:pt>
                <c:pt idx="1243">
                  <c:v>2.83</c:v>
                </c:pt>
                <c:pt idx="1244">
                  <c:v>2.8130000000000002</c:v>
                </c:pt>
                <c:pt idx="1245">
                  <c:v>2.8029999999999999</c:v>
                </c:pt>
                <c:pt idx="1246">
                  <c:v>2.7879999999999998</c:v>
                </c:pt>
                <c:pt idx="1247">
                  <c:v>2.7759999999999998</c:v>
                </c:pt>
                <c:pt idx="1248">
                  <c:v>2.7629999999999999</c:v>
                </c:pt>
                <c:pt idx="1249">
                  <c:v>2.7559999999999998</c:v>
                </c:pt>
                <c:pt idx="1250">
                  <c:v>2.7450000000000001</c:v>
                </c:pt>
                <c:pt idx="1251">
                  <c:v>2.734</c:v>
                </c:pt>
                <c:pt idx="1252">
                  <c:v>2.72</c:v>
                </c:pt>
                <c:pt idx="1253">
                  <c:v>2.7130000000000001</c:v>
                </c:pt>
                <c:pt idx="1254">
                  <c:v>2.7</c:v>
                </c:pt>
                <c:pt idx="1255">
                  <c:v>2.6890000000000001</c:v>
                </c:pt>
                <c:pt idx="1256">
                  <c:v>2.677</c:v>
                </c:pt>
                <c:pt idx="1257">
                  <c:v>2.6669999999999998</c:v>
                </c:pt>
                <c:pt idx="1258">
                  <c:v>2.6579999999999999</c:v>
                </c:pt>
                <c:pt idx="1259">
                  <c:v>2.6480000000000001</c:v>
                </c:pt>
                <c:pt idx="1260">
                  <c:v>2.6389999999999998</c:v>
                </c:pt>
                <c:pt idx="1261">
                  <c:v>2.6280000000000001</c:v>
                </c:pt>
                <c:pt idx="1262">
                  <c:v>2.6160000000000001</c:v>
                </c:pt>
                <c:pt idx="1263">
                  <c:v>2.6070000000000002</c:v>
                </c:pt>
                <c:pt idx="1264">
                  <c:v>2.5979999999999999</c:v>
                </c:pt>
                <c:pt idx="1265">
                  <c:v>2.593</c:v>
                </c:pt>
                <c:pt idx="1266">
                  <c:v>2.581</c:v>
                </c:pt>
                <c:pt idx="1267">
                  <c:v>2.5659999999999998</c:v>
                </c:pt>
                <c:pt idx="1268">
                  <c:v>2.552</c:v>
                </c:pt>
                <c:pt idx="1269">
                  <c:v>2.5449999999999999</c:v>
                </c:pt>
                <c:pt idx="1270">
                  <c:v>2.5350000000000001</c:v>
                </c:pt>
                <c:pt idx="1271">
                  <c:v>2.5230000000000001</c:v>
                </c:pt>
                <c:pt idx="1272">
                  <c:v>2.508</c:v>
                </c:pt>
                <c:pt idx="1273">
                  <c:v>2.4940000000000002</c:v>
                </c:pt>
                <c:pt idx="1274">
                  <c:v>2.4889999999999999</c:v>
                </c:pt>
                <c:pt idx="1275">
                  <c:v>2.48</c:v>
                </c:pt>
                <c:pt idx="1276">
                  <c:v>2.472</c:v>
                </c:pt>
                <c:pt idx="1277">
                  <c:v>2.46</c:v>
                </c:pt>
                <c:pt idx="1278">
                  <c:v>2.4489999999999998</c:v>
                </c:pt>
                <c:pt idx="1279">
                  <c:v>2.4350000000000001</c:v>
                </c:pt>
                <c:pt idx="1280">
                  <c:v>2.4260000000000002</c:v>
                </c:pt>
                <c:pt idx="1281">
                  <c:v>2.4129999999999998</c:v>
                </c:pt>
                <c:pt idx="1282">
                  <c:v>2.399</c:v>
                </c:pt>
                <c:pt idx="1283">
                  <c:v>2.387</c:v>
                </c:pt>
                <c:pt idx="1284">
                  <c:v>2.3740000000000001</c:v>
                </c:pt>
                <c:pt idx="1285">
                  <c:v>2.36</c:v>
                </c:pt>
                <c:pt idx="1286">
                  <c:v>2.3490000000000002</c:v>
                </c:pt>
                <c:pt idx="1287">
                  <c:v>2.3420000000000001</c:v>
                </c:pt>
                <c:pt idx="1288">
                  <c:v>2.3340000000000001</c:v>
                </c:pt>
                <c:pt idx="1289">
                  <c:v>2.3199999999999998</c:v>
                </c:pt>
                <c:pt idx="1290">
                  <c:v>2.3090000000000002</c:v>
                </c:pt>
                <c:pt idx="1291">
                  <c:v>2.2989999999999999</c:v>
                </c:pt>
                <c:pt idx="1292">
                  <c:v>2.29</c:v>
                </c:pt>
                <c:pt idx="1293">
                  <c:v>2.2789999999999999</c:v>
                </c:pt>
                <c:pt idx="1294">
                  <c:v>2.2719999999999998</c:v>
                </c:pt>
                <c:pt idx="1295">
                  <c:v>2.2629999999999999</c:v>
                </c:pt>
                <c:pt idx="1296">
                  <c:v>2.254</c:v>
                </c:pt>
                <c:pt idx="1297">
                  <c:v>2.2400000000000002</c:v>
                </c:pt>
                <c:pt idx="1298">
                  <c:v>2.2290000000000001</c:v>
                </c:pt>
                <c:pt idx="1299">
                  <c:v>2.2200000000000002</c:v>
                </c:pt>
                <c:pt idx="1300">
                  <c:v>2.2149999999999999</c:v>
                </c:pt>
                <c:pt idx="1301">
                  <c:v>2.2050000000000001</c:v>
                </c:pt>
                <c:pt idx="1302">
                  <c:v>2.1970000000000001</c:v>
                </c:pt>
                <c:pt idx="1303">
                  <c:v>2.1859999999999999</c:v>
                </c:pt>
                <c:pt idx="1304">
                  <c:v>2.177</c:v>
                </c:pt>
                <c:pt idx="1305">
                  <c:v>2.1669999999999998</c:v>
                </c:pt>
                <c:pt idx="1306">
                  <c:v>2.1589999999999998</c:v>
                </c:pt>
                <c:pt idx="1307">
                  <c:v>2.1469999999999998</c:v>
                </c:pt>
                <c:pt idx="1308">
                  <c:v>2.1320000000000001</c:v>
                </c:pt>
                <c:pt idx="1309">
                  <c:v>2.1259999999999999</c:v>
                </c:pt>
                <c:pt idx="1310">
                  <c:v>2.125</c:v>
                </c:pt>
                <c:pt idx="1311">
                  <c:v>2.1240000000000001</c:v>
                </c:pt>
                <c:pt idx="1312">
                  <c:v>2.113</c:v>
                </c:pt>
                <c:pt idx="1313">
                  <c:v>2.101</c:v>
                </c:pt>
                <c:pt idx="1314">
                  <c:v>2.09</c:v>
                </c:pt>
                <c:pt idx="1315">
                  <c:v>2.0830000000000002</c:v>
                </c:pt>
                <c:pt idx="1316">
                  <c:v>2.0750000000000002</c:v>
                </c:pt>
                <c:pt idx="1317">
                  <c:v>2.0680000000000001</c:v>
                </c:pt>
                <c:pt idx="1318">
                  <c:v>2.0419999999999998</c:v>
                </c:pt>
                <c:pt idx="1319">
                  <c:v>2.0270000000000001</c:v>
                </c:pt>
                <c:pt idx="1320">
                  <c:v>2.024</c:v>
                </c:pt>
                <c:pt idx="1321">
                  <c:v>2.0379999999999998</c:v>
                </c:pt>
                <c:pt idx="1322">
                  <c:v>2.0449999999999999</c:v>
                </c:pt>
                <c:pt idx="1323">
                  <c:v>2.0350000000000001</c:v>
                </c:pt>
                <c:pt idx="1324">
                  <c:v>2.0209999999999999</c:v>
                </c:pt>
                <c:pt idx="1325">
                  <c:v>2.016</c:v>
                </c:pt>
                <c:pt idx="1326">
                  <c:v>2.008</c:v>
                </c:pt>
                <c:pt idx="1327">
                  <c:v>2.0030000000000001</c:v>
                </c:pt>
                <c:pt idx="1328">
                  <c:v>1.998</c:v>
                </c:pt>
                <c:pt idx="1329">
                  <c:v>1.9910000000000001</c:v>
                </c:pt>
                <c:pt idx="1330">
                  <c:v>1.988</c:v>
                </c:pt>
                <c:pt idx="1331">
                  <c:v>1.9910000000000001</c:v>
                </c:pt>
                <c:pt idx="1332">
                  <c:v>1.9910000000000001</c:v>
                </c:pt>
                <c:pt idx="1333">
                  <c:v>1.9850000000000001</c:v>
                </c:pt>
                <c:pt idx="1334">
                  <c:v>1.974</c:v>
                </c:pt>
                <c:pt idx="1335">
                  <c:v>1.972</c:v>
                </c:pt>
                <c:pt idx="1336">
                  <c:v>1.976</c:v>
                </c:pt>
                <c:pt idx="1337">
                  <c:v>1.9750000000000001</c:v>
                </c:pt>
                <c:pt idx="1338">
                  <c:v>1.9650000000000001</c:v>
                </c:pt>
                <c:pt idx="1339">
                  <c:v>1.9570000000000001</c:v>
                </c:pt>
                <c:pt idx="1340">
                  <c:v>1.954</c:v>
                </c:pt>
                <c:pt idx="1341">
                  <c:v>1.958</c:v>
                </c:pt>
                <c:pt idx="1342">
                  <c:v>1.9510000000000001</c:v>
                </c:pt>
                <c:pt idx="1343">
                  <c:v>1.9530000000000001</c:v>
                </c:pt>
                <c:pt idx="1344">
                  <c:v>1.946</c:v>
                </c:pt>
                <c:pt idx="1345">
                  <c:v>1.946</c:v>
                </c:pt>
                <c:pt idx="1346">
                  <c:v>1.9490000000000001</c:v>
                </c:pt>
                <c:pt idx="1347">
                  <c:v>1.952</c:v>
                </c:pt>
                <c:pt idx="1348">
                  <c:v>1.9510000000000001</c:v>
                </c:pt>
                <c:pt idx="1349">
                  <c:v>1.946</c:v>
                </c:pt>
                <c:pt idx="1350">
                  <c:v>1.94</c:v>
                </c:pt>
                <c:pt idx="1351">
                  <c:v>1.9330000000000001</c:v>
                </c:pt>
                <c:pt idx="1352">
                  <c:v>1.9359999999999999</c:v>
                </c:pt>
                <c:pt idx="1353">
                  <c:v>1.9370000000000001</c:v>
                </c:pt>
                <c:pt idx="1354">
                  <c:v>1.9379999999999999</c:v>
                </c:pt>
                <c:pt idx="1355">
                  <c:v>1.9350000000000001</c:v>
                </c:pt>
                <c:pt idx="1356">
                  <c:v>1.93</c:v>
                </c:pt>
                <c:pt idx="1357">
                  <c:v>1.929</c:v>
                </c:pt>
                <c:pt idx="1358">
                  <c:v>1.927</c:v>
                </c:pt>
                <c:pt idx="1359">
                  <c:v>1.929</c:v>
                </c:pt>
                <c:pt idx="1360">
                  <c:v>1.9279999999999999</c:v>
                </c:pt>
                <c:pt idx="1361">
                  <c:v>1.9219999999999999</c:v>
                </c:pt>
                <c:pt idx="1362">
                  <c:v>1.92</c:v>
                </c:pt>
                <c:pt idx="1363">
                  <c:v>1.917</c:v>
                </c:pt>
                <c:pt idx="1364">
                  <c:v>1.9079999999999999</c:v>
                </c:pt>
                <c:pt idx="1365">
                  <c:v>1.9019999999999999</c:v>
                </c:pt>
                <c:pt idx="1366">
                  <c:v>1.895</c:v>
                </c:pt>
                <c:pt idx="1367">
                  <c:v>1.8959999999999999</c:v>
                </c:pt>
                <c:pt idx="1368">
                  <c:v>1.89</c:v>
                </c:pt>
                <c:pt idx="1369">
                  <c:v>1.8839999999999999</c:v>
                </c:pt>
                <c:pt idx="1370">
                  <c:v>1.877</c:v>
                </c:pt>
                <c:pt idx="1371">
                  <c:v>1.8680000000000001</c:v>
                </c:pt>
                <c:pt idx="1372">
                  <c:v>1.86</c:v>
                </c:pt>
                <c:pt idx="1373">
                  <c:v>1.8520000000000001</c:v>
                </c:pt>
                <c:pt idx="1374">
                  <c:v>1.8460000000000001</c:v>
                </c:pt>
                <c:pt idx="1375">
                  <c:v>1.84</c:v>
                </c:pt>
                <c:pt idx="1376">
                  <c:v>1.8340000000000001</c:v>
                </c:pt>
                <c:pt idx="1377">
                  <c:v>1.8260000000000001</c:v>
                </c:pt>
                <c:pt idx="1378">
                  <c:v>1.8169999999999999</c:v>
                </c:pt>
                <c:pt idx="1379">
                  <c:v>1.8169999999999999</c:v>
                </c:pt>
                <c:pt idx="1380">
                  <c:v>1.8160000000000001</c:v>
                </c:pt>
                <c:pt idx="1381">
                  <c:v>1.8089999999999999</c:v>
                </c:pt>
                <c:pt idx="1382">
                  <c:v>1.7969999999999999</c:v>
                </c:pt>
                <c:pt idx="1383">
                  <c:v>1.792</c:v>
                </c:pt>
                <c:pt idx="1384">
                  <c:v>1.7829999999999999</c:v>
                </c:pt>
                <c:pt idx="1385">
                  <c:v>1.7769999999999999</c:v>
                </c:pt>
                <c:pt idx="1386">
                  <c:v>1.7669999999999999</c:v>
                </c:pt>
                <c:pt idx="1387">
                  <c:v>1.762</c:v>
                </c:pt>
                <c:pt idx="1388">
                  <c:v>1.756</c:v>
                </c:pt>
                <c:pt idx="1389">
                  <c:v>1.7450000000000001</c:v>
                </c:pt>
                <c:pt idx="1390">
                  <c:v>1.736</c:v>
                </c:pt>
                <c:pt idx="1391">
                  <c:v>1.73</c:v>
                </c:pt>
                <c:pt idx="1392">
                  <c:v>1.7290000000000001</c:v>
                </c:pt>
                <c:pt idx="1393">
                  <c:v>1.7210000000000001</c:v>
                </c:pt>
                <c:pt idx="1394">
                  <c:v>1.71</c:v>
                </c:pt>
                <c:pt idx="1395">
                  <c:v>1.7030000000000001</c:v>
                </c:pt>
                <c:pt idx="1396">
                  <c:v>1.696</c:v>
                </c:pt>
                <c:pt idx="1397">
                  <c:v>1.69</c:v>
                </c:pt>
                <c:pt idx="1398">
                  <c:v>1.6759999999999999</c:v>
                </c:pt>
                <c:pt idx="1399">
                  <c:v>1.6679999999999999</c:v>
                </c:pt>
                <c:pt idx="1400">
                  <c:v>1.659</c:v>
                </c:pt>
                <c:pt idx="1401">
                  <c:v>1.651</c:v>
                </c:pt>
                <c:pt idx="1402">
                  <c:v>1.6379999999999999</c:v>
                </c:pt>
                <c:pt idx="1403">
                  <c:v>1.631</c:v>
                </c:pt>
                <c:pt idx="1404">
                  <c:v>1.619</c:v>
                </c:pt>
                <c:pt idx="1405">
                  <c:v>1.6060000000000001</c:v>
                </c:pt>
                <c:pt idx="1406">
                  <c:v>1.599</c:v>
                </c:pt>
                <c:pt idx="1407">
                  <c:v>1.59</c:v>
                </c:pt>
                <c:pt idx="1408">
                  <c:v>1.5840000000000001</c:v>
                </c:pt>
                <c:pt idx="1409">
                  <c:v>1.571</c:v>
                </c:pt>
                <c:pt idx="1410">
                  <c:v>1.5620000000000001</c:v>
                </c:pt>
                <c:pt idx="1411">
                  <c:v>1.554</c:v>
                </c:pt>
                <c:pt idx="1412">
                  <c:v>1.5409999999999999</c:v>
                </c:pt>
                <c:pt idx="1413">
                  <c:v>1.5329999999999999</c:v>
                </c:pt>
                <c:pt idx="1414">
                  <c:v>1.522</c:v>
                </c:pt>
                <c:pt idx="1415">
                  <c:v>1.5109999999999999</c:v>
                </c:pt>
                <c:pt idx="1416">
                  <c:v>1.5009999999999999</c:v>
                </c:pt>
                <c:pt idx="1417">
                  <c:v>1.4970000000000001</c:v>
                </c:pt>
                <c:pt idx="1418">
                  <c:v>1.492</c:v>
                </c:pt>
                <c:pt idx="1419">
                  <c:v>1.484</c:v>
                </c:pt>
                <c:pt idx="1420">
                  <c:v>1.4750000000000001</c:v>
                </c:pt>
                <c:pt idx="1421">
                  <c:v>1.4650000000000001</c:v>
                </c:pt>
                <c:pt idx="1422">
                  <c:v>1.458</c:v>
                </c:pt>
                <c:pt idx="1423">
                  <c:v>1.4490000000000001</c:v>
                </c:pt>
                <c:pt idx="1424">
                  <c:v>1.4419999999999999</c:v>
                </c:pt>
                <c:pt idx="1425">
                  <c:v>1.4339999999999999</c:v>
                </c:pt>
                <c:pt idx="1426">
                  <c:v>1.43</c:v>
                </c:pt>
                <c:pt idx="1427">
                  <c:v>1.425</c:v>
                </c:pt>
                <c:pt idx="1428">
                  <c:v>1.423</c:v>
                </c:pt>
                <c:pt idx="1429">
                  <c:v>1.371</c:v>
                </c:pt>
                <c:pt idx="1430">
                  <c:v>1.371</c:v>
                </c:pt>
                <c:pt idx="1431">
                  <c:v>1.371</c:v>
                </c:pt>
                <c:pt idx="1432">
                  <c:v>1.371</c:v>
                </c:pt>
                <c:pt idx="1433">
                  <c:v>1.371</c:v>
                </c:pt>
                <c:pt idx="1434">
                  <c:v>1.371</c:v>
                </c:pt>
                <c:pt idx="1435">
                  <c:v>1.371</c:v>
                </c:pt>
                <c:pt idx="1436">
                  <c:v>1.371</c:v>
                </c:pt>
                <c:pt idx="1437">
                  <c:v>1.371</c:v>
                </c:pt>
                <c:pt idx="1438">
                  <c:v>1.371</c:v>
                </c:pt>
                <c:pt idx="1439">
                  <c:v>1.371</c:v>
                </c:pt>
                <c:pt idx="1440">
                  <c:v>1.371</c:v>
                </c:pt>
                <c:pt idx="1441">
                  <c:v>1.37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9E8-5243-80B7-5E4EB0EB53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832112"/>
        <c:axId val="251982656"/>
      </c:scatterChart>
      <c:valAx>
        <c:axId val="251832112"/>
        <c:scaling>
          <c:orientation val="minMax"/>
          <c:max val="20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GB" sz="1200" b="1" dirty="0"/>
                  <a:t>Elute Volume, </a:t>
                </a:r>
                <a:r>
                  <a:rPr lang="en-GB" sz="1200" b="1" dirty="0" err="1"/>
                  <a:t>V</a:t>
                </a:r>
                <a:r>
                  <a:rPr lang="en-GB" sz="1000" b="1" dirty="0" err="1"/>
                  <a:t>e</a:t>
                </a:r>
                <a:r>
                  <a:rPr lang="en-GB" sz="1200" b="1" dirty="0"/>
                  <a:t> (ml)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 b="1"/>
            </a:pPr>
            <a:endParaRPr lang="en-US"/>
          </a:p>
        </c:txPr>
        <c:crossAx val="251982656"/>
        <c:crosses val="autoZero"/>
        <c:crossBetween val="midCat"/>
        <c:majorUnit val="5"/>
        <c:minorUnit val="1"/>
      </c:valAx>
      <c:valAx>
        <c:axId val="251982656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UV </a:t>
                </a:r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bsorption</a:t>
                </a:r>
                <a:r>
                  <a:rPr lang="en-GB" sz="1000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GB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mAU</a:t>
                </a:r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4.736452204043784E-2"/>
              <c:y val="9.9044596264566923E-2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 b="1"/>
            </a:pPr>
            <a:endParaRPr lang="en-US"/>
          </a:p>
        </c:txPr>
        <c:crossAx val="25183211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67873992452761"/>
          <c:y val="9.9611657263294601E-2"/>
          <c:w val="0.67955264724774811"/>
          <c:h val="0.5912159235734786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Curves!$B$3</c:f>
              <c:strCache>
                <c:ptCount val="1"/>
                <c:pt idx="0">
                  <c:v> mAU</c:v>
                </c:pt>
              </c:strCache>
            </c:strRef>
          </c:tx>
          <c:marker>
            <c:symbol val="none"/>
          </c:marker>
          <c:xVal>
            <c:numRef>
              <c:f>Curves!$A$4:$A$940</c:f>
              <c:numCache>
                <c:formatCode>###0.00</c:formatCode>
                <c:ptCount val="937"/>
                <c:pt idx="0">
                  <c:v>0</c:v>
                </c:pt>
                <c:pt idx="1">
                  <c:v>2.8228388473852725E-2</c:v>
                </c:pt>
                <c:pt idx="2">
                  <c:v>5.6456776947705449E-2</c:v>
                </c:pt>
                <c:pt idx="3">
                  <c:v>8.468516542155817E-2</c:v>
                </c:pt>
                <c:pt idx="4">
                  <c:v>0.1129135538954109</c:v>
                </c:pt>
                <c:pt idx="5">
                  <c:v>0.14114194236926361</c:v>
                </c:pt>
                <c:pt idx="6">
                  <c:v>0.16937033084311634</c:v>
                </c:pt>
                <c:pt idx="7">
                  <c:v>0.19759871931696907</c:v>
                </c:pt>
                <c:pt idx="8">
                  <c:v>0.2258271077908218</c:v>
                </c:pt>
                <c:pt idx="9">
                  <c:v>0.2540554962646745</c:v>
                </c:pt>
                <c:pt idx="10">
                  <c:v>0.28228388473852722</c:v>
                </c:pt>
                <c:pt idx="11">
                  <c:v>0.31051227321237995</c:v>
                </c:pt>
                <c:pt idx="12">
                  <c:v>0.33874066168623268</c:v>
                </c:pt>
                <c:pt idx="13">
                  <c:v>0.36696905016008541</c:v>
                </c:pt>
                <c:pt idx="14">
                  <c:v>0.39519743863393814</c:v>
                </c:pt>
                <c:pt idx="15">
                  <c:v>0.42342582710779086</c:v>
                </c:pt>
                <c:pt idx="16">
                  <c:v>0.45165421558164359</c:v>
                </c:pt>
                <c:pt idx="17">
                  <c:v>0.47988260405549626</c:v>
                </c:pt>
                <c:pt idx="18">
                  <c:v>0.50811099252934899</c:v>
                </c:pt>
                <c:pt idx="19">
                  <c:v>0.53633938100320178</c:v>
                </c:pt>
                <c:pt idx="20">
                  <c:v>0.56456776947705445</c:v>
                </c:pt>
                <c:pt idx="21">
                  <c:v>0.59279615795090723</c:v>
                </c:pt>
                <c:pt idx="22">
                  <c:v>0.6210245464247599</c:v>
                </c:pt>
                <c:pt idx="23">
                  <c:v>0.64925293489861258</c:v>
                </c:pt>
                <c:pt idx="24">
                  <c:v>0.67748132337246536</c:v>
                </c:pt>
                <c:pt idx="25">
                  <c:v>0.70570971184631803</c:v>
                </c:pt>
                <c:pt idx="26">
                  <c:v>0.73393810032017082</c:v>
                </c:pt>
                <c:pt idx="27">
                  <c:v>0.76216648879402349</c:v>
                </c:pt>
                <c:pt idx="28">
                  <c:v>0.79039487726787627</c:v>
                </c:pt>
                <c:pt idx="29">
                  <c:v>0.81862326574172894</c:v>
                </c:pt>
                <c:pt idx="30">
                  <c:v>0.84685165421558173</c:v>
                </c:pt>
                <c:pt idx="31">
                  <c:v>0.8750800426894344</c:v>
                </c:pt>
                <c:pt idx="32">
                  <c:v>0.90330843116328718</c:v>
                </c:pt>
                <c:pt idx="33">
                  <c:v>0.93153681963713986</c:v>
                </c:pt>
                <c:pt idx="34">
                  <c:v>0.95976520811099253</c:v>
                </c:pt>
                <c:pt idx="35">
                  <c:v>0.98799359658484531</c:v>
                </c:pt>
                <c:pt idx="36">
                  <c:v>1.016221985058698</c:v>
                </c:pt>
                <c:pt idx="37">
                  <c:v>1.0444503735325508</c:v>
                </c:pt>
                <c:pt idx="38">
                  <c:v>1.0726787620064036</c:v>
                </c:pt>
                <c:pt idx="39">
                  <c:v>1.1009071504802561</c:v>
                </c:pt>
                <c:pt idx="40">
                  <c:v>1.1291355389541089</c:v>
                </c:pt>
                <c:pt idx="41">
                  <c:v>1.1573639274279617</c:v>
                </c:pt>
                <c:pt idx="42">
                  <c:v>1.1855923159018145</c:v>
                </c:pt>
                <c:pt idx="43">
                  <c:v>1.213820704375667</c:v>
                </c:pt>
                <c:pt idx="44">
                  <c:v>1.2420490928495198</c:v>
                </c:pt>
                <c:pt idx="45">
                  <c:v>1.2702774813233726</c:v>
                </c:pt>
                <c:pt idx="46">
                  <c:v>1.2985058697972252</c:v>
                </c:pt>
                <c:pt idx="47">
                  <c:v>1.3267342582710779</c:v>
                </c:pt>
                <c:pt idx="48">
                  <c:v>1.3549626467449307</c:v>
                </c:pt>
                <c:pt idx="49">
                  <c:v>1.3831910352187835</c:v>
                </c:pt>
                <c:pt idx="50">
                  <c:v>1.4114194236926361</c:v>
                </c:pt>
                <c:pt idx="51">
                  <c:v>1.4396478121664888</c:v>
                </c:pt>
                <c:pt idx="52">
                  <c:v>1.4678762006403416</c:v>
                </c:pt>
                <c:pt idx="53">
                  <c:v>1.4961045891141944</c:v>
                </c:pt>
                <c:pt idx="54">
                  <c:v>1.524332977588047</c:v>
                </c:pt>
                <c:pt idx="55">
                  <c:v>1.5525613660618998</c:v>
                </c:pt>
                <c:pt idx="56">
                  <c:v>1.5807897545357525</c:v>
                </c:pt>
                <c:pt idx="57">
                  <c:v>1.6090181430096051</c:v>
                </c:pt>
                <c:pt idx="58">
                  <c:v>1.6372465314834579</c:v>
                </c:pt>
                <c:pt idx="59">
                  <c:v>1.6654749199573107</c:v>
                </c:pt>
                <c:pt idx="60">
                  <c:v>1.6937033084311635</c:v>
                </c:pt>
                <c:pt idx="61">
                  <c:v>1.721931696905016</c:v>
                </c:pt>
                <c:pt idx="62">
                  <c:v>1.7501600853788688</c:v>
                </c:pt>
                <c:pt idx="63">
                  <c:v>1.7783884738527216</c:v>
                </c:pt>
                <c:pt idx="64">
                  <c:v>1.8066168623265744</c:v>
                </c:pt>
                <c:pt idx="65">
                  <c:v>1.8348452508004269</c:v>
                </c:pt>
                <c:pt idx="66">
                  <c:v>1.8630736392742797</c:v>
                </c:pt>
                <c:pt idx="67">
                  <c:v>1.8913020277481325</c:v>
                </c:pt>
                <c:pt idx="68">
                  <c:v>1.9195304162219851</c:v>
                </c:pt>
                <c:pt idx="69">
                  <c:v>1.9477588046958378</c:v>
                </c:pt>
                <c:pt idx="70">
                  <c:v>1.9759871931696906</c:v>
                </c:pt>
                <c:pt idx="71">
                  <c:v>2.0042155816435434</c:v>
                </c:pt>
                <c:pt idx="72">
                  <c:v>2.032443970117396</c:v>
                </c:pt>
                <c:pt idx="73">
                  <c:v>2.060672358591249</c:v>
                </c:pt>
                <c:pt idx="74">
                  <c:v>2.0889007470651015</c:v>
                </c:pt>
                <c:pt idx="75">
                  <c:v>2.1171291355389541</c:v>
                </c:pt>
                <c:pt idx="76">
                  <c:v>2.1453575240128071</c:v>
                </c:pt>
                <c:pt idx="77">
                  <c:v>2.1735859124866597</c:v>
                </c:pt>
                <c:pt idx="78">
                  <c:v>2.2018143009605122</c:v>
                </c:pt>
                <c:pt idx="79">
                  <c:v>2.2300426894343652</c:v>
                </c:pt>
                <c:pt idx="80">
                  <c:v>2.2582710779082178</c:v>
                </c:pt>
                <c:pt idx="81">
                  <c:v>2.2864994663820704</c:v>
                </c:pt>
                <c:pt idx="82">
                  <c:v>2.3147278548559234</c:v>
                </c:pt>
                <c:pt idx="83">
                  <c:v>2.3429562433297759</c:v>
                </c:pt>
                <c:pt idx="84">
                  <c:v>2.3711846318036289</c:v>
                </c:pt>
                <c:pt idx="85">
                  <c:v>2.3994130202774815</c:v>
                </c:pt>
                <c:pt idx="86">
                  <c:v>2.4276414087513341</c:v>
                </c:pt>
                <c:pt idx="87">
                  <c:v>2.4558697972251871</c:v>
                </c:pt>
                <c:pt idx="88">
                  <c:v>2.4840981856990396</c:v>
                </c:pt>
                <c:pt idx="89">
                  <c:v>2.5123265741728922</c:v>
                </c:pt>
                <c:pt idx="90">
                  <c:v>2.5405549626467452</c:v>
                </c:pt>
                <c:pt idx="91">
                  <c:v>2.5687833511205977</c:v>
                </c:pt>
                <c:pt idx="92">
                  <c:v>2.5970117395944503</c:v>
                </c:pt>
                <c:pt idx="93">
                  <c:v>2.6252401280683033</c:v>
                </c:pt>
                <c:pt idx="94">
                  <c:v>2.6534685165421559</c:v>
                </c:pt>
                <c:pt idx="95">
                  <c:v>2.6816969050160089</c:v>
                </c:pt>
                <c:pt idx="96">
                  <c:v>2.7099252934898614</c:v>
                </c:pt>
                <c:pt idx="97">
                  <c:v>2.738153681963714</c:v>
                </c:pt>
                <c:pt idx="98">
                  <c:v>2.766382070437567</c:v>
                </c:pt>
                <c:pt idx="99">
                  <c:v>2.7946104589114196</c:v>
                </c:pt>
                <c:pt idx="100">
                  <c:v>2.8228388473852721</c:v>
                </c:pt>
                <c:pt idx="101">
                  <c:v>2.8510672358591251</c:v>
                </c:pt>
                <c:pt idx="102">
                  <c:v>2.8792956243329777</c:v>
                </c:pt>
                <c:pt idx="103">
                  <c:v>2.9075240128068303</c:v>
                </c:pt>
                <c:pt idx="104">
                  <c:v>2.9357524012806833</c:v>
                </c:pt>
                <c:pt idx="105">
                  <c:v>2.9639807897545358</c:v>
                </c:pt>
                <c:pt idx="106">
                  <c:v>2.9922091782283888</c:v>
                </c:pt>
                <c:pt idx="107">
                  <c:v>3.0204375667022414</c:v>
                </c:pt>
                <c:pt idx="108">
                  <c:v>3.048665955176094</c:v>
                </c:pt>
                <c:pt idx="109">
                  <c:v>3.076894343649947</c:v>
                </c:pt>
                <c:pt idx="110">
                  <c:v>3.1051227321237995</c:v>
                </c:pt>
                <c:pt idx="111">
                  <c:v>3.1333511205976521</c:v>
                </c:pt>
                <c:pt idx="112">
                  <c:v>3.1615795090715051</c:v>
                </c:pt>
                <c:pt idx="113">
                  <c:v>3.1898078975453577</c:v>
                </c:pt>
                <c:pt idx="114">
                  <c:v>3.2180362860192102</c:v>
                </c:pt>
                <c:pt idx="115">
                  <c:v>3.2462646744930632</c:v>
                </c:pt>
                <c:pt idx="116">
                  <c:v>3.2744930629669158</c:v>
                </c:pt>
                <c:pt idx="117">
                  <c:v>3.3027214514407688</c:v>
                </c:pt>
                <c:pt idx="118">
                  <c:v>3.3309498399146213</c:v>
                </c:pt>
                <c:pt idx="119">
                  <c:v>3.3591782283884739</c:v>
                </c:pt>
                <c:pt idx="120">
                  <c:v>3.3874066168623269</c:v>
                </c:pt>
                <c:pt idx="121">
                  <c:v>3.4156350053361795</c:v>
                </c:pt>
                <c:pt idx="122">
                  <c:v>3.443863393810032</c:v>
                </c:pt>
                <c:pt idx="123">
                  <c:v>3.472091782283885</c:v>
                </c:pt>
                <c:pt idx="124">
                  <c:v>3.5003201707577376</c:v>
                </c:pt>
                <c:pt idx="125">
                  <c:v>3.5285485592315902</c:v>
                </c:pt>
                <c:pt idx="126">
                  <c:v>3.5567769477054432</c:v>
                </c:pt>
                <c:pt idx="127">
                  <c:v>3.5850053361792957</c:v>
                </c:pt>
                <c:pt idx="128">
                  <c:v>3.6132337246531487</c:v>
                </c:pt>
                <c:pt idx="129">
                  <c:v>3.6414621131270013</c:v>
                </c:pt>
                <c:pt idx="130">
                  <c:v>3.6696905016008539</c:v>
                </c:pt>
                <c:pt idx="131">
                  <c:v>3.6979188900747069</c:v>
                </c:pt>
                <c:pt idx="132">
                  <c:v>3.7261472785485594</c:v>
                </c:pt>
                <c:pt idx="133">
                  <c:v>3.754375667022412</c:v>
                </c:pt>
                <c:pt idx="134">
                  <c:v>3.782604055496265</c:v>
                </c:pt>
                <c:pt idx="135">
                  <c:v>3.8108324439701176</c:v>
                </c:pt>
                <c:pt idx="136">
                  <c:v>3.8390608324439701</c:v>
                </c:pt>
                <c:pt idx="137">
                  <c:v>3.8672892209178231</c:v>
                </c:pt>
                <c:pt idx="138">
                  <c:v>3.8955176093916757</c:v>
                </c:pt>
                <c:pt idx="139">
                  <c:v>3.9237459978655287</c:v>
                </c:pt>
                <c:pt idx="140">
                  <c:v>3.9519743863393813</c:v>
                </c:pt>
                <c:pt idx="141">
                  <c:v>3.9802027748132338</c:v>
                </c:pt>
                <c:pt idx="142">
                  <c:v>4.0084311632870868</c:v>
                </c:pt>
                <c:pt idx="143">
                  <c:v>4.0366595517609394</c:v>
                </c:pt>
                <c:pt idx="144">
                  <c:v>4.0648879402347919</c:v>
                </c:pt>
                <c:pt idx="145">
                  <c:v>4.0931163287086445</c:v>
                </c:pt>
                <c:pt idx="146">
                  <c:v>4.121344717182498</c:v>
                </c:pt>
                <c:pt idx="147">
                  <c:v>4.1495731056563505</c:v>
                </c:pt>
                <c:pt idx="148">
                  <c:v>4.1778014941302031</c:v>
                </c:pt>
                <c:pt idx="149">
                  <c:v>4.2060298826040556</c:v>
                </c:pt>
                <c:pt idx="150">
                  <c:v>4.2342582710779082</c:v>
                </c:pt>
                <c:pt idx="151">
                  <c:v>4.2624866595517608</c:v>
                </c:pt>
                <c:pt idx="152">
                  <c:v>4.2907150480256142</c:v>
                </c:pt>
                <c:pt idx="153">
                  <c:v>4.3189434364994668</c:v>
                </c:pt>
                <c:pt idx="154">
                  <c:v>4.3471718249733193</c:v>
                </c:pt>
                <c:pt idx="155">
                  <c:v>4.3754002134471719</c:v>
                </c:pt>
                <c:pt idx="156">
                  <c:v>4.4036286019210245</c:v>
                </c:pt>
                <c:pt idx="157">
                  <c:v>4.4318569903948779</c:v>
                </c:pt>
                <c:pt idx="158">
                  <c:v>4.4600853788687305</c:v>
                </c:pt>
                <c:pt idx="159">
                  <c:v>4.488313767342583</c:v>
                </c:pt>
                <c:pt idx="160">
                  <c:v>4.5165421558164356</c:v>
                </c:pt>
                <c:pt idx="161">
                  <c:v>4.5447705442902882</c:v>
                </c:pt>
                <c:pt idx="162">
                  <c:v>4.5729989327641407</c:v>
                </c:pt>
                <c:pt idx="163">
                  <c:v>4.6012273212379942</c:v>
                </c:pt>
                <c:pt idx="164">
                  <c:v>4.6294557097118467</c:v>
                </c:pt>
                <c:pt idx="165">
                  <c:v>4.6576840981856993</c:v>
                </c:pt>
                <c:pt idx="166">
                  <c:v>4.6859124866595518</c:v>
                </c:pt>
                <c:pt idx="167">
                  <c:v>4.7141408751334044</c:v>
                </c:pt>
                <c:pt idx="168">
                  <c:v>4.7423692636072579</c:v>
                </c:pt>
                <c:pt idx="169">
                  <c:v>4.7705976520811104</c:v>
                </c:pt>
                <c:pt idx="170">
                  <c:v>4.798826040554963</c:v>
                </c:pt>
                <c:pt idx="171">
                  <c:v>4.8270544290288155</c:v>
                </c:pt>
                <c:pt idx="172">
                  <c:v>4.8552828175026681</c:v>
                </c:pt>
                <c:pt idx="173">
                  <c:v>4.8835112059765207</c:v>
                </c:pt>
                <c:pt idx="174">
                  <c:v>4.9117395944503741</c:v>
                </c:pt>
                <c:pt idx="175">
                  <c:v>4.9399679829242267</c:v>
                </c:pt>
                <c:pt idx="176">
                  <c:v>4.9681963713980792</c:v>
                </c:pt>
                <c:pt idx="177">
                  <c:v>4.9964247598719318</c:v>
                </c:pt>
                <c:pt idx="178">
                  <c:v>5.0246531483457844</c:v>
                </c:pt>
                <c:pt idx="179">
                  <c:v>5.0528815368196378</c:v>
                </c:pt>
                <c:pt idx="180">
                  <c:v>5.0811099252934904</c:v>
                </c:pt>
                <c:pt idx="181">
                  <c:v>5.1093383137673429</c:v>
                </c:pt>
                <c:pt idx="182">
                  <c:v>5.1375667022411955</c:v>
                </c:pt>
                <c:pt idx="183">
                  <c:v>5.1657950907150481</c:v>
                </c:pt>
                <c:pt idx="184">
                  <c:v>5.1940234791889006</c:v>
                </c:pt>
                <c:pt idx="185">
                  <c:v>5.2222518676627541</c:v>
                </c:pt>
                <c:pt idx="186">
                  <c:v>5.2504802561366066</c:v>
                </c:pt>
                <c:pt idx="187">
                  <c:v>5.2787086446104592</c:v>
                </c:pt>
                <c:pt idx="188">
                  <c:v>5.3069370330843118</c:v>
                </c:pt>
                <c:pt idx="189">
                  <c:v>5.3351654215581643</c:v>
                </c:pt>
                <c:pt idx="190">
                  <c:v>5.3633938100320178</c:v>
                </c:pt>
                <c:pt idx="191">
                  <c:v>5.3916221985058703</c:v>
                </c:pt>
                <c:pt idx="192">
                  <c:v>5.4198505869797229</c:v>
                </c:pt>
                <c:pt idx="193">
                  <c:v>5.4480789754535754</c:v>
                </c:pt>
                <c:pt idx="194">
                  <c:v>5.476307363927428</c:v>
                </c:pt>
                <c:pt idx="195">
                  <c:v>5.5045357524012806</c:v>
                </c:pt>
                <c:pt idx="196">
                  <c:v>5.532764140875134</c:v>
                </c:pt>
                <c:pt idx="197">
                  <c:v>5.5609925293489866</c:v>
                </c:pt>
                <c:pt idx="198">
                  <c:v>5.5892209178228391</c:v>
                </c:pt>
                <c:pt idx="199">
                  <c:v>5.6174493062966917</c:v>
                </c:pt>
                <c:pt idx="200">
                  <c:v>5.6456776947705443</c:v>
                </c:pt>
                <c:pt idx="201">
                  <c:v>5.6739060832443977</c:v>
                </c:pt>
                <c:pt idx="202">
                  <c:v>5.7021344717182503</c:v>
                </c:pt>
                <c:pt idx="203">
                  <c:v>5.7303628601921028</c:v>
                </c:pt>
                <c:pt idx="204">
                  <c:v>5.7585912486659554</c:v>
                </c:pt>
                <c:pt idx="205">
                  <c:v>5.786819637139808</c:v>
                </c:pt>
                <c:pt idx="206">
                  <c:v>5.8150480256136605</c:v>
                </c:pt>
                <c:pt idx="207">
                  <c:v>5.843276414087514</c:v>
                </c:pt>
                <c:pt idx="208">
                  <c:v>5.8715048025613665</c:v>
                </c:pt>
                <c:pt idx="209">
                  <c:v>5.8997331910352191</c:v>
                </c:pt>
                <c:pt idx="210">
                  <c:v>5.9279615795090717</c:v>
                </c:pt>
                <c:pt idx="211">
                  <c:v>5.9561899679829242</c:v>
                </c:pt>
                <c:pt idx="212">
                  <c:v>5.9844183564567777</c:v>
                </c:pt>
                <c:pt idx="213">
                  <c:v>6.0126467449306302</c:v>
                </c:pt>
                <c:pt idx="214">
                  <c:v>6.0408751334044828</c:v>
                </c:pt>
                <c:pt idx="215">
                  <c:v>6.0691035218783353</c:v>
                </c:pt>
                <c:pt idx="216">
                  <c:v>6.0973319103521879</c:v>
                </c:pt>
                <c:pt idx="217">
                  <c:v>6.1255602988260405</c:v>
                </c:pt>
                <c:pt idx="218">
                  <c:v>6.1537886872998939</c:v>
                </c:pt>
                <c:pt idx="219">
                  <c:v>6.1820170757737465</c:v>
                </c:pt>
                <c:pt idx="220">
                  <c:v>6.210245464247599</c:v>
                </c:pt>
                <c:pt idx="221">
                  <c:v>6.2384738527214516</c:v>
                </c:pt>
                <c:pt idx="222">
                  <c:v>6.2667022411953042</c:v>
                </c:pt>
                <c:pt idx="223">
                  <c:v>6.2949306296691576</c:v>
                </c:pt>
                <c:pt idx="224">
                  <c:v>6.3231590181430102</c:v>
                </c:pt>
                <c:pt idx="225">
                  <c:v>6.3513874066168627</c:v>
                </c:pt>
                <c:pt idx="226">
                  <c:v>6.3796157950907153</c:v>
                </c:pt>
                <c:pt idx="227">
                  <c:v>6.4078441835645679</c:v>
                </c:pt>
                <c:pt idx="228">
                  <c:v>6.4360725720384204</c:v>
                </c:pt>
                <c:pt idx="229">
                  <c:v>6.4643009605122739</c:v>
                </c:pt>
                <c:pt idx="230">
                  <c:v>6.4925293489861264</c:v>
                </c:pt>
                <c:pt idx="231">
                  <c:v>6.520757737459979</c:v>
                </c:pt>
                <c:pt idx="232">
                  <c:v>6.5489861259338316</c:v>
                </c:pt>
                <c:pt idx="233">
                  <c:v>6.5772145144076841</c:v>
                </c:pt>
                <c:pt idx="234">
                  <c:v>6.6054429028815376</c:v>
                </c:pt>
                <c:pt idx="235">
                  <c:v>6.6336712913553901</c:v>
                </c:pt>
                <c:pt idx="236">
                  <c:v>6.6618996798292427</c:v>
                </c:pt>
                <c:pt idx="237">
                  <c:v>6.6901280683030953</c:v>
                </c:pt>
                <c:pt idx="238">
                  <c:v>6.7183564567769478</c:v>
                </c:pt>
                <c:pt idx="239">
                  <c:v>6.7465848452508004</c:v>
                </c:pt>
                <c:pt idx="240">
                  <c:v>6.7748132337246538</c:v>
                </c:pt>
                <c:pt idx="241">
                  <c:v>6.8030416221985064</c:v>
                </c:pt>
                <c:pt idx="242">
                  <c:v>6.8312700106723589</c:v>
                </c:pt>
                <c:pt idx="243">
                  <c:v>6.8594983991462115</c:v>
                </c:pt>
                <c:pt idx="244">
                  <c:v>6.8877267876200641</c:v>
                </c:pt>
                <c:pt idx="245">
                  <c:v>6.9159551760939175</c:v>
                </c:pt>
                <c:pt idx="246">
                  <c:v>6.9441835645677701</c:v>
                </c:pt>
                <c:pt idx="247">
                  <c:v>6.9724119530416226</c:v>
                </c:pt>
                <c:pt idx="248">
                  <c:v>7.0006403415154752</c:v>
                </c:pt>
                <c:pt idx="249">
                  <c:v>7.0288687299893278</c:v>
                </c:pt>
                <c:pt idx="250">
                  <c:v>7.0570971184631803</c:v>
                </c:pt>
                <c:pt idx="251">
                  <c:v>7.0853255069370338</c:v>
                </c:pt>
                <c:pt idx="252">
                  <c:v>7.1135538954108863</c:v>
                </c:pt>
                <c:pt idx="253">
                  <c:v>7.1417822838847389</c:v>
                </c:pt>
                <c:pt idx="254">
                  <c:v>7.1700106723585915</c:v>
                </c:pt>
                <c:pt idx="255">
                  <c:v>7.198239060832444</c:v>
                </c:pt>
                <c:pt idx="256">
                  <c:v>7.2264674493062975</c:v>
                </c:pt>
                <c:pt idx="257">
                  <c:v>7.25469583778015</c:v>
                </c:pt>
                <c:pt idx="258">
                  <c:v>7.2829242262540026</c:v>
                </c:pt>
                <c:pt idx="259">
                  <c:v>7.3111526147278552</c:v>
                </c:pt>
                <c:pt idx="260">
                  <c:v>7.3393810032017077</c:v>
                </c:pt>
                <c:pt idx="261">
                  <c:v>7.3676093916755603</c:v>
                </c:pt>
                <c:pt idx="262">
                  <c:v>7.3958377801494137</c:v>
                </c:pt>
                <c:pt idx="263">
                  <c:v>7.4240661686232663</c:v>
                </c:pt>
                <c:pt idx="264">
                  <c:v>7.4522945570971189</c:v>
                </c:pt>
                <c:pt idx="265">
                  <c:v>7.4805229455709714</c:v>
                </c:pt>
                <c:pt idx="266">
                  <c:v>7.508751334044824</c:v>
                </c:pt>
                <c:pt idx="267">
                  <c:v>7.5369797225186774</c:v>
                </c:pt>
                <c:pt idx="268">
                  <c:v>7.56520811099253</c:v>
                </c:pt>
                <c:pt idx="269">
                  <c:v>7.5934364994663825</c:v>
                </c:pt>
                <c:pt idx="270">
                  <c:v>7.6216648879402351</c:v>
                </c:pt>
                <c:pt idx="271">
                  <c:v>7.6498932764140877</c:v>
                </c:pt>
                <c:pt idx="272">
                  <c:v>7.6781216648879402</c:v>
                </c:pt>
                <c:pt idx="273">
                  <c:v>7.7063500533617937</c:v>
                </c:pt>
                <c:pt idx="274">
                  <c:v>7.7345784418356462</c:v>
                </c:pt>
                <c:pt idx="275">
                  <c:v>7.7628068303094988</c:v>
                </c:pt>
                <c:pt idx="276">
                  <c:v>7.7910352187833514</c:v>
                </c:pt>
                <c:pt idx="277">
                  <c:v>7.8192636072572039</c:v>
                </c:pt>
                <c:pt idx="278">
                  <c:v>7.8474919957310574</c:v>
                </c:pt>
                <c:pt idx="279">
                  <c:v>7.8757203842049099</c:v>
                </c:pt>
                <c:pt idx="280">
                  <c:v>7.9039487726787625</c:v>
                </c:pt>
                <c:pt idx="281">
                  <c:v>7.9321771611526151</c:v>
                </c:pt>
                <c:pt idx="282">
                  <c:v>7.9604055496264676</c:v>
                </c:pt>
                <c:pt idx="283">
                  <c:v>7.9886339381003202</c:v>
                </c:pt>
                <c:pt idx="284">
                  <c:v>8.0168623265741736</c:v>
                </c:pt>
                <c:pt idx="285">
                  <c:v>8.0450907150480262</c:v>
                </c:pt>
                <c:pt idx="286">
                  <c:v>8.0733191035218788</c:v>
                </c:pt>
                <c:pt idx="287">
                  <c:v>8.1015474919957313</c:v>
                </c:pt>
                <c:pt idx="288">
                  <c:v>8.1297758804695839</c:v>
                </c:pt>
                <c:pt idx="289">
                  <c:v>8.1580042689434364</c:v>
                </c:pt>
                <c:pt idx="290">
                  <c:v>8.186232657417289</c:v>
                </c:pt>
                <c:pt idx="291">
                  <c:v>8.2144610458911416</c:v>
                </c:pt>
                <c:pt idx="292">
                  <c:v>8.2426894343649959</c:v>
                </c:pt>
                <c:pt idx="293">
                  <c:v>8.2709178228388485</c:v>
                </c:pt>
                <c:pt idx="294">
                  <c:v>8.299146211312701</c:v>
                </c:pt>
                <c:pt idx="295">
                  <c:v>8.3273745997865536</c:v>
                </c:pt>
                <c:pt idx="296">
                  <c:v>8.3556029882604061</c:v>
                </c:pt>
                <c:pt idx="297">
                  <c:v>8.3838313767342587</c:v>
                </c:pt>
                <c:pt idx="298">
                  <c:v>8.4120597652081113</c:v>
                </c:pt>
                <c:pt idx="299">
                  <c:v>8.4402881536819638</c:v>
                </c:pt>
                <c:pt idx="300">
                  <c:v>8.4685165421558164</c:v>
                </c:pt>
                <c:pt idx="301">
                  <c:v>8.496744930629669</c:v>
                </c:pt>
                <c:pt idx="302">
                  <c:v>8.5249733191035215</c:v>
                </c:pt>
                <c:pt idx="303">
                  <c:v>8.5532017075773759</c:v>
                </c:pt>
                <c:pt idx="304">
                  <c:v>8.5814300960512284</c:v>
                </c:pt>
                <c:pt idx="305">
                  <c:v>8.609658484525081</c:v>
                </c:pt>
                <c:pt idx="306">
                  <c:v>8.6378868729989335</c:v>
                </c:pt>
                <c:pt idx="307">
                  <c:v>8.6661152614727861</c:v>
                </c:pt>
                <c:pt idx="308">
                  <c:v>8.6943436499466387</c:v>
                </c:pt>
                <c:pt idx="309">
                  <c:v>8.7225720384204912</c:v>
                </c:pt>
                <c:pt idx="310">
                  <c:v>8.7508004268943438</c:v>
                </c:pt>
                <c:pt idx="311">
                  <c:v>8.7790288153681963</c:v>
                </c:pt>
                <c:pt idx="312">
                  <c:v>8.8072572038420489</c:v>
                </c:pt>
                <c:pt idx="313">
                  <c:v>8.8354855923159015</c:v>
                </c:pt>
                <c:pt idx="314">
                  <c:v>8.8637139807897558</c:v>
                </c:pt>
                <c:pt idx="315">
                  <c:v>8.8919423692636084</c:v>
                </c:pt>
                <c:pt idx="316">
                  <c:v>8.9201707577374609</c:v>
                </c:pt>
                <c:pt idx="317">
                  <c:v>8.9483991462113135</c:v>
                </c:pt>
                <c:pt idx="318">
                  <c:v>8.9766275346851661</c:v>
                </c:pt>
                <c:pt idx="319">
                  <c:v>9.0048559231590186</c:v>
                </c:pt>
                <c:pt idx="320">
                  <c:v>9.0330843116328712</c:v>
                </c:pt>
                <c:pt idx="321">
                  <c:v>9.0613127001067237</c:v>
                </c:pt>
                <c:pt idx="322">
                  <c:v>9.0895410885805763</c:v>
                </c:pt>
                <c:pt idx="323">
                  <c:v>9.1177694770544289</c:v>
                </c:pt>
                <c:pt idx="324">
                  <c:v>9.1459978655282814</c:v>
                </c:pt>
                <c:pt idx="325">
                  <c:v>9.1742262540021358</c:v>
                </c:pt>
                <c:pt idx="326">
                  <c:v>9.2024546424759883</c:v>
                </c:pt>
                <c:pt idx="327">
                  <c:v>9.2306830309498409</c:v>
                </c:pt>
                <c:pt idx="328">
                  <c:v>9.2589114194236934</c:v>
                </c:pt>
                <c:pt idx="329">
                  <c:v>9.287139807897546</c:v>
                </c:pt>
                <c:pt idx="330">
                  <c:v>9.3153681963713986</c:v>
                </c:pt>
                <c:pt idx="331">
                  <c:v>9.3435965848452511</c:v>
                </c:pt>
                <c:pt idx="332">
                  <c:v>9.3718249733191037</c:v>
                </c:pt>
                <c:pt idx="333">
                  <c:v>9.4000533617929563</c:v>
                </c:pt>
                <c:pt idx="334">
                  <c:v>9.4282817502668088</c:v>
                </c:pt>
                <c:pt idx="335">
                  <c:v>9.4565101387406614</c:v>
                </c:pt>
                <c:pt idx="336">
                  <c:v>9.4847385272145157</c:v>
                </c:pt>
                <c:pt idx="337">
                  <c:v>9.5129669156883683</c:v>
                </c:pt>
                <c:pt idx="338">
                  <c:v>9.5411953041622208</c:v>
                </c:pt>
                <c:pt idx="339">
                  <c:v>9.5694236926360734</c:v>
                </c:pt>
                <c:pt idx="340">
                  <c:v>9.597652081109926</c:v>
                </c:pt>
                <c:pt idx="341">
                  <c:v>9.6258804695837785</c:v>
                </c:pt>
                <c:pt idx="342">
                  <c:v>9.6541088580576311</c:v>
                </c:pt>
                <c:pt idx="343">
                  <c:v>9.6823372465314836</c:v>
                </c:pt>
                <c:pt idx="344">
                  <c:v>9.7105656350053362</c:v>
                </c:pt>
                <c:pt idx="345">
                  <c:v>9.7387940234791888</c:v>
                </c:pt>
                <c:pt idx="346">
                  <c:v>9.7670224119530413</c:v>
                </c:pt>
                <c:pt idx="347">
                  <c:v>9.7952508004268957</c:v>
                </c:pt>
                <c:pt idx="348">
                  <c:v>9.8234791889007482</c:v>
                </c:pt>
                <c:pt idx="349">
                  <c:v>9.8517075773746008</c:v>
                </c:pt>
                <c:pt idx="350">
                  <c:v>9.8799359658484533</c:v>
                </c:pt>
                <c:pt idx="351">
                  <c:v>9.9081643543223059</c:v>
                </c:pt>
                <c:pt idx="352">
                  <c:v>9.9363927427961585</c:v>
                </c:pt>
                <c:pt idx="353">
                  <c:v>9.964621131270011</c:v>
                </c:pt>
                <c:pt idx="354">
                  <c:v>9.9928495197438636</c:v>
                </c:pt>
                <c:pt idx="355">
                  <c:v>10.021077908217716</c:v>
                </c:pt>
                <c:pt idx="356">
                  <c:v>10.049306296691569</c:v>
                </c:pt>
                <c:pt idx="357">
                  <c:v>10.077534685165421</c:v>
                </c:pt>
                <c:pt idx="358">
                  <c:v>10.105763073639276</c:v>
                </c:pt>
                <c:pt idx="359">
                  <c:v>10.133991462113128</c:v>
                </c:pt>
                <c:pt idx="360">
                  <c:v>10.162219850586981</c:v>
                </c:pt>
                <c:pt idx="361">
                  <c:v>10.190448239060833</c:v>
                </c:pt>
                <c:pt idx="362">
                  <c:v>10.218676627534686</c:v>
                </c:pt>
                <c:pt idx="363">
                  <c:v>10.246905016008538</c:v>
                </c:pt>
                <c:pt idx="364">
                  <c:v>10.275133404482391</c:v>
                </c:pt>
                <c:pt idx="365">
                  <c:v>10.303361792956244</c:v>
                </c:pt>
                <c:pt idx="366">
                  <c:v>10.331590181430096</c:v>
                </c:pt>
                <c:pt idx="367">
                  <c:v>10.359818569903949</c:v>
                </c:pt>
                <c:pt idx="368">
                  <c:v>10.388046958377801</c:v>
                </c:pt>
                <c:pt idx="369">
                  <c:v>10.416275346851656</c:v>
                </c:pt>
                <c:pt idx="370">
                  <c:v>10.444503735325508</c:v>
                </c:pt>
                <c:pt idx="371">
                  <c:v>10.472732123799361</c:v>
                </c:pt>
                <c:pt idx="372">
                  <c:v>10.500960512273213</c:v>
                </c:pt>
                <c:pt idx="373">
                  <c:v>10.529188900747066</c:v>
                </c:pt>
                <c:pt idx="374">
                  <c:v>10.557417289220918</c:v>
                </c:pt>
                <c:pt idx="375">
                  <c:v>10.585645677694771</c:v>
                </c:pt>
                <c:pt idx="376">
                  <c:v>10.613874066168624</c:v>
                </c:pt>
                <c:pt idx="377">
                  <c:v>10.642102454642476</c:v>
                </c:pt>
                <c:pt idx="378">
                  <c:v>10.670330843116329</c:v>
                </c:pt>
                <c:pt idx="379">
                  <c:v>10.698559231590181</c:v>
                </c:pt>
                <c:pt idx="380">
                  <c:v>10.726787620064036</c:v>
                </c:pt>
                <c:pt idx="381">
                  <c:v>10.755016008537888</c:v>
                </c:pt>
                <c:pt idx="382">
                  <c:v>10.783244397011741</c:v>
                </c:pt>
                <c:pt idx="383">
                  <c:v>10.811472785485593</c:v>
                </c:pt>
                <c:pt idx="384">
                  <c:v>10.839701173959446</c:v>
                </c:pt>
                <c:pt idx="385">
                  <c:v>10.867929562433298</c:v>
                </c:pt>
                <c:pt idx="386">
                  <c:v>10.896157950907151</c:v>
                </c:pt>
                <c:pt idx="387">
                  <c:v>10.924386339381003</c:v>
                </c:pt>
                <c:pt idx="388">
                  <c:v>10.952614727854856</c:v>
                </c:pt>
                <c:pt idx="389">
                  <c:v>10.980843116328709</c:v>
                </c:pt>
                <c:pt idx="390">
                  <c:v>11.009071504802561</c:v>
                </c:pt>
                <c:pt idx="391">
                  <c:v>11.037299893276415</c:v>
                </c:pt>
                <c:pt idx="392">
                  <c:v>11.065528281750268</c:v>
                </c:pt>
                <c:pt idx="393">
                  <c:v>11.093756670224121</c:v>
                </c:pt>
                <c:pt idx="394">
                  <c:v>11.121985058697973</c:v>
                </c:pt>
                <c:pt idx="395">
                  <c:v>11.150213447171826</c:v>
                </c:pt>
                <c:pt idx="396">
                  <c:v>11.178441835645678</c:v>
                </c:pt>
                <c:pt idx="397">
                  <c:v>11.206670224119531</c:v>
                </c:pt>
                <c:pt idx="398">
                  <c:v>11.234898612593383</c:v>
                </c:pt>
                <c:pt idx="399">
                  <c:v>11.263127001067236</c:v>
                </c:pt>
                <c:pt idx="400">
                  <c:v>11.291355389541089</c:v>
                </c:pt>
                <c:pt idx="401">
                  <c:v>11.319583778014941</c:v>
                </c:pt>
                <c:pt idx="402">
                  <c:v>11.347812166488795</c:v>
                </c:pt>
                <c:pt idx="403">
                  <c:v>11.376040554962648</c:v>
                </c:pt>
                <c:pt idx="404">
                  <c:v>11.404268943436501</c:v>
                </c:pt>
                <c:pt idx="405">
                  <c:v>11.432497331910353</c:v>
                </c:pt>
                <c:pt idx="406">
                  <c:v>11.460725720384206</c:v>
                </c:pt>
                <c:pt idx="407">
                  <c:v>11.488954108858058</c:v>
                </c:pt>
                <c:pt idx="408">
                  <c:v>11.517182497331911</c:v>
                </c:pt>
                <c:pt idx="409">
                  <c:v>11.545410885805763</c:v>
                </c:pt>
                <c:pt idx="410">
                  <c:v>11.573639274279616</c:v>
                </c:pt>
                <c:pt idx="411">
                  <c:v>11.601867662753468</c:v>
                </c:pt>
                <c:pt idx="412">
                  <c:v>11.630096051227321</c:v>
                </c:pt>
                <c:pt idx="413">
                  <c:v>11.658324439701175</c:v>
                </c:pt>
                <c:pt idx="414">
                  <c:v>11.686552828175028</c:v>
                </c:pt>
                <c:pt idx="415">
                  <c:v>11.714781216648881</c:v>
                </c:pt>
                <c:pt idx="416">
                  <c:v>11.743009605122733</c:v>
                </c:pt>
                <c:pt idx="417">
                  <c:v>11.771237993596586</c:v>
                </c:pt>
                <c:pt idx="418">
                  <c:v>11.799466382070438</c:v>
                </c:pt>
                <c:pt idx="419">
                  <c:v>11.827694770544291</c:v>
                </c:pt>
                <c:pt idx="420">
                  <c:v>11.855923159018143</c:v>
                </c:pt>
                <c:pt idx="421">
                  <c:v>11.884151547491996</c:v>
                </c:pt>
                <c:pt idx="422">
                  <c:v>11.912379935965848</c:v>
                </c:pt>
                <c:pt idx="423">
                  <c:v>11.940608324439701</c:v>
                </c:pt>
                <c:pt idx="424">
                  <c:v>11.968836712913555</c:v>
                </c:pt>
                <c:pt idx="425">
                  <c:v>11.997065101387408</c:v>
                </c:pt>
                <c:pt idx="426">
                  <c:v>12.02529348986126</c:v>
                </c:pt>
                <c:pt idx="427">
                  <c:v>12.053521878335113</c:v>
                </c:pt>
                <c:pt idx="428">
                  <c:v>12.081750266808966</c:v>
                </c:pt>
                <c:pt idx="429">
                  <c:v>12.109978655282818</c:v>
                </c:pt>
                <c:pt idx="430">
                  <c:v>12.138207043756671</c:v>
                </c:pt>
                <c:pt idx="431">
                  <c:v>12.166435432230523</c:v>
                </c:pt>
                <c:pt idx="432">
                  <c:v>12.194663820704376</c:v>
                </c:pt>
                <c:pt idx="433">
                  <c:v>12.222892209178228</c:v>
                </c:pt>
                <c:pt idx="434">
                  <c:v>12.251120597652081</c:v>
                </c:pt>
                <c:pt idx="435">
                  <c:v>12.279348986125935</c:v>
                </c:pt>
                <c:pt idx="436">
                  <c:v>12.307577374599788</c:v>
                </c:pt>
                <c:pt idx="437">
                  <c:v>12.33580576307364</c:v>
                </c:pt>
                <c:pt idx="438">
                  <c:v>12.364034151547493</c:v>
                </c:pt>
                <c:pt idx="439">
                  <c:v>12.392262540021346</c:v>
                </c:pt>
                <c:pt idx="440">
                  <c:v>12.420490928495198</c:v>
                </c:pt>
                <c:pt idx="441">
                  <c:v>12.448719316969051</c:v>
                </c:pt>
                <c:pt idx="442">
                  <c:v>12.476947705442903</c:v>
                </c:pt>
                <c:pt idx="443">
                  <c:v>12.505176093916756</c:v>
                </c:pt>
                <c:pt idx="444">
                  <c:v>12.533404482390608</c:v>
                </c:pt>
                <c:pt idx="445">
                  <c:v>12.561632870864461</c:v>
                </c:pt>
                <c:pt idx="446">
                  <c:v>12.589861259338315</c:v>
                </c:pt>
                <c:pt idx="447">
                  <c:v>12.618089647812168</c:v>
                </c:pt>
                <c:pt idx="448">
                  <c:v>12.64631803628602</c:v>
                </c:pt>
                <c:pt idx="449">
                  <c:v>12.674546424759873</c:v>
                </c:pt>
                <c:pt idx="450">
                  <c:v>12.702774813233725</c:v>
                </c:pt>
                <c:pt idx="451">
                  <c:v>12.731003201707578</c:v>
                </c:pt>
                <c:pt idx="452">
                  <c:v>12.759231590181431</c:v>
                </c:pt>
                <c:pt idx="453">
                  <c:v>12.787459978655283</c:v>
                </c:pt>
                <c:pt idx="454">
                  <c:v>12.815688367129136</c:v>
                </c:pt>
                <c:pt idx="455">
                  <c:v>12.843916755602988</c:v>
                </c:pt>
                <c:pt idx="456">
                  <c:v>12.872145144076841</c:v>
                </c:pt>
                <c:pt idx="457">
                  <c:v>12.900373532550695</c:v>
                </c:pt>
                <c:pt idx="458">
                  <c:v>12.928601921024548</c:v>
                </c:pt>
                <c:pt idx="459">
                  <c:v>12.9568303094984</c:v>
                </c:pt>
                <c:pt idx="460">
                  <c:v>12.985058697972253</c:v>
                </c:pt>
                <c:pt idx="461">
                  <c:v>13.013287086446105</c:v>
                </c:pt>
                <c:pt idx="462">
                  <c:v>13.041515474919958</c:v>
                </c:pt>
                <c:pt idx="463">
                  <c:v>13.069743863393811</c:v>
                </c:pt>
                <c:pt idx="464">
                  <c:v>13.097972251867663</c:v>
                </c:pt>
                <c:pt idx="465">
                  <c:v>13.126200640341516</c:v>
                </c:pt>
                <c:pt idx="466">
                  <c:v>13.154429028815368</c:v>
                </c:pt>
                <c:pt idx="467">
                  <c:v>13.182657417289221</c:v>
                </c:pt>
                <c:pt idx="468">
                  <c:v>13.210885805763075</c:v>
                </c:pt>
                <c:pt idx="469">
                  <c:v>13.239114194236928</c:v>
                </c:pt>
                <c:pt idx="470">
                  <c:v>13.26734258271078</c:v>
                </c:pt>
                <c:pt idx="471">
                  <c:v>13.295570971184633</c:v>
                </c:pt>
                <c:pt idx="472">
                  <c:v>13.323799359658485</c:v>
                </c:pt>
                <c:pt idx="473">
                  <c:v>13.352027748132338</c:v>
                </c:pt>
                <c:pt idx="474">
                  <c:v>13.380256136606191</c:v>
                </c:pt>
                <c:pt idx="475">
                  <c:v>13.408484525080043</c:v>
                </c:pt>
                <c:pt idx="476">
                  <c:v>13.436712913553896</c:v>
                </c:pt>
                <c:pt idx="477">
                  <c:v>13.464941302027748</c:v>
                </c:pt>
                <c:pt idx="478">
                  <c:v>13.493169690501601</c:v>
                </c:pt>
                <c:pt idx="479">
                  <c:v>13.521398078975455</c:v>
                </c:pt>
                <c:pt idx="480">
                  <c:v>13.549626467449308</c:v>
                </c:pt>
                <c:pt idx="481">
                  <c:v>13.57785485592316</c:v>
                </c:pt>
                <c:pt idx="482">
                  <c:v>13.606083244397013</c:v>
                </c:pt>
                <c:pt idx="483">
                  <c:v>13.634311632870865</c:v>
                </c:pt>
                <c:pt idx="484">
                  <c:v>13.662540021344718</c:v>
                </c:pt>
                <c:pt idx="485">
                  <c:v>13.69076840981857</c:v>
                </c:pt>
                <c:pt idx="486">
                  <c:v>13.718996798292423</c:v>
                </c:pt>
                <c:pt idx="487">
                  <c:v>13.747225186766276</c:v>
                </c:pt>
                <c:pt idx="488">
                  <c:v>13.775453575240128</c:v>
                </c:pt>
                <c:pt idx="489">
                  <c:v>13.803681963713981</c:v>
                </c:pt>
                <c:pt idx="490">
                  <c:v>13.831910352187835</c:v>
                </c:pt>
                <c:pt idx="491">
                  <c:v>13.860138740661688</c:v>
                </c:pt>
                <c:pt idx="492">
                  <c:v>13.88836712913554</c:v>
                </c:pt>
                <c:pt idx="493">
                  <c:v>13.916595517609393</c:v>
                </c:pt>
                <c:pt idx="494">
                  <c:v>13.944823906083245</c:v>
                </c:pt>
                <c:pt idx="495">
                  <c:v>13.973052294557098</c:v>
                </c:pt>
                <c:pt idx="496">
                  <c:v>14.00128068303095</c:v>
                </c:pt>
                <c:pt idx="497">
                  <c:v>14.029509071504803</c:v>
                </c:pt>
                <c:pt idx="498">
                  <c:v>14.057737459978656</c:v>
                </c:pt>
                <c:pt idx="499">
                  <c:v>14.085965848452508</c:v>
                </c:pt>
                <c:pt idx="500">
                  <c:v>14.114194236926361</c:v>
                </c:pt>
                <c:pt idx="501">
                  <c:v>14.142422625400215</c:v>
                </c:pt>
                <c:pt idx="502">
                  <c:v>14.170651013874068</c:v>
                </c:pt>
                <c:pt idx="503">
                  <c:v>14.19887940234792</c:v>
                </c:pt>
                <c:pt idx="504">
                  <c:v>14.227107790821773</c:v>
                </c:pt>
                <c:pt idx="505">
                  <c:v>14.255336179295625</c:v>
                </c:pt>
                <c:pt idx="506">
                  <c:v>14.283564567769478</c:v>
                </c:pt>
                <c:pt idx="507">
                  <c:v>14.31179295624333</c:v>
                </c:pt>
                <c:pt idx="508">
                  <c:v>14.340021344717183</c:v>
                </c:pt>
                <c:pt idx="509">
                  <c:v>14.368249733191035</c:v>
                </c:pt>
                <c:pt idx="510">
                  <c:v>14.396478121664888</c:v>
                </c:pt>
                <c:pt idx="511">
                  <c:v>14.424706510138741</c:v>
                </c:pt>
                <c:pt idx="512">
                  <c:v>14.452934898612595</c:v>
                </c:pt>
                <c:pt idx="513">
                  <c:v>14.481163287086448</c:v>
                </c:pt>
                <c:pt idx="514">
                  <c:v>14.5093916755603</c:v>
                </c:pt>
                <c:pt idx="515">
                  <c:v>14.537620064034153</c:v>
                </c:pt>
                <c:pt idx="516">
                  <c:v>14.565848452508005</c:v>
                </c:pt>
                <c:pt idx="517">
                  <c:v>14.594076840981858</c:v>
                </c:pt>
                <c:pt idx="518">
                  <c:v>14.62230522945571</c:v>
                </c:pt>
                <c:pt idx="519">
                  <c:v>14.650533617929563</c:v>
                </c:pt>
                <c:pt idx="520">
                  <c:v>14.678762006403415</c:v>
                </c:pt>
                <c:pt idx="521">
                  <c:v>14.706990394877268</c:v>
                </c:pt>
                <c:pt idx="522">
                  <c:v>14.735218783351121</c:v>
                </c:pt>
                <c:pt idx="523">
                  <c:v>14.763447171824975</c:v>
                </c:pt>
                <c:pt idx="524">
                  <c:v>14.791675560298827</c:v>
                </c:pt>
                <c:pt idx="525">
                  <c:v>14.81990394877268</c:v>
                </c:pt>
                <c:pt idx="526">
                  <c:v>14.848132337246533</c:v>
                </c:pt>
                <c:pt idx="527">
                  <c:v>14.876360725720385</c:v>
                </c:pt>
                <c:pt idx="528">
                  <c:v>14.904589114194238</c:v>
                </c:pt>
                <c:pt idx="529">
                  <c:v>14.93281750266809</c:v>
                </c:pt>
                <c:pt idx="530">
                  <c:v>14.961045891141943</c:v>
                </c:pt>
                <c:pt idx="531">
                  <c:v>14.989274279615795</c:v>
                </c:pt>
                <c:pt idx="532">
                  <c:v>15.017502668089648</c:v>
                </c:pt>
                <c:pt idx="533">
                  <c:v>15.045731056563501</c:v>
                </c:pt>
                <c:pt idx="534">
                  <c:v>15.073959445037355</c:v>
                </c:pt>
                <c:pt idx="535">
                  <c:v>15.102187833511207</c:v>
                </c:pt>
                <c:pt idx="536">
                  <c:v>15.13041622198506</c:v>
                </c:pt>
                <c:pt idx="537">
                  <c:v>15.158644610458913</c:v>
                </c:pt>
                <c:pt idx="538">
                  <c:v>15.186872998932765</c:v>
                </c:pt>
                <c:pt idx="539">
                  <c:v>15.215101387406618</c:v>
                </c:pt>
                <c:pt idx="540">
                  <c:v>15.24332977588047</c:v>
                </c:pt>
                <c:pt idx="541">
                  <c:v>15.271558164354323</c:v>
                </c:pt>
                <c:pt idx="542">
                  <c:v>15.299786552828175</c:v>
                </c:pt>
                <c:pt idx="543">
                  <c:v>15.328014941302028</c:v>
                </c:pt>
                <c:pt idx="544">
                  <c:v>15.35624332977588</c:v>
                </c:pt>
                <c:pt idx="545">
                  <c:v>15.384471718249735</c:v>
                </c:pt>
                <c:pt idx="546">
                  <c:v>15.412700106723587</c:v>
                </c:pt>
                <c:pt idx="547">
                  <c:v>15.44092849519744</c:v>
                </c:pt>
                <c:pt idx="548">
                  <c:v>15.469156883671292</c:v>
                </c:pt>
                <c:pt idx="549">
                  <c:v>15.497385272145145</c:v>
                </c:pt>
                <c:pt idx="550">
                  <c:v>15.525613660618998</c:v>
                </c:pt>
                <c:pt idx="551">
                  <c:v>15.55384204909285</c:v>
                </c:pt>
                <c:pt idx="552">
                  <c:v>15.582070437566703</c:v>
                </c:pt>
                <c:pt idx="553">
                  <c:v>15.610298826040555</c:v>
                </c:pt>
                <c:pt idx="554">
                  <c:v>15.638527214514408</c:v>
                </c:pt>
                <c:pt idx="555">
                  <c:v>15.66675560298826</c:v>
                </c:pt>
                <c:pt idx="556">
                  <c:v>15.694983991462115</c:v>
                </c:pt>
                <c:pt idx="557">
                  <c:v>15.723212379935967</c:v>
                </c:pt>
                <c:pt idx="558">
                  <c:v>15.75144076840982</c:v>
                </c:pt>
                <c:pt idx="559">
                  <c:v>15.779669156883672</c:v>
                </c:pt>
                <c:pt idx="560">
                  <c:v>15.807897545357525</c:v>
                </c:pt>
                <c:pt idx="561">
                  <c:v>15.836125933831378</c:v>
                </c:pt>
                <c:pt idx="562">
                  <c:v>15.86435432230523</c:v>
                </c:pt>
                <c:pt idx="563">
                  <c:v>15.892582710779083</c:v>
                </c:pt>
                <c:pt idx="564">
                  <c:v>15.920811099252935</c:v>
                </c:pt>
                <c:pt idx="565">
                  <c:v>15.949039487726788</c:v>
                </c:pt>
                <c:pt idx="566">
                  <c:v>15.97726787620064</c:v>
                </c:pt>
                <c:pt idx="567">
                  <c:v>16.005496264674495</c:v>
                </c:pt>
                <c:pt idx="568">
                  <c:v>16.033724653148347</c:v>
                </c:pt>
                <c:pt idx="569">
                  <c:v>16.0619530416222</c:v>
                </c:pt>
                <c:pt idx="570">
                  <c:v>16.090181430096052</c:v>
                </c:pt>
                <c:pt idx="571">
                  <c:v>16.118409818569905</c:v>
                </c:pt>
                <c:pt idx="572">
                  <c:v>16.146638207043758</c:v>
                </c:pt>
                <c:pt idx="573">
                  <c:v>16.17486659551761</c:v>
                </c:pt>
                <c:pt idx="574">
                  <c:v>16.203094983991463</c:v>
                </c:pt>
                <c:pt idx="575">
                  <c:v>16.231323372465315</c:v>
                </c:pt>
                <c:pt idx="576">
                  <c:v>16.259551760939168</c:v>
                </c:pt>
                <c:pt idx="577">
                  <c:v>16.28778014941302</c:v>
                </c:pt>
                <c:pt idx="578">
                  <c:v>16.316008537886873</c:v>
                </c:pt>
                <c:pt idx="579">
                  <c:v>16.344236926360725</c:v>
                </c:pt>
                <c:pt idx="580">
                  <c:v>16.372465314834578</c:v>
                </c:pt>
                <c:pt idx="581">
                  <c:v>16.400693703308431</c:v>
                </c:pt>
                <c:pt idx="582">
                  <c:v>16.428922091782283</c:v>
                </c:pt>
                <c:pt idx="583">
                  <c:v>16.457150480256139</c:v>
                </c:pt>
                <c:pt idx="584">
                  <c:v>16.485378868729992</c:v>
                </c:pt>
                <c:pt idx="585">
                  <c:v>16.513607257203844</c:v>
                </c:pt>
                <c:pt idx="586">
                  <c:v>16.541835645677697</c:v>
                </c:pt>
                <c:pt idx="587">
                  <c:v>16.570064034151549</c:v>
                </c:pt>
                <c:pt idx="588">
                  <c:v>16.598292422625402</c:v>
                </c:pt>
                <c:pt idx="589">
                  <c:v>16.626520811099255</c:v>
                </c:pt>
                <c:pt idx="590">
                  <c:v>16.654749199573107</c:v>
                </c:pt>
                <c:pt idx="591">
                  <c:v>16.68297758804696</c:v>
                </c:pt>
                <c:pt idx="592">
                  <c:v>16.711205976520812</c:v>
                </c:pt>
                <c:pt idx="593">
                  <c:v>16.739434364994665</c:v>
                </c:pt>
                <c:pt idx="594">
                  <c:v>16.767662753468517</c:v>
                </c:pt>
                <c:pt idx="595">
                  <c:v>16.79589114194237</c:v>
                </c:pt>
                <c:pt idx="596">
                  <c:v>16.824119530416223</c:v>
                </c:pt>
                <c:pt idx="597">
                  <c:v>16.852347918890075</c:v>
                </c:pt>
                <c:pt idx="598">
                  <c:v>16.880576307363928</c:v>
                </c:pt>
                <c:pt idx="599">
                  <c:v>16.90880469583778</c:v>
                </c:pt>
                <c:pt idx="600">
                  <c:v>16.937033084311633</c:v>
                </c:pt>
                <c:pt idx="601">
                  <c:v>16.965261472785485</c:v>
                </c:pt>
                <c:pt idx="602">
                  <c:v>16.993489861259338</c:v>
                </c:pt>
                <c:pt idx="603">
                  <c:v>17.02171824973319</c:v>
                </c:pt>
                <c:pt idx="604">
                  <c:v>17.049946638207043</c:v>
                </c:pt>
                <c:pt idx="605">
                  <c:v>17.078175026680899</c:v>
                </c:pt>
                <c:pt idx="606">
                  <c:v>17.106403415154752</c:v>
                </c:pt>
                <c:pt idx="607">
                  <c:v>17.134631803628604</c:v>
                </c:pt>
                <c:pt idx="608">
                  <c:v>17.162860192102457</c:v>
                </c:pt>
                <c:pt idx="609">
                  <c:v>17.191088580576309</c:v>
                </c:pt>
                <c:pt idx="610">
                  <c:v>17.219316969050162</c:v>
                </c:pt>
                <c:pt idx="611">
                  <c:v>17.247545357524015</c:v>
                </c:pt>
                <c:pt idx="612">
                  <c:v>17.275773745997867</c:v>
                </c:pt>
                <c:pt idx="613">
                  <c:v>17.30400213447172</c:v>
                </c:pt>
                <c:pt idx="614">
                  <c:v>17.332230522945572</c:v>
                </c:pt>
                <c:pt idx="615">
                  <c:v>17.360458911419425</c:v>
                </c:pt>
                <c:pt idx="616">
                  <c:v>17.388687299893277</c:v>
                </c:pt>
                <c:pt idx="617">
                  <c:v>17.41691568836713</c:v>
                </c:pt>
                <c:pt idx="618">
                  <c:v>17.445144076840982</c:v>
                </c:pt>
                <c:pt idx="619">
                  <c:v>17.473372465314835</c:v>
                </c:pt>
                <c:pt idx="620">
                  <c:v>17.501600853788688</c:v>
                </c:pt>
                <c:pt idx="621">
                  <c:v>17.52982924226254</c:v>
                </c:pt>
                <c:pt idx="622">
                  <c:v>17.558057630736393</c:v>
                </c:pt>
                <c:pt idx="623">
                  <c:v>17.586286019210245</c:v>
                </c:pt>
                <c:pt idx="624">
                  <c:v>17.614514407684098</c:v>
                </c:pt>
                <c:pt idx="625">
                  <c:v>17.64274279615795</c:v>
                </c:pt>
                <c:pt idx="626">
                  <c:v>17.670971184631803</c:v>
                </c:pt>
                <c:pt idx="627">
                  <c:v>17.699199573105659</c:v>
                </c:pt>
                <c:pt idx="628">
                  <c:v>17.727427961579512</c:v>
                </c:pt>
                <c:pt idx="629">
                  <c:v>17.755656350053364</c:v>
                </c:pt>
                <c:pt idx="630">
                  <c:v>17.783884738527217</c:v>
                </c:pt>
                <c:pt idx="631">
                  <c:v>17.812113127001069</c:v>
                </c:pt>
                <c:pt idx="632">
                  <c:v>17.840341515474922</c:v>
                </c:pt>
                <c:pt idx="633">
                  <c:v>17.868569903948774</c:v>
                </c:pt>
                <c:pt idx="634">
                  <c:v>17.896798292422627</c:v>
                </c:pt>
                <c:pt idx="635">
                  <c:v>17.92502668089648</c:v>
                </c:pt>
                <c:pt idx="636">
                  <c:v>17.953255069370332</c:v>
                </c:pt>
                <c:pt idx="637">
                  <c:v>17.981483457844185</c:v>
                </c:pt>
                <c:pt idx="638">
                  <c:v>18.009711846318037</c:v>
                </c:pt>
                <c:pt idx="639">
                  <c:v>18.03794023479189</c:v>
                </c:pt>
                <c:pt idx="640">
                  <c:v>18.066168623265742</c:v>
                </c:pt>
                <c:pt idx="641">
                  <c:v>18.094397011739595</c:v>
                </c:pt>
                <c:pt idx="642">
                  <c:v>18.122625400213447</c:v>
                </c:pt>
                <c:pt idx="643">
                  <c:v>18.1508537886873</c:v>
                </c:pt>
                <c:pt idx="644">
                  <c:v>18.179082177161153</c:v>
                </c:pt>
                <c:pt idx="645">
                  <c:v>18.207310565635005</c:v>
                </c:pt>
                <c:pt idx="646">
                  <c:v>18.235538954108858</c:v>
                </c:pt>
                <c:pt idx="647">
                  <c:v>18.26376734258271</c:v>
                </c:pt>
                <c:pt idx="648">
                  <c:v>18.291995731056563</c:v>
                </c:pt>
                <c:pt idx="649">
                  <c:v>18.320224119530419</c:v>
                </c:pt>
                <c:pt idx="650">
                  <c:v>18.348452508004272</c:v>
                </c:pt>
                <c:pt idx="651">
                  <c:v>18.376680896478124</c:v>
                </c:pt>
                <c:pt idx="652">
                  <c:v>18.404909284951977</c:v>
                </c:pt>
                <c:pt idx="653">
                  <c:v>18.433137673425829</c:v>
                </c:pt>
                <c:pt idx="654">
                  <c:v>18.461366061899682</c:v>
                </c:pt>
                <c:pt idx="655">
                  <c:v>18.489594450373534</c:v>
                </c:pt>
                <c:pt idx="656">
                  <c:v>18.517822838847387</c:v>
                </c:pt>
                <c:pt idx="657">
                  <c:v>18.546051227321239</c:v>
                </c:pt>
                <c:pt idx="658">
                  <c:v>18.574279615795092</c:v>
                </c:pt>
                <c:pt idx="659">
                  <c:v>18.602508004268945</c:v>
                </c:pt>
                <c:pt idx="660">
                  <c:v>18.630736392742797</c:v>
                </c:pt>
                <c:pt idx="661">
                  <c:v>18.65896478121665</c:v>
                </c:pt>
                <c:pt idx="662">
                  <c:v>18.687193169690502</c:v>
                </c:pt>
                <c:pt idx="663">
                  <c:v>18.715421558164355</c:v>
                </c:pt>
                <c:pt idx="664">
                  <c:v>18.743649946638207</c:v>
                </c:pt>
                <c:pt idx="665">
                  <c:v>18.77187833511206</c:v>
                </c:pt>
                <c:pt idx="666">
                  <c:v>18.800106723585913</c:v>
                </c:pt>
                <c:pt idx="667">
                  <c:v>18.828335112059765</c:v>
                </c:pt>
                <c:pt idx="668">
                  <c:v>18.856563500533618</c:v>
                </c:pt>
                <c:pt idx="669">
                  <c:v>18.88479188900747</c:v>
                </c:pt>
                <c:pt idx="670">
                  <c:v>18.913020277481323</c:v>
                </c:pt>
                <c:pt idx="671">
                  <c:v>18.941248665955179</c:v>
                </c:pt>
                <c:pt idx="672">
                  <c:v>18.969477054429031</c:v>
                </c:pt>
                <c:pt idx="673">
                  <c:v>18.997705442902884</c:v>
                </c:pt>
                <c:pt idx="674">
                  <c:v>19.025933831376737</c:v>
                </c:pt>
                <c:pt idx="675">
                  <c:v>19.054162219850589</c:v>
                </c:pt>
                <c:pt idx="676">
                  <c:v>19.082390608324442</c:v>
                </c:pt>
                <c:pt idx="677">
                  <c:v>19.110618996798294</c:v>
                </c:pt>
                <c:pt idx="678">
                  <c:v>19.138847385272147</c:v>
                </c:pt>
                <c:pt idx="679">
                  <c:v>19.167075773745999</c:v>
                </c:pt>
                <c:pt idx="680">
                  <c:v>19.195304162219852</c:v>
                </c:pt>
                <c:pt idx="681">
                  <c:v>19.223532550693704</c:v>
                </c:pt>
                <c:pt idx="682">
                  <c:v>19.251760939167557</c:v>
                </c:pt>
                <c:pt idx="683">
                  <c:v>19.27998932764141</c:v>
                </c:pt>
                <c:pt idx="684">
                  <c:v>19.308217716115262</c:v>
                </c:pt>
                <c:pt idx="685">
                  <c:v>19.336446104589115</c:v>
                </c:pt>
                <c:pt idx="686">
                  <c:v>19.364674493062967</c:v>
                </c:pt>
                <c:pt idx="687">
                  <c:v>19.39290288153682</c:v>
                </c:pt>
                <c:pt idx="688">
                  <c:v>19.421131270010672</c:v>
                </c:pt>
                <c:pt idx="689">
                  <c:v>19.449359658484525</c:v>
                </c:pt>
                <c:pt idx="690">
                  <c:v>19.477588046958378</c:v>
                </c:pt>
                <c:pt idx="691">
                  <c:v>19.50581643543223</c:v>
                </c:pt>
                <c:pt idx="692">
                  <c:v>19.534044823906083</c:v>
                </c:pt>
                <c:pt idx="693">
                  <c:v>19.562273212379939</c:v>
                </c:pt>
                <c:pt idx="694">
                  <c:v>19.590501600853791</c:v>
                </c:pt>
                <c:pt idx="695">
                  <c:v>19.618729989327644</c:v>
                </c:pt>
                <c:pt idx="696">
                  <c:v>19.646958377801496</c:v>
                </c:pt>
                <c:pt idx="697">
                  <c:v>19.675186766275349</c:v>
                </c:pt>
                <c:pt idx="698">
                  <c:v>19.703415154749202</c:v>
                </c:pt>
                <c:pt idx="699">
                  <c:v>19.731643543223054</c:v>
                </c:pt>
                <c:pt idx="700">
                  <c:v>19.759871931696907</c:v>
                </c:pt>
                <c:pt idx="701">
                  <c:v>19.788100320170759</c:v>
                </c:pt>
                <c:pt idx="702">
                  <c:v>19.816328708644612</c:v>
                </c:pt>
                <c:pt idx="703">
                  <c:v>19.844557097118464</c:v>
                </c:pt>
                <c:pt idx="704">
                  <c:v>19.872785485592317</c:v>
                </c:pt>
                <c:pt idx="705">
                  <c:v>19.90101387406617</c:v>
                </c:pt>
                <c:pt idx="706">
                  <c:v>19.929242262540022</c:v>
                </c:pt>
                <c:pt idx="707">
                  <c:v>19.957470651013875</c:v>
                </c:pt>
                <c:pt idx="708">
                  <c:v>19.985699039487727</c:v>
                </c:pt>
                <c:pt idx="709">
                  <c:v>20.01392742796158</c:v>
                </c:pt>
                <c:pt idx="710">
                  <c:v>20.042155816435432</c:v>
                </c:pt>
                <c:pt idx="711">
                  <c:v>20.070384204909285</c:v>
                </c:pt>
                <c:pt idx="712">
                  <c:v>20.098612593383137</c:v>
                </c:pt>
                <c:pt idx="713">
                  <c:v>20.12684098185699</c:v>
                </c:pt>
                <c:pt idx="714">
                  <c:v>20.155069370330843</c:v>
                </c:pt>
                <c:pt idx="715">
                  <c:v>20.183297758804699</c:v>
                </c:pt>
                <c:pt idx="716">
                  <c:v>20.211526147278551</c:v>
                </c:pt>
                <c:pt idx="717">
                  <c:v>20.239754535752404</c:v>
                </c:pt>
                <c:pt idx="718">
                  <c:v>20.267982924226256</c:v>
                </c:pt>
                <c:pt idx="719">
                  <c:v>20.296211312700109</c:v>
                </c:pt>
                <c:pt idx="720">
                  <c:v>20.324439701173961</c:v>
                </c:pt>
                <c:pt idx="721">
                  <c:v>20.352668089647814</c:v>
                </c:pt>
                <c:pt idx="722">
                  <c:v>20.380896478121667</c:v>
                </c:pt>
                <c:pt idx="723">
                  <c:v>20.409124866595519</c:v>
                </c:pt>
                <c:pt idx="724">
                  <c:v>20.437353255069372</c:v>
                </c:pt>
                <c:pt idx="725">
                  <c:v>20.465581643543224</c:v>
                </c:pt>
                <c:pt idx="726">
                  <c:v>20.493810032017077</c:v>
                </c:pt>
                <c:pt idx="727">
                  <c:v>20.522038420490929</c:v>
                </c:pt>
                <c:pt idx="728">
                  <c:v>20.550266808964782</c:v>
                </c:pt>
                <c:pt idx="729">
                  <c:v>20.578495197438635</c:v>
                </c:pt>
                <c:pt idx="730">
                  <c:v>20.606723585912487</c:v>
                </c:pt>
                <c:pt idx="731">
                  <c:v>20.63495197438634</c:v>
                </c:pt>
                <c:pt idx="732">
                  <c:v>20.663180362860192</c:v>
                </c:pt>
                <c:pt idx="733">
                  <c:v>20.691408751334045</c:v>
                </c:pt>
                <c:pt idx="734">
                  <c:v>20.719637139807897</c:v>
                </c:pt>
                <c:pt idx="735">
                  <c:v>20.74786552828175</c:v>
                </c:pt>
                <c:pt idx="736">
                  <c:v>20.776093916755602</c:v>
                </c:pt>
                <c:pt idx="737">
                  <c:v>20.804322305229459</c:v>
                </c:pt>
                <c:pt idx="738">
                  <c:v>20.832550693703311</c:v>
                </c:pt>
                <c:pt idx="739">
                  <c:v>20.860779082177164</c:v>
                </c:pt>
                <c:pt idx="740">
                  <c:v>20.889007470651016</c:v>
                </c:pt>
                <c:pt idx="741">
                  <c:v>20.917235859124869</c:v>
                </c:pt>
                <c:pt idx="742">
                  <c:v>20.945464247598721</c:v>
                </c:pt>
                <c:pt idx="743">
                  <c:v>20.973692636072574</c:v>
                </c:pt>
                <c:pt idx="744">
                  <c:v>21.001921024546427</c:v>
                </c:pt>
                <c:pt idx="745">
                  <c:v>21.030149413020279</c:v>
                </c:pt>
                <c:pt idx="746">
                  <c:v>21.058377801494132</c:v>
                </c:pt>
                <c:pt idx="747">
                  <c:v>21.086606189967984</c:v>
                </c:pt>
                <c:pt idx="748">
                  <c:v>21.114834578441837</c:v>
                </c:pt>
                <c:pt idx="749">
                  <c:v>21.143062966915689</c:v>
                </c:pt>
                <c:pt idx="750">
                  <c:v>21.171291355389542</c:v>
                </c:pt>
                <c:pt idx="751">
                  <c:v>21.199519743863394</c:v>
                </c:pt>
                <c:pt idx="752">
                  <c:v>21.227748132337247</c:v>
                </c:pt>
                <c:pt idx="753">
                  <c:v>21.2559765208111</c:v>
                </c:pt>
                <c:pt idx="754">
                  <c:v>21.284204909284952</c:v>
                </c:pt>
                <c:pt idx="755">
                  <c:v>21.312433297758805</c:v>
                </c:pt>
                <c:pt idx="756">
                  <c:v>21.340661686232657</c:v>
                </c:pt>
                <c:pt idx="757">
                  <c:v>21.36889007470651</c:v>
                </c:pt>
                <c:pt idx="758">
                  <c:v>21.397118463180362</c:v>
                </c:pt>
                <c:pt idx="759">
                  <c:v>21.425346851654218</c:v>
                </c:pt>
                <c:pt idx="760">
                  <c:v>21.453575240128071</c:v>
                </c:pt>
                <c:pt idx="761">
                  <c:v>21.481803628601924</c:v>
                </c:pt>
                <c:pt idx="762">
                  <c:v>21.510032017075776</c:v>
                </c:pt>
                <c:pt idx="763">
                  <c:v>21.538260405549629</c:v>
                </c:pt>
                <c:pt idx="764">
                  <c:v>21.566488794023481</c:v>
                </c:pt>
                <c:pt idx="765">
                  <c:v>21.594717182497334</c:v>
                </c:pt>
                <c:pt idx="766">
                  <c:v>21.622945570971186</c:v>
                </c:pt>
                <c:pt idx="767">
                  <c:v>21.651173959445039</c:v>
                </c:pt>
                <c:pt idx="768">
                  <c:v>21.679402347918892</c:v>
                </c:pt>
                <c:pt idx="769">
                  <c:v>21.707630736392744</c:v>
                </c:pt>
                <c:pt idx="770">
                  <c:v>21.735859124866597</c:v>
                </c:pt>
                <c:pt idx="771">
                  <c:v>21.764087513340449</c:v>
                </c:pt>
                <c:pt idx="772">
                  <c:v>21.792315901814302</c:v>
                </c:pt>
                <c:pt idx="773">
                  <c:v>21.820544290288154</c:v>
                </c:pt>
                <c:pt idx="774">
                  <c:v>21.848772678762007</c:v>
                </c:pt>
                <c:pt idx="775">
                  <c:v>21.877001067235859</c:v>
                </c:pt>
                <c:pt idx="776">
                  <c:v>21.905229455709712</c:v>
                </c:pt>
                <c:pt idx="777">
                  <c:v>21.933457844183565</c:v>
                </c:pt>
                <c:pt idx="778">
                  <c:v>21.961686232657417</c:v>
                </c:pt>
                <c:pt idx="779">
                  <c:v>21.98991462113127</c:v>
                </c:pt>
                <c:pt idx="780">
                  <c:v>22.018143009605122</c:v>
                </c:pt>
                <c:pt idx="781">
                  <c:v>22.046371398078978</c:v>
                </c:pt>
                <c:pt idx="782">
                  <c:v>22.074599786552831</c:v>
                </c:pt>
                <c:pt idx="783">
                  <c:v>22.102828175026684</c:v>
                </c:pt>
                <c:pt idx="784">
                  <c:v>22.131056563500536</c:v>
                </c:pt>
                <c:pt idx="785">
                  <c:v>22.159284951974389</c:v>
                </c:pt>
                <c:pt idx="786">
                  <c:v>22.187513340448241</c:v>
                </c:pt>
                <c:pt idx="787">
                  <c:v>22.215741728922094</c:v>
                </c:pt>
                <c:pt idx="788">
                  <c:v>22.243970117395946</c:v>
                </c:pt>
                <c:pt idx="789">
                  <c:v>22.272198505869799</c:v>
                </c:pt>
                <c:pt idx="790">
                  <c:v>22.300426894343651</c:v>
                </c:pt>
                <c:pt idx="791">
                  <c:v>22.328655282817504</c:v>
                </c:pt>
                <c:pt idx="792">
                  <c:v>22.356883671291357</c:v>
                </c:pt>
                <c:pt idx="793">
                  <c:v>22.385112059765209</c:v>
                </c:pt>
                <c:pt idx="794">
                  <c:v>22.413340448239062</c:v>
                </c:pt>
                <c:pt idx="795">
                  <c:v>22.441568836712914</c:v>
                </c:pt>
                <c:pt idx="796">
                  <c:v>22.469797225186767</c:v>
                </c:pt>
                <c:pt idx="797">
                  <c:v>22.498025613660619</c:v>
                </c:pt>
                <c:pt idx="798">
                  <c:v>22.526254002134472</c:v>
                </c:pt>
                <c:pt idx="799">
                  <c:v>22.554482390608324</c:v>
                </c:pt>
                <c:pt idx="800">
                  <c:v>22.582710779082177</c:v>
                </c:pt>
                <c:pt idx="801">
                  <c:v>22.61093916755603</c:v>
                </c:pt>
                <c:pt idx="802">
                  <c:v>22.639167556029882</c:v>
                </c:pt>
                <c:pt idx="803">
                  <c:v>22.667395944503738</c:v>
                </c:pt>
                <c:pt idx="804">
                  <c:v>22.695624332977591</c:v>
                </c:pt>
                <c:pt idx="805">
                  <c:v>22.723852721451443</c:v>
                </c:pt>
                <c:pt idx="806">
                  <c:v>22.752081109925296</c:v>
                </c:pt>
                <c:pt idx="807">
                  <c:v>22.780309498399149</c:v>
                </c:pt>
                <c:pt idx="808">
                  <c:v>22.808537886873001</c:v>
                </c:pt>
                <c:pt idx="809">
                  <c:v>22.836766275346854</c:v>
                </c:pt>
                <c:pt idx="810">
                  <c:v>22.864994663820706</c:v>
                </c:pt>
                <c:pt idx="811">
                  <c:v>22.893223052294559</c:v>
                </c:pt>
                <c:pt idx="812">
                  <c:v>22.921451440768411</c:v>
                </c:pt>
                <c:pt idx="813">
                  <c:v>22.949679829242264</c:v>
                </c:pt>
                <c:pt idx="814">
                  <c:v>22.977908217716116</c:v>
                </c:pt>
                <c:pt idx="815">
                  <c:v>23.006136606189969</c:v>
                </c:pt>
                <c:pt idx="816">
                  <c:v>23.034364994663822</c:v>
                </c:pt>
                <c:pt idx="817">
                  <c:v>23.062593383137674</c:v>
                </c:pt>
                <c:pt idx="818">
                  <c:v>23.090821771611527</c:v>
                </c:pt>
                <c:pt idx="819">
                  <c:v>23.119050160085379</c:v>
                </c:pt>
                <c:pt idx="820">
                  <c:v>23.147278548559232</c:v>
                </c:pt>
                <c:pt idx="821">
                  <c:v>23.175506937033084</c:v>
                </c:pt>
                <c:pt idx="822">
                  <c:v>23.203735325506937</c:v>
                </c:pt>
                <c:pt idx="823">
                  <c:v>23.23196371398079</c:v>
                </c:pt>
                <c:pt idx="824">
                  <c:v>23.260192102454642</c:v>
                </c:pt>
                <c:pt idx="825">
                  <c:v>23.288420490928498</c:v>
                </c:pt>
                <c:pt idx="826">
                  <c:v>23.316648879402351</c:v>
                </c:pt>
                <c:pt idx="827">
                  <c:v>23.344877267876203</c:v>
                </c:pt>
                <c:pt idx="828">
                  <c:v>23.373105656350056</c:v>
                </c:pt>
                <c:pt idx="829">
                  <c:v>23.401334044823908</c:v>
                </c:pt>
                <c:pt idx="830">
                  <c:v>23.429562433297761</c:v>
                </c:pt>
                <c:pt idx="831">
                  <c:v>23.457790821771614</c:v>
                </c:pt>
                <c:pt idx="832">
                  <c:v>23.486019210245466</c:v>
                </c:pt>
                <c:pt idx="833">
                  <c:v>23.514247598719319</c:v>
                </c:pt>
                <c:pt idx="834">
                  <c:v>23.542475987193171</c:v>
                </c:pt>
                <c:pt idx="835">
                  <c:v>23.570704375667024</c:v>
                </c:pt>
                <c:pt idx="836">
                  <c:v>23.598932764140876</c:v>
                </c:pt>
                <c:pt idx="837">
                  <c:v>23.627161152614729</c:v>
                </c:pt>
                <c:pt idx="838">
                  <c:v>23.655389541088581</c:v>
                </c:pt>
                <c:pt idx="839">
                  <c:v>23.683617929562434</c:v>
                </c:pt>
                <c:pt idx="840">
                  <c:v>23.711846318036287</c:v>
                </c:pt>
                <c:pt idx="841">
                  <c:v>23.740074706510139</c:v>
                </c:pt>
                <c:pt idx="842">
                  <c:v>23.768303094983992</c:v>
                </c:pt>
                <c:pt idx="843">
                  <c:v>23.796531483457844</c:v>
                </c:pt>
                <c:pt idx="844">
                  <c:v>23.824759871931697</c:v>
                </c:pt>
                <c:pt idx="845">
                  <c:v>23.852988260405549</c:v>
                </c:pt>
                <c:pt idx="846">
                  <c:v>23.881216648879402</c:v>
                </c:pt>
                <c:pt idx="847">
                  <c:v>23.909445037353258</c:v>
                </c:pt>
                <c:pt idx="848">
                  <c:v>23.937673425827111</c:v>
                </c:pt>
                <c:pt idx="849">
                  <c:v>23.965901814300963</c:v>
                </c:pt>
                <c:pt idx="850">
                  <c:v>23.994130202774816</c:v>
                </c:pt>
                <c:pt idx="851">
                  <c:v>24.022358591248668</c:v>
                </c:pt>
                <c:pt idx="852">
                  <c:v>24.050586979722521</c:v>
                </c:pt>
                <c:pt idx="853">
                  <c:v>24.078815368196373</c:v>
                </c:pt>
                <c:pt idx="854">
                  <c:v>24.107043756670226</c:v>
                </c:pt>
                <c:pt idx="855">
                  <c:v>24.135272145144079</c:v>
                </c:pt>
                <c:pt idx="856">
                  <c:v>24.163500533617931</c:v>
                </c:pt>
                <c:pt idx="857">
                  <c:v>24.191728922091784</c:v>
                </c:pt>
                <c:pt idx="858">
                  <c:v>24.219957310565636</c:v>
                </c:pt>
                <c:pt idx="859">
                  <c:v>24.248185699039489</c:v>
                </c:pt>
                <c:pt idx="860">
                  <c:v>24.276414087513341</c:v>
                </c:pt>
                <c:pt idx="861">
                  <c:v>24.304642475987194</c:v>
                </c:pt>
                <c:pt idx="862">
                  <c:v>24.332870864461047</c:v>
                </c:pt>
                <c:pt idx="863">
                  <c:v>24.361099252934899</c:v>
                </c:pt>
                <c:pt idx="864">
                  <c:v>24.389327641408752</c:v>
                </c:pt>
                <c:pt idx="865">
                  <c:v>24.417556029882604</c:v>
                </c:pt>
                <c:pt idx="866">
                  <c:v>24.445784418356457</c:v>
                </c:pt>
                <c:pt idx="867">
                  <c:v>24.474012806830309</c:v>
                </c:pt>
                <c:pt idx="868">
                  <c:v>24.502241195304162</c:v>
                </c:pt>
                <c:pt idx="869">
                  <c:v>24.530469583778018</c:v>
                </c:pt>
                <c:pt idx="870">
                  <c:v>24.558697972251871</c:v>
                </c:pt>
                <c:pt idx="871">
                  <c:v>24.586926360725723</c:v>
                </c:pt>
                <c:pt idx="872">
                  <c:v>24.615154749199576</c:v>
                </c:pt>
                <c:pt idx="873">
                  <c:v>24.643383137673428</c:v>
                </c:pt>
                <c:pt idx="874">
                  <c:v>24.671611526147281</c:v>
                </c:pt>
                <c:pt idx="875">
                  <c:v>24.699839914621133</c:v>
                </c:pt>
                <c:pt idx="876">
                  <c:v>24.728068303094986</c:v>
                </c:pt>
                <c:pt idx="877">
                  <c:v>24.756296691568838</c:v>
                </c:pt>
                <c:pt idx="878">
                  <c:v>24.784525080042691</c:v>
                </c:pt>
                <c:pt idx="879">
                  <c:v>24.812753468516544</c:v>
                </c:pt>
                <c:pt idx="880">
                  <c:v>24.840981856990396</c:v>
                </c:pt>
                <c:pt idx="881">
                  <c:v>24.869210245464249</c:v>
                </c:pt>
                <c:pt idx="882">
                  <c:v>24.897438633938101</c:v>
                </c:pt>
                <c:pt idx="883">
                  <c:v>24.925667022411954</c:v>
                </c:pt>
                <c:pt idx="884">
                  <c:v>24.953895410885806</c:v>
                </c:pt>
                <c:pt idx="885">
                  <c:v>24.982123799359659</c:v>
                </c:pt>
                <c:pt idx="886">
                  <c:v>25.010352187833512</c:v>
                </c:pt>
                <c:pt idx="887">
                  <c:v>25.038580576307364</c:v>
                </c:pt>
                <c:pt idx="888">
                  <c:v>25.066808964781217</c:v>
                </c:pt>
                <c:pt idx="889">
                  <c:v>25.095037353255069</c:v>
                </c:pt>
                <c:pt idx="890">
                  <c:v>25.123265741728922</c:v>
                </c:pt>
                <c:pt idx="891">
                  <c:v>25.151494130202778</c:v>
                </c:pt>
                <c:pt idx="892">
                  <c:v>25.17972251867663</c:v>
                </c:pt>
                <c:pt idx="893">
                  <c:v>25.207950907150483</c:v>
                </c:pt>
                <c:pt idx="894">
                  <c:v>25.236179295624336</c:v>
                </c:pt>
                <c:pt idx="895">
                  <c:v>25.264407684098188</c:v>
                </c:pt>
                <c:pt idx="896">
                  <c:v>25.292636072572041</c:v>
                </c:pt>
                <c:pt idx="897">
                  <c:v>25.320864461045893</c:v>
                </c:pt>
                <c:pt idx="898">
                  <c:v>25.349092849519746</c:v>
                </c:pt>
                <c:pt idx="899">
                  <c:v>25.377321237993598</c:v>
                </c:pt>
                <c:pt idx="900">
                  <c:v>25.405549626467451</c:v>
                </c:pt>
                <c:pt idx="901">
                  <c:v>25.433778014941304</c:v>
                </c:pt>
                <c:pt idx="902">
                  <c:v>25.462006403415156</c:v>
                </c:pt>
                <c:pt idx="903">
                  <c:v>25.490234791889009</c:v>
                </c:pt>
                <c:pt idx="904">
                  <c:v>25.518463180362861</c:v>
                </c:pt>
                <c:pt idx="905">
                  <c:v>25.546691568836714</c:v>
                </c:pt>
                <c:pt idx="906">
                  <c:v>25.574919957310566</c:v>
                </c:pt>
                <c:pt idx="907">
                  <c:v>25.603148345784419</c:v>
                </c:pt>
                <c:pt idx="908">
                  <c:v>25.631376734258271</c:v>
                </c:pt>
                <c:pt idx="909">
                  <c:v>25.659605122732124</c:v>
                </c:pt>
                <c:pt idx="910">
                  <c:v>25.687833511205977</c:v>
                </c:pt>
                <c:pt idx="911">
                  <c:v>25.716061899679829</c:v>
                </c:pt>
                <c:pt idx="912">
                  <c:v>25.744290288153682</c:v>
                </c:pt>
                <c:pt idx="913">
                  <c:v>25.772518676627538</c:v>
                </c:pt>
                <c:pt idx="914">
                  <c:v>25.80074706510139</c:v>
                </c:pt>
                <c:pt idx="915">
                  <c:v>25.828975453575243</c:v>
                </c:pt>
                <c:pt idx="916">
                  <c:v>25.857203842049095</c:v>
                </c:pt>
                <c:pt idx="917">
                  <c:v>25.885432230522948</c:v>
                </c:pt>
                <c:pt idx="918">
                  <c:v>25.913660618996801</c:v>
                </c:pt>
                <c:pt idx="919">
                  <c:v>25.941889007470653</c:v>
                </c:pt>
                <c:pt idx="920">
                  <c:v>25.970117395944506</c:v>
                </c:pt>
                <c:pt idx="921">
                  <c:v>25.998345784418358</c:v>
                </c:pt>
                <c:pt idx="922">
                  <c:v>26.026574172892211</c:v>
                </c:pt>
                <c:pt idx="923">
                  <c:v>26.054802561366063</c:v>
                </c:pt>
                <c:pt idx="924">
                  <c:v>26.083030949839916</c:v>
                </c:pt>
                <c:pt idx="925">
                  <c:v>26.111259338313769</c:v>
                </c:pt>
                <c:pt idx="926">
                  <c:v>26.139487726787621</c:v>
                </c:pt>
                <c:pt idx="927">
                  <c:v>26.167716115261474</c:v>
                </c:pt>
                <c:pt idx="928">
                  <c:v>26.195944503735326</c:v>
                </c:pt>
                <c:pt idx="929">
                  <c:v>26.224172892209179</c:v>
                </c:pt>
                <c:pt idx="930">
                  <c:v>26.252401280683031</c:v>
                </c:pt>
                <c:pt idx="931">
                  <c:v>26.280629669156884</c:v>
                </c:pt>
                <c:pt idx="932">
                  <c:v>26.308858057630736</c:v>
                </c:pt>
                <c:pt idx="933">
                  <c:v>26.337086446104589</c:v>
                </c:pt>
                <c:pt idx="934">
                  <c:v>26.365314834578442</c:v>
                </c:pt>
                <c:pt idx="935">
                  <c:v>26.393543223052298</c:v>
                </c:pt>
                <c:pt idx="936">
                  <c:v>26.42177161152615</c:v>
                </c:pt>
              </c:numCache>
            </c:numRef>
          </c:xVal>
          <c:yVal>
            <c:numRef>
              <c:f>Curves!$B$4:$B$940</c:f>
              <c:numCache>
                <c:formatCode>###0.00</c:formatCode>
                <c:ptCount val="937"/>
                <c:pt idx="0">
                  <c:v>-3.0000000000000001E-3</c:v>
                </c:pt>
                <c:pt idx="1">
                  <c:v>2E-3</c:v>
                </c:pt>
                <c:pt idx="2">
                  <c:v>-1.0999999999999999E-2</c:v>
                </c:pt>
                <c:pt idx="3">
                  <c:v>-4.5999999999999999E-2</c:v>
                </c:pt>
                <c:pt idx="4">
                  <c:v>-3.4000000000000002E-2</c:v>
                </c:pt>
                <c:pt idx="5">
                  <c:v>0.33500000000000002</c:v>
                </c:pt>
                <c:pt idx="6">
                  <c:v>1.458</c:v>
                </c:pt>
                <c:pt idx="7">
                  <c:v>2.802</c:v>
                </c:pt>
                <c:pt idx="8">
                  <c:v>4.056</c:v>
                </c:pt>
                <c:pt idx="9">
                  <c:v>4.6159999999999997</c:v>
                </c:pt>
                <c:pt idx="10">
                  <c:v>4.74</c:v>
                </c:pt>
                <c:pt idx="11">
                  <c:v>4.7480000000000002</c:v>
                </c:pt>
                <c:pt idx="12">
                  <c:v>4.6980000000000004</c:v>
                </c:pt>
                <c:pt idx="13">
                  <c:v>4.6180000000000003</c:v>
                </c:pt>
                <c:pt idx="14">
                  <c:v>4.5190000000000001</c:v>
                </c:pt>
                <c:pt idx="15">
                  <c:v>4.4080000000000004</c:v>
                </c:pt>
                <c:pt idx="16">
                  <c:v>4.2859999999999996</c:v>
                </c:pt>
                <c:pt idx="17">
                  <c:v>4.1719999999999997</c:v>
                </c:pt>
                <c:pt idx="18">
                  <c:v>4.0759999999999996</c:v>
                </c:pt>
                <c:pt idx="19">
                  <c:v>3.9910000000000001</c:v>
                </c:pt>
                <c:pt idx="20">
                  <c:v>3.9129999999999998</c:v>
                </c:pt>
                <c:pt idx="21">
                  <c:v>3.8370000000000002</c:v>
                </c:pt>
                <c:pt idx="22">
                  <c:v>3.758</c:v>
                </c:pt>
                <c:pt idx="23">
                  <c:v>3.6869999999999998</c:v>
                </c:pt>
                <c:pt idx="24">
                  <c:v>3.621</c:v>
                </c:pt>
                <c:pt idx="25">
                  <c:v>3.5619999999999998</c:v>
                </c:pt>
                <c:pt idx="26">
                  <c:v>3.5</c:v>
                </c:pt>
                <c:pt idx="27">
                  <c:v>3.4350000000000001</c:v>
                </c:pt>
                <c:pt idx="28">
                  <c:v>3.37</c:v>
                </c:pt>
                <c:pt idx="29">
                  <c:v>3.31</c:v>
                </c:pt>
                <c:pt idx="30">
                  <c:v>3.2629999999999999</c:v>
                </c:pt>
                <c:pt idx="31">
                  <c:v>3.2160000000000002</c:v>
                </c:pt>
                <c:pt idx="32">
                  <c:v>3.1709999999999998</c:v>
                </c:pt>
                <c:pt idx="33">
                  <c:v>3.1309999999999998</c:v>
                </c:pt>
                <c:pt idx="34">
                  <c:v>3.0920000000000001</c:v>
                </c:pt>
                <c:pt idx="35">
                  <c:v>3.056</c:v>
                </c:pt>
                <c:pt idx="36">
                  <c:v>3.0259999999999998</c:v>
                </c:pt>
                <c:pt idx="37">
                  <c:v>2.9980000000000002</c:v>
                </c:pt>
                <c:pt idx="38">
                  <c:v>2.9750000000000001</c:v>
                </c:pt>
                <c:pt idx="39">
                  <c:v>2.9489999999999998</c:v>
                </c:pt>
                <c:pt idx="40">
                  <c:v>2.931</c:v>
                </c:pt>
                <c:pt idx="41">
                  <c:v>2.9039999999999999</c:v>
                </c:pt>
                <c:pt idx="42">
                  <c:v>2.887</c:v>
                </c:pt>
                <c:pt idx="43">
                  <c:v>2.8620000000000001</c:v>
                </c:pt>
                <c:pt idx="44">
                  <c:v>2.843</c:v>
                </c:pt>
                <c:pt idx="45">
                  <c:v>2.8170000000000002</c:v>
                </c:pt>
                <c:pt idx="46">
                  <c:v>2.7949999999999999</c:v>
                </c:pt>
                <c:pt idx="47">
                  <c:v>2.7639999999999998</c:v>
                </c:pt>
                <c:pt idx="48">
                  <c:v>2.74</c:v>
                </c:pt>
                <c:pt idx="49">
                  <c:v>2.7069999999999999</c:v>
                </c:pt>
                <c:pt idx="50">
                  <c:v>2.6760000000000002</c:v>
                </c:pt>
                <c:pt idx="51">
                  <c:v>2.6480000000000001</c:v>
                </c:pt>
                <c:pt idx="52">
                  <c:v>2.63</c:v>
                </c:pt>
                <c:pt idx="53">
                  <c:v>2.605</c:v>
                </c:pt>
                <c:pt idx="54">
                  <c:v>2.5779999999999998</c:v>
                </c:pt>
                <c:pt idx="55">
                  <c:v>2.5489999999999999</c:v>
                </c:pt>
                <c:pt idx="56">
                  <c:v>2.5219999999999998</c:v>
                </c:pt>
                <c:pt idx="57">
                  <c:v>2.4900000000000002</c:v>
                </c:pt>
                <c:pt idx="58">
                  <c:v>2.46</c:v>
                </c:pt>
                <c:pt idx="59">
                  <c:v>2.4340000000000002</c:v>
                </c:pt>
                <c:pt idx="60">
                  <c:v>2.4079999999999999</c:v>
                </c:pt>
                <c:pt idx="61">
                  <c:v>2.387</c:v>
                </c:pt>
                <c:pt idx="62">
                  <c:v>2.3610000000000002</c:v>
                </c:pt>
                <c:pt idx="63">
                  <c:v>2.339</c:v>
                </c:pt>
                <c:pt idx="64">
                  <c:v>2.3199999999999998</c:v>
                </c:pt>
                <c:pt idx="65">
                  <c:v>2.3090000000000002</c:v>
                </c:pt>
                <c:pt idx="66">
                  <c:v>2.29</c:v>
                </c:pt>
                <c:pt idx="67">
                  <c:v>2.27</c:v>
                </c:pt>
                <c:pt idx="68">
                  <c:v>2.2519999999999998</c:v>
                </c:pt>
                <c:pt idx="69">
                  <c:v>2.2370000000000001</c:v>
                </c:pt>
                <c:pt idx="70">
                  <c:v>2.2290000000000001</c:v>
                </c:pt>
                <c:pt idx="71">
                  <c:v>2.222</c:v>
                </c:pt>
                <c:pt idx="72">
                  <c:v>2.2120000000000002</c:v>
                </c:pt>
                <c:pt idx="73">
                  <c:v>2.202</c:v>
                </c:pt>
                <c:pt idx="74">
                  <c:v>2.198</c:v>
                </c:pt>
                <c:pt idx="75">
                  <c:v>2.1960000000000002</c:v>
                </c:pt>
                <c:pt idx="76">
                  <c:v>2.1949999999999998</c:v>
                </c:pt>
                <c:pt idx="77">
                  <c:v>2.202</c:v>
                </c:pt>
                <c:pt idx="78">
                  <c:v>2.2029999999999998</c:v>
                </c:pt>
                <c:pt idx="79">
                  <c:v>2.2069999999999999</c:v>
                </c:pt>
                <c:pt idx="80">
                  <c:v>2.21</c:v>
                </c:pt>
                <c:pt idx="81">
                  <c:v>2.2090000000000001</c:v>
                </c:pt>
                <c:pt idx="82">
                  <c:v>2.2080000000000002</c:v>
                </c:pt>
                <c:pt idx="83">
                  <c:v>2.202</c:v>
                </c:pt>
                <c:pt idx="84">
                  <c:v>2.2000000000000002</c:v>
                </c:pt>
                <c:pt idx="85">
                  <c:v>2.202</c:v>
                </c:pt>
                <c:pt idx="86">
                  <c:v>2.202</c:v>
                </c:pt>
                <c:pt idx="87">
                  <c:v>2.2040000000000002</c:v>
                </c:pt>
                <c:pt idx="88">
                  <c:v>2.2010000000000001</c:v>
                </c:pt>
                <c:pt idx="89">
                  <c:v>2.1970000000000001</c:v>
                </c:pt>
                <c:pt idx="90">
                  <c:v>2.1930000000000001</c:v>
                </c:pt>
                <c:pt idx="91">
                  <c:v>2.1930000000000001</c:v>
                </c:pt>
                <c:pt idx="92">
                  <c:v>2.1880000000000002</c:v>
                </c:pt>
                <c:pt idx="93">
                  <c:v>2.1850000000000001</c:v>
                </c:pt>
                <c:pt idx="94">
                  <c:v>2.1829999999999998</c:v>
                </c:pt>
                <c:pt idx="95">
                  <c:v>2.1819999999999999</c:v>
                </c:pt>
                <c:pt idx="96">
                  <c:v>2.1829999999999998</c:v>
                </c:pt>
                <c:pt idx="97">
                  <c:v>2.177</c:v>
                </c:pt>
                <c:pt idx="98">
                  <c:v>2.1760000000000002</c:v>
                </c:pt>
                <c:pt idx="99">
                  <c:v>2.1749999999999998</c:v>
                </c:pt>
                <c:pt idx="100">
                  <c:v>2.1720000000000002</c:v>
                </c:pt>
                <c:pt idx="101">
                  <c:v>2.1709999999999998</c:v>
                </c:pt>
                <c:pt idx="102">
                  <c:v>2.1629999999999998</c:v>
                </c:pt>
                <c:pt idx="103">
                  <c:v>2.1549999999999998</c:v>
                </c:pt>
                <c:pt idx="104">
                  <c:v>2.1459999999999999</c:v>
                </c:pt>
                <c:pt idx="105">
                  <c:v>2.14</c:v>
                </c:pt>
                <c:pt idx="106">
                  <c:v>2.1309999999999998</c:v>
                </c:pt>
                <c:pt idx="107">
                  <c:v>2.125</c:v>
                </c:pt>
                <c:pt idx="108">
                  <c:v>2.113</c:v>
                </c:pt>
                <c:pt idx="109">
                  <c:v>2.109</c:v>
                </c:pt>
                <c:pt idx="110">
                  <c:v>2.105</c:v>
                </c:pt>
                <c:pt idx="111">
                  <c:v>2.0950000000000002</c:v>
                </c:pt>
                <c:pt idx="112">
                  <c:v>2.0870000000000002</c:v>
                </c:pt>
                <c:pt idx="113">
                  <c:v>2.0779999999999998</c:v>
                </c:pt>
                <c:pt idx="114">
                  <c:v>2.0720000000000001</c:v>
                </c:pt>
                <c:pt idx="115">
                  <c:v>2.0609999999999999</c:v>
                </c:pt>
                <c:pt idx="116">
                  <c:v>2.052</c:v>
                </c:pt>
                <c:pt idx="117">
                  <c:v>2.0430000000000001</c:v>
                </c:pt>
                <c:pt idx="118">
                  <c:v>2.0379999999999998</c:v>
                </c:pt>
                <c:pt idx="119">
                  <c:v>2.0339999999999998</c:v>
                </c:pt>
                <c:pt idx="120">
                  <c:v>2.024</c:v>
                </c:pt>
                <c:pt idx="121">
                  <c:v>2.0179999999999998</c:v>
                </c:pt>
                <c:pt idx="122">
                  <c:v>2.0059999999999998</c:v>
                </c:pt>
                <c:pt idx="123">
                  <c:v>1.9990000000000001</c:v>
                </c:pt>
                <c:pt idx="124">
                  <c:v>1.9890000000000001</c:v>
                </c:pt>
                <c:pt idx="125">
                  <c:v>1.9790000000000001</c:v>
                </c:pt>
                <c:pt idx="126">
                  <c:v>1.9670000000000001</c:v>
                </c:pt>
                <c:pt idx="127">
                  <c:v>1.9550000000000001</c:v>
                </c:pt>
                <c:pt idx="128">
                  <c:v>1.9379999999999999</c:v>
                </c:pt>
                <c:pt idx="129">
                  <c:v>1.9279999999999999</c:v>
                </c:pt>
                <c:pt idx="130">
                  <c:v>1.917</c:v>
                </c:pt>
                <c:pt idx="131">
                  <c:v>1.905</c:v>
                </c:pt>
                <c:pt idx="132">
                  <c:v>1.9019999999999999</c:v>
                </c:pt>
                <c:pt idx="133">
                  <c:v>1.8919999999999999</c:v>
                </c:pt>
                <c:pt idx="134">
                  <c:v>1.883</c:v>
                </c:pt>
                <c:pt idx="135">
                  <c:v>1.877</c:v>
                </c:pt>
                <c:pt idx="136">
                  <c:v>1.867</c:v>
                </c:pt>
                <c:pt idx="137">
                  <c:v>1.8520000000000001</c:v>
                </c:pt>
                <c:pt idx="138">
                  <c:v>1.84</c:v>
                </c:pt>
                <c:pt idx="139">
                  <c:v>1.8240000000000001</c:v>
                </c:pt>
                <c:pt idx="140">
                  <c:v>1.8120000000000001</c:v>
                </c:pt>
                <c:pt idx="141">
                  <c:v>1.7989999999999999</c:v>
                </c:pt>
                <c:pt idx="142">
                  <c:v>1.7869999999999999</c:v>
                </c:pt>
                <c:pt idx="143">
                  <c:v>1.78</c:v>
                </c:pt>
                <c:pt idx="144">
                  <c:v>1.7749999999999999</c:v>
                </c:pt>
                <c:pt idx="145">
                  <c:v>1.766</c:v>
                </c:pt>
                <c:pt idx="146">
                  <c:v>1.7569999999999999</c:v>
                </c:pt>
                <c:pt idx="147">
                  <c:v>1.746</c:v>
                </c:pt>
                <c:pt idx="148">
                  <c:v>1.7430000000000001</c:v>
                </c:pt>
                <c:pt idx="149">
                  <c:v>1.7370000000000001</c:v>
                </c:pt>
                <c:pt idx="150">
                  <c:v>1.7310000000000001</c:v>
                </c:pt>
                <c:pt idx="151">
                  <c:v>1.722</c:v>
                </c:pt>
                <c:pt idx="152">
                  <c:v>1.712</c:v>
                </c:pt>
                <c:pt idx="153">
                  <c:v>1.7010000000000001</c:v>
                </c:pt>
                <c:pt idx="154">
                  <c:v>1.6970000000000001</c:v>
                </c:pt>
                <c:pt idx="155">
                  <c:v>1.6910000000000001</c:v>
                </c:pt>
                <c:pt idx="156">
                  <c:v>1.6870000000000001</c:v>
                </c:pt>
                <c:pt idx="157">
                  <c:v>1.6830000000000001</c:v>
                </c:pt>
                <c:pt idx="158">
                  <c:v>1.6739999999999999</c:v>
                </c:pt>
                <c:pt idx="159">
                  <c:v>1.6679999999999999</c:v>
                </c:pt>
                <c:pt idx="160">
                  <c:v>1.6579999999999999</c:v>
                </c:pt>
                <c:pt idx="161">
                  <c:v>1.65</c:v>
                </c:pt>
                <c:pt idx="162">
                  <c:v>1.6419999999999999</c:v>
                </c:pt>
                <c:pt idx="163">
                  <c:v>1.6339999999999999</c:v>
                </c:pt>
                <c:pt idx="164">
                  <c:v>1.6359999999999999</c:v>
                </c:pt>
                <c:pt idx="165">
                  <c:v>1.637</c:v>
                </c:pt>
                <c:pt idx="166">
                  <c:v>1.6339999999999999</c:v>
                </c:pt>
                <c:pt idx="167">
                  <c:v>1.6319999999999999</c:v>
                </c:pt>
                <c:pt idx="168">
                  <c:v>1.627</c:v>
                </c:pt>
                <c:pt idx="169">
                  <c:v>1.62</c:v>
                </c:pt>
                <c:pt idx="170">
                  <c:v>1.6140000000000001</c:v>
                </c:pt>
                <c:pt idx="171">
                  <c:v>1.609</c:v>
                </c:pt>
                <c:pt idx="172">
                  <c:v>1.607</c:v>
                </c:pt>
                <c:pt idx="173">
                  <c:v>1.5980000000000001</c:v>
                </c:pt>
                <c:pt idx="174">
                  <c:v>1.593</c:v>
                </c:pt>
                <c:pt idx="175">
                  <c:v>1.589</c:v>
                </c:pt>
                <c:pt idx="176">
                  <c:v>1.585</c:v>
                </c:pt>
                <c:pt idx="177">
                  <c:v>1.5820000000000001</c:v>
                </c:pt>
                <c:pt idx="178">
                  <c:v>1.579</c:v>
                </c:pt>
                <c:pt idx="179">
                  <c:v>1.5720000000000001</c:v>
                </c:pt>
                <c:pt idx="180">
                  <c:v>1.569</c:v>
                </c:pt>
                <c:pt idx="181">
                  <c:v>1.5620000000000001</c:v>
                </c:pt>
                <c:pt idx="182">
                  <c:v>1.556</c:v>
                </c:pt>
                <c:pt idx="183">
                  <c:v>1.546</c:v>
                </c:pt>
                <c:pt idx="184">
                  <c:v>1.534</c:v>
                </c:pt>
                <c:pt idx="185">
                  <c:v>1.524</c:v>
                </c:pt>
                <c:pt idx="186">
                  <c:v>1.5169999999999999</c:v>
                </c:pt>
                <c:pt idx="187">
                  <c:v>1.516</c:v>
                </c:pt>
                <c:pt idx="188">
                  <c:v>1.51</c:v>
                </c:pt>
                <c:pt idx="189">
                  <c:v>1.504</c:v>
                </c:pt>
                <c:pt idx="190">
                  <c:v>1.494</c:v>
                </c:pt>
                <c:pt idx="191">
                  <c:v>1.488</c:v>
                </c:pt>
                <c:pt idx="192">
                  <c:v>1.488</c:v>
                </c:pt>
                <c:pt idx="193">
                  <c:v>1.484</c:v>
                </c:pt>
                <c:pt idx="194">
                  <c:v>1.4770000000000001</c:v>
                </c:pt>
                <c:pt idx="195">
                  <c:v>1.474</c:v>
                </c:pt>
                <c:pt idx="196">
                  <c:v>1.47</c:v>
                </c:pt>
                <c:pt idx="197">
                  <c:v>1.4730000000000001</c:v>
                </c:pt>
                <c:pt idx="198">
                  <c:v>1.474</c:v>
                </c:pt>
                <c:pt idx="199">
                  <c:v>1.48</c:v>
                </c:pt>
                <c:pt idx="200">
                  <c:v>1.4810000000000001</c:v>
                </c:pt>
                <c:pt idx="201">
                  <c:v>1.4850000000000001</c:v>
                </c:pt>
                <c:pt idx="202">
                  <c:v>1.498</c:v>
                </c:pt>
                <c:pt idx="203">
                  <c:v>1.514</c:v>
                </c:pt>
                <c:pt idx="204">
                  <c:v>1.5329999999999999</c:v>
                </c:pt>
                <c:pt idx="205">
                  <c:v>1.554</c:v>
                </c:pt>
                <c:pt idx="206">
                  <c:v>1.581</c:v>
                </c:pt>
                <c:pt idx="207">
                  <c:v>1.61</c:v>
                </c:pt>
                <c:pt idx="208">
                  <c:v>1.65</c:v>
                </c:pt>
                <c:pt idx="209">
                  <c:v>1.698</c:v>
                </c:pt>
                <c:pt idx="210">
                  <c:v>1.7609999999999999</c:v>
                </c:pt>
                <c:pt idx="211">
                  <c:v>1.8420000000000001</c:v>
                </c:pt>
                <c:pt idx="212">
                  <c:v>1.9390000000000001</c:v>
                </c:pt>
                <c:pt idx="213">
                  <c:v>2.0409999999999999</c:v>
                </c:pt>
                <c:pt idx="214">
                  <c:v>2.1589999999999998</c:v>
                </c:pt>
                <c:pt idx="215">
                  <c:v>2.2930000000000001</c:v>
                </c:pt>
                <c:pt idx="216">
                  <c:v>2.4729999999999999</c:v>
                </c:pt>
                <c:pt idx="217">
                  <c:v>2.6720000000000002</c:v>
                </c:pt>
                <c:pt idx="218">
                  <c:v>2.9260000000000002</c:v>
                </c:pt>
                <c:pt idx="219">
                  <c:v>3.2149999999999999</c:v>
                </c:pt>
                <c:pt idx="220">
                  <c:v>3.597</c:v>
                </c:pt>
                <c:pt idx="221">
                  <c:v>4.0659999999999998</c:v>
                </c:pt>
                <c:pt idx="222">
                  <c:v>4.6239999999999997</c:v>
                </c:pt>
                <c:pt idx="223">
                  <c:v>5.327</c:v>
                </c:pt>
                <c:pt idx="224">
                  <c:v>6.1559999999999997</c:v>
                </c:pt>
                <c:pt idx="225">
                  <c:v>7.1909999999999998</c:v>
                </c:pt>
                <c:pt idx="226">
                  <c:v>8.4079999999999995</c:v>
                </c:pt>
                <c:pt idx="227">
                  <c:v>9.9600000000000009</c:v>
                </c:pt>
                <c:pt idx="228">
                  <c:v>11.727</c:v>
                </c:pt>
                <c:pt idx="229">
                  <c:v>13.893000000000001</c:v>
                </c:pt>
                <c:pt idx="230">
                  <c:v>16.411000000000001</c:v>
                </c:pt>
                <c:pt idx="231">
                  <c:v>19.346</c:v>
                </c:pt>
                <c:pt idx="232">
                  <c:v>22.788</c:v>
                </c:pt>
                <c:pt idx="233">
                  <c:v>26.734000000000002</c:v>
                </c:pt>
                <c:pt idx="234">
                  <c:v>31.303999999999998</c:v>
                </c:pt>
                <c:pt idx="235">
                  <c:v>36.465000000000003</c:v>
                </c:pt>
                <c:pt idx="236">
                  <c:v>42.38</c:v>
                </c:pt>
                <c:pt idx="237">
                  <c:v>49.176000000000002</c:v>
                </c:pt>
                <c:pt idx="238">
                  <c:v>56.32</c:v>
                </c:pt>
                <c:pt idx="239">
                  <c:v>64.620999999999995</c:v>
                </c:pt>
                <c:pt idx="240">
                  <c:v>73.09</c:v>
                </c:pt>
                <c:pt idx="241">
                  <c:v>82.616</c:v>
                </c:pt>
                <c:pt idx="242">
                  <c:v>92.238</c:v>
                </c:pt>
                <c:pt idx="243">
                  <c:v>102.776</c:v>
                </c:pt>
                <c:pt idx="244">
                  <c:v>113.128</c:v>
                </c:pt>
                <c:pt idx="245">
                  <c:v>124.035</c:v>
                </c:pt>
                <c:pt idx="246">
                  <c:v>135.05199999999999</c:v>
                </c:pt>
                <c:pt idx="247">
                  <c:v>146.12799999999999</c:v>
                </c:pt>
                <c:pt idx="248">
                  <c:v>157.16499999999999</c:v>
                </c:pt>
                <c:pt idx="249">
                  <c:v>167.65799999999999</c:v>
                </c:pt>
                <c:pt idx="250">
                  <c:v>178.54599999999999</c:v>
                </c:pt>
                <c:pt idx="251">
                  <c:v>188.74600000000001</c:v>
                </c:pt>
                <c:pt idx="252">
                  <c:v>198.999</c:v>
                </c:pt>
                <c:pt idx="253">
                  <c:v>208.78100000000001</c:v>
                </c:pt>
                <c:pt idx="254">
                  <c:v>218.30699999999999</c:v>
                </c:pt>
                <c:pt idx="255">
                  <c:v>227.54300000000001</c:v>
                </c:pt>
                <c:pt idx="256">
                  <c:v>236.398</c:v>
                </c:pt>
                <c:pt idx="257">
                  <c:v>244.94800000000001</c:v>
                </c:pt>
                <c:pt idx="258">
                  <c:v>253.108</c:v>
                </c:pt>
                <c:pt idx="259">
                  <c:v>261.02999999999997</c:v>
                </c:pt>
                <c:pt idx="260">
                  <c:v>268.58800000000002</c:v>
                </c:pt>
                <c:pt idx="261">
                  <c:v>275.89299999999997</c:v>
                </c:pt>
                <c:pt idx="262">
                  <c:v>283.01799999999997</c:v>
                </c:pt>
                <c:pt idx="263">
                  <c:v>289.47399999999999</c:v>
                </c:pt>
                <c:pt idx="264">
                  <c:v>295.99599999999998</c:v>
                </c:pt>
                <c:pt idx="265">
                  <c:v>301.96199999999999</c:v>
                </c:pt>
                <c:pt idx="266">
                  <c:v>307.95800000000003</c:v>
                </c:pt>
                <c:pt idx="267">
                  <c:v>313.37799999999999</c:v>
                </c:pt>
                <c:pt idx="268">
                  <c:v>318.64499999999998</c:v>
                </c:pt>
                <c:pt idx="269">
                  <c:v>323.67200000000003</c:v>
                </c:pt>
                <c:pt idx="270">
                  <c:v>328.428</c:v>
                </c:pt>
                <c:pt idx="271">
                  <c:v>332.99299999999999</c:v>
                </c:pt>
                <c:pt idx="272">
                  <c:v>337.18</c:v>
                </c:pt>
                <c:pt idx="273">
                  <c:v>341.35</c:v>
                </c:pt>
                <c:pt idx="274">
                  <c:v>345.137</c:v>
                </c:pt>
                <c:pt idx="275">
                  <c:v>348.79500000000002</c:v>
                </c:pt>
                <c:pt idx="276">
                  <c:v>352.09699999999998</c:v>
                </c:pt>
                <c:pt idx="277">
                  <c:v>355.38099999999997</c:v>
                </c:pt>
                <c:pt idx="278">
                  <c:v>358.392</c:v>
                </c:pt>
                <c:pt idx="279">
                  <c:v>361.15</c:v>
                </c:pt>
                <c:pt idx="280">
                  <c:v>363.73399999999998</c:v>
                </c:pt>
                <c:pt idx="281">
                  <c:v>366.08499999999998</c:v>
                </c:pt>
                <c:pt idx="282">
                  <c:v>368.28100000000001</c:v>
                </c:pt>
                <c:pt idx="283">
                  <c:v>370.26499999999999</c:v>
                </c:pt>
                <c:pt idx="284">
                  <c:v>372.04300000000001</c:v>
                </c:pt>
                <c:pt idx="285">
                  <c:v>373.63400000000001</c:v>
                </c:pt>
                <c:pt idx="286">
                  <c:v>374.983</c:v>
                </c:pt>
                <c:pt idx="287">
                  <c:v>376.18299999999999</c:v>
                </c:pt>
                <c:pt idx="288">
                  <c:v>377.14800000000002</c:v>
                </c:pt>
                <c:pt idx="289">
                  <c:v>377.96899999999999</c:v>
                </c:pt>
                <c:pt idx="290">
                  <c:v>378.596</c:v>
                </c:pt>
                <c:pt idx="291">
                  <c:v>379.07900000000001</c:v>
                </c:pt>
                <c:pt idx="292">
                  <c:v>379.41899999999998</c:v>
                </c:pt>
                <c:pt idx="293">
                  <c:v>379.584</c:v>
                </c:pt>
                <c:pt idx="294">
                  <c:v>379.589</c:v>
                </c:pt>
                <c:pt idx="295">
                  <c:v>379.44400000000002</c:v>
                </c:pt>
                <c:pt idx="296">
                  <c:v>379.15499999999997</c:v>
                </c:pt>
                <c:pt idx="297">
                  <c:v>378.76299999999998</c:v>
                </c:pt>
                <c:pt idx="298">
                  <c:v>378.27499999999998</c:v>
                </c:pt>
                <c:pt idx="299">
                  <c:v>377.74799999999999</c:v>
                </c:pt>
                <c:pt idx="300">
                  <c:v>377.17</c:v>
                </c:pt>
                <c:pt idx="301">
                  <c:v>376.62700000000001</c:v>
                </c:pt>
                <c:pt idx="302">
                  <c:v>376.05399999999997</c:v>
                </c:pt>
                <c:pt idx="303">
                  <c:v>375.5</c:v>
                </c:pt>
                <c:pt idx="304">
                  <c:v>374.947</c:v>
                </c:pt>
                <c:pt idx="305">
                  <c:v>374.42399999999998</c:v>
                </c:pt>
                <c:pt idx="306">
                  <c:v>373.94400000000002</c:v>
                </c:pt>
                <c:pt idx="307">
                  <c:v>373.49599999999998</c:v>
                </c:pt>
                <c:pt idx="308">
                  <c:v>373.10199999999998</c:v>
                </c:pt>
                <c:pt idx="309">
                  <c:v>372.77499999999998</c:v>
                </c:pt>
                <c:pt idx="310">
                  <c:v>372.53300000000002</c:v>
                </c:pt>
                <c:pt idx="311">
                  <c:v>372.36500000000001</c:v>
                </c:pt>
                <c:pt idx="312">
                  <c:v>372.25900000000001</c:v>
                </c:pt>
                <c:pt idx="313">
                  <c:v>372.20499999999998</c:v>
                </c:pt>
                <c:pt idx="314">
                  <c:v>372.22699999999998</c:v>
                </c:pt>
                <c:pt idx="315">
                  <c:v>372.31400000000002</c:v>
                </c:pt>
                <c:pt idx="316">
                  <c:v>372.48200000000003</c:v>
                </c:pt>
                <c:pt idx="317">
                  <c:v>372.61799999999999</c:v>
                </c:pt>
                <c:pt idx="318">
                  <c:v>372.678</c:v>
                </c:pt>
                <c:pt idx="319">
                  <c:v>372.61700000000002</c:v>
                </c:pt>
                <c:pt idx="320">
                  <c:v>372.351</c:v>
                </c:pt>
                <c:pt idx="321">
                  <c:v>371.80200000000002</c:v>
                </c:pt>
                <c:pt idx="322">
                  <c:v>370.84399999999999</c:v>
                </c:pt>
                <c:pt idx="323">
                  <c:v>369.286</c:v>
                </c:pt>
                <c:pt idx="324">
                  <c:v>367.17099999999999</c:v>
                </c:pt>
                <c:pt idx="325">
                  <c:v>364.25299999999999</c:v>
                </c:pt>
                <c:pt idx="326">
                  <c:v>360.53899999999999</c:v>
                </c:pt>
                <c:pt idx="327">
                  <c:v>355.80799999999999</c:v>
                </c:pt>
                <c:pt idx="328">
                  <c:v>349.98599999999999</c:v>
                </c:pt>
                <c:pt idx="329">
                  <c:v>343.096</c:v>
                </c:pt>
                <c:pt idx="330">
                  <c:v>335.06</c:v>
                </c:pt>
                <c:pt idx="331">
                  <c:v>325.99900000000002</c:v>
                </c:pt>
                <c:pt idx="332">
                  <c:v>315.82100000000003</c:v>
                </c:pt>
                <c:pt idx="333">
                  <c:v>304.50700000000001</c:v>
                </c:pt>
                <c:pt idx="334">
                  <c:v>293.51</c:v>
                </c:pt>
                <c:pt idx="335">
                  <c:v>281.58999999999997</c:v>
                </c:pt>
                <c:pt idx="336">
                  <c:v>270.58800000000002</c:v>
                </c:pt>
                <c:pt idx="337">
                  <c:v>258.42899999999997</c:v>
                </c:pt>
                <c:pt idx="338">
                  <c:v>245.96299999999999</c:v>
                </c:pt>
                <c:pt idx="339">
                  <c:v>232.03</c:v>
                </c:pt>
                <c:pt idx="340">
                  <c:v>218.48400000000001</c:v>
                </c:pt>
                <c:pt idx="341">
                  <c:v>205.17500000000001</c:v>
                </c:pt>
                <c:pt idx="342">
                  <c:v>192.75</c:v>
                </c:pt>
                <c:pt idx="343">
                  <c:v>181.292</c:v>
                </c:pt>
                <c:pt idx="344">
                  <c:v>170.83699999999999</c:v>
                </c:pt>
                <c:pt idx="345">
                  <c:v>161.733</c:v>
                </c:pt>
                <c:pt idx="346">
                  <c:v>153.19300000000001</c:v>
                </c:pt>
                <c:pt idx="347">
                  <c:v>145.86600000000001</c:v>
                </c:pt>
                <c:pt idx="348">
                  <c:v>139.12899999999999</c:v>
                </c:pt>
                <c:pt idx="349">
                  <c:v>133.28700000000001</c:v>
                </c:pt>
                <c:pt idx="350">
                  <c:v>127.66800000000001</c:v>
                </c:pt>
                <c:pt idx="351">
                  <c:v>122.66</c:v>
                </c:pt>
                <c:pt idx="352">
                  <c:v>118.09399999999999</c:v>
                </c:pt>
                <c:pt idx="353">
                  <c:v>113.819</c:v>
                </c:pt>
                <c:pt idx="354">
                  <c:v>109.85299999999999</c:v>
                </c:pt>
                <c:pt idx="355">
                  <c:v>106.102</c:v>
                </c:pt>
                <c:pt idx="356">
                  <c:v>102.596</c:v>
                </c:pt>
                <c:pt idx="357">
                  <c:v>99.3</c:v>
                </c:pt>
                <c:pt idx="358">
                  <c:v>96.174000000000007</c:v>
                </c:pt>
                <c:pt idx="359">
                  <c:v>93.290999999999997</c:v>
                </c:pt>
                <c:pt idx="360">
                  <c:v>90.481999999999999</c:v>
                </c:pt>
                <c:pt idx="361">
                  <c:v>87.956999999999994</c:v>
                </c:pt>
                <c:pt idx="362">
                  <c:v>85.441000000000003</c:v>
                </c:pt>
                <c:pt idx="363">
                  <c:v>83.203999999999994</c:v>
                </c:pt>
                <c:pt idx="364">
                  <c:v>80.98</c:v>
                </c:pt>
                <c:pt idx="365">
                  <c:v>78.891999999999996</c:v>
                </c:pt>
                <c:pt idx="366">
                  <c:v>76.912999999999997</c:v>
                </c:pt>
                <c:pt idx="367">
                  <c:v>75.016000000000005</c:v>
                </c:pt>
                <c:pt idx="368">
                  <c:v>73.268000000000001</c:v>
                </c:pt>
                <c:pt idx="369">
                  <c:v>71.5</c:v>
                </c:pt>
                <c:pt idx="370">
                  <c:v>69.869</c:v>
                </c:pt>
                <c:pt idx="371">
                  <c:v>68.259</c:v>
                </c:pt>
                <c:pt idx="372">
                  <c:v>66.787999999999997</c:v>
                </c:pt>
                <c:pt idx="373">
                  <c:v>65.298000000000002</c:v>
                </c:pt>
                <c:pt idx="374">
                  <c:v>63.91</c:v>
                </c:pt>
                <c:pt idx="375">
                  <c:v>62.591999999999999</c:v>
                </c:pt>
                <c:pt idx="376">
                  <c:v>61.322000000000003</c:v>
                </c:pt>
                <c:pt idx="377">
                  <c:v>60.110999999999997</c:v>
                </c:pt>
                <c:pt idx="378">
                  <c:v>58.942</c:v>
                </c:pt>
                <c:pt idx="379">
                  <c:v>57.823999999999998</c:v>
                </c:pt>
                <c:pt idx="380">
                  <c:v>56.744999999999997</c:v>
                </c:pt>
                <c:pt idx="381">
                  <c:v>55.685000000000002</c:v>
                </c:pt>
                <c:pt idx="382">
                  <c:v>54.680999999999997</c:v>
                </c:pt>
                <c:pt idx="383">
                  <c:v>53.662999999999997</c:v>
                </c:pt>
                <c:pt idx="384">
                  <c:v>52.722999999999999</c:v>
                </c:pt>
                <c:pt idx="385">
                  <c:v>51.744999999999997</c:v>
                </c:pt>
                <c:pt idx="386">
                  <c:v>50.844000000000001</c:v>
                </c:pt>
                <c:pt idx="387">
                  <c:v>49.923999999999999</c:v>
                </c:pt>
                <c:pt idx="388">
                  <c:v>49.048999999999999</c:v>
                </c:pt>
                <c:pt idx="389">
                  <c:v>48.203000000000003</c:v>
                </c:pt>
                <c:pt idx="390">
                  <c:v>47.383000000000003</c:v>
                </c:pt>
                <c:pt idx="391">
                  <c:v>46.606999999999999</c:v>
                </c:pt>
                <c:pt idx="392">
                  <c:v>45.829000000000001</c:v>
                </c:pt>
                <c:pt idx="393">
                  <c:v>45.094000000000001</c:v>
                </c:pt>
                <c:pt idx="394">
                  <c:v>44.356999999999999</c:v>
                </c:pt>
                <c:pt idx="395">
                  <c:v>43.67</c:v>
                </c:pt>
                <c:pt idx="396">
                  <c:v>42.954999999999998</c:v>
                </c:pt>
                <c:pt idx="397">
                  <c:v>42.296999999999997</c:v>
                </c:pt>
                <c:pt idx="398">
                  <c:v>41.631</c:v>
                </c:pt>
                <c:pt idx="399">
                  <c:v>40.994999999999997</c:v>
                </c:pt>
                <c:pt idx="400">
                  <c:v>40.378</c:v>
                </c:pt>
                <c:pt idx="401">
                  <c:v>39.777999999999999</c:v>
                </c:pt>
                <c:pt idx="402">
                  <c:v>39.198999999999998</c:v>
                </c:pt>
                <c:pt idx="403">
                  <c:v>38.643999999999998</c:v>
                </c:pt>
                <c:pt idx="404">
                  <c:v>38.107999999999997</c:v>
                </c:pt>
                <c:pt idx="405">
                  <c:v>37.606000000000002</c:v>
                </c:pt>
                <c:pt idx="406">
                  <c:v>37.103999999999999</c:v>
                </c:pt>
                <c:pt idx="407">
                  <c:v>36.639000000000003</c:v>
                </c:pt>
                <c:pt idx="408">
                  <c:v>36.156999999999996</c:v>
                </c:pt>
                <c:pt idx="409">
                  <c:v>35.71</c:v>
                </c:pt>
                <c:pt idx="410">
                  <c:v>35.25</c:v>
                </c:pt>
                <c:pt idx="411">
                  <c:v>34.822000000000003</c:v>
                </c:pt>
                <c:pt idx="412">
                  <c:v>34.378999999999998</c:v>
                </c:pt>
                <c:pt idx="413">
                  <c:v>33.97</c:v>
                </c:pt>
                <c:pt idx="414">
                  <c:v>33.554000000000002</c:v>
                </c:pt>
                <c:pt idx="415">
                  <c:v>33.139000000000003</c:v>
                </c:pt>
                <c:pt idx="416">
                  <c:v>32.744</c:v>
                </c:pt>
                <c:pt idx="417">
                  <c:v>32.35</c:v>
                </c:pt>
                <c:pt idx="418">
                  <c:v>31.98</c:v>
                </c:pt>
                <c:pt idx="419">
                  <c:v>31.596</c:v>
                </c:pt>
                <c:pt idx="420">
                  <c:v>31.231999999999999</c:v>
                </c:pt>
                <c:pt idx="421">
                  <c:v>30.863</c:v>
                </c:pt>
                <c:pt idx="422">
                  <c:v>30.504999999999999</c:v>
                </c:pt>
                <c:pt idx="423">
                  <c:v>30.148</c:v>
                </c:pt>
                <c:pt idx="424">
                  <c:v>29.786999999999999</c:v>
                </c:pt>
                <c:pt idx="425">
                  <c:v>29.436</c:v>
                </c:pt>
                <c:pt idx="426">
                  <c:v>29.084</c:v>
                </c:pt>
                <c:pt idx="427">
                  <c:v>28.738</c:v>
                </c:pt>
                <c:pt idx="428">
                  <c:v>28.399000000000001</c:v>
                </c:pt>
                <c:pt idx="429">
                  <c:v>28.047999999999998</c:v>
                </c:pt>
                <c:pt idx="430">
                  <c:v>27.727</c:v>
                </c:pt>
                <c:pt idx="431">
                  <c:v>27.391999999999999</c:v>
                </c:pt>
                <c:pt idx="432">
                  <c:v>27.085000000000001</c:v>
                </c:pt>
                <c:pt idx="433">
                  <c:v>26.763000000000002</c:v>
                </c:pt>
                <c:pt idx="434">
                  <c:v>26.465</c:v>
                </c:pt>
                <c:pt idx="435">
                  <c:v>26.161000000000001</c:v>
                </c:pt>
                <c:pt idx="436">
                  <c:v>25.878</c:v>
                </c:pt>
                <c:pt idx="437">
                  <c:v>25.588000000000001</c:v>
                </c:pt>
                <c:pt idx="438">
                  <c:v>25.302</c:v>
                </c:pt>
                <c:pt idx="439">
                  <c:v>25.024000000000001</c:v>
                </c:pt>
                <c:pt idx="440">
                  <c:v>24.748999999999999</c:v>
                </c:pt>
                <c:pt idx="441">
                  <c:v>24.495999999999999</c:v>
                </c:pt>
                <c:pt idx="442">
                  <c:v>24.231000000000002</c:v>
                </c:pt>
                <c:pt idx="443">
                  <c:v>23.98</c:v>
                </c:pt>
                <c:pt idx="444">
                  <c:v>23.725999999999999</c:v>
                </c:pt>
                <c:pt idx="445">
                  <c:v>23.488</c:v>
                </c:pt>
                <c:pt idx="446">
                  <c:v>23.254000000000001</c:v>
                </c:pt>
                <c:pt idx="447">
                  <c:v>23.029</c:v>
                </c:pt>
                <c:pt idx="448">
                  <c:v>22.812999999999999</c:v>
                </c:pt>
                <c:pt idx="449">
                  <c:v>22.594000000000001</c:v>
                </c:pt>
                <c:pt idx="450">
                  <c:v>22.376999999999999</c:v>
                </c:pt>
                <c:pt idx="451">
                  <c:v>22.161999999999999</c:v>
                </c:pt>
                <c:pt idx="452">
                  <c:v>21.951000000000001</c:v>
                </c:pt>
                <c:pt idx="453">
                  <c:v>21.747</c:v>
                </c:pt>
                <c:pt idx="454">
                  <c:v>21.544</c:v>
                </c:pt>
                <c:pt idx="455">
                  <c:v>21.343</c:v>
                </c:pt>
                <c:pt idx="456">
                  <c:v>21.138999999999999</c:v>
                </c:pt>
                <c:pt idx="457">
                  <c:v>20.945</c:v>
                </c:pt>
                <c:pt idx="458">
                  <c:v>20.747</c:v>
                </c:pt>
                <c:pt idx="459">
                  <c:v>20.56</c:v>
                </c:pt>
                <c:pt idx="460">
                  <c:v>20.369</c:v>
                </c:pt>
                <c:pt idx="461">
                  <c:v>20.187000000000001</c:v>
                </c:pt>
                <c:pt idx="462">
                  <c:v>19.997</c:v>
                </c:pt>
                <c:pt idx="463">
                  <c:v>19.818000000000001</c:v>
                </c:pt>
                <c:pt idx="464">
                  <c:v>19.635999999999999</c:v>
                </c:pt>
                <c:pt idx="465">
                  <c:v>19.454999999999998</c:v>
                </c:pt>
                <c:pt idx="466">
                  <c:v>19.282</c:v>
                </c:pt>
                <c:pt idx="467">
                  <c:v>19.109000000000002</c:v>
                </c:pt>
                <c:pt idx="468">
                  <c:v>18.946999999999999</c:v>
                </c:pt>
                <c:pt idx="469">
                  <c:v>18.78</c:v>
                </c:pt>
                <c:pt idx="470">
                  <c:v>18.632000000000001</c:v>
                </c:pt>
                <c:pt idx="471">
                  <c:v>18.475999999999999</c:v>
                </c:pt>
                <c:pt idx="472">
                  <c:v>18.326000000000001</c:v>
                </c:pt>
                <c:pt idx="473">
                  <c:v>18.172000000000001</c:v>
                </c:pt>
                <c:pt idx="474">
                  <c:v>18.030999999999999</c:v>
                </c:pt>
                <c:pt idx="475">
                  <c:v>17.887</c:v>
                </c:pt>
                <c:pt idx="476">
                  <c:v>17.747</c:v>
                </c:pt>
                <c:pt idx="477">
                  <c:v>17.606999999999999</c:v>
                </c:pt>
                <c:pt idx="478">
                  <c:v>17.472000000000001</c:v>
                </c:pt>
                <c:pt idx="479">
                  <c:v>17.332999999999998</c:v>
                </c:pt>
                <c:pt idx="480">
                  <c:v>17.202000000000002</c:v>
                </c:pt>
                <c:pt idx="481">
                  <c:v>17.068000000000001</c:v>
                </c:pt>
                <c:pt idx="482">
                  <c:v>16.952000000000002</c:v>
                </c:pt>
                <c:pt idx="483">
                  <c:v>16.832000000000001</c:v>
                </c:pt>
                <c:pt idx="484">
                  <c:v>16.716000000000001</c:v>
                </c:pt>
                <c:pt idx="485">
                  <c:v>16.597000000000001</c:v>
                </c:pt>
                <c:pt idx="486">
                  <c:v>16.491</c:v>
                </c:pt>
                <c:pt idx="487">
                  <c:v>16.391999999999999</c:v>
                </c:pt>
                <c:pt idx="488">
                  <c:v>16.291</c:v>
                </c:pt>
                <c:pt idx="489">
                  <c:v>16.189</c:v>
                </c:pt>
                <c:pt idx="490">
                  <c:v>16.084</c:v>
                </c:pt>
                <c:pt idx="491">
                  <c:v>15.987</c:v>
                </c:pt>
                <c:pt idx="492">
                  <c:v>15.891</c:v>
                </c:pt>
                <c:pt idx="493">
                  <c:v>15.805</c:v>
                </c:pt>
                <c:pt idx="494">
                  <c:v>15.714</c:v>
                </c:pt>
                <c:pt idx="495">
                  <c:v>15.627000000000001</c:v>
                </c:pt>
                <c:pt idx="496">
                  <c:v>15.541</c:v>
                </c:pt>
                <c:pt idx="497">
                  <c:v>15.456</c:v>
                </c:pt>
                <c:pt idx="498">
                  <c:v>15.375</c:v>
                </c:pt>
                <c:pt idx="499">
                  <c:v>15.297000000000001</c:v>
                </c:pt>
                <c:pt idx="500">
                  <c:v>15.218999999999999</c:v>
                </c:pt>
                <c:pt idx="501">
                  <c:v>15.151</c:v>
                </c:pt>
                <c:pt idx="502">
                  <c:v>15.082000000000001</c:v>
                </c:pt>
                <c:pt idx="503">
                  <c:v>15.013999999999999</c:v>
                </c:pt>
                <c:pt idx="504">
                  <c:v>14.939</c:v>
                </c:pt>
                <c:pt idx="505">
                  <c:v>14.866</c:v>
                </c:pt>
                <c:pt idx="506">
                  <c:v>14.784000000000001</c:v>
                </c:pt>
                <c:pt idx="507">
                  <c:v>14.702999999999999</c:v>
                </c:pt>
                <c:pt idx="508">
                  <c:v>14.616</c:v>
                </c:pt>
                <c:pt idx="509">
                  <c:v>14.539</c:v>
                </c:pt>
                <c:pt idx="510">
                  <c:v>14.446999999999999</c:v>
                </c:pt>
                <c:pt idx="511">
                  <c:v>14.353999999999999</c:v>
                </c:pt>
                <c:pt idx="512">
                  <c:v>14.252000000000001</c:v>
                </c:pt>
                <c:pt idx="513">
                  <c:v>14.16</c:v>
                </c:pt>
                <c:pt idx="514">
                  <c:v>14.074</c:v>
                </c:pt>
                <c:pt idx="515">
                  <c:v>13.98</c:v>
                </c:pt>
                <c:pt idx="516">
                  <c:v>13.897</c:v>
                </c:pt>
                <c:pt idx="517">
                  <c:v>13.81</c:v>
                </c:pt>
                <c:pt idx="518">
                  <c:v>13.728</c:v>
                </c:pt>
                <c:pt idx="519">
                  <c:v>13.653</c:v>
                </c:pt>
                <c:pt idx="520">
                  <c:v>13.577999999999999</c:v>
                </c:pt>
                <c:pt idx="521">
                  <c:v>13.507999999999999</c:v>
                </c:pt>
                <c:pt idx="522">
                  <c:v>13.441000000000001</c:v>
                </c:pt>
                <c:pt idx="523">
                  <c:v>13.375999999999999</c:v>
                </c:pt>
                <c:pt idx="524">
                  <c:v>13.319000000000001</c:v>
                </c:pt>
                <c:pt idx="525">
                  <c:v>13.257</c:v>
                </c:pt>
                <c:pt idx="526">
                  <c:v>13.199</c:v>
                </c:pt>
                <c:pt idx="527">
                  <c:v>13.14</c:v>
                </c:pt>
                <c:pt idx="528">
                  <c:v>13.086</c:v>
                </c:pt>
                <c:pt idx="529">
                  <c:v>13.026999999999999</c:v>
                </c:pt>
                <c:pt idx="530">
                  <c:v>12.965</c:v>
                </c:pt>
                <c:pt idx="531">
                  <c:v>12.907</c:v>
                </c:pt>
                <c:pt idx="532">
                  <c:v>12.855</c:v>
                </c:pt>
                <c:pt idx="533">
                  <c:v>12.801</c:v>
                </c:pt>
                <c:pt idx="534">
                  <c:v>12.750999999999999</c:v>
                </c:pt>
                <c:pt idx="535">
                  <c:v>12.696</c:v>
                </c:pt>
                <c:pt idx="536">
                  <c:v>12.638999999999999</c:v>
                </c:pt>
                <c:pt idx="537">
                  <c:v>12.592000000000001</c:v>
                </c:pt>
                <c:pt idx="538">
                  <c:v>12.542</c:v>
                </c:pt>
                <c:pt idx="539">
                  <c:v>12.5</c:v>
                </c:pt>
                <c:pt idx="540">
                  <c:v>12.455</c:v>
                </c:pt>
                <c:pt idx="541">
                  <c:v>12.417</c:v>
                </c:pt>
                <c:pt idx="542">
                  <c:v>12.385</c:v>
                </c:pt>
                <c:pt idx="543">
                  <c:v>12.349</c:v>
                </c:pt>
                <c:pt idx="544">
                  <c:v>12.315</c:v>
                </c:pt>
                <c:pt idx="545">
                  <c:v>12.281000000000001</c:v>
                </c:pt>
                <c:pt idx="546">
                  <c:v>12.257</c:v>
                </c:pt>
                <c:pt idx="547">
                  <c:v>12.241</c:v>
                </c:pt>
                <c:pt idx="548">
                  <c:v>12.218</c:v>
                </c:pt>
                <c:pt idx="549">
                  <c:v>12.196999999999999</c:v>
                </c:pt>
                <c:pt idx="550">
                  <c:v>12.177</c:v>
                </c:pt>
                <c:pt idx="551">
                  <c:v>12.156000000000001</c:v>
                </c:pt>
                <c:pt idx="552">
                  <c:v>12.137</c:v>
                </c:pt>
                <c:pt idx="553">
                  <c:v>12.118</c:v>
                </c:pt>
                <c:pt idx="554">
                  <c:v>12.101000000000001</c:v>
                </c:pt>
                <c:pt idx="555">
                  <c:v>12.093</c:v>
                </c:pt>
                <c:pt idx="556">
                  <c:v>12.082000000000001</c:v>
                </c:pt>
                <c:pt idx="557">
                  <c:v>12.077</c:v>
                </c:pt>
                <c:pt idx="558">
                  <c:v>12.077999999999999</c:v>
                </c:pt>
                <c:pt idx="559">
                  <c:v>12.076000000000001</c:v>
                </c:pt>
                <c:pt idx="560">
                  <c:v>12.077</c:v>
                </c:pt>
                <c:pt idx="561">
                  <c:v>12.082000000000001</c:v>
                </c:pt>
                <c:pt idx="562">
                  <c:v>12.090999999999999</c:v>
                </c:pt>
                <c:pt idx="563">
                  <c:v>12.095000000000001</c:v>
                </c:pt>
                <c:pt idx="564">
                  <c:v>12.103</c:v>
                </c:pt>
                <c:pt idx="565">
                  <c:v>12.12</c:v>
                </c:pt>
                <c:pt idx="566">
                  <c:v>12.138</c:v>
                </c:pt>
                <c:pt idx="567">
                  <c:v>12.157</c:v>
                </c:pt>
                <c:pt idx="568">
                  <c:v>12.177</c:v>
                </c:pt>
                <c:pt idx="569">
                  <c:v>12.206</c:v>
                </c:pt>
                <c:pt idx="570">
                  <c:v>12.234</c:v>
                </c:pt>
                <c:pt idx="571">
                  <c:v>12.263999999999999</c:v>
                </c:pt>
                <c:pt idx="572">
                  <c:v>12.297000000000001</c:v>
                </c:pt>
                <c:pt idx="573">
                  <c:v>12.335000000000001</c:v>
                </c:pt>
                <c:pt idx="574">
                  <c:v>12.379</c:v>
                </c:pt>
                <c:pt idx="575">
                  <c:v>12.428000000000001</c:v>
                </c:pt>
                <c:pt idx="576">
                  <c:v>12.481</c:v>
                </c:pt>
                <c:pt idx="577">
                  <c:v>12.542999999999999</c:v>
                </c:pt>
                <c:pt idx="578">
                  <c:v>12.602</c:v>
                </c:pt>
                <c:pt idx="579">
                  <c:v>12.662000000000001</c:v>
                </c:pt>
                <c:pt idx="580">
                  <c:v>12.728999999999999</c:v>
                </c:pt>
                <c:pt idx="581">
                  <c:v>12.805</c:v>
                </c:pt>
                <c:pt idx="582">
                  <c:v>12.88</c:v>
                </c:pt>
                <c:pt idx="583">
                  <c:v>12.962999999999999</c:v>
                </c:pt>
                <c:pt idx="584">
                  <c:v>13.048</c:v>
                </c:pt>
                <c:pt idx="585">
                  <c:v>13.132999999999999</c:v>
                </c:pt>
                <c:pt idx="586">
                  <c:v>13.217000000000001</c:v>
                </c:pt>
                <c:pt idx="587">
                  <c:v>13.298999999999999</c:v>
                </c:pt>
                <c:pt idx="588">
                  <c:v>13.388</c:v>
                </c:pt>
                <c:pt idx="589">
                  <c:v>13.478</c:v>
                </c:pt>
                <c:pt idx="590">
                  <c:v>13.571999999999999</c:v>
                </c:pt>
                <c:pt idx="591">
                  <c:v>13.670999999999999</c:v>
                </c:pt>
                <c:pt idx="592">
                  <c:v>13.771000000000001</c:v>
                </c:pt>
                <c:pt idx="593">
                  <c:v>13.871</c:v>
                </c:pt>
                <c:pt idx="594">
                  <c:v>13.972</c:v>
                </c:pt>
                <c:pt idx="595">
                  <c:v>14.074999999999999</c:v>
                </c:pt>
                <c:pt idx="596">
                  <c:v>14.180999999999999</c:v>
                </c:pt>
                <c:pt idx="597">
                  <c:v>14.295</c:v>
                </c:pt>
                <c:pt idx="598">
                  <c:v>14.412000000000001</c:v>
                </c:pt>
                <c:pt idx="599">
                  <c:v>14.523</c:v>
                </c:pt>
                <c:pt idx="600">
                  <c:v>14.641</c:v>
                </c:pt>
                <c:pt idx="601">
                  <c:v>14.752000000000001</c:v>
                </c:pt>
                <c:pt idx="602">
                  <c:v>14.872999999999999</c:v>
                </c:pt>
                <c:pt idx="603">
                  <c:v>14.987</c:v>
                </c:pt>
                <c:pt idx="604">
                  <c:v>15.106999999999999</c:v>
                </c:pt>
                <c:pt idx="605">
                  <c:v>15.218999999999999</c:v>
                </c:pt>
                <c:pt idx="606">
                  <c:v>15.331</c:v>
                </c:pt>
                <c:pt idx="607">
                  <c:v>15.443</c:v>
                </c:pt>
                <c:pt idx="608">
                  <c:v>15.544</c:v>
                </c:pt>
                <c:pt idx="609">
                  <c:v>15.643000000000001</c:v>
                </c:pt>
                <c:pt idx="610">
                  <c:v>15.746</c:v>
                </c:pt>
                <c:pt idx="611">
                  <c:v>15.852</c:v>
                </c:pt>
                <c:pt idx="612">
                  <c:v>15.956</c:v>
                </c:pt>
                <c:pt idx="613">
                  <c:v>16.056999999999999</c:v>
                </c:pt>
                <c:pt idx="614">
                  <c:v>16.155000000000001</c:v>
                </c:pt>
                <c:pt idx="615">
                  <c:v>16.245999999999999</c:v>
                </c:pt>
                <c:pt idx="616">
                  <c:v>16.335999999999999</c:v>
                </c:pt>
                <c:pt idx="617">
                  <c:v>16.425999999999998</c:v>
                </c:pt>
                <c:pt idx="618">
                  <c:v>16.510000000000002</c:v>
                </c:pt>
                <c:pt idx="619">
                  <c:v>16.599</c:v>
                </c:pt>
                <c:pt idx="620">
                  <c:v>16.683</c:v>
                </c:pt>
                <c:pt idx="621">
                  <c:v>16.771000000000001</c:v>
                </c:pt>
                <c:pt idx="622">
                  <c:v>16.850999999999999</c:v>
                </c:pt>
                <c:pt idx="623">
                  <c:v>16.922000000000001</c:v>
                </c:pt>
                <c:pt idx="624">
                  <c:v>16.994</c:v>
                </c:pt>
                <c:pt idx="625">
                  <c:v>17.067</c:v>
                </c:pt>
                <c:pt idx="626">
                  <c:v>17.138999999999999</c:v>
                </c:pt>
                <c:pt idx="627">
                  <c:v>17.213999999999999</c:v>
                </c:pt>
                <c:pt idx="628">
                  <c:v>17.288</c:v>
                </c:pt>
                <c:pt idx="629">
                  <c:v>17.367999999999999</c:v>
                </c:pt>
                <c:pt idx="630">
                  <c:v>17.443999999999999</c:v>
                </c:pt>
                <c:pt idx="631">
                  <c:v>17.521000000000001</c:v>
                </c:pt>
                <c:pt idx="632">
                  <c:v>17.591999999999999</c:v>
                </c:pt>
                <c:pt idx="633">
                  <c:v>17.664000000000001</c:v>
                </c:pt>
                <c:pt idx="634">
                  <c:v>17.744</c:v>
                </c:pt>
                <c:pt idx="635">
                  <c:v>17.821000000000002</c:v>
                </c:pt>
                <c:pt idx="636">
                  <c:v>17.893000000000001</c:v>
                </c:pt>
                <c:pt idx="637">
                  <c:v>17.966999999999999</c:v>
                </c:pt>
                <c:pt idx="638">
                  <c:v>18.036999999999999</c:v>
                </c:pt>
                <c:pt idx="639">
                  <c:v>18.111000000000001</c:v>
                </c:pt>
                <c:pt idx="640">
                  <c:v>18.181000000000001</c:v>
                </c:pt>
                <c:pt idx="641">
                  <c:v>18.251000000000001</c:v>
                </c:pt>
                <c:pt idx="642">
                  <c:v>18.315000000000001</c:v>
                </c:pt>
                <c:pt idx="643">
                  <c:v>18.372</c:v>
                </c:pt>
                <c:pt idx="644">
                  <c:v>18.428999999999998</c:v>
                </c:pt>
                <c:pt idx="645">
                  <c:v>18.484999999999999</c:v>
                </c:pt>
                <c:pt idx="646">
                  <c:v>18.542000000000002</c:v>
                </c:pt>
                <c:pt idx="647">
                  <c:v>18.594000000000001</c:v>
                </c:pt>
                <c:pt idx="648">
                  <c:v>18.643999999999998</c:v>
                </c:pt>
                <c:pt idx="649">
                  <c:v>18.68</c:v>
                </c:pt>
                <c:pt idx="650">
                  <c:v>18.72</c:v>
                </c:pt>
                <c:pt idx="651">
                  <c:v>18.751999999999999</c:v>
                </c:pt>
                <c:pt idx="652">
                  <c:v>18.783999999999999</c:v>
                </c:pt>
                <c:pt idx="653">
                  <c:v>18.821999999999999</c:v>
                </c:pt>
                <c:pt idx="654">
                  <c:v>18.849</c:v>
                </c:pt>
                <c:pt idx="655">
                  <c:v>18.872</c:v>
                </c:pt>
                <c:pt idx="656">
                  <c:v>18.884</c:v>
                </c:pt>
                <c:pt idx="657">
                  <c:v>18.896000000000001</c:v>
                </c:pt>
                <c:pt idx="658">
                  <c:v>18.902999999999999</c:v>
                </c:pt>
                <c:pt idx="659">
                  <c:v>18.907</c:v>
                </c:pt>
                <c:pt idx="660">
                  <c:v>18.902000000000001</c:v>
                </c:pt>
                <c:pt idx="661">
                  <c:v>18.888999999999999</c:v>
                </c:pt>
                <c:pt idx="662">
                  <c:v>18.876999999999999</c:v>
                </c:pt>
                <c:pt idx="663">
                  <c:v>18.861999999999998</c:v>
                </c:pt>
                <c:pt idx="664">
                  <c:v>18.841000000000001</c:v>
                </c:pt>
                <c:pt idx="665">
                  <c:v>18.814</c:v>
                </c:pt>
                <c:pt idx="666">
                  <c:v>18.785</c:v>
                </c:pt>
                <c:pt idx="667">
                  <c:v>18.757000000000001</c:v>
                </c:pt>
                <c:pt idx="668">
                  <c:v>18.739999999999998</c:v>
                </c:pt>
                <c:pt idx="669">
                  <c:v>18.721</c:v>
                </c:pt>
                <c:pt idx="670">
                  <c:v>18.702000000000002</c:v>
                </c:pt>
                <c:pt idx="671">
                  <c:v>18.675000000000001</c:v>
                </c:pt>
                <c:pt idx="672">
                  <c:v>18.638999999999999</c:v>
                </c:pt>
                <c:pt idx="673">
                  <c:v>18.603999999999999</c:v>
                </c:pt>
                <c:pt idx="674">
                  <c:v>18.565000000000001</c:v>
                </c:pt>
                <c:pt idx="675">
                  <c:v>18.521000000000001</c:v>
                </c:pt>
                <c:pt idx="676">
                  <c:v>18.474</c:v>
                </c:pt>
                <c:pt idx="677">
                  <c:v>18.422999999999998</c:v>
                </c:pt>
                <c:pt idx="678">
                  <c:v>18.37</c:v>
                </c:pt>
                <c:pt idx="679">
                  <c:v>18.306999999999999</c:v>
                </c:pt>
                <c:pt idx="680">
                  <c:v>18.245000000000001</c:v>
                </c:pt>
                <c:pt idx="681">
                  <c:v>18.175999999999998</c:v>
                </c:pt>
                <c:pt idx="682">
                  <c:v>18.100999999999999</c:v>
                </c:pt>
                <c:pt idx="683">
                  <c:v>18.027000000000001</c:v>
                </c:pt>
                <c:pt idx="684">
                  <c:v>17.943000000000001</c:v>
                </c:pt>
                <c:pt idx="685">
                  <c:v>17.863</c:v>
                </c:pt>
                <c:pt idx="686">
                  <c:v>17.768999999999998</c:v>
                </c:pt>
                <c:pt idx="687">
                  <c:v>17.684999999999999</c:v>
                </c:pt>
                <c:pt idx="688">
                  <c:v>17.599</c:v>
                </c:pt>
                <c:pt idx="689">
                  <c:v>17.513999999999999</c:v>
                </c:pt>
                <c:pt idx="690">
                  <c:v>17.425999999999998</c:v>
                </c:pt>
                <c:pt idx="691">
                  <c:v>17.335000000000001</c:v>
                </c:pt>
                <c:pt idx="692">
                  <c:v>17.248000000000001</c:v>
                </c:pt>
                <c:pt idx="693">
                  <c:v>17.163</c:v>
                </c:pt>
                <c:pt idx="694">
                  <c:v>17.077000000000002</c:v>
                </c:pt>
                <c:pt idx="695">
                  <c:v>17.001999999999999</c:v>
                </c:pt>
                <c:pt idx="696">
                  <c:v>16.920999999999999</c:v>
                </c:pt>
                <c:pt idx="697">
                  <c:v>16.849</c:v>
                </c:pt>
                <c:pt idx="698">
                  <c:v>16.78</c:v>
                </c:pt>
                <c:pt idx="699">
                  <c:v>16.713000000000001</c:v>
                </c:pt>
                <c:pt idx="700">
                  <c:v>16.643000000000001</c:v>
                </c:pt>
                <c:pt idx="701">
                  <c:v>16.579999999999998</c:v>
                </c:pt>
                <c:pt idx="702">
                  <c:v>16.521000000000001</c:v>
                </c:pt>
                <c:pt idx="703">
                  <c:v>16.463999999999999</c:v>
                </c:pt>
                <c:pt idx="704">
                  <c:v>16.408999999999999</c:v>
                </c:pt>
                <c:pt idx="705">
                  <c:v>16.352</c:v>
                </c:pt>
                <c:pt idx="706">
                  <c:v>16.3</c:v>
                </c:pt>
                <c:pt idx="707">
                  <c:v>16.245999999999999</c:v>
                </c:pt>
                <c:pt idx="708">
                  <c:v>16.199000000000002</c:v>
                </c:pt>
                <c:pt idx="709">
                  <c:v>16.155000000000001</c:v>
                </c:pt>
                <c:pt idx="710">
                  <c:v>16.11</c:v>
                </c:pt>
                <c:pt idx="711">
                  <c:v>16.065000000000001</c:v>
                </c:pt>
                <c:pt idx="712">
                  <c:v>16.013999999999999</c:v>
                </c:pt>
                <c:pt idx="713">
                  <c:v>15.968999999999999</c:v>
                </c:pt>
                <c:pt idx="714">
                  <c:v>15.923999999999999</c:v>
                </c:pt>
                <c:pt idx="715">
                  <c:v>15.877000000000001</c:v>
                </c:pt>
                <c:pt idx="716">
                  <c:v>15.83</c:v>
                </c:pt>
                <c:pt idx="717">
                  <c:v>15.778</c:v>
                </c:pt>
                <c:pt idx="718">
                  <c:v>15.731999999999999</c:v>
                </c:pt>
                <c:pt idx="719">
                  <c:v>15.680999999999999</c:v>
                </c:pt>
                <c:pt idx="720">
                  <c:v>15.632999999999999</c:v>
                </c:pt>
                <c:pt idx="721">
                  <c:v>15.577999999999999</c:v>
                </c:pt>
                <c:pt idx="722">
                  <c:v>15.521000000000001</c:v>
                </c:pt>
                <c:pt idx="723">
                  <c:v>15.459</c:v>
                </c:pt>
                <c:pt idx="724">
                  <c:v>15.401999999999999</c:v>
                </c:pt>
                <c:pt idx="725">
                  <c:v>15.340999999999999</c:v>
                </c:pt>
                <c:pt idx="726">
                  <c:v>15.279</c:v>
                </c:pt>
                <c:pt idx="727">
                  <c:v>15.205</c:v>
                </c:pt>
                <c:pt idx="728">
                  <c:v>15.131</c:v>
                </c:pt>
                <c:pt idx="729">
                  <c:v>15.06</c:v>
                </c:pt>
                <c:pt idx="730">
                  <c:v>14.984999999999999</c:v>
                </c:pt>
                <c:pt idx="731">
                  <c:v>14.907999999999999</c:v>
                </c:pt>
                <c:pt idx="732">
                  <c:v>14.824</c:v>
                </c:pt>
                <c:pt idx="733">
                  <c:v>14.744</c:v>
                </c:pt>
                <c:pt idx="734">
                  <c:v>14.66</c:v>
                </c:pt>
                <c:pt idx="735">
                  <c:v>14.571</c:v>
                </c:pt>
                <c:pt idx="736">
                  <c:v>14.483000000000001</c:v>
                </c:pt>
                <c:pt idx="737">
                  <c:v>14.398</c:v>
                </c:pt>
                <c:pt idx="738">
                  <c:v>14.315</c:v>
                </c:pt>
                <c:pt idx="739">
                  <c:v>14.233000000000001</c:v>
                </c:pt>
                <c:pt idx="740">
                  <c:v>14.148999999999999</c:v>
                </c:pt>
                <c:pt idx="741">
                  <c:v>14.071999999999999</c:v>
                </c:pt>
                <c:pt idx="742">
                  <c:v>13.997999999999999</c:v>
                </c:pt>
                <c:pt idx="743">
                  <c:v>13.920999999999999</c:v>
                </c:pt>
                <c:pt idx="744">
                  <c:v>13.843</c:v>
                </c:pt>
                <c:pt idx="745">
                  <c:v>13.769</c:v>
                </c:pt>
                <c:pt idx="746">
                  <c:v>13.698</c:v>
                </c:pt>
                <c:pt idx="747">
                  <c:v>13.632</c:v>
                </c:pt>
                <c:pt idx="748">
                  <c:v>13.563000000000001</c:v>
                </c:pt>
                <c:pt idx="749">
                  <c:v>13.494</c:v>
                </c:pt>
                <c:pt idx="750">
                  <c:v>13.423</c:v>
                </c:pt>
                <c:pt idx="751">
                  <c:v>13.352</c:v>
                </c:pt>
                <c:pt idx="752">
                  <c:v>13.276999999999999</c:v>
                </c:pt>
                <c:pt idx="753">
                  <c:v>13.211</c:v>
                </c:pt>
                <c:pt idx="754">
                  <c:v>13.143000000000001</c:v>
                </c:pt>
                <c:pt idx="755">
                  <c:v>13.077999999999999</c:v>
                </c:pt>
                <c:pt idx="756">
                  <c:v>13.012</c:v>
                </c:pt>
                <c:pt idx="757">
                  <c:v>12.928000000000001</c:v>
                </c:pt>
                <c:pt idx="758">
                  <c:v>12.856</c:v>
                </c:pt>
                <c:pt idx="759">
                  <c:v>12.773</c:v>
                </c:pt>
                <c:pt idx="760">
                  <c:v>12.696999999999999</c:v>
                </c:pt>
                <c:pt idx="761">
                  <c:v>12.611000000000001</c:v>
                </c:pt>
                <c:pt idx="762">
                  <c:v>12.518000000000001</c:v>
                </c:pt>
                <c:pt idx="763">
                  <c:v>12.430999999999999</c:v>
                </c:pt>
                <c:pt idx="764">
                  <c:v>12.334</c:v>
                </c:pt>
                <c:pt idx="765">
                  <c:v>12.24</c:v>
                </c:pt>
                <c:pt idx="766">
                  <c:v>12.143000000000001</c:v>
                </c:pt>
                <c:pt idx="767">
                  <c:v>12.042999999999999</c:v>
                </c:pt>
                <c:pt idx="768">
                  <c:v>11.941000000000001</c:v>
                </c:pt>
                <c:pt idx="769">
                  <c:v>11.834</c:v>
                </c:pt>
                <c:pt idx="770">
                  <c:v>11.731</c:v>
                </c:pt>
                <c:pt idx="771">
                  <c:v>11.622</c:v>
                </c:pt>
                <c:pt idx="772">
                  <c:v>11.513999999999999</c:v>
                </c:pt>
                <c:pt idx="773">
                  <c:v>11.398999999999999</c:v>
                </c:pt>
                <c:pt idx="774">
                  <c:v>11.282999999999999</c:v>
                </c:pt>
                <c:pt idx="775">
                  <c:v>11.164</c:v>
                </c:pt>
                <c:pt idx="776">
                  <c:v>11.048</c:v>
                </c:pt>
                <c:pt idx="777">
                  <c:v>10.929</c:v>
                </c:pt>
                <c:pt idx="778">
                  <c:v>10.811</c:v>
                </c:pt>
                <c:pt idx="779">
                  <c:v>10.688000000000001</c:v>
                </c:pt>
                <c:pt idx="780">
                  <c:v>10.561</c:v>
                </c:pt>
                <c:pt idx="781">
                  <c:v>10.436</c:v>
                </c:pt>
                <c:pt idx="782">
                  <c:v>10.311</c:v>
                </c:pt>
                <c:pt idx="783">
                  <c:v>10.193</c:v>
                </c:pt>
                <c:pt idx="784">
                  <c:v>10.067</c:v>
                </c:pt>
                <c:pt idx="785">
                  <c:v>9.9339999999999993</c:v>
                </c:pt>
                <c:pt idx="786">
                  <c:v>9.8040000000000003</c:v>
                </c:pt>
                <c:pt idx="787">
                  <c:v>9.6660000000000004</c:v>
                </c:pt>
                <c:pt idx="788">
                  <c:v>9.532</c:v>
                </c:pt>
                <c:pt idx="789">
                  <c:v>9.3949999999999996</c:v>
                </c:pt>
                <c:pt idx="790">
                  <c:v>9.2520000000000007</c:v>
                </c:pt>
                <c:pt idx="791">
                  <c:v>9.109</c:v>
                </c:pt>
                <c:pt idx="792">
                  <c:v>8.9570000000000007</c:v>
                </c:pt>
                <c:pt idx="793">
                  <c:v>8.8179999999999996</c:v>
                </c:pt>
                <c:pt idx="794">
                  <c:v>8.6690000000000005</c:v>
                </c:pt>
                <c:pt idx="795">
                  <c:v>8.5269999999999992</c:v>
                </c:pt>
                <c:pt idx="796">
                  <c:v>8.3770000000000007</c:v>
                </c:pt>
                <c:pt idx="797">
                  <c:v>8.2360000000000007</c:v>
                </c:pt>
                <c:pt idx="798">
                  <c:v>8.0869999999999997</c:v>
                </c:pt>
                <c:pt idx="799">
                  <c:v>7.9390000000000001</c:v>
                </c:pt>
                <c:pt idx="800">
                  <c:v>7.7859999999999996</c:v>
                </c:pt>
                <c:pt idx="801">
                  <c:v>7.6379999999999999</c:v>
                </c:pt>
                <c:pt idx="802">
                  <c:v>7.4969999999999999</c:v>
                </c:pt>
                <c:pt idx="803">
                  <c:v>7.351</c:v>
                </c:pt>
                <c:pt idx="804">
                  <c:v>7.2119999999999997</c:v>
                </c:pt>
                <c:pt idx="805">
                  <c:v>7.0629999999999997</c:v>
                </c:pt>
                <c:pt idx="806">
                  <c:v>6.9169999999999998</c:v>
                </c:pt>
                <c:pt idx="807">
                  <c:v>6.78</c:v>
                </c:pt>
                <c:pt idx="808">
                  <c:v>6.64</c:v>
                </c:pt>
                <c:pt idx="809">
                  <c:v>6.5129999999999999</c:v>
                </c:pt>
                <c:pt idx="810">
                  <c:v>6.3840000000000003</c:v>
                </c:pt>
                <c:pt idx="811">
                  <c:v>6.2640000000000002</c:v>
                </c:pt>
                <c:pt idx="812">
                  <c:v>6.1520000000000001</c:v>
                </c:pt>
                <c:pt idx="813">
                  <c:v>6.0449999999999999</c:v>
                </c:pt>
                <c:pt idx="814">
                  <c:v>5.9349999999999996</c:v>
                </c:pt>
                <c:pt idx="815">
                  <c:v>5.8280000000000003</c:v>
                </c:pt>
                <c:pt idx="816">
                  <c:v>5.7249999999999996</c:v>
                </c:pt>
                <c:pt idx="817">
                  <c:v>5.625</c:v>
                </c:pt>
                <c:pt idx="818">
                  <c:v>5.53</c:v>
                </c:pt>
                <c:pt idx="819">
                  <c:v>5.4329999999999998</c:v>
                </c:pt>
                <c:pt idx="820">
                  <c:v>5.35</c:v>
                </c:pt>
                <c:pt idx="821">
                  <c:v>5.2640000000000002</c:v>
                </c:pt>
                <c:pt idx="822">
                  <c:v>5.1840000000000002</c:v>
                </c:pt>
                <c:pt idx="823">
                  <c:v>5.1040000000000001</c:v>
                </c:pt>
                <c:pt idx="824">
                  <c:v>5.0289999999999999</c:v>
                </c:pt>
                <c:pt idx="825">
                  <c:v>4.9569999999999999</c:v>
                </c:pt>
                <c:pt idx="826">
                  <c:v>4.8869999999999996</c:v>
                </c:pt>
                <c:pt idx="827">
                  <c:v>4.8209999999999997</c:v>
                </c:pt>
                <c:pt idx="828">
                  <c:v>4.7569999999999997</c:v>
                </c:pt>
                <c:pt idx="829">
                  <c:v>4.6929999999999996</c:v>
                </c:pt>
                <c:pt idx="830">
                  <c:v>4.6369999999999996</c:v>
                </c:pt>
                <c:pt idx="831">
                  <c:v>4.5739999999999998</c:v>
                </c:pt>
                <c:pt idx="832">
                  <c:v>4.5179999999999998</c:v>
                </c:pt>
                <c:pt idx="833">
                  <c:v>4.4580000000000002</c:v>
                </c:pt>
                <c:pt idx="834">
                  <c:v>4.4029999999999996</c:v>
                </c:pt>
                <c:pt idx="835">
                  <c:v>4.3490000000000002</c:v>
                </c:pt>
                <c:pt idx="836">
                  <c:v>4.2960000000000003</c:v>
                </c:pt>
                <c:pt idx="837">
                  <c:v>4.2409999999999997</c:v>
                </c:pt>
                <c:pt idx="838">
                  <c:v>4.1879999999999997</c:v>
                </c:pt>
                <c:pt idx="839">
                  <c:v>4.1379999999999999</c:v>
                </c:pt>
                <c:pt idx="840">
                  <c:v>4.0860000000000003</c:v>
                </c:pt>
                <c:pt idx="841">
                  <c:v>4.0439999999999996</c:v>
                </c:pt>
                <c:pt idx="842">
                  <c:v>3.9889999999999999</c:v>
                </c:pt>
                <c:pt idx="843">
                  <c:v>3.9409999999999998</c:v>
                </c:pt>
                <c:pt idx="844">
                  <c:v>3.8929999999999998</c:v>
                </c:pt>
                <c:pt idx="845">
                  <c:v>3.8439999999999999</c:v>
                </c:pt>
                <c:pt idx="846">
                  <c:v>3.794</c:v>
                </c:pt>
                <c:pt idx="847">
                  <c:v>3.7440000000000002</c:v>
                </c:pt>
                <c:pt idx="848">
                  <c:v>3.6930000000000001</c:v>
                </c:pt>
                <c:pt idx="849">
                  <c:v>3.6379999999999999</c:v>
                </c:pt>
                <c:pt idx="850">
                  <c:v>3.589</c:v>
                </c:pt>
                <c:pt idx="851">
                  <c:v>3.5339999999999998</c:v>
                </c:pt>
                <c:pt idx="852">
                  <c:v>3.492</c:v>
                </c:pt>
                <c:pt idx="853">
                  <c:v>3.444</c:v>
                </c:pt>
                <c:pt idx="854">
                  <c:v>3.3929999999999998</c:v>
                </c:pt>
                <c:pt idx="855">
                  <c:v>3.3370000000000002</c:v>
                </c:pt>
                <c:pt idx="856">
                  <c:v>3.2839999999999998</c:v>
                </c:pt>
                <c:pt idx="857">
                  <c:v>3.2330000000000001</c:v>
                </c:pt>
                <c:pt idx="858">
                  <c:v>3.1829999999999998</c:v>
                </c:pt>
                <c:pt idx="859">
                  <c:v>3.1269999999999998</c:v>
                </c:pt>
                <c:pt idx="860">
                  <c:v>3.0750000000000002</c:v>
                </c:pt>
                <c:pt idx="861">
                  <c:v>3.028</c:v>
                </c:pt>
                <c:pt idx="862">
                  <c:v>2.9849999999999999</c:v>
                </c:pt>
                <c:pt idx="863">
                  <c:v>2.9319999999999999</c:v>
                </c:pt>
                <c:pt idx="864">
                  <c:v>2.8809999999999998</c:v>
                </c:pt>
                <c:pt idx="865">
                  <c:v>2.823</c:v>
                </c:pt>
                <c:pt idx="866">
                  <c:v>2.7749999999999999</c:v>
                </c:pt>
                <c:pt idx="867">
                  <c:v>2.7250000000000001</c:v>
                </c:pt>
                <c:pt idx="868">
                  <c:v>2.6789999999999998</c:v>
                </c:pt>
                <c:pt idx="869">
                  <c:v>2.63</c:v>
                </c:pt>
                <c:pt idx="870">
                  <c:v>2.589</c:v>
                </c:pt>
                <c:pt idx="871">
                  <c:v>2.544</c:v>
                </c:pt>
                <c:pt idx="872">
                  <c:v>2.5019999999999998</c:v>
                </c:pt>
                <c:pt idx="873">
                  <c:v>2.46</c:v>
                </c:pt>
                <c:pt idx="874">
                  <c:v>2.419</c:v>
                </c:pt>
                <c:pt idx="875">
                  <c:v>2.3780000000000001</c:v>
                </c:pt>
                <c:pt idx="876">
                  <c:v>2.3450000000000002</c:v>
                </c:pt>
                <c:pt idx="877">
                  <c:v>2.3119999999999998</c:v>
                </c:pt>
                <c:pt idx="878">
                  <c:v>2.282</c:v>
                </c:pt>
                <c:pt idx="879">
                  <c:v>2.2480000000000002</c:v>
                </c:pt>
                <c:pt idx="880">
                  <c:v>2.214</c:v>
                </c:pt>
                <c:pt idx="881">
                  <c:v>2.181</c:v>
                </c:pt>
                <c:pt idx="882">
                  <c:v>2.153</c:v>
                </c:pt>
                <c:pt idx="883">
                  <c:v>2.1259999999999999</c:v>
                </c:pt>
                <c:pt idx="884">
                  <c:v>2.1059999999999999</c:v>
                </c:pt>
                <c:pt idx="885">
                  <c:v>2.085</c:v>
                </c:pt>
                <c:pt idx="886">
                  <c:v>2.0680000000000001</c:v>
                </c:pt>
                <c:pt idx="887">
                  <c:v>2.0499999999999998</c:v>
                </c:pt>
                <c:pt idx="888">
                  <c:v>2.0299999999999998</c:v>
                </c:pt>
                <c:pt idx="889">
                  <c:v>2.0110000000000001</c:v>
                </c:pt>
                <c:pt idx="890">
                  <c:v>1.992</c:v>
                </c:pt>
                <c:pt idx="891">
                  <c:v>1.976</c:v>
                </c:pt>
                <c:pt idx="892">
                  <c:v>1.9530000000000001</c:v>
                </c:pt>
                <c:pt idx="893">
                  <c:v>1.9430000000000001</c:v>
                </c:pt>
                <c:pt idx="894">
                  <c:v>1.9259999999999999</c:v>
                </c:pt>
                <c:pt idx="895">
                  <c:v>1.9139999999999999</c:v>
                </c:pt>
                <c:pt idx="896">
                  <c:v>1.901</c:v>
                </c:pt>
                <c:pt idx="897">
                  <c:v>1.889</c:v>
                </c:pt>
                <c:pt idx="898">
                  <c:v>1.885</c:v>
                </c:pt>
                <c:pt idx="899">
                  <c:v>1.8720000000000001</c:v>
                </c:pt>
                <c:pt idx="900">
                  <c:v>1.8660000000000001</c:v>
                </c:pt>
                <c:pt idx="901">
                  <c:v>1.8580000000000001</c:v>
                </c:pt>
                <c:pt idx="902">
                  <c:v>1.85</c:v>
                </c:pt>
                <c:pt idx="903">
                  <c:v>1.8380000000000001</c:v>
                </c:pt>
                <c:pt idx="904">
                  <c:v>1.823</c:v>
                </c:pt>
                <c:pt idx="905">
                  <c:v>1.8140000000000001</c:v>
                </c:pt>
                <c:pt idx="906">
                  <c:v>1.8149999999999999</c:v>
                </c:pt>
                <c:pt idx="907">
                  <c:v>1.81</c:v>
                </c:pt>
                <c:pt idx="908">
                  <c:v>1.8049999999999999</c:v>
                </c:pt>
                <c:pt idx="909">
                  <c:v>1.7929999999999999</c:v>
                </c:pt>
                <c:pt idx="910">
                  <c:v>1.7849999999999999</c:v>
                </c:pt>
                <c:pt idx="911">
                  <c:v>1.774</c:v>
                </c:pt>
                <c:pt idx="912">
                  <c:v>1.762</c:v>
                </c:pt>
                <c:pt idx="913">
                  <c:v>1.752</c:v>
                </c:pt>
                <c:pt idx="914">
                  <c:v>1.744</c:v>
                </c:pt>
                <c:pt idx="915">
                  <c:v>1.738</c:v>
                </c:pt>
                <c:pt idx="916">
                  <c:v>1.732</c:v>
                </c:pt>
                <c:pt idx="917">
                  <c:v>1.728</c:v>
                </c:pt>
                <c:pt idx="918">
                  <c:v>1.7170000000000001</c:v>
                </c:pt>
                <c:pt idx="919">
                  <c:v>1.7070000000000001</c:v>
                </c:pt>
                <c:pt idx="920">
                  <c:v>1.694</c:v>
                </c:pt>
                <c:pt idx="921">
                  <c:v>1.6879999999999999</c:v>
                </c:pt>
                <c:pt idx="922">
                  <c:v>1.6830000000000001</c:v>
                </c:pt>
                <c:pt idx="923">
                  <c:v>1.6739999999999999</c:v>
                </c:pt>
                <c:pt idx="924">
                  <c:v>1.6679999999999999</c:v>
                </c:pt>
                <c:pt idx="925">
                  <c:v>1.6619999999999999</c:v>
                </c:pt>
                <c:pt idx="926">
                  <c:v>1.651</c:v>
                </c:pt>
                <c:pt idx="927">
                  <c:v>1.641</c:v>
                </c:pt>
                <c:pt idx="928">
                  <c:v>1.627</c:v>
                </c:pt>
                <c:pt idx="929">
                  <c:v>1.617</c:v>
                </c:pt>
                <c:pt idx="930">
                  <c:v>1.609</c:v>
                </c:pt>
                <c:pt idx="931">
                  <c:v>1.607</c:v>
                </c:pt>
                <c:pt idx="932">
                  <c:v>1.605</c:v>
                </c:pt>
                <c:pt idx="933">
                  <c:v>1.599</c:v>
                </c:pt>
                <c:pt idx="934">
                  <c:v>1.593</c:v>
                </c:pt>
                <c:pt idx="935">
                  <c:v>1.5820000000000001</c:v>
                </c:pt>
                <c:pt idx="936">
                  <c:v>1.574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469-8542-B03B-A3CDB24F0F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135624"/>
        <c:axId val="252133664"/>
      </c:scatterChart>
      <c:valAx>
        <c:axId val="252135624"/>
        <c:scaling>
          <c:orientation val="minMax"/>
          <c:max val="20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0" vert="horz"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252133664"/>
        <c:crosses val="autoZero"/>
        <c:crossBetween val="midCat"/>
        <c:majorUnit val="5"/>
      </c:valAx>
      <c:valAx>
        <c:axId val="252133664"/>
        <c:scaling>
          <c:orientation val="minMax"/>
          <c:max val="400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 b="1"/>
            </a:pPr>
            <a:endParaRPr lang="en-US"/>
          </a:p>
        </c:txPr>
        <c:crossAx val="25213562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6866397547034537"/>
          <c:y val="7.4624959807506816E-2"/>
          <c:w val="0.67407332547838961"/>
          <c:h val="0.60724287793053977"/>
        </c:manualLayout>
      </c:layout>
      <c:scatterChart>
        <c:scatterStyle val="smoothMarker"/>
        <c:varyColors val="0"/>
        <c:ser>
          <c:idx val="0"/>
          <c:order val="0"/>
          <c:marker>
            <c:symbol val="none"/>
          </c:marker>
          <c:xVal>
            <c:numRef>
              <c:f>Curves!$A$5:$A$941</c:f>
              <c:numCache>
                <c:formatCode>###0.00</c:formatCode>
                <c:ptCount val="937"/>
                <c:pt idx="0">
                  <c:v>2.658310554036936E-2</c:v>
                </c:pt>
                <c:pt idx="1">
                  <c:v>5.3166211080738719E-2</c:v>
                </c:pt>
                <c:pt idx="2">
                  <c:v>7.9749316621108082E-2</c:v>
                </c:pt>
                <c:pt idx="3">
                  <c:v>0.10633242216147744</c:v>
                </c:pt>
                <c:pt idx="4">
                  <c:v>0.13291552770184681</c:v>
                </c:pt>
                <c:pt idx="5">
                  <c:v>0.15949863324221616</c:v>
                </c:pt>
                <c:pt idx="6">
                  <c:v>0.18608173878258552</c:v>
                </c:pt>
                <c:pt idx="7">
                  <c:v>0.21266484432295488</c:v>
                </c:pt>
                <c:pt idx="8">
                  <c:v>0.23924794986332423</c:v>
                </c:pt>
                <c:pt idx="9">
                  <c:v>0.26583105540369362</c:v>
                </c:pt>
                <c:pt idx="10">
                  <c:v>0.29241416094406297</c:v>
                </c:pt>
                <c:pt idx="11">
                  <c:v>0.31899726648443233</c:v>
                </c:pt>
                <c:pt idx="12">
                  <c:v>0.34558037202480169</c:v>
                </c:pt>
                <c:pt idx="13">
                  <c:v>0.37216347756517104</c:v>
                </c:pt>
                <c:pt idx="14">
                  <c:v>0.3987465831055404</c:v>
                </c:pt>
                <c:pt idx="15">
                  <c:v>0.42532968864590975</c:v>
                </c:pt>
                <c:pt idx="16">
                  <c:v>0.45191279418627911</c:v>
                </c:pt>
                <c:pt idx="17">
                  <c:v>0.47849589972664847</c:v>
                </c:pt>
                <c:pt idx="18">
                  <c:v>0.50507900526701788</c:v>
                </c:pt>
                <c:pt idx="19">
                  <c:v>0.53166211080738723</c:v>
                </c:pt>
                <c:pt idx="20">
                  <c:v>0.55824521634775659</c:v>
                </c:pt>
                <c:pt idx="21">
                  <c:v>0.58482832188812595</c:v>
                </c:pt>
                <c:pt idx="22">
                  <c:v>0.6114114274284953</c:v>
                </c:pt>
                <c:pt idx="23">
                  <c:v>0.63799453296886466</c:v>
                </c:pt>
                <c:pt idx="24">
                  <c:v>0.66457763850923401</c:v>
                </c:pt>
                <c:pt idx="25">
                  <c:v>0.69116074404960337</c:v>
                </c:pt>
                <c:pt idx="26">
                  <c:v>0.71774384958997273</c:v>
                </c:pt>
                <c:pt idx="27">
                  <c:v>0.74432695513034208</c:v>
                </c:pt>
                <c:pt idx="28">
                  <c:v>0.77091006067071144</c:v>
                </c:pt>
                <c:pt idx="29">
                  <c:v>0.7974931662110808</c:v>
                </c:pt>
                <c:pt idx="30">
                  <c:v>0.82407627175145015</c:v>
                </c:pt>
                <c:pt idx="31">
                  <c:v>0.85065937729181951</c:v>
                </c:pt>
                <c:pt idx="32">
                  <c:v>0.87724248283218886</c:v>
                </c:pt>
                <c:pt idx="33">
                  <c:v>0.90382558837255822</c:v>
                </c:pt>
                <c:pt idx="34">
                  <c:v>0.93040869391292758</c:v>
                </c:pt>
                <c:pt idx="35">
                  <c:v>0.95699179945329693</c:v>
                </c:pt>
                <c:pt idx="36">
                  <c:v>0.98357490499366629</c:v>
                </c:pt>
                <c:pt idx="37">
                  <c:v>1.0101580105340358</c:v>
                </c:pt>
                <c:pt idx="38">
                  <c:v>1.0367411160744051</c:v>
                </c:pt>
                <c:pt idx="39">
                  <c:v>1.0633242216147745</c:v>
                </c:pt>
                <c:pt idx="40">
                  <c:v>1.0899073271551438</c:v>
                </c:pt>
                <c:pt idx="41">
                  <c:v>1.1164904326955132</c:v>
                </c:pt>
                <c:pt idx="42">
                  <c:v>1.1430735382358825</c:v>
                </c:pt>
                <c:pt idx="43">
                  <c:v>1.1696566437762519</c:v>
                </c:pt>
                <c:pt idx="44">
                  <c:v>1.1962397493166212</c:v>
                </c:pt>
                <c:pt idx="45">
                  <c:v>1.2228228548569906</c:v>
                </c:pt>
                <c:pt idx="46">
                  <c:v>1.24940596039736</c:v>
                </c:pt>
                <c:pt idx="47">
                  <c:v>1.2759890659377293</c:v>
                </c:pt>
                <c:pt idx="48">
                  <c:v>1.3025721714780987</c:v>
                </c:pt>
                <c:pt idx="49">
                  <c:v>1.329155277018468</c:v>
                </c:pt>
                <c:pt idx="50">
                  <c:v>1.3557383825588374</c:v>
                </c:pt>
                <c:pt idx="51">
                  <c:v>1.3823214880992067</c:v>
                </c:pt>
                <c:pt idx="52">
                  <c:v>1.4089045936395761</c:v>
                </c:pt>
                <c:pt idx="53">
                  <c:v>1.4354876991799455</c:v>
                </c:pt>
                <c:pt idx="54">
                  <c:v>1.4620708047203148</c:v>
                </c:pt>
                <c:pt idx="55">
                  <c:v>1.4886539102606842</c:v>
                </c:pt>
                <c:pt idx="56">
                  <c:v>1.5152370158010535</c:v>
                </c:pt>
                <c:pt idx="57">
                  <c:v>1.5418201213414229</c:v>
                </c:pt>
                <c:pt idx="58">
                  <c:v>1.5684032268817922</c:v>
                </c:pt>
                <c:pt idx="59">
                  <c:v>1.5949863324221616</c:v>
                </c:pt>
                <c:pt idx="60">
                  <c:v>1.6215694379625309</c:v>
                </c:pt>
                <c:pt idx="61">
                  <c:v>1.6481525435029003</c:v>
                </c:pt>
                <c:pt idx="62">
                  <c:v>1.6747356490432697</c:v>
                </c:pt>
                <c:pt idx="63">
                  <c:v>1.701318754583639</c:v>
                </c:pt>
                <c:pt idx="64">
                  <c:v>1.7279018601240084</c:v>
                </c:pt>
                <c:pt idx="65">
                  <c:v>1.7544849656643777</c:v>
                </c:pt>
                <c:pt idx="66">
                  <c:v>1.7810680712047471</c:v>
                </c:pt>
                <c:pt idx="67">
                  <c:v>1.8076511767451164</c:v>
                </c:pt>
                <c:pt idx="68">
                  <c:v>1.8342342822854858</c:v>
                </c:pt>
                <c:pt idx="69">
                  <c:v>1.8608173878258552</c:v>
                </c:pt>
                <c:pt idx="70">
                  <c:v>1.8874004933662245</c:v>
                </c:pt>
                <c:pt idx="71">
                  <c:v>1.9139835989065939</c:v>
                </c:pt>
                <c:pt idx="72">
                  <c:v>1.9405667044469632</c:v>
                </c:pt>
                <c:pt idx="73">
                  <c:v>1.9671498099873326</c:v>
                </c:pt>
                <c:pt idx="74">
                  <c:v>1.9937329155277019</c:v>
                </c:pt>
                <c:pt idx="75">
                  <c:v>2.0203160210680715</c:v>
                </c:pt>
                <c:pt idx="76">
                  <c:v>2.0468991266084409</c:v>
                </c:pt>
                <c:pt idx="77">
                  <c:v>2.0734822321488102</c:v>
                </c:pt>
                <c:pt idx="78">
                  <c:v>2.1000653376891796</c:v>
                </c:pt>
                <c:pt idx="79">
                  <c:v>2.1266484432295489</c:v>
                </c:pt>
                <c:pt idx="80">
                  <c:v>2.1532315487699183</c:v>
                </c:pt>
                <c:pt idx="81">
                  <c:v>2.1798146543102876</c:v>
                </c:pt>
                <c:pt idx="82">
                  <c:v>2.206397759850657</c:v>
                </c:pt>
                <c:pt idx="83">
                  <c:v>2.2329808653910264</c:v>
                </c:pt>
                <c:pt idx="84">
                  <c:v>2.2595639709313957</c:v>
                </c:pt>
                <c:pt idx="85">
                  <c:v>2.2861470764717651</c:v>
                </c:pt>
                <c:pt idx="86">
                  <c:v>2.3127301820121344</c:v>
                </c:pt>
                <c:pt idx="87">
                  <c:v>2.3393132875525038</c:v>
                </c:pt>
                <c:pt idx="88">
                  <c:v>2.3658963930928731</c:v>
                </c:pt>
                <c:pt idx="89">
                  <c:v>2.3924794986332425</c:v>
                </c:pt>
                <c:pt idx="90">
                  <c:v>2.4190626041736119</c:v>
                </c:pt>
                <c:pt idx="91">
                  <c:v>2.4456457097139812</c:v>
                </c:pt>
                <c:pt idx="92">
                  <c:v>2.4722288152543506</c:v>
                </c:pt>
                <c:pt idx="93">
                  <c:v>2.4988119207947199</c:v>
                </c:pt>
                <c:pt idx="94">
                  <c:v>2.5253950263350893</c:v>
                </c:pt>
                <c:pt idx="95">
                  <c:v>2.5519781318754586</c:v>
                </c:pt>
                <c:pt idx="96">
                  <c:v>2.578561237415828</c:v>
                </c:pt>
                <c:pt idx="97">
                  <c:v>2.6051443429561973</c:v>
                </c:pt>
                <c:pt idx="98">
                  <c:v>2.6317274484965667</c:v>
                </c:pt>
                <c:pt idx="99">
                  <c:v>2.6583105540369361</c:v>
                </c:pt>
                <c:pt idx="100">
                  <c:v>2.6848936595773054</c:v>
                </c:pt>
                <c:pt idx="101">
                  <c:v>2.7114767651176748</c:v>
                </c:pt>
                <c:pt idx="102">
                  <c:v>2.7380598706580441</c:v>
                </c:pt>
                <c:pt idx="103">
                  <c:v>2.7646429761984135</c:v>
                </c:pt>
                <c:pt idx="104">
                  <c:v>2.7912260817387828</c:v>
                </c:pt>
                <c:pt idx="105">
                  <c:v>2.8178091872791522</c:v>
                </c:pt>
                <c:pt idx="106">
                  <c:v>2.8443922928195216</c:v>
                </c:pt>
                <c:pt idx="107">
                  <c:v>2.8709753983598909</c:v>
                </c:pt>
                <c:pt idx="108">
                  <c:v>2.8975585039002603</c:v>
                </c:pt>
                <c:pt idx="109">
                  <c:v>2.9241416094406296</c:v>
                </c:pt>
                <c:pt idx="110">
                  <c:v>2.950724714980999</c:v>
                </c:pt>
                <c:pt idx="111">
                  <c:v>2.9773078205213683</c:v>
                </c:pt>
                <c:pt idx="112">
                  <c:v>3.0038909260617377</c:v>
                </c:pt>
                <c:pt idx="113">
                  <c:v>3.030474031602107</c:v>
                </c:pt>
                <c:pt idx="114">
                  <c:v>3.0570571371424764</c:v>
                </c:pt>
                <c:pt idx="115">
                  <c:v>3.0836402426828458</c:v>
                </c:pt>
                <c:pt idx="116">
                  <c:v>3.1102233482232151</c:v>
                </c:pt>
                <c:pt idx="117">
                  <c:v>3.1368064537635845</c:v>
                </c:pt>
                <c:pt idx="118">
                  <c:v>3.1633895593039538</c:v>
                </c:pt>
                <c:pt idx="119">
                  <c:v>3.1899726648443232</c:v>
                </c:pt>
                <c:pt idx="120">
                  <c:v>3.2165557703846925</c:v>
                </c:pt>
                <c:pt idx="121">
                  <c:v>3.2431388759250619</c:v>
                </c:pt>
                <c:pt idx="122">
                  <c:v>3.2697219814654312</c:v>
                </c:pt>
                <c:pt idx="123">
                  <c:v>3.2963050870058006</c:v>
                </c:pt>
                <c:pt idx="124">
                  <c:v>3.32288819254617</c:v>
                </c:pt>
                <c:pt idx="125">
                  <c:v>3.3494712980865393</c:v>
                </c:pt>
                <c:pt idx="126">
                  <c:v>3.3760544036269087</c:v>
                </c:pt>
                <c:pt idx="127">
                  <c:v>3.402637509167278</c:v>
                </c:pt>
                <c:pt idx="128">
                  <c:v>3.4292206147076474</c:v>
                </c:pt>
                <c:pt idx="129">
                  <c:v>3.4558037202480167</c:v>
                </c:pt>
                <c:pt idx="130">
                  <c:v>3.4823868257883861</c:v>
                </c:pt>
                <c:pt idx="131">
                  <c:v>3.5089699313287555</c:v>
                </c:pt>
                <c:pt idx="132">
                  <c:v>3.5355530368691248</c:v>
                </c:pt>
                <c:pt idx="133">
                  <c:v>3.5621361424094942</c:v>
                </c:pt>
                <c:pt idx="134">
                  <c:v>3.5887192479498635</c:v>
                </c:pt>
                <c:pt idx="135">
                  <c:v>3.6153023534902329</c:v>
                </c:pt>
                <c:pt idx="136">
                  <c:v>3.6418854590306022</c:v>
                </c:pt>
                <c:pt idx="137">
                  <c:v>3.6684685645709716</c:v>
                </c:pt>
                <c:pt idx="138">
                  <c:v>3.6950516701113409</c:v>
                </c:pt>
                <c:pt idx="139">
                  <c:v>3.7216347756517103</c:v>
                </c:pt>
                <c:pt idx="140">
                  <c:v>3.7482178811920797</c:v>
                </c:pt>
                <c:pt idx="141">
                  <c:v>3.774800986732449</c:v>
                </c:pt>
                <c:pt idx="142">
                  <c:v>3.8013840922728184</c:v>
                </c:pt>
                <c:pt idx="143">
                  <c:v>3.8279671978131877</c:v>
                </c:pt>
                <c:pt idx="144">
                  <c:v>3.8545503033535571</c:v>
                </c:pt>
                <c:pt idx="145">
                  <c:v>3.8811334088939264</c:v>
                </c:pt>
                <c:pt idx="146">
                  <c:v>3.9077165144342958</c:v>
                </c:pt>
                <c:pt idx="147">
                  <c:v>3.9342996199746652</c:v>
                </c:pt>
                <c:pt idx="148">
                  <c:v>3.9608827255150345</c:v>
                </c:pt>
                <c:pt idx="149">
                  <c:v>3.9874658310554039</c:v>
                </c:pt>
                <c:pt idx="150">
                  <c:v>4.0140489365957732</c:v>
                </c:pt>
                <c:pt idx="151">
                  <c:v>4.040632042136143</c:v>
                </c:pt>
                <c:pt idx="152">
                  <c:v>4.0672151476765119</c:v>
                </c:pt>
                <c:pt idx="153">
                  <c:v>4.0937982532168817</c:v>
                </c:pt>
                <c:pt idx="154">
                  <c:v>4.1203813587572506</c:v>
                </c:pt>
                <c:pt idx="155">
                  <c:v>4.1469644642976204</c:v>
                </c:pt>
                <c:pt idx="156">
                  <c:v>4.1735475698379894</c:v>
                </c:pt>
                <c:pt idx="157">
                  <c:v>4.2001306753783592</c:v>
                </c:pt>
                <c:pt idx="158">
                  <c:v>4.2267137809187281</c:v>
                </c:pt>
                <c:pt idx="159">
                  <c:v>4.2532968864590979</c:v>
                </c:pt>
                <c:pt idx="160">
                  <c:v>4.2798799919994668</c:v>
                </c:pt>
                <c:pt idx="161">
                  <c:v>4.3064630975398366</c:v>
                </c:pt>
                <c:pt idx="162">
                  <c:v>4.3330462030802055</c:v>
                </c:pt>
                <c:pt idx="163">
                  <c:v>4.3596293086205753</c:v>
                </c:pt>
                <c:pt idx="164">
                  <c:v>4.3862124141609442</c:v>
                </c:pt>
                <c:pt idx="165">
                  <c:v>4.412795519701314</c:v>
                </c:pt>
                <c:pt idx="166">
                  <c:v>4.4393786252416829</c:v>
                </c:pt>
                <c:pt idx="167">
                  <c:v>4.4659617307820527</c:v>
                </c:pt>
                <c:pt idx="168">
                  <c:v>4.4925448363224216</c:v>
                </c:pt>
                <c:pt idx="169">
                  <c:v>4.5191279418627914</c:v>
                </c:pt>
                <c:pt idx="170">
                  <c:v>4.5457110474031603</c:v>
                </c:pt>
                <c:pt idx="171">
                  <c:v>4.5722941529435301</c:v>
                </c:pt>
                <c:pt idx="172">
                  <c:v>4.5988772584838991</c:v>
                </c:pt>
                <c:pt idx="173">
                  <c:v>4.6254603640242689</c:v>
                </c:pt>
                <c:pt idx="174">
                  <c:v>4.6520434695646378</c:v>
                </c:pt>
                <c:pt idx="175">
                  <c:v>4.6786265751050076</c:v>
                </c:pt>
                <c:pt idx="176">
                  <c:v>4.7052096806453765</c:v>
                </c:pt>
                <c:pt idx="177">
                  <c:v>4.7317927861857463</c:v>
                </c:pt>
                <c:pt idx="178">
                  <c:v>4.7583758917261152</c:v>
                </c:pt>
                <c:pt idx="179">
                  <c:v>4.784958997266485</c:v>
                </c:pt>
                <c:pt idx="180">
                  <c:v>4.8115421028068539</c:v>
                </c:pt>
                <c:pt idx="181">
                  <c:v>4.8381252083472237</c:v>
                </c:pt>
                <c:pt idx="182">
                  <c:v>4.8647083138875926</c:v>
                </c:pt>
                <c:pt idx="183">
                  <c:v>4.8912914194279624</c:v>
                </c:pt>
                <c:pt idx="184">
                  <c:v>4.9178745249683313</c:v>
                </c:pt>
                <c:pt idx="185">
                  <c:v>4.9444576305087011</c:v>
                </c:pt>
                <c:pt idx="186">
                  <c:v>4.97104073604907</c:v>
                </c:pt>
                <c:pt idx="187">
                  <c:v>4.9976238415894398</c:v>
                </c:pt>
                <c:pt idx="188">
                  <c:v>5.0242069471298088</c:v>
                </c:pt>
                <c:pt idx="189">
                  <c:v>5.0507900526701786</c:v>
                </c:pt>
                <c:pt idx="190">
                  <c:v>5.0773731582105475</c:v>
                </c:pt>
                <c:pt idx="191">
                  <c:v>5.1039562637509173</c:v>
                </c:pt>
                <c:pt idx="192">
                  <c:v>5.1305393692912862</c:v>
                </c:pt>
                <c:pt idx="193">
                  <c:v>5.157122474831656</c:v>
                </c:pt>
                <c:pt idx="194">
                  <c:v>5.1837055803720249</c:v>
                </c:pt>
                <c:pt idx="195">
                  <c:v>5.2102886859123947</c:v>
                </c:pt>
                <c:pt idx="196">
                  <c:v>5.2368717914527636</c:v>
                </c:pt>
                <c:pt idx="197">
                  <c:v>5.2634548969931334</c:v>
                </c:pt>
                <c:pt idx="198">
                  <c:v>5.2900380025335023</c:v>
                </c:pt>
                <c:pt idx="199">
                  <c:v>5.3166211080738721</c:v>
                </c:pt>
                <c:pt idx="200">
                  <c:v>5.343204213614241</c:v>
                </c:pt>
                <c:pt idx="201">
                  <c:v>5.3697873191546108</c:v>
                </c:pt>
                <c:pt idx="202">
                  <c:v>5.3963704246949797</c:v>
                </c:pt>
                <c:pt idx="203">
                  <c:v>5.4229535302353495</c:v>
                </c:pt>
                <c:pt idx="204">
                  <c:v>5.4495366357757185</c:v>
                </c:pt>
                <c:pt idx="205">
                  <c:v>5.4761197413160883</c:v>
                </c:pt>
                <c:pt idx="206">
                  <c:v>5.5027028468564572</c:v>
                </c:pt>
                <c:pt idx="207">
                  <c:v>5.529285952396827</c:v>
                </c:pt>
                <c:pt idx="208">
                  <c:v>5.5558690579371959</c:v>
                </c:pt>
                <c:pt idx="209">
                  <c:v>5.5824521634775657</c:v>
                </c:pt>
                <c:pt idx="210">
                  <c:v>5.6090352690179346</c:v>
                </c:pt>
                <c:pt idx="211">
                  <c:v>5.6356183745583044</c:v>
                </c:pt>
                <c:pt idx="212">
                  <c:v>5.6622014800986733</c:v>
                </c:pt>
                <c:pt idx="213">
                  <c:v>5.6887845856390431</c:v>
                </c:pt>
                <c:pt idx="214">
                  <c:v>5.715367691179412</c:v>
                </c:pt>
                <c:pt idx="215">
                  <c:v>5.7419507967197818</c:v>
                </c:pt>
                <c:pt idx="216">
                  <c:v>5.7685339022601507</c:v>
                </c:pt>
                <c:pt idx="217">
                  <c:v>5.7951170078005205</c:v>
                </c:pt>
                <c:pt idx="218">
                  <c:v>5.8217001133408894</c:v>
                </c:pt>
                <c:pt idx="219">
                  <c:v>5.8482832188812592</c:v>
                </c:pt>
                <c:pt idx="220">
                  <c:v>5.8748663244216281</c:v>
                </c:pt>
                <c:pt idx="221">
                  <c:v>5.901449429961998</c:v>
                </c:pt>
                <c:pt idx="222">
                  <c:v>5.9280325355023669</c:v>
                </c:pt>
                <c:pt idx="223">
                  <c:v>5.9546156410427367</c:v>
                </c:pt>
                <c:pt idx="224">
                  <c:v>5.9811987465831056</c:v>
                </c:pt>
                <c:pt idx="225">
                  <c:v>6.0077818521234754</c:v>
                </c:pt>
                <c:pt idx="226">
                  <c:v>6.0343649576638443</c:v>
                </c:pt>
                <c:pt idx="227">
                  <c:v>6.0609480632042141</c:v>
                </c:pt>
                <c:pt idx="228">
                  <c:v>6.087531168744583</c:v>
                </c:pt>
                <c:pt idx="229">
                  <c:v>6.1141142742849528</c:v>
                </c:pt>
                <c:pt idx="230">
                  <c:v>6.1406973798253217</c:v>
                </c:pt>
                <c:pt idx="231">
                  <c:v>6.1672804853656915</c:v>
                </c:pt>
                <c:pt idx="232">
                  <c:v>6.1938635909060604</c:v>
                </c:pt>
                <c:pt idx="233">
                  <c:v>6.2204466964464302</c:v>
                </c:pt>
                <c:pt idx="234">
                  <c:v>6.2470298019867991</c:v>
                </c:pt>
                <c:pt idx="235">
                  <c:v>6.2736129075271689</c:v>
                </c:pt>
                <c:pt idx="236">
                  <c:v>6.3001960130675378</c:v>
                </c:pt>
                <c:pt idx="237">
                  <c:v>6.3267791186079076</c:v>
                </c:pt>
                <c:pt idx="238">
                  <c:v>6.3533622241482766</c:v>
                </c:pt>
                <c:pt idx="239">
                  <c:v>6.3799453296886464</c:v>
                </c:pt>
                <c:pt idx="240">
                  <c:v>6.4065284352290153</c:v>
                </c:pt>
                <c:pt idx="241">
                  <c:v>6.4331115407693851</c:v>
                </c:pt>
                <c:pt idx="242">
                  <c:v>6.459694646309754</c:v>
                </c:pt>
                <c:pt idx="243">
                  <c:v>6.4862777518501238</c:v>
                </c:pt>
                <c:pt idx="244">
                  <c:v>6.5128608573904927</c:v>
                </c:pt>
                <c:pt idx="245">
                  <c:v>6.5394439629308625</c:v>
                </c:pt>
                <c:pt idx="246">
                  <c:v>6.5660270684712314</c:v>
                </c:pt>
                <c:pt idx="247">
                  <c:v>6.5926101740116012</c:v>
                </c:pt>
                <c:pt idx="248">
                  <c:v>6.6191932795519701</c:v>
                </c:pt>
                <c:pt idx="249">
                  <c:v>6.6457763850923399</c:v>
                </c:pt>
                <c:pt idx="250">
                  <c:v>6.6723594906327088</c:v>
                </c:pt>
                <c:pt idx="251">
                  <c:v>6.6989425961730786</c:v>
                </c:pt>
                <c:pt idx="252">
                  <c:v>6.7255257017134475</c:v>
                </c:pt>
                <c:pt idx="253">
                  <c:v>6.7521088072538173</c:v>
                </c:pt>
                <c:pt idx="254">
                  <c:v>6.7786919127941863</c:v>
                </c:pt>
                <c:pt idx="255">
                  <c:v>6.8052750183345561</c:v>
                </c:pt>
                <c:pt idx="256">
                  <c:v>6.831858123874925</c:v>
                </c:pt>
                <c:pt idx="257">
                  <c:v>6.8584412294152948</c:v>
                </c:pt>
                <c:pt idx="258">
                  <c:v>6.8850243349556637</c:v>
                </c:pt>
                <c:pt idx="259">
                  <c:v>6.9116074404960335</c:v>
                </c:pt>
                <c:pt idx="260">
                  <c:v>6.9381905460364024</c:v>
                </c:pt>
                <c:pt idx="261">
                  <c:v>6.9647736515767722</c:v>
                </c:pt>
                <c:pt idx="262">
                  <c:v>6.9913567571171411</c:v>
                </c:pt>
                <c:pt idx="263">
                  <c:v>7.0179398626575109</c:v>
                </c:pt>
                <c:pt idx="264">
                  <c:v>7.0445229681978798</c:v>
                </c:pt>
                <c:pt idx="265">
                  <c:v>7.0711060737382496</c:v>
                </c:pt>
                <c:pt idx="266">
                  <c:v>7.0976891792786194</c:v>
                </c:pt>
                <c:pt idx="267">
                  <c:v>7.1242722848189883</c:v>
                </c:pt>
                <c:pt idx="268">
                  <c:v>7.1508553903593581</c:v>
                </c:pt>
                <c:pt idx="269">
                  <c:v>7.177438495899727</c:v>
                </c:pt>
                <c:pt idx="270">
                  <c:v>7.2040216014400968</c:v>
                </c:pt>
                <c:pt idx="271">
                  <c:v>7.2306047069804658</c:v>
                </c:pt>
                <c:pt idx="272">
                  <c:v>7.2571878125208356</c:v>
                </c:pt>
                <c:pt idx="273">
                  <c:v>7.2837709180612045</c:v>
                </c:pt>
                <c:pt idx="274">
                  <c:v>7.3103540236015743</c:v>
                </c:pt>
                <c:pt idx="275">
                  <c:v>7.3369371291419432</c:v>
                </c:pt>
                <c:pt idx="276">
                  <c:v>7.363520234682313</c:v>
                </c:pt>
                <c:pt idx="277">
                  <c:v>7.3901033402226819</c:v>
                </c:pt>
                <c:pt idx="278">
                  <c:v>7.4166864457630517</c:v>
                </c:pt>
                <c:pt idx="279">
                  <c:v>7.4432695513034206</c:v>
                </c:pt>
                <c:pt idx="280">
                  <c:v>7.4698526568437904</c:v>
                </c:pt>
                <c:pt idx="281">
                  <c:v>7.4964357623841593</c:v>
                </c:pt>
                <c:pt idx="282">
                  <c:v>7.5230188679245291</c:v>
                </c:pt>
                <c:pt idx="283">
                  <c:v>7.549601973464898</c:v>
                </c:pt>
                <c:pt idx="284">
                  <c:v>7.5761850790052678</c:v>
                </c:pt>
                <c:pt idx="285">
                  <c:v>7.6027681845456367</c:v>
                </c:pt>
                <c:pt idx="286">
                  <c:v>7.6293512900860065</c:v>
                </c:pt>
                <c:pt idx="287">
                  <c:v>7.6559343956263755</c:v>
                </c:pt>
                <c:pt idx="288">
                  <c:v>7.6825175011667453</c:v>
                </c:pt>
                <c:pt idx="289">
                  <c:v>7.7091006067071142</c:v>
                </c:pt>
                <c:pt idx="290">
                  <c:v>7.735683712247484</c:v>
                </c:pt>
                <c:pt idx="291">
                  <c:v>7.7622668177878529</c:v>
                </c:pt>
                <c:pt idx="292">
                  <c:v>7.7888499233282227</c:v>
                </c:pt>
                <c:pt idx="293">
                  <c:v>7.8154330288685916</c:v>
                </c:pt>
                <c:pt idx="294">
                  <c:v>7.8420161344089614</c:v>
                </c:pt>
                <c:pt idx="295">
                  <c:v>7.8685992399493303</c:v>
                </c:pt>
                <c:pt idx="296">
                  <c:v>7.8951823454897001</c:v>
                </c:pt>
                <c:pt idx="297">
                  <c:v>7.921765451030069</c:v>
                </c:pt>
                <c:pt idx="298">
                  <c:v>7.9483485565704388</c:v>
                </c:pt>
                <c:pt idx="299">
                  <c:v>7.9749316621108077</c:v>
                </c:pt>
                <c:pt idx="300">
                  <c:v>8.0015147676511766</c:v>
                </c:pt>
                <c:pt idx="301">
                  <c:v>8.0280978731915464</c:v>
                </c:pt>
                <c:pt idx="302">
                  <c:v>8.0546809787319162</c:v>
                </c:pt>
                <c:pt idx="303">
                  <c:v>8.081264084272286</c:v>
                </c:pt>
                <c:pt idx="304">
                  <c:v>8.1078471898126541</c:v>
                </c:pt>
                <c:pt idx="305">
                  <c:v>8.1344302953530239</c:v>
                </c:pt>
                <c:pt idx="306">
                  <c:v>8.1610134008933937</c:v>
                </c:pt>
                <c:pt idx="307">
                  <c:v>8.1875965064337635</c:v>
                </c:pt>
                <c:pt idx="308">
                  <c:v>8.2141796119741315</c:v>
                </c:pt>
                <c:pt idx="309">
                  <c:v>8.2407627175145013</c:v>
                </c:pt>
                <c:pt idx="310">
                  <c:v>8.2673458230548711</c:v>
                </c:pt>
                <c:pt idx="311">
                  <c:v>8.2939289285952409</c:v>
                </c:pt>
                <c:pt idx="312">
                  <c:v>8.3205120341356089</c:v>
                </c:pt>
                <c:pt idx="313">
                  <c:v>8.3470951396759787</c:v>
                </c:pt>
                <c:pt idx="314">
                  <c:v>8.3736782452163485</c:v>
                </c:pt>
                <c:pt idx="315">
                  <c:v>8.4002613507567183</c:v>
                </c:pt>
                <c:pt idx="316">
                  <c:v>8.4268444562970863</c:v>
                </c:pt>
                <c:pt idx="317">
                  <c:v>8.4534275618374561</c:v>
                </c:pt>
                <c:pt idx="318">
                  <c:v>8.4800106673778259</c:v>
                </c:pt>
                <c:pt idx="319">
                  <c:v>8.5065937729181957</c:v>
                </c:pt>
                <c:pt idx="320">
                  <c:v>8.5331768784585638</c:v>
                </c:pt>
                <c:pt idx="321">
                  <c:v>8.5597599839989336</c:v>
                </c:pt>
                <c:pt idx="322">
                  <c:v>8.5863430895393034</c:v>
                </c:pt>
                <c:pt idx="323">
                  <c:v>8.6129261950796732</c:v>
                </c:pt>
                <c:pt idx="324">
                  <c:v>8.6395093006200412</c:v>
                </c:pt>
                <c:pt idx="325">
                  <c:v>8.666092406160411</c:v>
                </c:pt>
                <c:pt idx="326">
                  <c:v>8.6926755117007808</c:v>
                </c:pt>
                <c:pt idx="327">
                  <c:v>8.7192586172411506</c:v>
                </c:pt>
                <c:pt idx="328">
                  <c:v>8.7458417227815186</c:v>
                </c:pt>
                <c:pt idx="329">
                  <c:v>8.7724248283218884</c:v>
                </c:pt>
                <c:pt idx="330">
                  <c:v>8.7990079338622582</c:v>
                </c:pt>
                <c:pt idx="331">
                  <c:v>8.825591039402628</c:v>
                </c:pt>
                <c:pt idx="332">
                  <c:v>8.852174144942996</c:v>
                </c:pt>
                <c:pt idx="333">
                  <c:v>8.8787572504833658</c:v>
                </c:pt>
                <c:pt idx="334">
                  <c:v>8.9053403560237356</c:v>
                </c:pt>
                <c:pt idx="335">
                  <c:v>8.9319234615641054</c:v>
                </c:pt>
                <c:pt idx="336">
                  <c:v>8.9585065671044735</c:v>
                </c:pt>
                <c:pt idx="337">
                  <c:v>8.9850896726448433</c:v>
                </c:pt>
                <c:pt idx="338">
                  <c:v>9.0116727781852131</c:v>
                </c:pt>
                <c:pt idx="339">
                  <c:v>9.0382558837255829</c:v>
                </c:pt>
                <c:pt idx="340">
                  <c:v>9.0648389892659509</c:v>
                </c:pt>
                <c:pt idx="341">
                  <c:v>9.0914220948063207</c:v>
                </c:pt>
                <c:pt idx="342">
                  <c:v>9.1180052003466905</c:v>
                </c:pt>
                <c:pt idx="343">
                  <c:v>9.1445883058870603</c:v>
                </c:pt>
                <c:pt idx="344">
                  <c:v>9.1711714114274283</c:v>
                </c:pt>
                <c:pt idx="345">
                  <c:v>9.1977545169677981</c:v>
                </c:pt>
                <c:pt idx="346">
                  <c:v>9.2243376225081679</c:v>
                </c:pt>
                <c:pt idx="347">
                  <c:v>9.2509207280485377</c:v>
                </c:pt>
                <c:pt idx="348">
                  <c:v>9.2775038335889057</c:v>
                </c:pt>
                <c:pt idx="349">
                  <c:v>9.3040869391292755</c:v>
                </c:pt>
                <c:pt idx="350">
                  <c:v>9.3306700446696453</c:v>
                </c:pt>
                <c:pt idx="351">
                  <c:v>9.3572531502100151</c:v>
                </c:pt>
                <c:pt idx="352">
                  <c:v>9.3838362557503832</c:v>
                </c:pt>
                <c:pt idx="353">
                  <c:v>9.410419361290753</c:v>
                </c:pt>
                <c:pt idx="354">
                  <c:v>9.4370024668311228</c:v>
                </c:pt>
                <c:pt idx="355">
                  <c:v>9.4635855723714926</c:v>
                </c:pt>
                <c:pt idx="356">
                  <c:v>9.4901686779118606</c:v>
                </c:pt>
                <c:pt idx="357">
                  <c:v>9.5167517834522304</c:v>
                </c:pt>
                <c:pt idx="358">
                  <c:v>9.5433348889926002</c:v>
                </c:pt>
                <c:pt idx="359">
                  <c:v>9.56991799453297</c:v>
                </c:pt>
                <c:pt idx="360">
                  <c:v>9.596501100073338</c:v>
                </c:pt>
                <c:pt idx="361">
                  <c:v>9.6230842056137078</c:v>
                </c:pt>
                <c:pt idx="362">
                  <c:v>9.6496673111540776</c:v>
                </c:pt>
                <c:pt idx="363">
                  <c:v>9.6762504166944474</c:v>
                </c:pt>
                <c:pt idx="364">
                  <c:v>9.7028335222348154</c:v>
                </c:pt>
                <c:pt idx="365">
                  <c:v>9.7294166277751852</c:v>
                </c:pt>
                <c:pt idx="366">
                  <c:v>9.755999733315555</c:v>
                </c:pt>
                <c:pt idx="367">
                  <c:v>9.7825828388559248</c:v>
                </c:pt>
                <c:pt idx="368">
                  <c:v>9.8091659443962929</c:v>
                </c:pt>
                <c:pt idx="369">
                  <c:v>9.8357490499366627</c:v>
                </c:pt>
                <c:pt idx="370">
                  <c:v>9.8623321554770325</c:v>
                </c:pt>
                <c:pt idx="371">
                  <c:v>9.8889152610174023</c:v>
                </c:pt>
                <c:pt idx="372">
                  <c:v>9.9154983665577703</c:v>
                </c:pt>
                <c:pt idx="373">
                  <c:v>9.9420814720981401</c:v>
                </c:pt>
                <c:pt idx="374">
                  <c:v>9.9686645776385099</c:v>
                </c:pt>
                <c:pt idx="375">
                  <c:v>9.9952476831788797</c:v>
                </c:pt>
                <c:pt idx="376">
                  <c:v>10.021830788719248</c:v>
                </c:pt>
                <c:pt idx="377">
                  <c:v>10.048413894259618</c:v>
                </c:pt>
                <c:pt idx="378">
                  <c:v>10.074996999799987</c:v>
                </c:pt>
                <c:pt idx="379">
                  <c:v>10.101580105340357</c:v>
                </c:pt>
                <c:pt idx="380">
                  <c:v>10.128163210880725</c:v>
                </c:pt>
                <c:pt idx="381">
                  <c:v>10.154746316421095</c:v>
                </c:pt>
                <c:pt idx="382">
                  <c:v>10.181329421961465</c:v>
                </c:pt>
                <c:pt idx="383">
                  <c:v>10.207912527501835</c:v>
                </c:pt>
                <c:pt idx="384">
                  <c:v>10.234495633042203</c:v>
                </c:pt>
                <c:pt idx="385">
                  <c:v>10.261078738582572</c:v>
                </c:pt>
                <c:pt idx="386">
                  <c:v>10.287661844122942</c:v>
                </c:pt>
                <c:pt idx="387">
                  <c:v>10.314244949663312</c:v>
                </c:pt>
                <c:pt idx="388">
                  <c:v>10.34082805520368</c:v>
                </c:pt>
                <c:pt idx="389">
                  <c:v>10.36741116074405</c:v>
                </c:pt>
                <c:pt idx="390">
                  <c:v>10.39399426628442</c:v>
                </c:pt>
                <c:pt idx="391">
                  <c:v>10.420577371824789</c:v>
                </c:pt>
                <c:pt idx="392">
                  <c:v>10.447160477365157</c:v>
                </c:pt>
                <c:pt idx="393">
                  <c:v>10.473743582905527</c:v>
                </c:pt>
                <c:pt idx="394">
                  <c:v>10.500326688445897</c:v>
                </c:pt>
                <c:pt idx="395">
                  <c:v>10.526909793986267</c:v>
                </c:pt>
                <c:pt idx="396">
                  <c:v>10.553492899526635</c:v>
                </c:pt>
                <c:pt idx="397">
                  <c:v>10.580076005067005</c:v>
                </c:pt>
                <c:pt idx="398">
                  <c:v>10.606659110607374</c:v>
                </c:pt>
                <c:pt idx="399">
                  <c:v>10.633242216147744</c:v>
                </c:pt>
                <c:pt idx="400">
                  <c:v>10.659825321688114</c:v>
                </c:pt>
                <c:pt idx="401">
                  <c:v>10.686408427228482</c:v>
                </c:pt>
                <c:pt idx="402">
                  <c:v>10.712991532768852</c:v>
                </c:pt>
                <c:pt idx="403">
                  <c:v>10.739574638309222</c:v>
                </c:pt>
                <c:pt idx="404">
                  <c:v>10.766157743849591</c:v>
                </c:pt>
                <c:pt idx="405">
                  <c:v>10.792740849389959</c:v>
                </c:pt>
                <c:pt idx="406">
                  <c:v>10.819323954930329</c:v>
                </c:pt>
                <c:pt idx="407">
                  <c:v>10.845907060470699</c:v>
                </c:pt>
                <c:pt idx="408">
                  <c:v>10.872490166011069</c:v>
                </c:pt>
                <c:pt idx="409">
                  <c:v>10.899073271551437</c:v>
                </c:pt>
                <c:pt idx="410">
                  <c:v>10.925656377091807</c:v>
                </c:pt>
                <c:pt idx="411">
                  <c:v>10.952239482632177</c:v>
                </c:pt>
                <c:pt idx="412">
                  <c:v>10.978822588172546</c:v>
                </c:pt>
                <c:pt idx="413">
                  <c:v>11.005405693712914</c:v>
                </c:pt>
                <c:pt idx="414">
                  <c:v>11.031988799253284</c:v>
                </c:pt>
                <c:pt idx="415">
                  <c:v>11.058571904793654</c:v>
                </c:pt>
                <c:pt idx="416">
                  <c:v>11.085155010334024</c:v>
                </c:pt>
                <c:pt idx="417">
                  <c:v>11.111738115874392</c:v>
                </c:pt>
                <c:pt idx="418">
                  <c:v>11.138321221414762</c:v>
                </c:pt>
                <c:pt idx="419">
                  <c:v>11.164904326955131</c:v>
                </c:pt>
                <c:pt idx="420">
                  <c:v>11.191487432495501</c:v>
                </c:pt>
                <c:pt idx="421">
                  <c:v>11.218070538035869</c:v>
                </c:pt>
                <c:pt idx="422">
                  <c:v>11.244653643576239</c:v>
                </c:pt>
                <c:pt idx="423">
                  <c:v>11.271236749116609</c:v>
                </c:pt>
                <c:pt idx="424">
                  <c:v>11.297819854656979</c:v>
                </c:pt>
                <c:pt idx="425">
                  <c:v>11.324402960197347</c:v>
                </c:pt>
                <c:pt idx="426">
                  <c:v>11.350986065737716</c:v>
                </c:pt>
                <c:pt idx="427">
                  <c:v>11.377569171278086</c:v>
                </c:pt>
                <c:pt idx="428">
                  <c:v>11.404152276818456</c:v>
                </c:pt>
                <c:pt idx="429">
                  <c:v>11.430735382358824</c:v>
                </c:pt>
                <c:pt idx="430">
                  <c:v>11.457318487899194</c:v>
                </c:pt>
                <c:pt idx="431">
                  <c:v>11.483901593439564</c:v>
                </c:pt>
                <c:pt idx="432">
                  <c:v>11.510484698979933</c:v>
                </c:pt>
                <c:pt idx="433">
                  <c:v>11.537067804520301</c:v>
                </c:pt>
                <c:pt idx="434">
                  <c:v>11.563650910060671</c:v>
                </c:pt>
                <c:pt idx="435">
                  <c:v>11.590234015601041</c:v>
                </c:pt>
                <c:pt idx="436">
                  <c:v>11.616817121141411</c:v>
                </c:pt>
                <c:pt idx="437">
                  <c:v>11.643400226681779</c:v>
                </c:pt>
                <c:pt idx="438">
                  <c:v>11.669983332222149</c:v>
                </c:pt>
                <c:pt idx="439">
                  <c:v>11.696566437762518</c:v>
                </c:pt>
                <c:pt idx="440">
                  <c:v>11.723149543302888</c:v>
                </c:pt>
                <c:pt idx="441">
                  <c:v>11.749732648843256</c:v>
                </c:pt>
                <c:pt idx="442">
                  <c:v>11.776315754383626</c:v>
                </c:pt>
                <c:pt idx="443">
                  <c:v>11.802898859923996</c:v>
                </c:pt>
                <c:pt idx="444">
                  <c:v>11.829481965464366</c:v>
                </c:pt>
                <c:pt idx="445">
                  <c:v>11.856065071004734</c:v>
                </c:pt>
                <c:pt idx="446">
                  <c:v>11.882648176545104</c:v>
                </c:pt>
                <c:pt idx="447">
                  <c:v>11.909231282085473</c:v>
                </c:pt>
                <c:pt idx="448">
                  <c:v>11.935814387625843</c:v>
                </c:pt>
                <c:pt idx="449">
                  <c:v>11.962397493166211</c:v>
                </c:pt>
                <c:pt idx="450">
                  <c:v>11.988980598706581</c:v>
                </c:pt>
                <c:pt idx="451">
                  <c:v>12.015563704246951</c:v>
                </c:pt>
                <c:pt idx="452">
                  <c:v>12.042146809787321</c:v>
                </c:pt>
                <c:pt idx="453">
                  <c:v>12.068729915327689</c:v>
                </c:pt>
                <c:pt idx="454">
                  <c:v>12.095313020868058</c:v>
                </c:pt>
                <c:pt idx="455">
                  <c:v>12.121896126408428</c:v>
                </c:pt>
                <c:pt idx="456">
                  <c:v>12.148479231948798</c:v>
                </c:pt>
                <c:pt idx="457">
                  <c:v>12.175062337489166</c:v>
                </c:pt>
                <c:pt idx="458">
                  <c:v>12.201645443029536</c:v>
                </c:pt>
                <c:pt idx="459">
                  <c:v>12.228228548569906</c:v>
                </c:pt>
                <c:pt idx="460">
                  <c:v>12.254811654110275</c:v>
                </c:pt>
                <c:pt idx="461">
                  <c:v>12.281394759650643</c:v>
                </c:pt>
                <c:pt idx="462">
                  <c:v>12.307977865191013</c:v>
                </c:pt>
                <c:pt idx="463">
                  <c:v>12.334560970731383</c:v>
                </c:pt>
                <c:pt idx="464">
                  <c:v>12.361144076271753</c:v>
                </c:pt>
                <c:pt idx="465">
                  <c:v>12.387727181812121</c:v>
                </c:pt>
                <c:pt idx="466">
                  <c:v>12.414310287352491</c:v>
                </c:pt>
                <c:pt idx="467">
                  <c:v>12.44089339289286</c:v>
                </c:pt>
                <c:pt idx="468">
                  <c:v>12.46747649843323</c:v>
                </c:pt>
                <c:pt idx="469">
                  <c:v>12.494059603973598</c:v>
                </c:pt>
                <c:pt idx="470">
                  <c:v>12.520642709513968</c:v>
                </c:pt>
                <c:pt idx="471">
                  <c:v>12.547225815054338</c:v>
                </c:pt>
                <c:pt idx="472">
                  <c:v>12.573808920594708</c:v>
                </c:pt>
                <c:pt idx="473">
                  <c:v>12.600392026135076</c:v>
                </c:pt>
                <c:pt idx="474">
                  <c:v>12.626975131675445</c:v>
                </c:pt>
                <c:pt idx="475">
                  <c:v>12.653558237215815</c:v>
                </c:pt>
                <c:pt idx="476">
                  <c:v>12.680141342756185</c:v>
                </c:pt>
                <c:pt idx="477">
                  <c:v>12.706724448296553</c:v>
                </c:pt>
                <c:pt idx="478">
                  <c:v>12.733307553836923</c:v>
                </c:pt>
                <c:pt idx="479">
                  <c:v>12.759890659377293</c:v>
                </c:pt>
                <c:pt idx="480">
                  <c:v>12.786473764917663</c:v>
                </c:pt>
                <c:pt idx="481">
                  <c:v>12.813056870458031</c:v>
                </c:pt>
                <c:pt idx="482">
                  <c:v>12.8396399759984</c:v>
                </c:pt>
                <c:pt idx="483">
                  <c:v>12.86622308153877</c:v>
                </c:pt>
                <c:pt idx="484">
                  <c:v>12.89280618707914</c:v>
                </c:pt>
                <c:pt idx="485">
                  <c:v>12.919389292619508</c:v>
                </c:pt>
                <c:pt idx="486">
                  <c:v>12.945972398159878</c:v>
                </c:pt>
                <c:pt idx="487">
                  <c:v>12.972555503700248</c:v>
                </c:pt>
                <c:pt idx="488">
                  <c:v>12.999138609240617</c:v>
                </c:pt>
                <c:pt idx="489">
                  <c:v>13.025721714780985</c:v>
                </c:pt>
                <c:pt idx="490">
                  <c:v>13.052304820321355</c:v>
                </c:pt>
                <c:pt idx="491">
                  <c:v>13.078887925861725</c:v>
                </c:pt>
                <c:pt idx="492">
                  <c:v>13.105471031402095</c:v>
                </c:pt>
                <c:pt idx="493">
                  <c:v>13.132054136942463</c:v>
                </c:pt>
                <c:pt idx="494">
                  <c:v>13.158637242482833</c:v>
                </c:pt>
                <c:pt idx="495">
                  <c:v>13.185220348023202</c:v>
                </c:pt>
                <c:pt idx="496">
                  <c:v>13.211803453563572</c:v>
                </c:pt>
                <c:pt idx="497">
                  <c:v>13.23838655910394</c:v>
                </c:pt>
                <c:pt idx="498">
                  <c:v>13.26496966464431</c:v>
                </c:pt>
                <c:pt idx="499">
                  <c:v>13.29155277018468</c:v>
                </c:pt>
                <c:pt idx="500">
                  <c:v>13.31813587572505</c:v>
                </c:pt>
                <c:pt idx="501">
                  <c:v>13.344718981265418</c:v>
                </c:pt>
                <c:pt idx="502">
                  <c:v>13.371302086805787</c:v>
                </c:pt>
                <c:pt idx="503">
                  <c:v>13.397885192346157</c:v>
                </c:pt>
                <c:pt idx="504">
                  <c:v>13.424468297886527</c:v>
                </c:pt>
                <c:pt idx="505">
                  <c:v>13.451051403426895</c:v>
                </c:pt>
                <c:pt idx="506">
                  <c:v>13.477634508967265</c:v>
                </c:pt>
                <c:pt idx="507">
                  <c:v>13.504217614507635</c:v>
                </c:pt>
                <c:pt idx="508">
                  <c:v>13.530800720048004</c:v>
                </c:pt>
                <c:pt idx="509">
                  <c:v>13.557383825588373</c:v>
                </c:pt>
                <c:pt idx="510">
                  <c:v>13.583966931128742</c:v>
                </c:pt>
                <c:pt idx="511">
                  <c:v>13.610550036669112</c:v>
                </c:pt>
                <c:pt idx="512">
                  <c:v>13.637133142209482</c:v>
                </c:pt>
                <c:pt idx="513">
                  <c:v>13.66371624774985</c:v>
                </c:pt>
                <c:pt idx="514">
                  <c:v>13.69029935329022</c:v>
                </c:pt>
                <c:pt idx="515">
                  <c:v>13.71688245883059</c:v>
                </c:pt>
                <c:pt idx="516">
                  <c:v>13.743465564370959</c:v>
                </c:pt>
                <c:pt idx="517">
                  <c:v>13.770048669911327</c:v>
                </c:pt>
                <c:pt idx="518">
                  <c:v>13.796631775451697</c:v>
                </c:pt>
                <c:pt idx="519">
                  <c:v>13.823214880992067</c:v>
                </c:pt>
                <c:pt idx="520">
                  <c:v>13.849797986532437</c:v>
                </c:pt>
                <c:pt idx="521">
                  <c:v>13.876381092072805</c:v>
                </c:pt>
                <c:pt idx="522">
                  <c:v>13.902964197613175</c:v>
                </c:pt>
                <c:pt idx="523">
                  <c:v>13.929547303153544</c:v>
                </c:pt>
                <c:pt idx="524">
                  <c:v>13.956130408693914</c:v>
                </c:pt>
                <c:pt idx="525">
                  <c:v>13.982713514234282</c:v>
                </c:pt>
                <c:pt idx="526">
                  <c:v>14.009296619774652</c:v>
                </c:pt>
                <c:pt idx="527">
                  <c:v>14.035879725315022</c:v>
                </c:pt>
                <c:pt idx="528">
                  <c:v>14.062462830855392</c:v>
                </c:pt>
                <c:pt idx="529">
                  <c:v>14.08904593639576</c:v>
                </c:pt>
                <c:pt idx="530">
                  <c:v>14.115629041936129</c:v>
                </c:pt>
                <c:pt idx="531">
                  <c:v>14.142212147476499</c:v>
                </c:pt>
                <c:pt idx="532">
                  <c:v>14.168795253016869</c:v>
                </c:pt>
                <c:pt idx="533">
                  <c:v>14.195378358557239</c:v>
                </c:pt>
                <c:pt idx="534">
                  <c:v>14.221961464097607</c:v>
                </c:pt>
                <c:pt idx="535">
                  <c:v>14.248544569637977</c:v>
                </c:pt>
                <c:pt idx="536">
                  <c:v>14.275127675178346</c:v>
                </c:pt>
                <c:pt idx="537">
                  <c:v>14.301710780718716</c:v>
                </c:pt>
                <c:pt idx="538">
                  <c:v>14.328293886259084</c:v>
                </c:pt>
                <c:pt idx="539">
                  <c:v>14.354876991799454</c:v>
                </c:pt>
                <c:pt idx="540">
                  <c:v>14.381460097339824</c:v>
                </c:pt>
                <c:pt idx="541">
                  <c:v>14.408043202880194</c:v>
                </c:pt>
                <c:pt idx="542">
                  <c:v>14.434626308420562</c:v>
                </c:pt>
                <c:pt idx="543">
                  <c:v>14.461209413960932</c:v>
                </c:pt>
                <c:pt idx="544">
                  <c:v>14.487792519501301</c:v>
                </c:pt>
                <c:pt idx="545">
                  <c:v>14.514375625041671</c:v>
                </c:pt>
                <c:pt idx="546">
                  <c:v>14.540958730582039</c:v>
                </c:pt>
                <c:pt idx="547">
                  <c:v>14.567541836122409</c:v>
                </c:pt>
                <c:pt idx="548">
                  <c:v>14.594124941662779</c:v>
                </c:pt>
                <c:pt idx="549">
                  <c:v>14.620708047203149</c:v>
                </c:pt>
                <c:pt idx="550">
                  <c:v>14.647291152743517</c:v>
                </c:pt>
                <c:pt idx="551">
                  <c:v>14.673874258283886</c:v>
                </c:pt>
                <c:pt idx="552">
                  <c:v>14.700457363824256</c:v>
                </c:pt>
                <c:pt idx="553">
                  <c:v>14.727040469364626</c:v>
                </c:pt>
                <c:pt idx="554">
                  <c:v>14.753623574904994</c:v>
                </c:pt>
                <c:pt idx="555">
                  <c:v>14.780206680445364</c:v>
                </c:pt>
                <c:pt idx="556">
                  <c:v>14.806789785985734</c:v>
                </c:pt>
                <c:pt idx="557">
                  <c:v>14.833372891526103</c:v>
                </c:pt>
                <c:pt idx="558">
                  <c:v>14.859955997066471</c:v>
                </c:pt>
                <c:pt idx="559">
                  <c:v>14.886539102606841</c:v>
                </c:pt>
                <c:pt idx="560">
                  <c:v>14.913122208147211</c:v>
                </c:pt>
                <c:pt idx="561">
                  <c:v>14.939705313687581</c:v>
                </c:pt>
                <c:pt idx="562">
                  <c:v>14.966288419227949</c:v>
                </c:pt>
                <c:pt idx="563">
                  <c:v>14.992871524768319</c:v>
                </c:pt>
                <c:pt idx="564">
                  <c:v>15.019454630308688</c:v>
                </c:pt>
                <c:pt idx="565">
                  <c:v>15.046037735849058</c:v>
                </c:pt>
                <c:pt idx="566">
                  <c:v>15.072620841389426</c:v>
                </c:pt>
                <c:pt idx="567">
                  <c:v>15.099203946929796</c:v>
                </c:pt>
                <c:pt idx="568">
                  <c:v>15.125787052470166</c:v>
                </c:pt>
                <c:pt idx="569">
                  <c:v>15.152370158010536</c:v>
                </c:pt>
                <c:pt idx="570">
                  <c:v>15.178953263550904</c:v>
                </c:pt>
                <c:pt idx="571">
                  <c:v>15.205536369091273</c:v>
                </c:pt>
                <c:pt idx="572">
                  <c:v>15.232119474631643</c:v>
                </c:pt>
                <c:pt idx="573">
                  <c:v>15.258702580172013</c:v>
                </c:pt>
                <c:pt idx="574">
                  <c:v>15.285285685712381</c:v>
                </c:pt>
                <c:pt idx="575">
                  <c:v>15.311868791252751</c:v>
                </c:pt>
                <c:pt idx="576">
                  <c:v>15.338451896793121</c:v>
                </c:pt>
                <c:pt idx="577">
                  <c:v>15.365035002333491</c:v>
                </c:pt>
                <c:pt idx="578">
                  <c:v>15.391618107873859</c:v>
                </c:pt>
                <c:pt idx="579">
                  <c:v>15.418201213414228</c:v>
                </c:pt>
                <c:pt idx="580">
                  <c:v>15.444784318954598</c:v>
                </c:pt>
                <c:pt idx="581">
                  <c:v>15.471367424494968</c:v>
                </c:pt>
                <c:pt idx="582">
                  <c:v>15.497950530035336</c:v>
                </c:pt>
                <c:pt idx="583">
                  <c:v>15.524533635575706</c:v>
                </c:pt>
                <c:pt idx="584">
                  <c:v>15.551116741116076</c:v>
                </c:pt>
                <c:pt idx="585">
                  <c:v>15.577699846656445</c:v>
                </c:pt>
                <c:pt idx="586">
                  <c:v>15.604282952196813</c:v>
                </c:pt>
                <c:pt idx="587">
                  <c:v>15.630866057737183</c:v>
                </c:pt>
                <c:pt idx="588">
                  <c:v>15.657449163277553</c:v>
                </c:pt>
                <c:pt idx="589">
                  <c:v>15.684032268817923</c:v>
                </c:pt>
                <c:pt idx="590">
                  <c:v>15.710615374358291</c:v>
                </c:pt>
                <c:pt idx="591">
                  <c:v>15.737198479898661</c:v>
                </c:pt>
                <c:pt idx="592">
                  <c:v>15.76378158543903</c:v>
                </c:pt>
                <c:pt idx="593">
                  <c:v>15.7903646909794</c:v>
                </c:pt>
                <c:pt idx="594">
                  <c:v>15.816947796519768</c:v>
                </c:pt>
                <c:pt idx="595">
                  <c:v>15.843530902060138</c:v>
                </c:pt>
                <c:pt idx="596">
                  <c:v>15.870114007600508</c:v>
                </c:pt>
                <c:pt idx="597">
                  <c:v>15.896697113140878</c:v>
                </c:pt>
                <c:pt idx="598">
                  <c:v>15.923280218681246</c:v>
                </c:pt>
                <c:pt idx="599">
                  <c:v>15.949863324221615</c:v>
                </c:pt>
                <c:pt idx="600">
                  <c:v>15.976446429761985</c:v>
                </c:pt>
                <c:pt idx="601">
                  <c:v>16.003029535302353</c:v>
                </c:pt>
                <c:pt idx="602">
                  <c:v>16.029612640842725</c:v>
                </c:pt>
                <c:pt idx="603">
                  <c:v>16.056195746383093</c:v>
                </c:pt>
                <c:pt idx="604">
                  <c:v>16.082778851923461</c:v>
                </c:pt>
                <c:pt idx="605">
                  <c:v>16.109361957463832</c:v>
                </c:pt>
                <c:pt idx="606">
                  <c:v>16.135945063004201</c:v>
                </c:pt>
                <c:pt idx="607">
                  <c:v>16.162528168544572</c:v>
                </c:pt>
                <c:pt idx="608">
                  <c:v>16.18911127408494</c:v>
                </c:pt>
                <c:pt idx="609">
                  <c:v>16.215694379625308</c:v>
                </c:pt>
                <c:pt idx="610">
                  <c:v>16.24227748516568</c:v>
                </c:pt>
                <c:pt idx="611">
                  <c:v>16.268860590706048</c:v>
                </c:pt>
                <c:pt idx="612">
                  <c:v>16.295443696246416</c:v>
                </c:pt>
                <c:pt idx="613">
                  <c:v>16.322026801786787</c:v>
                </c:pt>
                <c:pt idx="614">
                  <c:v>16.348609907327155</c:v>
                </c:pt>
                <c:pt idx="615">
                  <c:v>16.375193012867527</c:v>
                </c:pt>
                <c:pt idx="616">
                  <c:v>16.401776118407895</c:v>
                </c:pt>
                <c:pt idx="617">
                  <c:v>16.428359223948263</c:v>
                </c:pt>
                <c:pt idx="618">
                  <c:v>16.454942329488635</c:v>
                </c:pt>
                <c:pt idx="619">
                  <c:v>16.481525435029003</c:v>
                </c:pt>
                <c:pt idx="620">
                  <c:v>16.508108540569371</c:v>
                </c:pt>
                <c:pt idx="621">
                  <c:v>16.534691646109742</c:v>
                </c:pt>
                <c:pt idx="622">
                  <c:v>16.56127475165011</c:v>
                </c:pt>
                <c:pt idx="623">
                  <c:v>16.587857857190482</c:v>
                </c:pt>
                <c:pt idx="624">
                  <c:v>16.61444096273085</c:v>
                </c:pt>
                <c:pt idx="625">
                  <c:v>16.641024068271218</c:v>
                </c:pt>
                <c:pt idx="626">
                  <c:v>16.667607173811589</c:v>
                </c:pt>
                <c:pt idx="627">
                  <c:v>16.694190279351957</c:v>
                </c:pt>
                <c:pt idx="628">
                  <c:v>16.720773384892325</c:v>
                </c:pt>
                <c:pt idx="629">
                  <c:v>16.747356490432697</c:v>
                </c:pt>
                <c:pt idx="630">
                  <c:v>16.773939595973065</c:v>
                </c:pt>
                <c:pt idx="631">
                  <c:v>16.800522701513437</c:v>
                </c:pt>
                <c:pt idx="632">
                  <c:v>16.827105807053805</c:v>
                </c:pt>
                <c:pt idx="633">
                  <c:v>16.853688912594173</c:v>
                </c:pt>
                <c:pt idx="634">
                  <c:v>16.880272018134544</c:v>
                </c:pt>
                <c:pt idx="635">
                  <c:v>16.906855123674912</c:v>
                </c:pt>
                <c:pt idx="636">
                  <c:v>16.93343822921528</c:v>
                </c:pt>
                <c:pt idx="637">
                  <c:v>16.960021334755652</c:v>
                </c:pt>
                <c:pt idx="638">
                  <c:v>16.98660444029602</c:v>
                </c:pt>
                <c:pt idx="639">
                  <c:v>17.013187545836391</c:v>
                </c:pt>
                <c:pt idx="640">
                  <c:v>17.03977065137676</c:v>
                </c:pt>
                <c:pt idx="641">
                  <c:v>17.066353756917128</c:v>
                </c:pt>
                <c:pt idx="642">
                  <c:v>17.092936862457499</c:v>
                </c:pt>
                <c:pt idx="643">
                  <c:v>17.119519967997867</c:v>
                </c:pt>
                <c:pt idx="644">
                  <c:v>17.146103073538235</c:v>
                </c:pt>
                <c:pt idx="645">
                  <c:v>17.172686179078607</c:v>
                </c:pt>
                <c:pt idx="646">
                  <c:v>17.199269284618975</c:v>
                </c:pt>
                <c:pt idx="647">
                  <c:v>17.225852390159346</c:v>
                </c:pt>
                <c:pt idx="648">
                  <c:v>17.252435495699714</c:v>
                </c:pt>
                <c:pt idx="649">
                  <c:v>17.279018601240082</c:v>
                </c:pt>
                <c:pt idx="650">
                  <c:v>17.305601706780454</c:v>
                </c:pt>
                <c:pt idx="651">
                  <c:v>17.332184812320822</c:v>
                </c:pt>
                <c:pt idx="652">
                  <c:v>17.35876791786119</c:v>
                </c:pt>
                <c:pt idx="653">
                  <c:v>17.385351023401562</c:v>
                </c:pt>
                <c:pt idx="654">
                  <c:v>17.41193412894193</c:v>
                </c:pt>
                <c:pt idx="655">
                  <c:v>17.438517234482301</c:v>
                </c:pt>
                <c:pt idx="656">
                  <c:v>17.465100340022669</c:v>
                </c:pt>
                <c:pt idx="657">
                  <c:v>17.491683445563037</c:v>
                </c:pt>
                <c:pt idx="658">
                  <c:v>17.518266551103409</c:v>
                </c:pt>
                <c:pt idx="659">
                  <c:v>17.544849656643777</c:v>
                </c:pt>
                <c:pt idx="660">
                  <c:v>17.571432762184145</c:v>
                </c:pt>
                <c:pt idx="661">
                  <c:v>17.598015867724516</c:v>
                </c:pt>
                <c:pt idx="662">
                  <c:v>17.624598973264884</c:v>
                </c:pt>
                <c:pt idx="663">
                  <c:v>17.651182078805256</c:v>
                </c:pt>
                <c:pt idx="664">
                  <c:v>17.677765184345624</c:v>
                </c:pt>
                <c:pt idx="665">
                  <c:v>17.704348289885992</c:v>
                </c:pt>
                <c:pt idx="666">
                  <c:v>17.730931395426364</c:v>
                </c:pt>
                <c:pt idx="667">
                  <c:v>17.757514500966732</c:v>
                </c:pt>
                <c:pt idx="668">
                  <c:v>17.784097606507103</c:v>
                </c:pt>
                <c:pt idx="669">
                  <c:v>17.810680712047471</c:v>
                </c:pt>
                <c:pt idx="670">
                  <c:v>17.837263817587839</c:v>
                </c:pt>
                <c:pt idx="671">
                  <c:v>17.863846923128211</c:v>
                </c:pt>
                <c:pt idx="672">
                  <c:v>17.890430028668579</c:v>
                </c:pt>
                <c:pt idx="673">
                  <c:v>17.917013134208947</c:v>
                </c:pt>
                <c:pt idx="674">
                  <c:v>17.943596239749318</c:v>
                </c:pt>
                <c:pt idx="675">
                  <c:v>17.970179345289687</c:v>
                </c:pt>
                <c:pt idx="676">
                  <c:v>17.996762450830058</c:v>
                </c:pt>
                <c:pt idx="677">
                  <c:v>18.023345556370426</c:v>
                </c:pt>
                <c:pt idx="678">
                  <c:v>18.049928661910794</c:v>
                </c:pt>
                <c:pt idx="679">
                  <c:v>18.076511767451166</c:v>
                </c:pt>
                <c:pt idx="680">
                  <c:v>18.103094872991534</c:v>
                </c:pt>
                <c:pt idx="681">
                  <c:v>18.129677978531902</c:v>
                </c:pt>
                <c:pt idx="682">
                  <c:v>18.156261084072273</c:v>
                </c:pt>
                <c:pt idx="683">
                  <c:v>18.182844189612641</c:v>
                </c:pt>
                <c:pt idx="684">
                  <c:v>18.209427295153013</c:v>
                </c:pt>
                <c:pt idx="685">
                  <c:v>18.236010400693381</c:v>
                </c:pt>
                <c:pt idx="686">
                  <c:v>18.262593506233749</c:v>
                </c:pt>
                <c:pt idx="687">
                  <c:v>18.289176611774121</c:v>
                </c:pt>
                <c:pt idx="688">
                  <c:v>18.315759717314489</c:v>
                </c:pt>
                <c:pt idx="689">
                  <c:v>18.342342822854857</c:v>
                </c:pt>
                <c:pt idx="690">
                  <c:v>18.368925928395228</c:v>
                </c:pt>
                <c:pt idx="691">
                  <c:v>18.395509033935596</c:v>
                </c:pt>
                <c:pt idx="692">
                  <c:v>18.422092139475968</c:v>
                </c:pt>
                <c:pt idx="693">
                  <c:v>18.448675245016336</c:v>
                </c:pt>
                <c:pt idx="694">
                  <c:v>18.475258350556704</c:v>
                </c:pt>
                <c:pt idx="695">
                  <c:v>18.501841456097075</c:v>
                </c:pt>
                <c:pt idx="696">
                  <c:v>18.528424561637443</c:v>
                </c:pt>
                <c:pt idx="697">
                  <c:v>18.555007667177811</c:v>
                </c:pt>
                <c:pt idx="698">
                  <c:v>18.581590772718183</c:v>
                </c:pt>
                <c:pt idx="699">
                  <c:v>18.608173878258551</c:v>
                </c:pt>
                <c:pt idx="700">
                  <c:v>18.634756983798923</c:v>
                </c:pt>
                <c:pt idx="701">
                  <c:v>18.661340089339291</c:v>
                </c:pt>
                <c:pt idx="702">
                  <c:v>18.687923194879659</c:v>
                </c:pt>
                <c:pt idx="703">
                  <c:v>18.71450630042003</c:v>
                </c:pt>
                <c:pt idx="704">
                  <c:v>18.741089405960398</c:v>
                </c:pt>
                <c:pt idx="705">
                  <c:v>18.767672511500766</c:v>
                </c:pt>
                <c:pt idx="706">
                  <c:v>18.794255617041138</c:v>
                </c:pt>
                <c:pt idx="707">
                  <c:v>18.820838722581506</c:v>
                </c:pt>
                <c:pt idx="708">
                  <c:v>18.847421828121877</c:v>
                </c:pt>
                <c:pt idx="709">
                  <c:v>18.874004933662246</c:v>
                </c:pt>
                <c:pt idx="710">
                  <c:v>18.900588039202614</c:v>
                </c:pt>
                <c:pt idx="711">
                  <c:v>18.927171144742985</c:v>
                </c:pt>
                <c:pt idx="712">
                  <c:v>18.953754250283353</c:v>
                </c:pt>
                <c:pt idx="713">
                  <c:v>18.980337355823721</c:v>
                </c:pt>
                <c:pt idx="714">
                  <c:v>19.006920461364093</c:v>
                </c:pt>
                <c:pt idx="715">
                  <c:v>19.033503566904461</c:v>
                </c:pt>
                <c:pt idx="716">
                  <c:v>19.060086672444832</c:v>
                </c:pt>
                <c:pt idx="717">
                  <c:v>19.0866697779852</c:v>
                </c:pt>
                <c:pt idx="718">
                  <c:v>19.113252883525568</c:v>
                </c:pt>
                <c:pt idx="719">
                  <c:v>19.13983598906594</c:v>
                </c:pt>
                <c:pt idx="720">
                  <c:v>19.166419094606308</c:v>
                </c:pt>
                <c:pt idx="721">
                  <c:v>19.193002200146676</c:v>
                </c:pt>
                <c:pt idx="722">
                  <c:v>19.219585305687048</c:v>
                </c:pt>
                <c:pt idx="723">
                  <c:v>19.246168411227416</c:v>
                </c:pt>
                <c:pt idx="724">
                  <c:v>19.272751516767787</c:v>
                </c:pt>
                <c:pt idx="725">
                  <c:v>19.299334622308155</c:v>
                </c:pt>
                <c:pt idx="726">
                  <c:v>19.325917727848523</c:v>
                </c:pt>
                <c:pt idx="727">
                  <c:v>19.352500833388895</c:v>
                </c:pt>
                <c:pt idx="728">
                  <c:v>19.379083938929263</c:v>
                </c:pt>
                <c:pt idx="729">
                  <c:v>19.405667044469631</c:v>
                </c:pt>
                <c:pt idx="730">
                  <c:v>19.432250150010002</c:v>
                </c:pt>
                <c:pt idx="731">
                  <c:v>19.45883325555037</c:v>
                </c:pt>
                <c:pt idx="732">
                  <c:v>19.485416361090742</c:v>
                </c:pt>
                <c:pt idx="733">
                  <c:v>19.51199946663111</c:v>
                </c:pt>
                <c:pt idx="734">
                  <c:v>19.538582572171478</c:v>
                </c:pt>
                <c:pt idx="735">
                  <c:v>19.56516567771185</c:v>
                </c:pt>
                <c:pt idx="736">
                  <c:v>19.591748783252218</c:v>
                </c:pt>
                <c:pt idx="737">
                  <c:v>19.618331888792586</c:v>
                </c:pt>
                <c:pt idx="738">
                  <c:v>19.644914994332957</c:v>
                </c:pt>
                <c:pt idx="739">
                  <c:v>19.671498099873325</c:v>
                </c:pt>
                <c:pt idx="740">
                  <c:v>19.698081205413697</c:v>
                </c:pt>
                <c:pt idx="741">
                  <c:v>19.724664310954065</c:v>
                </c:pt>
                <c:pt idx="742">
                  <c:v>19.751247416494433</c:v>
                </c:pt>
                <c:pt idx="743">
                  <c:v>19.777830522034805</c:v>
                </c:pt>
                <c:pt idx="744">
                  <c:v>19.804413627575173</c:v>
                </c:pt>
                <c:pt idx="745">
                  <c:v>19.830996733115541</c:v>
                </c:pt>
                <c:pt idx="746">
                  <c:v>19.857579838655912</c:v>
                </c:pt>
                <c:pt idx="747">
                  <c:v>19.88416294419628</c:v>
                </c:pt>
                <c:pt idx="748">
                  <c:v>19.910746049736652</c:v>
                </c:pt>
                <c:pt idx="749">
                  <c:v>19.93732915527702</c:v>
                </c:pt>
                <c:pt idx="750">
                  <c:v>19.963912260817388</c:v>
                </c:pt>
                <c:pt idx="751">
                  <c:v>19.990495366357759</c:v>
                </c:pt>
                <c:pt idx="752">
                  <c:v>20.017078471898127</c:v>
                </c:pt>
                <c:pt idx="753">
                  <c:v>20.043661577438495</c:v>
                </c:pt>
                <c:pt idx="754">
                  <c:v>20.070244682978867</c:v>
                </c:pt>
                <c:pt idx="755">
                  <c:v>20.096827788519235</c:v>
                </c:pt>
                <c:pt idx="756">
                  <c:v>20.123410894059607</c:v>
                </c:pt>
                <c:pt idx="757">
                  <c:v>20.149993999599975</c:v>
                </c:pt>
                <c:pt idx="758">
                  <c:v>20.176577105140343</c:v>
                </c:pt>
                <c:pt idx="759">
                  <c:v>20.203160210680714</c:v>
                </c:pt>
                <c:pt idx="760">
                  <c:v>20.229743316221082</c:v>
                </c:pt>
                <c:pt idx="761">
                  <c:v>20.25632642176145</c:v>
                </c:pt>
                <c:pt idx="762">
                  <c:v>20.282909527301822</c:v>
                </c:pt>
                <c:pt idx="763">
                  <c:v>20.30949263284219</c:v>
                </c:pt>
                <c:pt idx="764">
                  <c:v>20.336075738382561</c:v>
                </c:pt>
                <c:pt idx="765">
                  <c:v>20.362658843922929</c:v>
                </c:pt>
                <c:pt idx="766">
                  <c:v>20.389241949463297</c:v>
                </c:pt>
                <c:pt idx="767">
                  <c:v>20.415825055003669</c:v>
                </c:pt>
                <c:pt idx="768">
                  <c:v>20.442408160544037</c:v>
                </c:pt>
                <c:pt idx="769">
                  <c:v>20.468991266084405</c:v>
                </c:pt>
                <c:pt idx="770">
                  <c:v>20.495574371624777</c:v>
                </c:pt>
                <c:pt idx="771">
                  <c:v>20.522157477165145</c:v>
                </c:pt>
                <c:pt idx="772">
                  <c:v>20.548740582705516</c:v>
                </c:pt>
                <c:pt idx="773">
                  <c:v>20.575323688245884</c:v>
                </c:pt>
                <c:pt idx="774">
                  <c:v>20.601906793786252</c:v>
                </c:pt>
                <c:pt idx="775">
                  <c:v>20.628489899326624</c:v>
                </c:pt>
                <c:pt idx="776">
                  <c:v>20.655073004866992</c:v>
                </c:pt>
                <c:pt idx="777">
                  <c:v>20.68165611040736</c:v>
                </c:pt>
                <c:pt idx="778">
                  <c:v>20.708239215947732</c:v>
                </c:pt>
                <c:pt idx="779">
                  <c:v>20.7348223214881</c:v>
                </c:pt>
                <c:pt idx="780">
                  <c:v>20.761405427028471</c:v>
                </c:pt>
                <c:pt idx="781">
                  <c:v>20.787988532568839</c:v>
                </c:pt>
                <c:pt idx="782">
                  <c:v>20.814571638109207</c:v>
                </c:pt>
                <c:pt idx="783">
                  <c:v>20.841154743649579</c:v>
                </c:pt>
                <c:pt idx="784">
                  <c:v>20.867737849189947</c:v>
                </c:pt>
                <c:pt idx="785">
                  <c:v>20.894320954730315</c:v>
                </c:pt>
                <c:pt idx="786">
                  <c:v>20.920904060270686</c:v>
                </c:pt>
                <c:pt idx="787">
                  <c:v>20.947487165811054</c:v>
                </c:pt>
                <c:pt idx="788">
                  <c:v>20.974070271351426</c:v>
                </c:pt>
                <c:pt idx="789">
                  <c:v>21.000653376891794</c:v>
                </c:pt>
                <c:pt idx="790">
                  <c:v>21.027236482432162</c:v>
                </c:pt>
                <c:pt idx="791">
                  <c:v>21.053819587972534</c:v>
                </c:pt>
                <c:pt idx="792">
                  <c:v>21.080402693512902</c:v>
                </c:pt>
                <c:pt idx="793">
                  <c:v>21.10698579905327</c:v>
                </c:pt>
                <c:pt idx="794">
                  <c:v>21.133568904593641</c:v>
                </c:pt>
                <c:pt idx="795">
                  <c:v>21.160152010134009</c:v>
                </c:pt>
                <c:pt idx="796">
                  <c:v>21.186735115674381</c:v>
                </c:pt>
                <c:pt idx="797">
                  <c:v>21.213318221214749</c:v>
                </c:pt>
                <c:pt idx="798">
                  <c:v>21.239901326755117</c:v>
                </c:pt>
                <c:pt idx="799">
                  <c:v>21.266484432295488</c:v>
                </c:pt>
                <c:pt idx="800">
                  <c:v>21.293067537835856</c:v>
                </c:pt>
                <c:pt idx="801">
                  <c:v>21.319650643376228</c:v>
                </c:pt>
                <c:pt idx="802">
                  <c:v>21.346233748916596</c:v>
                </c:pt>
                <c:pt idx="803">
                  <c:v>21.372816854456964</c:v>
                </c:pt>
                <c:pt idx="804">
                  <c:v>21.399399959997336</c:v>
                </c:pt>
                <c:pt idx="805">
                  <c:v>21.425983065537704</c:v>
                </c:pt>
                <c:pt idx="806">
                  <c:v>21.452566171078072</c:v>
                </c:pt>
                <c:pt idx="807">
                  <c:v>21.479149276618443</c:v>
                </c:pt>
                <c:pt idx="808">
                  <c:v>21.505732382158811</c:v>
                </c:pt>
                <c:pt idx="809">
                  <c:v>21.532315487699183</c:v>
                </c:pt>
                <c:pt idx="810">
                  <c:v>21.558898593239551</c:v>
                </c:pt>
                <c:pt idx="811">
                  <c:v>21.585481698779919</c:v>
                </c:pt>
                <c:pt idx="812">
                  <c:v>21.612064804320291</c:v>
                </c:pt>
                <c:pt idx="813">
                  <c:v>21.638647909860659</c:v>
                </c:pt>
                <c:pt idx="814">
                  <c:v>21.665231015401027</c:v>
                </c:pt>
                <c:pt idx="815">
                  <c:v>21.691814120941398</c:v>
                </c:pt>
                <c:pt idx="816">
                  <c:v>21.718397226481766</c:v>
                </c:pt>
                <c:pt idx="817">
                  <c:v>21.744980332022138</c:v>
                </c:pt>
                <c:pt idx="818">
                  <c:v>21.771563437562506</c:v>
                </c:pt>
                <c:pt idx="819">
                  <c:v>21.798146543102874</c:v>
                </c:pt>
                <c:pt idx="820">
                  <c:v>21.824729648643245</c:v>
                </c:pt>
                <c:pt idx="821">
                  <c:v>21.851312754183613</c:v>
                </c:pt>
                <c:pt idx="822">
                  <c:v>21.877895859723981</c:v>
                </c:pt>
                <c:pt idx="823">
                  <c:v>21.904478965264353</c:v>
                </c:pt>
                <c:pt idx="824">
                  <c:v>21.931062070804721</c:v>
                </c:pt>
                <c:pt idx="825">
                  <c:v>21.957645176345093</c:v>
                </c:pt>
                <c:pt idx="826">
                  <c:v>21.984228281885461</c:v>
                </c:pt>
                <c:pt idx="827">
                  <c:v>22.010811387425829</c:v>
                </c:pt>
                <c:pt idx="828">
                  <c:v>22.0373944929662</c:v>
                </c:pt>
                <c:pt idx="829">
                  <c:v>22.063977598506568</c:v>
                </c:pt>
                <c:pt idx="830">
                  <c:v>22.090560704046936</c:v>
                </c:pt>
                <c:pt idx="831">
                  <c:v>22.117143809587308</c:v>
                </c:pt>
                <c:pt idx="832">
                  <c:v>22.143726915127676</c:v>
                </c:pt>
                <c:pt idx="833">
                  <c:v>22.170310020668047</c:v>
                </c:pt>
                <c:pt idx="834">
                  <c:v>22.196893126208415</c:v>
                </c:pt>
                <c:pt idx="835">
                  <c:v>22.223476231748784</c:v>
                </c:pt>
                <c:pt idx="836">
                  <c:v>22.250059337289155</c:v>
                </c:pt>
                <c:pt idx="837">
                  <c:v>22.276642442829523</c:v>
                </c:pt>
                <c:pt idx="838">
                  <c:v>22.303225548369891</c:v>
                </c:pt>
                <c:pt idx="839">
                  <c:v>22.329808653910263</c:v>
                </c:pt>
                <c:pt idx="840">
                  <c:v>22.356391759450631</c:v>
                </c:pt>
                <c:pt idx="841">
                  <c:v>22.382974864991002</c:v>
                </c:pt>
                <c:pt idx="842">
                  <c:v>22.40955797053137</c:v>
                </c:pt>
                <c:pt idx="843">
                  <c:v>22.436141076071738</c:v>
                </c:pt>
                <c:pt idx="844">
                  <c:v>22.46272418161211</c:v>
                </c:pt>
                <c:pt idx="845">
                  <c:v>22.489307287152478</c:v>
                </c:pt>
                <c:pt idx="846">
                  <c:v>22.515890392692846</c:v>
                </c:pt>
                <c:pt idx="847">
                  <c:v>22.542473498233218</c:v>
                </c:pt>
                <c:pt idx="848">
                  <c:v>22.569056603773586</c:v>
                </c:pt>
                <c:pt idx="849">
                  <c:v>22.595639709313957</c:v>
                </c:pt>
                <c:pt idx="850">
                  <c:v>22.622222814854325</c:v>
                </c:pt>
                <c:pt idx="851">
                  <c:v>22.648805920394693</c:v>
                </c:pt>
                <c:pt idx="852">
                  <c:v>22.675389025935065</c:v>
                </c:pt>
                <c:pt idx="853">
                  <c:v>22.701972131475433</c:v>
                </c:pt>
                <c:pt idx="854">
                  <c:v>22.728555237015801</c:v>
                </c:pt>
                <c:pt idx="855">
                  <c:v>22.755138342556172</c:v>
                </c:pt>
                <c:pt idx="856">
                  <c:v>22.78172144809654</c:v>
                </c:pt>
                <c:pt idx="857">
                  <c:v>22.808304553636912</c:v>
                </c:pt>
                <c:pt idx="858">
                  <c:v>22.83488765917728</c:v>
                </c:pt>
                <c:pt idx="859">
                  <c:v>22.861470764717648</c:v>
                </c:pt>
                <c:pt idx="860">
                  <c:v>22.88805387025802</c:v>
                </c:pt>
                <c:pt idx="861">
                  <c:v>22.914636975798388</c:v>
                </c:pt>
                <c:pt idx="862">
                  <c:v>22.941220081338756</c:v>
                </c:pt>
                <c:pt idx="863">
                  <c:v>22.967803186879127</c:v>
                </c:pt>
                <c:pt idx="864">
                  <c:v>22.994386292419495</c:v>
                </c:pt>
                <c:pt idx="865">
                  <c:v>23.020969397959867</c:v>
                </c:pt>
                <c:pt idx="866">
                  <c:v>23.047552503500235</c:v>
                </c:pt>
                <c:pt idx="867">
                  <c:v>23.074135609040603</c:v>
                </c:pt>
                <c:pt idx="868">
                  <c:v>23.100718714580974</c:v>
                </c:pt>
                <c:pt idx="869">
                  <c:v>23.127301820121343</c:v>
                </c:pt>
                <c:pt idx="870">
                  <c:v>23.153884925661711</c:v>
                </c:pt>
                <c:pt idx="871">
                  <c:v>23.180468031202082</c:v>
                </c:pt>
                <c:pt idx="872">
                  <c:v>23.20705113674245</c:v>
                </c:pt>
                <c:pt idx="873">
                  <c:v>23.233634242282822</c:v>
                </c:pt>
                <c:pt idx="874">
                  <c:v>23.26021734782319</c:v>
                </c:pt>
                <c:pt idx="875">
                  <c:v>23.286800453363558</c:v>
                </c:pt>
                <c:pt idx="876">
                  <c:v>23.313383558903929</c:v>
                </c:pt>
                <c:pt idx="877">
                  <c:v>23.339966664444297</c:v>
                </c:pt>
                <c:pt idx="878">
                  <c:v>23.366549769984665</c:v>
                </c:pt>
                <c:pt idx="879">
                  <c:v>23.393132875525037</c:v>
                </c:pt>
                <c:pt idx="880">
                  <c:v>23.419715981065405</c:v>
                </c:pt>
                <c:pt idx="881">
                  <c:v>23.446299086605777</c:v>
                </c:pt>
                <c:pt idx="882">
                  <c:v>23.472882192146145</c:v>
                </c:pt>
                <c:pt idx="883">
                  <c:v>23.499465297686513</c:v>
                </c:pt>
                <c:pt idx="884">
                  <c:v>23.526048403226884</c:v>
                </c:pt>
                <c:pt idx="885">
                  <c:v>23.552631508767252</c:v>
                </c:pt>
                <c:pt idx="886">
                  <c:v>23.57921461430762</c:v>
                </c:pt>
                <c:pt idx="887">
                  <c:v>23.605797719847992</c:v>
                </c:pt>
                <c:pt idx="888">
                  <c:v>23.63238082538836</c:v>
                </c:pt>
                <c:pt idx="889">
                  <c:v>23.658963930928731</c:v>
                </c:pt>
                <c:pt idx="890">
                  <c:v>23.685547036469099</c:v>
                </c:pt>
                <c:pt idx="891">
                  <c:v>23.712130142009467</c:v>
                </c:pt>
                <c:pt idx="892">
                  <c:v>23.738713247549839</c:v>
                </c:pt>
                <c:pt idx="893">
                  <c:v>23.765296353090207</c:v>
                </c:pt>
                <c:pt idx="894">
                  <c:v>23.791879458630575</c:v>
                </c:pt>
                <c:pt idx="895">
                  <c:v>23.818462564170947</c:v>
                </c:pt>
                <c:pt idx="896">
                  <c:v>23.845045669711315</c:v>
                </c:pt>
                <c:pt idx="897">
                  <c:v>23.871628775251686</c:v>
                </c:pt>
                <c:pt idx="898">
                  <c:v>23.898211880792054</c:v>
                </c:pt>
                <c:pt idx="899">
                  <c:v>23.924794986332422</c:v>
                </c:pt>
                <c:pt idx="900">
                  <c:v>23.951378091872794</c:v>
                </c:pt>
                <c:pt idx="901">
                  <c:v>23.977961197413162</c:v>
                </c:pt>
                <c:pt idx="902">
                  <c:v>24.00454430295353</c:v>
                </c:pt>
                <c:pt idx="903">
                  <c:v>24.031127408493901</c:v>
                </c:pt>
                <c:pt idx="904">
                  <c:v>24.05771051403427</c:v>
                </c:pt>
                <c:pt idx="905">
                  <c:v>24.084293619574641</c:v>
                </c:pt>
                <c:pt idx="906">
                  <c:v>24.110876725115009</c:v>
                </c:pt>
                <c:pt idx="907">
                  <c:v>24.137459830655377</c:v>
                </c:pt>
                <c:pt idx="908">
                  <c:v>24.164042936195749</c:v>
                </c:pt>
                <c:pt idx="909">
                  <c:v>24.190626041736117</c:v>
                </c:pt>
                <c:pt idx="910">
                  <c:v>24.217209147276485</c:v>
                </c:pt>
                <c:pt idx="911">
                  <c:v>24.243792252816856</c:v>
                </c:pt>
                <c:pt idx="912">
                  <c:v>24.270375358357224</c:v>
                </c:pt>
                <c:pt idx="913">
                  <c:v>24.296958463897596</c:v>
                </c:pt>
                <c:pt idx="914">
                  <c:v>24.323541569437964</c:v>
                </c:pt>
                <c:pt idx="915">
                  <c:v>24.350124674978332</c:v>
                </c:pt>
                <c:pt idx="916">
                  <c:v>24.376707780518704</c:v>
                </c:pt>
                <c:pt idx="917">
                  <c:v>24.403290886059072</c:v>
                </c:pt>
                <c:pt idx="918">
                  <c:v>24.42987399159944</c:v>
                </c:pt>
                <c:pt idx="919">
                  <c:v>24.456457097139811</c:v>
                </c:pt>
                <c:pt idx="920">
                  <c:v>24.483040202680179</c:v>
                </c:pt>
                <c:pt idx="921">
                  <c:v>24.509623308220551</c:v>
                </c:pt>
                <c:pt idx="922">
                  <c:v>24.536206413760919</c:v>
                </c:pt>
                <c:pt idx="923">
                  <c:v>24.562789519301287</c:v>
                </c:pt>
                <c:pt idx="924">
                  <c:v>24.589372624841658</c:v>
                </c:pt>
                <c:pt idx="925">
                  <c:v>24.615955730382026</c:v>
                </c:pt>
                <c:pt idx="926">
                  <c:v>24.642538835922394</c:v>
                </c:pt>
                <c:pt idx="927">
                  <c:v>24.669121941462766</c:v>
                </c:pt>
                <c:pt idx="928">
                  <c:v>24.695705047003134</c:v>
                </c:pt>
                <c:pt idx="929">
                  <c:v>24.722288152543506</c:v>
                </c:pt>
                <c:pt idx="930">
                  <c:v>24.748871258083874</c:v>
                </c:pt>
                <c:pt idx="931">
                  <c:v>24.775454363624242</c:v>
                </c:pt>
                <c:pt idx="932">
                  <c:v>24.802037469164613</c:v>
                </c:pt>
                <c:pt idx="933">
                  <c:v>24.828620574704981</c:v>
                </c:pt>
                <c:pt idx="934">
                  <c:v>24.855203680245353</c:v>
                </c:pt>
                <c:pt idx="935">
                  <c:v>24.881786785785721</c:v>
                </c:pt>
                <c:pt idx="936">
                  <c:v>24.908369891326089</c:v>
                </c:pt>
              </c:numCache>
            </c:numRef>
          </c:xVal>
          <c:yVal>
            <c:numRef>
              <c:f>Curves!$B$5:$B$941</c:f>
              <c:numCache>
                <c:formatCode>###0.00</c:formatCode>
                <c:ptCount val="937"/>
                <c:pt idx="0">
                  <c:v>3.2000000000000001E-2</c:v>
                </c:pt>
                <c:pt idx="1">
                  <c:v>5.5E-2</c:v>
                </c:pt>
                <c:pt idx="2">
                  <c:v>7.3999999999999996E-2</c:v>
                </c:pt>
                <c:pt idx="3">
                  <c:v>0.496</c:v>
                </c:pt>
                <c:pt idx="4">
                  <c:v>1.8</c:v>
                </c:pt>
                <c:pt idx="5">
                  <c:v>2.8119999999999998</c:v>
                </c:pt>
                <c:pt idx="6">
                  <c:v>3.339</c:v>
                </c:pt>
                <c:pt idx="7">
                  <c:v>2.82</c:v>
                </c:pt>
                <c:pt idx="8">
                  <c:v>1.8260000000000001</c:v>
                </c:pt>
                <c:pt idx="9">
                  <c:v>1.3460000000000001</c:v>
                </c:pt>
                <c:pt idx="10">
                  <c:v>1.095</c:v>
                </c:pt>
                <c:pt idx="11">
                  <c:v>0.95799999999999996</c:v>
                </c:pt>
                <c:pt idx="12">
                  <c:v>0.85</c:v>
                </c:pt>
                <c:pt idx="13">
                  <c:v>0.77200000000000002</c:v>
                </c:pt>
                <c:pt idx="14">
                  <c:v>0.71099999999999997</c:v>
                </c:pt>
                <c:pt idx="15">
                  <c:v>0.65900000000000003</c:v>
                </c:pt>
                <c:pt idx="16">
                  <c:v>0.61799999999999999</c:v>
                </c:pt>
                <c:pt idx="17">
                  <c:v>0.57999999999999996</c:v>
                </c:pt>
                <c:pt idx="18">
                  <c:v>0.54100000000000004</c:v>
                </c:pt>
                <c:pt idx="19">
                  <c:v>0.51</c:v>
                </c:pt>
                <c:pt idx="20">
                  <c:v>0.48699999999999999</c:v>
                </c:pt>
                <c:pt idx="21">
                  <c:v>0.46500000000000002</c:v>
                </c:pt>
                <c:pt idx="22">
                  <c:v>0.44400000000000001</c:v>
                </c:pt>
                <c:pt idx="23">
                  <c:v>0.42</c:v>
                </c:pt>
                <c:pt idx="24">
                  <c:v>0.40300000000000002</c:v>
                </c:pt>
                <c:pt idx="25">
                  <c:v>0.38500000000000001</c:v>
                </c:pt>
                <c:pt idx="26">
                  <c:v>0.373</c:v>
                </c:pt>
                <c:pt idx="27">
                  <c:v>0.36199999999999999</c:v>
                </c:pt>
                <c:pt idx="28">
                  <c:v>0.34599999999999997</c:v>
                </c:pt>
                <c:pt idx="29">
                  <c:v>0.33900000000000002</c:v>
                </c:pt>
                <c:pt idx="30">
                  <c:v>0.32600000000000001</c:v>
                </c:pt>
                <c:pt idx="31">
                  <c:v>0.316</c:v>
                </c:pt>
                <c:pt idx="32">
                  <c:v>0.30599999999999999</c:v>
                </c:pt>
                <c:pt idx="33">
                  <c:v>0.29899999999999999</c:v>
                </c:pt>
                <c:pt idx="34">
                  <c:v>0.29399999999999998</c:v>
                </c:pt>
                <c:pt idx="35">
                  <c:v>0.29199999999999998</c:v>
                </c:pt>
                <c:pt idx="36">
                  <c:v>0.28499999999999998</c:v>
                </c:pt>
                <c:pt idx="37">
                  <c:v>0.27900000000000003</c:v>
                </c:pt>
                <c:pt idx="38">
                  <c:v>0.27100000000000002</c:v>
                </c:pt>
                <c:pt idx="39">
                  <c:v>0.27</c:v>
                </c:pt>
                <c:pt idx="40">
                  <c:v>0.26400000000000001</c:v>
                </c:pt>
                <c:pt idx="41">
                  <c:v>0.25800000000000001</c:v>
                </c:pt>
                <c:pt idx="42">
                  <c:v>0.253</c:v>
                </c:pt>
                <c:pt idx="43">
                  <c:v>0.25</c:v>
                </c:pt>
                <c:pt idx="44">
                  <c:v>0.245</c:v>
                </c:pt>
                <c:pt idx="45">
                  <c:v>0.23499999999999999</c:v>
                </c:pt>
                <c:pt idx="46">
                  <c:v>0.22600000000000001</c:v>
                </c:pt>
                <c:pt idx="47">
                  <c:v>0.218</c:v>
                </c:pt>
                <c:pt idx="48">
                  <c:v>0.21199999999999999</c:v>
                </c:pt>
                <c:pt idx="49">
                  <c:v>0.20499999999999999</c:v>
                </c:pt>
                <c:pt idx="50">
                  <c:v>0.20200000000000001</c:v>
                </c:pt>
                <c:pt idx="51">
                  <c:v>0.19800000000000001</c:v>
                </c:pt>
                <c:pt idx="52">
                  <c:v>0.19800000000000001</c:v>
                </c:pt>
                <c:pt idx="53">
                  <c:v>0.19800000000000001</c:v>
                </c:pt>
                <c:pt idx="54">
                  <c:v>0.19600000000000001</c:v>
                </c:pt>
                <c:pt idx="55">
                  <c:v>0.19500000000000001</c:v>
                </c:pt>
                <c:pt idx="56">
                  <c:v>0.186</c:v>
                </c:pt>
                <c:pt idx="57">
                  <c:v>0.183</c:v>
                </c:pt>
                <c:pt idx="58">
                  <c:v>0.17399999999999999</c:v>
                </c:pt>
                <c:pt idx="59">
                  <c:v>0.16400000000000001</c:v>
                </c:pt>
                <c:pt idx="60">
                  <c:v>0.161</c:v>
                </c:pt>
                <c:pt idx="61">
                  <c:v>0.154</c:v>
                </c:pt>
                <c:pt idx="62">
                  <c:v>0.14699999999999999</c:v>
                </c:pt>
                <c:pt idx="63">
                  <c:v>0.14599999999999999</c:v>
                </c:pt>
                <c:pt idx="64">
                  <c:v>0.14599999999999999</c:v>
                </c:pt>
                <c:pt idx="65">
                  <c:v>0.14399999999999999</c:v>
                </c:pt>
                <c:pt idx="66">
                  <c:v>0.14399999999999999</c:v>
                </c:pt>
                <c:pt idx="67">
                  <c:v>0.13600000000000001</c:v>
                </c:pt>
                <c:pt idx="68">
                  <c:v>0.13500000000000001</c:v>
                </c:pt>
                <c:pt idx="69">
                  <c:v>0.13400000000000001</c:v>
                </c:pt>
                <c:pt idx="70">
                  <c:v>0.129</c:v>
                </c:pt>
                <c:pt idx="71">
                  <c:v>0.129</c:v>
                </c:pt>
                <c:pt idx="72">
                  <c:v>0.121</c:v>
                </c:pt>
                <c:pt idx="73">
                  <c:v>0.123</c:v>
                </c:pt>
                <c:pt idx="74">
                  <c:v>0.121</c:v>
                </c:pt>
                <c:pt idx="75">
                  <c:v>0.115</c:v>
                </c:pt>
                <c:pt idx="76">
                  <c:v>0.11</c:v>
                </c:pt>
                <c:pt idx="77">
                  <c:v>0.10299999999999999</c:v>
                </c:pt>
                <c:pt idx="78">
                  <c:v>0.10199999999999999</c:v>
                </c:pt>
                <c:pt idx="79">
                  <c:v>0.10199999999999999</c:v>
                </c:pt>
                <c:pt idx="80">
                  <c:v>9.8000000000000004E-2</c:v>
                </c:pt>
                <c:pt idx="81">
                  <c:v>9.1999999999999998E-2</c:v>
                </c:pt>
                <c:pt idx="82">
                  <c:v>8.7999999999999995E-2</c:v>
                </c:pt>
                <c:pt idx="83">
                  <c:v>8.3000000000000004E-2</c:v>
                </c:pt>
                <c:pt idx="84">
                  <c:v>8.1000000000000003E-2</c:v>
                </c:pt>
                <c:pt idx="85">
                  <c:v>0.08</c:v>
                </c:pt>
                <c:pt idx="86">
                  <c:v>7.4999999999999997E-2</c:v>
                </c:pt>
                <c:pt idx="87">
                  <c:v>6.8000000000000005E-2</c:v>
                </c:pt>
                <c:pt idx="88">
                  <c:v>6.4000000000000001E-2</c:v>
                </c:pt>
                <c:pt idx="89">
                  <c:v>5.5E-2</c:v>
                </c:pt>
                <c:pt idx="90">
                  <c:v>5.7000000000000002E-2</c:v>
                </c:pt>
                <c:pt idx="91">
                  <c:v>0.06</c:v>
                </c:pt>
                <c:pt idx="92">
                  <c:v>6.4000000000000001E-2</c:v>
                </c:pt>
                <c:pt idx="93">
                  <c:v>6.0999999999999999E-2</c:v>
                </c:pt>
                <c:pt idx="94">
                  <c:v>5.7000000000000002E-2</c:v>
                </c:pt>
                <c:pt idx="95">
                  <c:v>5.6000000000000001E-2</c:v>
                </c:pt>
                <c:pt idx="96">
                  <c:v>5.6000000000000001E-2</c:v>
                </c:pt>
                <c:pt idx="97">
                  <c:v>5.8000000000000003E-2</c:v>
                </c:pt>
                <c:pt idx="98">
                  <c:v>5.8000000000000003E-2</c:v>
                </c:pt>
                <c:pt idx="99">
                  <c:v>6.3E-2</c:v>
                </c:pt>
                <c:pt idx="100">
                  <c:v>6.3E-2</c:v>
                </c:pt>
                <c:pt idx="101">
                  <c:v>6.3E-2</c:v>
                </c:pt>
                <c:pt idx="102">
                  <c:v>6.0999999999999999E-2</c:v>
                </c:pt>
                <c:pt idx="103">
                  <c:v>5.8000000000000003E-2</c:v>
                </c:pt>
                <c:pt idx="104">
                  <c:v>5.8999999999999997E-2</c:v>
                </c:pt>
                <c:pt idx="105">
                  <c:v>0.06</c:v>
                </c:pt>
                <c:pt idx="106">
                  <c:v>6.0999999999999999E-2</c:v>
                </c:pt>
                <c:pt idx="107">
                  <c:v>6.0999999999999999E-2</c:v>
                </c:pt>
                <c:pt idx="108">
                  <c:v>6.3E-2</c:v>
                </c:pt>
                <c:pt idx="109">
                  <c:v>6.4000000000000001E-2</c:v>
                </c:pt>
                <c:pt idx="110">
                  <c:v>5.8999999999999997E-2</c:v>
                </c:pt>
                <c:pt idx="111">
                  <c:v>5.0999999999999997E-2</c:v>
                </c:pt>
                <c:pt idx="112">
                  <c:v>4.8000000000000001E-2</c:v>
                </c:pt>
                <c:pt idx="113">
                  <c:v>4.2000000000000003E-2</c:v>
                </c:pt>
                <c:pt idx="114">
                  <c:v>4.1000000000000002E-2</c:v>
                </c:pt>
                <c:pt idx="115">
                  <c:v>3.6999999999999998E-2</c:v>
                </c:pt>
                <c:pt idx="116">
                  <c:v>3.1E-2</c:v>
                </c:pt>
                <c:pt idx="117">
                  <c:v>2.5999999999999999E-2</c:v>
                </c:pt>
                <c:pt idx="118">
                  <c:v>2.1000000000000001E-2</c:v>
                </c:pt>
                <c:pt idx="119">
                  <c:v>1.6E-2</c:v>
                </c:pt>
                <c:pt idx="120">
                  <c:v>8.9999999999999993E-3</c:v>
                </c:pt>
                <c:pt idx="121">
                  <c:v>0</c:v>
                </c:pt>
                <c:pt idx="122">
                  <c:v>-7.0000000000000001E-3</c:v>
                </c:pt>
                <c:pt idx="123">
                  <c:v>-1.4999999999999999E-2</c:v>
                </c:pt>
                <c:pt idx="124">
                  <c:v>-2.9000000000000001E-2</c:v>
                </c:pt>
                <c:pt idx="125">
                  <c:v>-3.5999999999999997E-2</c:v>
                </c:pt>
                <c:pt idx="126">
                  <c:v>-5.0999999999999997E-2</c:v>
                </c:pt>
                <c:pt idx="127">
                  <c:v>-5.3999999999999999E-2</c:v>
                </c:pt>
                <c:pt idx="128">
                  <c:v>-0.06</c:v>
                </c:pt>
                <c:pt idx="129">
                  <c:v>-6.5000000000000002E-2</c:v>
                </c:pt>
                <c:pt idx="130">
                  <c:v>-6.9000000000000006E-2</c:v>
                </c:pt>
                <c:pt idx="131">
                  <c:v>-7.5999999999999998E-2</c:v>
                </c:pt>
                <c:pt idx="132">
                  <c:v>-8.4000000000000005E-2</c:v>
                </c:pt>
                <c:pt idx="133">
                  <c:v>-8.4000000000000005E-2</c:v>
                </c:pt>
                <c:pt idx="134">
                  <c:v>-8.4000000000000005E-2</c:v>
                </c:pt>
                <c:pt idx="135">
                  <c:v>-8.4000000000000005E-2</c:v>
                </c:pt>
                <c:pt idx="136">
                  <c:v>-8.3000000000000004E-2</c:v>
                </c:pt>
                <c:pt idx="137">
                  <c:v>-8.7999999999999995E-2</c:v>
                </c:pt>
                <c:pt idx="138">
                  <c:v>-9.2999999999999999E-2</c:v>
                </c:pt>
                <c:pt idx="139">
                  <c:v>-9.1999999999999998E-2</c:v>
                </c:pt>
                <c:pt idx="140">
                  <c:v>-0.09</c:v>
                </c:pt>
                <c:pt idx="141">
                  <c:v>-0.09</c:v>
                </c:pt>
                <c:pt idx="142">
                  <c:v>-9.0999999999999998E-2</c:v>
                </c:pt>
                <c:pt idx="143">
                  <c:v>-9.1999999999999998E-2</c:v>
                </c:pt>
                <c:pt idx="144">
                  <c:v>-9.6000000000000002E-2</c:v>
                </c:pt>
                <c:pt idx="145">
                  <c:v>-9.8000000000000004E-2</c:v>
                </c:pt>
                <c:pt idx="146">
                  <c:v>-0.104</c:v>
                </c:pt>
                <c:pt idx="147">
                  <c:v>-0.10199999999999999</c:v>
                </c:pt>
                <c:pt idx="148">
                  <c:v>-0.10299999999999999</c:v>
                </c:pt>
                <c:pt idx="149">
                  <c:v>-0.106</c:v>
                </c:pt>
                <c:pt idx="150">
                  <c:v>-0.105</c:v>
                </c:pt>
                <c:pt idx="151">
                  <c:v>-0.10199999999999999</c:v>
                </c:pt>
                <c:pt idx="152">
                  <c:v>-9.9000000000000005E-2</c:v>
                </c:pt>
                <c:pt idx="153">
                  <c:v>-9.4E-2</c:v>
                </c:pt>
                <c:pt idx="154">
                  <c:v>-9.1999999999999998E-2</c:v>
                </c:pt>
                <c:pt idx="155">
                  <c:v>-9.1999999999999998E-2</c:v>
                </c:pt>
                <c:pt idx="156">
                  <c:v>-9.2999999999999999E-2</c:v>
                </c:pt>
                <c:pt idx="157">
                  <c:v>-0.1</c:v>
                </c:pt>
                <c:pt idx="158">
                  <c:v>-0.10100000000000001</c:v>
                </c:pt>
                <c:pt idx="159">
                  <c:v>-0.10299999999999999</c:v>
                </c:pt>
                <c:pt idx="160">
                  <c:v>-0.10299999999999999</c:v>
                </c:pt>
                <c:pt idx="161">
                  <c:v>-0.10100000000000001</c:v>
                </c:pt>
                <c:pt idx="162">
                  <c:v>-0.1</c:v>
                </c:pt>
                <c:pt idx="163">
                  <c:v>-0.1</c:v>
                </c:pt>
                <c:pt idx="164">
                  <c:v>-0.105</c:v>
                </c:pt>
                <c:pt idx="165">
                  <c:v>-0.105</c:v>
                </c:pt>
                <c:pt idx="166">
                  <c:v>-0.106</c:v>
                </c:pt>
                <c:pt idx="167">
                  <c:v>-0.106</c:v>
                </c:pt>
                <c:pt idx="168">
                  <c:v>-0.105</c:v>
                </c:pt>
                <c:pt idx="169">
                  <c:v>-0.112</c:v>
                </c:pt>
                <c:pt idx="170">
                  <c:v>-0.112</c:v>
                </c:pt>
                <c:pt idx="171">
                  <c:v>-0.107</c:v>
                </c:pt>
                <c:pt idx="172">
                  <c:v>-0.11</c:v>
                </c:pt>
                <c:pt idx="173">
                  <c:v>-0.108</c:v>
                </c:pt>
                <c:pt idx="174">
                  <c:v>-0.113</c:v>
                </c:pt>
                <c:pt idx="175">
                  <c:v>-0.114</c:v>
                </c:pt>
                <c:pt idx="176">
                  <c:v>-0.11</c:v>
                </c:pt>
                <c:pt idx="177">
                  <c:v>-0.11600000000000001</c:v>
                </c:pt>
                <c:pt idx="178">
                  <c:v>-0.11600000000000001</c:v>
                </c:pt>
                <c:pt idx="179">
                  <c:v>-0.12</c:v>
                </c:pt>
                <c:pt idx="180">
                  <c:v>-0.123</c:v>
                </c:pt>
                <c:pt idx="181">
                  <c:v>-0.126</c:v>
                </c:pt>
                <c:pt idx="182">
                  <c:v>-0.129</c:v>
                </c:pt>
                <c:pt idx="183">
                  <c:v>-0.13</c:v>
                </c:pt>
                <c:pt idx="184">
                  <c:v>-0.13300000000000001</c:v>
                </c:pt>
                <c:pt idx="185">
                  <c:v>-0.13300000000000001</c:v>
                </c:pt>
                <c:pt idx="186">
                  <c:v>-0.13500000000000001</c:v>
                </c:pt>
                <c:pt idx="187">
                  <c:v>-0.13400000000000001</c:v>
                </c:pt>
                <c:pt idx="188">
                  <c:v>-0.13700000000000001</c:v>
                </c:pt>
                <c:pt idx="189">
                  <c:v>-0.13800000000000001</c:v>
                </c:pt>
                <c:pt idx="190">
                  <c:v>-0.14000000000000001</c:v>
                </c:pt>
                <c:pt idx="191">
                  <c:v>-0.14699999999999999</c:v>
                </c:pt>
                <c:pt idx="192">
                  <c:v>-0.157</c:v>
                </c:pt>
                <c:pt idx="193">
                  <c:v>-0.159</c:v>
                </c:pt>
                <c:pt idx="194">
                  <c:v>-0.16900000000000001</c:v>
                </c:pt>
                <c:pt idx="195">
                  <c:v>-0.16800000000000001</c:v>
                </c:pt>
                <c:pt idx="196">
                  <c:v>-0.16800000000000001</c:v>
                </c:pt>
                <c:pt idx="197">
                  <c:v>-0.17100000000000001</c:v>
                </c:pt>
                <c:pt idx="198">
                  <c:v>-0.17</c:v>
                </c:pt>
                <c:pt idx="199">
                  <c:v>-0.17199999999999999</c:v>
                </c:pt>
                <c:pt idx="200">
                  <c:v>-0.17299999999999999</c:v>
                </c:pt>
                <c:pt idx="201">
                  <c:v>-0.17799999999999999</c:v>
                </c:pt>
                <c:pt idx="202">
                  <c:v>-0.182</c:v>
                </c:pt>
                <c:pt idx="203">
                  <c:v>-0.184</c:v>
                </c:pt>
                <c:pt idx="204">
                  <c:v>-0.184</c:v>
                </c:pt>
                <c:pt idx="205">
                  <c:v>-0.184</c:v>
                </c:pt>
                <c:pt idx="206">
                  <c:v>-0.185</c:v>
                </c:pt>
                <c:pt idx="207">
                  <c:v>-0.183</c:v>
                </c:pt>
                <c:pt idx="208">
                  <c:v>-0.185</c:v>
                </c:pt>
                <c:pt idx="209">
                  <c:v>-0.189</c:v>
                </c:pt>
                <c:pt idx="210">
                  <c:v>-0.187</c:v>
                </c:pt>
                <c:pt idx="211">
                  <c:v>-0.187</c:v>
                </c:pt>
                <c:pt idx="212">
                  <c:v>-0.184</c:v>
                </c:pt>
                <c:pt idx="213">
                  <c:v>-0.186</c:v>
                </c:pt>
                <c:pt idx="214">
                  <c:v>-0.19</c:v>
                </c:pt>
                <c:pt idx="215">
                  <c:v>-0.188</c:v>
                </c:pt>
                <c:pt idx="216">
                  <c:v>-0.191</c:v>
                </c:pt>
                <c:pt idx="217">
                  <c:v>-0.188</c:v>
                </c:pt>
                <c:pt idx="218">
                  <c:v>-0.192</c:v>
                </c:pt>
                <c:pt idx="219">
                  <c:v>-0.19600000000000001</c:v>
                </c:pt>
                <c:pt idx="220">
                  <c:v>-0.192</c:v>
                </c:pt>
                <c:pt idx="221">
                  <c:v>-0.192</c:v>
                </c:pt>
                <c:pt idx="222">
                  <c:v>-0.192</c:v>
                </c:pt>
                <c:pt idx="223">
                  <c:v>-0.19400000000000001</c:v>
                </c:pt>
                <c:pt idx="224">
                  <c:v>-0.19700000000000001</c:v>
                </c:pt>
                <c:pt idx="225">
                  <c:v>-0.20100000000000001</c:v>
                </c:pt>
                <c:pt idx="226">
                  <c:v>-0.19900000000000001</c:v>
                </c:pt>
                <c:pt idx="227">
                  <c:v>-0.20499999999999999</c:v>
                </c:pt>
                <c:pt idx="228">
                  <c:v>-0.20200000000000001</c:v>
                </c:pt>
                <c:pt idx="229">
                  <c:v>-0.2</c:v>
                </c:pt>
                <c:pt idx="230">
                  <c:v>-0.19700000000000001</c:v>
                </c:pt>
                <c:pt idx="231">
                  <c:v>-0.19600000000000001</c:v>
                </c:pt>
                <c:pt idx="232">
                  <c:v>-0.20100000000000001</c:v>
                </c:pt>
                <c:pt idx="233">
                  <c:v>-0.20399999999999999</c:v>
                </c:pt>
                <c:pt idx="234">
                  <c:v>-0.20100000000000001</c:v>
                </c:pt>
                <c:pt idx="235">
                  <c:v>-0.2</c:v>
                </c:pt>
                <c:pt idx="236">
                  <c:v>-0.2</c:v>
                </c:pt>
                <c:pt idx="237">
                  <c:v>-0.19600000000000001</c:v>
                </c:pt>
                <c:pt idx="238">
                  <c:v>-0.19900000000000001</c:v>
                </c:pt>
                <c:pt idx="239">
                  <c:v>-0.20599999999999999</c:v>
                </c:pt>
                <c:pt idx="240">
                  <c:v>-0.20599999999999999</c:v>
                </c:pt>
                <c:pt idx="241">
                  <c:v>-0.20799999999999999</c:v>
                </c:pt>
                <c:pt idx="242">
                  <c:v>-0.20899999999999999</c:v>
                </c:pt>
                <c:pt idx="243">
                  <c:v>-0.20499999999999999</c:v>
                </c:pt>
                <c:pt idx="244">
                  <c:v>-0.21099999999999999</c:v>
                </c:pt>
                <c:pt idx="245">
                  <c:v>-0.215</c:v>
                </c:pt>
                <c:pt idx="246">
                  <c:v>-0.217</c:v>
                </c:pt>
                <c:pt idx="247">
                  <c:v>-0.22</c:v>
                </c:pt>
                <c:pt idx="248">
                  <c:v>-0.22</c:v>
                </c:pt>
                <c:pt idx="249">
                  <c:v>-0.22</c:v>
                </c:pt>
                <c:pt idx="250">
                  <c:v>-0.217</c:v>
                </c:pt>
                <c:pt idx="251">
                  <c:v>-0.20899999999999999</c:v>
                </c:pt>
                <c:pt idx="252">
                  <c:v>-0.20899999999999999</c:v>
                </c:pt>
                <c:pt idx="253">
                  <c:v>-0.20499999999999999</c:v>
                </c:pt>
                <c:pt idx="254">
                  <c:v>-0.19500000000000001</c:v>
                </c:pt>
                <c:pt idx="255">
                  <c:v>-0.17599999999999999</c:v>
                </c:pt>
                <c:pt idx="256">
                  <c:v>-0.14299999999999999</c:v>
                </c:pt>
                <c:pt idx="257">
                  <c:v>-9.1999999999999998E-2</c:v>
                </c:pt>
                <c:pt idx="258">
                  <c:v>-2.1000000000000001E-2</c:v>
                </c:pt>
                <c:pt idx="259">
                  <c:v>9.2999999999999999E-2</c:v>
                </c:pt>
                <c:pt idx="260">
                  <c:v>0.246</c:v>
                </c:pt>
                <c:pt idx="261">
                  <c:v>0.44800000000000001</c:v>
                </c:pt>
                <c:pt idx="262">
                  <c:v>0.72199999999999998</c:v>
                </c:pt>
                <c:pt idx="263">
                  <c:v>1.0680000000000001</c:v>
                </c:pt>
                <c:pt idx="264">
                  <c:v>1.52</c:v>
                </c:pt>
                <c:pt idx="265">
                  <c:v>2.0950000000000002</c:v>
                </c:pt>
                <c:pt idx="266">
                  <c:v>2.7789999999999999</c:v>
                </c:pt>
                <c:pt idx="267">
                  <c:v>3.67</c:v>
                </c:pt>
                <c:pt idx="268">
                  <c:v>4.7050000000000001</c:v>
                </c:pt>
                <c:pt idx="269">
                  <c:v>6.0339999999999998</c:v>
                </c:pt>
                <c:pt idx="270">
                  <c:v>7.5620000000000003</c:v>
                </c:pt>
                <c:pt idx="271">
                  <c:v>9.4090000000000007</c:v>
                </c:pt>
                <c:pt idx="272">
                  <c:v>11.574999999999999</c:v>
                </c:pt>
                <c:pt idx="273">
                  <c:v>14.079000000000001</c:v>
                </c:pt>
                <c:pt idx="274">
                  <c:v>16.992999999999999</c:v>
                </c:pt>
                <c:pt idx="275">
                  <c:v>20.378</c:v>
                </c:pt>
                <c:pt idx="276">
                  <c:v>24.198</c:v>
                </c:pt>
                <c:pt idx="277">
                  <c:v>28.702000000000002</c:v>
                </c:pt>
                <c:pt idx="278">
                  <c:v>33.491999999999997</c:v>
                </c:pt>
                <c:pt idx="279">
                  <c:v>39.186999999999998</c:v>
                </c:pt>
                <c:pt idx="280">
                  <c:v>45.148000000000003</c:v>
                </c:pt>
                <c:pt idx="281">
                  <c:v>52.183999999999997</c:v>
                </c:pt>
                <c:pt idx="282">
                  <c:v>59.643000000000001</c:v>
                </c:pt>
                <c:pt idx="283">
                  <c:v>67.891000000000005</c:v>
                </c:pt>
                <c:pt idx="284">
                  <c:v>76.835999999999999</c:v>
                </c:pt>
                <c:pt idx="285">
                  <c:v>86.414000000000001</c:v>
                </c:pt>
                <c:pt idx="286">
                  <c:v>96.784000000000006</c:v>
                </c:pt>
                <c:pt idx="287">
                  <c:v>107.961</c:v>
                </c:pt>
                <c:pt idx="288">
                  <c:v>119.60599999999999</c:v>
                </c:pt>
                <c:pt idx="289">
                  <c:v>132.47800000000001</c:v>
                </c:pt>
                <c:pt idx="290">
                  <c:v>145.37</c:v>
                </c:pt>
                <c:pt idx="291">
                  <c:v>159.67599999999999</c:v>
                </c:pt>
                <c:pt idx="292">
                  <c:v>174.03700000000001</c:v>
                </c:pt>
                <c:pt idx="293">
                  <c:v>189.958</c:v>
                </c:pt>
                <c:pt idx="294">
                  <c:v>206.32400000000001</c:v>
                </c:pt>
                <c:pt idx="295">
                  <c:v>223.36199999999999</c:v>
                </c:pt>
                <c:pt idx="296">
                  <c:v>241.434</c:v>
                </c:pt>
                <c:pt idx="297">
                  <c:v>259.93099999999998</c:v>
                </c:pt>
                <c:pt idx="298">
                  <c:v>279.517</c:v>
                </c:pt>
                <c:pt idx="299">
                  <c:v>300.25900000000001</c:v>
                </c:pt>
                <c:pt idx="300">
                  <c:v>320.78399999999999</c:v>
                </c:pt>
                <c:pt idx="301">
                  <c:v>342.92599999999999</c:v>
                </c:pt>
                <c:pt idx="302">
                  <c:v>365.089</c:v>
                </c:pt>
                <c:pt idx="303">
                  <c:v>388.84199999999998</c:v>
                </c:pt>
                <c:pt idx="304">
                  <c:v>412.99200000000002</c:v>
                </c:pt>
                <c:pt idx="305">
                  <c:v>438.54700000000003</c:v>
                </c:pt>
                <c:pt idx="306">
                  <c:v>465.57299999999998</c:v>
                </c:pt>
                <c:pt idx="307">
                  <c:v>493.05500000000001</c:v>
                </c:pt>
                <c:pt idx="308">
                  <c:v>522.79499999999996</c:v>
                </c:pt>
                <c:pt idx="309">
                  <c:v>552.33500000000004</c:v>
                </c:pt>
                <c:pt idx="310">
                  <c:v>583.65899999999999</c:v>
                </c:pt>
                <c:pt idx="311">
                  <c:v>614.69899999999996</c:v>
                </c:pt>
                <c:pt idx="312">
                  <c:v>644.46900000000005</c:v>
                </c:pt>
                <c:pt idx="313">
                  <c:v>672.96600000000001</c:v>
                </c:pt>
                <c:pt idx="314">
                  <c:v>698.97799999999995</c:v>
                </c:pt>
                <c:pt idx="315">
                  <c:v>722.74099999999999</c:v>
                </c:pt>
                <c:pt idx="316">
                  <c:v>743.58799999999997</c:v>
                </c:pt>
                <c:pt idx="317">
                  <c:v>760.53200000000004</c:v>
                </c:pt>
                <c:pt idx="318">
                  <c:v>775.24800000000005</c:v>
                </c:pt>
                <c:pt idx="319">
                  <c:v>786.29499999999996</c:v>
                </c:pt>
                <c:pt idx="320">
                  <c:v>795.553</c:v>
                </c:pt>
                <c:pt idx="321">
                  <c:v>802.58100000000002</c:v>
                </c:pt>
                <c:pt idx="322">
                  <c:v>807.71199999999999</c:v>
                </c:pt>
                <c:pt idx="323">
                  <c:v>811.35699999999997</c:v>
                </c:pt>
                <c:pt idx="324">
                  <c:v>813.57299999999998</c:v>
                </c:pt>
                <c:pt idx="325">
                  <c:v>814.52300000000002</c:v>
                </c:pt>
                <c:pt idx="326">
                  <c:v>814.43700000000001</c:v>
                </c:pt>
                <c:pt idx="327">
                  <c:v>813.45799999999997</c:v>
                </c:pt>
                <c:pt idx="328">
                  <c:v>811.60699999999997</c:v>
                </c:pt>
                <c:pt idx="329">
                  <c:v>809.09199999999998</c:v>
                </c:pt>
                <c:pt idx="330">
                  <c:v>805.46199999999999</c:v>
                </c:pt>
                <c:pt idx="331">
                  <c:v>800.875</c:v>
                </c:pt>
                <c:pt idx="332">
                  <c:v>794.43600000000004</c:v>
                </c:pt>
                <c:pt idx="333">
                  <c:v>786.07799999999997</c:v>
                </c:pt>
                <c:pt idx="334">
                  <c:v>775.24900000000002</c:v>
                </c:pt>
                <c:pt idx="335">
                  <c:v>762.42200000000003</c:v>
                </c:pt>
                <c:pt idx="336">
                  <c:v>749.36</c:v>
                </c:pt>
                <c:pt idx="337">
                  <c:v>737.23699999999997</c:v>
                </c:pt>
                <c:pt idx="338">
                  <c:v>726.173</c:v>
                </c:pt>
                <c:pt idx="339">
                  <c:v>715.96</c:v>
                </c:pt>
                <c:pt idx="340">
                  <c:v>704.42</c:v>
                </c:pt>
                <c:pt idx="341">
                  <c:v>692.75300000000004</c:v>
                </c:pt>
                <c:pt idx="342">
                  <c:v>679.822</c:v>
                </c:pt>
                <c:pt idx="343">
                  <c:v>667.11599999999999</c:v>
                </c:pt>
                <c:pt idx="344">
                  <c:v>653.721</c:v>
                </c:pt>
                <c:pt idx="345">
                  <c:v>640.04999999999995</c:v>
                </c:pt>
                <c:pt idx="346">
                  <c:v>626.43700000000001</c:v>
                </c:pt>
                <c:pt idx="347">
                  <c:v>612.76499999999999</c:v>
                </c:pt>
                <c:pt idx="348">
                  <c:v>599.154</c:v>
                </c:pt>
                <c:pt idx="349">
                  <c:v>584.60299999999995</c:v>
                </c:pt>
                <c:pt idx="350">
                  <c:v>568.60799999999995</c:v>
                </c:pt>
                <c:pt idx="351">
                  <c:v>552.20399999999995</c:v>
                </c:pt>
                <c:pt idx="352">
                  <c:v>534.80200000000002</c:v>
                </c:pt>
                <c:pt idx="353">
                  <c:v>518.49800000000005</c:v>
                </c:pt>
                <c:pt idx="354">
                  <c:v>501.35899999999998</c:v>
                </c:pt>
                <c:pt idx="355">
                  <c:v>482.03</c:v>
                </c:pt>
                <c:pt idx="356">
                  <c:v>459.75900000000001</c:v>
                </c:pt>
                <c:pt idx="357">
                  <c:v>435.38299999999998</c:v>
                </c:pt>
                <c:pt idx="358">
                  <c:v>410.19900000000001</c:v>
                </c:pt>
                <c:pt idx="359">
                  <c:v>384.43</c:v>
                </c:pt>
                <c:pt idx="360">
                  <c:v>360.68700000000001</c:v>
                </c:pt>
                <c:pt idx="361">
                  <c:v>338.75400000000002</c:v>
                </c:pt>
                <c:pt idx="362">
                  <c:v>320.53899999999999</c:v>
                </c:pt>
                <c:pt idx="363">
                  <c:v>305.21800000000002</c:v>
                </c:pt>
                <c:pt idx="364">
                  <c:v>290.92099999999999</c:v>
                </c:pt>
                <c:pt idx="365">
                  <c:v>278.06</c:v>
                </c:pt>
                <c:pt idx="366">
                  <c:v>266.21300000000002</c:v>
                </c:pt>
                <c:pt idx="367">
                  <c:v>254.26499999999999</c:v>
                </c:pt>
                <c:pt idx="368">
                  <c:v>241.73400000000001</c:v>
                </c:pt>
                <c:pt idx="369">
                  <c:v>227.22</c:v>
                </c:pt>
                <c:pt idx="370">
                  <c:v>212.66499999999999</c:v>
                </c:pt>
                <c:pt idx="371">
                  <c:v>197.78700000000001</c:v>
                </c:pt>
                <c:pt idx="372">
                  <c:v>185.136</c:v>
                </c:pt>
                <c:pt idx="373">
                  <c:v>173.69900000000001</c:v>
                </c:pt>
                <c:pt idx="374">
                  <c:v>163.52500000000001</c:v>
                </c:pt>
                <c:pt idx="375">
                  <c:v>154.25</c:v>
                </c:pt>
                <c:pt idx="376">
                  <c:v>145.643</c:v>
                </c:pt>
                <c:pt idx="377">
                  <c:v>138.00399999999999</c:v>
                </c:pt>
                <c:pt idx="378">
                  <c:v>131.39099999999999</c:v>
                </c:pt>
                <c:pt idx="379">
                  <c:v>125.68899999999999</c:v>
                </c:pt>
                <c:pt idx="380">
                  <c:v>121.227</c:v>
                </c:pt>
                <c:pt idx="381">
                  <c:v>117.417</c:v>
                </c:pt>
                <c:pt idx="382">
                  <c:v>114.681</c:v>
                </c:pt>
                <c:pt idx="383">
                  <c:v>112.655</c:v>
                </c:pt>
                <c:pt idx="384">
                  <c:v>111.45699999999999</c:v>
                </c:pt>
                <c:pt idx="385">
                  <c:v>110.759</c:v>
                </c:pt>
                <c:pt idx="386">
                  <c:v>110.283</c:v>
                </c:pt>
                <c:pt idx="387">
                  <c:v>109.715</c:v>
                </c:pt>
                <c:pt idx="388">
                  <c:v>108.75</c:v>
                </c:pt>
                <c:pt idx="389">
                  <c:v>107.23099999999999</c:v>
                </c:pt>
                <c:pt idx="390">
                  <c:v>105.158</c:v>
                </c:pt>
                <c:pt idx="391">
                  <c:v>102.54900000000001</c:v>
                </c:pt>
                <c:pt idx="392">
                  <c:v>99.801000000000002</c:v>
                </c:pt>
                <c:pt idx="393">
                  <c:v>96.825000000000003</c:v>
                </c:pt>
                <c:pt idx="394">
                  <c:v>94.064999999999998</c:v>
                </c:pt>
                <c:pt idx="395">
                  <c:v>91.254000000000005</c:v>
                </c:pt>
                <c:pt idx="396">
                  <c:v>88.710999999999999</c:v>
                </c:pt>
                <c:pt idx="397">
                  <c:v>86.289000000000001</c:v>
                </c:pt>
                <c:pt idx="398">
                  <c:v>84.018000000000001</c:v>
                </c:pt>
                <c:pt idx="399">
                  <c:v>81.900000000000006</c:v>
                </c:pt>
                <c:pt idx="400">
                  <c:v>79.835999999999999</c:v>
                </c:pt>
                <c:pt idx="401">
                  <c:v>77.846000000000004</c:v>
                </c:pt>
                <c:pt idx="402">
                  <c:v>75.945999999999998</c:v>
                </c:pt>
                <c:pt idx="403">
                  <c:v>74.066000000000003</c:v>
                </c:pt>
                <c:pt idx="404">
                  <c:v>72.316999999999993</c:v>
                </c:pt>
                <c:pt idx="405">
                  <c:v>70.518000000000001</c:v>
                </c:pt>
                <c:pt idx="406">
                  <c:v>68.813000000000002</c:v>
                </c:pt>
                <c:pt idx="407">
                  <c:v>67.082999999999998</c:v>
                </c:pt>
                <c:pt idx="408">
                  <c:v>65.369</c:v>
                </c:pt>
                <c:pt idx="409">
                  <c:v>63.713000000000001</c:v>
                </c:pt>
                <c:pt idx="410">
                  <c:v>62.024000000000001</c:v>
                </c:pt>
                <c:pt idx="411">
                  <c:v>60.405000000000001</c:v>
                </c:pt>
                <c:pt idx="412">
                  <c:v>58.756</c:v>
                </c:pt>
                <c:pt idx="413">
                  <c:v>57.140999999999998</c:v>
                </c:pt>
                <c:pt idx="414">
                  <c:v>55.601999999999997</c:v>
                </c:pt>
                <c:pt idx="415">
                  <c:v>54.082000000000001</c:v>
                </c:pt>
                <c:pt idx="416">
                  <c:v>52.66</c:v>
                </c:pt>
                <c:pt idx="417">
                  <c:v>51.271999999999998</c:v>
                </c:pt>
                <c:pt idx="418">
                  <c:v>49.942999999999998</c:v>
                </c:pt>
                <c:pt idx="419">
                  <c:v>48.728000000000002</c:v>
                </c:pt>
                <c:pt idx="420">
                  <c:v>47.527000000000001</c:v>
                </c:pt>
                <c:pt idx="421">
                  <c:v>46.451999999999998</c:v>
                </c:pt>
                <c:pt idx="422">
                  <c:v>45.392000000000003</c:v>
                </c:pt>
                <c:pt idx="423">
                  <c:v>44.417000000000002</c:v>
                </c:pt>
                <c:pt idx="424">
                  <c:v>43.506</c:v>
                </c:pt>
                <c:pt idx="425">
                  <c:v>42.651000000000003</c:v>
                </c:pt>
                <c:pt idx="426">
                  <c:v>41.823</c:v>
                </c:pt>
                <c:pt idx="427">
                  <c:v>41.042000000000002</c:v>
                </c:pt>
                <c:pt idx="428">
                  <c:v>40.304000000000002</c:v>
                </c:pt>
                <c:pt idx="429">
                  <c:v>39.590000000000003</c:v>
                </c:pt>
                <c:pt idx="430">
                  <c:v>38.895000000000003</c:v>
                </c:pt>
                <c:pt idx="431">
                  <c:v>38.243000000000002</c:v>
                </c:pt>
                <c:pt idx="432">
                  <c:v>37.594999999999999</c:v>
                </c:pt>
                <c:pt idx="433">
                  <c:v>37.008000000000003</c:v>
                </c:pt>
                <c:pt idx="434">
                  <c:v>36.411000000000001</c:v>
                </c:pt>
                <c:pt idx="435">
                  <c:v>35.866999999999997</c:v>
                </c:pt>
                <c:pt idx="436">
                  <c:v>35.317</c:v>
                </c:pt>
                <c:pt idx="437">
                  <c:v>34.805999999999997</c:v>
                </c:pt>
                <c:pt idx="438">
                  <c:v>34.314</c:v>
                </c:pt>
                <c:pt idx="439">
                  <c:v>33.847999999999999</c:v>
                </c:pt>
                <c:pt idx="440">
                  <c:v>33.392000000000003</c:v>
                </c:pt>
                <c:pt idx="441">
                  <c:v>32.954999999999998</c:v>
                </c:pt>
                <c:pt idx="442">
                  <c:v>32.524000000000001</c:v>
                </c:pt>
                <c:pt idx="443">
                  <c:v>32.122</c:v>
                </c:pt>
                <c:pt idx="444">
                  <c:v>31.71</c:v>
                </c:pt>
                <c:pt idx="445">
                  <c:v>31.332999999999998</c:v>
                </c:pt>
                <c:pt idx="446">
                  <c:v>30.945</c:v>
                </c:pt>
                <c:pt idx="447">
                  <c:v>30.582000000000001</c:v>
                </c:pt>
                <c:pt idx="448">
                  <c:v>30.231000000000002</c:v>
                </c:pt>
                <c:pt idx="449">
                  <c:v>29.885999999999999</c:v>
                </c:pt>
                <c:pt idx="450">
                  <c:v>29.56</c:v>
                </c:pt>
                <c:pt idx="451">
                  <c:v>29.24</c:v>
                </c:pt>
                <c:pt idx="452">
                  <c:v>28.934000000000001</c:v>
                </c:pt>
                <c:pt idx="453">
                  <c:v>28.652000000000001</c:v>
                </c:pt>
                <c:pt idx="454">
                  <c:v>28.366</c:v>
                </c:pt>
                <c:pt idx="455">
                  <c:v>28.097999999999999</c:v>
                </c:pt>
                <c:pt idx="456">
                  <c:v>27.821999999999999</c:v>
                </c:pt>
                <c:pt idx="457">
                  <c:v>27.55</c:v>
                </c:pt>
                <c:pt idx="458">
                  <c:v>27.279</c:v>
                </c:pt>
                <c:pt idx="459">
                  <c:v>27.007999999999999</c:v>
                </c:pt>
                <c:pt idx="460">
                  <c:v>26.739000000000001</c:v>
                </c:pt>
                <c:pt idx="461">
                  <c:v>26.462</c:v>
                </c:pt>
                <c:pt idx="462">
                  <c:v>26.181000000000001</c:v>
                </c:pt>
                <c:pt idx="463">
                  <c:v>25.901</c:v>
                </c:pt>
                <c:pt idx="464">
                  <c:v>25.622</c:v>
                </c:pt>
                <c:pt idx="465">
                  <c:v>25.347999999999999</c:v>
                </c:pt>
                <c:pt idx="466">
                  <c:v>25.062000000000001</c:v>
                </c:pt>
                <c:pt idx="467">
                  <c:v>24.782</c:v>
                </c:pt>
                <c:pt idx="468">
                  <c:v>24.486999999999998</c:v>
                </c:pt>
                <c:pt idx="469">
                  <c:v>24.196999999999999</c:v>
                </c:pt>
                <c:pt idx="470">
                  <c:v>23.917000000000002</c:v>
                </c:pt>
                <c:pt idx="471">
                  <c:v>23.628</c:v>
                </c:pt>
                <c:pt idx="472">
                  <c:v>23.349</c:v>
                </c:pt>
                <c:pt idx="473">
                  <c:v>23.047999999999998</c:v>
                </c:pt>
                <c:pt idx="474">
                  <c:v>22.768000000000001</c:v>
                </c:pt>
                <c:pt idx="475">
                  <c:v>22.478000000000002</c:v>
                </c:pt>
                <c:pt idx="476">
                  <c:v>22.190999999999999</c:v>
                </c:pt>
                <c:pt idx="477">
                  <c:v>21.905000000000001</c:v>
                </c:pt>
                <c:pt idx="478">
                  <c:v>21.611000000000001</c:v>
                </c:pt>
                <c:pt idx="479">
                  <c:v>21.327000000000002</c:v>
                </c:pt>
                <c:pt idx="480">
                  <c:v>21.036999999999999</c:v>
                </c:pt>
                <c:pt idx="481">
                  <c:v>20.742000000000001</c:v>
                </c:pt>
                <c:pt idx="482">
                  <c:v>20.462</c:v>
                </c:pt>
                <c:pt idx="483">
                  <c:v>20.166</c:v>
                </c:pt>
                <c:pt idx="484">
                  <c:v>19.896999999999998</c:v>
                </c:pt>
                <c:pt idx="485">
                  <c:v>19.619</c:v>
                </c:pt>
                <c:pt idx="486">
                  <c:v>19.356999999999999</c:v>
                </c:pt>
                <c:pt idx="487">
                  <c:v>19.091000000000001</c:v>
                </c:pt>
                <c:pt idx="488">
                  <c:v>18.832999999999998</c:v>
                </c:pt>
                <c:pt idx="489">
                  <c:v>18.579000000000001</c:v>
                </c:pt>
                <c:pt idx="490">
                  <c:v>18.327999999999999</c:v>
                </c:pt>
                <c:pt idx="491">
                  <c:v>18.085999999999999</c:v>
                </c:pt>
                <c:pt idx="492">
                  <c:v>17.856999999999999</c:v>
                </c:pt>
                <c:pt idx="493">
                  <c:v>17.623000000000001</c:v>
                </c:pt>
                <c:pt idx="494">
                  <c:v>17.408000000000001</c:v>
                </c:pt>
                <c:pt idx="495">
                  <c:v>17.184000000000001</c:v>
                </c:pt>
                <c:pt idx="496">
                  <c:v>16.98</c:v>
                </c:pt>
                <c:pt idx="497">
                  <c:v>16.77</c:v>
                </c:pt>
                <c:pt idx="498">
                  <c:v>16.576000000000001</c:v>
                </c:pt>
                <c:pt idx="499">
                  <c:v>16.387</c:v>
                </c:pt>
                <c:pt idx="500">
                  <c:v>16.207000000000001</c:v>
                </c:pt>
                <c:pt idx="501">
                  <c:v>16.033000000000001</c:v>
                </c:pt>
                <c:pt idx="502">
                  <c:v>15.858000000000001</c:v>
                </c:pt>
                <c:pt idx="503">
                  <c:v>15.699</c:v>
                </c:pt>
                <c:pt idx="504">
                  <c:v>15.54</c:v>
                </c:pt>
                <c:pt idx="505">
                  <c:v>15.378</c:v>
                </c:pt>
                <c:pt idx="506">
                  <c:v>15.234999999999999</c:v>
                </c:pt>
                <c:pt idx="507">
                  <c:v>15.085000000000001</c:v>
                </c:pt>
                <c:pt idx="508">
                  <c:v>14.942</c:v>
                </c:pt>
                <c:pt idx="509">
                  <c:v>14.798999999999999</c:v>
                </c:pt>
                <c:pt idx="510">
                  <c:v>14.656000000000001</c:v>
                </c:pt>
                <c:pt idx="511">
                  <c:v>14.523</c:v>
                </c:pt>
                <c:pt idx="512">
                  <c:v>14.394</c:v>
                </c:pt>
                <c:pt idx="513">
                  <c:v>14.272</c:v>
                </c:pt>
                <c:pt idx="514">
                  <c:v>14.151</c:v>
                </c:pt>
                <c:pt idx="515">
                  <c:v>14.031000000000001</c:v>
                </c:pt>
                <c:pt idx="516">
                  <c:v>13.919</c:v>
                </c:pt>
                <c:pt idx="517">
                  <c:v>13.807</c:v>
                </c:pt>
                <c:pt idx="518">
                  <c:v>13.706</c:v>
                </c:pt>
                <c:pt idx="519">
                  <c:v>13.606</c:v>
                </c:pt>
                <c:pt idx="520">
                  <c:v>13.513</c:v>
                </c:pt>
                <c:pt idx="521">
                  <c:v>13.414999999999999</c:v>
                </c:pt>
                <c:pt idx="522">
                  <c:v>13.316000000000001</c:v>
                </c:pt>
                <c:pt idx="523">
                  <c:v>13.224</c:v>
                </c:pt>
                <c:pt idx="524">
                  <c:v>13.132999999999999</c:v>
                </c:pt>
                <c:pt idx="525">
                  <c:v>13.051</c:v>
                </c:pt>
                <c:pt idx="526">
                  <c:v>12.968</c:v>
                </c:pt>
                <c:pt idx="527">
                  <c:v>12.882</c:v>
                </c:pt>
                <c:pt idx="528">
                  <c:v>12.803000000000001</c:v>
                </c:pt>
                <c:pt idx="529">
                  <c:v>12.727</c:v>
                </c:pt>
                <c:pt idx="530">
                  <c:v>12.654</c:v>
                </c:pt>
                <c:pt idx="531">
                  <c:v>12.584</c:v>
                </c:pt>
                <c:pt idx="532">
                  <c:v>12.518000000000001</c:v>
                </c:pt>
                <c:pt idx="533">
                  <c:v>12.451000000000001</c:v>
                </c:pt>
                <c:pt idx="534">
                  <c:v>12.387</c:v>
                </c:pt>
                <c:pt idx="535">
                  <c:v>12.326000000000001</c:v>
                </c:pt>
                <c:pt idx="536">
                  <c:v>12.263</c:v>
                </c:pt>
                <c:pt idx="537">
                  <c:v>12.21</c:v>
                </c:pt>
                <c:pt idx="538">
                  <c:v>12.153</c:v>
                </c:pt>
                <c:pt idx="539">
                  <c:v>12.101000000000001</c:v>
                </c:pt>
                <c:pt idx="540">
                  <c:v>12.052</c:v>
                </c:pt>
                <c:pt idx="541">
                  <c:v>12.007999999999999</c:v>
                </c:pt>
                <c:pt idx="542">
                  <c:v>11.952999999999999</c:v>
                </c:pt>
                <c:pt idx="543">
                  <c:v>11.911</c:v>
                </c:pt>
                <c:pt idx="544">
                  <c:v>11.87</c:v>
                </c:pt>
                <c:pt idx="545">
                  <c:v>11.831</c:v>
                </c:pt>
                <c:pt idx="546">
                  <c:v>11.795999999999999</c:v>
                </c:pt>
                <c:pt idx="547">
                  <c:v>11.754</c:v>
                </c:pt>
                <c:pt idx="548">
                  <c:v>11.715</c:v>
                </c:pt>
                <c:pt idx="549">
                  <c:v>11.678000000000001</c:v>
                </c:pt>
                <c:pt idx="550">
                  <c:v>11.64</c:v>
                </c:pt>
                <c:pt idx="551">
                  <c:v>11.609</c:v>
                </c:pt>
                <c:pt idx="552">
                  <c:v>11.581</c:v>
                </c:pt>
                <c:pt idx="553">
                  <c:v>11.551</c:v>
                </c:pt>
                <c:pt idx="554">
                  <c:v>11.515000000000001</c:v>
                </c:pt>
                <c:pt idx="555">
                  <c:v>11.473000000000001</c:v>
                </c:pt>
                <c:pt idx="556">
                  <c:v>11.446</c:v>
                </c:pt>
                <c:pt idx="557">
                  <c:v>11.412000000000001</c:v>
                </c:pt>
                <c:pt idx="558">
                  <c:v>11.385999999999999</c:v>
                </c:pt>
                <c:pt idx="559">
                  <c:v>11.356999999999999</c:v>
                </c:pt>
                <c:pt idx="560">
                  <c:v>11.324999999999999</c:v>
                </c:pt>
                <c:pt idx="561">
                  <c:v>11.305999999999999</c:v>
                </c:pt>
                <c:pt idx="562">
                  <c:v>11.291</c:v>
                </c:pt>
                <c:pt idx="563">
                  <c:v>11.28</c:v>
                </c:pt>
                <c:pt idx="564">
                  <c:v>11.269</c:v>
                </c:pt>
                <c:pt idx="565">
                  <c:v>11.26</c:v>
                </c:pt>
                <c:pt idx="566">
                  <c:v>11.252000000000001</c:v>
                </c:pt>
                <c:pt idx="567">
                  <c:v>11.244999999999999</c:v>
                </c:pt>
                <c:pt idx="568">
                  <c:v>11.244999999999999</c:v>
                </c:pt>
                <c:pt idx="569">
                  <c:v>11.241</c:v>
                </c:pt>
                <c:pt idx="570">
                  <c:v>11.238</c:v>
                </c:pt>
                <c:pt idx="571">
                  <c:v>11.24</c:v>
                </c:pt>
                <c:pt idx="572">
                  <c:v>11.24</c:v>
                </c:pt>
                <c:pt idx="573">
                  <c:v>11.244</c:v>
                </c:pt>
                <c:pt idx="574">
                  <c:v>11.247</c:v>
                </c:pt>
                <c:pt idx="575">
                  <c:v>11.25</c:v>
                </c:pt>
                <c:pt idx="576">
                  <c:v>11.250999999999999</c:v>
                </c:pt>
                <c:pt idx="577">
                  <c:v>11.253</c:v>
                </c:pt>
                <c:pt idx="578">
                  <c:v>11.253</c:v>
                </c:pt>
                <c:pt idx="579">
                  <c:v>11.260999999999999</c:v>
                </c:pt>
                <c:pt idx="580">
                  <c:v>11.265000000000001</c:v>
                </c:pt>
                <c:pt idx="581">
                  <c:v>11.266</c:v>
                </c:pt>
                <c:pt idx="582">
                  <c:v>11.269</c:v>
                </c:pt>
                <c:pt idx="583">
                  <c:v>11.266</c:v>
                </c:pt>
                <c:pt idx="584">
                  <c:v>11.266</c:v>
                </c:pt>
                <c:pt idx="585">
                  <c:v>11.276</c:v>
                </c:pt>
                <c:pt idx="586">
                  <c:v>11.287000000000001</c:v>
                </c:pt>
                <c:pt idx="587">
                  <c:v>11.297000000000001</c:v>
                </c:pt>
                <c:pt idx="588">
                  <c:v>11.308</c:v>
                </c:pt>
                <c:pt idx="589">
                  <c:v>11.31</c:v>
                </c:pt>
                <c:pt idx="590">
                  <c:v>11.314</c:v>
                </c:pt>
                <c:pt idx="591">
                  <c:v>11.316000000000001</c:v>
                </c:pt>
                <c:pt idx="592">
                  <c:v>11.316000000000001</c:v>
                </c:pt>
                <c:pt idx="593">
                  <c:v>11.319000000000001</c:v>
                </c:pt>
                <c:pt idx="594">
                  <c:v>11.326000000000001</c:v>
                </c:pt>
                <c:pt idx="595">
                  <c:v>11.33</c:v>
                </c:pt>
                <c:pt idx="596">
                  <c:v>11.331</c:v>
                </c:pt>
                <c:pt idx="597">
                  <c:v>11.336</c:v>
                </c:pt>
                <c:pt idx="598">
                  <c:v>11.334</c:v>
                </c:pt>
                <c:pt idx="599">
                  <c:v>11.339</c:v>
                </c:pt>
                <c:pt idx="600">
                  <c:v>11.343</c:v>
                </c:pt>
                <c:pt idx="601">
                  <c:v>11.346</c:v>
                </c:pt>
                <c:pt idx="602">
                  <c:v>11.347</c:v>
                </c:pt>
                <c:pt idx="603">
                  <c:v>11.345000000000001</c:v>
                </c:pt>
                <c:pt idx="604">
                  <c:v>11.336</c:v>
                </c:pt>
                <c:pt idx="605">
                  <c:v>11.334</c:v>
                </c:pt>
                <c:pt idx="606">
                  <c:v>11.327</c:v>
                </c:pt>
                <c:pt idx="607">
                  <c:v>11.316000000000001</c:v>
                </c:pt>
                <c:pt idx="608">
                  <c:v>11.307</c:v>
                </c:pt>
                <c:pt idx="609">
                  <c:v>11.29</c:v>
                </c:pt>
                <c:pt idx="610">
                  <c:v>11.27</c:v>
                </c:pt>
                <c:pt idx="611">
                  <c:v>11.244</c:v>
                </c:pt>
                <c:pt idx="612">
                  <c:v>11.215</c:v>
                </c:pt>
                <c:pt idx="613">
                  <c:v>11.18</c:v>
                </c:pt>
                <c:pt idx="614">
                  <c:v>11.137</c:v>
                </c:pt>
                <c:pt idx="615">
                  <c:v>11.092000000000001</c:v>
                </c:pt>
                <c:pt idx="616">
                  <c:v>11.042</c:v>
                </c:pt>
                <c:pt idx="617">
                  <c:v>10.994</c:v>
                </c:pt>
                <c:pt idx="618">
                  <c:v>10.933999999999999</c:v>
                </c:pt>
                <c:pt idx="619">
                  <c:v>10.867000000000001</c:v>
                </c:pt>
                <c:pt idx="620">
                  <c:v>10.792999999999999</c:v>
                </c:pt>
                <c:pt idx="621">
                  <c:v>10.707000000000001</c:v>
                </c:pt>
                <c:pt idx="622">
                  <c:v>10.616</c:v>
                </c:pt>
                <c:pt idx="623">
                  <c:v>10.513</c:v>
                </c:pt>
                <c:pt idx="624">
                  <c:v>10.398</c:v>
                </c:pt>
                <c:pt idx="625">
                  <c:v>10.278</c:v>
                </c:pt>
                <c:pt idx="626">
                  <c:v>10.148999999999999</c:v>
                </c:pt>
                <c:pt idx="627">
                  <c:v>10.02</c:v>
                </c:pt>
                <c:pt idx="628">
                  <c:v>9.8729999999999993</c:v>
                </c:pt>
                <c:pt idx="629">
                  <c:v>9.7240000000000002</c:v>
                </c:pt>
                <c:pt idx="630">
                  <c:v>9.5660000000000007</c:v>
                </c:pt>
                <c:pt idx="631">
                  <c:v>9.3989999999999991</c:v>
                </c:pt>
                <c:pt idx="632">
                  <c:v>9.2249999999999996</c:v>
                </c:pt>
                <c:pt idx="633">
                  <c:v>9.0419999999999998</c:v>
                </c:pt>
                <c:pt idx="634">
                  <c:v>8.8510000000000009</c:v>
                </c:pt>
                <c:pt idx="635">
                  <c:v>8.6639999999999997</c:v>
                </c:pt>
                <c:pt idx="636">
                  <c:v>8.4640000000000004</c:v>
                </c:pt>
                <c:pt idx="637">
                  <c:v>8.2680000000000007</c:v>
                </c:pt>
                <c:pt idx="638">
                  <c:v>8.0640000000000001</c:v>
                </c:pt>
                <c:pt idx="639">
                  <c:v>7.8659999999999997</c:v>
                </c:pt>
                <c:pt idx="640">
                  <c:v>7.6559999999999997</c:v>
                </c:pt>
                <c:pt idx="641">
                  <c:v>7.444</c:v>
                </c:pt>
                <c:pt idx="642">
                  <c:v>7.2380000000000004</c:v>
                </c:pt>
                <c:pt idx="643">
                  <c:v>7.0339999999999998</c:v>
                </c:pt>
                <c:pt idx="644">
                  <c:v>6.8360000000000003</c:v>
                </c:pt>
                <c:pt idx="645">
                  <c:v>6.6379999999999999</c:v>
                </c:pt>
                <c:pt idx="646">
                  <c:v>6.44</c:v>
                </c:pt>
                <c:pt idx="647">
                  <c:v>6.2560000000000002</c:v>
                </c:pt>
                <c:pt idx="648">
                  <c:v>6.0650000000000004</c:v>
                </c:pt>
                <c:pt idx="649">
                  <c:v>5.891</c:v>
                </c:pt>
                <c:pt idx="650">
                  <c:v>5.7089999999999996</c:v>
                </c:pt>
                <c:pt idx="651">
                  <c:v>5.5449999999999999</c:v>
                </c:pt>
                <c:pt idx="652">
                  <c:v>5.3819999999999997</c:v>
                </c:pt>
                <c:pt idx="653">
                  <c:v>5.218</c:v>
                </c:pt>
                <c:pt idx="654">
                  <c:v>5.0720000000000001</c:v>
                </c:pt>
                <c:pt idx="655">
                  <c:v>4.93</c:v>
                </c:pt>
                <c:pt idx="656">
                  <c:v>4.7960000000000003</c:v>
                </c:pt>
                <c:pt idx="657">
                  <c:v>4.6689999999999996</c:v>
                </c:pt>
                <c:pt idx="658">
                  <c:v>4.5449999999999999</c:v>
                </c:pt>
                <c:pt idx="659">
                  <c:v>4.4359999999999999</c:v>
                </c:pt>
                <c:pt idx="660">
                  <c:v>4.3259999999999996</c:v>
                </c:pt>
                <c:pt idx="661">
                  <c:v>4.2300000000000004</c:v>
                </c:pt>
                <c:pt idx="662">
                  <c:v>4.133</c:v>
                </c:pt>
                <c:pt idx="663">
                  <c:v>4.0430000000000001</c:v>
                </c:pt>
                <c:pt idx="664">
                  <c:v>3.9630000000000001</c:v>
                </c:pt>
                <c:pt idx="665">
                  <c:v>3.8809999999999998</c:v>
                </c:pt>
                <c:pt idx="666">
                  <c:v>3.8140000000000001</c:v>
                </c:pt>
                <c:pt idx="667">
                  <c:v>3.75</c:v>
                </c:pt>
                <c:pt idx="668">
                  <c:v>3.6789999999999998</c:v>
                </c:pt>
                <c:pt idx="669">
                  <c:v>3.62</c:v>
                </c:pt>
                <c:pt idx="670">
                  <c:v>3.56</c:v>
                </c:pt>
                <c:pt idx="671">
                  <c:v>3.508</c:v>
                </c:pt>
                <c:pt idx="672">
                  <c:v>3.46</c:v>
                </c:pt>
                <c:pt idx="673">
                  <c:v>3.411</c:v>
                </c:pt>
                <c:pt idx="674">
                  <c:v>3.3690000000000002</c:v>
                </c:pt>
                <c:pt idx="675">
                  <c:v>3.32</c:v>
                </c:pt>
                <c:pt idx="676">
                  <c:v>3.2839999999999998</c:v>
                </c:pt>
                <c:pt idx="677">
                  <c:v>3.2469999999999999</c:v>
                </c:pt>
                <c:pt idx="678">
                  <c:v>3.2109999999999999</c:v>
                </c:pt>
                <c:pt idx="679">
                  <c:v>3.18</c:v>
                </c:pt>
                <c:pt idx="680">
                  <c:v>3.1549999999999998</c:v>
                </c:pt>
                <c:pt idx="681">
                  <c:v>3.133</c:v>
                </c:pt>
                <c:pt idx="682">
                  <c:v>3.11</c:v>
                </c:pt>
                <c:pt idx="683">
                  <c:v>3.09</c:v>
                </c:pt>
                <c:pt idx="684">
                  <c:v>3.0710000000000002</c:v>
                </c:pt>
                <c:pt idx="685">
                  <c:v>3.0579999999999998</c:v>
                </c:pt>
                <c:pt idx="686">
                  <c:v>3.048</c:v>
                </c:pt>
                <c:pt idx="687">
                  <c:v>3.0350000000000001</c:v>
                </c:pt>
                <c:pt idx="688">
                  <c:v>3.0249999999999999</c:v>
                </c:pt>
                <c:pt idx="689">
                  <c:v>3.012</c:v>
                </c:pt>
                <c:pt idx="690">
                  <c:v>3.0070000000000001</c:v>
                </c:pt>
                <c:pt idx="691">
                  <c:v>3.0089999999999999</c:v>
                </c:pt>
                <c:pt idx="692">
                  <c:v>3.0059999999999998</c:v>
                </c:pt>
                <c:pt idx="693">
                  <c:v>3.004</c:v>
                </c:pt>
                <c:pt idx="694">
                  <c:v>2.9950000000000001</c:v>
                </c:pt>
                <c:pt idx="695">
                  <c:v>2.9889999999999999</c:v>
                </c:pt>
                <c:pt idx="696">
                  <c:v>2.9830000000000001</c:v>
                </c:pt>
                <c:pt idx="697">
                  <c:v>2.9780000000000002</c:v>
                </c:pt>
                <c:pt idx="698">
                  <c:v>2.98</c:v>
                </c:pt>
                <c:pt idx="699">
                  <c:v>2.984</c:v>
                </c:pt>
                <c:pt idx="700">
                  <c:v>2.9830000000000001</c:v>
                </c:pt>
                <c:pt idx="701">
                  <c:v>2.9849999999999999</c:v>
                </c:pt>
                <c:pt idx="702">
                  <c:v>2.9809999999999999</c:v>
                </c:pt>
                <c:pt idx="703">
                  <c:v>2.976</c:v>
                </c:pt>
                <c:pt idx="704">
                  <c:v>2.9769999999999999</c:v>
                </c:pt>
                <c:pt idx="705">
                  <c:v>2.9780000000000002</c:v>
                </c:pt>
                <c:pt idx="706">
                  <c:v>2.9780000000000002</c:v>
                </c:pt>
                <c:pt idx="707">
                  <c:v>2.9769999999999999</c:v>
                </c:pt>
                <c:pt idx="708">
                  <c:v>2.9820000000000002</c:v>
                </c:pt>
                <c:pt idx="709">
                  <c:v>2.99</c:v>
                </c:pt>
                <c:pt idx="710">
                  <c:v>2.9980000000000002</c:v>
                </c:pt>
                <c:pt idx="711">
                  <c:v>3.008</c:v>
                </c:pt>
                <c:pt idx="712">
                  <c:v>3.0179999999999998</c:v>
                </c:pt>
                <c:pt idx="713">
                  <c:v>3.0329999999999999</c:v>
                </c:pt>
                <c:pt idx="714">
                  <c:v>3.048</c:v>
                </c:pt>
                <c:pt idx="715">
                  <c:v>3.0659999999999998</c:v>
                </c:pt>
                <c:pt idx="716">
                  <c:v>3.081</c:v>
                </c:pt>
                <c:pt idx="717">
                  <c:v>3.0920000000000001</c:v>
                </c:pt>
                <c:pt idx="718">
                  <c:v>3.1070000000000002</c:v>
                </c:pt>
                <c:pt idx="719">
                  <c:v>3.121</c:v>
                </c:pt>
                <c:pt idx="720">
                  <c:v>3.133</c:v>
                </c:pt>
                <c:pt idx="721">
                  <c:v>3.149</c:v>
                </c:pt>
                <c:pt idx="722">
                  <c:v>3.169</c:v>
                </c:pt>
                <c:pt idx="723">
                  <c:v>3.1850000000000001</c:v>
                </c:pt>
                <c:pt idx="724">
                  <c:v>3.21</c:v>
                </c:pt>
                <c:pt idx="725">
                  <c:v>3.2309999999999999</c:v>
                </c:pt>
                <c:pt idx="726">
                  <c:v>3.2530000000000001</c:v>
                </c:pt>
                <c:pt idx="727">
                  <c:v>3.2719999999999998</c:v>
                </c:pt>
                <c:pt idx="728">
                  <c:v>3.2919999999999998</c:v>
                </c:pt>
                <c:pt idx="729">
                  <c:v>3.3149999999999999</c:v>
                </c:pt>
                <c:pt idx="730">
                  <c:v>3.3420000000000001</c:v>
                </c:pt>
                <c:pt idx="731">
                  <c:v>3.3719999999999999</c:v>
                </c:pt>
                <c:pt idx="732">
                  <c:v>3.4009999999999998</c:v>
                </c:pt>
                <c:pt idx="733">
                  <c:v>3.4289999999999998</c:v>
                </c:pt>
                <c:pt idx="734">
                  <c:v>3.4510000000000001</c:v>
                </c:pt>
                <c:pt idx="735">
                  <c:v>3.4740000000000002</c:v>
                </c:pt>
                <c:pt idx="736">
                  <c:v>3.4969999999999999</c:v>
                </c:pt>
                <c:pt idx="737">
                  <c:v>3.53</c:v>
                </c:pt>
                <c:pt idx="738">
                  <c:v>3.5569999999999999</c:v>
                </c:pt>
                <c:pt idx="739">
                  <c:v>3.581</c:v>
                </c:pt>
                <c:pt idx="740">
                  <c:v>3.609</c:v>
                </c:pt>
                <c:pt idx="741">
                  <c:v>3.6339999999999999</c:v>
                </c:pt>
                <c:pt idx="742">
                  <c:v>3.6709999999999998</c:v>
                </c:pt>
                <c:pt idx="743">
                  <c:v>3.7050000000000001</c:v>
                </c:pt>
                <c:pt idx="744">
                  <c:v>3.7360000000000002</c:v>
                </c:pt>
                <c:pt idx="745">
                  <c:v>3.77</c:v>
                </c:pt>
                <c:pt idx="746">
                  <c:v>3.7959999999999998</c:v>
                </c:pt>
                <c:pt idx="747">
                  <c:v>3.823</c:v>
                </c:pt>
                <c:pt idx="748">
                  <c:v>3.8580000000000001</c:v>
                </c:pt>
                <c:pt idx="749">
                  <c:v>3.8879999999999999</c:v>
                </c:pt>
                <c:pt idx="750">
                  <c:v>3.9279999999999999</c:v>
                </c:pt>
                <c:pt idx="751">
                  <c:v>3.9630000000000001</c:v>
                </c:pt>
                <c:pt idx="752">
                  <c:v>3.9990000000000001</c:v>
                </c:pt>
                <c:pt idx="753">
                  <c:v>4.0380000000000003</c:v>
                </c:pt>
                <c:pt idx="754">
                  <c:v>4.0789999999999997</c:v>
                </c:pt>
                <c:pt idx="755">
                  <c:v>4.1230000000000002</c:v>
                </c:pt>
                <c:pt idx="756">
                  <c:v>4.1779999999999999</c:v>
                </c:pt>
                <c:pt idx="757">
                  <c:v>4.2350000000000003</c:v>
                </c:pt>
                <c:pt idx="758">
                  <c:v>4.298</c:v>
                </c:pt>
                <c:pt idx="759">
                  <c:v>4.3710000000000004</c:v>
                </c:pt>
                <c:pt idx="760">
                  <c:v>4.4560000000000004</c:v>
                </c:pt>
                <c:pt idx="761">
                  <c:v>4.5529999999999999</c:v>
                </c:pt>
                <c:pt idx="762">
                  <c:v>4.6680000000000001</c:v>
                </c:pt>
                <c:pt idx="763">
                  <c:v>4.7939999999999996</c:v>
                </c:pt>
                <c:pt idx="764">
                  <c:v>4.9550000000000001</c:v>
                </c:pt>
                <c:pt idx="765">
                  <c:v>5.1340000000000003</c:v>
                </c:pt>
                <c:pt idx="766">
                  <c:v>5.335</c:v>
                </c:pt>
                <c:pt idx="767">
                  <c:v>5.5549999999999997</c:v>
                </c:pt>
                <c:pt idx="768">
                  <c:v>5.7750000000000004</c:v>
                </c:pt>
                <c:pt idx="769">
                  <c:v>5.9969999999999999</c:v>
                </c:pt>
                <c:pt idx="770">
                  <c:v>6.22</c:v>
                </c:pt>
                <c:pt idx="771">
                  <c:v>6.4580000000000002</c:v>
                </c:pt>
                <c:pt idx="772">
                  <c:v>6.7130000000000001</c:v>
                </c:pt>
                <c:pt idx="773">
                  <c:v>6.9720000000000004</c:v>
                </c:pt>
                <c:pt idx="774">
                  <c:v>7.2729999999999997</c:v>
                </c:pt>
                <c:pt idx="775">
                  <c:v>7.6879999999999997</c:v>
                </c:pt>
                <c:pt idx="776">
                  <c:v>8.202</c:v>
                </c:pt>
                <c:pt idx="777">
                  <c:v>8.6479999999999997</c:v>
                </c:pt>
                <c:pt idx="778">
                  <c:v>8.9559999999999995</c:v>
                </c:pt>
                <c:pt idx="779">
                  <c:v>9.0489999999999995</c:v>
                </c:pt>
                <c:pt idx="780">
                  <c:v>9.0879999999999992</c:v>
                </c:pt>
                <c:pt idx="781">
                  <c:v>9.1690000000000005</c:v>
                </c:pt>
                <c:pt idx="782">
                  <c:v>9.2439999999999998</c:v>
                </c:pt>
                <c:pt idx="783">
                  <c:v>9.2270000000000003</c:v>
                </c:pt>
                <c:pt idx="784">
                  <c:v>9.1340000000000003</c:v>
                </c:pt>
                <c:pt idx="785">
                  <c:v>8.9689999999999994</c:v>
                </c:pt>
                <c:pt idx="786">
                  <c:v>8.8580000000000005</c:v>
                </c:pt>
                <c:pt idx="787">
                  <c:v>8.8279999999999994</c:v>
                </c:pt>
                <c:pt idx="788">
                  <c:v>8.8480000000000008</c:v>
                </c:pt>
                <c:pt idx="789">
                  <c:v>8.8879999999999999</c:v>
                </c:pt>
                <c:pt idx="790">
                  <c:v>8.9369999999999994</c:v>
                </c:pt>
                <c:pt idx="791">
                  <c:v>8.9749999999999996</c:v>
                </c:pt>
                <c:pt idx="792">
                  <c:v>8.9830000000000005</c:v>
                </c:pt>
                <c:pt idx="793">
                  <c:v>8.9480000000000004</c:v>
                </c:pt>
                <c:pt idx="794">
                  <c:v>8.8689999999999998</c:v>
                </c:pt>
                <c:pt idx="795">
                  <c:v>8.75</c:v>
                </c:pt>
                <c:pt idx="796">
                  <c:v>8.5850000000000009</c:v>
                </c:pt>
                <c:pt idx="797">
                  <c:v>8.3849999999999998</c:v>
                </c:pt>
                <c:pt idx="798">
                  <c:v>8.1539999999999999</c:v>
                </c:pt>
                <c:pt idx="799">
                  <c:v>7.8920000000000003</c:v>
                </c:pt>
                <c:pt idx="800">
                  <c:v>7.6189999999999998</c:v>
                </c:pt>
                <c:pt idx="801">
                  <c:v>7.3230000000000004</c:v>
                </c:pt>
                <c:pt idx="802">
                  <c:v>7.0419999999999998</c:v>
                </c:pt>
                <c:pt idx="803">
                  <c:v>6.7439999999999998</c:v>
                </c:pt>
                <c:pt idx="804">
                  <c:v>6.476</c:v>
                </c:pt>
                <c:pt idx="805">
                  <c:v>6.2030000000000003</c:v>
                </c:pt>
                <c:pt idx="806">
                  <c:v>5.9509999999999996</c:v>
                </c:pt>
                <c:pt idx="807">
                  <c:v>5.7190000000000003</c:v>
                </c:pt>
                <c:pt idx="808">
                  <c:v>5.484</c:v>
                </c:pt>
                <c:pt idx="809">
                  <c:v>5.2709999999999999</c:v>
                </c:pt>
                <c:pt idx="810">
                  <c:v>5.0650000000000004</c:v>
                </c:pt>
                <c:pt idx="811">
                  <c:v>4.8730000000000002</c:v>
                </c:pt>
                <c:pt idx="812">
                  <c:v>4.694</c:v>
                </c:pt>
                <c:pt idx="813">
                  <c:v>4.5140000000000002</c:v>
                </c:pt>
                <c:pt idx="814">
                  <c:v>4.3499999999999996</c:v>
                </c:pt>
                <c:pt idx="815">
                  <c:v>4.1909999999999998</c:v>
                </c:pt>
                <c:pt idx="816">
                  <c:v>4.0419999999999998</c:v>
                </c:pt>
                <c:pt idx="817">
                  <c:v>3.8980000000000001</c:v>
                </c:pt>
                <c:pt idx="818">
                  <c:v>3.7639999999999998</c:v>
                </c:pt>
                <c:pt idx="819">
                  <c:v>3.6440000000000001</c:v>
                </c:pt>
                <c:pt idx="820">
                  <c:v>3.5270000000000001</c:v>
                </c:pt>
                <c:pt idx="821">
                  <c:v>3.4169999999999998</c:v>
                </c:pt>
                <c:pt idx="822">
                  <c:v>3.3029999999999999</c:v>
                </c:pt>
                <c:pt idx="823">
                  <c:v>3.1850000000000001</c:v>
                </c:pt>
                <c:pt idx="824">
                  <c:v>3.081</c:v>
                </c:pt>
                <c:pt idx="825">
                  <c:v>2.976</c:v>
                </c:pt>
                <c:pt idx="826">
                  <c:v>2.8780000000000001</c:v>
                </c:pt>
                <c:pt idx="827">
                  <c:v>2.79</c:v>
                </c:pt>
                <c:pt idx="828">
                  <c:v>2.702</c:v>
                </c:pt>
                <c:pt idx="829">
                  <c:v>2.6269999999999998</c:v>
                </c:pt>
                <c:pt idx="830">
                  <c:v>2.5499999999999998</c:v>
                </c:pt>
                <c:pt idx="831">
                  <c:v>2.4809999999999999</c:v>
                </c:pt>
                <c:pt idx="832">
                  <c:v>2.4089999999999998</c:v>
                </c:pt>
                <c:pt idx="833">
                  <c:v>2.3359999999999999</c:v>
                </c:pt>
                <c:pt idx="834">
                  <c:v>2.2669999999999999</c:v>
                </c:pt>
                <c:pt idx="835">
                  <c:v>2.194</c:v>
                </c:pt>
                <c:pt idx="836">
                  <c:v>2.12</c:v>
                </c:pt>
                <c:pt idx="837">
                  <c:v>2.0459999999999998</c:v>
                </c:pt>
                <c:pt idx="838">
                  <c:v>1.98</c:v>
                </c:pt>
                <c:pt idx="839">
                  <c:v>1.9139999999999999</c:v>
                </c:pt>
                <c:pt idx="840">
                  <c:v>1.847</c:v>
                </c:pt>
                <c:pt idx="841">
                  <c:v>1.7849999999999999</c:v>
                </c:pt>
                <c:pt idx="842">
                  <c:v>1.7170000000000001</c:v>
                </c:pt>
                <c:pt idx="843">
                  <c:v>1.651</c:v>
                </c:pt>
                <c:pt idx="844">
                  <c:v>1.589</c:v>
                </c:pt>
                <c:pt idx="845">
                  <c:v>1.5249999999999999</c:v>
                </c:pt>
                <c:pt idx="846">
                  <c:v>1.464</c:v>
                </c:pt>
                <c:pt idx="847">
                  <c:v>1.4039999999999999</c:v>
                </c:pt>
                <c:pt idx="848">
                  <c:v>1.343</c:v>
                </c:pt>
                <c:pt idx="849">
                  <c:v>1.2869999999999999</c:v>
                </c:pt>
                <c:pt idx="850">
                  <c:v>1.2330000000000001</c:v>
                </c:pt>
                <c:pt idx="851">
                  <c:v>1.18</c:v>
                </c:pt>
                <c:pt idx="852">
                  <c:v>1.127</c:v>
                </c:pt>
                <c:pt idx="853">
                  <c:v>1.079</c:v>
                </c:pt>
                <c:pt idx="854">
                  <c:v>1.0349999999999999</c:v>
                </c:pt>
                <c:pt idx="855">
                  <c:v>0.98699999999999999</c:v>
                </c:pt>
                <c:pt idx="856">
                  <c:v>0.94399999999999995</c:v>
                </c:pt>
                <c:pt idx="857">
                  <c:v>0.90700000000000003</c:v>
                </c:pt>
                <c:pt idx="858">
                  <c:v>0.87</c:v>
                </c:pt>
                <c:pt idx="859">
                  <c:v>0.84599999999999997</c:v>
                </c:pt>
                <c:pt idx="860">
                  <c:v>0.82</c:v>
                </c:pt>
                <c:pt idx="861">
                  <c:v>0.80100000000000005</c:v>
                </c:pt>
                <c:pt idx="862">
                  <c:v>0.78600000000000003</c:v>
                </c:pt>
                <c:pt idx="863">
                  <c:v>0.77400000000000002</c:v>
                </c:pt>
                <c:pt idx="864">
                  <c:v>0.77100000000000002</c:v>
                </c:pt>
                <c:pt idx="865">
                  <c:v>0.76700000000000002</c:v>
                </c:pt>
                <c:pt idx="866">
                  <c:v>0.76500000000000001</c:v>
                </c:pt>
                <c:pt idx="867">
                  <c:v>0.76400000000000001</c:v>
                </c:pt>
                <c:pt idx="868">
                  <c:v>0.77100000000000002</c:v>
                </c:pt>
                <c:pt idx="869">
                  <c:v>0.78500000000000003</c:v>
                </c:pt>
                <c:pt idx="870">
                  <c:v>0.80600000000000005</c:v>
                </c:pt>
                <c:pt idx="871">
                  <c:v>0.82899999999999996</c:v>
                </c:pt>
                <c:pt idx="872">
                  <c:v>0.84799999999999998</c:v>
                </c:pt>
                <c:pt idx="873">
                  <c:v>0.86699999999999999</c:v>
                </c:pt>
                <c:pt idx="874">
                  <c:v>0.872</c:v>
                </c:pt>
                <c:pt idx="875">
                  <c:v>0.877</c:v>
                </c:pt>
                <c:pt idx="876">
                  <c:v>0.873</c:v>
                </c:pt>
                <c:pt idx="877">
                  <c:v>0.86</c:v>
                </c:pt>
                <c:pt idx="878">
                  <c:v>0.84199999999999997</c:v>
                </c:pt>
                <c:pt idx="879">
                  <c:v>0.82099999999999995</c:v>
                </c:pt>
                <c:pt idx="880">
                  <c:v>0.80300000000000005</c:v>
                </c:pt>
                <c:pt idx="881">
                  <c:v>0.77400000000000002</c:v>
                </c:pt>
                <c:pt idx="882">
                  <c:v>0.74</c:v>
                </c:pt>
                <c:pt idx="883">
                  <c:v>0.70099999999999996</c:v>
                </c:pt>
                <c:pt idx="884">
                  <c:v>0.66200000000000003</c:v>
                </c:pt>
                <c:pt idx="885">
                  <c:v>0.61899999999999999</c:v>
                </c:pt>
                <c:pt idx="886">
                  <c:v>0.57799999999999996</c:v>
                </c:pt>
                <c:pt idx="887">
                  <c:v>0.53600000000000003</c:v>
                </c:pt>
                <c:pt idx="888">
                  <c:v>0.497</c:v>
                </c:pt>
                <c:pt idx="889">
                  <c:v>0.46100000000000002</c:v>
                </c:pt>
                <c:pt idx="890">
                  <c:v>0.42899999999999999</c:v>
                </c:pt>
                <c:pt idx="891">
                  <c:v>0.39800000000000002</c:v>
                </c:pt>
                <c:pt idx="892">
                  <c:v>0.371</c:v>
                </c:pt>
                <c:pt idx="893">
                  <c:v>0.34899999999999998</c:v>
                </c:pt>
                <c:pt idx="894">
                  <c:v>0.33</c:v>
                </c:pt>
                <c:pt idx="895">
                  <c:v>0.308</c:v>
                </c:pt>
                <c:pt idx="896">
                  <c:v>0.29399999999999998</c:v>
                </c:pt>
                <c:pt idx="897">
                  <c:v>0.28199999999999997</c:v>
                </c:pt>
                <c:pt idx="898">
                  <c:v>0.27</c:v>
                </c:pt>
                <c:pt idx="899">
                  <c:v>0.25800000000000001</c:v>
                </c:pt>
                <c:pt idx="900">
                  <c:v>0.245</c:v>
                </c:pt>
                <c:pt idx="901">
                  <c:v>0.23499999999999999</c:v>
                </c:pt>
                <c:pt idx="902">
                  <c:v>0.22700000000000001</c:v>
                </c:pt>
                <c:pt idx="903">
                  <c:v>0.215</c:v>
                </c:pt>
                <c:pt idx="904">
                  <c:v>0.20599999999999999</c:v>
                </c:pt>
                <c:pt idx="905">
                  <c:v>0.19500000000000001</c:v>
                </c:pt>
                <c:pt idx="906">
                  <c:v>0.193</c:v>
                </c:pt>
                <c:pt idx="907">
                  <c:v>0.187</c:v>
                </c:pt>
                <c:pt idx="908">
                  <c:v>0.18099999999999999</c:v>
                </c:pt>
                <c:pt idx="909">
                  <c:v>0.17399999999999999</c:v>
                </c:pt>
                <c:pt idx="910">
                  <c:v>0.16700000000000001</c:v>
                </c:pt>
                <c:pt idx="911">
                  <c:v>0.158</c:v>
                </c:pt>
                <c:pt idx="912">
                  <c:v>0.152</c:v>
                </c:pt>
                <c:pt idx="913">
                  <c:v>0.14099999999999999</c:v>
                </c:pt>
                <c:pt idx="914">
                  <c:v>0.13200000000000001</c:v>
                </c:pt>
                <c:pt idx="915">
                  <c:v>0.123</c:v>
                </c:pt>
                <c:pt idx="916">
                  <c:v>0.125</c:v>
                </c:pt>
                <c:pt idx="917">
                  <c:v>0.126</c:v>
                </c:pt>
                <c:pt idx="918">
                  <c:v>0.125</c:v>
                </c:pt>
                <c:pt idx="919">
                  <c:v>0.124</c:v>
                </c:pt>
                <c:pt idx="920">
                  <c:v>0.121</c:v>
                </c:pt>
                <c:pt idx="921">
                  <c:v>0.12</c:v>
                </c:pt>
                <c:pt idx="922">
                  <c:v>0.11700000000000001</c:v>
                </c:pt>
                <c:pt idx="923">
                  <c:v>0.113</c:v>
                </c:pt>
                <c:pt idx="924">
                  <c:v>0.11</c:v>
                </c:pt>
                <c:pt idx="925">
                  <c:v>0.10299999999999999</c:v>
                </c:pt>
                <c:pt idx="926">
                  <c:v>0.104</c:v>
                </c:pt>
                <c:pt idx="927">
                  <c:v>0.11</c:v>
                </c:pt>
                <c:pt idx="928">
                  <c:v>0.11</c:v>
                </c:pt>
                <c:pt idx="929">
                  <c:v>0.112</c:v>
                </c:pt>
                <c:pt idx="930">
                  <c:v>0.105</c:v>
                </c:pt>
                <c:pt idx="931">
                  <c:v>0.10100000000000001</c:v>
                </c:pt>
                <c:pt idx="932">
                  <c:v>9.9000000000000005E-2</c:v>
                </c:pt>
                <c:pt idx="933">
                  <c:v>9.8000000000000004E-2</c:v>
                </c:pt>
                <c:pt idx="934">
                  <c:v>0.105</c:v>
                </c:pt>
                <c:pt idx="935">
                  <c:v>0.106</c:v>
                </c:pt>
                <c:pt idx="936">
                  <c:v>0.10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52B-274D-9532-C09E012E20DD}"/>
            </c:ext>
          </c:extLst>
        </c:ser>
        <c:ser>
          <c:idx val="1"/>
          <c:order val="1"/>
          <c:marker>
            <c:symbol val="none"/>
          </c:marker>
          <c:xVal>
            <c:numRef>
              <c:f>Curves!$A$5:$A$941</c:f>
              <c:numCache>
                <c:formatCode>###0.00</c:formatCode>
                <c:ptCount val="937"/>
                <c:pt idx="0">
                  <c:v>2.658310554036936E-2</c:v>
                </c:pt>
                <c:pt idx="1">
                  <c:v>5.3166211080738719E-2</c:v>
                </c:pt>
                <c:pt idx="2">
                  <c:v>7.9749316621108082E-2</c:v>
                </c:pt>
                <c:pt idx="3">
                  <c:v>0.10633242216147744</c:v>
                </c:pt>
                <c:pt idx="4">
                  <c:v>0.13291552770184681</c:v>
                </c:pt>
                <c:pt idx="5">
                  <c:v>0.15949863324221616</c:v>
                </c:pt>
                <c:pt idx="6">
                  <c:v>0.18608173878258552</c:v>
                </c:pt>
                <c:pt idx="7">
                  <c:v>0.21266484432295488</c:v>
                </c:pt>
                <c:pt idx="8">
                  <c:v>0.23924794986332423</c:v>
                </c:pt>
                <c:pt idx="9">
                  <c:v>0.26583105540369362</c:v>
                </c:pt>
                <c:pt idx="10">
                  <c:v>0.29241416094406297</c:v>
                </c:pt>
                <c:pt idx="11">
                  <c:v>0.31899726648443233</c:v>
                </c:pt>
                <c:pt idx="12">
                  <c:v>0.34558037202480169</c:v>
                </c:pt>
                <c:pt idx="13">
                  <c:v>0.37216347756517104</c:v>
                </c:pt>
                <c:pt idx="14">
                  <c:v>0.3987465831055404</c:v>
                </c:pt>
                <c:pt idx="15">
                  <c:v>0.42532968864590975</c:v>
                </c:pt>
                <c:pt idx="16">
                  <c:v>0.45191279418627911</c:v>
                </c:pt>
                <c:pt idx="17">
                  <c:v>0.47849589972664847</c:v>
                </c:pt>
                <c:pt idx="18">
                  <c:v>0.50507900526701788</c:v>
                </c:pt>
                <c:pt idx="19">
                  <c:v>0.53166211080738723</c:v>
                </c:pt>
                <c:pt idx="20">
                  <c:v>0.55824521634775659</c:v>
                </c:pt>
                <c:pt idx="21">
                  <c:v>0.58482832188812595</c:v>
                </c:pt>
                <c:pt idx="22">
                  <c:v>0.6114114274284953</c:v>
                </c:pt>
                <c:pt idx="23">
                  <c:v>0.63799453296886466</c:v>
                </c:pt>
                <c:pt idx="24">
                  <c:v>0.66457763850923401</c:v>
                </c:pt>
                <c:pt idx="25">
                  <c:v>0.69116074404960337</c:v>
                </c:pt>
                <c:pt idx="26">
                  <c:v>0.71774384958997273</c:v>
                </c:pt>
                <c:pt idx="27">
                  <c:v>0.74432695513034208</c:v>
                </c:pt>
                <c:pt idx="28">
                  <c:v>0.77091006067071144</c:v>
                </c:pt>
                <c:pt idx="29">
                  <c:v>0.7974931662110808</c:v>
                </c:pt>
                <c:pt idx="30">
                  <c:v>0.82407627175145015</c:v>
                </c:pt>
                <c:pt idx="31">
                  <c:v>0.85065937729181951</c:v>
                </c:pt>
                <c:pt idx="32">
                  <c:v>0.87724248283218886</c:v>
                </c:pt>
                <c:pt idx="33">
                  <c:v>0.90382558837255822</c:v>
                </c:pt>
                <c:pt idx="34">
                  <c:v>0.93040869391292758</c:v>
                </c:pt>
                <c:pt idx="35">
                  <c:v>0.95699179945329693</c:v>
                </c:pt>
                <c:pt idx="36">
                  <c:v>0.98357490499366629</c:v>
                </c:pt>
                <c:pt idx="37">
                  <c:v>1.0101580105340358</c:v>
                </c:pt>
                <c:pt idx="38">
                  <c:v>1.0367411160744051</c:v>
                </c:pt>
                <c:pt idx="39">
                  <c:v>1.0633242216147745</c:v>
                </c:pt>
                <c:pt idx="40">
                  <c:v>1.0899073271551438</c:v>
                </c:pt>
                <c:pt idx="41">
                  <c:v>1.1164904326955132</c:v>
                </c:pt>
                <c:pt idx="42">
                  <c:v>1.1430735382358825</c:v>
                </c:pt>
                <c:pt idx="43">
                  <c:v>1.1696566437762519</c:v>
                </c:pt>
                <c:pt idx="44">
                  <c:v>1.1962397493166212</c:v>
                </c:pt>
                <c:pt idx="45">
                  <c:v>1.2228228548569906</c:v>
                </c:pt>
                <c:pt idx="46">
                  <c:v>1.24940596039736</c:v>
                </c:pt>
                <c:pt idx="47">
                  <c:v>1.2759890659377293</c:v>
                </c:pt>
                <c:pt idx="48">
                  <c:v>1.3025721714780987</c:v>
                </c:pt>
                <c:pt idx="49">
                  <c:v>1.329155277018468</c:v>
                </c:pt>
                <c:pt idx="50">
                  <c:v>1.3557383825588374</c:v>
                </c:pt>
                <c:pt idx="51">
                  <c:v>1.3823214880992067</c:v>
                </c:pt>
                <c:pt idx="52">
                  <c:v>1.4089045936395761</c:v>
                </c:pt>
                <c:pt idx="53">
                  <c:v>1.4354876991799455</c:v>
                </c:pt>
                <c:pt idx="54">
                  <c:v>1.4620708047203148</c:v>
                </c:pt>
                <c:pt idx="55">
                  <c:v>1.4886539102606842</c:v>
                </c:pt>
                <c:pt idx="56">
                  <c:v>1.5152370158010535</c:v>
                </c:pt>
                <c:pt idx="57">
                  <c:v>1.5418201213414229</c:v>
                </c:pt>
                <c:pt idx="58">
                  <c:v>1.5684032268817922</c:v>
                </c:pt>
                <c:pt idx="59">
                  <c:v>1.5949863324221616</c:v>
                </c:pt>
                <c:pt idx="60">
                  <c:v>1.6215694379625309</c:v>
                </c:pt>
                <c:pt idx="61">
                  <c:v>1.6481525435029003</c:v>
                </c:pt>
                <c:pt idx="62">
                  <c:v>1.6747356490432697</c:v>
                </c:pt>
                <c:pt idx="63">
                  <c:v>1.701318754583639</c:v>
                </c:pt>
                <c:pt idx="64">
                  <c:v>1.7279018601240084</c:v>
                </c:pt>
                <c:pt idx="65">
                  <c:v>1.7544849656643777</c:v>
                </c:pt>
                <c:pt idx="66">
                  <c:v>1.7810680712047471</c:v>
                </c:pt>
                <c:pt idx="67">
                  <c:v>1.8076511767451164</c:v>
                </c:pt>
                <c:pt idx="68">
                  <c:v>1.8342342822854858</c:v>
                </c:pt>
                <c:pt idx="69">
                  <c:v>1.8608173878258552</c:v>
                </c:pt>
                <c:pt idx="70">
                  <c:v>1.8874004933662245</c:v>
                </c:pt>
                <c:pt idx="71">
                  <c:v>1.9139835989065939</c:v>
                </c:pt>
                <c:pt idx="72">
                  <c:v>1.9405667044469632</c:v>
                </c:pt>
                <c:pt idx="73">
                  <c:v>1.9671498099873326</c:v>
                </c:pt>
                <c:pt idx="74">
                  <c:v>1.9937329155277019</c:v>
                </c:pt>
                <c:pt idx="75">
                  <c:v>2.0203160210680715</c:v>
                </c:pt>
                <c:pt idx="76">
                  <c:v>2.0468991266084409</c:v>
                </c:pt>
                <c:pt idx="77">
                  <c:v>2.0734822321488102</c:v>
                </c:pt>
                <c:pt idx="78">
                  <c:v>2.1000653376891796</c:v>
                </c:pt>
                <c:pt idx="79">
                  <c:v>2.1266484432295489</c:v>
                </c:pt>
                <c:pt idx="80">
                  <c:v>2.1532315487699183</c:v>
                </c:pt>
                <c:pt idx="81">
                  <c:v>2.1798146543102876</c:v>
                </c:pt>
                <c:pt idx="82">
                  <c:v>2.206397759850657</c:v>
                </c:pt>
                <c:pt idx="83">
                  <c:v>2.2329808653910264</c:v>
                </c:pt>
                <c:pt idx="84">
                  <c:v>2.2595639709313957</c:v>
                </c:pt>
                <c:pt idx="85">
                  <c:v>2.2861470764717651</c:v>
                </c:pt>
                <c:pt idx="86">
                  <c:v>2.3127301820121344</c:v>
                </c:pt>
                <c:pt idx="87">
                  <c:v>2.3393132875525038</c:v>
                </c:pt>
                <c:pt idx="88">
                  <c:v>2.3658963930928731</c:v>
                </c:pt>
                <c:pt idx="89">
                  <c:v>2.3924794986332425</c:v>
                </c:pt>
                <c:pt idx="90">
                  <c:v>2.4190626041736119</c:v>
                </c:pt>
                <c:pt idx="91">
                  <c:v>2.4456457097139812</c:v>
                </c:pt>
                <c:pt idx="92">
                  <c:v>2.4722288152543506</c:v>
                </c:pt>
                <c:pt idx="93">
                  <c:v>2.4988119207947199</c:v>
                </c:pt>
                <c:pt idx="94">
                  <c:v>2.5253950263350893</c:v>
                </c:pt>
                <c:pt idx="95">
                  <c:v>2.5519781318754586</c:v>
                </c:pt>
                <c:pt idx="96">
                  <c:v>2.578561237415828</c:v>
                </c:pt>
                <c:pt idx="97">
                  <c:v>2.6051443429561973</c:v>
                </c:pt>
                <c:pt idx="98">
                  <c:v>2.6317274484965667</c:v>
                </c:pt>
                <c:pt idx="99">
                  <c:v>2.6583105540369361</c:v>
                </c:pt>
                <c:pt idx="100">
                  <c:v>2.6848936595773054</c:v>
                </c:pt>
                <c:pt idx="101">
                  <c:v>2.7114767651176748</c:v>
                </c:pt>
                <c:pt idx="102">
                  <c:v>2.7380598706580441</c:v>
                </c:pt>
                <c:pt idx="103">
                  <c:v>2.7646429761984135</c:v>
                </c:pt>
                <c:pt idx="104">
                  <c:v>2.7912260817387828</c:v>
                </c:pt>
                <c:pt idx="105">
                  <c:v>2.8178091872791522</c:v>
                </c:pt>
                <c:pt idx="106">
                  <c:v>2.8443922928195216</c:v>
                </c:pt>
                <c:pt idx="107">
                  <c:v>2.8709753983598909</c:v>
                </c:pt>
                <c:pt idx="108">
                  <c:v>2.8975585039002603</c:v>
                </c:pt>
                <c:pt idx="109">
                  <c:v>2.9241416094406296</c:v>
                </c:pt>
                <c:pt idx="110">
                  <c:v>2.950724714980999</c:v>
                </c:pt>
                <c:pt idx="111">
                  <c:v>2.9773078205213683</c:v>
                </c:pt>
                <c:pt idx="112">
                  <c:v>3.0038909260617377</c:v>
                </c:pt>
                <c:pt idx="113">
                  <c:v>3.030474031602107</c:v>
                </c:pt>
                <c:pt idx="114">
                  <c:v>3.0570571371424764</c:v>
                </c:pt>
                <c:pt idx="115">
                  <c:v>3.0836402426828458</c:v>
                </c:pt>
                <c:pt idx="116">
                  <c:v>3.1102233482232151</c:v>
                </c:pt>
                <c:pt idx="117">
                  <c:v>3.1368064537635845</c:v>
                </c:pt>
                <c:pt idx="118">
                  <c:v>3.1633895593039538</c:v>
                </c:pt>
                <c:pt idx="119">
                  <c:v>3.1899726648443232</c:v>
                </c:pt>
                <c:pt idx="120">
                  <c:v>3.2165557703846925</c:v>
                </c:pt>
                <c:pt idx="121">
                  <c:v>3.2431388759250619</c:v>
                </c:pt>
                <c:pt idx="122">
                  <c:v>3.2697219814654312</c:v>
                </c:pt>
                <c:pt idx="123">
                  <c:v>3.2963050870058006</c:v>
                </c:pt>
                <c:pt idx="124">
                  <c:v>3.32288819254617</c:v>
                </c:pt>
                <c:pt idx="125">
                  <c:v>3.3494712980865393</c:v>
                </c:pt>
                <c:pt idx="126">
                  <c:v>3.3760544036269087</c:v>
                </c:pt>
                <c:pt idx="127">
                  <c:v>3.402637509167278</c:v>
                </c:pt>
                <c:pt idx="128">
                  <c:v>3.4292206147076474</c:v>
                </c:pt>
                <c:pt idx="129">
                  <c:v>3.4558037202480167</c:v>
                </c:pt>
                <c:pt idx="130">
                  <c:v>3.4823868257883861</c:v>
                </c:pt>
                <c:pt idx="131">
                  <c:v>3.5089699313287555</c:v>
                </c:pt>
                <c:pt idx="132">
                  <c:v>3.5355530368691248</c:v>
                </c:pt>
                <c:pt idx="133">
                  <c:v>3.5621361424094942</c:v>
                </c:pt>
                <c:pt idx="134">
                  <c:v>3.5887192479498635</c:v>
                </c:pt>
                <c:pt idx="135">
                  <c:v>3.6153023534902329</c:v>
                </c:pt>
                <c:pt idx="136">
                  <c:v>3.6418854590306022</c:v>
                </c:pt>
                <c:pt idx="137">
                  <c:v>3.6684685645709716</c:v>
                </c:pt>
                <c:pt idx="138">
                  <c:v>3.6950516701113409</c:v>
                </c:pt>
                <c:pt idx="139">
                  <c:v>3.7216347756517103</c:v>
                </c:pt>
                <c:pt idx="140">
                  <c:v>3.7482178811920797</c:v>
                </c:pt>
                <c:pt idx="141">
                  <c:v>3.774800986732449</c:v>
                </c:pt>
                <c:pt idx="142">
                  <c:v>3.8013840922728184</c:v>
                </c:pt>
                <c:pt idx="143">
                  <c:v>3.8279671978131877</c:v>
                </c:pt>
                <c:pt idx="144">
                  <c:v>3.8545503033535571</c:v>
                </c:pt>
                <c:pt idx="145">
                  <c:v>3.8811334088939264</c:v>
                </c:pt>
                <c:pt idx="146">
                  <c:v>3.9077165144342958</c:v>
                </c:pt>
                <c:pt idx="147">
                  <c:v>3.9342996199746652</c:v>
                </c:pt>
                <c:pt idx="148">
                  <c:v>3.9608827255150345</c:v>
                </c:pt>
                <c:pt idx="149">
                  <c:v>3.9874658310554039</c:v>
                </c:pt>
                <c:pt idx="150">
                  <c:v>4.0140489365957732</c:v>
                </c:pt>
                <c:pt idx="151">
                  <c:v>4.040632042136143</c:v>
                </c:pt>
                <c:pt idx="152">
                  <c:v>4.0672151476765119</c:v>
                </c:pt>
                <c:pt idx="153">
                  <c:v>4.0937982532168817</c:v>
                </c:pt>
                <c:pt idx="154">
                  <c:v>4.1203813587572506</c:v>
                </c:pt>
                <c:pt idx="155">
                  <c:v>4.1469644642976204</c:v>
                </c:pt>
                <c:pt idx="156">
                  <c:v>4.1735475698379894</c:v>
                </c:pt>
                <c:pt idx="157">
                  <c:v>4.2001306753783592</c:v>
                </c:pt>
                <c:pt idx="158">
                  <c:v>4.2267137809187281</c:v>
                </c:pt>
                <c:pt idx="159">
                  <c:v>4.2532968864590979</c:v>
                </c:pt>
                <c:pt idx="160">
                  <c:v>4.2798799919994668</c:v>
                </c:pt>
                <c:pt idx="161">
                  <c:v>4.3064630975398366</c:v>
                </c:pt>
                <c:pt idx="162">
                  <c:v>4.3330462030802055</c:v>
                </c:pt>
                <c:pt idx="163">
                  <c:v>4.3596293086205753</c:v>
                </c:pt>
                <c:pt idx="164">
                  <c:v>4.3862124141609442</c:v>
                </c:pt>
                <c:pt idx="165">
                  <c:v>4.412795519701314</c:v>
                </c:pt>
                <c:pt idx="166">
                  <c:v>4.4393786252416829</c:v>
                </c:pt>
                <c:pt idx="167">
                  <c:v>4.4659617307820527</c:v>
                </c:pt>
                <c:pt idx="168">
                  <c:v>4.4925448363224216</c:v>
                </c:pt>
                <c:pt idx="169">
                  <c:v>4.5191279418627914</c:v>
                </c:pt>
                <c:pt idx="170">
                  <c:v>4.5457110474031603</c:v>
                </c:pt>
                <c:pt idx="171">
                  <c:v>4.5722941529435301</c:v>
                </c:pt>
                <c:pt idx="172">
                  <c:v>4.5988772584838991</c:v>
                </c:pt>
                <c:pt idx="173">
                  <c:v>4.6254603640242689</c:v>
                </c:pt>
                <c:pt idx="174">
                  <c:v>4.6520434695646378</c:v>
                </c:pt>
                <c:pt idx="175">
                  <c:v>4.6786265751050076</c:v>
                </c:pt>
                <c:pt idx="176">
                  <c:v>4.7052096806453765</c:v>
                </c:pt>
                <c:pt idx="177">
                  <c:v>4.7317927861857463</c:v>
                </c:pt>
                <c:pt idx="178">
                  <c:v>4.7583758917261152</c:v>
                </c:pt>
                <c:pt idx="179">
                  <c:v>4.784958997266485</c:v>
                </c:pt>
                <c:pt idx="180">
                  <c:v>4.8115421028068539</c:v>
                </c:pt>
                <c:pt idx="181">
                  <c:v>4.8381252083472237</c:v>
                </c:pt>
                <c:pt idx="182">
                  <c:v>4.8647083138875926</c:v>
                </c:pt>
                <c:pt idx="183">
                  <c:v>4.8912914194279624</c:v>
                </c:pt>
                <c:pt idx="184">
                  <c:v>4.9178745249683313</c:v>
                </c:pt>
                <c:pt idx="185">
                  <c:v>4.9444576305087011</c:v>
                </c:pt>
                <c:pt idx="186">
                  <c:v>4.97104073604907</c:v>
                </c:pt>
                <c:pt idx="187">
                  <c:v>4.9976238415894398</c:v>
                </c:pt>
                <c:pt idx="188">
                  <c:v>5.0242069471298088</c:v>
                </c:pt>
                <c:pt idx="189">
                  <c:v>5.0507900526701786</c:v>
                </c:pt>
                <c:pt idx="190">
                  <c:v>5.0773731582105475</c:v>
                </c:pt>
                <c:pt idx="191">
                  <c:v>5.1039562637509173</c:v>
                </c:pt>
                <c:pt idx="192">
                  <c:v>5.1305393692912862</c:v>
                </c:pt>
                <c:pt idx="193">
                  <c:v>5.157122474831656</c:v>
                </c:pt>
                <c:pt idx="194">
                  <c:v>5.1837055803720249</c:v>
                </c:pt>
                <c:pt idx="195">
                  <c:v>5.2102886859123947</c:v>
                </c:pt>
                <c:pt idx="196">
                  <c:v>5.2368717914527636</c:v>
                </c:pt>
                <c:pt idx="197">
                  <c:v>5.2634548969931334</c:v>
                </c:pt>
                <c:pt idx="198">
                  <c:v>5.2900380025335023</c:v>
                </c:pt>
                <c:pt idx="199">
                  <c:v>5.3166211080738721</c:v>
                </c:pt>
                <c:pt idx="200">
                  <c:v>5.343204213614241</c:v>
                </c:pt>
                <c:pt idx="201">
                  <c:v>5.3697873191546108</c:v>
                </c:pt>
                <c:pt idx="202">
                  <c:v>5.3963704246949797</c:v>
                </c:pt>
                <c:pt idx="203">
                  <c:v>5.4229535302353495</c:v>
                </c:pt>
                <c:pt idx="204">
                  <c:v>5.4495366357757185</c:v>
                </c:pt>
                <c:pt idx="205">
                  <c:v>5.4761197413160883</c:v>
                </c:pt>
                <c:pt idx="206">
                  <c:v>5.5027028468564572</c:v>
                </c:pt>
                <c:pt idx="207">
                  <c:v>5.529285952396827</c:v>
                </c:pt>
                <c:pt idx="208">
                  <c:v>5.5558690579371959</c:v>
                </c:pt>
                <c:pt idx="209">
                  <c:v>5.5824521634775657</c:v>
                </c:pt>
                <c:pt idx="210">
                  <c:v>5.6090352690179346</c:v>
                </c:pt>
                <c:pt idx="211">
                  <c:v>5.6356183745583044</c:v>
                </c:pt>
                <c:pt idx="212">
                  <c:v>5.6622014800986733</c:v>
                </c:pt>
                <c:pt idx="213">
                  <c:v>5.6887845856390431</c:v>
                </c:pt>
                <c:pt idx="214">
                  <c:v>5.715367691179412</c:v>
                </c:pt>
                <c:pt idx="215">
                  <c:v>5.7419507967197818</c:v>
                </c:pt>
                <c:pt idx="216">
                  <c:v>5.7685339022601507</c:v>
                </c:pt>
                <c:pt idx="217">
                  <c:v>5.7951170078005205</c:v>
                </c:pt>
                <c:pt idx="218">
                  <c:v>5.8217001133408894</c:v>
                </c:pt>
                <c:pt idx="219">
                  <c:v>5.8482832188812592</c:v>
                </c:pt>
                <c:pt idx="220">
                  <c:v>5.8748663244216281</c:v>
                </c:pt>
                <c:pt idx="221">
                  <c:v>5.901449429961998</c:v>
                </c:pt>
                <c:pt idx="222">
                  <c:v>5.9280325355023669</c:v>
                </c:pt>
                <c:pt idx="223">
                  <c:v>5.9546156410427367</c:v>
                </c:pt>
                <c:pt idx="224">
                  <c:v>5.9811987465831056</c:v>
                </c:pt>
                <c:pt idx="225">
                  <c:v>6.0077818521234754</c:v>
                </c:pt>
                <c:pt idx="226">
                  <c:v>6.0343649576638443</c:v>
                </c:pt>
                <c:pt idx="227">
                  <c:v>6.0609480632042141</c:v>
                </c:pt>
                <c:pt idx="228">
                  <c:v>6.087531168744583</c:v>
                </c:pt>
                <c:pt idx="229">
                  <c:v>6.1141142742849528</c:v>
                </c:pt>
                <c:pt idx="230">
                  <c:v>6.1406973798253217</c:v>
                </c:pt>
                <c:pt idx="231">
                  <c:v>6.1672804853656915</c:v>
                </c:pt>
                <c:pt idx="232">
                  <c:v>6.1938635909060604</c:v>
                </c:pt>
                <c:pt idx="233">
                  <c:v>6.2204466964464302</c:v>
                </c:pt>
                <c:pt idx="234">
                  <c:v>6.2470298019867991</c:v>
                </c:pt>
                <c:pt idx="235">
                  <c:v>6.2736129075271689</c:v>
                </c:pt>
                <c:pt idx="236">
                  <c:v>6.3001960130675378</c:v>
                </c:pt>
                <c:pt idx="237">
                  <c:v>6.3267791186079076</c:v>
                </c:pt>
                <c:pt idx="238">
                  <c:v>6.3533622241482766</c:v>
                </c:pt>
                <c:pt idx="239">
                  <c:v>6.3799453296886464</c:v>
                </c:pt>
                <c:pt idx="240">
                  <c:v>6.4065284352290153</c:v>
                </c:pt>
                <c:pt idx="241">
                  <c:v>6.4331115407693851</c:v>
                </c:pt>
                <c:pt idx="242">
                  <c:v>6.459694646309754</c:v>
                </c:pt>
                <c:pt idx="243">
                  <c:v>6.4862777518501238</c:v>
                </c:pt>
                <c:pt idx="244">
                  <c:v>6.5128608573904927</c:v>
                </c:pt>
                <c:pt idx="245">
                  <c:v>6.5394439629308625</c:v>
                </c:pt>
                <c:pt idx="246">
                  <c:v>6.5660270684712314</c:v>
                </c:pt>
                <c:pt idx="247">
                  <c:v>6.5926101740116012</c:v>
                </c:pt>
                <c:pt idx="248">
                  <c:v>6.6191932795519701</c:v>
                </c:pt>
                <c:pt idx="249">
                  <c:v>6.6457763850923399</c:v>
                </c:pt>
                <c:pt idx="250">
                  <c:v>6.6723594906327088</c:v>
                </c:pt>
                <c:pt idx="251">
                  <c:v>6.6989425961730786</c:v>
                </c:pt>
                <c:pt idx="252">
                  <c:v>6.7255257017134475</c:v>
                </c:pt>
                <c:pt idx="253">
                  <c:v>6.7521088072538173</c:v>
                </c:pt>
                <c:pt idx="254">
                  <c:v>6.7786919127941863</c:v>
                </c:pt>
                <c:pt idx="255">
                  <c:v>6.8052750183345561</c:v>
                </c:pt>
                <c:pt idx="256">
                  <c:v>6.831858123874925</c:v>
                </c:pt>
                <c:pt idx="257">
                  <c:v>6.8584412294152948</c:v>
                </c:pt>
                <c:pt idx="258">
                  <c:v>6.8850243349556637</c:v>
                </c:pt>
                <c:pt idx="259">
                  <c:v>6.9116074404960335</c:v>
                </c:pt>
                <c:pt idx="260">
                  <c:v>6.9381905460364024</c:v>
                </c:pt>
                <c:pt idx="261">
                  <c:v>6.9647736515767722</c:v>
                </c:pt>
                <c:pt idx="262">
                  <c:v>6.9913567571171411</c:v>
                </c:pt>
                <c:pt idx="263">
                  <c:v>7.0179398626575109</c:v>
                </c:pt>
                <c:pt idx="264">
                  <c:v>7.0445229681978798</c:v>
                </c:pt>
                <c:pt idx="265">
                  <c:v>7.0711060737382496</c:v>
                </c:pt>
                <c:pt idx="266">
                  <c:v>7.0976891792786194</c:v>
                </c:pt>
                <c:pt idx="267">
                  <c:v>7.1242722848189883</c:v>
                </c:pt>
                <c:pt idx="268">
                  <c:v>7.1508553903593581</c:v>
                </c:pt>
                <c:pt idx="269">
                  <c:v>7.177438495899727</c:v>
                </c:pt>
                <c:pt idx="270">
                  <c:v>7.2040216014400968</c:v>
                </c:pt>
                <c:pt idx="271">
                  <c:v>7.2306047069804658</c:v>
                </c:pt>
                <c:pt idx="272">
                  <c:v>7.2571878125208356</c:v>
                </c:pt>
                <c:pt idx="273">
                  <c:v>7.2837709180612045</c:v>
                </c:pt>
                <c:pt idx="274">
                  <c:v>7.3103540236015743</c:v>
                </c:pt>
                <c:pt idx="275">
                  <c:v>7.3369371291419432</c:v>
                </c:pt>
                <c:pt idx="276">
                  <c:v>7.363520234682313</c:v>
                </c:pt>
                <c:pt idx="277">
                  <c:v>7.3901033402226819</c:v>
                </c:pt>
                <c:pt idx="278">
                  <c:v>7.4166864457630517</c:v>
                </c:pt>
                <c:pt idx="279">
                  <c:v>7.4432695513034206</c:v>
                </c:pt>
                <c:pt idx="280">
                  <c:v>7.4698526568437904</c:v>
                </c:pt>
                <c:pt idx="281">
                  <c:v>7.4964357623841593</c:v>
                </c:pt>
                <c:pt idx="282">
                  <c:v>7.5230188679245291</c:v>
                </c:pt>
                <c:pt idx="283">
                  <c:v>7.549601973464898</c:v>
                </c:pt>
                <c:pt idx="284">
                  <c:v>7.5761850790052678</c:v>
                </c:pt>
                <c:pt idx="285">
                  <c:v>7.6027681845456367</c:v>
                </c:pt>
                <c:pt idx="286">
                  <c:v>7.6293512900860065</c:v>
                </c:pt>
                <c:pt idx="287">
                  <c:v>7.6559343956263755</c:v>
                </c:pt>
                <c:pt idx="288">
                  <c:v>7.6825175011667453</c:v>
                </c:pt>
                <c:pt idx="289">
                  <c:v>7.7091006067071142</c:v>
                </c:pt>
                <c:pt idx="290">
                  <c:v>7.735683712247484</c:v>
                </c:pt>
                <c:pt idx="291">
                  <c:v>7.7622668177878529</c:v>
                </c:pt>
                <c:pt idx="292">
                  <c:v>7.7888499233282227</c:v>
                </c:pt>
                <c:pt idx="293">
                  <c:v>7.8154330288685916</c:v>
                </c:pt>
                <c:pt idx="294">
                  <c:v>7.8420161344089614</c:v>
                </c:pt>
                <c:pt idx="295">
                  <c:v>7.8685992399493303</c:v>
                </c:pt>
                <c:pt idx="296">
                  <c:v>7.8951823454897001</c:v>
                </c:pt>
                <c:pt idx="297">
                  <c:v>7.921765451030069</c:v>
                </c:pt>
                <c:pt idx="298">
                  <c:v>7.9483485565704388</c:v>
                </c:pt>
                <c:pt idx="299">
                  <c:v>7.9749316621108077</c:v>
                </c:pt>
                <c:pt idx="300">
                  <c:v>8.0015147676511766</c:v>
                </c:pt>
                <c:pt idx="301">
                  <c:v>8.0280978731915464</c:v>
                </c:pt>
                <c:pt idx="302">
                  <c:v>8.0546809787319162</c:v>
                </c:pt>
                <c:pt idx="303">
                  <c:v>8.081264084272286</c:v>
                </c:pt>
                <c:pt idx="304">
                  <c:v>8.1078471898126541</c:v>
                </c:pt>
                <c:pt idx="305">
                  <c:v>8.1344302953530239</c:v>
                </c:pt>
                <c:pt idx="306">
                  <c:v>8.1610134008933937</c:v>
                </c:pt>
                <c:pt idx="307">
                  <c:v>8.1875965064337635</c:v>
                </c:pt>
                <c:pt idx="308">
                  <c:v>8.2141796119741315</c:v>
                </c:pt>
                <c:pt idx="309">
                  <c:v>8.2407627175145013</c:v>
                </c:pt>
                <c:pt idx="310">
                  <c:v>8.2673458230548711</c:v>
                </c:pt>
                <c:pt idx="311">
                  <c:v>8.2939289285952409</c:v>
                </c:pt>
                <c:pt idx="312">
                  <c:v>8.3205120341356089</c:v>
                </c:pt>
                <c:pt idx="313">
                  <c:v>8.3470951396759787</c:v>
                </c:pt>
                <c:pt idx="314">
                  <c:v>8.3736782452163485</c:v>
                </c:pt>
                <c:pt idx="315">
                  <c:v>8.4002613507567183</c:v>
                </c:pt>
                <c:pt idx="316">
                  <c:v>8.4268444562970863</c:v>
                </c:pt>
                <c:pt idx="317">
                  <c:v>8.4534275618374561</c:v>
                </c:pt>
                <c:pt idx="318">
                  <c:v>8.4800106673778259</c:v>
                </c:pt>
                <c:pt idx="319">
                  <c:v>8.5065937729181957</c:v>
                </c:pt>
                <c:pt idx="320">
                  <c:v>8.5331768784585638</c:v>
                </c:pt>
                <c:pt idx="321">
                  <c:v>8.5597599839989336</c:v>
                </c:pt>
                <c:pt idx="322">
                  <c:v>8.5863430895393034</c:v>
                </c:pt>
                <c:pt idx="323">
                  <c:v>8.6129261950796732</c:v>
                </c:pt>
                <c:pt idx="324">
                  <c:v>8.6395093006200412</c:v>
                </c:pt>
                <c:pt idx="325">
                  <c:v>8.666092406160411</c:v>
                </c:pt>
                <c:pt idx="326">
                  <c:v>8.6926755117007808</c:v>
                </c:pt>
                <c:pt idx="327">
                  <c:v>8.7192586172411506</c:v>
                </c:pt>
                <c:pt idx="328">
                  <c:v>8.7458417227815186</c:v>
                </c:pt>
                <c:pt idx="329">
                  <c:v>8.7724248283218884</c:v>
                </c:pt>
                <c:pt idx="330">
                  <c:v>8.7990079338622582</c:v>
                </c:pt>
                <c:pt idx="331">
                  <c:v>8.825591039402628</c:v>
                </c:pt>
                <c:pt idx="332">
                  <c:v>8.852174144942996</c:v>
                </c:pt>
                <c:pt idx="333">
                  <c:v>8.8787572504833658</c:v>
                </c:pt>
                <c:pt idx="334">
                  <c:v>8.9053403560237356</c:v>
                </c:pt>
                <c:pt idx="335">
                  <c:v>8.9319234615641054</c:v>
                </c:pt>
                <c:pt idx="336">
                  <c:v>8.9585065671044735</c:v>
                </c:pt>
                <c:pt idx="337">
                  <c:v>8.9850896726448433</c:v>
                </c:pt>
                <c:pt idx="338">
                  <c:v>9.0116727781852131</c:v>
                </c:pt>
                <c:pt idx="339">
                  <c:v>9.0382558837255829</c:v>
                </c:pt>
                <c:pt idx="340">
                  <c:v>9.0648389892659509</c:v>
                </c:pt>
                <c:pt idx="341">
                  <c:v>9.0914220948063207</c:v>
                </c:pt>
                <c:pt idx="342">
                  <c:v>9.1180052003466905</c:v>
                </c:pt>
                <c:pt idx="343">
                  <c:v>9.1445883058870603</c:v>
                </c:pt>
                <c:pt idx="344">
                  <c:v>9.1711714114274283</c:v>
                </c:pt>
                <c:pt idx="345">
                  <c:v>9.1977545169677981</c:v>
                </c:pt>
                <c:pt idx="346">
                  <c:v>9.2243376225081679</c:v>
                </c:pt>
                <c:pt idx="347">
                  <c:v>9.2509207280485377</c:v>
                </c:pt>
                <c:pt idx="348">
                  <c:v>9.2775038335889057</c:v>
                </c:pt>
                <c:pt idx="349">
                  <c:v>9.3040869391292755</c:v>
                </c:pt>
                <c:pt idx="350">
                  <c:v>9.3306700446696453</c:v>
                </c:pt>
                <c:pt idx="351">
                  <c:v>9.3572531502100151</c:v>
                </c:pt>
                <c:pt idx="352">
                  <c:v>9.3838362557503832</c:v>
                </c:pt>
                <c:pt idx="353">
                  <c:v>9.410419361290753</c:v>
                </c:pt>
                <c:pt idx="354">
                  <c:v>9.4370024668311228</c:v>
                </c:pt>
                <c:pt idx="355">
                  <c:v>9.4635855723714926</c:v>
                </c:pt>
                <c:pt idx="356">
                  <c:v>9.4901686779118606</c:v>
                </c:pt>
                <c:pt idx="357">
                  <c:v>9.5167517834522304</c:v>
                </c:pt>
                <c:pt idx="358">
                  <c:v>9.5433348889926002</c:v>
                </c:pt>
                <c:pt idx="359">
                  <c:v>9.56991799453297</c:v>
                </c:pt>
                <c:pt idx="360">
                  <c:v>9.596501100073338</c:v>
                </c:pt>
                <c:pt idx="361">
                  <c:v>9.6230842056137078</c:v>
                </c:pt>
                <c:pt idx="362">
                  <c:v>9.6496673111540776</c:v>
                </c:pt>
                <c:pt idx="363">
                  <c:v>9.6762504166944474</c:v>
                </c:pt>
                <c:pt idx="364">
                  <c:v>9.7028335222348154</c:v>
                </c:pt>
                <c:pt idx="365">
                  <c:v>9.7294166277751852</c:v>
                </c:pt>
                <c:pt idx="366">
                  <c:v>9.755999733315555</c:v>
                </c:pt>
                <c:pt idx="367">
                  <c:v>9.7825828388559248</c:v>
                </c:pt>
                <c:pt idx="368">
                  <c:v>9.8091659443962929</c:v>
                </c:pt>
                <c:pt idx="369">
                  <c:v>9.8357490499366627</c:v>
                </c:pt>
                <c:pt idx="370">
                  <c:v>9.8623321554770325</c:v>
                </c:pt>
                <c:pt idx="371">
                  <c:v>9.8889152610174023</c:v>
                </c:pt>
                <c:pt idx="372">
                  <c:v>9.9154983665577703</c:v>
                </c:pt>
                <c:pt idx="373">
                  <c:v>9.9420814720981401</c:v>
                </c:pt>
                <c:pt idx="374">
                  <c:v>9.9686645776385099</c:v>
                </c:pt>
                <c:pt idx="375">
                  <c:v>9.9952476831788797</c:v>
                </c:pt>
                <c:pt idx="376">
                  <c:v>10.021830788719248</c:v>
                </c:pt>
                <c:pt idx="377">
                  <c:v>10.048413894259618</c:v>
                </c:pt>
                <c:pt idx="378">
                  <c:v>10.074996999799987</c:v>
                </c:pt>
                <c:pt idx="379">
                  <c:v>10.101580105340357</c:v>
                </c:pt>
                <c:pt idx="380">
                  <c:v>10.128163210880725</c:v>
                </c:pt>
                <c:pt idx="381">
                  <c:v>10.154746316421095</c:v>
                </c:pt>
                <c:pt idx="382">
                  <c:v>10.181329421961465</c:v>
                </c:pt>
                <c:pt idx="383">
                  <c:v>10.207912527501835</c:v>
                </c:pt>
                <c:pt idx="384">
                  <c:v>10.234495633042203</c:v>
                </c:pt>
                <c:pt idx="385">
                  <c:v>10.261078738582572</c:v>
                </c:pt>
                <c:pt idx="386">
                  <c:v>10.287661844122942</c:v>
                </c:pt>
                <c:pt idx="387">
                  <c:v>10.314244949663312</c:v>
                </c:pt>
                <c:pt idx="388">
                  <c:v>10.34082805520368</c:v>
                </c:pt>
                <c:pt idx="389">
                  <c:v>10.36741116074405</c:v>
                </c:pt>
                <c:pt idx="390">
                  <c:v>10.39399426628442</c:v>
                </c:pt>
                <c:pt idx="391">
                  <c:v>10.420577371824789</c:v>
                </c:pt>
                <c:pt idx="392">
                  <c:v>10.447160477365157</c:v>
                </c:pt>
                <c:pt idx="393">
                  <c:v>10.473743582905527</c:v>
                </c:pt>
                <c:pt idx="394">
                  <c:v>10.500326688445897</c:v>
                </c:pt>
                <c:pt idx="395">
                  <c:v>10.526909793986267</c:v>
                </c:pt>
                <c:pt idx="396">
                  <c:v>10.553492899526635</c:v>
                </c:pt>
                <c:pt idx="397">
                  <c:v>10.580076005067005</c:v>
                </c:pt>
                <c:pt idx="398">
                  <c:v>10.606659110607374</c:v>
                </c:pt>
                <c:pt idx="399">
                  <c:v>10.633242216147744</c:v>
                </c:pt>
                <c:pt idx="400">
                  <c:v>10.659825321688114</c:v>
                </c:pt>
                <c:pt idx="401">
                  <c:v>10.686408427228482</c:v>
                </c:pt>
                <c:pt idx="402">
                  <c:v>10.712991532768852</c:v>
                </c:pt>
                <c:pt idx="403">
                  <c:v>10.739574638309222</c:v>
                </c:pt>
                <c:pt idx="404">
                  <c:v>10.766157743849591</c:v>
                </c:pt>
                <c:pt idx="405">
                  <c:v>10.792740849389959</c:v>
                </c:pt>
                <c:pt idx="406">
                  <c:v>10.819323954930329</c:v>
                </c:pt>
                <c:pt idx="407">
                  <c:v>10.845907060470699</c:v>
                </c:pt>
                <c:pt idx="408">
                  <c:v>10.872490166011069</c:v>
                </c:pt>
                <c:pt idx="409">
                  <c:v>10.899073271551437</c:v>
                </c:pt>
                <c:pt idx="410">
                  <c:v>10.925656377091807</c:v>
                </c:pt>
                <c:pt idx="411">
                  <c:v>10.952239482632177</c:v>
                </c:pt>
                <c:pt idx="412">
                  <c:v>10.978822588172546</c:v>
                </c:pt>
                <c:pt idx="413">
                  <c:v>11.005405693712914</c:v>
                </c:pt>
                <c:pt idx="414">
                  <c:v>11.031988799253284</c:v>
                </c:pt>
                <c:pt idx="415">
                  <c:v>11.058571904793654</c:v>
                </c:pt>
                <c:pt idx="416">
                  <c:v>11.085155010334024</c:v>
                </c:pt>
                <c:pt idx="417">
                  <c:v>11.111738115874392</c:v>
                </c:pt>
                <c:pt idx="418">
                  <c:v>11.138321221414762</c:v>
                </c:pt>
                <c:pt idx="419">
                  <c:v>11.164904326955131</c:v>
                </c:pt>
                <c:pt idx="420">
                  <c:v>11.191487432495501</c:v>
                </c:pt>
                <c:pt idx="421">
                  <c:v>11.218070538035869</c:v>
                </c:pt>
                <c:pt idx="422">
                  <c:v>11.244653643576239</c:v>
                </c:pt>
                <c:pt idx="423">
                  <c:v>11.271236749116609</c:v>
                </c:pt>
                <c:pt idx="424">
                  <c:v>11.297819854656979</c:v>
                </c:pt>
                <c:pt idx="425">
                  <c:v>11.324402960197347</c:v>
                </c:pt>
                <c:pt idx="426">
                  <c:v>11.350986065737716</c:v>
                </c:pt>
                <c:pt idx="427">
                  <c:v>11.377569171278086</c:v>
                </c:pt>
                <c:pt idx="428">
                  <c:v>11.404152276818456</c:v>
                </c:pt>
                <c:pt idx="429">
                  <c:v>11.430735382358824</c:v>
                </c:pt>
                <c:pt idx="430">
                  <c:v>11.457318487899194</c:v>
                </c:pt>
                <c:pt idx="431">
                  <c:v>11.483901593439564</c:v>
                </c:pt>
                <c:pt idx="432">
                  <c:v>11.510484698979933</c:v>
                </c:pt>
                <c:pt idx="433">
                  <c:v>11.537067804520301</c:v>
                </c:pt>
                <c:pt idx="434">
                  <c:v>11.563650910060671</c:v>
                </c:pt>
                <c:pt idx="435">
                  <c:v>11.590234015601041</c:v>
                </c:pt>
                <c:pt idx="436">
                  <c:v>11.616817121141411</c:v>
                </c:pt>
                <c:pt idx="437">
                  <c:v>11.643400226681779</c:v>
                </c:pt>
                <c:pt idx="438">
                  <c:v>11.669983332222149</c:v>
                </c:pt>
                <c:pt idx="439">
                  <c:v>11.696566437762518</c:v>
                </c:pt>
                <c:pt idx="440">
                  <c:v>11.723149543302888</c:v>
                </c:pt>
                <c:pt idx="441">
                  <c:v>11.749732648843256</c:v>
                </c:pt>
                <c:pt idx="442">
                  <c:v>11.776315754383626</c:v>
                </c:pt>
                <c:pt idx="443">
                  <c:v>11.802898859923996</c:v>
                </c:pt>
                <c:pt idx="444">
                  <c:v>11.829481965464366</c:v>
                </c:pt>
                <c:pt idx="445">
                  <c:v>11.856065071004734</c:v>
                </c:pt>
                <c:pt idx="446">
                  <c:v>11.882648176545104</c:v>
                </c:pt>
                <c:pt idx="447">
                  <c:v>11.909231282085473</c:v>
                </c:pt>
                <c:pt idx="448">
                  <c:v>11.935814387625843</c:v>
                </c:pt>
                <c:pt idx="449">
                  <c:v>11.962397493166211</c:v>
                </c:pt>
                <c:pt idx="450">
                  <c:v>11.988980598706581</c:v>
                </c:pt>
                <c:pt idx="451">
                  <c:v>12.015563704246951</c:v>
                </c:pt>
                <c:pt idx="452">
                  <c:v>12.042146809787321</c:v>
                </c:pt>
                <c:pt idx="453">
                  <c:v>12.068729915327689</c:v>
                </c:pt>
                <c:pt idx="454">
                  <c:v>12.095313020868058</c:v>
                </c:pt>
                <c:pt idx="455">
                  <c:v>12.121896126408428</c:v>
                </c:pt>
                <c:pt idx="456">
                  <c:v>12.148479231948798</c:v>
                </c:pt>
                <c:pt idx="457">
                  <c:v>12.175062337489166</c:v>
                </c:pt>
                <c:pt idx="458">
                  <c:v>12.201645443029536</c:v>
                </c:pt>
                <c:pt idx="459">
                  <c:v>12.228228548569906</c:v>
                </c:pt>
                <c:pt idx="460">
                  <c:v>12.254811654110275</c:v>
                </c:pt>
                <c:pt idx="461">
                  <c:v>12.281394759650643</c:v>
                </c:pt>
                <c:pt idx="462">
                  <c:v>12.307977865191013</c:v>
                </c:pt>
                <c:pt idx="463">
                  <c:v>12.334560970731383</c:v>
                </c:pt>
                <c:pt idx="464">
                  <c:v>12.361144076271753</c:v>
                </c:pt>
                <c:pt idx="465">
                  <c:v>12.387727181812121</c:v>
                </c:pt>
                <c:pt idx="466">
                  <c:v>12.414310287352491</c:v>
                </c:pt>
                <c:pt idx="467">
                  <c:v>12.44089339289286</c:v>
                </c:pt>
                <c:pt idx="468">
                  <c:v>12.46747649843323</c:v>
                </c:pt>
                <c:pt idx="469">
                  <c:v>12.494059603973598</c:v>
                </c:pt>
                <c:pt idx="470">
                  <c:v>12.520642709513968</c:v>
                </c:pt>
                <c:pt idx="471">
                  <c:v>12.547225815054338</c:v>
                </c:pt>
                <c:pt idx="472">
                  <c:v>12.573808920594708</c:v>
                </c:pt>
                <c:pt idx="473">
                  <c:v>12.600392026135076</c:v>
                </c:pt>
                <c:pt idx="474">
                  <c:v>12.626975131675445</c:v>
                </c:pt>
                <c:pt idx="475">
                  <c:v>12.653558237215815</c:v>
                </c:pt>
                <c:pt idx="476">
                  <c:v>12.680141342756185</c:v>
                </c:pt>
                <c:pt idx="477">
                  <c:v>12.706724448296553</c:v>
                </c:pt>
                <c:pt idx="478">
                  <c:v>12.733307553836923</c:v>
                </c:pt>
                <c:pt idx="479">
                  <c:v>12.759890659377293</c:v>
                </c:pt>
                <c:pt idx="480">
                  <c:v>12.786473764917663</c:v>
                </c:pt>
                <c:pt idx="481">
                  <c:v>12.813056870458031</c:v>
                </c:pt>
                <c:pt idx="482">
                  <c:v>12.8396399759984</c:v>
                </c:pt>
                <c:pt idx="483">
                  <c:v>12.86622308153877</c:v>
                </c:pt>
                <c:pt idx="484">
                  <c:v>12.89280618707914</c:v>
                </c:pt>
                <c:pt idx="485">
                  <c:v>12.919389292619508</c:v>
                </c:pt>
                <c:pt idx="486">
                  <c:v>12.945972398159878</c:v>
                </c:pt>
                <c:pt idx="487">
                  <c:v>12.972555503700248</c:v>
                </c:pt>
                <c:pt idx="488">
                  <c:v>12.999138609240617</c:v>
                </c:pt>
                <c:pt idx="489">
                  <c:v>13.025721714780985</c:v>
                </c:pt>
                <c:pt idx="490">
                  <c:v>13.052304820321355</c:v>
                </c:pt>
                <c:pt idx="491">
                  <c:v>13.078887925861725</c:v>
                </c:pt>
                <c:pt idx="492">
                  <c:v>13.105471031402095</c:v>
                </c:pt>
                <c:pt idx="493">
                  <c:v>13.132054136942463</c:v>
                </c:pt>
                <c:pt idx="494">
                  <c:v>13.158637242482833</c:v>
                </c:pt>
                <c:pt idx="495">
                  <c:v>13.185220348023202</c:v>
                </c:pt>
                <c:pt idx="496">
                  <c:v>13.211803453563572</c:v>
                </c:pt>
                <c:pt idx="497">
                  <c:v>13.23838655910394</c:v>
                </c:pt>
                <c:pt idx="498">
                  <c:v>13.26496966464431</c:v>
                </c:pt>
                <c:pt idx="499">
                  <c:v>13.29155277018468</c:v>
                </c:pt>
                <c:pt idx="500">
                  <c:v>13.31813587572505</c:v>
                </c:pt>
                <c:pt idx="501">
                  <c:v>13.344718981265418</c:v>
                </c:pt>
                <c:pt idx="502">
                  <c:v>13.371302086805787</c:v>
                </c:pt>
                <c:pt idx="503">
                  <c:v>13.397885192346157</c:v>
                </c:pt>
                <c:pt idx="504">
                  <c:v>13.424468297886527</c:v>
                </c:pt>
                <c:pt idx="505">
                  <c:v>13.451051403426895</c:v>
                </c:pt>
                <c:pt idx="506">
                  <c:v>13.477634508967265</c:v>
                </c:pt>
                <c:pt idx="507">
                  <c:v>13.504217614507635</c:v>
                </c:pt>
                <c:pt idx="508">
                  <c:v>13.530800720048004</c:v>
                </c:pt>
                <c:pt idx="509">
                  <c:v>13.557383825588373</c:v>
                </c:pt>
                <c:pt idx="510">
                  <c:v>13.583966931128742</c:v>
                </c:pt>
                <c:pt idx="511">
                  <c:v>13.610550036669112</c:v>
                </c:pt>
                <c:pt idx="512">
                  <c:v>13.637133142209482</c:v>
                </c:pt>
                <c:pt idx="513">
                  <c:v>13.66371624774985</c:v>
                </c:pt>
                <c:pt idx="514">
                  <c:v>13.69029935329022</c:v>
                </c:pt>
                <c:pt idx="515">
                  <c:v>13.71688245883059</c:v>
                </c:pt>
                <c:pt idx="516">
                  <c:v>13.743465564370959</c:v>
                </c:pt>
                <c:pt idx="517">
                  <c:v>13.770048669911327</c:v>
                </c:pt>
                <c:pt idx="518">
                  <c:v>13.796631775451697</c:v>
                </c:pt>
                <c:pt idx="519">
                  <c:v>13.823214880992067</c:v>
                </c:pt>
                <c:pt idx="520">
                  <c:v>13.849797986532437</c:v>
                </c:pt>
                <c:pt idx="521">
                  <c:v>13.876381092072805</c:v>
                </c:pt>
                <c:pt idx="522">
                  <c:v>13.902964197613175</c:v>
                </c:pt>
                <c:pt idx="523">
                  <c:v>13.929547303153544</c:v>
                </c:pt>
                <c:pt idx="524">
                  <c:v>13.956130408693914</c:v>
                </c:pt>
                <c:pt idx="525">
                  <c:v>13.982713514234282</c:v>
                </c:pt>
                <c:pt idx="526">
                  <c:v>14.009296619774652</c:v>
                </c:pt>
                <c:pt idx="527">
                  <c:v>14.035879725315022</c:v>
                </c:pt>
                <c:pt idx="528">
                  <c:v>14.062462830855392</c:v>
                </c:pt>
                <c:pt idx="529">
                  <c:v>14.08904593639576</c:v>
                </c:pt>
                <c:pt idx="530">
                  <c:v>14.115629041936129</c:v>
                </c:pt>
                <c:pt idx="531">
                  <c:v>14.142212147476499</c:v>
                </c:pt>
                <c:pt idx="532">
                  <c:v>14.168795253016869</c:v>
                </c:pt>
                <c:pt idx="533">
                  <c:v>14.195378358557239</c:v>
                </c:pt>
                <c:pt idx="534">
                  <c:v>14.221961464097607</c:v>
                </c:pt>
                <c:pt idx="535">
                  <c:v>14.248544569637977</c:v>
                </c:pt>
                <c:pt idx="536">
                  <c:v>14.275127675178346</c:v>
                </c:pt>
                <c:pt idx="537">
                  <c:v>14.301710780718716</c:v>
                </c:pt>
                <c:pt idx="538">
                  <c:v>14.328293886259084</c:v>
                </c:pt>
                <c:pt idx="539">
                  <c:v>14.354876991799454</c:v>
                </c:pt>
                <c:pt idx="540">
                  <c:v>14.381460097339824</c:v>
                </c:pt>
                <c:pt idx="541">
                  <c:v>14.408043202880194</c:v>
                </c:pt>
                <c:pt idx="542">
                  <c:v>14.434626308420562</c:v>
                </c:pt>
                <c:pt idx="543">
                  <c:v>14.461209413960932</c:v>
                </c:pt>
                <c:pt idx="544">
                  <c:v>14.487792519501301</c:v>
                </c:pt>
                <c:pt idx="545">
                  <c:v>14.514375625041671</c:v>
                </c:pt>
                <c:pt idx="546">
                  <c:v>14.540958730582039</c:v>
                </c:pt>
                <c:pt idx="547">
                  <c:v>14.567541836122409</c:v>
                </c:pt>
                <c:pt idx="548">
                  <c:v>14.594124941662779</c:v>
                </c:pt>
                <c:pt idx="549">
                  <c:v>14.620708047203149</c:v>
                </c:pt>
                <c:pt idx="550">
                  <c:v>14.647291152743517</c:v>
                </c:pt>
                <c:pt idx="551">
                  <c:v>14.673874258283886</c:v>
                </c:pt>
                <c:pt idx="552">
                  <c:v>14.700457363824256</c:v>
                </c:pt>
                <c:pt idx="553">
                  <c:v>14.727040469364626</c:v>
                </c:pt>
                <c:pt idx="554">
                  <c:v>14.753623574904994</c:v>
                </c:pt>
                <c:pt idx="555">
                  <c:v>14.780206680445364</c:v>
                </c:pt>
                <c:pt idx="556">
                  <c:v>14.806789785985734</c:v>
                </c:pt>
                <c:pt idx="557">
                  <c:v>14.833372891526103</c:v>
                </c:pt>
                <c:pt idx="558">
                  <c:v>14.859955997066471</c:v>
                </c:pt>
                <c:pt idx="559">
                  <c:v>14.886539102606841</c:v>
                </c:pt>
                <c:pt idx="560">
                  <c:v>14.913122208147211</c:v>
                </c:pt>
                <c:pt idx="561">
                  <c:v>14.939705313687581</c:v>
                </c:pt>
                <c:pt idx="562">
                  <c:v>14.966288419227949</c:v>
                </c:pt>
                <c:pt idx="563">
                  <c:v>14.992871524768319</c:v>
                </c:pt>
                <c:pt idx="564">
                  <c:v>15.019454630308688</c:v>
                </c:pt>
                <c:pt idx="565">
                  <c:v>15.046037735849058</c:v>
                </c:pt>
                <c:pt idx="566">
                  <c:v>15.072620841389426</c:v>
                </c:pt>
                <c:pt idx="567">
                  <c:v>15.099203946929796</c:v>
                </c:pt>
                <c:pt idx="568">
                  <c:v>15.125787052470166</c:v>
                </c:pt>
                <c:pt idx="569">
                  <c:v>15.152370158010536</c:v>
                </c:pt>
                <c:pt idx="570">
                  <c:v>15.178953263550904</c:v>
                </c:pt>
                <c:pt idx="571">
                  <c:v>15.205536369091273</c:v>
                </c:pt>
                <c:pt idx="572">
                  <c:v>15.232119474631643</c:v>
                </c:pt>
                <c:pt idx="573">
                  <c:v>15.258702580172013</c:v>
                </c:pt>
                <c:pt idx="574">
                  <c:v>15.285285685712381</c:v>
                </c:pt>
                <c:pt idx="575">
                  <c:v>15.311868791252751</c:v>
                </c:pt>
                <c:pt idx="576">
                  <c:v>15.338451896793121</c:v>
                </c:pt>
                <c:pt idx="577">
                  <c:v>15.365035002333491</c:v>
                </c:pt>
                <c:pt idx="578">
                  <c:v>15.391618107873859</c:v>
                </c:pt>
                <c:pt idx="579">
                  <c:v>15.418201213414228</c:v>
                </c:pt>
                <c:pt idx="580">
                  <c:v>15.444784318954598</c:v>
                </c:pt>
                <c:pt idx="581">
                  <c:v>15.471367424494968</c:v>
                </c:pt>
                <c:pt idx="582">
                  <c:v>15.497950530035336</c:v>
                </c:pt>
                <c:pt idx="583">
                  <c:v>15.524533635575706</c:v>
                </c:pt>
                <c:pt idx="584">
                  <c:v>15.551116741116076</c:v>
                </c:pt>
                <c:pt idx="585">
                  <c:v>15.577699846656445</c:v>
                </c:pt>
                <c:pt idx="586">
                  <c:v>15.604282952196813</c:v>
                </c:pt>
                <c:pt idx="587">
                  <c:v>15.630866057737183</c:v>
                </c:pt>
                <c:pt idx="588">
                  <c:v>15.657449163277553</c:v>
                </c:pt>
                <c:pt idx="589">
                  <c:v>15.684032268817923</c:v>
                </c:pt>
                <c:pt idx="590">
                  <c:v>15.710615374358291</c:v>
                </c:pt>
                <c:pt idx="591">
                  <c:v>15.737198479898661</c:v>
                </c:pt>
                <c:pt idx="592">
                  <c:v>15.76378158543903</c:v>
                </c:pt>
                <c:pt idx="593">
                  <c:v>15.7903646909794</c:v>
                </c:pt>
                <c:pt idx="594">
                  <c:v>15.816947796519768</c:v>
                </c:pt>
                <c:pt idx="595">
                  <c:v>15.843530902060138</c:v>
                </c:pt>
                <c:pt idx="596">
                  <c:v>15.870114007600508</c:v>
                </c:pt>
                <c:pt idx="597">
                  <c:v>15.896697113140878</c:v>
                </c:pt>
                <c:pt idx="598">
                  <c:v>15.923280218681246</c:v>
                </c:pt>
                <c:pt idx="599">
                  <c:v>15.949863324221615</c:v>
                </c:pt>
                <c:pt idx="600">
                  <c:v>15.976446429761985</c:v>
                </c:pt>
                <c:pt idx="601">
                  <c:v>16.003029535302353</c:v>
                </c:pt>
                <c:pt idx="602">
                  <c:v>16.029612640842725</c:v>
                </c:pt>
                <c:pt idx="603">
                  <c:v>16.056195746383093</c:v>
                </c:pt>
                <c:pt idx="604">
                  <c:v>16.082778851923461</c:v>
                </c:pt>
                <c:pt idx="605">
                  <c:v>16.109361957463832</c:v>
                </c:pt>
                <c:pt idx="606">
                  <c:v>16.135945063004201</c:v>
                </c:pt>
                <c:pt idx="607">
                  <c:v>16.162528168544572</c:v>
                </c:pt>
                <c:pt idx="608">
                  <c:v>16.18911127408494</c:v>
                </c:pt>
                <c:pt idx="609">
                  <c:v>16.215694379625308</c:v>
                </c:pt>
                <c:pt idx="610">
                  <c:v>16.24227748516568</c:v>
                </c:pt>
                <c:pt idx="611">
                  <c:v>16.268860590706048</c:v>
                </c:pt>
                <c:pt idx="612">
                  <c:v>16.295443696246416</c:v>
                </c:pt>
                <c:pt idx="613">
                  <c:v>16.322026801786787</c:v>
                </c:pt>
                <c:pt idx="614">
                  <c:v>16.348609907327155</c:v>
                </c:pt>
                <c:pt idx="615">
                  <c:v>16.375193012867527</c:v>
                </c:pt>
                <c:pt idx="616">
                  <c:v>16.401776118407895</c:v>
                </c:pt>
                <c:pt idx="617">
                  <c:v>16.428359223948263</c:v>
                </c:pt>
                <c:pt idx="618">
                  <c:v>16.454942329488635</c:v>
                </c:pt>
                <c:pt idx="619">
                  <c:v>16.481525435029003</c:v>
                </c:pt>
                <c:pt idx="620">
                  <c:v>16.508108540569371</c:v>
                </c:pt>
                <c:pt idx="621">
                  <c:v>16.534691646109742</c:v>
                </c:pt>
                <c:pt idx="622">
                  <c:v>16.56127475165011</c:v>
                </c:pt>
                <c:pt idx="623">
                  <c:v>16.587857857190482</c:v>
                </c:pt>
                <c:pt idx="624">
                  <c:v>16.61444096273085</c:v>
                </c:pt>
                <c:pt idx="625">
                  <c:v>16.641024068271218</c:v>
                </c:pt>
                <c:pt idx="626">
                  <c:v>16.667607173811589</c:v>
                </c:pt>
                <c:pt idx="627">
                  <c:v>16.694190279351957</c:v>
                </c:pt>
                <c:pt idx="628">
                  <c:v>16.720773384892325</c:v>
                </c:pt>
                <c:pt idx="629">
                  <c:v>16.747356490432697</c:v>
                </c:pt>
                <c:pt idx="630">
                  <c:v>16.773939595973065</c:v>
                </c:pt>
                <c:pt idx="631">
                  <c:v>16.800522701513437</c:v>
                </c:pt>
                <c:pt idx="632">
                  <c:v>16.827105807053805</c:v>
                </c:pt>
                <c:pt idx="633">
                  <c:v>16.853688912594173</c:v>
                </c:pt>
                <c:pt idx="634">
                  <c:v>16.880272018134544</c:v>
                </c:pt>
                <c:pt idx="635">
                  <c:v>16.906855123674912</c:v>
                </c:pt>
                <c:pt idx="636">
                  <c:v>16.93343822921528</c:v>
                </c:pt>
                <c:pt idx="637">
                  <c:v>16.960021334755652</c:v>
                </c:pt>
                <c:pt idx="638">
                  <c:v>16.98660444029602</c:v>
                </c:pt>
                <c:pt idx="639">
                  <c:v>17.013187545836391</c:v>
                </c:pt>
                <c:pt idx="640">
                  <c:v>17.03977065137676</c:v>
                </c:pt>
                <c:pt idx="641">
                  <c:v>17.066353756917128</c:v>
                </c:pt>
                <c:pt idx="642">
                  <c:v>17.092936862457499</c:v>
                </c:pt>
                <c:pt idx="643">
                  <c:v>17.119519967997867</c:v>
                </c:pt>
                <c:pt idx="644">
                  <c:v>17.146103073538235</c:v>
                </c:pt>
                <c:pt idx="645">
                  <c:v>17.172686179078607</c:v>
                </c:pt>
                <c:pt idx="646">
                  <c:v>17.199269284618975</c:v>
                </c:pt>
                <c:pt idx="647">
                  <c:v>17.225852390159346</c:v>
                </c:pt>
                <c:pt idx="648">
                  <c:v>17.252435495699714</c:v>
                </c:pt>
                <c:pt idx="649">
                  <c:v>17.279018601240082</c:v>
                </c:pt>
                <c:pt idx="650">
                  <c:v>17.305601706780454</c:v>
                </c:pt>
                <c:pt idx="651">
                  <c:v>17.332184812320822</c:v>
                </c:pt>
                <c:pt idx="652">
                  <c:v>17.35876791786119</c:v>
                </c:pt>
                <c:pt idx="653">
                  <c:v>17.385351023401562</c:v>
                </c:pt>
                <c:pt idx="654">
                  <c:v>17.41193412894193</c:v>
                </c:pt>
                <c:pt idx="655">
                  <c:v>17.438517234482301</c:v>
                </c:pt>
                <c:pt idx="656">
                  <c:v>17.465100340022669</c:v>
                </c:pt>
                <c:pt idx="657">
                  <c:v>17.491683445563037</c:v>
                </c:pt>
                <c:pt idx="658">
                  <c:v>17.518266551103409</c:v>
                </c:pt>
                <c:pt idx="659">
                  <c:v>17.544849656643777</c:v>
                </c:pt>
                <c:pt idx="660">
                  <c:v>17.571432762184145</c:v>
                </c:pt>
                <c:pt idx="661">
                  <c:v>17.598015867724516</c:v>
                </c:pt>
                <c:pt idx="662">
                  <c:v>17.624598973264884</c:v>
                </c:pt>
                <c:pt idx="663">
                  <c:v>17.651182078805256</c:v>
                </c:pt>
                <c:pt idx="664">
                  <c:v>17.677765184345624</c:v>
                </c:pt>
                <c:pt idx="665">
                  <c:v>17.704348289885992</c:v>
                </c:pt>
                <c:pt idx="666">
                  <c:v>17.730931395426364</c:v>
                </c:pt>
                <c:pt idx="667">
                  <c:v>17.757514500966732</c:v>
                </c:pt>
                <c:pt idx="668">
                  <c:v>17.784097606507103</c:v>
                </c:pt>
                <c:pt idx="669">
                  <c:v>17.810680712047471</c:v>
                </c:pt>
                <c:pt idx="670">
                  <c:v>17.837263817587839</c:v>
                </c:pt>
                <c:pt idx="671">
                  <c:v>17.863846923128211</c:v>
                </c:pt>
                <c:pt idx="672">
                  <c:v>17.890430028668579</c:v>
                </c:pt>
                <c:pt idx="673">
                  <c:v>17.917013134208947</c:v>
                </c:pt>
                <c:pt idx="674">
                  <c:v>17.943596239749318</c:v>
                </c:pt>
                <c:pt idx="675">
                  <c:v>17.970179345289687</c:v>
                </c:pt>
                <c:pt idx="676">
                  <c:v>17.996762450830058</c:v>
                </c:pt>
                <c:pt idx="677">
                  <c:v>18.023345556370426</c:v>
                </c:pt>
                <c:pt idx="678">
                  <c:v>18.049928661910794</c:v>
                </c:pt>
                <c:pt idx="679">
                  <c:v>18.076511767451166</c:v>
                </c:pt>
                <c:pt idx="680">
                  <c:v>18.103094872991534</c:v>
                </c:pt>
                <c:pt idx="681">
                  <c:v>18.129677978531902</c:v>
                </c:pt>
                <c:pt idx="682">
                  <c:v>18.156261084072273</c:v>
                </c:pt>
                <c:pt idx="683">
                  <c:v>18.182844189612641</c:v>
                </c:pt>
                <c:pt idx="684">
                  <c:v>18.209427295153013</c:v>
                </c:pt>
                <c:pt idx="685">
                  <c:v>18.236010400693381</c:v>
                </c:pt>
                <c:pt idx="686">
                  <c:v>18.262593506233749</c:v>
                </c:pt>
                <c:pt idx="687">
                  <c:v>18.289176611774121</c:v>
                </c:pt>
                <c:pt idx="688">
                  <c:v>18.315759717314489</c:v>
                </c:pt>
                <c:pt idx="689">
                  <c:v>18.342342822854857</c:v>
                </c:pt>
                <c:pt idx="690">
                  <c:v>18.368925928395228</c:v>
                </c:pt>
                <c:pt idx="691">
                  <c:v>18.395509033935596</c:v>
                </c:pt>
                <c:pt idx="692">
                  <c:v>18.422092139475968</c:v>
                </c:pt>
                <c:pt idx="693">
                  <c:v>18.448675245016336</c:v>
                </c:pt>
                <c:pt idx="694">
                  <c:v>18.475258350556704</c:v>
                </c:pt>
                <c:pt idx="695">
                  <c:v>18.501841456097075</c:v>
                </c:pt>
                <c:pt idx="696">
                  <c:v>18.528424561637443</c:v>
                </c:pt>
                <c:pt idx="697">
                  <c:v>18.555007667177811</c:v>
                </c:pt>
                <c:pt idx="698">
                  <c:v>18.581590772718183</c:v>
                </c:pt>
                <c:pt idx="699">
                  <c:v>18.608173878258551</c:v>
                </c:pt>
                <c:pt idx="700">
                  <c:v>18.634756983798923</c:v>
                </c:pt>
                <c:pt idx="701">
                  <c:v>18.661340089339291</c:v>
                </c:pt>
                <c:pt idx="702">
                  <c:v>18.687923194879659</c:v>
                </c:pt>
                <c:pt idx="703">
                  <c:v>18.71450630042003</c:v>
                </c:pt>
                <c:pt idx="704">
                  <c:v>18.741089405960398</c:v>
                </c:pt>
                <c:pt idx="705">
                  <c:v>18.767672511500766</c:v>
                </c:pt>
                <c:pt idx="706">
                  <c:v>18.794255617041138</c:v>
                </c:pt>
                <c:pt idx="707">
                  <c:v>18.820838722581506</c:v>
                </c:pt>
                <c:pt idx="708">
                  <c:v>18.847421828121877</c:v>
                </c:pt>
                <c:pt idx="709">
                  <c:v>18.874004933662246</c:v>
                </c:pt>
                <c:pt idx="710">
                  <c:v>18.900588039202614</c:v>
                </c:pt>
                <c:pt idx="711">
                  <c:v>18.927171144742985</c:v>
                </c:pt>
                <c:pt idx="712">
                  <c:v>18.953754250283353</c:v>
                </c:pt>
                <c:pt idx="713">
                  <c:v>18.980337355823721</c:v>
                </c:pt>
                <c:pt idx="714">
                  <c:v>19.006920461364093</c:v>
                </c:pt>
                <c:pt idx="715">
                  <c:v>19.033503566904461</c:v>
                </c:pt>
                <c:pt idx="716">
                  <c:v>19.060086672444832</c:v>
                </c:pt>
                <c:pt idx="717">
                  <c:v>19.0866697779852</c:v>
                </c:pt>
                <c:pt idx="718">
                  <c:v>19.113252883525568</c:v>
                </c:pt>
                <c:pt idx="719">
                  <c:v>19.13983598906594</c:v>
                </c:pt>
                <c:pt idx="720">
                  <c:v>19.166419094606308</c:v>
                </c:pt>
                <c:pt idx="721">
                  <c:v>19.193002200146676</c:v>
                </c:pt>
                <c:pt idx="722">
                  <c:v>19.219585305687048</c:v>
                </c:pt>
                <c:pt idx="723">
                  <c:v>19.246168411227416</c:v>
                </c:pt>
                <c:pt idx="724">
                  <c:v>19.272751516767787</c:v>
                </c:pt>
                <c:pt idx="725">
                  <c:v>19.299334622308155</c:v>
                </c:pt>
                <c:pt idx="726">
                  <c:v>19.325917727848523</c:v>
                </c:pt>
                <c:pt idx="727">
                  <c:v>19.352500833388895</c:v>
                </c:pt>
                <c:pt idx="728">
                  <c:v>19.379083938929263</c:v>
                </c:pt>
                <c:pt idx="729">
                  <c:v>19.405667044469631</c:v>
                </c:pt>
                <c:pt idx="730">
                  <c:v>19.432250150010002</c:v>
                </c:pt>
                <c:pt idx="731">
                  <c:v>19.45883325555037</c:v>
                </c:pt>
                <c:pt idx="732">
                  <c:v>19.485416361090742</c:v>
                </c:pt>
                <c:pt idx="733">
                  <c:v>19.51199946663111</c:v>
                </c:pt>
                <c:pt idx="734">
                  <c:v>19.538582572171478</c:v>
                </c:pt>
                <c:pt idx="735">
                  <c:v>19.56516567771185</c:v>
                </c:pt>
                <c:pt idx="736">
                  <c:v>19.591748783252218</c:v>
                </c:pt>
                <c:pt idx="737">
                  <c:v>19.618331888792586</c:v>
                </c:pt>
                <c:pt idx="738">
                  <c:v>19.644914994332957</c:v>
                </c:pt>
                <c:pt idx="739">
                  <c:v>19.671498099873325</c:v>
                </c:pt>
                <c:pt idx="740">
                  <c:v>19.698081205413697</c:v>
                </c:pt>
                <c:pt idx="741">
                  <c:v>19.724664310954065</c:v>
                </c:pt>
                <c:pt idx="742">
                  <c:v>19.751247416494433</c:v>
                </c:pt>
                <c:pt idx="743">
                  <c:v>19.777830522034805</c:v>
                </c:pt>
                <c:pt idx="744">
                  <c:v>19.804413627575173</c:v>
                </c:pt>
                <c:pt idx="745">
                  <c:v>19.830996733115541</c:v>
                </c:pt>
                <c:pt idx="746">
                  <c:v>19.857579838655912</c:v>
                </c:pt>
                <c:pt idx="747">
                  <c:v>19.88416294419628</c:v>
                </c:pt>
                <c:pt idx="748">
                  <c:v>19.910746049736652</c:v>
                </c:pt>
                <c:pt idx="749">
                  <c:v>19.93732915527702</c:v>
                </c:pt>
                <c:pt idx="750">
                  <c:v>19.963912260817388</c:v>
                </c:pt>
                <c:pt idx="751">
                  <c:v>19.990495366357759</c:v>
                </c:pt>
                <c:pt idx="752">
                  <c:v>20.017078471898127</c:v>
                </c:pt>
                <c:pt idx="753">
                  <c:v>20.043661577438495</c:v>
                </c:pt>
                <c:pt idx="754">
                  <c:v>20.070244682978867</c:v>
                </c:pt>
                <c:pt idx="755">
                  <c:v>20.096827788519235</c:v>
                </c:pt>
                <c:pt idx="756">
                  <c:v>20.123410894059607</c:v>
                </c:pt>
                <c:pt idx="757">
                  <c:v>20.149993999599975</c:v>
                </c:pt>
                <c:pt idx="758">
                  <c:v>20.176577105140343</c:v>
                </c:pt>
                <c:pt idx="759">
                  <c:v>20.203160210680714</c:v>
                </c:pt>
                <c:pt idx="760">
                  <c:v>20.229743316221082</c:v>
                </c:pt>
                <c:pt idx="761">
                  <c:v>20.25632642176145</c:v>
                </c:pt>
                <c:pt idx="762">
                  <c:v>20.282909527301822</c:v>
                </c:pt>
                <c:pt idx="763">
                  <c:v>20.30949263284219</c:v>
                </c:pt>
                <c:pt idx="764">
                  <c:v>20.336075738382561</c:v>
                </c:pt>
                <c:pt idx="765">
                  <c:v>20.362658843922929</c:v>
                </c:pt>
                <c:pt idx="766">
                  <c:v>20.389241949463297</c:v>
                </c:pt>
                <c:pt idx="767">
                  <c:v>20.415825055003669</c:v>
                </c:pt>
                <c:pt idx="768">
                  <c:v>20.442408160544037</c:v>
                </c:pt>
                <c:pt idx="769">
                  <c:v>20.468991266084405</c:v>
                </c:pt>
                <c:pt idx="770">
                  <c:v>20.495574371624777</c:v>
                </c:pt>
                <c:pt idx="771">
                  <c:v>20.522157477165145</c:v>
                </c:pt>
                <c:pt idx="772">
                  <c:v>20.548740582705516</c:v>
                </c:pt>
                <c:pt idx="773">
                  <c:v>20.575323688245884</c:v>
                </c:pt>
                <c:pt idx="774">
                  <c:v>20.601906793786252</c:v>
                </c:pt>
                <c:pt idx="775">
                  <c:v>20.628489899326624</c:v>
                </c:pt>
                <c:pt idx="776">
                  <c:v>20.655073004866992</c:v>
                </c:pt>
                <c:pt idx="777">
                  <c:v>20.68165611040736</c:v>
                </c:pt>
                <c:pt idx="778">
                  <c:v>20.708239215947732</c:v>
                </c:pt>
                <c:pt idx="779">
                  <c:v>20.7348223214881</c:v>
                </c:pt>
                <c:pt idx="780">
                  <c:v>20.761405427028471</c:v>
                </c:pt>
                <c:pt idx="781">
                  <c:v>20.787988532568839</c:v>
                </c:pt>
                <c:pt idx="782">
                  <c:v>20.814571638109207</c:v>
                </c:pt>
                <c:pt idx="783">
                  <c:v>20.841154743649579</c:v>
                </c:pt>
                <c:pt idx="784">
                  <c:v>20.867737849189947</c:v>
                </c:pt>
                <c:pt idx="785">
                  <c:v>20.894320954730315</c:v>
                </c:pt>
                <c:pt idx="786">
                  <c:v>20.920904060270686</c:v>
                </c:pt>
                <c:pt idx="787">
                  <c:v>20.947487165811054</c:v>
                </c:pt>
                <c:pt idx="788">
                  <c:v>20.974070271351426</c:v>
                </c:pt>
                <c:pt idx="789">
                  <c:v>21.000653376891794</c:v>
                </c:pt>
                <c:pt idx="790">
                  <c:v>21.027236482432162</c:v>
                </c:pt>
                <c:pt idx="791">
                  <c:v>21.053819587972534</c:v>
                </c:pt>
                <c:pt idx="792">
                  <c:v>21.080402693512902</c:v>
                </c:pt>
                <c:pt idx="793">
                  <c:v>21.10698579905327</c:v>
                </c:pt>
                <c:pt idx="794">
                  <c:v>21.133568904593641</c:v>
                </c:pt>
                <c:pt idx="795">
                  <c:v>21.160152010134009</c:v>
                </c:pt>
                <c:pt idx="796">
                  <c:v>21.186735115674381</c:v>
                </c:pt>
                <c:pt idx="797">
                  <c:v>21.213318221214749</c:v>
                </c:pt>
                <c:pt idx="798">
                  <c:v>21.239901326755117</c:v>
                </c:pt>
                <c:pt idx="799">
                  <c:v>21.266484432295488</c:v>
                </c:pt>
                <c:pt idx="800">
                  <c:v>21.293067537835856</c:v>
                </c:pt>
                <c:pt idx="801">
                  <c:v>21.319650643376228</c:v>
                </c:pt>
                <c:pt idx="802">
                  <c:v>21.346233748916596</c:v>
                </c:pt>
                <c:pt idx="803">
                  <c:v>21.372816854456964</c:v>
                </c:pt>
                <c:pt idx="804">
                  <c:v>21.399399959997336</c:v>
                </c:pt>
                <c:pt idx="805">
                  <c:v>21.425983065537704</c:v>
                </c:pt>
                <c:pt idx="806">
                  <c:v>21.452566171078072</c:v>
                </c:pt>
                <c:pt idx="807">
                  <c:v>21.479149276618443</c:v>
                </c:pt>
                <c:pt idx="808">
                  <c:v>21.505732382158811</c:v>
                </c:pt>
                <c:pt idx="809">
                  <c:v>21.532315487699183</c:v>
                </c:pt>
                <c:pt idx="810">
                  <c:v>21.558898593239551</c:v>
                </c:pt>
                <c:pt idx="811">
                  <c:v>21.585481698779919</c:v>
                </c:pt>
                <c:pt idx="812">
                  <c:v>21.612064804320291</c:v>
                </c:pt>
                <c:pt idx="813">
                  <c:v>21.638647909860659</c:v>
                </c:pt>
                <c:pt idx="814">
                  <c:v>21.665231015401027</c:v>
                </c:pt>
                <c:pt idx="815">
                  <c:v>21.691814120941398</c:v>
                </c:pt>
                <c:pt idx="816">
                  <c:v>21.718397226481766</c:v>
                </c:pt>
                <c:pt idx="817">
                  <c:v>21.744980332022138</c:v>
                </c:pt>
                <c:pt idx="818">
                  <c:v>21.771563437562506</c:v>
                </c:pt>
                <c:pt idx="819">
                  <c:v>21.798146543102874</c:v>
                </c:pt>
                <c:pt idx="820">
                  <c:v>21.824729648643245</c:v>
                </c:pt>
                <c:pt idx="821">
                  <c:v>21.851312754183613</c:v>
                </c:pt>
                <c:pt idx="822">
                  <c:v>21.877895859723981</c:v>
                </c:pt>
                <c:pt idx="823">
                  <c:v>21.904478965264353</c:v>
                </c:pt>
                <c:pt idx="824">
                  <c:v>21.931062070804721</c:v>
                </c:pt>
                <c:pt idx="825">
                  <c:v>21.957645176345093</c:v>
                </c:pt>
                <c:pt idx="826">
                  <c:v>21.984228281885461</c:v>
                </c:pt>
                <c:pt idx="827">
                  <c:v>22.010811387425829</c:v>
                </c:pt>
                <c:pt idx="828">
                  <c:v>22.0373944929662</c:v>
                </c:pt>
                <c:pt idx="829">
                  <c:v>22.063977598506568</c:v>
                </c:pt>
                <c:pt idx="830">
                  <c:v>22.090560704046936</c:v>
                </c:pt>
                <c:pt idx="831">
                  <c:v>22.117143809587308</c:v>
                </c:pt>
                <c:pt idx="832">
                  <c:v>22.143726915127676</c:v>
                </c:pt>
                <c:pt idx="833">
                  <c:v>22.170310020668047</c:v>
                </c:pt>
                <c:pt idx="834">
                  <c:v>22.196893126208415</c:v>
                </c:pt>
                <c:pt idx="835">
                  <c:v>22.223476231748784</c:v>
                </c:pt>
                <c:pt idx="836">
                  <c:v>22.250059337289155</c:v>
                </c:pt>
                <c:pt idx="837">
                  <c:v>22.276642442829523</c:v>
                </c:pt>
                <c:pt idx="838">
                  <c:v>22.303225548369891</c:v>
                </c:pt>
                <c:pt idx="839">
                  <c:v>22.329808653910263</c:v>
                </c:pt>
                <c:pt idx="840">
                  <c:v>22.356391759450631</c:v>
                </c:pt>
                <c:pt idx="841">
                  <c:v>22.382974864991002</c:v>
                </c:pt>
                <c:pt idx="842">
                  <c:v>22.40955797053137</c:v>
                </c:pt>
                <c:pt idx="843">
                  <c:v>22.436141076071738</c:v>
                </c:pt>
                <c:pt idx="844">
                  <c:v>22.46272418161211</c:v>
                </c:pt>
                <c:pt idx="845">
                  <c:v>22.489307287152478</c:v>
                </c:pt>
                <c:pt idx="846">
                  <c:v>22.515890392692846</c:v>
                </c:pt>
                <c:pt idx="847">
                  <c:v>22.542473498233218</c:v>
                </c:pt>
                <c:pt idx="848">
                  <c:v>22.569056603773586</c:v>
                </c:pt>
                <c:pt idx="849">
                  <c:v>22.595639709313957</c:v>
                </c:pt>
                <c:pt idx="850">
                  <c:v>22.622222814854325</c:v>
                </c:pt>
                <c:pt idx="851">
                  <c:v>22.648805920394693</c:v>
                </c:pt>
                <c:pt idx="852">
                  <c:v>22.675389025935065</c:v>
                </c:pt>
                <c:pt idx="853">
                  <c:v>22.701972131475433</c:v>
                </c:pt>
                <c:pt idx="854">
                  <c:v>22.728555237015801</c:v>
                </c:pt>
                <c:pt idx="855">
                  <c:v>22.755138342556172</c:v>
                </c:pt>
                <c:pt idx="856">
                  <c:v>22.78172144809654</c:v>
                </c:pt>
                <c:pt idx="857">
                  <c:v>22.808304553636912</c:v>
                </c:pt>
                <c:pt idx="858">
                  <c:v>22.83488765917728</c:v>
                </c:pt>
                <c:pt idx="859">
                  <c:v>22.861470764717648</c:v>
                </c:pt>
                <c:pt idx="860">
                  <c:v>22.88805387025802</c:v>
                </c:pt>
                <c:pt idx="861">
                  <c:v>22.914636975798388</c:v>
                </c:pt>
                <c:pt idx="862">
                  <c:v>22.941220081338756</c:v>
                </c:pt>
                <c:pt idx="863">
                  <c:v>22.967803186879127</c:v>
                </c:pt>
                <c:pt idx="864">
                  <c:v>22.994386292419495</c:v>
                </c:pt>
                <c:pt idx="865">
                  <c:v>23.020969397959867</c:v>
                </c:pt>
                <c:pt idx="866">
                  <c:v>23.047552503500235</c:v>
                </c:pt>
                <c:pt idx="867">
                  <c:v>23.074135609040603</c:v>
                </c:pt>
                <c:pt idx="868">
                  <c:v>23.100718714580974</c:v>
                </c:pt>
                <c:pt idx="869">
                  <c:v>23.127301820121343</c:v>
                </c:pt>
                <c:pt idx="870">
                  <c:v>23.153884925661711</c:v>
                </c:pt>
                <c:pt idx="871">
                  <c:v>23.180468031202082</c:v>
                </c:pt>
                <c:pt idx="872">
                  <c:v>23.20705113674245</c:v>
                </c:pt>
                <c:pt idx="873">
                  <c:v>23.233634242282822</c:v>
                </c:pt>
                <c:pt idx="874">
                  <c:v>23.26021734782319</c:v>
                </c:pt>
                <c:pt idx="875">
                  <c:v>23.286800453363558</c:v>
                </c:pt>
                <c:pt idx="876">
                  <c:v>23.313383558903929</c:v>
                </c:pt>
                <c:pt idx="877">
                  <c:v>23.339966664444297</c:v>
                </c:pt>
                <c:pt idx="878">
                  <c:v>23.366549769984665</c:v>
                </c:pt>
                <c:pt idx="879">
                  <c:v>23.393132875525037</c:v>
                </c:pt>
                <c:pt idx="880">
                  <c:v>23.419715981065405</c:v>
                </c:pt>
                <c:pt idx="881">
                  <c:v>23.446299086605777</c:v>
                </c:pt>
                <c:pt idx="882">
                  <c:v>23.472882192146145</c:v>
                </c:pt>
                <c:pt idx="883">
                  <c:v>23.499465297686513</c:v>
                </c:pt>
                <c:pt idx="884">
                  <c:v>23.526048403226884</c:v>
                </c:pt>
                <c:pt idx="885">
                  <c:v>23.552631508767252</c:v>
                </c:pt>
                <c:pt idx="886">
                  <c:v>23.57921461430762</c:v>
                </c:pt>
                <c:pt idx="887">
                  <c:v>23.605797719847992</c:v>
                </c:pt>
                <c:pt idx="888">
                  <c:v>23.63238082538836</c:v>
                </c:pt>
                <c:pt idx="889">
                  <c:v>23.658963930928731</c:v>
                </c:pt>
                <c:pt idx="890">
                  <c:v>23.685547036469099</c:v>
                </c:pt>
                <c:pt idx="891">
                  <c:v>23.712130142009467</c:v>
                </c:pt>
                <c:pt idx="892">
                  <c:v>23.738713247549839</c:v>
                </c:pt>
                <c:pt idx="893">
                  <c:v>23.765296353090207</c:v>
                </c:pt>
                <c:pt idx="894">
                  <c:v>23.791879458630575</c:v>
                </c:pt>
                <c:pt idx="895">
                  <c:v>23.818462564170947</c:v>
                </c:pt>
                <c:pt idx="896">
                  <c:v>23.845045669711315</c:v>
                </c:pt>
                <c:pt idx="897">
                  <c:v>23.871628775251686</c:v>
                </c:pt>
                <c:pt idx="898">
                  <c:v>23.898211880792054</c:v>
                </c:pt>
                <c:pt idx="899">
                  <c:v>23.924794986332422</c:v>
                </c:pt>
                <c:pt idx="900">
                  <c:v>23.951378091872794</c:v>
                </c:pt>
                <c:pt idx="901">
                  <c:v>23.977961197413162</c:v>
                </c:pt>
                <c:pt idx="902">
                  <c:v>24.00454430295353</c:v>
                </c:pt>
                <c:pt idx="903">
                  <c:v>24.031127408493901</c:v>
                </c:pt>
                <c:pt idx="904">
                  <c:v>24.05771051403427</c:v>
                </c:pt>
                <c:pt idx="905">
                  <c:v>24.084293619574641</c:v>
                </c:pt>
                <c:pt idx="906">
                  <c:v>24.110876725115009</c:v>
                </c:pt>
                <c:pt idx="907">
                  <c:v>24.137459830655377</c:v>
                </c:pt>
                <c:pt idx="908">
                  <c:v>24.164042936195749</c:v>
                </c:pt>
                <c:pt idx="909">
                  <c:v>24.190626041736117</c:v>
                </c:pt>
                <c:pt idx="910">
                  <c:v>24.217209147276485</c:v>
                </c:pt>
                <c:pt idx="911">
                  <c:v>24.243792252816856</c:v>
                </c:pt>
                <c:pt idx="912">
                  <c:v>24.270375358357224</c:v>
                </c:pt>
                <c:pt idx="913">
                  <c:v>24.296958463897596</c:v>
                </c:pt>
                <c:pt idx="914">
                  <c:v>24.323541569437964</c:v>
                </c:pt>
                <c:pt idx="915">
                  <c:v>24.350124674978332</c:v>
                </c:pt>
                <c:pt idx="916">
                  <c:v>24.376707780518704</c:v>
                </c:pt>
                <c:pt idx="917">
                  <c:v>24.403290886059072</c:v>
                </c:pt>
                <c:pt idx="918">
                  <c:v>24.42987399159944</c:v>
                </c:pt>
                <c:pt idx="919">
                  <c:v>24.456457097139811</c:v>
                </c:pt>
                <c:pt idx="920">
                  <c:v>24.483040202680179</c:v>
                </c:pt>
                <c:pt idx="921">
                  <c:v>24.509623308220551</c:v>
                </c:pt>
                <c:pt idx="922">
                  <c:v>24.536206413760919</c:v>
                </c:pt>
                <c:pt idx="923">
                  <c:v>24.562789519301287</c:v>
                </c:pt>
                <c:pt idx="924">
                  <c:v>24.589372624841658</c:v>
                </c:pt>
                <c:pt idx="925">
                  <c:v>24.615955730382026</c:v>
                </c:pt>
                <c:pt idx="926">
                  <c:v>24.642538835922394</c:v>
                </c:pt>
                <c:pt idx="927">
                  <c:v>24.669121941462766</c:v>
                </c:pt>
                <c:pt idx="928">
                  <c:v>24.695705047003134</c:v>
                </c:pt>
                <c:pt idx="929">
                  <c:v>24.722288152543506</c:v>
                </c:pt>
                <c:pt idx="930">
                  <c:v>24.748871258083874</c:v>
                </c:pt>
                <c:pt idx="931">
                  <c:v>24.775454363624242</c:v>
                </c:pt>
                <c:pt idx="932">
                  <c:v>24.802037469164613</c:v>
                </c:pt>
                <c:pt idx="933">
                  <c:v>24.828620574704981</c:v>
                </c:pt>
                <c:pt idx="934">
                  <c:v>24.855203680245353</c:v>
                </c:pt>
                <c:pt idx="935">
                  <c:v>24.881786785785721</c:v>
                </c:pt>
                <c:pt idx="936">
                  <c:v>24.908369891326089</c:v>
                </c:pt>
              </c:numCache>
            </c:numRef>
          </c:xVal>
          <c:yVal>
            <c:numRef>
              <c:f>Curves!$B$4</c:f>
              <c:numCache>
                <c:formatCode>###0.00</c:formatCode>
                <c:ptCount val="1"/>
                <c:pt idx="0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52B-274D-9532-C09E012E20DD}"/>
            </c:ext>
          </c:extLst>
        </c:ser>
        <c:ser>
          <c:idx val="2"/>
          <c:order val="2"/>
          <c:marker>
            <c:symbol val="none"/>
          </c:marker>
          <c:xVal>
            <c:numRef>
              <c:f>Curves!$A$5:$A$941</c:f>
              <c:numCache>
                <c:formatCode>###0.00</c:formatCode>
                <c:ptCount val="937"/>
                <c:pt idx="0">
                  <c:v>2.658310554036936E-2</c:v>
                </c:pt>
                <c:pt idx="1">
                  <c:v>5.3166211080738719E-2</c:v>
                </c:pt>
                <c:pt idx="2">
                  <c:v>7.9749316621108082E-2</c:v>
                </c:pt>
                <c:pt idx="3">
                  <c:v>0.10633242216147744</c:v>
                </c:pt>
                <c:pt idx="4">
                  <c:v>0.13291552770184681</c:v>
                </c:pt>
                <c:pt idx="5">
                  <c:v>0.15949863324221616</c:v>
                </c:pt>
                <c:pt idx="6">
                  <c:v>0.18608173878258552</c:v>
                </c:pt>
                <c:pt idx="7">
                  <c:v>0.21266484432295488</c:v>
                </c:pt>
                <c:pt idx="8">
                  <c:v>0.23924794986332423</c:v>
                </c:pt>
                <c:pt idx="9">
                  <c:v>0.26583105540369362</c:v>
                </c:pt>
                <c:pt idx="10">
                  <c:v>0.29241416094406297</c:v>
                </c:pt>
                <c:pt idx="11">
                  <c:v>0.31899726648443233</c:v>
                </c:pt>
                <c:pt idx="12">
                  <c:v>0.34558037202480169</c:v>
                </c:pt>
                <c:pt idx="13">
                  <c:v>0.37216347756517104</c:v>
                </c:pt>
                <c:pt idx="14">
                  <c:v>0.3987465831055404</c:v>
                </c:pt>
                <c:pt idx="15">
                  <c:v>0.42532968864590975</c:v>
                </c:pt>
                <c:pt idx="16">
                  <c:v>0.45191279418627911</c:v>
                </c:pt>
                <c:pt idx="17">
                  <c:v>0.47849589972664847</c:v>
                </c:pt>
                <c:pt idx="18">
                  <c:v>0.50507900526701788</c:v>
                </c:pt>
                <c:pt idx="19">
                  <c:v>0.53166211080738723</c:v>
                </c:pt>
                <c:pt idx="20">
                  <c:v>0.55824521634775659</c:v>
                </c:pt>
                <c:pt idx="21">
                  <c:v>0.58482832188812595</c:v>
                </c:pt>
                <c:pt idx="22">
                  <c:v>0.6114114274284953</c:v>
                </c:pt>
                <c:pt idx="23">
                  <c:v>0.63799453296886466</c:v>
                </c:pt>
                <c:pt idx="24">
                  <c:v>0.66457763850923401</c:v>
                </c:pt>
                <c:pt idx="25">
                  <c:v>0.69116074404960337</c:v>
                </c:pt>
                <c:pt idx="26">
                  <c:v>0.71774384958997273</c:v>
                </c:pt>
                <c:pt idx="27">
                  <c:v>0.74432695513034208</c:v>
                </c:pt>
                <c:pt idx="28">
                  <c:v>0.77091006067071144</c:v>
                </c:pt>
                <c:pt idx="29">
                  <c:v>0.7974931662110808</c:v>
                </c:pt>
                <c:pt idx="30">
                  <c:v>0.82407627175145015</c:v>
                </c:pt>
                <c:pt idx="31">
                  <c:v>0.85065937729181951</c:v>
                </c:pt>
                <c:pt idx="32">
                  <c:v>0.87724248283218886</c:v>
                </c:pt>
                <c:pt idx="33">
                  <c:v>0.90382558837255822</c:v>
                </c:pt>
                <c:pt idx="34">
                  <c:v>0.93040869391292758</c:v>
                </c:pt>
                <c:pt idx="35">
                  <c:v>0.95699179945329693</c:v>
                </c:pt>
                <c:pt idx="36">
                  <c:v>0.98357490499366629</c:v>
                </c:pt>
                <c:pt idx="37">
                  <c:v>1.0101580105340358</c:v>
                </c:pt>
                <c:pt idx="38">
                  <c:v>1.0367411160744051</c:v>
                </c:pt>
                <c:pt idx="39">
                  <c:v>1.0633242216147745</c:v>
                </c:pt>
                <c:pt idx="40">
                  <c:v>1.0899073271551438</c:v>
                </c:pt>
                <c:pt idx="41">
                  <c:v>1.1164904326955132</c:v>
                </c:pt>
                <c:pt idx="42">
                  <c:v>1.1430735382358825</c:v>
                </c:pt>
                <c:pt idx="43">
                  <c:v>1.1696566437762519</c:v>
                </c:pt>
                <c:pt idx="44">
                  <c:v>1.1962397493166212</c:v>
                </c:pt>
                <c:pt idx="45">
                  <c:v>1.2228228548569906</c:v>
                </c:pt>
                <c:pt idx="46">
                  <c:v>1.24940596039736</c:v>
                </c:pt>
                <c:pt idx="47">
                  <c:v>1.2759890659377293</c:v>
                </c:pt>
                <c:pt idx="48">
                  <c:v>1.3025721714780987</c:v>
                </c:pt>
                <c:pt idx="49">
                  <c:v>1.329155277018468</c:v>
                </c:pt>
                <c:pt idx="50">
                  <c:v>1.3557383825588374</c:v>
                </c:pt>
                <c:pt idx="51">
                  <c:v>1.3823214880992067</c:v>
                </c:pt>
                <c:pt idx="52">
                  <c:v>1.4089045936395761</c:v>
                </c:pt>
                <c:pt idx="53">
                  <c:v>1.4354876991799455</c:v>
                </c:pt>
                <c:pt idx="54">
                  <c:v>1.4620708047203148</c:v>
                </c:pt>
                <c:pt idx="55">
                  <c:v>1.4886539102606842</c:v>
                </c:pt>
                <c:pt idx="56">
                  <c:v>1.5152370158010535</c:v>
                </c:pt>
                <c:pt idx="57">
                  <c:v>1.5418201213414229</c:v>
                </c:pt>
                <c:pt idx="58">
                  <c:v>1.5684032268817922</c:v>
                </c:pt>
                <c:pt idx="59">
                  <c:v>1.5949863324221616</c:v>
                </c:pt>
                <c:pt idx="60">
                  <c:v>1.6215694379625309</c:v>
                </c:pt>
                <c:pt idx="61">
                  <c:v>1.6481525435029003</c:v>
                </c:pt>
                <c:pt idx="62">
                  <c:v>1.6747356490432697</c:v>
                </c:pt>
                <c:pt idx="63">
                  <c:v>1.701318754583639</c:v>
                </c:pt>
                <c:pt idx="64">
                  <c:v>1.7279018601240084</c:v>
                </c:pt>
                <c:pt idx="65">
                  <c:v>1.7544849656643777</c:v>
                </c:pt>
                <c:pt idx="66">
                  <c:v>1.7810680712047471</c:v>
                </c:pt>
                <c:pt idx="67">
                  <c:v>1.8076511767451164</c:v>
                </c:pt>
                <c:pt idx="68">
                  <c:v>1.8342342822854858</c:v>
                </c:pt>
                <c:pt idx="69">
                  <c:v>1.8608173878258552</c:v>
                </c:pt>
                <c:pt idx="70">
                  <c:v>1.8874004933662245</c:v>
                </c:pt>
                <c:pt idx="71">
                  <c:v>1.9139835989065939</c:v>
                </c:pt>
                <c:pt idx="72">
                  <c:v>1.9405667044469632</c:v>
                </c:pt>
                <c:pt idx="73">
                  <c:v>1.9671498099873326</c:v>
                </c:pt>
                <c:pt idx="74">
                  <c:v>1.9937329155277019</c:v>
                </c:pt>
                <c:pt idx="75">
                  <c:v>2.0203160210680715</c:v>
                </c:pt>
                <c:pt idx="76">
                  <c:v>2.0468991266084409</c:v>
                </c:pt>
                <c:pt idx="77">
                  <c:v>2.0734822321488102</c:v>
                </c:pt>
                <c:pt idx="78">
                  <c:v>2.1000653376891796</c:v>
                </c:pt>
                <c:pt idx="79">
                  <c:v>2.1266484432295489</c:v>
                </c:pt>
                <c:pt idx="80">
                  <c:v>2.1532315487699183</c:v>
                </c:pt>
                <c:pt idx="81">
                  <c:v>2.1798146543102876</c:v>
                </c:pt>
                <c:pt idx="82">
                  <c:v>2.206397759850657</c:v>
                </c:pt>
                <c:pt idx="83">
                  <c:v>2.2329808653910264</c:v>
                </c:pt>
                <c:pt idx="84">
                  <c:v>2.2595639709313957</c:v>
                </c:pt>
                <c:pt idx="85">
                  <c:v>2.2861470764717651</c:v>
                </c:pt>
                <c:pt idx="86">
                  <c:v>2.3127301820121344</c:v>
                </c:pt>
                <c:pt idx="87">
                  <c:v>2.3393132875525038</c:v>
                </c:pt>
                <c:pt idx="88">
                  <c:v>2.3658963930928731</c:v>
                </c:pt>
                <c:pt idx="89">
                  <c:v>2.3924794986332425</c:v>
                </c:pt>
                <c:pt idx="90">
                  <c:v>2.4190626041736119</c:v>
                </c:pt>
                <c:pt idx="91">
                  <c:v>2.4456457097139812</c:v>
                </c:pt>
                <c:pt idx="92">
                  <c:v>2.4722288152543506</c:v>
                </c:pt>
                <c:pt idx="93">
                  <c:v>2.4988119207947199</c:v>
                </c:pt>
                <c:pt idx="94">
                  <c:v>2.5253950263350893</c:v>
                </c:pt>
                <c:pt idx="95">
                  <c:v>2.5519781318754586</c:v>
                </c:pt>
                <c:pt idx="96">
                  <c:v>2.578561237415828</c:v>
                </c:pt>
                <c:pt idx="97">
                  <c:v>2.6051443429561973</c:v>
                </c:pt>
                <c:pt idx="98">
                  <c:v>2.6317274484965667</c:v>
                </c:pt>
                <c:pt idx="99">
                  <c:v>2.6583105540369361</c:v>
                </c:pt>
                <c:pt idx="100">
                  <c:v>2.6848936595773054</c:v>
                </c:pt>
                <c:pt idx="101">
                  <c:v>2.7114767651176748</c:v>
                </c:pt>
                <c:pt idx="102">
                  <c:v>2.7380598706580441</c:v>
                </c:pt>
                <c:pt idx="103">
                  <c:v>2.7646429761984135</c:v>
                </c:pt>
                <c:pt idx="104">
                  <c:v>2.7912260817387828</c:v>
                </c:pt>
                <c:pt idx="105">
                  <c:v>2.8178091872791522</c:v>
                </c:pt>
                <c:pt idx="106">
                  <c:v>2.8443922928195216</c:v>
                </c:pt>
                <c:pt idx="107">
                  <c:v>2.8709753983598909</c:v>
                </c:pt>
                <c:pt idx="108">
                  <c:v>2.8975585039002603</c:v>
                </c:pt>
                <c:pt idx="109">
                  <c:v>2.9241416094406296</c:v>
                </c:pt>
                <c:pt idx="110">
                  <c:v>2.950724714980999</c:v>
                </c:pt>
                <c:pt idx="111">
                  <c:v>2.9773078205213683</c:v>
                </c:pt>
                <c:pt idx="112">
                  <c:v>3.0038909260617377</c:v>
                </c:pt>
                <c:pt idx="113">
                  <c:v>3.030474031602107</c:v>
                </c:pt>
                <c:pt idx="114">
                  <c:v>3.0570571371424764</c:v>
                </c:pt>
                <c:pt idx="115">
                  <c:v>3.0836402426828458</c:v>
                </c:pt>
                <c:pt idx="116">
                  <c:v>3.1102233482232151</c:v>
                </c:pt>
                <c:pt idx="117">
                  <c:v>3.1368064537635845</c:v>
                </c:pt>
                <c:pt idx="118">
                  <c:v>3.1633895593039538</c:v>
                </c:pt>
                <c:pt idx="119">
                  <c:v>3.1899726648443232</c:v>
                </c:pt>
                <c:pt idx="120">
                  <c:v>3.2165557703846925</c:v>
                </c:pt>
                <c:pt idx="121">
                  <c:v>3.2431388759250619</c:v>
                </c:pt>
                <c:pt idx="122">
                  <c:v>3.2697219814654312</c:v>
                </c:pt>
                <c:pt idx="123">
                  <c:v>3.2963050870058006</c:v>
                </c:pt>
                <c:pt idx="124">
                  <c:v>3.32288819254617</c:v>
                </c:pt>
                <c:pt idx="125">
                  <c:v>3.3494712980865393</c:v>
                </c:pt>
                <c:pt idx="126">
                  <c:v>3.3760544036269087</c:v>
                </c:pt>
                <c:pt idx="127">
                  <c:v>3.402637509167278</c:v>
                </c:pt>
                <c:pt idx="128">
                  <c:v>3.4292206147076474</c:v>
                </c:pt>
                <c:pt idx="129">
                  <c:v>3.4558037202480167</c:v>
                </c:pt>
                <c:pt idx="130">
                  <c:v>3.4823868257883861</c:v>
                </c:pt>
                <c:pt idx="131">
                  <c:v>3.5089699313287555</c:v>
                </c:pt>
                <c:pt idx="132">
                  <c:v>3.5355530368691248</c:v>
                </c:pt>
                <c:pt idx="133">
                  <c:v>3.5621361424094942</c:v>
                </c:pt>
                <c:pt idx="134">
                  <c:v>3.5887192479498635</c:v>
                </c:pt>
                <c:pt idx="135">
                  <c:v>3.6153023534902329</c:v>
                </c:pt>
                <c:pt idx="136">
                  <c:v>3.6418854590306022</c:v>
                </c:pt>
                <c:pt idx="137">
                  <c:v>3.6684685645709716</c:v>
                </c:pt>
                <c:pt idx="138">
                  <c:v>3.6950516701113409</c:v>
                </c:pt>
                <c:pt idx="139">
                  <c:v>3.7216347756517103</c:v>
                </c:pt>
                <c:pt idx="140">
                  <c:v>3.7482178811920797</c:v>
                </c:pt>
                <c:pt idx="141">
                  <c:v>3.774800986732449</c:v>
                </c:pt>
                <c:pt idx="142">
                  <c:v>3.8013840922728184</c:v>
                </c:pt>
                <c:pt idx="143">
                  <c:v>3.8279671978131877</c:v>
                </c:pt>
                <c:pt idx="144">
                  <c:v>3.8545503033535571</c:v>
                </c:pt>
                <c:pt idx="145">
                  <c:v>3.8811334088939264</c:v>
                </c:pt>
                <c:pt idx="146">
                  <c:v>3.9077165144342958</c:v>
                </c:pt>
                <c:pt idx="147">
                  <c:v>3.9342996199746652</c:v>
                </c:pt>
                <c:pt idx="148">
                  <c:v>3.9608827255150345</c:v>
                </c:pt>
                <c:pt idx="149">
                  <c:v>3.9874658310554039</c:v>
                </c:pt>
                <c:pt idx="150">
                  <c:v>4.0140489365957732</c:v>
                </c:pt>
                <c:pt idx="151">
                  <c:v>4.040632042136143</c:v>
                </c:pt>
                <c:pt idx="152">
                  <c:v>4.0672151476765119</c:v>
                </c:pt>
                <c:pt idx="153">
                  <c:v>4.0937982532168817</c:v>
                </c:pt>
                <c:pt idx="154">
                  <c:v>4.1203813587572506</c:v>
                </c:pt>
                <c:pt idx="155">
                  <c:v>4.1469644642976204</c:v>
                </c:pt>
                <c:pt idx="156">
                  <c:v>4.1735475698379894</c:v>
                </c:pt>
                <c:pt idx="157">
                  <c:v>4.2001306753783592</c:v>
                </c:pt>
                <c:pt idx="158">
                  <c:v>4.2267137809187281</c:v>
                </c:pt>
                <c:pt idx="159">
                  <c:v>4.2532968864590979</c:v>
                </c:pt>
                <c:pt idx="160">
                  <c:v>4.2798799919994668</c:v>
                </c:pt>
                <c:pt idx="161">
                  <c:v>4.3064630975398366</c:v>
                </c:pt>
                <c:pt idx="162">
                  <c:v>4.3330462030802055</c:v>
                </c:pt>
                <c:pt idx="163">
                  <c:v>4.3596293086205753</c:v>
                </c:pt>
                <c:pt idx="164">
                  <c:v>4.3862124141609442</c:v>
                </c:pt>
                <c:pt idx="165">
                  <c:v>4.412795519701314</c:v>
                </c:pt>
                <c:pt idx="166">
                  <c:v>4.4393786252416829</c:v>
                </c:pt>
                <c:pt idx="167">
                  <c:v>4.4659617307820527</c:v>
                </c:pt>
                <c:pt idx="168">
                  <c:v>4.4925448363224216</c:v>
                </c:pt>
                <c:pt idx="169">
                  <c:v>4.5191279418627914</c:v>
                </c:pt>
                <c:pt idx="170">
                  <c:v>4.5457110474031603</c:v>
                </c:pt>
                <c:pt idx="171">
                  <c:v>4.5722941529435301</c:v>
                </c:pt>
                <c:pt idx="172">
                  <c:v>4.5988772584838991</c:v>
                </c:pt>
                <c:pt idx="173">
                  <c:v>4.6254603640242689</c:v>
                </c:pt>
                <c:pt idx="174">
                  <c:v>4.6520434695646378</c:v>
                </c:pt>
                <c:pt idx="175">
                  <c:v>4.6786265751050076</c:v>
                </c:pt>
                <c:pt idx="176">
                  <c:v>4.7052096806453765</c:v>
                </c:pt>
                <c:pt idx="177">
                  <c:v>4.7317927861857463</c:v>
                </c:pt>
                <c:pt idx="178">
                  <c:v>4.7583758917261152</c:v>
                </c:pt>
                <c:pt idx="179">
                  <c:v>4.784958997266485</c:v>
                </c:pt>
                <c:pt idx="180">
                  <c:v>4.8115421028068539</c:v>
                </c:pt>
                <c:pt idx="181">
                  <c:v>4.8381252083472237</c:v>
                </c:pt>
                <c:pt idx="182">
                  <c:v>4.8647083138875926</c:v>
                </c:pt>
                <c:pt idx="183">
                  <c:v>4.8912914194279624</c:v>
                </c:pt>
                <c:pt idx="184">
                  <c:v>4.9178745249683313</c:v>
                </c:pt>
                <c:pt idx="185">
                  <c:v>4.9444576305087011</c:v>
                </c:pt>
                <c:pt idx="186">
                  <c:v>4.97104073604907</c:v>
                </c:pt>
                <c:pt idx="187">
                  <c:v>4.9976238415894398</c:v>
                </c:pt>
                <c:pt idx="188">
                  <c:v>5.0242069471298088</c:v>
                </c:pt>
                <c:pt idx="189">
                  <c:v>5.0507900526701786</c:v>
                </c:pt>
                <c:pt idx="190">
                  <c:v>5.0773731582105475</c:v>
                </c:pt>
                <c:pt idx="191">
                  <c:v>5.1039562637509173</c:v>
                </c:pt>
                <c:pt idx="192">
                  <c:v>5.1305393692912862</c:v>
                </c:pt>
                <c:pt idx="193">
                  <c:v>5.157122474831656</c:v>
                </c:pt>
                <c:pt idx="194">
                  <c:v>5.1837055803720249</c:v>
                </c:pt>
                <c:pt idx="195">
                  <c:v>5.2102886859123947</c:v>
                </c:pt>
                <c:pt idx="196">
                  <c:v>5.2368717914527636</c:v>
                </c:pt>
                <c:pt idx="197">
                  <c:v>5.2634548969931334</c:v>
                </c:pt>
                <c:pt idx="198">
                  <c:v>5.2900380025335023</c:v>
                </c:pt>
                <c:pt idx="199">
                  <c:v>5.3166211080738721</c:v>
                </c:pt>
                <c:pt idx="200">
                  <c:v>5.343204213614241</c:v>
                </c:pt>
                <c:pt idx="201">
                  <c:v>5.3697873191546108</c:v>
                </c:pt>
                <c:pt idx="202">
                  <c:v>5.3963704246949797</c:v>
                </c:pt>
                <c:pt idx="203">
                  <c:v>5.4229535302353495</c:v>
                </c:pt>
                <c:pt idx="204">
                  <c:v>5.4495366357757185</c:v>
                </c:pt>
                <c:pt idx="205">
                  <c:v>5.4761197413160883</c:v>
                </c:pt>
                <c:pt idx="206">
                  <c:v>5.5027028468564572</c:v>
                </c:pt>
                <c:pt idx="207">
                  <c:v>5.529285952396827</c:v>
                </c:pt>
                <c:pt idx="208">
                  <c:v>5.5558690579371959</c:v>
                </c:pt>
                <c:pt idx="209">
                  <c:v>5.5824521634775657</c:v>
                </c:pt>
                <c:pt idx="210">
                  <c:v>5.6090352690179346</c:v>
                </c:pt>
                <c:pt idx="211">
                  <c:v>5.6356183745583044</c:v>
                </c:pt>
                <c:pt idx="212">
                  <c:v>5.6622014800986733</c:v>
                </c:pt>
                <c:pt idx="213">
                  <c:v>5.6887845856390431</c:v>
                </c:pt>
                <c:pt idx="214">
                  <c:v>5.715367691179412</c:v>
                </c:pt>
                <c:pt idx="215">
                  <c:v>5.7419507967197818</c:v>
                </c:pt>
                <c:pt idx="216">
                  <c:v>5.7685339022601507</c:v>
                </c:pt>
                <c:pt idx="217">
                  <c:v>5.7951170078005205</c:v>
                </c:pt>
                <c:pt idx="218">
                  <c:v>5.8217001133408894</c:v>
                </c:pt>
                <c:pt idx="219">
                  <c:v>5.8482832188812592</c:v>
                </c:pt>
                <c:pt idx="220">
                  <c:v>5.8748663244216281</c:v>
                </c:pt>
                <c:pt idx="221">
                  <c:v>5.901449429961998</c:v>
                </c:pt>
                <c:pt idx="222">
                  <c:v>5.9280325355023669</c:v>
                </c:pt>
                <c:pt idx="223">
                  <c:v>5.9546156410427367</c:v>
                </c:pt>
                <c:pt idx="224">
                  <c:v>5.9811987465831056</c:v>
                </c:pt>
                <c:pt idx="225">
                  <c:v>6.0077818521234754</c:v>
                </c:pt>
                <c:pt idx="226">
                  <c:v>6.0343649576638443</c:v>
                </c:pt>
                <c:pt idx="227">
                  <c:v>6.0609480632042141</c:v>
                </c:pt>
                <c:pt idx="228">
                  <c:v>6.087531168744583</c:v>
                </c:pt>
                <c:pt idx="229">
                  <c:v>6.1141142742849528</c:v>
                </c:pt>
                <c:pt idx="230">
                  <c:v>6.1406973798253217</c:v>
                </c:pt>
                <c:pt idx="231">
                  <c:v>6.1672804853656915</c:v>
                </c:pt>
                <c:pt idx="232">
                  <c:v>6.1938635909060604</c:v>
                </c:pt>
                <c:pt idx="233">
                  <c:v>6.2204466964464302</c:v>
                </c:pt>
                <c:pt idx="234">
                  <c:v>6.2470298019867991</c:v>
                </c:pt>
                <c:pt idx="235">
                  <c:v>6.2736129075271689</c:v>
                </c:pt>
                <c:pt idx="236">
                  <c:v>6.3001960130675378</c:v>
                </c:pt>
                <c:pt idx="237">
                  <c:v>6.3267791186079076</c:v>
                </c:pt>
                <c:pt idx="238">
                  <c:v>6.3533622241482766</c:v>
                </c:pt>
                <c:pt idx="239">
                  <c:v>6.3799453296886464</c:v>
                </c:pt>
                <c:pt idx="240">
                  <c:v>6.4065284352290153</c:v>
                </c:pt>
                <c:pt idx="241">
                  <c:v>6.4331115407693851</c:v>
                </c:pt>
                <c:pt idx="242">
                  <c:v>6.459694646309754</c:v>
                </c:pt>
                <c:pt idx="243">
                  <c:v>6.4862777518501238</c:v>
                </c:pt>
                <c:pt idx="244">
                  <c:v>6.5128608573904927</c:v>
                </c:pt>
                <c:pt idx="245">
                  <c:v>6.5394439629308625</c:v>
                </c:pt>
                <c:pt idx="246">
                  <c:v>6.5660270684712314</c:v>
                </c:pt>
                <c:pt idx="247">
                  <c:v>6.5926101740116012</c:v>
                </c:pt>
                <c:pt idx="248">
                  <c:v>6.6191932795519701</c:v>
                </c:pt>
                <c:pt idx="249">
                  <c:v>6.6457763850923399</c:v>
                </c:pt>
                <c:pt idx="250">
                  <c:v>6.6723594906327088</c:v>
                </c:pt>
                <c:pt idx="251">
                  <c:v>6.6989425961730786</c:v>
                </c:pt>
                <c:pt idx="252">
                  <c:v>6.7255257017134475</c:v>
                </c:pt>
                <c:pt idx="253">
                  <c:v>6.7521088072538173</c:v>
                </c:pt>
                <c:pt idx="254">
                  <c:v>6.7786919127941863</c:v>
                </c:pt>
                <c:pt idx="255">
                  <c:v>6.8052750183345561</c:v>
                </c:pt>
                <c:pt idx="256">
                  <c:v>6.831858123874925</c:v>
                </c:pt>
                <c:pt idx="257">
                  <c:v>6.8584412294152948</c:v>
                </c:pt>
                <c:pt idx="258">
                  <c:v>6.8850243349556637</c:v>
                </c:pt>
                <c:pt idx="259">
                  <c:v>6.9116074404960335</c:v>
                </c:pt>
                <c:pt idx="260">
                  <c:v>6.9381905460364024</c:v>
                </c:pt>
                <c:pt idx="261">
                  <c:v>6.9647736515767722</c:v>
                </c:pt>
                <c:pt idx="262">
                  <c:v>6.9913567571171411</c:v>
                </c:pt>
                <c:pt idx="263">
                  <c:v>7.0179398626575109</c:v>
                </c:pt>
                <c:pt idx="264">
                  <c:v>7.0445229681978798</c:v>
                </c:pt>
                <c:pt idx="265">
                  <c:v>7.0711060737382496</c:v>
                </c:pt>
                <c:pt idx="266">
                  <c:v>7.0976891792786194</c:v>
                </c:pt>
                <c:pt idx="267">
                  <c:v>7.1242722848189883</c:v>
                </c:pt>
                <c:pt idx="268">
                  <c:v>7.1508553903593581</c:v>
                </c:pt>
                <c:pt idx="269">
                  <c:v>7.177438495899727</c:v>
                </c:pt>
                <c:pt idx="270">
                  <c:v>7.2040216014400968</c:v>
                </c:pt>
                <c:pt idx="271">
                  <c:v>7.2306047069804658</c:v>
                </c:pt>
                <c:pt idx="272">
                  <c:v>7.2571878125208356</c:v>
                </c:pt>
                <c:pt idx="273">
                  <c:v>7.2837709180612045</c:v>
                </c:pt>
                <c:pt idx="274">
                  <c:v>7.3103540236015743</c:v>
                </c:pt>
                <c:pt idx="275">
                  <c:v>7.3369371291419432</c:v>
                </c:pt>
                <c:pt idx="276">
                  <c:v>7.363520234682313</c:v>
                </c:pt>
                <c:pt idx="277">
                  <c:v>7.3901033402226819</c:v>
                </c:pt>
                <c:pt idx="278">
                  <c:v>7.4166864457630517</c:v>
                </c:pt>
                <c:pt idx="279">
                  <c:v>7.4432695513034206</c:v>
                </c:pt>
                <c:pt idx="280">
                  <c:v>7.4698526568437904</c:v>
                </c:pt>
                <c:pt idx="281">
                  <c:v>7.4964357623841593</c:v>
                </c:pt>
                <c:pt idx="282">
                  <c:v>7.5230188679245291</c:v>
                </c:pt>
                <c:pt idx="283">
                  <c:v>7.549601973464898</c:v>
                </c:pt>
                <c:pt idx="284">
                  <c:v>7.5761850790052678</c:v>
                </c:pt>
                <c:pt idx="285">
                  <c:v>7.6027681845456367</c:v>
                </c:pt>
                <c:pt idx="286">
                  <c:v>7.6293512900860065</c:v>
                </c:pt>
                <c:pt idx="287">
                  <c:v>7.6559343956263755</c:v>
                </c:pt>
                <c:pt idx="288">
                  <c:v>7.6825175011667453</c:v>
                </c:pt>
                <c:pt idx="289">
                  <c:v>7.7091006067071142</c:v>
                </c:pt>
                <c:pt idx="290">
                  <c:v>7.735683712247484</c:v>
                </c:pt>
                <c:pt idx="291">
                  <c:v>7.7622668177878529</c:v>
                </c:pt>
                <c:pt idx="292">
                  <c:v>7.7888499233282227</c:v>
                </c:pt>
                <c:pt idx="293">
                  <c:v>7.8154330288685916</c:v>
                </c:pt>
                <c:pt idx="294">
                  <c:v>7.8420161344089614</c:v>
                </c:pt>
                <c:pt idx="295">
                  <c:v>7.8685992399493303</c:v>
                </c:pt>
                <c:pt idx="296">
                  <c:v>7.8951823454897001</c:v>
                </c:pt>
                <c:pt idx="297">
                  <c:v>7.921765451030069</c:v>
                </c:pt>
                <c:pt idx="298">
                  <c:v>7.9483485565704388</c:v>
                </c:pt>
                <c:pt idx="299">
                  <c:v>7.9749316621108077</c:v>
                </c:pt>
                <c:pt idx="300">
                  <c:v>8.0015147676511766</c:v>
                </c:pt>
                <c:pt idx="301">
                  <c:v>8.0280978731915464</c:v>
                </c:pt>
                <c:pt idx="302">
                  <c:v>8.0546809787319162</c:v>
                </c:pt>
                <c:pt idx="303">
                  <c:v>8.081264084272286</c:v>
                </c:pt>
                <c:pt idx="304">
                  <c:v>8.1078471898126541</c:v>
                </c:pt>
                <c:pt idx="305">
                  <c:v>8.1344302953530239</c:v>
                </c:pt>
                <c:pt idx="306">
                  <c:v>8.1610134008933937</c:v>
                </c:pt>
                <c:pt idx="307">
                  <c:v>8.1875965064337635</c:v>
                </c:pt>
                <c:pt idx="308">
                  <c:v>8.2141796119741315</c:v>
                </c:pt>
                <c:pt idx="309">
                  <c:v>8.2407627175145013</c:v>
                </c:pt>
                <c:pt idx="310">
                  <c:v>8.2673458230548711</c:v>
                </c:pt>
                <c:pt idx="311">
                  <c:v>8.2939289285952409</c:v>
                </c:pt>
                <c:pt idx="312">
                  <c:v>8.3205120341356089</c:v>
                </c:pt>
                <c:pt idx="313">
                  <c:v>8.3470951396759787</c:v>
                </c:pt>
                <c:pt idx="314">
                  <c:v>8.3736782452163485</c:v>
                </c:pt>
                <c:pt idx="315">
                  <c:v>8.4002613507567183</c:v>
                </c:pt>
                <c:pt idx="316">
                  <c:v>8.4268444562970863</c:v>
                </c:pt>
                <c:pt idx="317">
                  <c:v>8.4534275618374561</c:v>
                </c:pt>
                <c:pt idx="318">
                  <c:v>8.4800106673778259</c:v>
                </c:pt>
                <c:pt idx="319">
                  <c:v>8.5065937729181957</c:v>
                </c:pt>
                <c:pt idx="320">
                  <c:v>8.5331768784585638</c:v>
                </c:pt>
                <c:pt idx="321">
                  <c:v>8.5597599839989336</c:v>
                </c:pt>
                <c:pt idx="322">
                  <c:v>8.5863430895393034</c:v>
                </c:pt>
                <c:pt idx="323">
                  <c:v>8.6129261950796732</c:v>
                </c:pt>
                <c:pt idx="324">
                  <c:v>8.6395093006200412</c:v>
                </c:pt>
                <c:pt idx="325">
                  <c:v>8.666092406160411</c:v>
                </c:pt>
                <c:pt idx="326">
                  <c:v>8.6926755117007808</c:v>
                </c:pt>
                <c:pt idx="327">
                  <c:v>8.7192586172411506</c:v>
                </c:pt>
                <c:pt idx="328">
                  <c:v>8.7458417227815186</c:v>
                </c:pt>
                <c:pt idx="329">
                  <c:v>8.7724248283218884</c:v>
                </c:pt>
                <c:pt idx="330">
                  <c:v>8.7990079338622582</c:v>
                </c:pt>
                <c:pt idx="331">
                  <c:v>8.825591039402628</c:v>
                </c:pt>
                <c:pt idx="332">
                  <c:v>8.852174144942996</c:v>
                </c:pt>
                <c:pt idx="333">
                  <c:v>8.8787572504833658</c:v>
                </c:pt>
                <c:pt idx="334">
                  <c:v>8.9053403560237356</c:v>
                </c:pt>
                <c:pt idx="335">
                  <c:v>8.9319234615641054</c:v>
                </c:pt>
                <c:pt idx="336">
                  <c:v>8.9585065671044735</c:v>
                </c:pt>
                <c:pt idx="337">
                  <c:v>8.9850896726448433</c:v>
                </c:pt>
                <c:pt idx="338">
                  <c:v>9.0116727781852131</c:v>
                </c:pt>
                <c:pt idx="339">
                  <c:v>9.0382558837255829</c:v>
                </c:pt>
                <c:pt idx="340">
                  <c:v>9.0648389892659509</c:v>
                </c:pt>
                <c:pt idx="341">
                  <c:v>9.0914220948063207</c:v>
                </c:pt>
                <c:pt idx="342">
                  <c:v>9.1180052003466905</c:v>
                </c:pt>
                <c:pt idx="343">
                  <c:v>9.1445883058870603</c:v>
                </c:pt>
                <c:pt idx="344">
                  <c:v>9.1711714114274283</c:v>
                </c:pt>
                <c:pt idx="345">
                  <c:v>9.1977545169677981</c:v>
                </c:pt>
                <c:pt idx="346">
                  <c:v>9.2243376225081679</c:v>
                </c:pt>
                <c:pt idx="347">
                  <c:v>9.2509207280485377</c:v>
                </c:pt>
                <c:pt idx="348">
                  <c:v>9.2775038335889057</c:v>
                </c:pt>
                <c:pt idx="349">
                  <c:v>9.3040869391292755</c:v>
                </c:pt>
                <c:pt idx="350">
                  <c:v>9.3306700446696453</c:v>
                </c:pt>
                <c:pt idx="351">
                  <c:v>9.3572531502100151</c:v>
                </c:pt>
                <c:pt idx="352">
                  <c:v>9.3838362557503832</c:v>
                </c:pt>
                <c:pt idx="353">
                  <c:v>9.410419361290753</c:v>
                </c:pt>
                <c:pt idx="354">
                  <c:v>9.4370024668311228</c:v>
                </c:pt>
                <c:pt idx="355">
                  <c:v>9.4635855723714926</c:v>
                </c:pt>
                <c:pt idx="356">
                  <c:v>9.4901686779118606</c:v>
                </c:pt>
                <c:pt idx="357">
                  <c:v>9.5167517834522304</c:v>
                </c:pt>
                <c:pt idx="358">
                  <c:v>9.5433348889926002</c:v>
                </c:pt>
                <c:pt idx="359">
                  <c:v>9.56991799453297</c:v>
                </c:pt>
                <c:pt idx="360">
                  <c:v>9.596501100073338</c:v>
                </c:pt>
                <c:pt idx="361">
                  <c:v>9.6230842056137078</c:v>
                </c:pt>
                <c:pt idx="362">
                  <c:v>9.6496673111540776</c:v>
                </c:pt>
                <c:pt idx="363">
                  <c:v>9.6762504166944474</c:v>
                </c:pt>
                <c:pt idx="364">
                  <c:v>9.7028335222348154</c:v>
                </c:pt>
                <c:pt idx="365">
                  <c:v>9.7294166277751852</c:v>
                </c:pt>
                <c:pt idx="366">
                  <c:v>9.755999733315555</c:v>
                </c:pt>
                <c:pt idx="367">
                  <c:v>9.7825828388559248</c:v>
                </c:pt>
                <c:pt idx="368">
                  <c:v>9.8091659443962929</c:v>
                </c:pt>
                <c:pt idx="369">
                  <c:v>9.8357490499366627</c:v>
                </c:pt>
                <c:pt idx="370">
                  <c:v>9.8623321554770325</c:v>
                </c:pt>
                <c:pt idx="371">
                  <c:v>9.8889152610174023</c:v>
                </c:pt>
                <c:pt idx="372">
                  <c:v>9.9154983665577703</c:v>
                </c:pt>
                <c:pt idx="373">
                  <c:v>9.9420814720981401</c:v>
                </c:pt>
                <c:pt idx="374">
                  <c:v>9.9686645776385099</c:v>
                </c:pt>
                <c:pt idx="375">
                  <c:v>9.9952476831788797</c:v>
                </c:pt>
                <c:pt idx="376">
                  <c:v>10.021830788719248</c:v>
                </c:pt>
                <c:pt idx="377">
                  <c:v>10.048413894259618</c:v>
                </c:pt>
                <c:pt idx="378">
                  <c:v>10.074996999799987</c:v>
                </c:pt>
                <c:pt idx="379">
                  <c:v>10.101580105340357</c:v>
                </c:pt>
                <c:pt idx="380">
                  <c:v>10.128163210880725</c:v>
                </c:pt>
                <c:pt idx="381">
                  <c:v>10.154746316421095</c:v>
                </c:pt>
                <c:pt idx="382">
                  <c:v>10.181329421961465</c:v>
                </c:pt>
                <c:pt idx="383">
                  <c:v>10.207912527501835</c:v>
                </c:pt>
                <c:pt idx="384">
                  <c:v>10.234495633042203</c:v>
                </c:pt>
                <c:pt idx="385">
                  <c:v>10.261078738582572</c:v>
                </c:pt>
                <c:pt idx="386">
                  <c:v>10.287661844122942</c:v>
                </c:pt>
                <c:pt idx="387">
                  <c:v>10.314244949663312</c:v>
                </c:pt>
                <c:pt idx="388">
                  <c:v>10.34082805520368</c:v>
                </c:pt>
                <c:pt idx="389">
                  <c:v>10.36741116074405</c:v>
                </c:pt>
                <c:pt idx="390">
                  <c:v>10.39399426628442</c:v>
                </c:pt>
                <c:pt idx="391">
                  <c:v>10.420577371824789</c:v>
                </c:pt>
                <c:pt idx="392">
                  <c:v>10.447160477365157</c:v>
                </c:pt>
                <c:pt idx="393">
                  <c:v>10.473743582905527</c:v>
                </c:pt>
                <c:pt idx="394">
                  <c:v>10.500326688445897</c:v>
                </c:pt>
                <c:pt idx="395">
                  <c:v>10.526909793986267</c:v>
                </c:pt>
                <c:pt idx="396">
                  <c:v>10.553492899526635</c:v>
                </c:pt>
                <c:pt idx="397">
                  <c:v>10.580076005067005</c:v>
                </c:pt>
                <c:pt idx="398">
                  <c:v>10.606659110607374</c:v>
                </c:pt>
                <c:pt idx="399">
                  <c:v>10.633242216147744</c:v>
                </c:pt>
                <c:pt idx="400">
                  <c:v>10.659825321688114</c:v>
                </c:pt>
                <c:pt idx="401">
                  <c:v>10.686408427228482</c:v>
                </c:pt>
                <c:pt idx="402">
                  <c:v>10.712991532768852</c:v>
                </c:pt>
                <c:pt idx="403">
                  <c:v>10.739574638309222</c:v>
                </c:pt>
                <c:pt idx="404">
                  <c:v>10.766157743849591</c:v>
                </c:pt>
                <c:pt idx="405">
                  <c:v>10.792740849389959</c:v>
                </c:pt>
                <c:pt idx="406">
                  <c:v>10.819323954930329</c:v>
                </c:pt>
                <c:pt idx="407">
                  <c:v>10.845907060470699</c:v>
                </c:pt>
                <c:pt idx="408">
                  <c:v>10.872490166011069</c:v>
                </c:pt>
                <c:pt idx="409">
                  <c:v>10.899073271551437</c:v>
                </c:pt>
                <c:pt idx="410">
                  <c:v>10.925656377091807</c:v>
                </c:pt>
                <c:pt idx="411">
                  <c:v>10.952239482632177</c:v>
                </c:pt>
                <c:pt idx="412">
                  <c:v>10.978822588172546</c:v>
                </c:pt>
                <c:pt idx="413">
                  <c:v>11.005405693712914</c:v>
                </c:pt>
                <c:pt idx="414">
                  <c:v>11.031988799253284</c:v>
                </c:pt>
                <c:pt idx="415">
                  <c:v>11.058571904793654</c:v>
                </c:pt>
                <c:pt idx="416">
                  <c:v>11.085155010334024</c:v>
                </c:pt>
                <c:pt idx="417">
                  <c:v>11.111738115874392</c:v>
                </c:pt>
                <c:pt idx="418">
                  <c:v>11.138321221414762</c:v>
                </c:pt>
                <c:pt idx="419">
                  <c:v>11.164904326955131</c:v>
                </c:pt>
                <c:pt idx="420">
                  <c:v>11.191487432495501</c:v>
                </c:pt>
                <c:pt idx="421">
                  <c:v>11.218070538035869</c:v>
                </c:pt>
                <c:pt idx="422">
                  <c:v>11.244653643576239</c:v>
                </c:pt>
                <c:pt idx="423">
                  <c:v>11.271236749116609</c:v>
                </c:pt>
                <c:pt idx="424">
                  <c:v>11.297819854656979</c:v>
                </c:pt>
                <c:pt idx="425">
                  <c:v>11.324402960197347</c:v>
                </c:pt>
                <c:pt idx="426">
                  <c:v>11.350986065737716</c:v>
                </c:pt>
                <c:pt idx="427">
                  <c:v>11.377569171278086</c:v>
                </c:pt>
                <c:pt idx="428">
                  <c:v>11.404152276818456</c:v>
                </c:pt>
                <c:pt idx="429">
                  <c:v>11.430735382358824</c:v>
                </c:pt>
                <c:pt idx="430">
                  <c:v>11.457318487899194</c:v>
                </c:pt>
                <c:pt idx="431">
                  <c:v>11.483901593439564</c:v>
                </c:pt>
                <c:pt idx="432">
                  <c:v>11.510484698979933</c:v>
                </c:pt>
                <c:pt idx="433">
                  <c:v>11.537067804520301</c:v>
                </c:pt>
                <c:pt idx="434">
                  <c:v>11.563650910060671</c:v>
                </c:pt>
                <c:pt idx="435">
                  <c:v>11.590234015601041</c:v>
                </c:pt>
                <c:pt idx="436">
                  <c:v>11.616817121141411</c:v>
                </c:pt>
                <c:pt idx="437">
                  <c:v>11.643400226681779</c:v>
                </c:pt>
                <c:pt idx="438">
                  <c:v>11.669983332222149</c:v>
                </c:pt>
                <c:pt idx="439">
                  <c:v>11.696566437762518</c:v>
                </c:pt>
                <c:pt idx="440">
                  <c:v>11.723149543302888</c:v>
                </c:pt>
                <c:pt idx="441">
                  <c:v>11.749732648843256</c:v>
                </c:pt>
                <c:pt idx="442">
                  <c:v>11.776315754383626</c:v>
                </c:pt>
                <c:pt idx="443">
                  <c:v>11.802898859923996</c:v>
                </c:pt>
                <c:pt idx="444">
                  <c:v>11.829481965464366</c:v>
                </c:pt>
                <c:pt idx="445">
                  <c:v>11.856065071004734</c:v>
                </c:pt>
                <c:pt idx="446">
                  <c:v>11.882648176545104</c:v>
                </c:pt>
                <c:pt idx="447">
                  <c:v>11.909231282085473</c:v>
                </c:pt>
                <c:pt idx="448">
                  <c:v>11.935814387625843</c:v>
                </c:pt>
                <c:pt idx="449">
                  <c:v>11.962397493166211</c:v>
                </c:pt>
                <c:pt idx="450">
                  <c:v>11.988980598706581</c:v>
                </c:pt>
                <c:pt idx="451">
                  <c:v>12.015563704246951</c:v>
                </c:pt>
                <c:pt idx="452">
                  <c:v>12.042146809787321</c:v>
                </c:pt>
                <c:pt idx="453">
                  <c:v>12.068729915327689</c:v>
                </c:pt>
                <c:pt idx="454">
                  <c:v>12.095313020868058</c:v>
                </c:pt>
                <c:pt idx="455">
                  <c:v>12.121896126408428</c:v>
                </c:pt>
                <c:pt idx="456">
                  <c:v>12.148479231948798</c:v>
                </c:pt>
                <c:pt idx="457">
                  <c:v>12.175062337489166</c:v>
                </c:pt>
                <c:pt idx="458">
                  <c:v>12.201645443029536</c:v>
                </c:pt>
                <c:pt idx="459">
                  <c:v>12.228228548569906</c:v>
                </c:pt>
                <c:pt idx="460">
                  <c:v>12.254811654110275</c:v>
                </c:pt>
                <c:pt idx="461">
                  <c:v>12.281394759650643</c:v>
                </c:pt>
                <c:pt idx="462">
                  <c:v>12.307977865191013</c:v>
                </c:pt>
                <c:pt idx="463">
                  <c:v>12.334560970731383</c:v>
                </c:pt>
                <c:pt idx="464">
                  <c:v>12.361144076271753</c:v>
                </c:pt>
                <c:pt idx="465">
                  <c:v>12.387727181812121</c:v>
                </c:pt>
                <c:pt idx="466">
                  <c:v>12.414310287352491</c:v>
                </c:pt>
                <c:pt idx="467">
                  <c:v>12.44089339289286</c:v>
                </c:pt>
                <c:pt idx="468">
                  <c:v>12.46747649843323</c:v>
                </c:pt>
                <c:pt idx="469">
                  <c:v>12.494059603973598</c:v>
                </c:pt>
                <c:pt idx="470">
                  <c:v>12.520642709513968</c:v>
                </c:pt>
                <c:pt idx="471">
                  <c:v>12.547225815054338</c:v>
                </c:pt>
                <c:pt idx="472">
                  <c:v>12.573808920594708</c:v>
                </c:pt>
                <c:pt idx="473">
                  <c:v>12.600392026135076</c:v>
                </c:pt>
                <c:pt idx="474">
                  <c:v>12.626975131675445</c:v>
                </c:pt>
                <c:pt idx="475">
                  <c:v>12.653558237215815</c:v>
                </c:pt>
                <c:pt idx="476">
                  <c:v>12.680141342756185</c:v>
                </c:pt>
                <c:pt idx="477">
                  <c:v>12.706724448296553</c:v>
                </c:pt>
                <c:pt idx="478">
                  <c:v>12.733307553836923</c:v>
                </c:pt>
                <c:pt idx="479">
                  <c:v>12.759890659377293</c:v>
                </c:pt>
                <c:pt idx="480">
                  <c:v>12.786473764917663</c:v>
                </c:pt>
                <c:pt idx="481">
                  <c:v>12.813056870458031</c:v>
                </c:pt>
                <c:pt idx="482">
                  <c:v>12.8396399759984</c:v>
                </c:pt>
                <c:pt idx="483">
                  <c:v>12.86622308153877</c:v>
                </c:pt>
                <c:pt idx="484">
                  <c:v>12.89280618707914</c:v>
                </c:pt>
                <c:pt idx="485">
                  <c:v>12.919389292619508</c:v>
                </c:pt>
                <c:pt idx="486">
                  <c:v>12.945972398159878</c:v>
                </c:pt>
                <c:pt idx="487">
                  <c:v>12.972555503700248</c:v>
                </c:pt>
                <c:pt idx="488">
                  <c:v>12.999138609240617</c:v>
                </c:pt>
                <c:pt idx="489">
                  <c:v>13.025721714780985</c:v>
                </c:pt>
                <c:pt idx="490">
                  <c:v>13.052304820321355</c:v>
                </c:pt>
                <c:pt idx="491">
                  <c:v>13.078887925861725</c:v>
                </c:pt>
                <c:pt idx="492">
                  <c:v>13.105471031402095</c:v>
                </c:pt>
                <c:pt idx="493">
                  <c:v>13.132054136942463</c:v>
                </c:pt>
                <c:pt idx="494">
                  <c:v>13.158637242482833</c:v>
                </c:pt>
                <c:pt idx="495">
                  <c:v>13.185220348023202</c:v>
                </c:pt>
                <c:pt idx="496">
                  <c:v>13.211803453563572</c:v>
                </c:pt>
                <c:pt idx="497">
                  <c:v>13.23838655910394</c:v>
                </c:pt>
                <c:pt idx="498">
                  <c:v>13.26496966464431</c:v>
                </c:pt>
                <c:pt idx="499">
                  <c:v>13.29155277018468</c:v>
                </c:pt>
                <c:pt idx="500">
                  <c:v>13.31813587572505</c:v>
                </c:pt>
                <c:pt idx="501">
                  <c:v>13.344718981265418</c:v>
                </c:pt>
                <c:pt idx="502">
                  <c:v>13.371302086805787</c:v>
                </c:pt>
                <c:pt idx="503">
                  <c:v>13.397885192346157</c:v>
                </c:pt>
                <c:pt idx="504">
                  <c:v>13.424468297886527</c:v>
                </c:pt>
                <c:pt idx="505">
                  <c:v>13.451051403426895</c:v>
                </c:pt>
                <c:pt idx="506">
                  <c:v>13.477634508967265</c:v>
                </c:pt>
                <c:pt idx="507">
                  <c:v>13.504217614507635</c:v>
                </c:pt>
                <c:pt idx="508">
                  <c:v>13.530800720048004</c:v>
                </c:pt>
                <c:pt idx="509">
                  <c:v>13.557383825588373</c:v>
                </c:pt>
                <c:pt idx="510">
                  <c:v>13.583966931128742</c:v>
                </c:pt>
                <c:pt idx="511">
                  <c:v>13.610550036669112</c:v>
                </c:pt>
                <c:pt idx="512">
                  <c:v>13.637133142209482</c:v>
                </c:pt>
                <c:pt idx="513">
                  <c:v>13.66371624774985</c:v>
                </c:pt>
                <c:pt idx="514">
                  <c:v>13.69029935329022</c:v>
                </c:pt>
                <c:pt idx="515">
                  <c:v>13.71688245883059</c:v>
                </c:pt>
                <c:pt idx="516">
                  <c:v>13.743465564370959</c:v>
                </c:pt>
                <c:pt idx="517">
                  <c:v>13.770048669911327</c:v>
                </c:pt>
                <c:pt idx="518">
                  <c:v>13.796631775451697</c:v>
                </c:pt>
                <c:pt idx="519">
                  <c:v>13.823214880992067</c:v>
                </c:pt>
                <c:pt idx="520">
                  <c:v>13.849797986532437</c:v>
                </c:pt>
                <c:pt idx="521">
                  <c:v>13.876381092072805</c:v>
                </c:pt>
                <c:pt idx="522">
                  <c:v>13.902964197613175</c:v>
                </c:pt>
                <c:pt idx="523">
                  <c:v>13.929547303153544</c:v>
                </c:pt>
                <c:pt idx="524">
                  <c:v>13.956130408693914</c:v>
                </c:pt>
                <c:pt idx="525">
                  <c:v>13.982713514234282</c:v>
                </c:pt>
                <c:pt idx="526">
                  <c:v>14.009296619774652</c:v>
                </c:pt>
                <c:pt idx="527">
                  <c:v>14.035879725315022</c:v>
                </c:pt>
                <c:pt idx="528">
                  <c:v>14.062462830855392</c:v>
                </c:pt>
                <c:pt idx="529">
                  <c:v>14.08904593639576</c:v>
                </c:pt>
                <c:pt idx="530">
                  <c:v>14.115629041936129</c:v>
                </c:pt>
                <c:pt idx="531">
                  <c:v>14.142212147476499</c:v>
                </c:pt>
                <c:pt idx="532">
                  <c:v>14.168795253016869</c:v>
                </c:pt>
                <c:pt idx="533">
                  <c:v>14.195378358557239</c:v>
                </c:pt>
                <c:pt idx="534">
                  <c:v>14.221961464097607</c:v>
                </c:pt>
                <c:pt idx="535">
                  <c:v>14.248544569637977</c:v>
                </c:pt>
                <c:pt idx="536">
                  <c:v>14.275127675178346</c:v>
                </c:pt>
                <c:pt idx="537">
                  <c:v>14.301710780718716</c:v>
                </c:pt>
                <c:pt idx="538">
                  <c:v>14.328293886259084</c:v>
                </c:pt>
                <c:pt idx="539">
                  <c:v>14.354876991799454</c:v>
                </c:pt>
                <c:pt idx="540">
                  <c:v>14.381460097339824</c:v>
                </c:pt>
                <c:pt idx="541">
                  <c:v>14.408043202880194</c:v>
                </c:pt>
                <c:pt idx="542">
                  <c:v>14.434626308420562</c:v>
                </c:pt>
                <c:pt idx="543">
                  <c:v>14.461209413960932</c:v>
                </c:pt>
                <c:pt idx="544">
                  <c:v>14.487792519501301</c:v>
                </c:pt>
                <c:pt idx="545">
                  <c:v>14.514375625041671</c:v>
                </c:pt>
                <c:pt idx="546">
                  <c:v>14.540958730582039</c:v>
                </c:pt>
                <c:pt idx="547">
                  <c:v>14.567541836122409</c:v>
                </c:pt>
                <c:pt idx="548">
                  <c:v>14.594124941662779</c:v>
                </c:pt>
                <c:pt idx="549">
                  <c:v>14.620708047203149</c:v>
                </c:pt>
                <c:pt idx="550">
                  <c:v>14.647291152743517</c:v>
                </c:pt>
                <c:pt idx="551">
                  <c:v>14.673874258283886</c:v>
                </c:pt>
                <c:pt idx="552">
                  <c:v>14.700457363824256</c:v>
                </c:pt>
                <c:pt idx="553">
                  <c:v>14.727040469364626</c:v>
                </c:pt>
                <c:pt idx="554">
                  <c:v>14.753623574904994</c:v>
                </c:pt>
                <c:pt idx="555">
                  <c:v>14.780206680445364</c:v>
                </c:pt>
                <c:pt idx="556">
                  <c:v>14.806789785985734</c:v>
                </c:pt>
                <c:pt idx="557">
                  <c:v>14.833372891526103</c:v>
                </c:pt>
                <c:pt idx="558">
                  <c:v>14.859955997066471</c:v>
                </c:pt>
                <c:pt idx="559">
                  <c:v>14.886539102606841</c:v>
                </c:pt>
                <c:pt idx="560">
                  <c:v>14.913122208147211</c:v>
                </c:pt>
                <c:pt idx="561">
                  <c:v>14.939705313687581</c:v>
                </c:pt>
                <c:pt idx="562">
                  <c:v>14.966288419227949</c:v>
                </c:pt>
                <c:pt idx="563">
                  <c:v>14.992871524768319</c:v>
                </c:pt>
                <c:pt idx="564">
                  <c:v>15.019454630308688</c:v>
                </c:pt>
                <c:pt idx="565">
                  <c:v>15.046037735849058</c:v>
                </c:pt>
                <c:pt idx="566">
                  <c:v>15.072620841389426</c:v>
                </c:pt>
                <c:pt idx="567">
                  <c:v>15.099203946929796</c:v>
                </c:pt>
                <c:pt idx="568">
                  <c:v>15.125787052470166</c:v>
                </c:pt>
                <c:pt idx="569">
                  <c:v>15.152370158010536</c:v>
                </c:pt>
                <c:pt idx="570">
                  <c:v>15.178953263550904</c:v>
                </c:pt>
                <c:pt idx="571">
                  <c:v>15.205536369091273</c:v>
                </c:pt>
                <c:pt idx="572">
                  <c:v>15.232119474631643</c:v>
                </c:pt>
                <c:pt idx="573">
                  <c:v>15.258702580172013</c:v>
                </c:pt>
                <c:pt idx="574">
                  <c:v>15.285285685712381</c:v>
                </c:pt>
                <c:pt idx="575">
                  <c:v>15.311868791252751</c:v>
                </c:pt>
                <c:pt idx="576">
                  <c:v>15.338451896793121</c:v>
                </c:pt>
                <c:pt idx="577">
                  <c:v>15.365035002333491</c:v>
                </c:pt>
                <c:pt idx="578">
                  <c:v>15.391618107873859</c:v>
                </c:pt>
                <c:pt idx="579">
                  <c:v>15.418201213414228</c:v>
                </c:pt>
                <c:pt idx="580">
                  <c:v>15.444784318954598</c:v>
                </c:pt>
                <c:pt idx="581">
                  <c:v>15.471367424494968</c:v>
                </c:pt>
                <c:pt idx="582">
                  <c:v>15.497950530035336</c:v>
                </c:pt>
                <c:pt idx="583">
                  <c:v>15.524533635575706</c:v>
                </c:pt>
                <c:pt idx="584">
                  <c:v>15.551116741116076</c:v>
                </c:pt>
                <c:pt idx="585">
                  <c:v>15.577699846656445</c:v>
                </c:pt>
                <c:pt idx="586">
                  <c:v>15.604282952196813</c:v>
                </c:pt>
                <c:pt idx="587">
                  <c:v>15.630866057737183</c:v>
                </c:pt>
                <c:pt idx="588">
                  <c:v>15.657449163277553</c:v>
                </c:pt>
                <c:pt idx="589">
                  <c:v>15.684032268817923</c:v>
                </c:pt>
                <c:pt idx="590">
                  <c:v>15.710615374358291</c:v>
                </c:pt>
                <c:pt idx="591">
                  <c:v>15.737198479898661</c:v>
                </c:pt>
                <c:pt idx="592">
                  <c:v>15.76378158543903</c:v>
                </c:pt>
                <c:pt idx="593">
                  <c:v>15.7903646909794</c:v>
                </c:pt>
                <c:pt idx="594">
                  <c:v>15.816947796519768</c:v>
                </c:pt>
                <c:pt idx="595">
                  <c:v>15.843530902060138</c:v>
                </c:pt>
                <c:pt idx="596">
                  <c:v>15.870114007600508</c:v>
                </c:pt>
                <c:pt idx="597">
                  <c:v>15.896697113140878</c:v>
                </c:pt>
                <c:pt idx="598">
                  <c:v>15.923280218681246</c:v>
                </c:pt>
                <c:pt idx="599">
                  <c:v>15.949863324221615</c:v>
                </c:pt>
                <c:pt idx="600">
                  <c:v>15.976446429761985</c:v>
                </c:pt>
                <c:pt idx="601">
                  <c:v>16.003029535302353</c:v>
                </c:pt>
                <c:pt idx="602">
                  <c:v>16.029612640842725</c:v>
                </c:pt>
                <c:pt idx="603">
                  <c:v>16.056195746383093</c:v>
                </c:pt>
                <c:pt idx="604">
                  <c:v>16.082778851923461</c:v>
                </c:pt>
                <c:pt idx="605">
                  <c:v>16.109361957463832</c:v>
                </c:pt>
                <c:pt idx="606">
                  <c:v>16.135945063004201</c:v>
                </c:pt>
                <c:pt idx="607">
                  <c:v>16.162528168544572</c:v>
                </c:pt>
                <c:pt idx="608">
                  <c:v>16.18911127408494</c:v>
                </c:pt>
                <c:pt idx="609">
                  <c:v>16.215694379625308</c:v>
                </c:pt>
                <c:pt idx="610">
                  <c:v>16.24227748516568</c:v>
                </c:pt>
                <c:pt idx="611">
                  <c:v>16.268860590706048</c:v>
                </c:pt>
                <c:pt idx="612">
                  <c:v>16.295443696246416</c:v>
                </c:pt>
                <c:pt idx="613">
                  <c:v>16.322026801786787</c:v>
                </c:pt>
                <c:pt idx="614">
                  <c:v>16.348609907327155</c:v>
                </c:pt>
                <c:pt idx="615">
                  <c:v>16.375193012867527</c:v>
                </c:pt>
                <c:pt idx="616">
                  <c:v>16.401776118407895</c:v>
                </c:pt>
                <c:pt idx="617">
                  <c:v>16.428359223948263</c:v>
                </c:pt>
                <c:pt idx="618">
                  <c:v>16.454942329488635</c:v>
                </c:pt>
                <c:pt idx="619">
                  <c:v>16.481525435029003</c:v>
                </c:pt>
                <c:pt idx="620">
                  <c:v>16.508108540569371</c:v>
                </c:pt>
                <c:pt idx="621">
                  <c:v>16.534691646109742</c:v>
                </c:pt>
                <c:pt idx="622">
                  <c:v>16.56127475165011</c:v>
                </c:pt>
                <c:pt idx="623">
                  <c:v>16.587857857190482</c:v>
                </c:pt>
                <c:pt idx="624">
                  <c:v>16.61444096273085</c:v>
                </c:pt>
                <c:pt idx="625">
                  <c:v>16.641024068271218</c:v>
                </c:pt>
                <c:pt idx="626">
                  <c:v>16.667607173811589</c:v>
                </c:pt>
                <c:pt idx="627">
                  <c:v>16.694190279351957</c:v>
                </c:pt>
                <c:pt idx="628">
                  <c:v>16.720773384892325</c:v>
                </c:pt>
                <c:pt idx="629">
                  <c:v>16.747356490432697</c:v>
                </c:pt>
                <c:pt idx="630">
                  <c:v>16.773939595973065</c:v>
                </c:pt>
                <c:pt idx="631">
                  <c:v>16.800522701513437</c:v>
                </c:pt>
                <c:pt idx="632">
                  <c:v>16.827105807053805</c:v>
                </c:pt>
                <c:pt idx="633">
                  <c:v>16.853688912594173</c:v>
                </c:pt>
                <c:pt idx="634">
                  <c:v>16.880272018134544</c:v>
                </c:pt>
                <c:pt idx="635">
                  <c:v>16.906855123674912</c:v>
                </c:pt>
                <c:pt idx="636">
                  <c:v>16.93343822921528</c:v>
                </c:pt>
                <c:pt idx="637">
                  <c:v>16.960021334755652</c:v>
                </c:pt>
                <c:pt idx="638">
                  <c:v>16.98660444029602</c:v>
                </c:pt>
                <c:pt idx="639">
                  <c:v>17.013187545836391</c:v>
                </c:pt>
                <c:pt idx="640">
                  <c:v>17.03977065137676</c:v>
                </c:pt>
                <c:pt idx="641">
                  <c:v>17.066353756917128</c:v>
                </c:pt>
                <c:pt idx="642">
                  <c:v>17.092936862457499</c:v>
                </c:pt>
                <c:pt idx="643">
                  <c:v>17.119519967997867</c:v>
                </c:pt>
                <c:pt idx="644">
                  <c:v>17.146103073538235</c:v>
                </c:pt>
                <c:pt idx="645">
                  <c:v>17.172686179078607</c:v>
                </c:pt>
                <c:pt idx="646">
                  <c:v>17.199269284618975</c:v>
                </c:pt>
                <c:pt idx="647">
                  <c:v>17.225852390159346</c:v>
                </c:pt>
                <c:pt idx="648">
                  <c:v>17.252435495699714</c:v>
                </c:pt>
                <c:pt idx="649">
                  <c:v>17.279018601240082</c:v>
                </c:pt>
                <c:pt idx="650">
                  <c:v>17.305601706780454</c:v>
                </c:pt>
                <c:pt idx="651">
                  <c:v>17.332184812320822</c:v>
                </c:pt>
                <c:pt idx="652">
                  <c:v>17.35876791786119</c:v>
                </c:pt>
                <c:pt idx="653">
                  <c:v>17.385351023401562</c:v>
                </c:pt>
                <c:pt idx="654">
                  <c:v>17.41193412894193</c:v>
                </c:pt>
                <c:pt idx="655">
                  <c:v>17.438517234482301</c:v>
                </c:pt>
                <c:pt idx="656">
                  <c:v>17.465100340022669</c:v>
                </c:pt>
                <c:pt idx="657">
                  <c:v>17.491683445563037</c:v>
                </c:pt>
                <c:pt idx="658">
                  <c:v>17.518266551103409</c:v>
                </c:pt>
                <c:pt idx="659">
                  <c:v>17.544849656643777</c:v>
                </c:pt>
                <c:pt idx="660">
                  <c:v>17.571432762184145</c:v>
                </c:pt>
                <c:pt idx="661">
                  <c:v>17.598015867724516</c:v>
                </c:pt>
                <c:pt idx="662">
                  <c:v>17.624598973264884</c:v>
                </c:pt>
                <c:pt idx="663">
                  <c:v>17.651182078805256</c:v>
                </c:pt>
                <c:pt idx="664">
                  <c:v>17.677765184345624</c:v>
                </c:pt>
                <c:pt idx="665">
                  <c:v>17.704348289885992</c:v>
                </c:pt>
                <c:pt idx="666">
                  <c:v>17.730931395426364</c:v>
                </c:pt>
                <c:pt idx="667">
                  <c:v>17.757514500966732</c:v>
                </c:pt>
                <c:pt idx="668">
                  <c:v>17.784097606507103</c:v>
                </c:pt>
                <c:pt idx="669">
                  <c:v>17.810680712047471</c:v>
                </c:pt>
                <c:pt idx="670">
                  <c:v>17.837263817587839</c:v>
                </c:pt>
                <c:pt idx="671">
                  <c:v>17.863846923128211</c:v>
                </c:pt>
                <c:pt idx="672">
                  <c:v>17.890430028668579</c:v>
                </c:pt>
                <c:pt idx="673">
                  <c:v>17.917013134208947</c:v>
                </c:pt>
                <c:pt idx="674">
                  <c:v>17.943596239749318</c:v>
                </c:pt>
                <c:pt idx="675">
                  <c:v>17.970179345289687</c:v>
                </c:pt>
                <c:pt idx="676">
                  <c:v>17.996762450830058</c:v>
                </c:pt>
                <c:pt idx="677">
                  <c:v>18.023345556370426</c:v>
                </c:pt>
                <c:pt idx="678">
                  <c:v>18.049928661910794</c:v>
                </c:pt>
                <c:pt idx="679">
                  <c:v>18.076511767451166</c:v>
                </c:pt>
                <c:pt idx="680">
                  <c:v>18.103094872991534</c:v>
                </c:pt>
                <c:pt idx="681">
                  <c:v>18.129677978531902</c:v>
                </c:pt>
                <c:pt idx="682">
                  <c:v>18.156261084072273</c:v>
                </c:pt>
                <c:pt idx="683">
                  <c:v>18.182844189612641</c:v>
                </c:pt>
                <c:pt idx="684">
                  <c:v>18.209427295153013</c:v>
                </c:pt>
                <c:pt idx="685">
                  <c:v>18.236010400693381</c:v>
                </c:pt>
                <c:pt idx="686">
                  <c:v>18.262593506233749</c:v>
                </c:pt>
                <c:pt idx="687">
                  <c:v>18.289176611774121</c:v>
                </c:pt>
                <c:pt idx="688">
                  <c:v>18.315759717314489</c:v>
                </c:pt>
                <c:pt idx="689">
                  <c:v>18.342342822854857</c:v>
                </c:pt>
                <c:pt idx="690">
                  <c:v>18.368925928395228</c:v>
                </c:pt>
                <c:pt idx="691">
                  <c:v>18.395509033935596</c:v>
                </c:pt>
                <c:pt idx="692">
                  <c:v>18.422092139475968</c:v>
                </c:pt>
                <c:pt idx="693">
                  <c:v>18.448675245016336</c:v>
                </c:pt>
                <c:pt idx="694">
                  <c:v>18.475258350556704</c:v>
                </c:pt>
                <c:pt idx="695">
                  <c:v>18.501841456097075</c:v>
                </c:pt>
                <c:pt idx="696">
                  <c:v>18.528424561637443</c:v>
                </c:pt>
                <c:pt idx="697">
                  <c:v>18.555007667177811</c:v>
                </c:pt>
                <c:pt idx="698">
                  <c:v>18.581590772718183</c:v>
                </c:pt>
                <c:pt idx="699">
                  <c:v>18.608173878258551</c:v>
                </c:pt>
                <c:pt idx="700">
                  <c:v>18.634756983798923</c:v>
                </c:pt>
                <c:pt idx="701">
                  <c:v>18.661340089339291</c:v>
                </c:pt>
                <c:pt idx="702">
                  <c:v>18.687923194879659</c:v>
                </c:pt>
                <c:pt idx="703">
                  <c:v>18.71450630042003</c:v>
                </c:pt>
                <c:pt idx="704">
                  <c:v>18.741089405960398</c:v>
                </c:pt>
                <c:pt idx="705">
                  <c:v>18.767672511500766</c:v>
                </c:pt>
                <c:pt idx="706">
                  <c:v>18.794255617041138</c:v>
                </c:pt>
                <c:pt idx="707">
                  <c:v>18.820838722581506</c:v>
                </c:pt>
                <c:pt idx="708">
                  <c:v>18.847421828121877</c:v>
                </c:pt>
                <c:pt idx="709">
                  <c:v>18.874004933662246</c:v>
                </c:pt>
                <c:pt idx="710">
                  <c:v>18.900588039202614</c:v>
                </c:pt>
                <c:pt idx="711">
                  <c:v>18.927171144742985</c:v>
                </c:pt>
                <c:pt idx="712">
                  <c:v>18.953754250283353</c:v>
                </c:pt>
                <c:pt idx="713">
                  <c:v>18.980337355823721</c:v>
                </c:pt>
                <c:pt idx="714">
                  <c:v>19.006920461364093</c:v>
                </c:pt>
                <c:pt idx="715">
                  <c:v>19.033503566904461</c:v>
                </c:pt>
                <c:pt idx="716">
                  <c:v>19.060086672444832</c:v>
                </c:pt>
                <c:pt idx="717">
                  <c:v>19.0866697779852</c:v>
                </c:pt>
                <c:pt idx="718">
                  <c:v>19.113252883525568</c:v>
                </c:pt>
                <c:pt idx="719">
                  <c:v>19.13983598906594</c:v>
                </c:pt>
                <c:pt idx="720">
                  <c:v>19.166419094606308</c:v>
                </c:pt>
                <c:pt idx="721">
                  <c:v>19.193002200146676</c:v>
                </c:pt>
                <c:pt idx="722">
                  <c:v>19.219585305687048</c:v>
                </c:pt>
                <c:pt idx="723">
                  <c:v>19.246168411227416</c:v>
                </c:pt>
                <c:pt idx="724">
                  <c:v>19.272751516767787</c:v>
                </c:pt>
                <c:pt idx="725">
                  <c:v>19.299334622308155</c:v>
                </c:pt>
                <c:pt idx="726">
                  <c:v>19.325917727848523</c:v>
                </c:pt>
                <c:pt idx="727">
                  <c:v>19.352500833388895</c:v>
                </c:pt>
                <c:pt idx="728">
                  <c:v>19.379083938929263</c:v>
                </c:pt>
                <c:pt idx="729">
                  <c:v>19.405667044469631</c:v>
                </c:pt>
                <c:pt idx="730">
                  <c:v>19.432250150010002</c:v>
                </c:pt>
                <c:pt idx="731">
                  <c:v>19.45883325555037</c:v>
                </c:pt>
                <c:pt idx="732">
                  <c:v>19.485416361090742</c:v>
                </c:pt>
                <c:pt idx="733">
                  <c:v>19.51199946663111</c:v>
                </c:pt>
                <c:pt idx="734">
                  <c:v>19.538582572171478</c:v>
                </c:pt>
                <c:pt idx="735">
                  <c:v>19.56516567771185</c:v>
                </c:pt>
                <c:pt idx="736">
                  <c:v>19.591748783252218</c:v>
                </c:pt>
                <c:pt idx="737">
                  <c:v>19.618331888792586</c:v>
                </c:pt>
                <c:pt idx="738">
                  <c:v>19.644914994332957</c:v>
                </c:pt>
                <c:pt idx="739">
                  <c:v>19.671498099873325</c:v>
                </c:pt>
                <c:pt idx="740">
                  <c:v>19.698081205413697</c:v>
                </c:pt>
                <c:pt idx="741">
                  <c:v>19.724664310954065</c:v>
                </c:pt>
                <c:pt idx="742">
                  <c:v>19.751247416494433</c:v>
                </c:pt>
                <c:pt idx="743">
                  <c:v>19.777830522034805</c:v>
                </c:pt>
                <c:pt idx="744">
                  <c:v>19.804413627575173</c:v>
                </c:pt>
                <c:pt idx="745">
                  <c:v>19.830996733115541</c:v>
                </c:pt>
                <c:pt idx="746">
                  <c:v>19.857579838655912</c:v>
                </c:pt>
                <c:pt idx="747">
                  <c:v>19.88416294419628</c:v>
                </c:pt>
                <c:pt idx="748">
                  <c:v>19.910746049736652</c:v>
                </c:pt>
                <c:pt idx="749">
                  <c:v>19.93732915527702</c:v>
                </c:pt>
                <c:pt idx="750">
                  <c:v>19.963912260817388</c:v>
                </c:pt>
                <c:pt idx="751">
                  <c:v>19.990495366357759</c:v>
                </c:pt>
                <c:pt idx="752">
                  <c:v>20.017078471898127</c:v>
                </c:pt>
                <c:pt idx="753">
                  <c:v>20.043661577438495</c:v>
                </c:pt>
                <c:pt idx="754">
                  <c:v>20.070244682978867</c:v>
                </c:pt>
                <c:pt idx="755">
                  <c:v>20.096827788519235</c:v>
                </c:pt>
                <c:pt idx="756">
                  <c:v>20.123410894059607</c:v>
                </c:pt>
                <c:pt idx="757">
                  <c:v>20.149993999599975</c:v>
                </c:pt>
                <c:pt idx="758">
                  <c:v>20.176577105140343</c:v>
                </c:pt>
                <c:pt idx="759">
                  <c:v>20.203160210680714</c:v>
                </c:pt>
                <c:pt idx="760">
                  <c:v>20.229743316221082</c:v>
                </c:pt>
                <c:pt idx="761">
                  <c:v>20.25632642176145</c:v>
                </c:pt>
                <c:pt idx="762">
                  <c:v>20.282909527301822</c:v>
                </c:pt>
                <c:pt idx="763">
                  <c:v>20.30949263284219</c:v>
                </c:pt>
                <c:pt idx="764">
                  <c:v>20.336075738382561</c:v>
                </c:pt>
                <c:pt idx="765">
                  <c:v>20.362658843922929</c:v>
                </c:pt>
                <c:pt idx="766">
                  <c:v>20.389241949463297</c:v>
                </c:pt>
                <c:pt idx="767">
                  <c:v>20.415825055003669</c:v>
                </c:pt>
                <c:pt idx="768">
                  <c:v>20.442408160544037</c:v>
                </c:pt>
                <c:pt idx="769">
                  <c:v>20.468991266084405</c:v>
                </c:pt>
                <c:pt idx="770">
                  <c:v>20.495574371624777</c:v>
                </c:pt>
                <c:pt idx="771">
                  <c:v>20.522157477165145</c:v>
                </c:pt>
                <c:pt idx="772">
                  <c:v>20.548740582705516</c:v>
                </c:pt>
                <c:pt idx="773">
                  <c:v>20.575323688245884</c:v>
                </c:pt>
                <c:pt idx="774">
                  <c:v>20.601906793786252</c:v>
                </c:pt>
                <c:pt idx="775">
                  <c:v>20.628489899326624</c:v>
                </c:pt>
                <c:pt idx="776">
                  <c:v>20.655073004866992</c:v>
                </c:pt>
                <c:pt idx="777">
                  <c:v>20.68165611040736</c:v>
                </c:pt>
                <c:pt idx="778">
                  <c:v>20.708239215947732</c:v>
                </c:pt>
                <c:pt idx="779">
                  <c:v>20.7348223214881</c:v>
                </c:pt>
                <c:pt idx="780">
                  <c:v>20.761405427028471</c:v>
                </c:pt>
                <c:pt idx="781">
                  <c:v>20.787988532568839</c:v>
                </c:pt>
                <c:pt idx="782">
                  <c:v>20.814571638109207</c:v>
                </c:pt>
                <c:pt idx="783">
                  <c:v>20.841154743649579</c:v>
                </c:pt>
                <c:pt idx="784">
                  <c:v>20.867737849189947</c:v>
                </c:pt>
                <c:pt idx="785">
                  <c:v>20.894320954730315</c:v>
                </c:pt>
                <c:pt idx="786">
                  <c:v>20.920904060270686</c:v>
                </c:pt>
                <c:pt idx="787">
                  <c:v>20.947487165811054</c:v>
                </c:pt>
                <c:pt idx="788">
                  <c:v>20.974070271351426</c:v>
                </c:pt>
                <c:pt idx="789">
                  <c:v>21.000653376891794</c:v>
                </c:pt>
                <c:pt idx="790">
                  <c:v>21.027236482432162</c:v>
                </c:pt>
                <c:pt idx="791">
                  <c:v>21.053819587972534</c:v>
                </c:pt>
                <c:pt idx="792">
                  <c:v>21.080402693512902</c:v>
                </c:pt>
                <c:pt idx="793">
                  <c:v>21.10698579905327</c:v>
                </c:pt>
                <c:pt idx="794">
                  <c:v>21.133568904593641</c:v>
                </c:pt>
                <c:pt idx="795">
                  <c:v>21.160152010134009</c:v>
                </c:pt>
                <c:pt idx="796">
                  <c:v>21.186735115674381</c:v>
                </c:pt>
                <c:pt idx="797">
                  <c:v>21.213318221214749</c:v>
                </c:pt>
                <c:pt idx="798">
                  <c:v>21.239901326755117</c:v>
                </c:pt>
                <c:pt idx="799">
                  <c:v>21.266484432295488</c:v>
                </c:pt>
                <c:pt idx="800">
                  <c:v>21.293067537835856</c:v>
                </c:pt>
                <c:pt idx="801">
                  <c:v>21.319650643376228</c:v>
                </c:pt>
                <c:pt idx="802">
                  <c:v>21.346233748916596</c:v>
                </c:pt>
                <c:pt idx="803">
                  <c:v>21.372816854456964</c:v>
                </c:pt>
                <c:pt idx="804">
                  <c:v>21.399399959997336</c:v>
                </c:pt>
                <c:pt idx="805">
                  <c:v>21.425983065537704</c:v>
                </c:pt>
                <c:pt idx="806">
                  <c:v>21.452566171078072</c:v>
                </c:pt>
                <c:pt idx="807">
                  <c:v>21.479149276618443</c:v>
                </c:pt>
                <c:pt idx="808">
                  <c:v>21.505732382158811</c:v>
                </c:pt>
                <c:pt idx="809">
                  <c:v>21.532315487699183</c:v>
                </c:pt>
                <c:pt idx="810">
                  <c:v>21.558898593239551</c:v>
                </c:pt>
                <c:pt idx="811">
                  <c:v>21.585481698779919</c:v>
                </c:pt>
                <c:pt idx="812">
                  <c:v>21.612064804320291</c:v>
                </c:pt>
                <c:pt idx="813">
                  <c:v>21.638647909860659</c:v>
                </c:pt>
                <c:pt idx="814">
                  <c:v>21.665231015401027</c:v>
                </c:pt>
                <c:pt idx="815">
                  <c:v>21.691814120941398</c:v>
                </c:pt>
                <c:pt idx="816">
                  <c:v>21.718397226481766</c:v>
                </c:pt>
                <c:pt idx="817">
                  <c:v>21.744980332022138</c:v>
                </c:pt>
                <c:pt idx="818">
                  <c:v>21.771563437562506</c:v>
                </c:pt>
                <c:pt idx="819">
                  <c:v>21.798146543102874</c:v>
                </c:pt>
                <c:pt idx="820">
                  <c:v>21.824729648643245</c:v>
                </c:pt>
                <c:pt idx="821">
                  <c:v>21.851312754183613</c:v>
                </c:pt>
                <c:pt idx="822">
                  <c:v>21.877895859723981</c:v>
                </c:pt>
                <c:pt idx="823">
                  <c:v>21.904478965264353</c:v>
                </c:pt>
                <c:pt idx="824">
                  <c:v>21.931062070804721</c:v>
                </c:pt>
                <c:pt idx="825">
                  <c:v>21.957645176345093</c:v>
                </c:pt>
                <c:pt idx="826">
                  <c:v>21.984228281885461</c:v>
                </c:pt>
                <c:pt idx="827">
                  <c:v>22.010811387425829</c:v>
                </c:pt>
                <c:pt idx="828">
                  <c:v>22.0373944929662</c:v>
                </c:pt>
                <c:pt idx="829">
                  <c:v>22.063977598506568</c:v>
                </c:pt>
                <c:pt idx="830">
                  <c:v>22.090560704046936</c:v>
                </c:pt>
                <c:pt idx="831">
                  <c:v>22.117143809587308</c:v>
                </c:pt>
                <c:pt idx="832">
                  <c:v>22.143726915127676</c:v>
                </c:pt>
                <c:pt idx="833">
                  <c:v>22.170310020668047</c:v>
                </c:pt>
                <c:pt idx="834">
                  <c:v>22.196893126208415</c:v>
                </c:pt>
                <c:pt idx="835">
                  <c:v>22.223476231748784</c:v>
                </c:pt>
                <c:pt idx="836">
                  <c:v>22.250059337289155</c:v>
                </c:pt>
                <c:pt idx="837">
                  <c:v>22.276642442829523</c:v>
                </c:pt>
                <c:pt idx="838">
                  <c:v>22.303225548369891</c:v>
                </c:pt>
                <c:pt idx="839">
                  <c:v>22.329808653910263</c:v>
                </c:pt>
                <c:pt idx="840">
                  <c:v>22.356391759450631</c:v>
                </c:pt>
                <c:pt idx="841">
                  <c:v>22.382974864991002</c:v>
                </c:pt>
                <c:pt idx="842">
                  <c:v>22.40955797053137</c:v>
                </c:pt>
                <c:pt idx="843">
                  <c:v>22.436141076071738</c:v>
                </c:pt>
                <c:pt idx="844">
                  <c:v>22.46272418161211</c:v>
                </c:pt>
                <c:pt idx="845">
                  <c:v>22.489307287152478</c:v>
                </c:pt>
                <c:pt idx="846">
                  <c:v>22.515890392692846</c:v>
                </c:pt>
                <c:pt idx="847">
                  <c:v>22.542473498233218</c:v>
                </c:pt>
                <c:pt idx="848">
                  <c:v>22.569056603773586</c:v>
                </c:pt>
                <c:pt idx="849">
                  <c:v>22.595639709313957</c:v>
                </c:pt>
                <c:pt idx="850">
                  <c:v>22.622222814854325</c:v>
                </c:pt>
                <c:pt idx="851">
                  <c:v>22.648805920394693</c:v>
                </c:pt>
                <c:pt idx="852">
                  <c:v>22.675389025935065</c:v>
                </c:pt>
                <c:pt idx="853">
                  <c:v>22.701972131475433</c:v>
                </c:pt>
                <c:pt idx="854">
                  <c:v>22.728555237015801</c:v>
                </c:pt>
                <c:pt idx="855">
                  <c:v>22.755138342556172</c:v>
                </c:pt>
                <c:pt idx="856">
                  <c:v>22.78172144809654</c:v>
                </c:pt>
                <c:pt idx="857">
                  <c:v>22.808304553636912</c:v>
                </c:pt>
                <c:pt idx="858">
                  <c:v>22.83488765917728</c:v>
                </c:pt>
                <c:pt idx="859">
                  <c:v>22.861470764717648</c:v>
                </c:pt>
                <c:pt idx="860">
                  <c:v>22.88805387025802</c:v>
                </c:pt>
                <c:pt idx="861">
                  <c:v>22.914636975798388</c:v>
                </c:pt>
                <c:pt idx="862">
                  <c:v>22.941220081338756</c:v>
                </c:pt>
                <c:pt idx="863">
                  <c:v>22.967803186879127</c:v>
                </c:pt>
                <c:pt idx="864">
                  <c:v>22.994386292419495</c:v>
                </c:pt>
                <c:pt idx="865">
                  <c:v>23.020969397959867</c:v>
                </c:pt>
                <c:pt idx="866">
                  <c:v>23.047552503500235</c:v>
                </c:pt>
                <c:pt idx="867">
                  <c:v>23.074135609040603</c:v>
                </c:pt>
                <c:pt idx="868">
                  <c:v>23.100718714580974</c:v>
                </c:pt>
                <c:pt idx="869">
                  <c:v>23.127301820121343</c:v>
                </c:pt>
                <c:pt idx="870">
                  <c:v>23.153884925661711</c:v>
                </c:pt>
                <c:pt idx="871">
                  <c:v>23.180468031202082</c:v>
                </c:pt>
                <c:pt idx="872">
                  <c:v>23.20705113674245</c:v>
                </c:pt>
                <c:pt idx="873">
                  <c:v>23.233634242282822</c:v>
                </c:pt>
                <c:pt idx="874">
                  <c:v>23.26021734782319</c:v>
                </c:pt>
                <c:pt idx="875">
                  <c:v>23.286800453363558</c:v>
                </c:pt>
                <c:pt idx="876">
                  <c:v>23.313383558903929</c:v>
                </c:pt>
                <c:pt idx="877">
                  <c:v>23.339966664444297</c:v>
                </c:pt>
                <c:pt idx="878">
                  <c:v>23.366549769984665</c:v>
                </c:pt>
                <c:pt idx="879">
                  <c:v>23.393132875525037</c:v>
                </c:pt>
                <c:pt idx="880">
                  <c:v>23.419715981065405</c:v>
                </c:pt>
                <c:pt idx="881">
                  <c:v>23.446299086605777</c:v>
                </c:pt>
                <c:pt idx="882">
                  <c:v>23.472882192146145</c:v>
                </c:pt>
                <c:pt idx="883">
                  <c:v>23.499465297686513</c:v>
                </c:pt>
                <c:pt idx="884">
                  <c:v>23.526048403226884</c:v>
                </c:pt>
                <c:pt idx="885">
                  <c:v>23.552631508767252</c:v>
                </c:pt>
                <c:pt idx="886">
                  <c:v>23.57921461430762</c:v>
                </c:pt>
                <c:pt idx="887">
                  <c:v>23.605797719847992</c:v>
                </c:pt>
                <c:pt idx="888">
                  <c:v>23.63238082538836</c:v>
                </c:pt>
                <c:pt idx="889">
                  <c:v>23.658963930928731</c:v>
                </c:pt>
                <c:pt idx="890">
                  <c:v>23.685547036469099</c:v>
                </c:pt>
                <c:pt idx="891">
                  <c:v>23.712130142009467</c:v>
                </c:pt>
                <c:pt idx="892">
                  <c:v>23.738713247549839</c:v>
                </c:pt>
                <c:pt idx="893">
                  <c:v>23.765296353090207</c:v>
                </c:pt>
                <c:pt idx="894">
                  <c:v>23.791879458630575</c:v>
                </c:pt>
                <c:pt idx="895">
                  <c:v>23.818462564170947</c:v>
                </c:pt>
                <c:pt idx="896">
                  <c:v>23.845045669711315</c:v>
                </c:pt>
                <c:pt idx="897">
                  <c:v>23.871628775251686</c:v>
                </c:pt>
                <c:pt idx="898">
                  <c:v>23.898211880792054</c:v>
                </c:pt>
                <c:pt idx="899">
                  <c:v>23.924794986332422</c:v>
                </c:pt>
                <c:pt idx="900">
                  <c:v>23.951378091872794</c:v>
                </c:pt>
                <c:pt idx="901">
                  <c:v>23.977961197413162</c:v>
                </c:pt>
                <c:pt idx="902">
                  <c:v>24.00454430295353</c:v>
                </c:pt>
                <c:pt idx="903">
                  <c:v>24.031127408493901</c:v>
                </c:pt>
                <c:pt idx="904">
                  <c:v>24.05771051403427</c:v>
                </c:pt>
                <c:pt idx="905">
                  <c:v>24.084293619574641</c:v>
                </c:pt>
                <c:pt idx="906">
                  <c:v>24.110876725115009</c:v>
                </c:pt>
                <c:pt idx="907">
                  <c:v>24.137459830655377</c:v>
                </c:pt>
                <c:pt idx="908">
                  <c:v>24.164042936195749</c:v>
                </c:pt>
                <c:pt idx="909">
                  <c:v>24.190626041736117</c:v>
                </c:pt>
                <c:pt idx="910">
                  <c:v>24.217209147276485</c:v>
                </c:pt>
                <c:pt idx="911">
                  <c:v>24.243792252816856</c:v>
                </c:pt>
                <c:pt idx="912">
                  <c:v>24.270375358357224</c:v>
                </c:pt>
                <c:pt idx="913">
                  <c:v>24.296958463897596</c:v>
                </c:pt>
                <c:pt idx="914">
                  <c:v>24.323541569437964</c:v>
                </c:pt>
                <c:pt idx="915">
                  <c:v>24.350124674978332</c:v>
                </c:pt>
                <c:pt idx="916">
                  <c:v>24.376707780518704</c:v>
                </c:pt>
                <c:pt idx="917">
                  <c:v>24.403290886059072</c:v>
                </c:pt>
                <c:pt idx="918">
                  <c:v>24.42987399159944</c:v>
                </c:pt>
                <c:pt idx="919">
                  <c:v>24.456457097139811</c:v>
                </c:pt>
                <c:pt idx="920">
                  <c:v>24.483040202680179</c:v>
                </c:pt>
                <c:pt idx="921">
                  <c:v>24.509623308220551</c:v>
                </c:pt>
                <c:pt idx="922">
                  <c:v>24.536206413760919</c:v>
                </c:pt>
                <c:pt idx="923">
                  <c:v>24.562789519301287</c:v>
                </c:pt>
                <c:pt idx="924">
                  <c:v>24.589372624841658</c:v>
                </c:pt>
                <c:pt idx="925">
                  <c:v>24.615955730382026</c:v>
                </c:pt>
                <c:pt idx="926">
                  <c:v>24.642538835922394</c:v>
                </c:pt>
                <c:pt idx="927">
                  <c:v>24.669121941462766</c:v>
                </c:pt>
                <c:pt idx="928">
                  <c:v>24.695705047003134</c:v>
                </c:pt>
                <c:pt idx="929">
                  <c:v>24.722288152543506</c:v>
                </c:pt>
                <c:pt idx="930">
                  <c:v>24.748871258083874</c:v>
                </c:pt>
                <c:pt idx="931">
                  <c:v>24.775454363624242</c:v>
                </c:pt>
                <c:pt idx="932">
                  <c:v>24.802037469164613</c:v>
                </c:pt>
                <c:pt idx="933">
                  <c:v>24.828620574704981</c:v>
                </c:pt>
                <c:pt idx="934">
                  <c:v>24.855203680245353</c:v>
                </c:pt>
                <c:pt idx="935">
                  <c:v>24.881786785785721</c:v>
                </c:pt>
                <c:pt idx="936">
                  <c:v>24.908369891326089</c:v>
                </c:pt>
              </c:numCache>
            </c:numRef>
          </c:xVal>
          <c:yVal>
            <c:numRef>
              <c:f>Curves!$A$4</c:f>
              <c:numCache>
                <c:formatCode>###0.00</c:formatCode>
                <c:ptCount val="1"/>
                <c:pt idx="0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D52B-274D-9532-C09E012E20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134056"/>
        <c:axId val="252134448"/>
      </c:scatterChart>
      <c:valAx>
        <c:axId val="252134056"/>
        <c:scaling>
          <c:orientation val="minMax"/>
          <c:max val="20"/>
        </c:scaling>
        <c:delete val="0"/>
        <c:axPos val="b"/>
        <c:title>
          <c:tx>
            <c:rich>
              <a:bodyPr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 dirty="0">
                    <a:latin typeface="+mn-lt"/>
                    <a:cs typeface="Arial" panose="020B0604020202020204" pitchFamily="34" charset="0"/>
                  </a:rPr>
                  <a:t>Elute Volume, </a:t>
                </a:r>
                <a:r>
                  <a:rPr lang="en-US" sz="1200" dirty="0" err="1">
                    <a:latin typeface="+mn-lt"/>
                    <a:cs typeface="Arial" panose="020B0604020202020204" pitchFamily="34" charset="0"/>
                  </a:rPr>
                  <a:t>V</a:t>
                </a:r>
                <a:r>
                  <a:rPr lang="en-US" sz="1000" dirty="0" err="1">
                    <a:latin typeface="+mn-lt"/>
                    <a:cs typeface="Arial" panose="020B0604020202020204" pitchFamily="34" charset="0"/>
                  </a:rPr>
                  <a:t>e</a:t>
                </a:r>
                <a:r>
                  <a:rPr lang="en-US" sz="1200" dirty="0">
                    <a:latin typeface="+mn-lt"/>
                    <a:cs typeface="Arial" panose="020B0604020202020204" pitchFamily="34" charset="0"/>
                  </a:rPr>
                  <a:t> (ml)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
</a:t>
                </a:r>
              </a:p>
            </c:rich>
          </c:tx>
          <c:layout>
            <c:manualLayout>
              <c:xMode val="edge"/>
              <c:yMode val="edge"/>
              <c:x val="0.36242097149447822"/>
              <c:y val="0.82757228110283587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 b="1"/>
            </a:pPr>
            <a:endParaRPr lang="en-US"/>
          </a:p>
        </c:txPr>
        <c:crossAx val="252134448"/>
        <c:crosses val="autoZero"/>
        <c:crossBetween val="midCat"/>
        <c:majorUnit val="5"/>
      </c:valAx>
      <c:valAx>
        <c:axId val="252134448"/>
        <c:scaling>
          <c:orientation val="minMax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 b="1"/>
            </a:pPr>
            <a:endParaRPr lang="en-US"/>
          </a:p>
        </c:txPr>
        <c:crossAx val="25213405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1797013326283491"/>
          <c:y val="0.13713601194990274"/>
          <c:w val="0.61576965493198699"/>
          <c:h val="0.620559287372891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Curves!$B$3</c:f>
              <c:strCache>
                <c:ptCount val="1"/>
                <c:pt idx="0">
                  <c:v> mAU</c:v>
                </c:pt>
              </c:strCache>
            </c:strRef>
          </c:tx>
          <c:marker>
            <c:symbol val="none"/>
          </c:marker>
          <c:xVal>
            <c:numRef>
              <c:f>Curves!$A$4:$A$976</c:f>
              <c:numCache>
                <c:formatCode>###0.00</c:formatCode>
                <c:ptCount val="973"/>
                <c:pt idx="0">
                  <c:v>0</c:v>
                </c:pt>
                <c:pt idx="1">
                  <c:v>3.325110494398191E-2</c:v>
                </c:pt>
                <c:pt idx="2">
                  <c:v>6.650220988796382E-2</c:v>
                </c:pt>
                <c:pt idx="3">
                  <c:v>9.975331483194573E-2</c:v>
                </c:pt>
                <c:pt idx="4">
                  <c:v>0.13300441977592764</c:v>
                </c:pt>
                <c:pt idx="5">
                  <c:v>0.16625552471990954</c:v>
                </c:pt>
                <c:pt idx="6">
                  <c:v>0.19950662966389146</c:v>
                </c:pt>
                <c:pt idx="7">
                  <c:v>0.23275773460787336</c:v>
                </c:pt>
                <c:pt idx="8">
                  <c:v>0.26600883955185528</c:v>
                </c:pt>
                <c:pt idx="9">
                  <c:v>0.2992599444958372</c:v>
                </c:pt>
                <c:pt idx="10">
                  <c:v>0.33251104943981907</c:v>
                </c:pt>
                <c:pt idx="11">
                  <c:v>0.365762154383801</c:v>
                </c:pt>
                <c:pt idx="12">
                  <c:v>0.39901325932778292</c:v>
                </c:pt>
                <c:pt idx="13">
                  <c:v>0.43226436427176479</c:v>
                </c:pt>
                <c:pt idx="14">
                  <c:v>0.46551546921574671</c:v>
                </c:pt>
                <c:pt idx="15">
                  <c:v>0.49876657415972864</c:v>
                </c:pt>
                <c:pt idx="16">
                  <c:v>0.53201767910371056</c:v>
                </c:pt>
                <c:pt idx="17">
                  <c:v>0.56526878404769243</c:v>
                </c:pt>
                <c:pt idx="18">
                  <c:v>0.59851988899167441</c:v>
                </c:pt>
                <c:pt idx="19">
                  <c:v>0.63177099393565628</c:v>
                </c:pt>
                <c:pt idx="20">
                  <c:v>0.66502209887963815</c:v>
                </c:pt>
                <c:pt idx="21">
                  <c:v>0.69827320382362013</c:v>
                </c:pt>
                <c:pt idx="22">
                  <c:v>0.73152430876760199</c:v>
                </c:pt>
                <c:pt idx="23">
                  <c:v>0.76477541371158386</c:v>
                </c:pt>
                <c:pt idx="24">
                  <c:v>0.79802651865556584</c:v>
                </c:pt>
                <c:pt idx="25">
                  <c:v>0.83127762359954771</c:v>
                </c:pt>
                <c:pt idx="26">
                  <c:v>0.86452872854352958</c:v>
                </c:pt>
                <c:pt idx="27">
                  <c:v>0.89777983348751156</c:v>
                </c:pt>
                <c:pt idx="28">
                  <c:v>0.93103093843149343</c:v>
                </c:pt>
                <c:pt idx="29">
                  <c:v>0.96428204337547541</c:v>
                </c:pt>
                <c:pt idx="30">
                  <c:v>0.99753314831945727</c:v>
                </c:pt>
                <c:pt idx="31">
                  <c:v>1.0307842532634393</c:v>
                </c:pt>
                <c:pt idx="32">
                  <c:v>1.0640353582074211</c:v>
                </c:pt>
                <c:pt idx="33">
                  <c:v>1.097286463151403</c:v>
                </c:pt>
                <c:pt idx="34">
                  <c:v>1.1305375680953849</c:v>
                </c:pt>
                <c:pt idx="35">
                  <c:v>1.1637886730393667</c:v>
                </c:pt>
                <c:pt idx="36">
                  <c:v>1.1970397779833488</c:v>
                </c:pt>
                <c:pt idx="37">
                  <c:v>1.2302908829273307</c:v>
                </c:pt>
                <c:pt idx="38">
                  <c:v>1.2635419878713126</c:v>
                </c:pt>
                <c:pt idx="39">
                  <c:v>1.2967930928152944</c:v>
                </c:pt>
                <c:pt idx="40">
                  <c:v>1.3300441977592763</c:v>
                </c:pt>
                <c:pt idx="41">
                  <c:v>1.3632953027032582</c:v>
                </c:pt>
                <c:pt idx="42">
                  <c:v>1.3965464076472403</c:v>
                </c:pt>
                <c:pt idx="43">
                  <c:v>1.4297975125912221</c:v>
                </c:pt>
                <c:pt idx="44">
                  <c:v>1.463048617535204</c:v>
                </c:pt>
                <c:pt idx="45">
                  <c:v>1.4962997224791859</c:v>
                </c:pt>
                <c:pt idx="46">
                  <c:v>1.5295508274231677</c:v>
                </c:pt>
                <c:pt idx="47">
                  <c:v>1.5628019323671498</c:v>
                </c:pt>
                <c:pt idx="48">
                  <c:v>1.5960530373111317</c:v>
                </c:pt>
                <c:pt idx="49">
                  <c:v>1.6293041422551136</c:v>
                </c:pt>
                <c:pt idx="50">
                  <c:v>1.6625552471990954</c:v>
                </c:pt>
                <c:pt idx="51">
                  <c:v>1.6958063521430773</c:v>
                </c:pt>
                <c:pt idx="52">
                  <c:v>1.7290574570870592</c:v>
                </c:pt>
                <c:pt idx="53">
                  <c:v>1.7623085620310412</c:v>
                </c:pt>
                <c:pt idx="54">
                  <c:v>1.7955596669750231</c:v>
                </c:pt>
                <c:pt idx="55">
                  <c:v>1.828810771919005</c:v>
                </c:pt>
                <c:pt idx="56">
                  <c:v>1.8620618768629869</c:v>
                </c:pt>
                <c:pt idx="57">
                  <c:v>1.8953129818069687</c:v>
                </c:pt>
                <c:pt idx="58">
                  <c:v>1.9285640867509508</c:v>
                </c:pt>
                <c:pt idx="59">
                  <c:v>1.9618151916949327</c:v>
                </c:pt>
                <c:pt idx="60">
                  <c:v>1.9950662966389145</c:v>
                </c:pt>
                <c:pt idx="61">
                  <c:v>2.0283174015828966</c:v>
                </c:pt>
                <c:pt idx="62">
                  <c:v>2.0615685065268785</c:v>
                </c:pt>
                <c:pt idx="63">
                  <c:v>2.0948196114708604</c:v>
                </c:pt>
                <c:pt idx="64">
                  <c:v>2.1280707164148422</c:v>
                </c:pt>
                <c:pt idx="65">
                  <c:v>2.1613218213588241</c:v>
                </c:pt>
                <c:pt idx="66">
                  <c:v>2.194572926302806</c:v>
                </c:pt>
                <c:pt idx="67">
                  <c:v>2.2278240312467879</c:v>
                </c:pt>
                <c:pt idx="68">
                  <c:v>2.2610751361907697</c:v>
                </c:pt>
                <c:pt idx="69">
                  <c:v>2.2943262411347516</c:v>
                </c:pt>
                <c:pt idx="70">
                  <c:v>2.3275773460787335</c:v>
                </c:pt>
                <c:pt idx="71">
                  <c:v>2.3608284510227153</c:v>
                </c:pt>
                <c:pt idx="72">
                  <c:v>2.3940795559666976</c:v>
                </c:pt>
                <c:pt idx="73">
                  <c:v>2.4273306609106795</c:v>
                </c:pt>
                <c:pt idx="74">
                  <c:v>2.4605817658546614</c:v>
                </c:pt>
                <c:pt idx="75">
                  <c:v>2.4938328707986432</c:v>
                </c:pt>
                <c:pt idx="76">
                  <c:v>2.5270839757426251</c:v>
                </c:pt>
                <c:pt idx="77">
                  <c:v>2.560335080686607</c:v>
                </c:pt>
                <c:pt idx="78">
                  <c:v>2.5935861856305888</c:v>
                </c:pt>
                <c:pt idx="79">
                  <c:v>2.6268372905745707</c:v>
                </c:pt>
                <c:pt idx="80">
                  <c:v>2.6600883955185526</c:v>
                </c:pt>
                <c:pt idx="81">
                  <c:v>2.6933395004625345</c:v>
                </c:pt>
                <c:pt idx="82">
                  <c:v>2.7265906054065163</c:v>
                </c:pt>
                <c:pt idx="83">
                  <c:v>2.7598417103504986</c:v>
                </c:pt>
                <c:pt idx="84">
                  <c:v>2.7930928152944805</c:v>
                </c:pt>
                <c:pt idx="85">
                  <c:v>2.8263439202384624</c:v>
                </c:pt>
                <c:pt idx="86">
                  <c:v>2.8595950251824442</c:v>
                </c:pt>
                <c:pt idx="87">
                  <c:v>2.8928461301264261</c:v>
                </c:pt>
                <c:pt idx="88">
                  <c:v>2.926097235070408</c:v>
                </c:pt>
                <c:pt idx="89">
                  <c:v>2.9593483400143898</c:v>
                </c:pt>
                <c:pt idx="90">
                  <c:v>2.9925994449583717</c:v>
                </c:pt>
                <c:pt idx="91">
                  <c:v>3.0258505499023536</c:v>
                </c:pt>
                <c:pt idx="92">
                  <c:v>3.0591016548463354</c:v>
                </c:pt>
                <c:pt idx="93">
                  <c:v>3.0923527597903173</c:v>
                </c:pt>
                <c:pt idx="94">
                  <c:v>3.1256038647342996</c:v>
                </c:pt>
                <c:pt idx="95">
                  <c:v>3.1588549696782815</c:v>
                </c:pt>
                <c:pt idx="96">
                  <c:v>3.1921060746222634</c:v>
                </c:pt>
                <c:pt idx="97">
                  <c:v>3.2253571795662452</c:v>
                </c:pt>
                <c:pt idx="98">
                  <c:v>3.2586082845102271</c:v>
                </c:pt>
                <c:pt idx="99">
                  <c:v>3.291859389454209</c:v>
                </c:pt>
                <c:pt idx="100">
                  <c:v>3.3251104943981908</c:v>
                </c:pt>
                <c:pt idx="101">
                  <c:v>3.3583615993421727</c:v>
                </c:pt>
                <c:pt idx="102">
                  <c:v>3.3916127042861546</c:v>
                </c:pt>
                <c:pt idx="103">
                  <c:v>3.4248638092301364</c:v>
                </c:pt>
                <c:pt idx="104">
                  <c:v>3.4581149141741183</c:v>
                </c:pt>
                <c:pt idx="105">
                  <c:v>3.4913660191181006</c:v>
                </c:pt>
                <c:pt idx="106">
                  <c:v>3.5246171240620825</c:v>
                </c:pt>
                <c:pt idx="107">
                  <c:v>3.5578682290060644</c:v>
                </c:pt>
                <c:pt idx="108">
                  <c:v>3.5911193339500462</c:v>
                </c:pt>
                <c:pt idx="109">
                  <c:v>3.6243704388940281</c:v>
                </c:pt>
                <c:pt idx="110">
                  <c:v>3.65762154383801</c:v>
                </c:pt>
                <c:pt idx="111">
                  <c:v>3.6908726487819918</c:v>
                </c:pt>
                <c:pt idx="112">
                  <c:v>3.7241237537259737</c:v>
                </c:pt>
                <c:pt idx="113">
                  <c:v>3.7573748586699556</c:v>
                </c:pt>
                <c:pt idx="114">
                  <c:v>3.7906259636139374</c:v>
                </c:pt>
                <c:pt idx="115">
                  <c:v>3.8238770685579193</c:v>
                </c:pt>
                <c:pt idx="116">
                  <c:v>3.8571281735019016</c:v>
                </c:pt>
                <c:pt idx="117">
                  <c:v>3.8903792784458835</c:v>
                </c:pt>
                <c:pt idx="118">
                  <c:v>3.9236303833898654</c:v>
                </c:pt>
                <c:pt idx="119">
                  <c:v>3.9568814883338472</c:v>
                </c:pt>
                <c:pt idx="120">
                  <c:v>3.9901325932778291</c:v>
                </c:pt>
                <c:pt idx="121">
                  <c:v>4.023383698221811</c:v>
                </c:pt>
                <c:pt idx="122">
                  <c:v>4.0566348031657933</c:v>
                </c:pt>
                <c:pt idx="123">
                  <c:v>4.0898859081097747</c:v>
                </c:pt>
                <c:pt idx="124">
                  <c:v>4.123137013053757</c:v>
                </c:pt>
                <c:pt idx="125">
                  <c:v>4.1563881179977384</c:v>
                </c:pt>
                <c:pt idx="126">
                  <c:v>4.1896392229417208</c:v>
                </c:pt>
                <c:pt idx="127">
                  <c:v>4.2228903278857022</c:v>
                </c:pt>
                <c:pt idx="128">
                  <c:v>4.2561414328296845</c:v>
                </c:pt>
                <c:pt idx="129">
                  <c:v>4.2893925377736659</c:v>
                </c:pt>
                <c:pt idx="130">
                  <c:v>4.3226436427176482</c:v>
                </c:pt>
                <c:pt idx="131">
                  <c:v>4.3558947476616297</c:v>
                </c:pt>
                <c:pt idx="132">
                  <c:v>4.389145852605612</c:v>
                </c:pt>
                <c:pt idx="133">
                  <c:v>4.4223969575495943</c:v>
                </c:pt>
                <c:pt idx="134">
                  <c:v>4.4556480624935757</c:v>
                </c:pt>
                <c:pt idx="135">
                  <c:v>4.488899167437558</c:v>
                </c:pt>
                <c:pt idx="136">
                  <c:v>4.5221502723815394</c:v>
                </c:pt>
                <c:pt idx="137">
                  <c:v>4.5554013773255218</c:v>
                </c:pt>
                <c:pt idx="138">
                  <c:v>4.5886524822695032</c:v>
                </c:pt>
                <c:pt idx="139">
                  <c:v>4.6219035872134855</c:v>
                </c:pt>
                <c:pt idx="140">
                  <c:v>4.6551546921574669</c:v>
                </c:pt>
                <c:pt idx="141">
                  <c:v>4.6884057971014492</c:v>
                </c:pt>
                <c:pt idx="142">
                  <c:v>4.7216569020454306</c:v>
                </c:pt>
                <c:pt idx="143">
                  <c:v>4.754908006989413</c:v>
                </c:pt>
                <c:pt idx="144">
                  <c:v>4.7881591119333953</c:v>
                </c:pt>
                <c:pt idx="145">
                  <c:v>4.8214102168773767</c:v>
                </c:pt>
                <c:pt idx="146">
                  <c:v>4.854661321821359</c:v>
                </c:pt>
                <c:pt idx="147">
                  <c:v>4.8879124267653404</c:v>
                </c:pt>
                <c:pt idx="148">
                  <c:v>4.9211635317093227</c:v>
                </c:pt>
                <c:pt idx="149">
                  <c:v>4.9544146366533042</c:v>
                </c:pt>
                <c:pt idx="150">
                  <c:v>4.9876657415972865</c:v>
                </c:pt>
                <c:pt idx="151">
                  <c:v>5.0209168465412679</c:v>
                </c:pt>
                <c:pt idx="152">
                  <c:v>5.0541679514852502</c:v>
                </c:pt>
                <c:pt idx="153">
                  <c:v>5.0874190564292316</c:v>
                </c:pt>
                <c:pt idx="154">
                  <c:v>5.120670161373214</c:v>
                </c:pt>
                <c:pt idx="155">
                  <c:v>5.1539212663171963</c:v>
                </c:pt>
                <c:pt idx="156">
                  <c:v>5.1871723712611777</c:v>
                </c:pt>
                <c:pt idx="157">
                  <c:v>5.22042347620516</c:v>
                </c:pt>
                <c:pt idx="158">
                  <c:v>5.2536745811491414</c:v>
                </c:pt>
                <c:pt idx="159">
                  <c:v>5.2869256860931237</c:v>
                </c:pt>
                <c:pt idx="160">
                  <c:v>5.3201767910371052</c:v>
                </c:pt>
                <c:pt idx="161">
                  <c:v>5.3534278959810875</c:v>
                </c:pt>
                <c:pt idx="162">
                  <c:v>5.3866790009250689</c:v>
                </c:pt>
                <c:pt idx="163">
                  <c:v>5.4199301058690512</c:v>
                </c:pt>
                <c:pt idx="164">
                  <c:v>5.4531812108130326</c:v>
                </c:pt>
                <c:pt idx="165">
                  <c:v>5.486432315757015</c:v>
                </c:pt>
                <c:pt idx="166">
                  <c:v>5.5196834207009973</c:v>
                </c:pt>
                <c:pt idx="167">
                  <c:v>5.5529345256449787</c:v>
                </c:pt>
                <c:pt idx="168">
                  <c:v>5.586185630588961</c:v>
                </c:pt>
                <c:pt idx="169">
                  <c:v>5.6194367355329424</c:v>
                </c:pt>
                <c:pt idx="170">
                  <c:v>5.6526878404769247</c:v>
                </c:pt>
                <c:pt idx="171">
                  <c:v>5.6859389454209062</c:v>
                </c:pt>
                <c:pt idx="172">
                  <c:v>5.7191900503648885</c:v>
                </c:pt>
                <c:pt idx="173">
                  <c:v>5.7524411553088699</c:v>
                </c:pt>
                <c:pt idx="174">
                  <c:v>5.7856922602528522</c:v>
                </c:pt>
                <c:pt idx="175">
                  <c:v>5.8189433651968336</c:v>
                </c:pt>
                <c:pt idx="176">
                  <c:v>5.852194470140816</c:v>
                </c:pt>
                <c:pt idx="177">
                  <c:v>5.8854455750847983</c:v>
                </c:pt>
                <c:pt idx="178">
                  <c:v>5.9186966800287797</c:v>
                </c:pt>
                <c:pt idx="179">
                  <c:v>5.951947784972762</c:v>
                </c:pt>
                <c:pt idx="180">
                  <c:v>5.9851988899167434</c:v>
                </c:pt>
                <c:pt idx="181">
                  <c:v>6.0184499948607257</c:v>
                </c:pt>
                <c:pt idx="182">
                  <c:v>6.0517010998047072</c:v>
                </c:pt>
                <c:pt idx="183">
                  <c:v>6.0849522047486895</c:v>
                </c:pt>
                <c:pt idx="184">
                  <c:v>6.1182033096926709</c:v>
                </c:pt>
                <c:pt idx="185">
                  <c:v>6.1514544146366532</c:v>
                </c:pt>
                <c:pt idx="186">
                  <c:v>6.1847055195806346</c:v>
                </c:pt>
                <c:pt idx="187">
                  <c:v>6.2179566245246169</c:v>
                </c:pt>
                <c:pt idx="188">
                  <c:v>6.2512077294685993</c:v>
                </c:pt>
                <c:pt idx="189">
                  <c:v>6.2844588344125807</c:v>
                </c:pt>
                <c:pt idx="190">
                  <c:v>6.317709939356563</c:v>
                </c:pt>
                <c:pt idx="191">
                  <c:v>6.3509610443005444</c:v>
                </c:pt>
                <c:pt idx="192">
                  <c:v>6.3842121492445267</c:v>
                </c:pt>
                <c:pt idx="193">
                  <c:v>6.4174632541885082</c:v>
                </c:pt>
                <c:pt idx="194">
                  <c:v>6.4507143591324905</c:v>
                </c:pt>
                <c:pt idx="195">
                  <c:v>6.4839654640764719</c:v>
                </c:pt>
                <c:pt idx="196">
                  <c:v>6.5172165690204542</c:v>
                </c:pt>
                <c:pt idx="197">
                  <c:v>6.5504676739644356</c:v>
                </c:pt>
                <c:pt idx="198">
                  <c:v>6.5837187789084179</c:v>
                </c:pt>
                <c:pt idx="199">
                  <c:v>6.6169698838524003</c:v>
                </c:pt>
                <c:pt idx="200">
                  <c:v>6.6502209887963817</c:v>
                </c:pt>
                <c:pt idx="201">
                  <c:v>6.683472093740364</c:v>
                </c:pt>
                <c:pt idx="202">
                  <c:v>6.7167231986843454</c:v>
                </c:pt>
                <c:pt idx="203">
                  <c:v>6.7499743036283277</c:v>
                </c:pt>
                <c:pt idx="204">
                  <c:v>6.7832254085723092</c:v>
                </c:pt>
                <c:pt idx="205">
                  <c:v>6.8164765135162915</c:v>
                </c:pt>
                <c:pt idx="206">
                  <c:v>6.8497276184602729</c:v>
                </c:pt>
                <c:pt idx="207">
                  <c:v>6.8829787234042552</c:v>
                </c:pt>
                <c:pt idx="208">
                  <c:v>6.9162298283482366</c:v>
                </c:pt>
                <c:pt idx="209">
                  <c:v>6.9494809332922189</c:v>
                </c:pt>
                <c:pt idx="210">
                  <c:v>6.9827320382362013</c:v>
                </c:pt>
                <c:pt idx="211">
                  <c:v>7.0159831431801827</c:v>
                </c:pt>
                <c:pt idx="212">
                  <c:v>7.049234248124165</c:v>
                </c:pt>
                <c:pt idx="213">
                  <c:v>7.0824853530681464</c:v>
                </c:pt>
                <c:pt idx="214">
                  <c:v>7.1157364580121287</c:v>
                </c:pt>
                <c:pt idx="215">
                  <c:v>7.1489875629561102</c:v>
                </c:pt>
                <c:pt idx="216">
                  <c:v>7.1822386679000925</c:v>
                </c:pt>
                <c:pt idx="217">
                  <c:v>7.2154897728440739</c:v>
                </c:pt>
                <c:pt idx="218">
                  <c:v>7.2487408777880562</c:v>
                </c:pt>
                <c:pt idx="219">
                  <c:v>7.2819919827320376</c:v>
                </c:pt>
                <c:pt idx="220">
                  <c:v>7.3152430876760199</c:v>
                </c:pt>
                <c:pt idx="221">
                  <c:v>7.3484941926200023</c:v>
                </c:pt>
                <c:pt idx="222">
                  <c:v>7.3817452975639837</c:v>
                </c:pt>
                <c:pt idx="223">
                  <c:v>7.414996402507966</c:v>
                </c:pt>
                <c:pt idx="224">
                  <c:v>7.4482475074519474</c:v>
                </c:pt>
                <c:pt idx="225">
                  <c:v>7.4814986123959297</c:v>
                </c:pt>
                <c:pt idx="226">
                  <c:v>7.5147497173399112</c:v>
                </c:pt>
                <c:pt idx="227">
                  <c:v>7.5480008222838935</c:v>
                </c:pt>
                <c:pt idx="228">
                  <c:v>7.5812519272278749</c:v>
                </c:pt>
                <c:pt idx="229">
                  <c:v>7.6145030321718572</c:v>
                </c:pt>
                <c:pt idx="230">
                  <c:v>7.6477541371158386</c:v>
                </c:pt>
                <c:pt idx="231">
                  <c:v>7.6810052420598209</c:v>
                </c:pt>
                <c:pt idx="232">
                  <c:v>7.7142563470038032</c:v>
                </c:pt>
                <c:pt idx="233">
                  <c:v>7.7475074519477847</c:v>
                </c:pt>
                <c:pt idx="234">
                  <c:v>7.780758556891767</c:v>
                </c:pt>
                <c:pt idx="235">
                  <c:v>7.8140096618357484</c:v>
                </c:pt>
                <c:pt idx="236">
                  <c:v>7.8472607667797307</c:v>
                </c:pt>
                <c:pt idx="237">
                  <c:v>7.8805118717237121</c:v>
                </c:pt>
                <c:pt idx="238">
                  <c:v>7.9137629766676945</c:v>
                </c:pt>
                <c:pt idx="239">
                  <c:v>7.9470140816116759</c:v>
                </c:pt>
                <c:pt idx="240">
                  <c:v>7.9802651865556582</c:v>
                </c:pt>
                <c:pt idx="241">
                  <c:v>8.0135162914996396</c:v>
                </c:pt>
                <c:pt idx="242">
                  <c:v>8.0467673964436219</c:v>
                </c:pt>
                <c:pt idx="243">
                  <c:v>8.0800185013876042</c:v>
                </c:pt>
                <c:pt idx="244">
                  <c:v>8.1132696063315866</c:v>
                </c:pt>
                <c:pt idx="245">
                  <c:v>8.1465207112755671</c:v>
                </c:pt>
                <c:pt idx="246">
                  <c:v>8.1797718162195494</c:v>
                </c:pt>
                <c:pt idx="247">
                  <c:v>8.2130229211635317</c:v>
                </c:pt>
                <c:pt idx="248">
                  <c:v>8.246274026107514</c:v>
                </c:pt>
                <c:pt idx="249">
                  <c:v>8.2795251310514946</c:v>
                </c:pt>
                <c:pt idx="250">
                  <c:v>8.3127762359954769</c:v>
                </c:pt>
                <c:pt idx="251">
                  <c:v>8.3460273409394592</c:v>
                </c:pt>
                <c:pt idx="252">
                  <c:v>8.3792784458834415</c:v>
                </c:pt>
                <c:pt idx="253">
                  <c:v>8.412529550827422</c:v>
                </c:pt>
                <c:pt idx="254">
                  <c:v>8.4457806557714044</c:v>
                </c:pt>
                <c:pt idx="255">
                  <c:v>8.4790317607153867</c:v>
                </c:pt>
                <c:pt idx="256">
                  <c:v>8.512282865659369</c:v>
                </c:pt>
                <c:pt idx="257">
                  <c:v>8.5455339706033513</c:v>
                </c:pt>
                <c:pt idx="258">
                  <c:v>8.5787850755473318</c:v>
                </c:pt>
                <c:pt idx="259">
                  <c:v>8.6120361804913141</c:v>
                </c:pt>
                <c:pt idx="260">
                  <c:v>8.6452872854352965</c:v>
                </c:pt>
                <c:pt idx="261">
                  <c:v>8.6785383903792788</c:v>
                </c:pt>
                <c:pt idx="262">
                  <c:v>8.7117894953232593</c:v>
                </c:pt>
                <c:pt idx="263">
                  <c:v>8.7450406002672416</c:v>
                </c:pt>
                <c:pt idx="264">
                  <c:v>8.7782917052112239</c:v>
                </c:pt>
                <c:pt idx="265">
                  <c:v>8.8115428101552062</c:v>
                </c:pt>
                <c:pt idx="266">
                  <c:v>8.8447939150991886</c:v>
                </c:pt>
                <c:pt idx="267">
                  <c:v>8.8780450200431691</c:v>
                </c:pt>
                <c:pt idx="268">
                  <c:v>8.9112961249871514</c:v>
                </c:pt>
                <c:pt idx="269">
                  <c:v>8.9445472299311337</c:v>
                </c:pt>
                <c:pt idx="270">
                  <c:v>8.977798334875116</c:v>
                </c:pt>
                <c:pt idx="271">
                  <c:v>9.0110494398190966</c:v>
                </c:pt>
                <c:pt idx="272">
                  <c:v>9.0443005447630789</c:v>
                </c:pt>
                <c:pt idx="273">
                  <c:v>9.0775516497070612</c:v>
                </c:pt>
                <c:pt idx="274">
                  <c:v>9.1108027546510435</c:v>
                </c:pt>
                <c:pt idx="275">
                  <c:v>9.144053859595024</c:v>
                </c:pt>
                <c:pt idx="276">
                  <c:v>9.1773049645390063</c:v>
                </c:pt>
                <c:pt idx="277">
                  <c:v>9.2105560694829887</c:v>
                </c:pt>
                <c:pt idx="278">
                  <c:v>9.243807174426971</c:v>
                </c:pt>
                <c:pt idx="279">
                  <c:v>9.2770582793709533</c:v>
                </c:pt>
                <c:pt idx="280">
                  <c:v>9.3103093843149338</c:v>
                </c:pt>
                <c:pt idx="281">
                  <c:v>9.3435604892589161</c:v>
                </c:pt>
                <c:pt idx="282">
                  <c:v>9.3768115942028984</c:v>
                </c:pt>
                <c:pt idx="283">
                  <c:v>9.4100626991468808</c:v>
                </c:pt>
                <c:pt idx="284">
                  <c:v>9.4433138040908613</c:v>
                </c:pt>
                <c:pt idx="285">
                  <c:v>9.4765649090348436</c:v>
                </c:pt>
                <c:pt idx="286">
                  <c:v>9.5098160139788259</c:v>
                </c:pt>
                <c:pt idx="287">
                  <c:v>9.5430671189228082</c:v>
                </c:pt>
                <c:pt idx="288">
                  <c:v>9.5763182238667905</c:v>
                </c:pt>
                <c:pt idx="289">
                  <c:v>9.6095693288107711</c:v>
                </c:pt>
                <c:pt idx="290">
                  <c:v>9.6428204337547534</c:v>
                </c:pt>
                <c:pt idx="291">
                  <c:v>9.6760715386987357</c:v>
                </c:pt>
                <c:pt idx="292">
                  <c:v>9.709322643642718</c:v>
                </c:pt>
                <c:pt idx="293">
                  <c:v>9.7425737485866986</c:v>
                </c:pt>
                <c:pt idx="294">
                  <c:v>9.7758248535306809</c:v>
                </c:pt>
                <c:pt idx="295">
                  <c:v>9.8090759584746632</c:v>
                </c:pt>
                <c:pt idx="296">
                  <c:v>9.8423270634186455</c:v>
                </c:pt>
                <c:pt idx="297">
                  <c:v>9.875578168362626</c:v>
                </c:pt>
                <c:pt idx="298">
                  <c:v>9.9088292733066083</c:v>
                </c:pt>
                <c:pt idx="299">
                  <c:v>9.9420803782505907</c:v>
                </c:pt>
                <c:pt idx="300">
                  <c:v>9.975331483194573</c:v>
                </c:pt>
                <c:pt idx="301">
                  <c:v>10.008582588138555</c:v>
                </c:pt>
                <c:pt idx="302">
                  <c:v>10.041833693082536</c:v>
                </c:pt>
                <c:pt idx="303">
                  <c:v>10.075084798026518</c:v>
                </c:pt>
                <c:pt idx="304">
                  <c:v>10.1083359029705</c:v>
                </c:pt>
                <c:pt idx="305">
                  <c:v>10.141587007914483</c:v>
                </c:pt>
                <c:pt idx="306">
                  <c:v>10.174838112858463</c:v>
                </c:pt>
                <c:pt idx="307">
                  <c:v>10.208089217802446</c:v>
                </c:pt>
                <c:pt idx="308">
                  <c:v>10.241340322746428</c:v>
                </c:pt>
                <c:pt idx="309">
                  <c:v>10.27459142769041</c:v>
                </c:pt>
                <c:pt idx="310">
                  <c:v>10.307842532634393</c:v>
                </c:pt>
                <c:pt idx="311">
                  <c:v>10.341093637578373</c:v>
                </c:pt>
                <c:pt idx="312">
                  <c:v>10.374344742522355</c:v>
                </c:pt>
                <c:pt idx="313">
                  <c:v>10.407595847466338</c:v>
                </c:pt>
                <c:pt idx="314">
                  <c:v>10.44084695241032</c:v>
                </c:pt>
                <c:pt idx="315">
                  <c:v>10.474098057354301</c:v>
                </c:pt>
                <c:pt idx="316">
                  <c:v>10.507349162298283</c:v>
                </c:pt>
                <c:pt idx="317">
                  <c:v>10.540600267242265</c:v>
                </c:pt>
                <c:pt idx="318">
                  <c:v>10.573851372186247</c:v>
                </c:pt>
                <c:pt idx="319">
                  <c:v>10.607102477130228</c:v>
                </c:pt>
                <c:pt idx="320">
                  <c:v>10.64035358207421</c:v>
                </c:pt>
                <c:pt idx="321">
                  <c:v>10.673604687018193</c:v>
                </c:pt>
                <c:pt idx="322">
                  <c:v>10.706855791962175</c:v>
                </c:pt>
                <c:pt idx="323">
                  <c:v>10.740106896906157</c:v>
                </c:pt>
                <c:pt idx="324">
                  <c:v>10.773358001850138</c:v>
                </c:pt>
                <c:pt idx="325">
                  <c:v>10.80660910679412</c:v>
                </c:pt>
                <c:pt idx="326">
                  <c:v>10.839860211738102</c:v>
                </c:pt>
                <c:pt idx="327">
                  <c:v>10.873111316682085</c:v>
                </c:pt>
                <c:pt idx="328">
                  <c:v>10.906362421626065</c:v>
                </c:pt>
                <c:pt idx="329">
                  <c:v>10.939613526570048</c:v>
                </c:pt>
                <c:pt idx="330">
                  <c:v>10.97286463151403</c:v>
                </c:pt>
                <c:pt idx="331">
                  <c:v>11.006115736458012</c:v>
                </c:pt>
                <c:pt idx="332">
                  <c:v>11.039366841401995</c:v>
                </c:pt>
                <c:pt idx="333">
                  <c:v>11.072617946345975</c:v>
                </c:pt>
                <c:pt idx="334">
                  <c:v>11.105869051289957</c:v>
                </c:pt>
                <c:pt idx="335">
                  <c:v>11.13912015623394</c:v>
                </c:pt>
                <c:pt idx="336">
                  <c:v>11.172371261177922</c:v>
                </c:pt>
                <c:pt idx="337">
                  <c:v>11.205622366121903</c:v>
                </c:pt>
                <c:pt idx="338">
                  <c:v>11.238873471065885</c:v>
                </c:pt>
                <c:pt idx="339">
                  <c:v>11.272124576009867</c:v>
                </c:pt>
                <c:pt idx="340">
                  <c:v>11.305375680953849</c:v>
                </c:pt>
                <c:pt idx="341">
                  <c:v>11.33862678589783</c:v>
                </c:pt>
                <c:pt idx="342">
                  <c:v>11.371877890841812</c:v>
                </c:pt>
                <c:pt idx="343">
                  <c:v>11.405128995785795</c:v>
                </c:pt>
                <c:pt idx="344">
                  <c:v>11.438380100729777</c:v>
                </c:pt>
                <c:pt idx="345">
                  <c:v>11.471631205673759</c:v>
                </c:pt>
                <c:pt idx="346">
                  <c:v>11.50488231061774</c:v>
                </c:pt>
                <c:pt idx="347">
                  <c:v>11.538133415561722</c:v>
                </c:pt>
                <c:pt idx="348">
                  <c:v>11.571384520505704</c:v>
                </c:pt>
                <c:pt idx="349">
                  <c:v>11.604635625449687</c:v>
                </c:pt>
                <c:pt idx="350">
                  <c:v>11.637886730393667</c:v>
                </c:pt>
                <c:pt idx="351">
                  <c:v>11.67113783533765</c:v>
                </c:pt>
                <c:pt idx="352">
                  <c:v>11.704388940281632</c:v>
                </c:pt>
                <c:pt idx="353">
                  <c:v>11.737640045225614</c:v>
                </c:pt>
                <c:pt idx="354">
                  <c:v>11.770891150169597</c:v>
                </c:pt>
                <c:pt idx="355">
                  <c:v>11.804142255113577</c:v>
                </c:pt>
                <c:pt idx="356">
                  <c:v>11.837393360057559</c:v>
                </c:pt>
                <c:pt idx="357">
                  <c:v>11.870644465001542</c:v>
                </c:pt>
                <c:pt idx="358">
                  <c:v>11.903895569945524</c:v>
                </c:pt>
                <c:pt idx="359">
                  <c:v>11.937146674889505</c:v>
                </c:pt>
                <c:pt idx="360">
                  <c:v>11.970397779833487</c:v>
                </c:pt>
                <c:pt idx="361">
                  <c:v>12.003648884777469</c:v>
                </c:pt>
                <c:pt idx="362">
                  <c:v>12.036899989721451</c:v>
                </c:pt>
                <c:pt idx="363">
                  <c:v>12.070151094665432</c:v>
                </c:pt>
                <c:pt idx="364">
                  <c:v>12.103402199609414</c:v>
                </c:pt>
                <c:pt idx="365">
                  <c:v>12.136653304553397</c:v>
                </c:pt>
                <c:pt idx="366">
                  <c:v>12.169904409497379</c:v>
                </c:pt>
                <c:pt idx="367">
                  <c:v>12.203155514441361</c:v>
                </c:pt>
                <c:pt idx="368">
                  <c:v>12.236406619385342</c:v>
                </c:pt>
                <c:pt idx="369">
                  <c:v>12.269657724329324</c:v>
                </c:pt>
                <c:pt idx="370">
                  <c:v>12.302908829273306</c:v>
                </c:pt>
                <c:pt idx="371">
                  <c:v>12.336159934217289</c:v>
                </c:pt>
                <c:pt idx="372">
                  <c:v>12.369411039161269</c:v>
                </c:pt>
                <c:pt idx="373">
                  <c:v>12.402662144105252</c:v>
                </c:pt>
                <c:pt idx="374">
                  <c:v>12.435913249049234</c:v>
                </c:pt>
                <c:pt idx="375">
                  <c:v>12.469164353993216</c:v>
                </c:pt>
                <c:pt idx="376">
                  <c:v>12.502415458937199</c:v>
                </c:pt>
                <c:pt idx="377">
                  <c:v>12.535666563881179</c:v>
                </c:pt>
                <c:pt idx="378">
                  <c:v>12.568917668825161</c:v>
                </c:pt>
                <c:pt idx="379">
                  <c:v>12.602168773769144</c:v>
                </c:pt>
                <c:pt idx="380">
                  <c:v>12.635419878713126</c:v>
                </c:pt>
                <c:pt idx="381">
                  <c:v>12.668670983657107</c:v>
                </c:pt>
                <c:pt idx="382">
                  <c:v>12.701922088601089</c:v>
                </c:pt>
                <c:pt idx="383">
                  <c:v>12.735173193545071</c:v>
                </c:pt>
                <c:pt idx="384">
                  <c:v>12.768424298489053</c:v>
                </c:pt>
                <c:pt idx="385">
                  <c:v>12.801675403433034</c:v>
                </c:pt>
                <c:pt idx="386">
                  <c:v>12.834926508377016</c:v>
                </c:pt>
                <c:pt idx="387">
                  <c:v>12.868177613320999</c:v>
                </c:pt>
                <c:pt idx="388">
                  <c:v>12.901428718264981</c:v>
                </c:pt>
                <c:pt idx="389">
                  <c:v>12.934679823208963</c:v>
                </c:pt>
                <c:pt idx="390">
                  <c:v>12.967930928152944</c:v>
                </c:pt>
                <c:pt idx="391">
                  <c:v>13.001182033096926</c:v>
                </c:pt>
                <c:pt idx="392">
                  <c:v>13.034433138040908</c:v>
                </c:pt>
                <c:pt idx="393">
                  <c:v>13.067684242984891</c:v>
                </c:pt>
                <c:pt idx="394">
                  <c:v>13.100935347928871</c:v>
                </c:pt>
                <c:pt idx="395">
                  <c:v>13.134186452872854</c:v>
                </c:pt>
                <c:pt idx="396">
                  <c:v>13.167437557816836</c:v>
                </c:pt>
                <c:pt idx="397">
                  <c:v>13.200688662760818</c:v>
                </c:pt>
                <c:pt idx="398">
                  <c:v>13.233939767704801</c:v>
                </c:pt>
                <c:pt idx="399">
                  <c:v>13.267190872648781</c:v>
                </c:pt>
                <c:pt idx="400">
                  <c:v>13.300441977592763</c:v>
                </c:pt>
                <c:pt idx="401">
                  <c:v>13.333693082536746</c:v>
                </c:pt>
                <c:pt idx="402">
                  <c:v>13.366944187480728</c:v>
                </c:pt>
                <c:pt idx="403">
                  <c:v>13.400195292424709</c:v>
                </c:pt>
                <c:pt idx="404">
                  <c:v>13.433446397368691</c:v>
                </c:pt>
                <c:pt idx="405">
                  <c:v>13.466697502312673</c:v>
                </c:pt>
                <c:pt idx="406">
                  <c:v>13.499948607256655</c:v>
                </c:pt>
                <c:pt idx="407">
                  <c:v>13.533199712200636</c:v>
                </c:pt>
                <c:pt idx="408">
                  <c:v>13.566450817144618</c:v>
                </c:pt>
                <c:pt idx="409">
                  <c:v>13.599701922088601</c:v>
                </c:pt>
                <c:pt idx="410">
                  <c:v>13.632953027032583</c:v>
                </c:pt>
                <c:pt idx="411">
                  <c:v>13.666204131976565</c:v>
                </c:pt>
                <c:pt idx="412">
                  <c:v>13.699455236920546</c:v>
                </c:pt>
                <c:pt idx="413">
                  <c:v>13.732706341864528</c:v>
                </c:pt>
                <c:pt idx="414">
                  <c:v>13.76595744680851</c:v>
                </c:pt>
                <c:pt idx="415">
                  <c:v>13.799208551752493</c:v>
                </c:pt>
                <c:pt idx="416">
                  <c:v>13.832459656696473</c:v>
                </c:pt>
                <c:pt idx="417">
                  <c:v>13.865710761640456</c:v>
                </c:pt>
                <c:pt idx="418">
                  <c:v>13.898961866584438</c:v>
                </c:pt>
                <c:pt idx="419">
                  <c:v>13.93221297152842</c:v>
                </c:pt>
                <c:pt idx="420">
                  <c:v>13.965464076472403</c:v>
                </c:pt>
                <c:pt idx="421">
                  <c:v>13.998715181416383</c:v>
                </c:pt>
                <c:pt idx="422">
                  <c:v>14.031966286360365</c:v>
                </c:pt>
                <c:pt idx="423">
                  <c:v>14.065217391304348</c:v>
                </c:pt>
                <c:pt idx="424">
                  <c:v>14.09846849624833</c:v>
                </c:pt>
                <c:pt idx="425">
                  <c:v>14.131719601192311</c:v>
                </c:pt>
                <c:pt idx="426">
                  <c:v>14.164970706136293</c:v>
                </c:pt>
                <c:pt idx="427">
                  <c:v>14.198221811080275</c:v>
                </c:pt>
                <c:pt idx="428">
                  <c:v>14.231472916024257</c:v>
                </c:pt>
                <c:pt idx="429">
                  <c:v>14.264724020968238</c:v>
                </c:pt>
                <c:pt idx="430">
                  <c:v>14.29797512591222</c:v>
                </c:pt>
                <c:pt idx="431">
                  <c:v>14.331226230856203</c:v>
                </c:pt>
                <c:pt idx="432">
                  <c:v>14.364477335800185</c:v>
                </c:pt>
                <c:pt idx="433">
                  <c:v>14.397728440744167</c:v>
                </c:pt>
                <c:pt idx="434">
                  <c:v>14.430979545688148</c:v>
                </c:pt>
                <c:pt idx="435">
                  <c:v>14.46423065063213</c:v>
                </c:pt>
                <c:pt idx="436">
                  <c:v>14.497481755576112</c:v>
                </c:pt>
                <c:pt idx="437">
                  <c:v>14.530732860520095</c:v>
                </c:pt>
                <c:pt idx="438">
                  <c:v>14.563983965464075</c:v>
                </c:pt>
                <c:pt idx="439">
                  <c:v>14.597235070408058</c:v>
                </c:pt>
                <c:pt idx="440">
                  <c:v>14.63048617535204</c:v>
                </c:pt>
                <c:pt idx="441">
                  <c:v>14.663737280296022</c:v>
                </c:pt>
                <c:pt idx="442">
                  <c:v>14.696988385240005</c:v>
                </c:pt>
                <c:pt idx="443">
                  <c:v>14.730239490183985</c:v>
                </c:pt>
                <c:pt idx="444">
                  <c:v>14.763490595127967</c:v>
                </c:pt>
                <c:pt idx="445">
                  <c:v>14.79674170007195</c:v>
                </c:pt>
                <c:pt idx="446">
                  <c:v>14.829992805015932</c:v>
                </c:pt>
                <c:pt idx="447">
                  <c:v>14.863243909959913</c:v>
                </c:pt>
                <c:pt idx="448">
                  <c:v>14.896495014903895</c:v>
                </c:pt>
                <c:pt idx="449">
                  <c:v>14.929746119847877</c:v>
                </c:pt>
                <c:pt idx="450">
                  <c:v>14.962997224791859</c:v>
                </c:pt>
                <c:pt idx="451">
                  <c:v>14.99624832973584</c:v>
                </c:pt>
                <c:pt idx="452">
                  <c:v>15.029499434679822</c:v>
                </c:pt>
                <c:pt idx="453">
                  <c:v>15.062750539623805</c:v>
                </c:pt>
                <c:pt idx="454">
                  <c:v>15.096001644567787</c:v>
                </c:pt>
                <c:pt idx="455">
                  <c:v>15.129252749511769</c:v>
                </c:pt>
                <c:pt idx="456">
                  <c:v>15.16250385445575</c:v>
                </c:pt>
                <c:pt idx="457">
                  <c:v>15.195754959399732</c:v>
                </c:pt>
                <c:pt idx="458">
                  <c:v>15.229006064343714</c:v>
                </c:pt>
                <c:pt idx="459">
                  <c:v>15.262257169287697</c:v>
                </c:pt>
                <c:pt idx="460">
                  <c:v>15.295508274231677</c:v>
                </c:pt>
                <c:pt idx="461">
                  <c:v>15.32875937917566</c:v>
                </c:pt>
                <c:pt idx="462">
                  <c:v>15.362010484119642</c:v>
                </c:pt>
                <c:pt idx="463">
                  <c:v>15.395261589063624</c:v>
                </c:pt>
                <c:pt idx="464">
                  <c:v>15.428512694007606</c:v>
                </c:pt>
                <c:pt idx="465">
                  <c:v>15.461763798951587</c:v>
                </c:pt>
                <c:pt idx="466">
                  <c:v>15.495014903895569</c:v>
                </c:pt>
                <c:pt idx="467">
                  <c:v>15.528266008839552</c:v>
                </c:pt>
                <c:pt idx="468">
                  <c:v>15.561517113783534</c:v>
                </c:pt>
                <c:pt idx="469">
                  <c:v>15.594768218727515</c:v>
                </c:pt>
                <c:pt idx="470">
                  <c:v>15.628019323671497</c:v>
                </c:pt>
                <c:pt idx="471">
                  <c:v>15.661270428615479</c:v>
                </c:pt>
                <c:pt idx="472">
                  <c:v>15.694521533559461</c:v>
                </c:pt>
                <c:pt idx="473">
                  <c:v>15.727772638503442</c:v>
                </c:pt>
                <c:pt idx="474">
                  <c:v>15.761023743447424</c:v>
                </c:pt>
                <c:pt idx="475">
                  <c:v>15.794274848391407</c:v>
                </c:pt>
                <c:pt idx="476">
                  <c:v>15.827525953335389</c:v>
                </c:pt>
                <c:pt idx="477">
                  <c:v>15.860777058279371</c:v>
                </c:pt>
                <c:pt idx="478">
                  <c:v>15.894028163223352</c:v>
                </c:pt>
                <c:pt idx="479">
                  <c:v>15.927279268167334</c:v>
                </c:pt>
                <c:pt idx="480">
                  <c:v>15.960530373111316</c:v>
                </c:pt>
                <c:pt idx="481">
                  <c:v>15.993781478055299</c:v>
                </c:pt>
                <c:pt idx="482">
                  <c:v>16.027032582999279</c:v>
                </c:pt>
                <c:pt idx="483">
                  <c:v>16.060283687943262</c:v>
                </c:pt>
                <c:pt idx="484">
                  <c:v>16.093534792887244</c:v>
                </c:pt>
                <c:pt idx="485">
                  <c:v>16.126785897831226</c:v>
                </c:pt>
                <c:pt idx="486">
                  <c:v>16.160037002775208</c:v>
                </c:pt>
                <c:pt idx="487">
                  <c:v>16.193288107719191</c:v>
                </c:pt>
                <c:pt idx="488">
                  <c:v>16.226539212663173</c:v>
                </c:pt>
                <c:pt idx="489">
                  <c:v>16.259790317607152</c:v>
                </c:pt>
                <c:pt idx="490">
                  <c:v>16.293041422551134</c:v>
                </c:pt>
                <c:pt idx="491">
                  <c:v>16.326292527495117</c:v>
                </c:pt>
                <c:pt idx="492">
                  <c:v>16.359543632439099</c:v>
                </c:pt>
                <c:pt idx="493">
                  <c:v>16.392794737383081</c:v>
                </c:pt>
                <c:pt idx="494">
                  <c:v>16.426045842327063</c:v>
                </c:pt>
                <c:pt idx="495">
                  <c:v>16.459296947271046</c:v>
                </c:pt>
                <c:pt idx="496">
                  <c:v>16.492548052215028</c:v>
                </c:pt>
                <c:pt idx="497">
                  <c:v>16.52579915715901</c:v>
                </c:pt>
                <c:pt idx="498">
                  <c:v>16.559050262102989</c:v>
                </c:pt>
                <c:pt idx="499">
                  <c:v>16.592301367046971</c:v>
                </c:pt>
                <c:pt idx="500">
                  <c:v>16.625552471990954</c:v>
                </c:pt>
                <c:pt idx="501">
                  <c:v>16.658803576934936</c:v>
                </c:pt>
                <c:pt idx="502">
                  <c:v>16.692054681878918</c:v>
                </c:pt>
                <c:pt idx="503">
                  <c:v>16.725305786822901</c:v>
                </c:pt>
                <c:pt idx="504">
                  <c:v>16.758556891766883</c:v>
                </c:pt>
                <c:pt idx="505">
                  <c:v>16.791807996710865</c:v>
                </c:pt>
                <c:pt idx="506">
                  <c:v>16.825059101654844</c:v>
                </c:pt>
                <c:pt idx="507">
                  <c:v>16.858310206598826</c:v>
                </c:pt>
                <c:pt idx="508">
                  <c:v>16.891561311542809</c:v>
                </c:pt>
                <c:pt idx="509">
                  <c:v>16.924812416486791</c:v>
                </c:pt>
                <c:pt idx="510">
                  <c:v>16.958063521430773</c:v>
                </c:pt>
                <c:pt idx="511">
                  <c:v>16.991314626374756</c:v>
                </c:pt>
                <c:pt idx="512">
                  <c:v>17.024565731318738</c:v>
                </c:pt>
                <c:pt idx="513">
                  <c:v>17.05781683626272</c:v>
                </c:pt>
                <c:pt idx="514">
                  <c:v>17.091067941206703</c:v>
                </c:pt>
                <c:pt idx="515">
                  <c:v>17.124319046150681</c:v>
                </c:pt>
                <c:pt idx="516">
                  <c:v>17.157570151094664</c:v>
                </c:pt>
                <c:pt idx="517">
                  <c:v>17.190821256038646</c:v>
                </c:pt>
                <c:pt idx="518">
                  <c:v>17.224072360982628</c:v>
                </c:pt>
                <c:pt idx="519">
                  <c:v>17.257323465926611</c:v>
                </c:pt>
                <c:pt idx="520">
                  <c:v>17.290574570870593</c:v>
                </c:pt>
                <c:pt idx="521">
                  <c:v>17.323825675814575</c:v>
                </c:pt>
                <c:pt idx="522">
                  <c:v>17.357076780758558</c:v>
                </c:pt>
                <c:pt idx="523">
                  <c:v>17.39032788570254</c:v>
                </c:pt>
                <c:pt idx="524">
                  <c:v>17.423578990646519</c:v>
                </c:pt>
                <c:pt idx="525">
                  <c:v>17.456830095590501</c:v>
                </c:pt>
                <c:pt idx="526">
                  <c:v>17.490081200534483</c:v>
                </c:pt>
                <c:pt idx="527">
                  <c:v>17.523332305478466</c:v>
                </c:pt>
                <c:pt idx="528">
                  <c:v>17.556583410422448</c:v>
                </c:pt>
                <c:pt idx="529">
                  <c:v>17.58983451536643</c:v>
                </c:pt>
                <c:pt idx="530">
                  <c:v>17.623085620310412</c:v>
                </c:pt>
                <c:pt idx="531">
                  <c:v>17.656336725254395</c:v>
                </c:pt>
                <c:pt idx="532">
                  <c:v>17.689587830198377</c:v>
                </c:pt>
                <c:pt idx="533">
                  <c:v>17.722838935142356</c:v>
                </c:pt>
                <c:pt idx="534">
                  <c:v>17.756090040086338</c:v>
                </c:pt>
                <c:pt idx="535">
                  <c:v>17.78934114503032</c:v>
                </c:pt>
                <c:pt idx="536">
                  <c:v>17.822592249974303</c:v>
                </c:pt>
                <c:pt idx="537">
                  <c:v>17.855843354918285</c:v>
                </c:pt>
                <c:pt idx="538">
                  <c:v>17.889094459862267</c:v>
                </c:pt>
                <c:pt idx="539">
                  <c:v>17.92234556480625</c:v>
                </c:pt>
                <c:pt idx="540">
                  <c:v>17.955596669750232</c:v>
                </c:pt>
                <c:pt idx="541">
                  <c:v>17.988847774694214</c:v>
                </c:pt>
                <c:pt idx="542">
                  <c:v>18.022098879638193</c:v>
                </c:pt>
                <c:pt idx="543">
                  <c:v>18.055349984582175</c:v>
                </c:pt>
                <c:pt idx="544">
                  <c:v>18.088601089526158</c:v>
                </c:pt>
                <c:pt idx="545">
                  <c:v>18.12185219447014</c:v>
                </c:pt>
                <c:pt idx="546">
                  <c:v>18.155103299414122</c:v>
                </c:pt>
                <c:pt idx="547">
                  <c:v>18.188354404358105</c:v>
                </c:pt>
                <c:pt idx="548">
                  <c:v>18.221605509302087</c:v>
                </c:pt>
                <c:pt idx="549">
                  <c:v>18.254856614246069</c:v>
                </c:pt>
                <c:pt idx="550">
                  <c:v>18.288107719190048</c:v>
                </c:pt>
                <c:pt idx="551">
                  <c:v>18.32135882413403</c:v>
                </c:pt>
                <c:pt idx="552">
                  <c:v>18.354609929078013</c:v>
                </c:pt>
                <c:pt idx="553">
                  <c:v>18.387861034021995</c:v>
                </c:pt>
                <c:pt idx="554">
                  <c:v>18.421112138965977</c:v>
                </c:pt>
                <c:pt idx="555">
                  <c:v>18.45436324390996</c:v>
                </c:pt>
                <c:pt idx="556">
                  <c:v>18.487614348853942</c:v>
                </c:pt>
                <c:pt idx="557">
                  <c:v>18.520865453797924</c:v>
                </c:pt>
                <c:pt idx="558">
                  <c:v>18.554116558741907</c:v>
                </c:pt>
                <c:pt idx="559">
                  <c:v>18.587367663685885</c:v>
                </c:pt>
                <c:pt idx="560">
                  <c:v>18.620618768629868</c:v>
                </c:pt>
                <c:pt idx="561">
                  <c:v>18.65386987357385</c:v>
                </c:pt>
                <c:pt idx="562">
                  <c:v>18.687120978517832</c:v>
                </c:pt>
                <c:pt idx="563">
                  <c:v>18.720372083461815</c:v>
                </c:pt>
                <c:pt idx="564">
                  <c:v>18.753623188405797</c:v>
                </c:pt>
                <c:pt idx="565">
                  <c:v>18.786874293349779</c:v>
                </c:pt>
                <c:pt idx="566">
                  <c:v>18.820125398293762</c:v>
                </c:pt>
                <c:pt idx="567">
                  <c:v>18.853376503237744</c:v>
                </c:pt>
                <c:pt idx="568">
                  <c:v>18.886627608181723</c:v>
                </c:pt>
                <c:pt idx="569">
                  <c:v>18.919878713125705</c:v>
                </c:pt>
                <c:pt idx="570">
                  <c:v>18.953129818069687</c:v>
                </c:pt>
                <c:pt idx="571">
                  <c:v>18.98638092301367</c:v>
                </c:pt>
                <c:pt idx="572">
                  <c:v>19.019632027957652</c:v>
                </c:pt>
                <c:pt idx="573">
                  <c:v>19.052883132901634</c:v>
                </c:pt>
                <c:pt idx="574">
                  <c:v>19.086134237845616</c:v>
                </c:pt>
                <c:pt idx="575">
                  <c:v>19.119385342789599</c:v>
                </c:pt>
                <c:pt idx="576">
                  <c:v>19.152636447733581</c:v>
                </c:pt>
                <c:pt idx="577">
                  <c:v>19.18588755267756</c:v>
                </c:pt>
                <c:pt idx="578">
                  <c:v>19.219138657621542</c:v>
                </c:pt>
                <c:pt idx="579">
                  <c:v>19.252389762565524</c:v>
                </c:pt>
                <c:pt idx="580">
                  <c:v>19.285640867509507</c:v>
                </c:pt>
                <c:pt idx="581">
                  <c:v>19.318891972453489</c:v>
                </c:pt>
                <c:pt idx="582">
                  <c:v>19.352143077397471</c:v>
                </c:pt>
                <c:pt idx="583">
                  <c:v>19.385394182341454</c:v>
                </c:pt>
                <c:pt idx="584">
                  <c:v>19.418645287285436</c:v>
                </c:pt>
                <c:pt idx="585">
                  <c:v>19.451896392229418</c:v>
                </c:pt>
                <c:pt idx="586">
                  <c:v>19.485147497173397</c:v>
                </c:pt>
                <c:pt idx="587">
                  <c:v>19.518398602117379</c:v>
                </c:pt>
                <c:pt idx="588">
                  <c:v>19.551649707061362</c:v>
                </c:pt>
                <c:pt idx="589">
                  <c:v>19.584900812005344</c:v>
                </c:pt>
                <c:pt idx="590">
                  <c:v>19.618151916949326</c:v>
                </c:pt>
                <c:pt idx="591">
                  <c:v>19.651403021893309</c:v>
                </c:pt>
                <c:pt idx="592">
                  <c:v>19.684654126837291</c:v>
                </c:pt>
                <c:pt idx="593">
                  <c:v>19.717905231781273</c:v>
                </c:pt>
                <c:pt idx="594">
                  <c:v>19.751156336725252</c:v>
                </c:pt>
                <c:pt idx="595">
                  <c:v>19.784407441669234</c:v>
                </c:pt>
                <c:pt idx="596">
                  <c:v>19.817658546613217</c:v>
                </c:pt>
                <c:pt idx="597">
                  <c:v>19.850909651557199</c:v>
                </c:pt>
                <c:pt idx="598">
                  <c:v>19.884160756501181</c:v>
                </c:pt>
                <c:pt idx="599">
                  <c:v>19.917411861445164</c:v>
                </c:pt>
                <c:pt idx="600">
                  <c:v>19.950662966389146</c:v>
                </c:pt>
                <c:pt idx="601">
                  <c:v>19.983914071333128</c:v>
                </c:pt>
                <c:pt idx="602">
                  <c:v>20.017165176277111</c:v>
                </c:pt>
                <c:pt idx="603">
                  <c:v>20.050416281221089</c:v>
                </c:pt>
                <c:pt idx="604">
                  <c:v>20.083667386165072</c:v>
                </c:pt>
                <c:pt idx="605">
                  <c:v>20.116918491109054</c:v>
                </c:pt>
                <c:pt idx="606">
                  <c:v>20.150169596053036</c:v>
                </c:pt>
                <c:pt idx="607">
                  <c:v>20.183420700997019</c:v>
                </c:pt>
                <c:pt idx="608">
                  <c:v>20.216671805941001</c:v>
                </c:pt>
                <c:pt idx="609">
                  <c:v>20.249922910884983</c:v>
                </c:pt>
                <c:pt idx="610">
                  <c:v>20.283174015828966</c:v>
                </c:pt>
                <c:pt idx="611">
                  <c:v>20.316425120772948</c:v>
                </c:pt>
                <c:pt idx="612">
                  <c:v>20.349676225716927</c:v>
                </c:pt>
                <c:pt idx="613">
                  <c:v>20.382927330660909</c:v>
                </c:pt>
                <c:pt idx="614">
                  <c:v>20.416178435604891</c:v>
                </c:pt>
                <c:pt idx="615">
                  <c:v>20.449429540548874</c:v>
                </c:pt>
                <c:pt idx="616">
                  <c:v>20.482680645492856</c:v>
                </c:pt>
                <c:pt idx="617">
                  <c:v>20.515931750436838</c:v>
                </c:pt>
                <c:pt idx="618">
                  <c:v>20.54918285538082</c:v>
                </c:pt>
                <c:pt idx="619">
                  <c:v>20.582433960324803</c:v>
                </c:pt>
                <c:pt idx="620">
                  <c:v>20.615685065268785</c:v>
                </c:pt>
                <c:pt idx="621">
                  <c:v>20.648936170212764</c:v>
                </c:pt>
                <c:pt idx="622">
                  <c:v>20.682187275156746</c:v>
                </c:pt>
                <c:pt idx="623">
                  <c:v>20.715438380100728</c:v>
                </c:pt>
                <c:pt idx="624">
                  <c:v>20.748689485044711</c:v>
                </c:pt>
                <c:pt idx="625">
                  <c:v>20.781940589988693</c:v>
                </c:pt>
                <c:pt idx="626">
                  <c:v>20.815191694932675</c:v>
                </c:pt>
                <c:pt idx="627">
                  <c:v>20.848442799876658</c:v>
                </c:pt>
                <c:pt idx="628">
                  <c:v>20.88169390482064</c:v>
                </c:pt>
                <c:pt idx="629">
                  <c:v>20.914945009764622</c:v>
                </c:pt>
                <c:pt idx="630">
                  <c:v>20.948196114708601</c:v>
                </c:pt>
                <c:pt idx="631">
                  <c:v>20.981447219652583</c:v>
                </c:pt>
                <c:pt idx="632">
                  <c:v>21.014698324596566</c:v>
                </c:pt>
                <c:pt idx="633">
                  <c:v>21.047949429540548</c:v>
                </c:pt>
                <c:pt idx="634">
                  <c:v>21.08120053448453</c:v>
                </c:pt>
                <c:pt idx="635">
                  <c:v>21.114451639428513</c:v>
                </c:pt>
                <c:pt idx="636">
                  <c:v>21.147702744372495</c:v>
                </c:pt>
                <c:pt idx="637">
                  <c:v>21.180953849316477</c:v>
                </c:pt>
                <c:pt idx="638">
                  <c:v>21.214204954260456</c:v>
                </c:pt>
                <c:pt idx="639">
                  <c:v>21.247456059204438</c:v>
                </c:pt>
                <c:pt idx="640">
                  <c:v>21.280707164148421</c:v>
                </c:pt>
                <c:pt idx="641">
                  <c:v>21.313958269092403</c:v>
                </c:pt>
                <c:pt idx="642">
                  <c:v>21.347209374036385</c:v>
                </c:pt>
                <c:pt idx="643">
                  <c:v>21.380460478980368</c:v>
                </c:pt>
                <c:pt idx="644">
                  <c:v>21.41371158392435</c:v>
                </c:pt>
                <c:pt idx="645">
                  <c:v>21.446962688868332</c:v>
                </c:pt>
                <c:pt idx="646">
                  <c:v>21.480213793812315</c:v>
                </c:pt>
                <c:pt idx="647">
                  <c:v>21.513464898756293</c:v>
                </c:pt>
                <c:pt idx="648">
                  <c:v>21.546716003700276</c:v>
                </c:pt>
                <c:pt idx="649">
                  <c:v>21.579967108644258</c:v>
                </c:pt>
                <c:pt idx="650">
                  <c:v>21.61321821358824</c:v>
                </c:pt>
                <c:pt idx="651">
                  <c:v>21.646469318532223</c:v>
                </c:pt>
                <c:pt idx="652">
                  <c:v>21.679720423476205</c:v>
                </c:pt>
                <c:pt idx="653">
                  <c:v>21.712971528420187</c:v>
                </c:pt>
                <c:pt idx="654">
                  <c:v>21.746222633364169</c:v>
                </c:pt>
                <c:pt idx="655">
                  <c:v>21.779473738308152</c:v>
                </c:pt>
                <c:pt idx="656">
                  <c:v>21.812724843252131</c:v>
                </c:pt>
                <c:pt idx="657">
                  <c:v>21.845975948196113</c:v>
                </c:pt>
                <c:pt idx="658">
                  <c:v>21.879227053140095</c:v>
                </c:pt>
                <c:pt idx="659">
                  <c:v>21.912478158084078</c:v>
                </c:pt>
                <c:pt idx="660">
                  <c:v>21.94572926302806</c:v>
                </c:pt>
                <c:pt idx="661">
                  <c:v>21.978980367972042</c:v>
                </c:pt>
                <c:pt idx="662">
                  <c:v>22.012231472916024</c:v>
                </c:pt>
                <c:pt idx="663">
                  <c:v>22.045482577860007</c:v>
                </c:pt>
                <c:pt idx="664">
                  <c:v>22.078733682803989</c:v>
                </c:pt>
                <c:pt idx="665">
                  <c:v>22.111984787747968</c:v>
                </c:pt>
                <c:pt idx="666">
                  <c:v>22.14523589269195</c:v>
                </c:pt>
                <c:pt idx="667">
                  <c:v>22.178486997635932</c:v>
                </c:pt>
                <c:pt idx="668">
                  <c:v>22.211738102579915</c:v>
                </c:pt>
                <c:pt idx="669">
                  <c:v>22.244989207523897</c:v>
                </c:pt>
                <c:pt idx="670">
                  <c:v>22.278240312467879</c:v>
                </c:pt>
                <c:pt idx="671">
                  <c:v>22.311491417411862</c:v>
                </c:pt>
                <c:pt idx="672">
                  <c:v>22.344742522355844</c:v>
                </c:pt>
                <c:pt idx="673">
                  <c:v>22.377993627299826</c:v>
                </c:pt>
                <c:pt idx="674">
                  <c:v>22.411244732243805</c:v>
                </c:pt>
                <c:pt idx="675">
                  <c:v>22.444495837187787</c:v>
                </c:pt>
                <c:pt idx="676">
                  <c:v>22.47774694213177</c:v>
                </c:pt>
                <c:pt idx="677">
                  <c:v>22.510998047075752</c:v>
                </c:pt>
                <c:pt idx="678">
                  <c:v>22.544249152019734</c:v>
                </c:pt>
                <c:pt idx="679">
                  <c:v>22.577500256963717</c:v>
                </c:pt>
                <c:pt idx="680">
                  <c:v>22.610751361907699</c:v>
                </c:pt>
                <c:pt idx="681">
                  <c:v>22.644002466851681</c:v>
                </c:pt>
                <c:pt idx="682">
                  <c:v>22.67725357179566</c:v>
                </c:pt>
                <c:pt idx="683">
                  <c:v>22.710504676739642</c:v>
                </c:pt>
                <c:pt idx="684">
                  <c:v>22.743755781683625</c:v>
                </c:pt>
                <c:pt idx="685">
                  <c:v>22.777006886627607</c:v>
                </c:pt>
                <c:pt idx="686">
                  <c:v>22.810257991571589</c:v>
                </c:pt>
                <c:pt idx="687">
                  <c:v>22.843509096515572</c:v>
                </c:pt>
                <c:pt idx="688">
                  <c:v>22.876760201459554</c:v>
                </c:pt>
                <c:pt idx="689">
                  <c:v>22.910011306403536</c:v>
                </c:pt>
                <c:pt idx="690">
                  <c:v>22.943262411347519</c:v>
                </c:pt>
                <c:pt idx="691">
                  <c:v>22.976513516291497</c:v>
                </c:pt>
                <c:pt idx="692">
                  <c:v>23.00976462123548</c:v>
                </c:pt>
                <c:pt idx="693">
                  <c:v>23.043015726179462</c:v>
                </c:pt>
                <c:pt idx="694">
                  <c:v>23.076266831123444</c:v>
                </c:pt>
                <c:pt idx="695">
                  <c:v>23.109517936067427</c:v>
                </c:pt>
                <c:pt idx="696">
                  <c:v>23.142769041011409</c:v>
                </c:pt>
                <c:pt idx="697">
                  <c:v>23.176020145955391</c:v>
                </c:pt>
                <c:pt idx="698">
                  <c:v>23.209271250899373</c:v>
                </c:pt>
                <c:pt idx="699">
                  <c:v>23.242522355843356</c:v>
                </c:pt>
                <c:pt idx="700">
                  <c:v>23.275773460787335</c:v>
                </c:pt>
                <c:pt idx="701">
                  <c:v>23.309024565731317</c:v>
                </c:pt>
                <c:pt idx="702">
                  <c:v>23.342275670675299</c:v>
                </c:pt>
                <c:pt idx="703">
                  <c:v>23.375526775619281</c:v>
                </c:pt>
                <c:pt idx="704">
                  <c:v>23.408777880563264</c:v>
                </c:pt>
                <c:pt idx="705">
                  <c:v>23.442028985507246</c:v>
                </c:pt>
                <c:pt idx="706">
                  <c:v>23.475280090451228</c:v>
                </c:pt>
                <c:pt idx="707">
                  <c:v>23.508531195395211</c:v>
                </c:pt>
                <c:pt idx="708">
                  <c:v>23.541782300339193</c:v>
                </c:pt>
                <c:pt idx="709">
                  <c:v>23.575033405283172</c:v>
                </c:pt>
                <c:pt idx="710">
                  <c:v>23.608284510227154</c:v>
                </c:pt>
                <c:pt idx="711">
                  <c:v>23.641535615171136</c:v>
                </c:pt>
                <c:pt idx="712">
                  <c:v>23.674786720115119</c:v>
                </c:pt>
                <c:pt idx="713">
                  <c:v>23.708037825059101</c:v>
                </c:pt>
                <c:pt idx="714">
                  <c:v>23.741288930003083</c:v>
                </c:pt>
                <c:pt idx="715">
                  <c:v>23.774540034947066</c:v>
                </c:pt>
                <c:pt idx="716">
                  <c:v>23.807791139891048</c:v>
                </c:pt>
                <c:pt idx="717">
                  <c:v>23.84104224483503</c:v>
                </c:pt>
                <c:pt idx="718">
                  <c:v>23.874293349779009</c:v>
                </c:pt>
                <c:pt idx="719">
                  <c:v>23.907544454722991</c:v>
                </c:pt>
                <c:pt idx="720">
                  <c:v>23.940795559666974</c:v>
                </c:pt>
                <c:pt idx="721">
                  <c:v>23.974046664610956</c:v>
                </c:pt>
                <c:pt idx="722">
                  <c:v>24.007297769554938</c:v>
                </c:pt>
                <c:pt idx="723">
                  <c:v>24.040548874498921</c:v>
                </c:pt>
                <c:pt idx="724">
                  <c:v>24.073799979442903</c:v>
                </c:pt>
                <c:pt idx="725">
                  <c:v>24.107051084386885</c:v>
                </c:pt>
                <c:pt idx="726">
                  <c:v>24.140302189330864</c:v>
                </c:pt>
                <c:pt idx="727">
                  <c:v>24.173553294274846</c:v>
                </c:pt>
                <c:pt idx="728">
                  <c:v>24.206804399218829</c:v>
                </c:pt>
                <c:pt idx="729">
                  <c:v>24.240055504162811</c:v>
                </c:pt>
                <c:pt idx="730">
                  <c:v>24.273306609106793</c:v>
                </c:pt>
                <c:pt idx="731">
                  <c:v>24.306557714050776</c:v>
                </c:pt>
                <c:pt idx="732">
                  <c:v>24.339808818994758</c:v>
                </c:pt>
                <c:pt idx="733">
                  <c:v>24.37305992393874</c:v>
                </c:pt>
                <c:pt idx="734">
                  <c:v>24.406311028882723</c:v>
                </c:pt>
                <c:pt idx="735">
                  <c:v>24.439562133826701</c:v>
                </c:pt>
                <c:pt idx="736">
                  <c:v>24.472813238770684</c:v>
                </c:pt>
                <c:pt idx="737">
                  <c:v>24.506064343714666</c:v>
                </c:pt>
                <c:pt idx="738">
                  <c:v>24.539315448658648</c:v>
                </c:pt>
                <c:pt idx="739">
                  <c:v>24.572566553602631</c:v>
                </c:pt>
                <c:pt idx="740">
                  <c:v>24.605817658546613</c:v>
                </c:pt>
                <c:pt idx="741">
                  <c:v>24.639068763490595</c:v>
                </c:pt>
                <c:pt idx="742">
                  <c:v>24.672319868434577</c:v>
                </c:pt>
                <c:pt idx="743">
                  <c:v>24.70557097337856</c:v>
                </c:pt>
                <c:pt idx="744">
                  <c:v>24.738822078322539</c:v>
                </c:pt>
                <c:pt idx="745">
                  <c:v>24.772073183266521</c:v>
                </c:pt>
                <c:pt idx="746">
                  <c:v>24.805324288210503</c:v>
                </c:pt>
                <c:pt idx="747">
                  <c:v>24.838575393154485</c:v>
                </c:pt>
                <c:pt idx="748">
                  <c:v>24.871826498098468</c:v>
                </c:pt>
                <c:pt idx="749">
                  <c:v>24.90507760304245</c:v>
                </c:pt>
                <c:pt idx="750">
                  <c:v>24.938328707986432</c:v>
                </c:pt>
                <c:pt idx="751">
                  <c:v>24.971579812930415</c:v>
                </c:pt>
                <c:pt idx="752">
                  <c:v>25.004830917874397</c:v>
                </c:pt>
                <c:pt idx="753">
                  <c:v>25.038082022818376</c:v>
                </c:pt>
                <c:pt idx="754">
                  <c:v>25.071333127762358</c:v>
                </c:pt>
                <c:pt idx="755">
                  <c:v>25.10458423270634</c:v>
                </c:pt>
                <c:pt idx="756">
                  <c:v>25.137835337650323</c:v>
                </c:pt>
                <c:pt idx="757">
                  <c:v>25.171086442594305</c:v>
                </c:pt>
                <c:pt idx="758">
                  <c:v>25.204337547538287</c:v>
                </c:pt>
                <c:pt idx="759">
                  <c:v>25.23758865248227</c:v>
                </c:pt>
                <c:pt idx="760">
                  <c:v>25.270839757426252</c:v>
                </c:pt>
                <c:pt idx="761">
                  <c:v>25.304090862370234</c:v>
                </c:pt>
                <c:pt idx="762">
                  <c:v>25.337341967314213</c:v>
                </c:pt>
                <c:pt idx="763">
                  <c:v>25.370593072258195</c:v>
                </c:pt>
                <c:pt idx="764">
                  <c:v>25.403844177202178</c:v>
                </c:pt>
                <c:pt idx="765">
                  <c:v>25.43709528214616</c:v>
                </c:pt>
                <c:pt idx="766">
                  <c:v>25.470346387090142</c:v>
                </c:pt>
                <c:pt idx="767">
                  <c:v>25.503597492034125</c:v>
                </c:pt>
                <c:pt idx="768">
                  <c:v>25.536848596978107</c:v>
                </c:pt>
                <c:pt idx="769">
                  <c:v>25.570099701922089</c:v>
                </c:pt>
                <c:pt idx="770">
                  <c:v>25.603350806866068</c:v>
                </c:pt>
                <c:pt idx="771">
                  <c:v>25.63660191181005</c:v>
                </c:pt>
                <c:pt idx="772">
                  <c:v>25.669853016754033</c:v>
                </c:pt>
                <c:pt idx="773">
                  <c:v>25.703104121698015</c:v>
                </c:pt>
                <c:pt idx="774">
                  <c:v>25.736355226641997</c:v>
                </c:pt>
                <c:pt idx="775">
                  <c:v>25.76960633158598</c:v>
                </c:pt>
                <c:pt idx="776">
                  <c:v>25.802857436529962</c:v>
                </c:pt>
                <c:pt idx="777">
                  <c:v>25.836108541473944</c:v>
                </c:pt>
                <c:pt idx="778">
                  <c:v>25.869359646417927</c:v>
                </c:pt>
                <c:pt idx="779">
                  <c:v>25.902610751361905</c:v>
                </c:pt>
                <c:pt idx="780">
                  <c:v>25.935861856305888</c:v>
                </c:pt>
                <c:pt idx="781">
                  <c:v>25.96911296124987</c:v>
                </c:pt>
                <c:pt idx="782">
                  <c:v>26.002364066193852</c:v>
                </c:pt>
                <c:pt idx="783">
                  <c:v>26.035615171137835</c:v>
                </c:pt>
                <c:pt idx="784">
                  <c:v>26.068866276081817</c:v>
                </c:pt>
                <c:pt idx="785">
                  <c:v>26.102117381025799</c:v>
                </c:pt>
                <c:pt idx="786">
                  <c:v>26.135368485969781</c:v>
                </c:pt>
                <c:pt idx="787">
                  <c:v>26.168619590913764</c:v>
                </c:pt>
                <c:pt idx="788">
                  <c:v>26.201870695857743</c:v>
                </c:pt>
                <c:pt idx="789">
                  <c:v>26.235121800801725</c:v>
                </c:pt>
                <c:pt idx="790">
                  <c:v>26.268372905745707</c:v>
                </c:pt>
                <c:pt idx="791">
                  <c:v>26.301624010689689</c:v>
                </c:pt>
                <c:pt idx="792">
                  <c:v>26.334875115633672</c:v>
                </c:pt>
                <c:pt idx="793">
                  <c:v>26.368126220577654</c:v>
                </c:pt>
                <c:pt idx="794">
                  <c:v>26.401377325521636</c:v>
                </c:pt>
                <c:pt idx="795">
                  <c:v>26.434628430465619</c:v>
                </c:pt>
                <c:pt idx="796">
                  <c:v>26.467879535409601</c:v>
                </c:pt>
                <c:pt idx="797">
                  <c:v>26.50113064035358</c:v>
                </c:pt>
                <c:pt idx="798">
                  <c:v>26.534381745297562</c:v>
                </c:pt>
                <c:pt idx="799">
                  <c:v>26.567632850241544</c:v>
                </c:pt>
                <c:pt idx="800">
                  <c:v>26.600883955185527</c:v>
                </c:pt>
                <c:pt idx="801">
                  <c:v>26.634135060129509</c:v>
                </c:pt>
                <c:pt idx="802">
                  <c:v>26.667386165073491</c:v>
                </c:pt>
                <c:pt idx="803">
                  <c:v>26.700637270017474</c:v>
                </c:pt>
                <c:pt idx="804">
                  <c:v>26.733888374961456</c:v>
                </c:pt>
                <c:pt idx="805">
                  <c:v>26.767139479905438</c:v>
                </c:pt>
                <c:pt idx="806">
                  <c:v>26.800390584849417</c:v>
                </c:pt>
                <c:pt idx="807">
                  <c:v>26.833641689793399</c:v>
                </c:pt>
                <c:pt idx="808">
                  <c:v>26.866892794737382</c:v>
                </c:pt>
                <c:pt idx="809">
                  <c:v>26.900143899681364</c:v>
                </c:pt>
                <c:pt idx="810">
                  <c:v>26.933395004625346</c:v>
                </c:pt>
                <c:pt idx="811">
                  <c:v>26.966646109569329</c:v>
                </c:pt>
                <c:pt idx="812">
                  <c:v>26.999897214513311</c:v>
                </c:pt>
                <c:pt idx="813">
                  <c:v>27.033148319457293</c:v>
                </c:pt>
                <c:pt idx="814">
                  <c:v>27.066399424401272</c:v>
                </c:pt>
                <c:pt idx="815">
                  <c:v>27.099650529345254</c:v>
                </c:pt>
                <c:pt idx="816">
                  <c:v>27.132901634289237</c:v>
                </c:pt>
                <c:pt idx="817">
                  <c:v>27.166152739233219</c:v>
                </c:pt>
                <c:pt idx="818">
                  <c:v>27.199403844177201</c:v>
                </c:pt>
                <c:pt idx="819">
                  <c:v>27.232654949121184</c:v>
                </c:pt>
                <c:pt idx="820">
                  <c:v>27.265906054065166</c:v>
                </c:pt>
                <c:pt idx="821">
                  <c:v>27.299157159009148</c:v>
                </c:pt>
                <c:pt idx="822">
                  <c:v>27.332408263953131</c:v>
                </c:pt>
                <c:pt idx="823">
                  <c:v>27.365659368897109</c:v>
                </c:pt>
                <c:pt idx="824">
                  <c:v>27.398910473841092</c:v>
                </c:pt>
                <c:pt idx="825">
                  <c:v>27.432161578785074</c:v>
                </c:pt>
                <c:pt idx="826">
                  <c:v>27.465412683729056</c:v>
                </c:pt>
                <c:pt idx="827">
                  <c:v>27.498663788673039</c:v>
                </c:pt>
                <c:pt idx="828">
                  <c:v>27.531914893617021</c:v>
                </c:pt>
                <c:pt idx="829">
                  <c:v>27.565165998561003</c:v>
                </c:pt>
                <c:pt idx="830">
                  <c:v>27.598417103504985</c:v>
                </c:pt>
                <c:pt idx="831">
                  <c:v>27.631668208448968</c:v>
                </c:pt>
                <c:pt idx="832">
                  <c:v>27.664919313392947</c:v>
                </c:pt>
                <c:pt idx="833">
                  <c:v>27.698170418336929</c:v>
                </c:pt>
                <c:pt idx="834">
                  <c:v>27.731421523280911</c:v>
                </c:pt>
                <c:pt idx="835">
                  <c:v>27.764672628224893</c:v>
                </c:pt>
                <c:pt idx="836">
                  <c:v>27.797923733168876</c:v>
                </c:pt>
                <c:pt idx="837">
                  <c:v>27.831174838112858</c:v>
                </c:pt>
                <c:pt idx="838">
                  <c:v>27.86442594305684</c:v>
                </c:pt>
                <c:pt idx="839">
                  <c:v>27.897677048000823</c:v>
                </c:pt>
                <c:pt idx="840">
                  <c:v>27.930928152944805</c:v>
                </c:pt>
                <c:pt idx="841">
                  <c:v>27.964179257888784</c:v>
                </c:pt>
                <c:pt idx="842">
                  <c:v>27.997430362832766</c:v>
                </c:pt>
                <c:pt idx="843">
                  <c:v>28.030681467776748</c:v>
                </c:pt>
                <c:pt idx="844">
                  <c:v>28.063932572720731</c:v>
                </c:pt>
                <c:pt idx="845">
                  <c:v>28.097183677664713</c:v>
                </c:pt>
                <c:pt idx="846">
                  <c:v>28.130434782608695</c:v>
                </c:pt>
                <c:pt idx="847">
                  <c:v>28.163685887552678</c:v>
                </c:pt>
                <c:pt idx="848">
                  <c:v>28.19693699249666</c:v>
                </c:pt>
                <c:pt idx="849">
                  <c:v>28.230188097440642</c:v>
                </c:pt>
                <c:pt idx="850">
                  <c:v>28.263439202384621</c:v>
                </c:pt>
                <c:pt idx="851">
                  <c:v>28.296690307328603</c:v>
                </c:pt>
                <c:pt idx="852">
                  <c:v>28.329941412272586</c:v>
                </c:pt>
                <c:pt idx="853">
                  <c:v>28.363192517216568</c:v>
                </c:pt>
                <c:pt idx="854">
                  <c:v>28.39644362216055</c:v>
                </c:pt>
                <c:pt idx="855">
                  <c:v>28.429694727104533</c:v>
                </c:pt>
                <c:pt idx="856">
                  <c:v>28.462945832048515</c:v>
                </c:pt>
                <c:pt idx="857">
                  <c:v>28.496196936992497</c:v>
                </c:pt>
                <c:pt idx="858">
                  <c:v>28.529448041936476</c:v>
                </c:pt>
                <c:pt idx="859">
                  <c:v>28.562699146880458</c:v>
                </c:pt>
                <c:pt idx="860">
                  <c:v>28.595950251824441</c:v>
                </c:pt>
                <c:pt idx="861">
                  <c:v>28.629201356768423</c:v>
                </c:pt>
                <c:pt idx="862">
                  <c:v>28.662452461712405</c:v>
                </c:pt>
                <c:pt idx="863">
                  <c:v>28.695703566656388</c:v>
                </c:pt>
                <c:pt idx="864">
                  <c:v>28.72895467160037</c:v>
                </c:pt>
                <c:pt idx="865">
                  <c:v>28.762205776544352</c:v>
                </c:pt>
                <c:pt idx="866">
                  <c:v>28.795456881488334</c:v>
                </c:pt>
                <c:pt idx="867">
                  <c:v>28.828707986432313</c:v>
                </c:pt>
                <c:pt idx="868">
                  <c:v>28.861959091376296</c:v>
                </c:pt>
                <c:pt idx="869">
                  <c:v>28.895210196320278</c:v>
                </c:pt>
                <c:pt idx="870">
                  <c:v>28.92846130126426</c:v>
                </c:pt>
                <c:pt idx="871">
                  <c:v>28.961712406208242</c:v>
                </c:pt>
                <c:pt idx="872">
                  <c:v>28.994963511152225</c:v>
                </c:pt>
                <c:pt idx="873">
                  <c:v>29.028214616096207</c:v>
                </c:pt>
                <c:pt idx="874">
                  <c:v>29.061465721040189</c:v>
                </c:pt>
                <c:pt idx="875">
                  <c:v>29.094716825984172</c:v>
                </c:pt>
                <c:pt idx="876">
                  <c:v>29.127967930928151</c:v>
                </c:pt>
                <c:pt idx="877">
                  <c:v>29.161219035872133</c:v>
                </c:pt>
                <c:pt idx="878">
                  <c:v>29.194470140816115</c:v>
                </c:pt>
                <c:pt idx="879">
                  <c:v>29.227721245760097</c:v>
                </c:pt>
                <c:pt idx="880">
                  <c:v>29.26097235070408</c:v>
                </c:pt>
                <c:pt idx="881">
                  <c:v>29.294223455648062</c:v>
                </c:pt>
                <c:pt idx="882">
                  <c:v>29.327474560592044</c:v>
                </c:pt>
                <c:pt idx="883">
                  <c:v>29.360725665536027</c:v>
                </c:pt>
                <c:pt idx="884">
                  <c:v>29.393976770480009</c:v>
                </c:pt>
                <c:pt idx="885">
                  <c:v>29.427227875423988</c:v>
                </c:pt>
                <c:pt idx="886">
                  <c:v>29.46047898036797</c:v>
                </c:pt>
                <c:pt idx="887">
                  <c:v>29.493730085311952</c:v>
                </c:pt>
                <c:pt idx="888">
                  <c:v>29.526981190255935</c:v>
                </c:pt>
                <c:pt idx="889">
                  <c:v>29.560232295199917</c:v>
                </c:pt>
                <c:pt idx="890">
                  <c:v>29.593483400143899</c:v>
                </c:pt>
                <c:pt idx="891">
                  <c:v>29.626734505087882</c:v>
                </c:pt>
                <c:pt idx="892">
                  <c:v>29.659985610031864</c:v>
                </c:pt>
                <c:pt idx="893">
                  <c:v>29.693236714975846</c:v>
                </c:pt>
                <c:pt idx="894">
                  <c:v>29.726487819919825</c:v>
                </c:pt>
                <c:pt idx="895">
                  <c:v>29.759738924863807</c:v>
                </c:pt>
                <c:pt idx="896">
                  <c:v>29.79299002980779</c:v>
                </c:pt>
                <c:pt idx="897">
                  <c:v>29.826241134751772</c:v>
                </c:pt>
                <c:pt idx="898">
                  <c:v>29.859492239695754</c:v>
                </c:pt>
                <c:pt idx="899">
                  <c:v>29.892743344639737</c:v>
                </c:pt>
                <c:pt idx="900">
                  <c:v>29.925994449583719</c:v>
                </c:pt>
                <c:pt idx="901">
                  <c:v>29.959245554527701</c:v>
                </c:pt>
                <c:pt idx="902">
                  <c:v>29.99249665947168</c:v>
                </c:pt>
                <c:pt idx="903">
                  <c:v>30.025747764415662</c:v>
                </c:pt>
                <c:pt idx="904">
                  <c:v>30.058998869359645</c:v>
                </c:pt>
                <c:pt idx="905">
                  <c:v>30.092249974303627</c:v>
                </c:pt>
                <c:pt idx="906">
                  <c:v>30.125501079247609</c:v>
                </c:pt>
                <c:pt idx="907">
                  <c:v>30.158752184191592</c:v>
                </c:pt>
                <c:pt idx="908">
                  <c:v>30.192003289135574</c:v>
                </c:pt>
                <c:pt idx="909">
                  <c:v>30.225254394079556</c:v>
                </c:pt>
                <c:pt idx="910">
                  <c:v>30.258505499023538</c:v>
                </c:pt>
                <c:pt idx="911">
                  <c:v>30.291756603967517</c:v>
                </c:pt>
                <c:pt idx="912">
                  <c:v>30.3250077089115</c:v>
                </c:pt>
                <c:pt idx="913">
                  <c:v>30.358258813855482</c:v>
                </c:pt>
                <c:pt idx="914">
                  <c:v>30.391509918799464</c:v>
                </c:pt>
                <c:pt idx="915">
                  <c:v>30.424761023743446</c:v>
                </c:pt>
                <c:pt idx="916">
                  <c:v>30.458012128687429</c:v>
                </c:pt>
                <c:pt idx="917">
                  <c:v>30.491263233631411</c:v>
                </c:pt>
                <c:pt idx="918">
                  <c:v>30.524514338575393</c:v>
                </c:pt>
                <c:pt idx="919">
                  <c:v>30.557765443519376</c:v>
                </c:pt>
                <c:pt idx="920">
                  <c:v>30.591016548463354</c:v>
                </c:pt>
                <c:pt idx="921">
                  <c:v>30.624267653407337</c:v>
                </c:pt>
                <c:pt idx="922">
                  <c:v>30.657518758351319</c:v>
                </c:pt>
                <c:pt idx="923">
                  <c:v>30.690769863295301</c:v>
                </c:pt>
                <c:pt idx="924">
                  <c:v>30.724020968239284</c:v>
                </c:pt>
                <c:pt idx="925">
                  <c:v>30.757272073183266</c:v>
                </c:pt>
                <c:pt idx="926">
                  <c:v>30.790523178127248</c:v>
                </c:pt>
                <c:pt idx="927">
                  <c:v>30.823774283071231</c:v>
                </c:pt>
                <c:pt idx="928">
                  <c:v>30.857025388015213</c:v>
                </c:pt>
                <c:pt idx="929">
                  <c:v>30.890276492959192</c:v>
                </c:pt>
                <c:pt idx="930">
                  <c:v>30.923527597903174</c:v>
                </c:pt>
                <c:pt idx="931">
                  <c:v>30.956778702847156</c:v>
                </c:pt>
                <c:pt idx="932">
                  <c:v>30.990029807791139</c:v>
                </c:pt>
                <c:pt idx="933">
                  <c:v>31.023280912735121</c:v>
                </c:pt>
                <c:pt idx="934">
                  <c:v>31.056532017679103</c:v>
                </c:pt>
                <c:pt idx="935">
                  <c:v>31.089783122623086</c:v>
                </c:pt>
                <c:pt idx="936">
                  <c:v>31.123034227567068</c:v>
                </c:pt>
                <c:pt idx="937">
                  <c:v>31.15628533251105</c:v>
                </c:pt>
                <c:pt idx="938">
                  <c:v>31.189536437455029</c:v>
                </c:pt>
                <c:pt idx="939">
                  <c:v>31.222787542399011</c:v>
                </c:pt>
                <c:pt idx="940">
                  <c:v>31.256038647342994</c:v>
                </c:pt>
                <c:pt idx="941">
                  <c:v>31.289289752286976</c:v>
                </c:pt>
                <c:pt idx="942">
                  <c:v>31.322540857230958</c:v>
                </c:pt>
                <c:pt idx="943">
                  <c:v>31.355791962174941</c:v>
                </c:pt>
                <c:pt idx="944">
                  <c:v>31.389043067118923</c:v>
                </c:pt>
                <c:pt idx="945">
                  <c:v>31.422294172062905</c:v>
                </c:pt>
                <c:pt idx="946">
                  <c:v>31.455545277006884</c:v>
                </c:pt>
                <c:pt idx="947">
                  <c:v>31.488796381950866</c:v>
                </c:pt>
                <c:pt idx="948">
                  <c:v>31.522047486894849</c:v>
                </c:pt>
                <c:pt idx="949">
                  <c:v>31.555298591838831</c:v>
                </c:pt>
                <c:pt idx="950">
                  <c:v>31.588549696782813</c:v>
                </c:pt>
                <c:pt idx="951">
                  <c:v>31.621800801726796</c:v>
                </c:pt>
                <c:pt idx="952">
                  <c:v>31.655051906670778</c:v>
                </c:pt>
                <c:pt idx="953">
                  <c:v>31.68830301161476</c:v>
                </c:pt>
                <c:pt idx="954">
                  <c:v>31.721554116558742</c:v>
                </c:pt>
                <c:pt idx="955">
                  <c:v>31.754805221502721</c:v>
                </c:pt>
                <c:pt idx="956">
                  <c:v>31.788056326446704</c:v>
                </c:pt>
                <c:pt idx="957">
                  <c:v>31.821307431390686</c:v>
                </c:pt>
                <c:pt idx="958">
                  <c:v>31.854558536334668</c:v>
                </c:pt>
                <c:pt idx="959">
                  <c:v>31.88780964127865</c:v>
                </c:pt>
                <c:pt idx="960">
                  <c:v>31.921060746222633</c:v>
                </c:pt>
                <c:pt idx="961">
                  <c:v>31.954311851166615</c:v>
                </c:pt>
                <c:pt idx="962">
                  <c:v>31.987562956110597</c:v>
                </c:pt>
                <c:pt idx="963">
                  <c:v>32.02081406105458</c:v>
                </c:pt>
                <c:pt idx="964">
                  <c:v>32.054065165998558</c:v>
                </c:pt>
                <c:pt idx="965">
                  <c:v>32.087316270942544</c:v>
                </c:pt>
                <c:pt idx="966">
                  <c:v>32.120567375886523</c:v>
                </c:pt>
                <c:pt idx="967">
                  <c:v>32.153818480830509</c:v>
                </c:pt>
                <c:pt idx="968">
                  <c:v>32.187069585774488</c:v>
                </c:pt>
                <c:pt idx="969">
                  <c:v>32.220320690718466</c:v>
                </c:pt>
                <c:pt idx="970">
                  <c:v>32.253571795662452</c:v>
                </c:pt>
                <c:pt idx="971">
                  <c:v>32.286822900606431</c:v>
                </c:pt>
                <c:pt idx="972">
                  <c:v>32.320074005550417</c:v>
                </c:pt>
              </c:numCache>
            </c:numRef>
          </c:xVal>
          <c:yVal>
            <c:numRef>
              <c:f>Curves!$B$4:$B$976</c:f>
              <c:numCache>
                <c:formatCode>###0.00</c:formatCode>
                <c:ptCount val="973"/>
                <c:pt idx="0">
                  <c:v>1E-3</c:v>
                </c:pt>
                <c:pt idx="1">
                  <c:v>3.0000000000000001E-3</c:v>
                </c:pt>
                <c:pt idx="2">
                  <c:v>-8.0000000000000002E-3</c:v>
                </c:pt>
                <c:pt idx="3">
                  <c:v>-2.7E-2</c:v>
                </c:pt>
                <c:pt idx="4">
                  <c:v>-4.2999999999999997E-2</c:v>
                </c:pt>
                <c:pt idx="5">
                  <c:v>-3.0000000000000001E-3</c:v>
                </c:pt>
                <c:pt idx="6">
                  <c:v>7.1999999999999995E-2</c:v>
                </c:pt>
                <c:pt idx="7">
                  <c:v>0.115</c:v>
                </c:pt>
                <c:pt idx="8">
                  <c:v>9.1999999999999998E-2</c:v>
                </c:pt>
                <c:pt idx="9">
                  <c:v>5.3999999999999999E-2</c:v>
                </c:pt>
                <c:pt idx="10">
                  <c:v>3.7999999999999999E-2</c:v>
                </c:pt>
                <c:pt idx="11">
                  <c:v>2.9000000000000001E-2</c:v>
                </c:pt>
                <c:pt idx="12">
                  <c:v>2.1999999999999999E-2</c:v>
                </c:pt>
                <c:pt idx="13">
                  <c:v>1.2E-2</c:v>
                </c:pt>
                <c:pt idx="14">
                  <c:v>4.0000000000000001E-3</c:v>
                </c:pt>
                <c:pt idx="15">
                  <c:v>-4.0000000000000001E-3</c:v>
                </c:pt>
                <c:pt idx="16">
                  <c:v>-3.0000000000000001E-3</c:v>
                </c:pt>
                <c:pt idx="17">
                  <c:v>-7.0000000000000001E-3</c:v>
                </c:pt>
                <c:pt idx="18">
                  <c:v>-7.0000000000000001E-3</c:v>
                </c:pt>
                <c:pt idx="19">
                  <c:v>-7.0000000000000001E-3</c:v>
                </c:pt>
                <c:pt idx="20">
                  <c:v>-1.4E-2</c:v>
                </c:pt>
                <c:pt idx="21">
                  <c:v>-1.6E-2</c:v>
                </c:pt>
                <c:pt idx="22">
                  <c:v>-1.7000000000000001E-2</c:v>
                </c:pt>
                <c:pt idx="23">
                  <c:v>-1.7000000000000001E-2</c:v>
                </c:pt>
                <c:pt idx="24">
                  <c:v>-0.02</c:v>
                </c:pt>
                <c:pt idx="25">
                  <c:v>-3.2000000000000001E-2</c:v>
                </c:pt>
                <c:pt idx="26">
                  <c:v>-3.5999999999999997E-2</c:v>
                </c:pt>
                <c:pt idx="27">
                  <c:v>-4.2999999999999997E-2</c:v>
                </c:pt>
                <c:pt idx="28">
                  <c:v>-3.7999999999999999E-2</c:v>
                </c:pt>
                <c:pt idx="29">
                  <c:v>-0.04</c:v>
                </c:pt>
                <c:pt idx="30">
                  <c:v>-3.6999999999999998E-2</c:v>
                </c:pt>
                <c:pt idx="31">
                  <c:v>-3.7999999999999999E-2</c:v>
                </c:pt>
                <c:pt idx="32">
                  <c:v>-4.1000000000000002E-2</c:v>
                </c:pt>
                <c:pt idx="33">
                  <c:v>-0.04</c:v>
                </c:pt>
                <c:pt idx="34">
                  <c:v>-3.5000000000000003E-2</c:v>
                </c:pt>
                <c:pt idx="35">
                  <c:v>-3.6999999999999998E-2</c:v>
                </c:pt>
                <c:pt idx="36">
                  <c:v>-4.1000000000000002E-2</c:v>
                </c:pt>
                <c:pt idx="37">
                  <c:v>-4.1000000000000002E-2</c:v>
                </c:pt>
                <c:pt idx="38">
                  <c:v>-4.2000000000000003E-2</c:v>
                </c:pt>
                <c:pt idx="39">
                  <c:v>-4.4999999999999998E-2</c:v>
                </c:pt>
                <c:pt idx="40">
                  <c:v>-4.4999999999999998E-2</c:v>
                </c:pt>
                <c:pt idx="41">
                  <c:v>-4.4999999999999998E-2</c:v>
                </c:pt>
                <c:pt idx="42">
                  <c:v>-4.7E-2</c:v>
                </c:pt>
                <c:pt idx="43">
                  <c:v>-0.05</c:v>
                </c:pt>
                <c:pt idx="44">
                  <c:v>-4.7E-2</c:v>
                </c:pt>
                <c:pt idx="45">
                  <c:v>-4.5999999999999999E-2</c:v>
                </c:pt>
                <c:pt idx="46">
                  <c:v>-4.4999999999999998E-2</c:v>
                </c:pt>
                <c:pt idx="47">
                  <c:v>-0.05</c:v>
                </c:pt>
                <c:pt idx="48">
                  <c:v>-5.2999999999999999E-2</c:v>
                </c:pt>
                <c:pt idx="49">
                  <c:v>-5.5E-2</c:v>
                </c:pt>
                <c:pt idx="50">
                  <c:v>-5.7000000000000002E-2</c:v>
                </c:pt>
                <c:pt idx="51">
                  <c:v>-5.8999999999999997E-2</c:v>
                </c:pt>
                <c:pt idx="52">
                  <c:v>-5.6000000000000001E-2</c:v>
                </c:pt>
                <c:pt idx="53">
                  <c:v>-5.0999999999999997E-2</c:v>
                </c:pt>
                <c:pt idx="54">
                  <c:v>-4.4999999999999998E-2</c:v>
                </c:pt>
                <c:pt idx="55">
                  <c:v>-4.3999999999999997E-2</c:v>
                </c:pt>
                <c:pt idx="56">
                  <c:v>-0.05</c:v>
                </c:pt>
                <c:pt idx="57">
                  <c:v>-5.8999999999999997E-2</c:v>
                </c:pt>
                <c:pt idx="58">
                  <c:v>-5.5E-2</c:v>
                </c:pt>
                <c:pt idx="59">
                  <c:v>-5.8000000000000003E-2</c:v>
                </c:pt>
                <c:pt idx="60">
                  <c:v>-6.0999999999999999E-2</c:v>
                </c:pt>
                <c:pt idx="61">
                  <c:v>-6.0999999999999999E-2</c:v>
                </c:pt>
                <c:pt idx="62">
                  <c:v>-5.2999999999999999E-2</c:v>
                </c:pt>
                <c:pt idx="63">
                  <c:v>-0.05</c:v>
                </c:pt>
                <c:pt idx="64">
                  <c:v>-5.2999999999999999E-2</c:v>
                </c:pt>
                <c:pt idx="65">
                  <c:v>-5.7000000000000002E-2</c:v>
                </c:pt>
                <c:pt idx="66">
                  <c:v>-0.06</c:v>
                </c:pt>
                <c:pt idx="67">
                  <c:v>-5.7000000000000002E-2</c:v>
                </c:pt>
                <c:pt idx="68">
                  <c:v>-5.6000000000000001E-2</c:v>
                </c:pt>
                <c:pt idx="69">
                  <c:v>-5.5E-2</c:v>
                </c:pt>
                <c:pt idx="70">
                  <c:v>-5.8000000000000003E-2</c:v>
                </c:pt>
                <c:pt idx="71">
                  <c:v>-5.8999999999999997E-2</c:v>
                </c:pt>
                <c:pt idx="72">
                  <c:v>-5.8999999999999997E-2</c:v>
                </c:pt>
                <c:pt idx="73">
                  <c:v>-5.8999999999999997E-2</c:v>
                </c:pt>
                <c:pt idx="74">
                  <c:v>-5.7000000000000002E-2</c:v>
                </c:pt>
                <c:pt idx="75">
                  <c:v>-5.7000000000000002E-2</c:v>
                </c:pt>
                <c:pt idx="76">
                  <c:v>-5.5E-2</c:v>
                </c:pt>
                <c:pt idx="77">
                  <c:v>-4.9000000000000002E-2</c:v>
                </c:pt>
                <c:pt idx="78">
                  <c:v>-4.8000000000000001E-2</c:v>
                </c:pt>
                <c:pt idx="79">
                  <c:v>-5.2999999999999999E-2</c:v>
                </c:pt>
                <c:pt idx="80">
                  <c:v>-0.06</c:v>
                </c:pt>
                <c:pt idx="81">
                  <c:v>-0.06</c:v>
                </c:pt>
                <c:pt idx="82">
                  <c:v>-0.06</c:v>
                </c:pt>
                <c:pt idx="83">
                  <c:v>-6.6000000000000003E-2</c:v>
                </c:pt>
                <c:pt idx="84">
                  <c:v>-6.7000000000000004E-2</c:v>
                </c:pt>
                <c:pt idx="85">
                  <c:v>-6.5000000000000002E-2</c:v>
                </c:pt>
                <c:pt idx="86">
                  <c:v>-5.7000000000000002E-2</c:v>
                </c:pt>
                <c:pt idx="87">
                  <c:v>-5.2999999999999999E-2</c:v>
                </c:pt>
                <c:pt idx="88">
                  <c:v>-5.0999999999999997E-2</c:v>
                </c:pt>
                <c:pt idx="89">
                  <c:v>-5.3999999999999999E-2</c:v>
                </c:pt>
                <c:pt idx="90">
                  <c:v>-6.2E-2</c:v>
                </c:pt>
                <c:pt idx="91">
                  <c:v>-6.9000000000000006E-2</c:v>
                </c:pt>
                <c:pt idx="92">
                  <c:v>-7.0999999999999994E-2</c:v>
                </c:pt>
                <c:pt idx="93">
                  <c:v>-7.0000000000000007E-2</c:v>
                </c:pt>
                <c:pt idx="94">
                  <c:v>-6.9000000000000006E-2</c:v>
                </c:pt>
                <c:pt idx="95">
                  <c:v>-7.0999999999999994E-2</c:v>
                </c:pt>
                <c:pt idx="96">
                  <c:v>-7.0999999999999994E-2</c:v>
                </c:pt>
                <c:pt idx="97">
                  <c:v>-7.0000000000000007E-2</c:v>
                </c:pt>
                <c:pt idx="98">
                  <c:v>-7.1999999999999995E-2</c:v>
                </c:pt>
                <c:pt idx="99">
                  <c:v>-7.0000000000000007E-2</c:v>
                </c:pt>
                <c:pt idx="100">
                  <c:v>-7.0000000000000007E-2</c:v>
                </c:pt>
                <c:pt idx="101">
                  <c:v>-6.9000000000000006E-2</c:v>
                </c:pt>
                <c:pt idx="102">
                  <c:v>-7.2999999999999995E-2</c:v>
                </c:pt>
                <c:pt idx="103">
                  <c:v>-7.4999999999999997E-2</c:v>
                </c:pt>
                <c:pt idx="104">
                  <c:v>-7.3999999999999996E-2</c:v>
                </c:pt>
                <c:pt idx="105">
                  <c:v>-6.8000000000000005E-2</c:v>
                </c:pt>
                <c:pt idx="106">
                  <c:v>-5.8000000000000003E-2</c:v>
                </c:pt>
                <c:pt idx="107">
                  <c:v>-6.0999999999999999E-2</c:v>
                </c:pt>
                <c:pt idx="108">
                  <c:v>-6.2E-2</c:v>
                </c:pt>
                <c:pt idx="109">
                  <c:v>-6.8000000000000005E-2</c:v>
                </c:pt>
                <c:pt idx="110">
                  <c:v>-0.06</c:v>
                </c:pt>
                <c:pt idx="111">
                  <c:v>-6.4000000000000001E-2</c:v>
                </c:pt>
                <c:pt idx="112">
                  <c:v>-6.3E-2</c:v>
                </c:pt>
                <c:pt idx="113">
                  <c:v>-6.7000000000000004E-2</c:v>
                </c:pt>
                <c:pt idx="114">
                  <c:v>-6.8000000000000005E-2</c:v>
                </c:pt>
                <c:pt idx="115">
                  <c:v>-6.9000000000000006E-2</c:v>
                </c:pt>
                <c:pt idx="116">
                  <c:v>-6.5000000000000002E-2</c:v>
                </c:pt>
                <c:pt idx="117">
                  <c:v>-6.7000000000000004E-2</c:v>
                </c:pt>
                <c:pt idx="118">
                  <c:v>-7.0999999999999994E-2</c:v>
                </c:pt>
                <c:pt idx="119">
                  <c:v>-6.7000000000000004E-2</c:v>
                </c:pt>
                <c:pt idx="120">
                  <c:v>-6.9000000000000006E-2</c:v>
                </c:pt>
                <c:pt idx="121">
                  <c:v>-6.5000000000000002E-2</c:v>
                </c:pt>
                <c:pt idx="122">
                  <c:v>-6.8000000000000005E-2</c:v>
                </c:pt>
                <c:pt idx="123">
                  <c:v>-6.5000000000000002E-2</c:v>
                </c:pt>
                <c:pt idx="124">
                  <c:v>-7.0000000000000007E-2</c:v>
                </c:pt>
                <c:pt idx="125">
                  <c:v>-7.2999999999999995E-2</c:v>
                </c:pt>
                <c:pt idx="126">
                  <c:v>-7.0999999999999994E-2</c:v>
                </c:pt>
                <c:pt idx="127">
                  <c:v>-6.7000000000000004E-2</c:v>
                </c:pt>
                <c:pt idx="128">
                  <c:v>-6.8000000000000005E-2</c:v>
                </c:pt>
                <c:pt idx="129">
                  <c:v>-6.6000000000000003E-2</c:v>
                </c:pt>
                <c:pt idx="130">
                  <c:v>-6.5000000000000002E-2</c:v>
                </c:pt>
                <c:pt idx="131">
                  <c:v>-6.8000000000000005E-2</c:v>
                </c:pt>
                <c:pt idx="132">
                  <c:v>-7.0000000000000007E-2</c:v>
                </c:pt>
                <c:pt idx="133">
                  <c:v>-6.9000000000000006E-2</c:v>
                </c:pt>
                <c:pt idx="134">
                  <c:v>-6.7000000000000004E-2</c:v>
                </c:pt>
                <c:pt idx="135">
                  <c:v>-6.9000000000000006E-2</c:v>
                </c:pt>
                <c:pt idx="136">
                  <c:v>-7.0999999999999994E-2</c:v>
                </c:pt>
                <c:pt idx="137">
                  <c:v>-7.5999999999999998E-2</c:v>
                </c:pt>
                <c:pt idx="138">
                  <c:v>-7.4999999999999997E-2</c:v>
                </c:pt>
                <c:pt idx="139">
                  <c:v>-7.2999999999999995E-2</c:v>
                </c:pt>
                <c:pt idx="140">
                  <c:v>-6.7000000000000004E-2</c:v>
                </c:pt>
                <c:pt idx="141">
                  <c:v>-6.9000000000000006E-2</c:v>
                </c:pt>
                <c:pt idx="142">
                  <c:v>-7.1999999999999995E-2</c:v>
                </c:pt>
                <c:pt idx="143">
                  <c:v>-7.4999999999999997E-2</c:v>
                </c:pt>
                <c:pt idx="144">
                  <c:v>-7.4999999999999997E-2</c:v>
                </c:pt>
                <c:pt idx="145">
                  <c:v>-7.2999999999999995E-2</c:v>
                </c:pt>
                <c:pt idx="146">
                  <c:v>-7.0000000000000007E-2</c:v>
                </c:pt>
                <c:pt idx="147">
                  <c:v>-7.0000000000000007E-2</c:v>
                </c:pt>
                <c:pt idx="148">
                  <c:v>-7.0999999999999994E-2</c:v>
                </c:pt>
                <c:pt idx="149">
                  <c:v>-6.4000000000000001E-2</c:v>
                </c:pt>
                <c:pt idx="150">
                  <c:v>-6.0999999999999999E-2</c:v>
                </c:pt>
                <c:pt idx="151">
                  <c:v>-6.0999999999999999E-2</c:v>
                </c:pt>
                <c:pt idx="152">
                  <c:v>-6.4000000000000001E-2</c:v>
                </c:pt>
                <c:pt idx="153">
                  <c:v>-6.4000000000000001E-2</c:v>
                </c:pt>
                <c:pt idx="154">
                  <c:v>-5.5E-2</c:v>
                </c:pt>
                <c:pt idx="155">
                  <c:v>-5.0999999999999997E-2</c:v>
                </c:pt>
                <c:pt idx="156">
                  <c:v>-4.7E-2</c:v>
                </c:pt>
                <c:pt idx="157">
                  <c:v>-4.4999999999999998E-2</c:v>
                </c:pt>
                <c:pt idx="158">
                  <c:v>-4.4999999999999998E-2</c:v>
                </c:pt>
                <c:pt idx="159">
                  <c:v>-3.7999999999999999E-2</c:v>
                </c:pt>
                <c:pt idx="160">
                  <c:v>-2.8000000000000001E-2</c:v>
                </c:pt>
                <c:pt idx="161">
                  <c:v>-1.4E-2</c:v>
                </c:pt>
                <c:pt idx="162">
                  <c:v>0</c:v>
                </c:pt>
                <c:pt idx="163">
                  <c:v>1.2E-2</c:v>
                </c:pt>
                <c:pt idx="164">
                  <c:v>2.5999999999999999E-2</c:v>
                </c:pt>
                <c:pt idx="165">
                  <c:v>4.7E-2</c:v>
                </c:pt>
                <c:pt idx="166">
                  <c:v>8.1000000000000003E-2</c:v>
                </c:pt>
                <c:pt idx="167">
                  <c:v>0.114</c:v>
                </c:pt>
                <c:pt idx="168">
                  <c:v>0.155</c:v>
                </c:pt>
                <c:pt idx="169">
                  <c:v>0.19600000000000001</c:v>
                </c:pt>
                <c:pt idx="170">
                  <c:v>0.248</c:v>
                </c:pt>
                <c:pt idx="171">
                  <c:v>0.30399999999999999</c:v>
                </c:pt>
                <c:pt idx="172">
                  <c:v>0.373</c:v>
                </c:pt>
                <c:pt idx="173">
                  <c:v>0.45200000000000001</c:v>
                </c:pt>
                <c:pt idx="174">
                  <c:v>0.54800000000000004</c:v>
                </c:pt>
                <c:pt idx="175">
                  <c:v>0.65400000000000003</c:v>
                </c:pt>
                <c:pt idx="176">
                  <c:v>0.77600000000000002</c:v>
                </c:pt>
                <c:pt idx="177">
                  <c:v>0.90900000000000003</c:v>
                </c:pt>
                <c:pt idx="178">
                  <c:v>1.0680000000000001</c:v>
                </c:pt>
                <c:pt idx="179">
                  <c:v>1.246</c:v>
                </c:pt>
                <c:pt idx="180">
                  <c:v>1.4490000000000001</c:v>
                </c:pt>
                <c:pt idx="181">
                  <c:v>1.6619999999999999</c:v>
                </c:pt>
                <c:pt idx="182">
                  <c:v>1.92</c:v>
                </c:pt>
                <c:pt idx="183">
                  <c:v>2.1909999999999998</c:v>
                </c:pt>
                <c:pt idx="184">
                  <c:v>2.5150000000000001</c:v>
                </c:pt>
                <c:pt idx="185">
                  <c:v>2.8580000000000001</c:v>
                </c:pt>
                <c:pt idx="186">
                  <c:v>3.2410000000000001</c:v>
                </c:pt>
                <c:pt idx="187">
                  <c:v>3.68</c:v>
                </c:pt>
                <c:pt idx="188">
                  <c:v>4.1769999999999996</c:v>
                </c:pt>
                <c:pt idx="189">
                  <c:v>4.7329999999999997</c:v>
                </c:pt>
                <c:pt idx="190">
                  <c:v>5.3470000000000004</c:v>
                </c:pt>
                <c:pt idx="191">
                  <c:v>6.0090000000000003</c:v>
                </c:pt>
                <c:pt idx="192">
                  <c:v>6.7430000000000003</c:v>
                </c:pt>
                <c:pt idx="193">
                  <c:v>7.5629999999999997</c:v>
                </c:pt>
                <c:pt idx="194">
                  <c:v>8.49</c:v>
                </c:pt>
                <c:pt idx="195">
                  <c:v>9.5609999999999999</c:v>
                </c:pt>
                <c:pt idx="196">
                  <c:v>10.766999999999999</c:v>
                </c:pt>
                <c:pt idx="197">
                  <c:v>12.247</c:v>
                </c:pt>
                <c:pt idx="198">
                  <c:v>13.922000000000001</c:v>
                </c:pt>
                <c:pt idx="199">
                  <c:v>15.976000000000001</c:v>
                </c:pt>
                <c:pt idx="200">
                  <c:v>18.385999999999999</c:v>
                </c:pt>
                <c:pt idx="201">
                  <c:v>21.280999999999999</c:v>
                </c:pt>
                <c:pt idx="202">
                  <c:v>24.681000000000001</c:v>
                </c:pt>
                <c:pt idx="203">
                  <c:v>28.739000000000001</c:v>
                </c:pt>
                <c:pt idx="204">
                  <c:v>33.494999999999997</c:v>
                </c:pt>
                <c:pt idx="205">
                  <c:v>39.497999999999998</c:v>
                </c:pt>
                <c:pt idx="206">
                  <c:v>46.363</c:v>
                </c:pt>
                <c:pt idx="207">
                  <c:v>55.006999999999998</c:v>
                </c:pt>
                <c:pt idx="208">
                  <c:v>65.013000000000005</c:v>
                </c:pt>
                <c:pt idx="209">
                  <c:v>77.216999999999999</c:v>
                </c:pt>
                <c:pt idx="210">
                  <c:v>91.616</c:v>
                </c:pt>
                <c:pt idx="211">
                  <c:v>108.669</c:v>
                </c:pt>
                <c:pt idx="212">
                  <c:v>128.011</c:v>
                </c:pt>
                <c:pt idx="213">
                  <c:v>151.54300000000001</c:v>
                </c:pt>
                <c:pt idx="214">
                  <c:v>177.31899999999999</c:v>
                </c:pt>
                <c:pt idx="215">
                  <c:v>208.14500000000001</c:v>
                </c:pt>
                <c:pt idx="216">
                  <c:v>241.39699999999999</c:v>
                </c:pt>
                <c:pt idx="217">
                  <c:v>279.041</c:v>
                </c:pt>
                <c:pt idx="218">
                  <c:v>321.85399999999998</c:v>
                </c:pt>
                <c:pt idx="219">
                  <c:v>368.11</c:v>
                </c:pt>
                <c:pt idx="220">
                  <c:v>417.72800000000001</c:v>
                </c:pt>
                <c:pt idx="221">
                  <c:v>470.471</c:v>
                </c:pt>
                <c:pt idx="222">
                  <c:v>525.98900000000003</c:v>
                </c:pt>
                <c:pt idx="223">
                  <c:v>583.62</c:v>
                </c:pt>
                <c:pt idx="224">
                  <c:v>640.35699999999997</c:v>
                </c:pt>
                <c:pt idx="225">
                  <c:v>696.80100000000004</c:v>
                </c:pt>
                <c:pt idx="226">
                  <c:v>752.255</c:v>
                </c:pt>
                <c:pt idx="227">
                  <c:v>803.63800000000003</c:v>
                </c:pt>
                <c:pt idx="228">
                  <c:v>853.07600000000002</c:v>
                </c:pt>
                <c:pt idx="229">
                  <c:v>896.26300000000003</c:v>
                </c:pt>
                <c:pt idx="230">
                  <c:v>936.08500000000004</c:v>
                </c:pt>
                <c:pt idx="231">
                  <c:v>970.61599999999999</c:v>
                </c:pt>
                <c:pt idx="232">
                  <c:v>1001.0839999999999</c:v>
                </c:pt>
                <c:pt idx="233">
                  <c:v>1027.4780000000001</c:v>
                </c:pt>
                <c:pt idx="234">
                  <c:v>1050.537</c:v>
                </c:pt>
                <c:pt idx="235">
                  <c:v>1069.9559999999999</c:v>
                </c:pt>
                <c:pt idx="236">
                  <c:v>1087.5609999999999</c:v>
                </c:pt>
                <c:pt idx="237">
                  <c:v>1102.049</c:v>
                </c:pt>
                <c:pt idx="238">
                  <c:v>1115.019</c:v>
                </c:pt>
                <c:pt idx="239">
                  <c:v>1125.713</c:v>
                </c:pt>
                <c:pt idx="240">
                  <c:v>1134.963</c:v>
                </c:pt>
                <c:pt idx="241">
                  <c:v>1142.6310000000001</c:v>
                </c:pt>
                <c:pt idx="242">
                  <c:v>1149.1210000000001</c:v>
                </c:pt>
                <c:pt idx="243">
                  <c:v>1154.289</c:v>
                </c:pt>
                <c:pt idx="244">
                  <c:v>1158.5619999999999</c:v>
                </c:pt>
                <c:pt idx="245">
                  <c:v>1161.7339999999999</c:v>
                </c:pt>
                <c:pt idx="246">
                  <c:v>1164.1869999999999</c:v>
                </c:pt>
                <c:pt idx="247">
                  <c:v>1165.7329999999999</c:v>
                </c:pt>
                <c:pt idx="248">
                  <c:v>1166.6420000000001</c:v>
                </c:pt>
                <c:pt idx="249">
                  <c:v>1166.9459999999999</c:v>
                </c:pt>
                <c:pt idx="250">
                  <c:v>1166.7059999999999</c:v>
                </c:pt>
                <c:pt idx="251">
                  <c:v>1166.0050000000001</c:v>
                </c:pt>
                <c:pt idx="252">
                  <c:v>1164.9169999999999</c:v>
                </c:pt>
                <c:pt idx="253">
                  <c:v>1163.3889999999999</c:v>
                </c:pt>
                <c:pt idx="254">
                  <c:v>1161.4770000000001</c:v>
                </c:pt>
                <c:pt idx="255">
                  <c:v>1159.2339999999999</c:v>
                </c:pt>
                <c:pt idx="256">
                  <c:v>1156.6189999999999</c:v>
                </c:pt>
                <c:pt idx="257">
                  <c:v>1153.5650000000001</c:v>
                </c:pt>
                <c:pt idx="258">
                  <c:v>1150.153</c:v>
                </c:pt>
                <c:pt idx="259">
                  <c:v>1146.1110000000001</c:v>
                </c:pt>
                <c:pt idx="260">
                  <c:v>1141.671</c:v>
                </c:pt>
                <c:pt idx="261">
                  <c:v>1136.518</c:v>
                </c:pt>
                <c:pt idx="262">
                  <c:v>1130.797</c:v>
                </c:pt>
                <c:pt idx="263">
                  <c:v>1124.3040000000001</c:v>
                </c:pt>
                <c:pt idx="264">
                  <c:v>1117.0509999999999</c:v>
                </c:pt>
                <c:pt idx="265">
                  <c:v>1108.7670000000001</c:v>
                </c:pt>
                <c:pt idx="266">
                  <c:v>1099.704</c:v>
                </c:pt>
                <c:pt idx="267">
                  <c:v>1089.0250000000001</c:v>
                </c:pt>
                <c:pt idx="268">
                  <c:v>1077.643</c:v>
                </c:pt>
                <c:pt idx="269">
                  <c:v>1064.25</c:v>
                </c:pt>
                <c:pt idx="270">
                  <c:v>1049.578</c:v>
                </c:pt>
                <c:pt idx="271">
                  <c:v>1032.768</c:v>
                </c:pt>
                <c:pt idx="272">
                  <c:v>1013.92</c:v>
                </c:pt>
                <c:pt idx="273">
                  <c:v>992.59900000000005</c:v>
                </c:pt>
                <c:pt idx="274">
                  <c:v>969.572</c:v>
                </c:pt>
                <c:pt idx="275">
                  <c:v>943.15599999999995</c:v>
                </c:pt>
                <c:pt idx="276">
                  <c:v>914.93600000000004</c:v>
                </c:pt>
                <c:pt idx="277">
                  <c:v>883.05200000000002</c:v>
                </c:pt>
                <c:pt idx="278">
                  <c:v>850.28399999999999</c:v>
                </c:pt>
                <c:pt idx="279">
                  <c:v>815.54200000000003</c:v>
                </c:pt>
                <c:pt idx="280">
                  <c:v>778.01199999999994</c:v>
                </c:pt>
                <c:pt idx="281">
                  <c:v>740</c:v>
                </c:pt>
                <c:pt idx="282">
                  <c:v>701.41600000000005</c:v>
                </c:pt>
                <c:pt idx="283">
                  <c:v>661.71699999999998</c:v>
                </c:pt>
                <c:pt idx="284">
                  <c:v>622.83299999999997</c:v>
                </c:pt>
                <c:pt idx="285">
                  <c:v>585.94500000000005</c:v>
                </c:pt>
                <c:pt idx="286">
                  <c:v>551.00699999999995</c:v>
                </c:pt>
                <c:pt idx="287">
                  <c:v>516.85699999999997</c:v>
                </c:pt>
                <c:pt idx="288">
                  <c:v>484.33800000000002</c:v>
                </c:pt>
                <c:pt idx="289">
                  <c:v>457.61799999999999</c:v>
                </c:pt>
                <c:pt idx="290">
                  <c:v>433.36200000000002</c:v>
                </c:pt>
                <c:pt idx="291">
                  <c:v>412.41500000000002</c:v>
                </c:pt>
                <c:pt idx="292">
                  <c:v>392.995</c:v>
                </c:pt>
                <c:pt idx="293">
                  <c:v>375.517</c:v>
                </c:pt>
                <c:pt idx="294">
                  <c:v>359.42500000000001</c:v>
                </c:pt>
                <c:pt idx="295">
                  <c:v>344.72199999999998</c:v>
                </c:pt>
                <c:pt idx="296">
                  <c:v>331.04700000000003</c:v>
                </c:pt>
                <c:pt idx="297">
                  <c:v>318.70299999999997</c:v>
                </c:pt>
                <c:pt idx="298">
                  <c:v>306.59500000000003</c:v>
                </c:pt>
                <c:pt idx="299">
                  <c:v>295.73399999999998</c:v>
                </c:pt>
                <c:pt idx="300">
                  <c:v>285.113</c:v>
                </c:pt>
                <c:pt idx="301">
                  <c:v>275.34399999999999</c:v>
                </c:pt>
                <c:pt idx="302">
                  <c:v>265.97899999999998</c:v>
                </c:pt>
                <c:pt idx="303">
                  <c:v>257.12099999999998</c:v>
                </c:pt>
                <c:pt idx="304">
                  <c:v>248.60400000000001</c:v>
                </c:pt>
                <c:pt idx="305">
                  <c:v>240.751</c:v>
                </c:pt>
                <c:pt idx="306">
                  <c:v>232.947</c:v>
                </c:pt>
                <c:pt idx="307">
                  <c:v>225.87</c:v>
                </c:pt>
                <c:pt idx="308">
                  <c:v>218.81399999999999</c:v>
                </c:pt>
                <c:pt idx="309">
                  <c:v>212.376</c:v>
                </c:pt>
                <c:pt idx="310">
                  <c:v>206.149</c:v>
                </c:pt>
                <c:pt idx="311">
                  <c:v>200.227</c:v>
                </c:pt>
                <c:pt idx="312">
                  <c:v>194.61699999999999</c:v>
                </c:pt>
                <c:pt idx="313">
                  <c:v>189.28800000000001</c:v>
                </c:pt>
                <c:pt idx="314">
                  <c:v>184.126</c:v>
                </c:pt>
                <c:pt idx="315">
                  <c:v>179.369</c:v>
                </c:pt>
                <c:pt idx="316">
                  <c:v>174.68700000000001</c:v>
                </c:pt>
                <c:pt idx="317">
                  <c:v>170.29900000000001</c:v>
                </c:pt>
                <c:pt idx="318">
                  <c:v>166.11</c:v>
                </c:pt>
                <c:pt idx="319">
                  <c:v>161.946</c:v>
                </c:pt>
                <c:pt idx="320">
                  <c:v>158.054</c:v>
                </c:pt>
                <c:pt idx="321">
                  <c:v>154.203</c:v>
                </c:pt>
                <c:pt idx="322">
                  <c:v>150.64699999999999</c:v>
                </c:pt>
                <c:pt idx="323">
                  <c:v>147.203</c:v>
                </c:pt>
                <c:pt idx="324">
                  <c:v>143.90799999999999</c:v>
                </c:pt>
                <c:pt idx="325">
                  <c:v>140.70599999999999</c:v>
                </c:pt>
                <c:pt idx="326">
                  <c:v>137.65</c:v>
                </c:pt>
                <c:pt idx="327">
                  <c:v>134.68899999999999</c:v>
                </c:pt>
                <c:pt idx="328">
                  <c:v>131.91499999999999</c:v>
                </c:pt>
                <c:pt idx="329">
                  <c:v>129.107</c:v>
                </c:pt>
                <c:pt idx="330">
                  <c:v>126.53700000000001</c:v>
                </c:pt>
                <c:pt idx="331">
                  <c:v>123.964</c:v>
                </c:pt>
                <c:pt idx="332">
                  <c:v>121.53</c:v>
                </c:pt>
                <c:pt idx="333">
                  <c:v>119.158</c:v>
                </c:pt>
                <c:pt idx="334">
                  <c:v>116.904</c:v>
                </c:pt>
                <c:pt idx="335">
                  <c:v>114.711</c:v>
                </c:pt>
                <c:pt idx="336">
                  <c:v>112.64</c:v>
                </c:pt>
                <c:pt idx="337">
                  <c:v>110.527</c:v>
                </c:pt>
                <c:pt idx="338">
                  <c:v>108.59399999999999</c:v>
                </c:pt>
                <c:pt idx="339">
                  <c:v>106.63500000000001</c:v>
                </c:pt>
                <c:pt idx="340">
                  <c:v>104.801</c:v>
                </c:pt>
                <c:pt idx="341">
                  <c:v>102.985</c:v>
                </c:pt>
                <c:pt idx="342">
                  <c:v>101.223</c:v>
                </c:pt>
                <c:pt idx="343">
                  <c:v>99.519000000000005</c:v>
                </c:pt>
                <c:pt idx="344">
                  <c:v>97.852999999999994</c:v>
                </c:pt>
                <c:pt idx="345">
                  <c:v>96.21</c:v>
                </c:pt>
                <c:pt idx="346">
                  <c:v>94.677000000000007</c:v>
                </c:pt>
                <c:pt idx="347">
                  <c:v>93.123999999999995</c:v>
                </c:pt>
                <c:pt idx="348">
                  <c:v>91.694999999999993</c:v>
                </c:pt>
                <c:pt idx="349">
                  <c:v>90.281999999999996</c:v>
                </c:pt>
                <c:pt idx="350">
                  <c:v>88.888000000000005</c:v>
                </c:pt>
                <c:pt idx="351">
                  <c:v>87.567999999999998</c:v>
                </c:pt>
                <c:pt idx="352">
                  <c:v>86.234999999999999</c:v>
                </c:pt>
                <c:pt idx="353">
                  <c:v>84.965000000000003</c:v>
                </c:pt>
                <c:pt idx="354">
                  <c:v>83.722999999999999</c:v>
                </c:pt>
                <c:pt idx="355">
                  <c:v>82.510999999999996</c:v>
                </c:pt>
                <c:pt idx="356">
                  <c:v>81.326999999999998</c:v>
                </c:pt>
                <c:pt idx="357">
                  <c:v>80.183000000000007</c:v>
                </c:pt>
                <c:pt idx="358">
                  <c:v>79.057000000000002</c:v>
                </c:pt>
                <c:pt idx="359">
                  <c:v>77.995999999999995</c:v>
                </c:pt>
                <c:pt idx="360">
                  <c:v>76.908000000000001</c:v>
                </c:pt>
                <c:pt idx="361">
                  <c:v>75.894999999999996</c:v>
                </c:pt>
                <c:pt idx="362">
                  <c:v>74.866</c:v>
                </c:pt>
                <c:pt idx="363">
                  <c:v>73.882000000000005</c:v>
                </c:pt>
                <c:pt idx="364">
                  <c:v>72.906000000000006</c:v>
                </c:pt>
                <c:pt idx="365">
                  <c:v>71.951999999999998</c:v>
                </c:pt>
                <c:pt idx="366">
                  <c:v>71.003</c:v>
                </c:pt>
                <c:pt idx="367">
                  <c:v>70.090999999999994</c:v>
                </c:pt>
                <c:pt idx="368">
                  <c:v>69.153000000000006</c:v>
                </c:pt>
                <c:pt idx="369">
                  <c:v>68.284000000000006</c:v>
                </c:pt>
                <c:pt idx="370">
                  <c:v>67.399000000000001</c:v>
                </c:pt>
                <c:pt idx="371">
                  <c:v>66.539000000000001</c:v>
                </c:pt>
                <c:pt idx="372">
                  <c:v>65.698999999999998</c:v>
                </c:pt>
                <c:pt idx="373">
                  <c:v>64.876000000000005</c:v>
                </c:pt>
                <c:pt idx="374">
                  <c:v>64.084000000000003</c:v>
                </c:pt>
                <c:pt idx="375">
                  <c:v>63.293999999999997</c:v>
                </c:pt>
                <c:pt idx="376">
                  <c:v>62.502000000000002</c:v>
                </c:pt>
                <c:pt idx="377">
                  <c:v>61.753</c:v>
                </c:pt>
                <c:pt idx="378">
                  <c:v>60.988999999999997</c:v>
                </c:pt>
                <c:pt idx="379">
                  <c:v>60.24</c:v>
                </c:pt>
                <c:pt idx="380">
                  <c:v>59.508000000000003</c:v>
                </c:pt>
                <c:pt idx="381">
                  <c:v>58.774000000000001</c:v>
                </c:pt>
                <c:pt idx="382">
                  <c:v>58.076000000000001</c:v>
                </c:pt>
                <c:pt idx="383">
                  <c:v>57.362000000000002</c:v>
                </c:pt>
                <c:pt idx="384">
                  <c:v>56.679000000000002</c:v>
                </c:pt>
                <c:pt idx="385">
                  <c:v>56.009</c:v>
                </c:pt>
                <c:pt idx="386">
                  <c:v>55.353999999999999</c:v>
                </c:pt>
                <c:pt idx="387">
                  <c:v>54.704999999999998</c:v>
                </c:pt>
                <c:pt idx="388">
                  <c:v>54.069000000000003</c:v>
                </c:pt>
                <c:pt idx="389">
                  <c:v>53.44</c:v>
                </c:pt>
                <c:pt idx="390">
                  <c:v>52.835999999999999</c:v>
                </c:pt>
                <c:pt idx="391">
                  <c:v>52.210999999999999</c:v>
                </c:pt>
                <c:pt idx="392">
                  <c:v>51.622</c:v>
                </c:pt>
                <c:pt idx="393">
                  <c:v>51.023000000000003</c:v>
                </c:pt>
                <c:pt idx="394">
                  <c:v>50.451999999999998</c:v>
                </c:pt>
                <c:pt idx="395">
                  <c:v>49.877000000000002</c:v>
                </c:pt>
                <c:pt idx="396">
                  <c:v>49.320999999999998</c:v>
                </c:pt>
                <c:pt idx="397">
                  <c:v>48.777000000000001</c:v>
                </c:pt>
                <c:pt idx="398">
                  <c:v>48.255000000000003</c:v>
                </c:pt>
                <c:pt idx="399">
                  <c:v>47.728000000000002</c:v>
                </c:pt>
                <c:pt idx="400">
                  <c:v>47.232999999999997</c:v>
                </c:pt>
                <c:pt idx="401">
                  <c:v>46.726999999999997</c:v>
                </c:pt>
                <c:pt idx="402">
                  <c:v>46.237000000000002</c:v>
                </c:pt>
                <c:pt idx="403">
                  <c:v>45.752000000000002</c:v>
                </c:pt>
                <c:pt idx="404">
                  <c:v>45.273000000000003</c:v>
                </c:pt>
                <c:pt idx="405">
                  <c:v>44.802999999999997</c:v>
                </c:pt>
                <c:pt idx="406">
                  <c:v>44.356999999999999</c:v>
                </c:pt>
                <c:pt idx="407">
                  <c:v>43.906999999999996</c:v>
                </c:pt>
                <c:pt idx="408">
                  <c:v>43.487000000000002</c:v>
                </c:pt>
                <c:pt idx="409">
                  <c:v>43.058999999999997</c:v>
                </c:pt>
                <c:pt idx="410">
                  <c:v>42.649000000000001</c:v>
                </c:pt>
                <c:pt idx="411">
                  <c:v>42.256</c:v>
                </c:pt>
                <c:pt idx="412">
                  <c:v>41.871000000000002</c:v>
                </c:pt>
                <c:pt idx="413">
                  <c:v>41.499000000000002</c:v>
                </c:pt>
                <c:pt idx="414">
                  <c:v>41.125</c:v>
                </c:pt>
                <c:pt idx="415">
                  <c:v>40.767000000000003</c:v>
                </c:pt>
                <c:pt idx="416">
                  <c:v>40.418999999999997</c:v>
                </c:pt>
                <c:pt idx="417">
                  <c:v>40.078000000000003</c:v>
                </c:pt>
                <c:pt idx="418">
                  <c:v>39.744999999999997</c:v>
                </c:pt>
                <c:pt idx="419">
                  <c:v>39.421999999999997</c:v>
                </c:pt>
                <c:pt idx="420">
                  <c:v>39.113</c:v>
                </c:pt>
                <c:pt idx="421">
                  <c:v>38.822000000000003</c:v>
                </c:pt>
                <c:pt idx="422">
                  <c:v>38.53</c:v>
                </c:pt>
                <c:pt idx="423">
                  <c:v>38.262999999999998</c:v>
                </c:pt>
                <c:pt idx="424">
                  <c:v>37.994</c:v>
                </c:pt>
                <c:pt idx="425">
                  <c:v>37.738999999999997</c:v>
                </c:pt>
                <c:pt idx="426">
                  <c:v>37.479999999999997</c:v>
                </c:pt>
                <c:pt idx="427">
                  <c:v>37.24</c:v>
                </c:pt>
                <c:pt idx="428">
                  <c:v>36.997</c:v>
                </c:pt>
                <c:pt idx="429">
                  <c:v>36.774999999999999</c:v>
                </c:pt>
                <c:pt idx="430">
                  <c:v>36.557000000000002</c:v>
                </c:pt>
                <c:pt idx="431">
                  <c:v>36.356999999999999</c:v>
                </c:pt>
                <c:pt idx="432">
                  <c:v>36.154000000000003</c:v>
                </c:pt>
                <c:pt idx="433">
                  <c:v>35.966000000000001</c:v>
                </c:pt>
                <c:pt idx="434">
                  <c:v>35.784999999999997</c:v>
                </c:pt>
                <c:pt idx="435">
                  <c:v>35.607999999999997</c:v>
                </c:pt>
                <c:pt idx="436">
                  <c:v>35.436999999999998</c:v>
                </c:pt>
                <c:pt idx="437">
                  <c:v>35.277999999999999</c:v>
                </c:pt>
                <c:pt idx="438">
                  <c:v>35.116</c:v>
                </c:pt>
                <c:pt idx="439">
                  <c:v>34.966999999999999</c:v>
                </c:pt>
                <c:pt idx="440">
                  <c:v>34.817</c:v>
                </c:pt>
                <c:pt idx="441">
                  <c:v>34.686</c:v>
                </c:pt>
                <c:pt idx="442">
                  <c:v>34.555999999999997</c:v>
                </c:pt>
                <c:pt idx="443">
                  <c:v>34.436999999999998</c:v>
                </c:pt>
                <c:pt idx="444">
                  <c:v>34.326999999999998</c:v>
                </c:pt>
                <c:pt idx="445">
                  <c:v>34.226999999999997</c:v>
                </c:pt>
                <c:pt idx="446">
                  <c:v>34.133000000000003</c:v>
                </c:pt>
                <c:pt idx="447">
                  <c:v>34.045000000000002</c:v>
                </c:pt>
                <c:pt idx="448">
                  <c:v>33.951000000000001</c:v>
                </c:pt>
                <c:pt idx="449">
                  <c:v>33.856999999999999</c:v>
                </c:pt>
                <c:pt idx="450">
                  <c:v>33.759</c:v>
                </c:pt>
                <c:pt idx="451">
                  <c:v>33.661999999999999</c:v>
                </c:pt>
                <c:pt idx="452">
                  <c:v>33.566000000000003</c:v>
                </c:pt>
                <c:pt idx="453">
                  <c:v>33.465000000000003</c:v>
                </c:pt>
                <c:pt idx="454">
                  <c:v>33.372999999999998</c:v>
                </c:pt>
                <c:pt idx="455">
                  <c:v>33.283999999999999</c:v>
                </c:pt>
                <c:pt idx="456">
                  <c:v>33.201000000000001</c:v>
                </c:pt>
                <c:pt idx="457">
                  <c:v>33.118000000000002</c:v>
                </c:pt>
                <c:pt idx="458">
                  <c:v>33.033000000000001</c:v>
                </c:pt>
                <c:pt idx="459">
                  <c:v>32.96</c:v>
                </c:pt>
                <c:pt idx="460">
                  <c:v>32.887999999999998</c:v>
                </c:pt>
                <c:pt idx="461">
                  <c:v>32.808</c:v>
                </c:pt>
                <c:pt idx="462">
                  <c:v>32.734999999999999</c:v>
                </c:pt>
                <c:pt idx="463">
                  <c:v>32.659999999999997</c:v>
                </c:pt>
                <c:pt idx="464">
                  <c:v>32.591999999999999</c:v>
                </c:pt>
                <c:pt idx="465">
                  <c:v>32.521000000000001</c:v>
                </c:pt>
                <c:pt idx="466">
                  <c:v>32.463999999999999</c:v>
                </c:pt>
                <c:pt idx="467">
                  <c:v>32.405999999999999</c:v>
                </c:pt>
                <c:pt idx="468">
                  <c:v>32.353999999999999</c:v>
                </c:pt>
                <c:pt idx="469">
                  <c:v>32.298000000000002</c:v>
                </c:pt>
                <c:pt idx="470">
                  <c:v>32.262</c:v>
                </c:pt>
                <c:pt idx="471">
                  <c:v>32.229999999999997</c:v>
                </c:pt>
                <c:pt idx="472">
                  <c:v>32.198999999999998</c:v>
                </c:pt>
                <c:pt idx="473">
                  <c:v>32.171999999999997</c:v>
                </c:pt>
                <c:pt idx="474">
                  <c:v>32.15</c:v>
                </c:pt>
                <c:pt idx="475">
                  <c:v>32.134999999999998</c:v>
                </c:pt>
                <c:pt idx="476">
                  <c:v>32.118000000000002</c:v>
                </c:pt>
                <c:pt idx="477">
                  <c:v>32.104999999999997</c:v>
                </c:pt>
                <c:pt idx="478">
                  <c:v>32.094000000000001</c:v>
                </c:pt>
                <c:pt idx="479">
                  <c:v>32.091000000000001</c:v>
                </c:pt>
                <c:pt idx="480">
                  <c:v>32.094000000000001</c:v>
                </c:pt>
                <c:pt idx="481">
                  <c:v>32.103999999999999</c:v>
                </c:pt>
                <c:pt idx="482">
                  <c:v>32.122999999999998</c:v>
                </c:pt>
                <c:pt idx="483">
                  <c:v>32.140999999999998</c:v>
                </c:pt>
                <c:pt idx="484">
                  <c:v>32.167999999999999</c:v>
                </c:pt>
                <c:pt idx="485">
                  <c:v>32.204000000000001</c:v>
                </c:pt>
                <c:pt idx="486">
                  <c:v>32.255000000000003</c:v>
                </c:pt>
                <c:pt idx="487">
                  <c:v>32.305999999999997</c:v>
                </c:pt>
                <c:pt idx="488">
                  <c:v>32.362000000000002</c:v>
                </c:pt>
                <c:pt idx="489">
                  <c:v>32.42</c:v>
                </c:pt>
                <c:pt idx="490">
                  <c:v>32.488999999999997</c:v>
                </c:pt>
                <c:pt idx="491">
                  <c:v>32.567</c:v>
                </c:pt>
                <c:pt idx="492">
                  <c:v>32.667000000000002</c:v>
                </c:pt>
                <c:pt idx="493">
                  <c:v>32.777000000000001</c:v>
                </c:pt>
                <c:pt idx="494">
                  <c:v>32.905999999999999</c:v>
                </c:pt>
                <c:pt idx="495">
                  <c:v>33.051000000000002</c:v>
                </c:pt>
                <c:pt idx="496">
                  <c:v>33.213999999999999</c:v>
                </c:pt>
                <c:pt idx="497">
                  <c:v>33.398000000000003</c:v>
                </c:pt>
                <c:pt idx="498">
                  <c:v>33.600999999999999</c:v>
                </c:pt>
                <c:pt idx="499">
                  <c:v>33.814</c:v>
                </c:pt>
                <c:pt idx="500">
                  <c:v>34.064</c:v>
                </c:pt>
                <c:pt idx="501">
                  <c:v>34.326000000000001</c:v>
                </c:pt>
                <c:pt idx="502">
                  <c:v>34.628</c:v>
                </c:pt>
                <c:pt idx="503">
                  <c:v>34.938000000000002</c:v>
                </c:pt>
                <c:pt idx="504">
                  <c:v>35.292999999999999</c:v>
                </c:pt>
                <c:pt idx="505">
                  <c:v>35.683999999999997</c:v>
                </c:pt>
                <c:pt idx="506">
                  <c:v>36.098999999999997</c:v>
                </c:pt>
                <c:pt idx="507">
                  <c:v>36.545999999999999</c:v>
                </c:pt>
                <c:pt idx="508">
                  <c:v>37.024999999999999</c:v>
                </c:pt>
                <c:pt idx="509">
                  <c:v>37.54</c:v>
                </c:pt>
                <c:pt idx="510">
                  <c:v>38.085000000000001</c:v>
                </c:pt>
                <c:pt idx="511">
                  <c:v>38.648000000000003</c:v>
                </c:pt>
                <c:pt idx="512">
                  <c:v>39.246000000000002</c:v>
                </c:pt>
                <c:pt idx="513">
                  <c:v>39.892000000000003</c:v>
                </c:pt>
                <c:pt idx="514">
                  <c:v>40.536000000000001</c:v>
                </c:pt>
                <c:pt idx="515">
                  <c:v>41.225000000000001</c:v>
                </c:pt>
                <c:pt idx="516">
                  <c:v>41.906999999999996</c:v>
                </c:pt>
                <c:pt idx="517">
                  <c:v>42.612000000000002</c:v>
                </c:pt>
                <c:pt idx="518">
                  <c:v>43.329000000000001</c:v>
                </c:pt>
                <c:pt idx="519">
                  <c:v>44.055</c:v>
                </c:pt>
                <c:pt idx="520">
                  <c:v>44.776000000000003</c:v>
                </c:pt>
                <c:pt idx="521">
                  <c:v>45.497</c:v>
                </c:pt>
                <c:pt idx="522">
                  <c:v>46.182000000000002</c:v>
                </c:pt>
                <c:pt idx="523">
                  <c:v>46.889000000000003</c:v>
                </c:pt>
                <c:pt idx="524">
                  <c:v>47.543999999999997</c:v>
                </c:pt>
                <c:pt idx="525">
                  <c:v>48.207000000000001</c:v>
                </c:pt>
                <c:pt idx="526">
                  <c:v>48.829000000000001</c:v>
                </c:pt>
                <c:pt idx="527">
                  <c:v>49.430999999999997</c:v>
                </c:pt>
                <c:pt idx="528">
                  <c:v>49.996000000000002</c:v>
                </c:pt>
                <c:pt idx="529">
                  <c:v>50.537999999999997</c:v>
                </c:pt>
                <c:pt idx="530">
                  <c:v>51.033999999999999</c:v>
                </c:pt>
                <c:pt idx="531">
                  <c:v>51.524999999999999</c:v>
                </c:pt>
                <c:pt idx="532">
                  <c:v>51.960999999999999</c:v>
                </c:pt>
                <c:pt idx="533">
                  <c:v>52.383000000000003</c:v>
                </c:pt>
                <c:pt idx="534">
                  <c:v>52.758000000000003</c:v>
                </c:pt>
                <c:pt idx="535">
                  <c:v>53.106000000000002</c:v>
                </c:pt>
                <c:pt idx="536">
                  <c:v>53.421999999999997</c:v>
                </c:pt>
                <c:pt idx="537">
                  <c:v>53.720999999999997</c:v>
                </c:pt>
                <c:pt idx="538">
                  <c:v>53.988999999999997</c:v>
                </c:pt>
                <c:pt idx="539">
                  <c:v>54.235999999999997</c:v>
                </c:pt>
                <c:pt idx="540">
                  <c:v>54.45</c:v>
                </c:pt>
                <c:pt idx="541">
                  <c:v>54.651000000000003</c:v>
                </c:pt>
                <c:pt idx="542">
                  <c:v>54.835000000000001</c:v>
                </c:pt>
                <c:pt idx="543">
                  <c:v>54.997999999999998</c:v>
                </c:pt>
                <c:pt idx="544">
                  <c:v>55.149000000000001</c:v>
                </c:pt>
                <c:pt idx="545">
                  <c:v>55.276000000000003</c:v>
                </c:pt>
                <c:pt idx="546">
                  <c:v>55.390999999999998</c:v>
                </c:pt>
                <c:pt idx="547">
                  <c:v>55.481000000000002</c:v>
                </c:pt>
                <c:pt idx="548">
                  <c:v>55.558999999999997</c:v>
                </c:pt>
                <c:pt idx="549">
                  <c:v>55.628999999999998</c:v>
                </c:pt>
                <c:pt idx="550">
                  <c:v>55.683</c:v>
                </c:pt>
                <c:pt idx="551">
                  <c:v>55.720999999999997</c:v>
                </c:pt>
                <c:pt idx="552">
                  <c:v>55.73</c:v>
                </c:pt>
                <c:pt idx="553">
                  <c:v>55.728000000000002</c:v>
                </c:pt>
                <c:pt idx="554">
                  <c:v>55.695999999999998</c:v>
                </c:pt>
                <c:pt idx="555">
                  <c:v>55.651000000000003</c:v>
                </c:pt>
                <c:pt idx="556">
                  <c:v>55.579000000000001</c:v>
                </c:pt>
                <c:pt idx="557">
                  <c:v>55.485999999999997</c:v>
                </c:pt>
                <c:pt idx="558">
                  <c:v>55.356000000000002</c:v>
                </c:pt>
                <c:pt idx="559">
                  <c:v>55.197000000000003</c:v>
                </c:pt>
                <c:pt idx="560">
                  <c:v>55.003</c:v>
                </c:pt>
                <c:pt idx="561">
                  <c:v>54.787999999999997</c:v>
                </c:pt>
                <c:pt idx="562">
                  <c:v>54.524999999999999</c:v>
                </c:pt>
                <c:pt idx="563">
                  <c:v>54.241</c:v>
                </c:pt>
                <c:pt idx="564">
                  <c:v>53.908000000000001</c:v>
                </c:pt>
                <c:pt idx="565">
                  <c:v>53.555</c:v>
                </c:pt>
                <c:pt idx="566">
                  <c:v>53.158999999999999</c:v>
                </c:pt>
                <c:pt idx="567">
                  <c:v>52.722000000000001</c:v>
                </c:pt>
                <c:pt idx="568">
                  <c:v>52.246000000000002</c:v>
                </c:pt>
                <c:pt idx="569">
                  <c:v>51.753</c:v>
                </c:pt>
                <c:pt idx="570">
                  <c:v>51.206000000000003</c:v>
                </c:pt>
                <c:pt idx="571">
                  <c:v>50.636000000000003</c:v>
                </c:pt>
                <c:pt idx="572">
                  <c:v>50.005000000000003</c:v>
                </c:pt>
                <c:pt idx="573">
                  <c:v>49.374000000000002</c:v>
                </c:pt>
                <c:pt idx="574">
                  <c:v>48.710999999999999</c:v>
                </c:pt>
                <c:pt idx="575">
                  <c:v>48.012</c:v>
                </c:pt>
                <c:pt idx="576">
                  <c:v>47.320999999999998</c:v>
                </c:pt>
                <c:pt idx="577">
                  <c:v>46.594999999999999</c:v>
                </c:pt>
                <c:pt idx="578">
                  <c:v>45.868000000000002</c:v>
                </c:pt>
                <c:pt idx="579">
                  <c:v>45.134</c:v>
                </c:pt>
                <c:pt idx="580">
                  <c:v>44.393000000000001</c:v>
                </c:pt>
                <c:pt idx="581">
                  <c:v>43.661000000000001</c:v>
                </c:pt>
                <c:pt idx="582">
                  <c:v>42.933999999999997</c:v>
                </c:pt>
                <c:pt idx="583">
                  <c:v>42.2</c:v>
                </c:pt>
                <c:pt idx="584">
                  <c:v>41.494</c:v>
                </c:pt>
                <c:pt idx="585">
                  <c:v>40.76</c:v>
                </c:pt>
                <c:pt idx="586">
                  <c:v>40.073999999999998</c:v>
                </c:pt>
                <c:pt idx="587">
                  <c:v>39.39</c:v>
                </c:pt>
                <c:pt idx="588">
                  <c:v>38.728000000000002</c:v>
                </c:pt>
                <c:pt idx="589">
                  <c:v>38.079000000000001</c:v>
                </c:pt>
                <c:pt idx="590">
                  <c:v>37.456000000000003</c:v>
                </c:pt>
                <c:pt idx="591">
                  <c:v>36.856999999999999</c:v>
                </c:pt>
                <c:pt idx="592">
                  <c:v>36.292000000000002</c:v>
                </c:pt>
                <c:pt idx="593">
                  <c:v>35.718000000000004</c:v>
                </c:pt>
                <c:pt idx="594">
                  <c:v>35.19</c:v>
                </c:pt>
                <c:pt idx="595">
                  <c:v>34.673999999999999</c:v>
                </c:pt>
                <c:pt idx="596">
                  <c:v>34.192999999999998</c:v>
                </c:pt>
                <c:pt idx="597">
                  <c:v>33.72</c:v>
                </c:pt>
                <c:pt idx="598">
                  <c:v>33.270000000000003</c:v>
                </c:pt>
                <c:pt idx="599">
                  <c:v>32.832999999999998</c:v>
                </c:pt>
                <c:pt idx="600">
                  <c:v>32.430999999999997</c:v>
                </c:pt>
                <c:pt idx="601">
                  <c:v>32.027000000000001</c:v>
                </c:pt>
                <c:pt idx="602">
                  <c:v>31.655999999999999</c:v>
                </c:pt>
                <c:pt idx="603">
                  <c:v>31.279</c:v>
                </c:pt>
                <c:pt idx="604">
                  <c:v>30.946000000000002</c:v>
                </c:pt>
                <c:pt idx="605">
                  <c:v>30.626999999999999</c:v>
                </c:pt>
                <c:pt idx="606">
                  <c:v>30.317</c:v>
                </c:pt>
                <c:pt idx="607">
                  <c:v>30.024000000000001</c:v>
                </c:pt>
                <c:pt idx="608">
                  <c:v>29.738</c:v>
                </c:pt>
                <c:pt idx="609">
                  <c:v>29.469000000000001</c:v>
                </c:pt>
                <c:pt idx="610">
                  <c:v>29.212</c:v>
                </c:pt>
                <c:pt idx="611">
                  <c:v>28.963000000000001</c:v>
                </c:pt>
                <c:pt idx="612">
                  <c:v>28.721</c:v>
                </c:pt>
                <c:pt idx="613">
                  <c:v>28.48</c:v>
                </c:pt>
                <c:pt idx="614">
                  <c:v>28.245999999999999</c:v>
                </c:pt>
                <c:pt idx="615">
                  <c:v>28.018000000000001</c:v>
                </c:pt>
                <c:pt idx="616">
                  <c:v>27.791</c:v>
                </c:pt>
                <c:pt idx="617">
                  <c:v>27.568999999999999</c:v>
                </c:pt>
                <c:pt idx="618">
                  <c:v>27.341999999999999</c:v>
                </c:pt>
                <c:pt idx="619">
                  <c:v>27.102</c:v>
                </c:pt>
                <c:pt idx="620">
                  <c:v>26.861000000000001</c:v>
                </c:pt>
                <c:pt idx="621">
                  <c:v>26.611999999999998</c:v>
                </c:pt>
                <c:pt idx="622">
                  <c:v>26.361999999999998</c:v>
                </c:pt>
                <c:pt idx="623">
                  <c:v>26.111000000000001</c:v>
                </c:pt>
                <c:pt idx="624">
                  <c:v>25.843</c:v>
                </c:pt>
                <c:pt idx="625">
                  <c:v>25.582000000000001</c:v>
                </c:pt>
                <c:pt idx="626">
                  <c:v>25.308</c:v>
                </c:pt>
                <c:pt idx="627">
                  <c:v>25.029</c:v>
                </c:pt>
                <c:pt idx="628">
                  <c:v>24.744</c:v>
                </c:pt>
                <c:pt idx="629">
                  <c:v>24.46</c:v>
                </c:pt>
                <c:pt idx="630">
                  <c:v>24.175000000000001</c:v>
                </c:pt>
                <c:pt idx="631">
                  <c:v>23.890999999999998</c:v>
                </c:pt>
                <c:pt idx="632">
                  <c:v>23.591000000000001</c:v>
                </c:pt>
                <c:pt idx="633">
                  <c:v>23.300999999999998</c:v>
                </c:pt>
                <c:pt idx="634">
                  <c:v>23.02</c:v>
                </c:pt>
                <c:pt idx="635">
                  <c:v>22.731999999999999</c:v>
                </c:pt>
                <c:pt idx="636">
                  <c:v>22.452999999999999</c:v>
                </c:pt>
                <c:pt idx="637">
                  <c:v>22.158000000000001</c:v>
                </c:pt>
                <c:pt idx="638">
                  <c:v>21.885000000000002</c:v>
                </c:pt>
                <c:pt idx="639">
                  <c:v>21.620999999999999</c:v>
                </c:pt>
                <c:pt idx="640">
                  <c:v>21.364000000000001</c:v>
                </c:pt>
                <c:pt idx="641">
                  <c:v>21.108000000000001</c:v>
                </c:pt>
                <c:pt idx="642">
                  <c:v>20.852</c:v>
                </c:pt>
                <c:pt idx="643">
                  <c:v>20.596</c:v>
                </c:pt>
                <c:pt idx="644">
                  <c:v>20.355</c:v>
                </c:pt>
                <c:pt idx="645">
                  <c:v>20.116</c:v>
                </c:pt>
                <c:pt idx="646">
                  <c:v>19.902999999999999</c:v>
                </c:pt>
                <c:pt idx="647">
                  <c:v>19.672999999999998</c:v>
                </c:pt>
                <c:pt idx="648">
                  <c:v>19.454000000000001</c:v>
                </c:pt>
                <c:pt idx="649">
                  <c:v>19.225999999999999</c:v>
                </c:pt>
                <c:pt idx="650">
                  <c:v>19.007000000000001</c:v>
                </c:pt>
                <c:pt idx="651">
                  <c:v>18.776</c:v>
                </c:pt>
                <c:pt idx="652">
                  <c:v>18.545999999999999</c:v>
                </c:pt>
                <c:pt idx="653">
                  <c:v>18.315000000000001</c:v>
                </c:pt>
                <c:pt idx="654">
                  <c:v>18.085000000000001</c:v>
                </c:pt>
                <c:pt idx="655">
                  <c:v>17.838000000000001</c:v>
                </c:pt>
                <c:pt idx="656">
                  <c:v>17.603999999999999</c:v>
                </c:pt>
                <c:pt idx="657">
                  <c:v>17.364999999999998</c:v>
                </c:pt>
                <c:pt idx="658">
                  <c:v>17.129000000000001</c:v>
                </c:pt>
                <c:pt idx="659">
                  <c:v>16.884</c:v>
                </c:pt>
                <c:pt idx="660">
                  <c:v>16.643000000000001</c:v>
                </c:pt>
                <c:pt idx="661">
                  <c:v>16.401</c:v>
                </c:pt>
                <c:pt idx="662">
                  <c:v>16.163</c:v>
                </c:pt>
                <c:pt idx="663">
                  <c:v>15.909000000000001</c:v>
                </c:pt>
                <c:pt idx="664">
                  <c:v>15.661</c:v>
                </c:pt>
                <c:pt idx="665">
                  <c:v>15.4</c:v>
                </c:pt>
                <c:pt idx="666">
                  <c:v>15.135999999999999</c:v>
                </c:pt>
                <c:pt idx="667">
                  <c:v>14.87</c:v>
                </c:pt>
                <c:pt idx="668">
                  <c:v>14.601000000000001</c:v>
                </c:pt>
                <c:pt idx="669">
                  <c:v>14.332000000000001</c:v>
                </c:pt>
                <c:pt idx="670">
                  <c:v>14.054</c:v>
                </c:pt>
                <c:pt idx="671">
                  <c:v>13.775</c:v>
                </c:pt>
                <c:pt idx="672">
                  <c:v>13.494999999999999</c:v>
                </c:pt>
                <c:pt idx="673">
                  <c:v>13.209</c:v>
                </c:pt>
                <c:pt idx="674">
                  <c:v>12.926</c:v>
                </c:pt>
                <c:pt idx="675">
                  <c:v>12.648</c:v>
                </c:pt>
                <c:pt idx="676">
                  <c:v>12.369</c:v>
                </c:pt>
                <c:pt idx="677">
                  <c:v>12.101000000000001</c:v>
                </c:pt>
                <c:pt idx="678">
                  <c:v>11.821</c:v>
                </c:pt>
                <c:pt idx="679">
                  <c:v>11.555</c:v>
                </c:pt>
                <c:pt idx="680">
                  <c:v>11.292</c:v>
                </c:pt>
                <c:pt idx="681">
                  <c:v>11.034000000000001</c:v>
                </c:pt>
                <c:pt idx="682">
                  <c:v>10.776</c:v>
                </c:pt>
                <c:pt idx="683">
                  <c:v>10.525</c:v>
                </c:pt>
                <c:pt idx="684">
                  <c:v>10.288</c:v>
                </c:pt>
                <c:pt idx="685">
                  <c:v>10.061999999999999</c:v>
                </c:pt>
                <c:pt idx="686">
                  <c:v>9.83</c:v>
                </c:pt>
                <c:pt idx="687">
                  <c:v>9.6080000000000005</c:v>
                </c:pt>
                <c:pt idx="688">
                  <c:v>9.391</c:v>
                </c:pt>
                <c:pt idx="689">
                  <c:v>9.19</c:v>
                </c:pt>
                <c:pt idx="690">
                  <c:v>8.9930000000000003</c:v>
                </c:pt>
                <c:pt idx="691">
                  <c:v>8.8049999999999997</c:v>
                </c:pt>
                <c:pt idx="692">
                  <c:v>8.6150000000000002</c:v>
                </c:pt>
                <c:pt idx="693">
                  <c:v>8.4359999999999999</c:v>
                </c:pt>
                <c:pt idx="694">
                  <c:v>8.2609999999999992</c:v>
                </c:pt>
                <c:pt idx="695">
                  <c:v>8.1080000000000005</c:v>
                </c:pt>
                <c:pt idx="696">
                  <c:v>7.9580000000000002</c:v>
                </c:pt>
                <c:pt idx="697">
                  <c:v>7.8090000000000002</c:v>
                </c:pt>
                <c:pt idx="698">
                  <c:v>7.6580000000000004</c:v>
                </c:pt>
                <c:pt idx="699">
                  <c:v>7.52</c:v>
                </c:pt>
                <c:pt idx="700">
                  <c:v>7.3869999999999996</c:v>
                </c:pt>
                <c:pt idx="701">
                  <c:v>7.2629999999999999</c:v>
                </c:pt>
                <c:pt idx="702">
                  <c:v>7.1280000000000001</c:v>
                </c:pt>
                <c:pt idx="703">
                  <c:v>7.01</c:v>
                </c:pt>
                <c:pt idx="704">
                  <c:v>6.8920000000000003</c:v>
                </c:pt>
                <c:pt idx="705">
                  <c:v>6.7830000000000004</c:v>
                </c:pt>
                <c:pt idx="706">
                  <c:v>6.6749999999999998</c:v>
                </c:pt>
                <c:pt idx="707">
                  <c:v>6.5720000000000001</c:v>
                </c:pt>
                <c:pt idx="708">
                  <c:v>6.484</c:v>
                </c:pt>
                <c:pt idx="709">
                  <c:v>6.3940000000000001</c:v>
                </c:pt>
                <c:pt idx="710">
                  <c:v>6.306</c:v>
                </c:pt>
                <c:pt idx="711">
                  <c:v>6.2169999999999996</c:v>
                </c:pt>
                <c:pt idx="712">
                  <c:v>6.133</c:v>
                </c:pt>
                <c:pt idx="713">
                  <c:v>6.0510000000000002</c:v>
                </c:pt>
                <c:pt idx="714">
                  <c:v>5.9690000000000003</c:v>
                </c:pt>
                <c:pt idx="715">
                  <c:v>5.8920000000000003</c:v>
                </c:pt>
                <c:pt idx="716">
                  <c:v>5.8170000000000002</c:v>
                </c:pt>
                <c:pt idx="717">
                  <c:v>5.7469999999999999</c:v>
                </c:pt>
                <c:pt idx="718">
                  <c:v>5.6790000000000003</c:v>
                </c:pt>
                <c:pt idx="719">
                  <c:v>5.6059999999999999</c:v>
                </c:pt>
                <c:pt idx="720">
                  <c:v>5.5330000000000004</c:v>
                </c:pt>
                <c:pt idx="721">
                  <c:v>5.4539999999999997</c:v>
                </c:pt>
                <c:pt idx="722">
                  <c:v>5.3710000000000004</c:v>
                </c:pt>
                <c:pt idx="723">
                  <c:v>5.29</c:v>
                </c:pt>
                <c:pt idx="724">
                  <c:v>5.2119999999999997</c:v>
                </c:pt>
                <c:pt idx="725">
                  <c:v>5.1269999999999998</c:v>
                </c:pt>
                <c:pt idx="726">
                  <c:v>5.0449999999999999</c:v>
                </c:pt>
                <c:pt idx="727">
                  <c:v>4.9539999999999997</c:v>
                </c:pt>
                <c:pt idx="728">
                  <c:v>4.8659999999999997</c:v>
                </c:pt>
                <c:pt idx="729">
                  <c:v>4.7880000000000003</c:v>
                </c:pt>
                <c:pt idx="730">
                  <c:v>4.7069999999999999</c:v>
                </c:pt>
                <c:pt idx="731">
                  <c:v>4.6289999999999996</c:v>
                </c:pt>
                <c:pt idx="732">
                  <c:v>4.55</c:v>
                </c:pt>
                <c:pt idx="733">
                  <c:v>4.4710000000000001</c:v>
                </c:pt>
                <c:pt idx="734">
                  <c:v>4.3979999999999997</c:v>
                </c:pt>
                <c:pt idx="735">
                  <c:v>4.3259999999999996</c:v>
                </c:pt>
                <c:pt idx="736">
                  <c:v>4.2590000000000003</c:v>
                </c:pt>
                <c:pt idx="737">
                  <c:v>4.1920000000000002</c:v>
                </c:pt>
                <c:pt idx="738">
                  <c:v>4.1260000000000003</c:v>
                </c:pt>
                <c:pt idx="739">
                  <c:v>4.0670000000000002</c:v>
                </c:pt>
                <c:pt idx="740">
                  <c:v>3.9980000000000002</c:v>
                </c:pt>
                <c:pt idx="741">
                  <c:v>3.9340000000000002</c:v>
                </c:pt>
                <c:pt idx="742">
                  <c:v>3.87</c:v>
                </c:pt>
                <c:pt idx="743">
                  <c:v>3.8130000000000002</c:v>
                </c:pt>
                <c:pt idx="744">
                  <c:v>3.7530000000000001</c:v>
                </c:pt>
                <c:pt idx="745">
                  <c:v>3.698</c:v>
                </c:pt>
                <c:pt idx="746">
                  <c:v>3.641</c:v>
                </c:pt>
                <c:pt idx="747">
                  <c:v>3.5920000000000001</c:v>
                </c:pt>
                <c:pt idx="748">
                  <c:v>3.5419999999999998</c:v>
                </c:pt>
                <c:pt idx="749">
                  <c:v>3.4940000000000002</c:v>
                </c:pt>
                <c:pt idx="750">
                  <c:v>3.4550000000000001</c:v>
                </c:pt>
                <c:pt idx="751">
                  <c:v>3.411</c:v>
                </c:pt>
                <c:pt idx="752">
                  <c:v>3.3730000000000002</c:v>
                </c:pt>
                <c:pt idx="753">
                  <c:v>3.33</c:v>
                </c:pt>
                <c:pt idx="754">
                  <c:v>3.2970000000000002</c:v>
                </c:pt>
                <c:pt idx="755">
                  <c:v>3.2639999999999998</c:v>
                </c:pt>
                <c:pt idx="756">
                  <c:v>3.2320000000000002</c:v>
                </c:pt>
                <c:pt idx="757">
                  <c:v>3.2</c:v>
                </c:pt>
                <c:pt idx="758">
                  <c:v>3.1720000000000002</c:v>
                </c:pt>
                <c:pt idx="759">
                  <c:v>3.1469999999999998</c:v>
                </c:pt>
                <c:pt idx="760">
                  <c:v>3.1219999999999999</c:v>
                </c:pt>
                <c:pt idx="761">
                  <c:v>3.0939999999999999</c:v>
                </c:pt>
                <c:pt idx="762">
                  <c:v>3.0630000000000002</c:v>
                </c:pt>
                <c:pt idx="763">
                  <c:v>3.0409999999999999</c:v>
                </c:pt>
                <c:pt idx="764">
                  <c:v>3.016</c:v>
                </c:pt>
                <c:pt idx="765">
                  <c:v>2.996</c:v>
                </c:pt>
                <c:pt idx="766">
                  <c:v>2.9689999999999999</c:v>
                </c:pt>
                <c:pt idx="767">
                  <c:v>2.9489999999999998</c:v>
                </c:pt>
                <c:pt idx="768">
                  <c:v>2.9319999999999999</c:v>
                </c:pt>
                <c:pt idx="769">
                  <c:v>2.9180000000000001</c:v>
                </c:pt>
                <c:pt idx="770">
                  <c:v>2.899</c:v>
                </c:pt>
                <c:pt idx="771">
                  <c:v>2.8849999999999998</c:v>
                </c:pt>
                <c:pt idx="772">
                  <c:v>2.8639999999999999</c:v>
                </c:pt>
                <c:pt idx="773">
                  <c:v>2.8479999999999999</c:v>
                </c:pt>
                <c:pt idx="774">
                  <c:v>2.83</c:v>
                </c:pt>
                <c:pt idx="775">
                  <c:v>2.8130000000000002</c:v>
                </c:pt>
                <c:pt idx="776">
                  <c:v>2.8029999999999999</c:v>
                </c:pt>
                <c:pt idx="777">
                  <c:v>2.7879999999999998</c:v>
                </c:pt>
                <c:pt idx="778">
                  <c:v>2.7759999999999998</c:v>
                </c:pt>
                <c:pt idx="779">
                  <c:v>2.7629999999999999</c:v>
                </c:pt>
                <c:pt idx="780">
                  <c:v>2.7559999999999998</c:v>
                </c:pt>
                <c:pt idx="781">
                  <c:v>2.7450000000000001</c:v>
                </c:pt>
                <c:pt idx="782">
                  <c:v>2.734</c:v>
                </c:pt>
                <c:pt idx="783">
                  <c:v>2.72</c:v>
                </c:pt>
                <c:pt idx="784">
                  <c:v>2.7130000000000001</c:v>
                </c:pt>
                <c:pt idx="785">
                  <c:v>2.7</c:v>
                </c:pt>
                <c:pt idx="786">
                  <c:v>2.6890000000000001</c:v>
                </c:pt>
                <c:pt idx="787">
                  <c:v>2.677</c:v>
                </c:pt>
                <c:pt idx="788">
                  <c:v>2.6669999999999998</c:v>
                </c:pt>
                <c:pt idx="789">
                  <c:v>2.6579999999999999</c:v>
                </c:pt>
                <c:pt idx="790">
                  <c:v>2.6480000000000001</c:v>
                </c:pt>
                <c:pt idx="791">
                  <c:v>2.6389999999999998</c:v>
                </c:pt>
                <c:pt idx="792">
                  <c:v>2.6280000000000001</c:v>
                </c:pt>
                <c:pt idx="793">
                  <c:v>2.6160000000000001</c:v>
                </c:pt>
                <c:pt idx="794">
                  <c:v>2.6070000000000002</c:v>
                </c:pt>
                <c:pt idx="795">
                  <c:v>2.5979999999999999</c:v>
                </c:pt>
                <c:pt idx="796">
                  <c:v>2.593</c:v>
                </c:pt>
                <c:pt idx="797">
                  <c:v>2.581</c:v>
                </c:pt>
                <c:pt idx="798">
                  <c:v>2.5659999999999998</c:v>
                </c:pt>
                <c:pt idx="799">
                  <c:v>2.552</c:v>
                </c:pt>
                <c:pt idx="800">
                  <c:v>2.5449999999999999</c:v>
                </c:pt>
                <c:pt idx="801">
                  <c:v>2.5350000000000001</c:v>
                </c:pt>
                <c:pt idx="802">
                  <c:v>2.5230000000000001</c:v>
                </c:pt>
                <c:pt idx="803">
                  <c:v>2.508</c:v>
                </c:pt>
                <c:pt idx="804">
                  <c:v>2.4940000000000002</c:v>
                </c:pt>
                <c:pt idx="805">
                  <c:v>2.4889999999999999</c:v>
                </c:pt>
                <c:pt idx="806">
                  <c:v>2.48</c:v>
                </c:pt>
                <c:pt idx="807">
                  <c:v>2.472</c:v>
                </c:pt>
                <c:pt idx="808">
                  <c:v>2.46</c:v>
                </c:pt>
                <c:pt idx="809">
                  <c:v>2.4489999999999998</c:v>
                </c:pt>
                <c:pt idx="810">
                  <c:v>2.4350000000000001</c:v>
                </c:pt>
                <c:pt idx="811">
                  <c:v>2.4260000000000002</c:v>
                </c:pt>
                <c:pt idx="812">
                  <c:v>2.4129999999999998</c:v>
                </c:pt>
                <c:pt idx="813">
                  <c:v>2.399</c:v>
                </c:pt>
                <c:pt idx="814">
                  <c:v>2.387</c:v>
                </c:pt>
                <c:pt idx="815">
                  <c:v>2.3740000000000001</c:v>
                </c:pt>
                <c:pt idx="816">
                  <c:v>2.36</c:v>
                </c:pt>
                <c:pt idx="817">
                  <c:v>2.3490000000000002</c:v>
                </c:pt>
                <c:pt idx="818">
                  <c:v>2.3420000000000001</c:v>
                </c:pt>
                <c:pt idx="819">
                  <c:v>2.3340000000000001</c:v>
                </c:pt>
                <c:pt idx="820">
                  <c:v>2.3199999999999998</c:v>
                </c:pt>
                <c:pt idx="821">
                  <c:v>2.3090000000000002</c:v>
                </c:pt>
                <c:pt idx="822">
                  <c:v>2.2989999999999999</c:v>
                </c:pt>
                <c:pt idx="823">
                  <c:v>2.29</c:v>
                </c:pt>
                <c:pt idx="824">
                  <c:v>2.2789999999999999</c:v>
                </c:pt>
                <c:pt idx="825">
                  <c:v>2.2719999999999998</c:v>
                </c:pt>
                <c:pt idx="826">
                  <c:v>2.2629999999999999</c:v>
                </c:pt>
                <c:pt idx="827">
                  <c:v>2.254</c:v>
                </c:pt>
                <c:pt idx="828">
                  <c:v>2.2400000000000002</c:v>
                </c:pt>
                <c:pt idx="829">
                  <c:v>2.2290000000000001</c:v>
                </c:pt>
                <c:pt idx="830">
                  <c:v>2.2200000000000002</c:v>
                </c:pt>
                <c:pt idx="831">
                  <c:v>2.2149999999999999</c:v>
                </c:pt>
                <c:pt idx="832">
                  <c:v>2.2050000000000001</c:v>
                </c:pt>
                <c:pt idx="833">
                  <c:v>2.1970000000000001</c:v>
                </c:pt>
                <c:pt idx="834">
                  <c:v>2.1859999999999999</c:v>
                </c:pt>
                <c:pt idx="835">
                  <c:v>2.177</c:v>
                </c:pt>
                <c:pt idx="836">
                  <c:v>2.1669999999999998</c:v>
                </c:pt>
                <c:pt idx="837">
                  <c:v>2.1589999999999998</c:v>
                </c:pt>
                <c:pt idx="838">
                  <c:v>2.1469999999999998</c:v>
                </c:pt>
                <c:pt idx="839">
                  <c:v>2.1320000000000001</c:v>
                </c:pt>
                <c:pt idx="840">
                  <c:v>2.1259999999999999</c:v>
                </c:pt>
                <c:pt idx="841">
                  <c:v>2.125</c:v>
                </c:pt>
                <c:pt idx="842">
                  <c:v>2.1240000000000001</c:v>
                </c:pt>
                <c:pt idx="843">
                  <c:v>2.113</c:v>
                </c:pt>
                <c:pt idx="844">
                  <c:v>2.101</c:v>
                </c:pt>
                <c:pt idx="845">
                  <c:v>2.09</c:v>
                </c:pt>
                <c:pt idx="846">
                  <c:v>2.0830000000000002</c:v>
                </c:pt>
                <c:pt idx="847">
                  <c:v>2.0750000000000002</c:v>
                </c:pt>
                <c:pt idx="848">
                  <c:v>2.0680000000000001</c:v>
                </c:pt>
                <c:pt idx="849">
                  <c:v>2.0419999999999998</c:v>
                </c:pt>
                <c:pt idx="850">
                  <c:v>2.0270000000000001</c:v>
                </c:pt>
                <c:pt idx="851">
                  <c:v>2.024</c:v>
                </c:pt>
                <c:pt idx="852">
                  <c:v>2.0379999999999998</c:v>
                </c:pt>
                <c:pt idx="853">
                  <c:v>2.0449999999999999</c:v>
                </c:pt>
                <c:pt idx="854">
                  <c:v>2.0350000000000001</c:v>
                </c:pt>
                <c:pt idx="855">
                  <c:v>2.0209999999999999</c:v>
                </c:pt>
                <c:pt idx="856">
                  <c:v>2.016</c:v>
                </c:pt>
                <c:pt idx="857">
                  <c:v>2.008</c:v>
                </c:pt>
                <c:pt idx="858">
                  <c:v>2.0030000000000001</c:v>
                </c:pt>
                <c:pt idx="859">
                  <c:v>1.998</c:v>
                </c:pt>
                <c:pt idx="860">
                  <c:v>1.9910000000000001</c:v>
                </c:pt>
                <c:pt idx="861">
                  <c:v>1.988</c:v>
                </c:pt>
                <c:pt idx="862">
                  <c:v>1.9910000000000001</c:v>
                </c:pt>
                <c:pt idx="863">
                  <c:v>1.9910000000000001</c:v>
                </c:pt>
                <c:pt idx="864">
                  <c:v>1.9850000000000001</c:v>
                </c:pt>
                <c:pt idx="865">
                  <c:v>1.974</c:v>
                </c:pt>
                <c:pt idx="866">
                  <c:v>1.972</c:v>
                </c:pt>
                <c:pt idx="867">
                  <c:v>1.976</c:v>
                </c:pt>
                <c:pt idx="868">
                  <c:v>1.9750000000000001</c:v>
                </c:pt>
                <c:pt idx="869">
                  <c:v>1.9650000000000001</c:v>
                </c:pt>
                <c:pt idx="870">
                  <c:v>1.9570000000000001</c:v>
                </c:pt>
                <c:pt idx="871">
                  <c:v>1.954</c:v>
                </c:pt>
                <c:pt idx="872">
                  <c:v>1.958</c:v>
                </c:pt>
                <c:pt idx="873">
                  <c:v>1.9510000000000001</c:v>
                </c:pt>
                <c:pt idx="874">
                  <c:v>1.9530000000000001</c:v>
                </c:pt>
                <c:pt idx="875">
                  <c:v>1.946</c:v>
                </c:pt>
                <c:pt idx="876">
                  <c:v>1.946</c:v>
                </c:pt>
                <c:pt idx="877">
                  <c:v>1.9490000000000001</c:v>
                </c:pt>
                <c:pt idx="878">
                  <c:v>1.952</c:v>
                </c:pt>
                <c:pt idx="879">
                  <c:v>1.9510000000000001</c:v>
                </c:pt>
                <c:pt idx="880">
                  <c:v>1.946</c:v>
                </c:pt>
                <c:pt idx="881">
                  <c:v>1.94</c:v>
                </c:pt>
                <c:pt idx="882">
                  <c:v>1.9330000000000001</c:v>
                </c:pt>
                <c:pt idx="883">
                  <c:v>1.9359999999999999</c:v>
                </c:pt>
                <c:pt idx="884">
                  <c:v>1.9370000000000001</c:v>
                </c:pt>
                <c:pt idx="885">
                  <c:v>1.9379999999999999</c:v>
                </c:pt>
                <c:pt idx="886">
                  <c:v>1.9350000000000001</c:v>
                </c:pt>
                <c:pt idx="887">
                  <c:v>1.93</c:v>
                </c:pt>
                <c:pt idx="888">
                  <c:v>1.929</c:v>
                </c:pt>
                <c:pt idx="889">
                  <c:v>1.927</c:v>
                </c:pt>
                <c:pt idx="890">
                  <c:v>1.929</c:v>
                </c:pt>
                <c:pt idx="891">
                  <c:v>1.9279999999999999</c:v>
                </c:pt>
                <c:pt idx="892">
                  <c:v>1.9219999999999999</c:v>
                </c:pt>
                <c:pt idx="893">
                  <c:v>1.92</c:v>
                </c:pt>
                <c:pt idx="894">
                  <c:v>1.917</c:v>
                </c:pt>
                <c:pt idx="895">
                  <c:v>1.9079999999999999</c:v>
                </c:pt>
                <c:pt idx="896">
                  <c:v>1.9019999999999999</c:v>
                </c:pt>
                <c:pt idx="897">
                  <c:v>1.895</c:v>
                </c:pt>
                <c:pt idx="898">
                  <c:v>1.8959999999999999</c:v>
                </c:pt>
                <c:pt idx="899">
                  <c:v>1.89</c:v>
                </c:pt>
                <c:pt idx="900">
                  <c:v>1.8839999999999999</c:v>
                </c:pt>
                <c:pt idx="901">
                  <c:v>1.877</c:v>
                </c:pt>
                <c:pt idx="902">
                  <c:v>1.8680000000000001</c:v>
                </c:pt>
                <c:pt idx="903">
                  <c:v>1.86</c:v>
                </c:pt>
                <c:pt idx="904">
                  <c:v>1.8520000000000001</c:v>
                </c:pt>
                <c:pt idx="905">
                  <c:v>1.8460000000000001</c:v>
                </c:pt>
                <c:pt idx="906">
                  <c:v>1.84</c:v>
                </c:pt>
                <c:pt idx="907">
                  <c:v>1.8340000000000001</c:v>
                </c:pt>
                <c:pt idx="908">
                  <c:v>1.8260000000000001</c:v>
                </c:pt>
                <c:pt idx="909">
                  <c:v>1.8169999999999999</c:v>
                </c:pt>
                <c:pt idx="910">
                  <c:v>1.8169999999999999</c:v>
                </c:pt>
                <c:pt idx="911">
                  <c:v>1.8160000000000001</c:v>
                </c:pt>
                <c:pt idx="912">
                  <c:v>1.8089999999999999</c:v>
                </c:pt>
                <c:pt idx="913">
                  <c:v>1.7969999999999999</c:v>
                </c:pt>
                <c:pt idx="914">
                  <c:v>1.792</c:v>
                </c:pt>
                <c:pt idx="915">
                  <c:v>1.7829999999999999</c:v>
                </c:pt>
                <c:pt idx="916">
                  <c:v>1.7769999999999999</c:v>
                </c:pt>
                <c:pt idx="917">
                  <c:v>1.7669999999999999</c:v>
                </c:pt>
                <c:pt idx="918">
                  <c:v>1.762</c:v>
                </c:pt>
                <c:pt idx="919">
                  <c:v>1.756</c:v>
                </c:pt>
                <c:pt idx="920">
                  <c:v>1.7450000000000001</c:v>
                </c:pt>
                <c:pt idx="921">
                  <c:v>1.736</c:v>
                </c:pt>
                <c:pt idx="922">
                  <c:v>1.73</c:v>
                </c:pt>
                <c:pt idx="923">
                  <c:v>1.7290000000000001</c:v>
                </c:pt>
                <c:pt idx="924">
                  <c:v>1.7210000000000001</c:v>
                </c:pt>
                <c:pt idx="925">
                  <c:v>1.71</c:v>
                </c:pt>
                <c:pt idx="926">
                  <c:v>1.7030000000000001</c:v>
                </c:pt>
                <c:pt idx="927">
                  <c:v>1.696</c:v>
                </c:pt>
                <c:pt idx="928">
                  <c:v>1.69</c:v>
                </c:pt>
                <c:pt idx="929">
                  <c:v>1.6759999999999999</c:v>
                </c:pt>
                <c:pt idx="930">
                  <c:v>1.6679999999999999</c:v>
                </c:pt>
                <c:pt idx="931">
                  <c:v>1.659</c:v>
                </c:pt>
                <c:pt idx="932">
                  <c:v>1.651</c:v>
                </c:pt>
                <c:pt idx="933">
                  <c:v>1.6379999999999999</c:v>
                </c:pt>
                <c:pt idx="934">
                  <c:v>1.631</c:v>
                </c:pt>
                <c:pt idx="935">
                  <c:v>1.619</c:v>
                </c:pt>
                <c:pt idx="936">
                  <c:v>1.6060000000000001</c:v>
                </c:pt>
                <c:pt idx="937">
                  <c:v>1.599</c:v>
                </c:pt>
                <c:pt idx="938">
                  <c:v>1.59</c:v>
                </c:pt>
                <c:pt idx="939">
                  <c:v>1.5840000000000001</c:v>
                </c:pt>
                <c:pt idx="940">
                  <c:v>1.571</c:v>
                </c:pt>
                <c:pt idx="941">
                  <c:v>1.5620000000000001</c:v>
                </c:pt>
                <c:pt idx="942">
                  <c:v>1.554</c:v>
                </c:pt>
                <c:pt idx="943">
                  <c:v>1.5409999999999999</c:v>
                </c:pt>
                <c:pt idx="944">
                  <c:v>1.5329999999999999</c:v>
                </c:pt>
                <c:pt idx="945">
                  <c:v>1.522</c:v>
                </c:pt>
                <c:pt idx="946">
                  <c:v>1.5109999999999999</c:v>
                </c:pt>
                <c:pt idx="947">
                  <c:v>1.5009999999999999</c:v>
                </c:pt>
                <c:pt idx="948">
                  <c:v>1.4970000000000001</c:v>
                </c:pt>
                <c:pt idx="949">
                  <c:v>1.492</c:v>
                </c:pt>
                <c:pt idx="950">
                  <c:v>1.484</c:v>
                </c:pt>
                <c:pt idx="951">
                  <c:v>1.4750000000000001</c:v>
                </c:pt>
                <c:pt idx="952">
                  <c:v>1.4650000000000001</c:v>
                </c:pt>
                <c:pt idx="953">
                  <c:v>1.458</c:v>
                </c:pt>
                <c:pt idx="954">
                  <c:v>1.4490000000000001</c:v>
                </c:pt>
                <c:pt idx="955">
                  <c:v>1.4419999999999999</c:v>
                </c:pt>
                <c:pt idx="956">
                  <c:v>1.4339999999999999</c:v>
                </c:pt>
                <c:pt idx="957">
                  <c:v>1.43</c:v>
                </c:pt>
                <c:pt idx="958">
                  <c:v>1.425</c:v>
                </c:pt>
                <c:pt idx="959">
                  <c:v>1.423</c:v>
                </c:pt>
                <c:pt idx="960">
                  <c:v>1.4179999999999999</c:v>
                </c:pt>
                <c:pt idx="961">
                  <c:v>1.415</c:v>
                </c:pt>
                <c:pt idx="962">
                  <c:v>1.417</c:v>
                </c:pt>
                <c:pt idx="963">
                  <c:v>1.4119999999999999</c:v>
                </c:pt>
                <c:pt idx="964">
                  <c:v>1.405</c:v>
                </c:pt>
                <c:pt idx="965">
                  <c:v>1.3939999999999999</c:v>
                </c:pt>
                <c:pt idx="966">
                  <c:v>1.389</c:v>
                </c:pt>
                <c:pt idx="967">
                  <c:v>1.383</c:v>
                </c:pt>
                <c:pt idx="968">
                  <c:v>1.377</c:v>
                </c:pt>
                <c:pt idx="969">
                  <c:v>1.3759999999999999</c:v>
                </c:pt>
                <c:pt idx="970">
                  <c:v>1.375</c:v>
                </c:pt>
                <c:pt idx="971">
                  <c:v>1.37</c:v>
                </c:pt>
                <c:pt idx="972">
                  <c:v>1.37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EFF-FD4E-AF1E-D175F2A815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133272"/>
        <c:axId val="252132096"/>
      </c:scatterChart>
      <c:valAx>
        <c:axId val="252133272"/>
        <c:scaling>
          <c:orientation val="minMax"/>
          <c:max val="20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0" vert="horz"/>
          <a:lstStyle/>
          <a:p>
            <a:pPr>
              <a:defRPr sz="1200"/>
            </a:pPr>
            <a:endParaRPr lang="en-US"/>
          </a:p>
        </c:txPr>
        <c:crossAx val="252132096"/>
        <c:crosses val="autoZero"/>
        <c:crossBetween val="midCat"/>
        <c:majorUnit val="5"/>
      </c:valAx>
      <c:valAx>
        <c:axId val="252132096"/>
        <c:scaling>
          <c:orientation val="minMax"/>
          <c:max val="1400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252133272"/>
        <c:crosses val="autoZero"/>
        <c:crossBetween val="midCat"/>
        <c:majorUnit val="200"/>
      </c:valAx>
    </c:plotArea>
    <c:plotVisOnly val="1"/>
    <c:dispBlanksAs val="gap"/>
    <c:showDLblsOverMax val="0"/>
  </c:chart>
  <c:txPr>
    <a:bodyPr/>
    <a:lstStyle/>
    <a:p>
      <a:pPr>
        <a:defRPr b="1"/>
      </a:pPr>
      <a:endParaRPr lang="en-US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marker>
            <c:symbol val="none"/>
          </c:marker>
          <c:xVal>
            <c:numRef>
              <c:f>Curves!$A$4:$A$962</c:f>
              <c:numCache>
                <c:formatCode>###0.00</c:formatCode>
                <c:ptCount val="959"/>
                <c:pt idx="0">
                  <c:v>0</c:v>
                </c:pt>
                <c:pt idx="1">
                  <c:v>1.6571071018875796E-2</c:v>
                </c:pt>
                <c:pt idx="2">
                  <c:v>3.3142142037751593E-2</c:v>
                </c:pt>
                <c:pt idx="3">
                  <c:v>4.9713213056627389E-2</c:v>
                </c:pt>
                <c:pt idx="4">
                  <c:v>6.6284284075503186E-2</c:v>
                </c:pt>
                <c:pt idx="5">
                  <c:v>8.2855355094378982E-2</c:v>
                </c:pt>
                <c:pt idx="6">
                  <c:v>9.9426426113254779E-2</c:v>
                </c:pt>
                <c:pt idx="7">
                  <c:v>0.11599749713213058</c:v>
                </c:pt>
                <c:pt idx="8">
                  <c:v>0.13256856815100637</c:v>
                </c:pt>
                <c:pt idx="9">
                  <c:v>0.14913963916988215</c:v>
                </c:pt>
                <c:pt idx="10">
                  <c:v>0.16571071018875796</c:v>
                </c:pt>
                <c:pt idx="11">
                  <c:v>0.18228178120763375</c:v>
                </c:pt>
                <c:pt idx="12">
                  <c:v>0.19885285222650956</c:v>
                </c:pt>
                <c:pt idx="13">
                  <c:v>0.21542392324538534</c:v>
                </c:pt>
                <c:pt idx="14">
                  <c:v>0.23199499426426115</c:v>
                </c:pt>
                <c:pt idx="15">
                  <c:v>0.24856606528313693</c:v>
                </c:pt>
                <c:pt idx="16">
                  <c:v>0.26513713630201274</c:v>
                </c:pt>
                <c:pt idx="17">
                  <c:v>0.28170820732088853</c:v>
                </c:pt>
                <c:pt idx="18">
                  <c:v>0.29827927833976431</c:v>
                </c:pt>
                <c:pt idx="19">
                  <c:v>0.31485034935864015</c:v>
                </c:pt>
                <c:pt idx="20">
                  <c:v>0.33142142037751593</c:v>
                </c:pt>
                <c:pt idx="21">
                  <c:v>0.34799249139639171</c:v>
                </c:pt>
                <c:pt idx="22">
                  <c:v>0.36456356241526749</c:v>
                </c:pt>
                <c:pt idx="23">
                  <c:v>0.38113463343414333</c:v>
                </c:pt>
                <c:pt idx="24">
                  <c:v>0.39770570445301912</c:v>
                </c:pt>
                <c:pt idx="25">
                  <c:v>0.4142767754718949</c:v>
                </c:pt>
                <c:pt idx="26">
                  <c:v>0.43084784649077068</c:v>
                </c:pt>
                <c:pt idx="27">
                  <c:v>0.44741891750964646</c:v>
                </c:pt>
                <c:pt idx="28">
                  <c:v>0.4639899885285223</c:v>
                </c:pt>
                <c:pt idx="29">
                  <c:v>0.48056105954739808</c:v>
                </c:pt>
                <c:pt idx="30">
                  <c:v>0.49713213056627387</c:v>
                </c:pt>
                <c:pt idx="31">
                  <c:v>0.5137032015851497</c:v>
                </c:pt>
                <c:pt idx="32">
                  <c:v>0.53027427260402549</c:v>
                </c:pt>
                <c:pt idx="33">
                  <c:v>0.54684534362290127</c:v>
                </c:pt>
                <c:pt idx="34">
                  <c:v>0.56341641464177705</c:v>
                </c:pt>
                <c:pt idx="35">
                  <c:v>0.57998748566065284</c:v>
                </c:pt>
                <c:pt idx="36">
                  <c:v>0.59655855667952862</c:v>
                </c:pt>
                <c:pt idx="37">
                  <c:v>0.6131296276984044</c:v>
                </c:pt>
                <c:pt idx="38">
                  <c:v>0.62970069871728029</c:v>
                </c:pt>
                <c:pt idx="39">
                  <c:v>0.64627176973615608</c:v>
                </c:pt>
                <c:pt idx="40">
                  <c:v>0.66284284075503186</c:v>
                </c:pt>
                <c:pt idx="41">
                  <c:v>0.67941391177390764</c:v>
                </c:pt>
                <c:pt idx="42">
                  <c:v>0.69598498279278342</c:v>
                </c:pt>
                <c:pt idx="43">
                  <c:v>0.71255605381165921</c:v>
                </c:pt>
                <c:pt idx="44">
                  <c:v>0.72912712483053499</c:v>
                </c:pt>
                <c:pt idx="45">
                  <c:v>0.74569819584941077</c:v>
                </c:pt>
                <c:pt idx="46">
                  <c:v>0.76226926686828667</c:v>
                </c:pt>
                <c:pt idx="47">
                  <c:v>0.77884033788716245</c:v>
                </c:pt>
                <c:pt idx="48">
                  <c:v>0.79541140890603823</c:v>
                </c:pt>
                <c:pt idx="49">
                  <c:v>0.81198247992491401</c:v>
                </c:pt>
                <c:pt idx="50">
                  <c:v>0.8285535509437898</c:v>
                </c:pt>
                <c:pt idx="51">
                  <c:v>0.84512462196266558</c:v>
                </c:pt>
                <c:pt idx="52">
                  <c:v>0.86169569298154136</c:v>
                </c:pt>
                <c:pt idx="53">
                  <c:v>0.87826676400041714</c:v>
                </c:pt>
                <c:pt idx="54">
                  <c:v>0.89483783501929293</c:v>
                </c:pt>
                <c:pt idx="55">
                  <c:v>0.91140890603816882</c:v>
                </c:pt>
                <c:pt idx="56">
                  <c:v>0.9279799770570446</c:v>
                </c:pt>
                <c:pt idx="57">
                  <c:v>0.94455104807592039</c:v>
                </c:pt>
                <c:pt idx="58">
                  <c:v>0.96112211909479617</c:v>
                </c:pt>
                <c:pt idx="59">
                  <c:v>0.97769319011367195</c:v>
                </c:pt>
                <c:pt idx="60">
                  <c:v>0.99426426113254773</c:v>
                </c:pt>
                <c:pt idx="61">
                  <c:v>1.0108353321514236</c:v>
                </c:pt>
                <c:pt idx="62">
                  <c:v>1.0274064031702994</c:v>
                </c:pt>
                <c:pt idx="63">
                  <c:v>1.0439774741891752</c:v>
                </c:pt>
                <c:pt idx="64">
                  <c:v>1.060548545208051</c:v>
                </c:pt>
                <c:pt idx="65">
                  <c:v>1.0771196162269268</c:v>
                </c:pt>
                <c:pt idx="66">
                  <c:v>1.0936906872458025</c:v>
                </c:pt>
                <c:pt idx="67">
                  <c:v>1.1102617582646783</c:v>
                </c:pt>
                <c:pt idx="68">
                  <c:v>1.1268328292835541</c:v>
                </c:pt>
                <c:pt idx="69">
                  <c:v>1.1434039003024299</c:v>
                </c:pt>
                <c:pt idx="70">
                  <c:v>1.1599749713213057</c:v>
                </c:pt>
                <c:pt idx="71">
                  <c:v>1.1765460423401815</c:v>
                </c:pt>
                <c:pt idx="72">
                  <c:v>1.1931171133590572</c:v>
                </c:pt>
                <c:pt idx="73">
                  <c:v>1.209688184377933</c:v>
                </c:pt>
                <c:pt idx="74">
                  <c:v>1.2262592553968088</c:v>
                </c:pt>
                <c:pt idx="75">
                  <c:v>1.2428303264156846</c:v>
                </c:pt>
                <c:pt idx="76">
                  <c:v>1.2594013974345606</c:v>
                </c:pt>
                <c:pt idx="77">
                  <c:v>1.2759724684534364</c:v>
                </c:pt>
                <c:pt idx="78">
                  <c:v>1.2925435394723122</c:v>
                </c:pt>
                <c:pt idx="79">
                  <c:v>1.3091146104911879</c:v>
                </c:pt>
                <c:pt idx="80">
                  <c:v>1.3256856815100637</c:v>
                </c:pt>
                <c:pt idx="81">
                  <c:v>1.3422567525289395</c:v>
                </c:pt>
                <c:pt idx="82">
                  <c:v>1.3588278235478153</c:v>
                </c:pt>
                <c:pt idx="83">
                  <c:v>1.3753988945666911</c:v>
                </c:pt>
                <c:pt idx="84">
                  <c:v>1.3919699655855668</c:v>
                </c:pt>
                <c:pt idx="85">
                  <c:v>1.4085410366044426</c:v>
                </c:pt>
                <c:pt idx="86">
                  <c:v>1.4251121076233184</c:v>
                </c:pt>
                <c:pt idx="87">
                  <c:v>1.4416831786421942</c:v>
                </c:pt>
                <c:pt idx="88">
                  <c:v>1.45825424966107</c:v>
                </c:pt>
                <c:pt idx="89">
                  <c:v>1.4748253206799458</c:v>
                </c:pt>
                <c:pt idx="90">
                  <c:v>1.4913963916988215</c:v>
                </c:pt>
                <c:pt idx="91">
                  <c:v>1.5079674627176973</c:v>
                </c:pt>
                <c:pt idx="92">
                  <c:v>1.5245385337365733</c:v>
                </c:pt>
                <c:pt idx="93">
                  <c:v>1.5411096047554491</c:v>
                </c:pt>
                <c:pt idx="94">
                  <c:v>1.5576806757743249</c:v>
                </c:pt>
                <c:pt idx="95">
                  <c:v>1.5742517467932007</c:v>
                </c:pt>
                <c:pt idx="96">
                  <c:v>1.5908228178120765</c:v>
                </c:pt>
                <c:pt idx="97">
                  <c:v>1.6073938888309522</c:v>
                </c:pt>
                <c:pt idx="98">
                  <c:v>1.623964959849828</c:v>
                </c:pt>
                <c:pt idx="99">
                  <c:v>1.6405360308687038</c:v>
                </c:pt>
                <c:pt idx="100">
                  <c:v>1.6571071018875796</c:v>
                </c:pt>
                <c:pt idx="101">
                  <c:v>1.6736781729064554</c:v>
                </c:pt>
                <c:pt idx="102">
                  <c:v>1.6902492439253312</c:v>
                </c:pt>
                <c:pt idx="103">
                  <c:v>1.7068203149442069</c:v>
                </c:pt>
                <c:pt idx="104">
                  <c:v>1.7233913859630827</c:v>
                </c:pt>
                <c:pt idx="105">
                  <c:v>1.7399624569819585</c:v>
                </c:pt>
                <c:pt idx="106">
                  <c:v>1.7565335280008343</c:v>
                </c:pt>
                <c:pt idx="107">
                  <c:v>1.7731045990197101</c:v>
                </c:pt>
                <c:pt idx="108">
                  <c:v>1.7896756700385859</c:v>
                </c:pt>
                <c:pt idx="109">
                  <c:v>1.8062467410574619</c:v>
                </c:pt>
                <c:pt idx="110">
                  <c:v>1.8228178120763376</c:v>
                </c:pt>
                <c:pt idx="111">
                  <c:v>1.8393888830952134</c:v>
                </c:pt>
                <c:pt idx="112">
                  <c:v>1.8559599541140892</c:v>
                </c:pt>
                <c:pt idx="113">
                  <c:v>1.872531025132965</c:v>
                </c:pt>
                <c:pt idx="114">
                  <c:v>1.8891020961518408</c:v>
                </c:pt>
                <c:pt idx="115">
                  <c:v>1.9056731671707166</c:v>
                </c:pt>
                <c:pt idx="116">
                  <c:v>1.9222442381895923</c:v>
                </c:pt>
                <c:pt idx="117">
                  <c:v>1.9388153092084681</c:v>
                </c:pt>
                <c:pt idx="118">
                  <c:v>1.9553863802273439</c:v>
                </c:pt>
                <c:pt idx="119">
                  <c:v>1.9719574512462197</c:v>
                </c:pt>
                <c:pt idx="120">
                  <c:v>1.9885285222650955</c:v>
                </c:pt>
                <c:pt idx="121">
                  <c:v>2.0050995932839712</c:v>
                </c:pt>
                <c:pt idx="122">
                  <c:v>2.0216706643028473</c:v>
                </c:pt>
                <c:pt idx="123">
                  <c:v>2.0382417353217228</c:v>
                </c:pt>
                <c:pt idx="124">
                  <c:v>2.0548128063405988</c:v>
                </c:pt>
                <c:pt idx="125">
                  <c:v>2.0713838773594744</c:v>
                </c:pt>
                <c:pt idx="126">
                  <c:v>2.0879549483783504</c:v>
                </c:pt>
                <c:pt idx="127">
                  <c:v>2.1045260193972259</c:v>
                </c:pt>
                <c:pt idx="128">
                  <c:v>2.1210970904161019</c:v>
                </c:pt>
                <c:pt idx="129">
                  <c:v>2.1376681614349775</c:v>
                </c:pt>
                <c:pt idx="130">
                  <c:v>2.1542392324538535</c:v>
                </c:pt>
                <c:pt idx="131">
                  <c:v>2.1708103034727291</c:v>
                </c:pt>
                <c:pt idx="132">
                  <c:v>2.1873813744916051</c:v>
                </c:pt>
                <c:pt idx="133">
                  <c:v>2.2039524455104806</c:v>
                </c:pt>
                <c:pt idx="134">
                  <c:v>2.2205235165293566</c:v>
                </c:pt>
                <c:pt idx="135">
                  <c:v>2.2370945875482326</c:v>
                </c:pt>
                <c:pt idx="136">
                  <c:v>2.2536656585671082</c:v>
                </c:pt>
                <c:pt idx="137">
                  <c:v>2.2702367295859842</c:v>
                </c:pt>
                <c:pt idx="138">
                  <c:v>2.2868078006048598</c:v>
                </c:pt>
                <c:pt idx="139">
                  <c:v>2.3033788716237358</c:v>
                </c:pt>
                <c:pt idx="140">
                  <c:v>2.3199499426426113</c:v>
                </c:pt>
                <c:pt idx="141">
                  <c:v>2.3365210136614873</c:v>
                </c:pt>
                <c:pt idx="142">
                  <c:v>2.3530920846803629</c:v>
                </c:pt>
                <c:pt idx="143">
                  <c:v>2.3696631556992389</c:v>
                </c:pt>
                <c:pt idx="144">
                  <c:v>2.3862342267181145</c:v>
                </c:pt>
                <c:pt idx="145">
                  <c:v>2.4028052977369905</c:v>
                </c:pt>
                <c:pt idx="146">
                  <c:v>2.419376368755866</c:v>
                </c:pt>
                <c:pt idx="147">
                  <c:v>2.435947439774742</c:v>
                </c:pt>
                <c:pt idx="148">
                  <c:v>2.4525185107936176</c:v>
                </c:pt>
                <c:pt idx="149">
                  <c:v>2.4690895818124936</c:v>
                </c:pt>
                <c:pt idx="150">
                  <c:v>2.4856606528313692</c:v>
                </c:pt>
                <c:pt idx="151">
                  <c:v>2.5022317238502452</c:v>
                </c:pt>
                <c:pt idx="152">
                  <c:v>2.5188027948691212</c:v>
                </c:pt>
                <c:pt idx="153">
                  <c:v>2.5353738658879967</c:v>
                </c:pt>
                <c:pt idx="154">
                  <c:v>2.5519449369068727</c:v>
                </c:pt>
                <c:pt idx="155">
                  <c:v>2.5685160079257483</c:v>
                </c:pt>
                <c:pt idx="156">
                  <c:v>2.5850870789446243</c:v>
                </c:pt>
                <c:pt idx="157">
                  <c:v>2.6016581499634999</c:v>
                </c:pt>
                <c:pt idx="158">
                  <c:v>2.6182292209823759</c:v>
                </c:pt>
                <c:pt idx="159">
                  <c:v>2.6348002920012514</c:v>
                </c:pt>
                <c:pt idx="160">
                  <c:v>2.6513713630201274</c:v>
                </c:pt>
                <c:pt idx="161">
                  <c:v>2.667942434039003</c:v>
                </c:pt>
                <c:pt idx="162">
                  <c:v>2.684513505057879</c:v>
                </c:pt>
                <c:pt idx="163">
                  <c:v>2.7010845760767546</c:v>
                </c:pt>
                <c:pt idx="164">
                  <c:v>2.7176556470956306</c:v>
                </c:pt>
                <c:pt idx="165">
                  <c:v>2.7342267181145061</c:v>
                </c:pt>
                <c:pt idx="166">
                  <c:v>2.7507977891333821</c:v>
                </c:pt>
                <c:pt idx="167">
                  <c:v>2.7673688601522577</c:v>
                </c:pt>
                <c:pt idx="168">
                  <c:v>2.7839399311711337</c:v>
                </c:pt>
                <c:pt idx="169">
                  <c:v>2.8005110021900097</c:v>
                </c:pt>
                <c:pt idx="170">
                  <c:v>2.8170820732088853</c:v>
                </c:pt>
                <c:pt idx="171">
                  <c:v>2.8336531442277613</c:v>
                </c:pt>
                <c:pt idx="172">
                  <c:v>2.8502242152466368</c:v>
                </c:pt>
                <c:pt idx="173">
                  <c:v>2.8667952862655128</c:v>
                </c:pt>
                <c:pt idx="174">
                  <c:v>2.8833663572843884</c:v>
                </c:pt>
                <c:pt idx="175">
                  <c:v>2.8999374283032644</c:v>
                </c:pt>
                <c:pt idx="176">
                  <c:v>2.91650849932214</c:v>
                </c:pt>
                <c:pt idx="177">
                  <c:v>2.933079570341016</c:v>
                </c:pt>
                <c:pt idx="178">
                  <c:v>2.9496506413598915</c:v>
                </c:pt>
                <c:pt idx="179">
                  <c:v>2.9662217123787675</c:v>
                </c:pt>
                <c:pt idx="180">
                  <c:v>2.9827927833976431</c:v>
                </c:pt>
                <c:pt idx="181">
                  <c:v>2.9993638544165191</c:v>
                </c:pt>
                <c:pt idx="182">
                  <c:v>3.0159349254353947</c:v>
                </c:pt>
                <c:pt idx="183">
                  <c:v>3.0325059964542707</c:v>
                </c:pt>
                <c:pt idx="184">
                  <c:v>3.0490770674731467</c:v>
                </c:pt>
                <c:pt idx="185">
                  <c:v>3.0656481384920222</c:v>
                </c:pt>
                <c:pt idx="186">
                  <c:v>3.0822192095108982</c:v>
                </c:pt>
                <c:pt idx="187">
                  <c:v>3.0987902805297738</c:v>
                </c:pt>
                <c:pt idx="188">
                  <c:v>3.1153613515486498</c:v>
                </c:pt>
                <c:pt idx="189">
                  <c:v>3.1319324225675254</c:v>
                </c:pt>
                <c:pt idx="190">
                  <c:v>3.1485034935864014</c:v>
                </c:pt>
                <c:pt idx="191">
                  <c:v>3.1650745646052769</c:v>
                </c:pt>
                <c:pt idx="192">
                  <c:v>3.1816456356241529</c:v>
                </c:pt>
                <c:pt idx="193">
                  <c:v>3.1982167066430285</c:v>
                </c:pt>
                <c:pt idx="194">
                  <c:v>3.2147877776619045</c:v>
                </c:pt>
                <c:pt idx="195">
                  <c:v>3.23135884868078</c:v>
                </c:pt>
                <c:pt idx="196">
                  <c:v>3.2479299196996561</c:v>
                </c:pt>
                <c:pt idx="197">
                  <c:v>3.2645009907185316</c:v>
                </c:pt>
                <c:pt idx="198">
                  <c:v>3.2810720617374076</c:v>
                </c:pt>
                <c:pt idx="199">
                  <c:v>3.2976431327562832</c:v>
                </c:pt>
                <c:pt idx="200">
                  <c:v>3.3142142037751592</c:v>
                </c:pt>
                <c:pt idx="201">
                  <c:v>3.3307852747940352</c:v>
                </c:pt>
                <c:pt idx="202">
                  <c:v>3.3473563458129107</c:v>
                </c:pt>
                <c:pt idx="203">
                  <c:v>3.3639274168317868</c:v>
                </c:pt>
                <c:pt idx="204">
                  <c:v>3.3804984878506623</c:v>
                </c:pt>
                <c:pt idx="205">
                  <c:v>3.3970695588695383</c:v>
                </c:pt>
                <c:pt idx="206">
                  <c:v>3.4136406298884139</c:v>
                </c:pt>
                <c:pt idx="207">
                  <c:v>3.4302117009072899</c:v>
                </c:pt>
                <c:pt idx="208">
                  <c:v>3.4467827719261654</c:v>
                </c:pt>
                <c:pt idx="209">
                  <c:v>3.4633538429450414</c:v>
                </c:pt>
                <c:pt idx="210">
                  <c:v>3.479924913963917</c:v>
                </c:pt>
                <c:pt idx="211">
                  <c:v>3.496495984982793</c:v>
                </c:pt>
                <c:pt idx="212">
                  <c:v>3.5130670560016686</c:v>
                </c:pt>
                <c:pt idx="213">
                  <c:v>3.5296381270205446</c:v>
                </c:pt>
                <c:pt idx="214">
                  <c:v>3.5462091980394201</c:v>
                </c:pt>
                <c:pt idx="215">
                  <c:v>3.5627802690582961</c:v>
                </c:pt>
                <c:pt idx="216">
                  <c:v>3.5793513400771717</c:v>
                </c:pt>
                <c:pt idx="217">
                  <c:v>3.5959224110960477</c:v>
                </c:pt>
                <c:pt idx="218">
                  <c:v>3.6124934821149237</c:v>
                </c:pt>
                <c:pt idx="219">
                  <c:v>3.6290645531337993</c:v>
                </c:pt>
                <c:pt idx="220">
                  <c:v>3.6456356241526753</c:v>
                </c:pt>
                <c:pt idx="221">
                  <c:v>3.6622066951715508</c:v>
                </c:pt>
                <c:pt idx="222">
                  <c:v>3.6787777661904268</c:v>
                </c:pt>
                <c:pt idx="223">
                  <c:v>3.6953488372093024</c:v>
                </c:pt>
                <c:pt idx="224">
                  <c:v>3.7119199082281784</c:v>
                </c:pt>
                <c:pt idx="225">
                  <c:v>3.728490979247054</c:v>
                </c:pt>
                <c:pt idx="226">
                  <c:v>3.74506205026593</c:v>
                </c:pt>
                <c:pt idx="227">
                  <c:v>3.7616331212848055</c:v>
                </c:pt>
                <c:pt idx="228">
                  <c:v>3.7782041923036815</c:v>
                </c:pt>
                <c:pt idx="229">
                  <c:v>3.7947752633225571</c:v>
                </c:pt>
                <c:pt idx="230">
                  <c:v>3.8113463343414331</c:v>
                </c:pt>
                <c:pt idx="231">
                  <c:v>3.8279174053603087</c:v>
                </c:pt>
                <c:pt idx="232">
                  <c:v>3.8444884763791847</c:v>
                </c:pt>
                <c:pt idx="233">
                  <c:v>3.8610595473980602</c:v>
                </c:pt>
                <c:pt idx="234">
                  <c:v>3.8776306184169362</c:v>
                </c:pt>
                <c:pt idx="235">
                  <c:v>3.8942016894358122</c:v>
                </c:pt>
                <c:pt idx="236">
                  <c:v>3.9107727604546878</c:v>
                </c:pt>
                <c:pt idx="237">
                  <c:v>3.9273438314735638</c:v>
                </c:pt>
                <c:pt idx="238">
                  <c:v>3.9439149024924394</c:v>
                </c:pt>
                <c:pt idx="239">
                  <c:v>3.9604859735113154</c:v>
                </c:pt>
                <c:pt idx="240">
                  <c:v>3.9770570445301909</c:v>
                </c:pt>
                <c:pt idx="241">
                  <c:v>3.9936281155490669</c:v>
                </c:pt>
                <c:pt idx="242">
                  <c:v>4.0101991865679425</c:v>
                </c:pt>
                <c:pt idx="243">
                  <c:v>4.0267702575868185</c:v>
                </c:pt>
                <c:pt idx="244">
                  <c:v>4.0433413286056945</c:v>
                </c:pt>
                <c:pt idx="245">
                  <c:v>4.0599123996245696</c:v>
                </c:pt>
                <c:pt idx="246">
                  <c:v>4.0764834706434456</c:v>
                </c:pt>
                <c:pt idx="247">
                  <c:v>4.0930545416623216</c:v>
                </c:pt>
                <c:pt idx="248">
                  <c:v>4.1096256126811976</c:v>
                </c:pt>
                <c:pt idx="249">
                  <c:v>4.1261966837000728</c:v>
                </c:pt>
                <c:pt idx="250">
                  <c:v>4.1427677547189488</c:v>
                </c:pt>
                <c:pt idx="251">
                  <c:v>4.1593388257378248</c:v>
                </c:pt>
                <c:pt idx="252">
                  <c:v>4.1759098967567008</c:v>
                </c:pt>
                <c:pt idx="253">
                  <c:v>4.1924809677755768</c:v>
                </c:pt>
                <c:pt idx="254">
                  <c:v>4.2090520387944519</c:v>
                </c:pt>
                <c:pt idx="255">
                  <c:v>4.2256231098133279</c:v>
                </c:pt>
                <c:pt idx="256">
                  <c:v>4.2421941808322039</c:v>
                </c:pt>
                <c:pt idx="257">
                  <c:v>4.2587652518510799</c:v>
                </c:pt>
                <c:pt idx="258">
                  <c:v>4.275336322869955</c:v>
                </c:pt>
                <c:pt idx="259">
                  <c:v>4.291907393888831</c:v>
                </c:pt>
                <c:pt idx="260">
                  <c:v>4.308478464907707</c:v>
                </c:pt>
                <c:pt idx="261">
                  <c:v>4.325049535926583</c:v>
                </c:pt>
                <c:pt idx="262">
                  <c:v>4.3416206069454581</c:v>
                </c:pt>
                <c:pt idx="263">
                  <c:v>4.3581916779643342</c:v>
                </c:pt>
                <c:pt idx="264">
                  <c:v>4.3747627489832102</c:v>
                </c:pt>
                <c:pt idx="265">
                  <c:v>4.3913338200020862</c:v>
                </c:pt>
                <c:pt idx="266">
                  <c:v>4.4079048910209613</c:v>
                </c:pt>
                <c:pt idx="267">
                  <c:v>4.4244759620398373</c:v>
                </c:pt>
                <c:pt idx="268">
                  <c:v>4.4410470330587133</c:v>
                </c:pt>
                <c:pt idx="269">
                  <c:v>4.4576181040775893</c:v>
                </c:pt>
                <c:pt idx="270">
                  <c:v>4.4741891750964653</c:v>
                </c:pt>
                <c:pt idx="271">
                  <c:v>4.4907602461153404</c:v>
                </c:pt>
                <c:pt idx="272">
                  <c:v>4.5073313171342164</c:v>
                </c:pt>
                <c:pt idx="273">
                  <c:v>4.5239023881530924</c:v>
                </c:pt>
                <c:pt idx="274">
                  <c:v>4.5404734591719684</c:v>
                </c:pt>
                <c:pt idx="275">
                  <c:v>4.5570445301908435</c:v>
                </c:pt>
                <c:pt idx="276">
                  <c:v>4.5736156012097196</c:v>
                </c:pt>
                <c:pt idx="277">
                  <c:v>4.5901866722285956</c:v>
                </c:pt>
                <c:pt idx="278">
                  <c:v>4.6067577432474716</c:v>
                </c:pt>
                <c:pt idx="279">
                  <c:v>4.6233288142663467</c:v>
                </c:pt>
                <c:pt idx="280">
                  <c:v>4.6398998852852227</c:v>
                </c:pt>
                <c:pt idx="281">
                  <c:v>4.6564709563040987</c:v>
                </c:pt>
                <c:pt idx="282">
                  <c:v>4.6730420273229747</c:v>
                </c:pt>
                <c:pt idx="283">
                  <c:v>4.6896130983418498</c:v>
                </c:pt>
                <c:pt idx="284">
                  <c:v>4.7061841693607258</c:v>
                </c:pt>
                <c:pt idx="285">
                  <c:v>4.7227552403796018</c:v>
                </c:pt>
                <c:pt idx="286">
                  <c:v>4.7393263113984778</c:v>
                </c:pt>
                <c:pt idx="287">
                  <c:v>4.7558973824173538</c:v>
                </c:pt>
                <c:pt idx="288">
                  <c:v>4.7724684534362289</c:v>
                </c:pt>
                <c:pt idx="289">
                  <c:v>4.7890395244551049</c:v>
                </c:pt>
                <c:pt idx="290">
                  <c:v>4.805610595473981</c:v>
                </c:pt>
                <c:pt idx="291">
                  <c:v>4.822181666492857</c:v>
                </c:pt>
                <c:pt idx="292">
                  <c:v>4.8387527375117321</c:v>
                </c:pt>
                <c:pt idx="293">
                  <c:v>4.8553238085306081</c:v>
                </c:pt>
                <c:pt idx="294">
                  <c:v>4.8718948795494841</c:v>
                </c:pt>
                <c:pt idx="295">
                  <c:v>4.8884659505683601</c:v>
                </c:pt>
                <c:pt idx="296">
                  <c:v>4.9050370215872352</c:v>
                </c:pt>
                <c:pt idx="297">
                  <c:v>4.9216080926061112</c:v>
                </c:pt>
                <c:pt idx="298">
                  <c:v>4.9381791636249872</c:v>
                </c:pt>
                <c:pt idx="299">
                  <c:v>4.9547502346438632</c:v>
                </c:pt>
                <c:pt idx="300">
                  <c:v>4.9713213056627383</c:v>
                </c:pt>
                <c:pt idx="301">
                  <c:v>4.9878923766816143</c:v>
                </c:pt>
                <c:pt idx="302">
                  <c:v>5.0044634477004903</c:v>
                </c:pt>
                <c:pt idx="303">
                  <c:v>5.0210345187193663</c:v>
                </c:pt>
                <c:pt idx="304">
                  <c:v>5.0376055897382424</c:v>
                </c:pt>
                <c:pt idx="305">
                  <c:v>5.0541766607571175</c:v>
                </c:pt>
                <c:pt idx="306">
                  <c:v>5.0707477317759935</c:v>
                </c:pt>
                <c:pt idx="307">
                  <c:v>5.0873188027948695</c:v>
                </c:pt>
                <c:pt idx="308">
                  <c:v>5.1038898738137455</c:v>
                </c:pt>
                <c:pt idx="309">
                  <c:v>5.1204609448326206</c:v>
                </c:pt>
                <c:pt idx="310">
                  <c:v>5.1370320158514966</c:v>
                </c:pt>
                <c:pt idx="311">
                  <c:v>5.1536030868703726</c:v>
                </c:pt>
                <c:pt idx="312">
                  <c:v>5.1701741578892486</c:v>
                </c:pt>
                <c:pt idx="313">
                  <c:v>5.1867452289081237</c:v>
                </c:pt>
                <c:pt idx="314">
                  <c:v>5.2033162999269997</c:v>
                </c:pt>
                <c:pt idx="315">
                  <c:v>5.2198873709458757</c:v>
                </c:pt>
                <c:pt idx="316">
                  <c:v>5.2364584419647517</c:v>
                </c:pt>
                <c:pt idx="317">
                  <c:v>5.2530295129836269</c:v>
                </c:pt>
                <c:pt idx="318">
                  <c:v>5.2696005840025029</c:v>
                </c:pt>
                <c:pt idx="319">
                  <c:v>5.2861716550213789</c:v>
                </c:pt>
                <c:pt idx="320">
                  <c:v>5.3027427260402549</c:v>
                </c:pt>
                <c:pt idx="321">
                  <c:v>5.3193137970591309</c:v>
                </c:pt>
                <c:pt idx="322">
                  <c:v>5.335884868078006</c:v>
                </c:pt>
                <c:pt idx="323">
                  <c:v>5.352455939096882</c:v>
                </c:pt>
                <c:pt idx="324">
                  <c:v>5.369027010115758</c:v>
                </c:pt>
                <c:pt idx="325">
                  <c:v>5.385598081134634</c:v>
                </c:pt>
                <c:pt idx="326">
                  <c:v>5.4021691521535091</c:v>
                </c:pt>
                <c:pt idx="327">
                  <c:v>5.4187402231723851</c:v>
                </c:pt>
                <c:pt idx="328">
                  <c:v>5.4353112941912611</c:v>
                </c:pt>
                <c:pt idx="329">
                  <c:v>5.4518823652101371</c:v>
                </c:pt>
                <c:pt idx="330">
                  <c:v>5.4684534362290123</c:v>
                </c:pt>
                <c:pt idx="331">
                  <c:v>5.4850245072478883</c:v>
                </c:pt>
                <c:pt idx="332">
                  <c:v>5.5015955782667643</c:v>
                </c:pt>
                <c:pt idx="333">
                  <c:v>5.5181666492856403</c:v>
                </c:pt>
                <c:pt idx="334">
                  <c:v>5.5347377203045154</c:v>
                </c:pt>
                <c:pt idx="335">
                  <c:v>5.5513087913233914</c:v>
                </c:pt>
                <c:pt idx="336">
                  <c:v>5.5678798623422674</c:v>
                </c:pt>
                <c:pt idx="337">
                  <c:v>5.5844509333611434</c:v>
                </c:pt>
                <c:pt idx="338">
                  <c:v>5.6010220043800194</c:v>
                </c:pt>
                <c:pt idx="339">
                  <c:v>5.6175930753988945</c:v>
                </c:pt>
                <c:pt idx="340">
                  <c:v>5.6341641464177705</c:v>
                </c:pt>
                <c:pt idx="341">
                  <c:v>5.6507352174366465</c:v>
                </c:pt>
                <c:pt idx="342">
                  <c:v>5.6673062884555225</c:v>
                </c:pt>
                <c:pt idx="343">
                  <c:v>5.6838773594743977</c:v>
                </c:pt>
                <c:pt idx="344">
                  <c:v>5.7004484304932737</c:v>
                </c:pt>
                <c:pt idx="345">
                  <c:v>5.7170195015121497</c:v>
                </c:pt>
                <c:pt idx="346">
                  <c:v>5.7335905725310257</c:v>
                </c:pt>
                <c:pt idx="347">
                  <c:v>5.7501616435499008</c:v>
                </c:pt>
                <c:pt idx="348">
                  <c:v>5.7667327145687768</c:v>
                </c:pt>
                <c:pt idx="349">
                  <c:v>5.7833037855876528</c:v>
                </c:pt>
                <c:pt idx="350">
                  <c:v>5.7998748566065288</c:v>
                </c:pt>
                <c:pt idx="351">
                  <c:v>5.8164459276254048</c:v>
                </c:pt>
                <c:pt idx="352">
                  <c:v>5.8330169986442799</c:v>
                </c:pt>
                <c:pt idx="353">
                  <c:v>5.8495880696631559</c:v>
                </c:pt>
                <c:pt idx="354">
                  <c:v>5.8661591406820319</c:v>
                </c:pt>
                <c:pt idx="355">
                  <c:v>5.8827302117009079</c:v>
                </c:pt>
                <c:pt idx="356">
                  <c:v>5.899301282719783</c:v>
                </c:pt>
                <c:pt idx="357">
                  <c:v>5.9158723537386591</c:v>
                </c:pt>
                <c:pt idx="358">
                  <c:v>5.9324434247575351</c:v>
                </c:pt>
                <c:pt idx="359">
                  <c:v>5.9490144957764111</c:v>
                </c:pt>
                <c:pt idx="360">
                  <c:v>5.9655855667952862</c:v>
                </c:pt>
                <c:pt idx="361">
                  <c:v>5.9821566378141622</c:v>
                </c:pt>
                <c:pt idx="362">
                  <c:v>5.9987277088330382</c:v>
                </c:pt>
                <c:pt idx="363">
                  <c:v>6.0152987798519142</c:v>
                </c:pt>
                <c:pt idx="364">
                  <c:v>6.0318698508707893</c:v>
                </c:pt>
                <c:pt idx="365">
                  <c:v>6.0484409218896653</c:v>
                </c:pt>
                <c:pt idx="366">
                  <c:v>6.0650119929085413</c:v>
                </c:pt>
                <c:pt idx="367">
                  <c:v>6.0815830639274173</c:v>
                </c:pt>
                <c:pt idx="368">
                  <c:v>6.0981541349462933</c:v>
                </c:pt>
                <c:pt idx="369">
                  <c:v>6.1147252059651684</c:v>
                </c:pt>
                <c:pt idx="370">
                  <c:v>6.1312962769840444</c:v>
                </c:pt>
                <c:pt idx="371">
                  <c:v>6.1478673480029205</c:v>
                </c:pt>
                <c:pt idx="372">
                  <c:v>6.1644384190217965</c:v>
                </c:pt>
                <c:pt idx="373">
                  <c:v>6.1810094900406716</c:v>
                </c:pt>
                <c:pt idx="374">
                  <c:v>6.1975805610595476</c:v>
                </c:pt>
                <c:pt idx="375">
                  <c:v>6.2141516320784236</c:v>
                </c:pt>
                <c:pt idx="376">
                  <c:v>6.2307227030972996</c:v>
                </c:pt>
                <c:pt idx="377">
                  <c:v>6.2472937741161747</c:v>
                </c:pt>
                <c:pt idx="378">
                  <c:v>6.2638648451350507</c:v>
                </c:pt>
                <c:pt idx="379">
                  <c:v>6.2804359161539267</c:v>
                </c:pt>
                <c:pt idx="380">
                  <c:v>6.2970069871728027</c:v>
                </c:pt>
                <c:pt idx="381">
                  <c:v>6.3135780581916778</c:v>
                </c:pt>
                <c:pt idx="382">
                  <c:v>6.3301491292105538</c:v>
                </c:pt>
                <c:pt idx="383">
                  <c:v>6.3467202002294298</c:v>
                </c:pt>
                <c:pt idx="384">
                  <c:v>6.3632912712483058</c:v>
                </c:pt>
                <c:pt idx="385">
                  <c:v>6.3798623422671819</c:v>
                </c:pt>
                <c:pt idx="386">
                  <c:v>6.396433413286057</c:v>
                </c:pt>
                <c:pt idx="387">
                  <c:v>6.413004484304933</c:v>
                </c:pt>
                <c:pt idx="388">
                  <c:v>6.429575555323809</c:v>
                </c:pt>
                <c:pt idx="389">
                  <c:v>6.446146626342685</c:v>
                </c:pt>
                <c:pt idx="390">
                  <c:v>6.4627176973615601</c:v>
                </c:pt>
                <c:pt idx="391">
                  <c:v>6.4792887683804361</c:v>
                </c:pt>
                <c:pt idx="392">
                  <c:v>6.4958598393993121</c:v>
                </c:pt>
                <c:pt idx="393">
                  <c:v>6.5124309104181881</c:v>
                </c:pt>
                <c:pt idx="394">
                  <c:v>6.5290019814370632</c:v>
                </c:pt>
                <c:pt idx="395">
                  <c:v>6.5455730524559392</c:v>
                </c:pt>
                <c:pt idx="396">
                  <c:v>6.5621441234748152</c:v>
                </c:pt>
                <c:pt idx="397">
                  <c:v>6.5787151944936912</c:v>
                </c:pt>
                <c:pt idx="398">
                  <c:v>6.5952862655125664</c:v>
                </c:pt>
                <c:pt idx="399">
                  <c:v>6.6118573365314424</c:v>
                </c:pt>
                <c:pt idx="400">
                  <c:v>6.6284284075503184</c:v>
                </c:pt>
                <c:pt idx="401">
                  <c:v>6.6449994785691944</c:v>
                </c:pt>
                <c:pt idx="402">
                  <c:v>6.6615705495880704</c:v>
                </c:pt>
                <c:pt idx="403">
                  <c:v>6.6781416206069455</c:v>
                </c:pt>
                <c:pt idx="404">
                  <c:v>6.6947126916258215</c:v>
                </c:pt>
                <c:pt idx="405">
                  <c:v>6.7112837626446975</c:v>
                </c:pt>
                <c:pt idx="406">
                  <c:v>6.7278548336635735</c:v>
                </c:pt>
                <c:pt idx="407">
                  <c:v>6.7444259046824486</c:v>
                </c:pt>
                <c:pt idx="408">
                  <c:v>6.7609969757013246</c:v>
                </c:pt>
                <c:pt idx="409">
                  <c:v>6.7775680467202006</c:v>
                </c:pt>
                <c:pt idx="410">
                  <c:v>6.7941391177390766</c:v>
                </c:pt>
                <c:pt idx="411">
                  <c:v>6.8107101887579518</c:v>
                </c:pt>
                <c:pt idx="412">
                  <c:v>6.8272812597768278</c:v>
                </c:pt>
                <c:pt idx="413">
                  <c:v>6.8438523307957038</c:v>
                </c:pt>
                <c:pt idx="414">
                  <c:v>6.8604234018145798</c:v>
                </c:pt>
                <c:pt idx="415">
                  <c:v>6.8769944728334549</c:v>
                </c:pt>
                <c:pt idx="416">
                  <c:v>6.8935655438523309</c:v>
                </c:pt>
                <c:pt idx="417">
                  <c:v>6.9101366148712069</c:v>
                </c:pt>
                <c:pt idx="418">
                  <c:v>6.9267076858900829</c:v>
                </c:pt>
                <c:pt idx="419">
                  <c:v>6.9432787569089589</c:v>
                </c:pt>
                <c:pt idx="420">
                  <c:v>6.959849827927834</c:v>
                </c:pt>
                <c:pt idx="421">
                  <c:v>6.97642089894671</c:v>
                </c:pt>
                <c:pt idx="422">
                  <c:v>6.992991969965586</c:v>
                </c:pt>
                <c:pt idx="423">
                  <c:v>7.009563040984462</c:v>
                </c:pt>
                <c:pt idx="424">
                  <c:v>7.0261341120033372</c:v>
                </c:pt>
                <c:pt idx="425">
                  <c:v>7.0427051830222132</c:v>
                </c:pt>
                <c:pt idx="426">
                  <c:v>7.0592762540410892</c:v>
                </c:pt>
                <c:pt idx="427">
                  <c:v>7.0758473250599652</c:v>
                </c:pt>
                <c:pt idx="428">
                  <c:v>7.0924183960788403</c:v>
                </c:pt>
                <c:pt idx="429">
                  <c:v>7.1089894670977163</c:v>
                </c:pt>
                <c:pt idx="430">
                  <c:v>7.1255605381165923</c:v>
                </c:pt>
                <c:pt idx="431">
                  <c:v>7.1421316091354683</c:v>
                </c:pt>
                <c:pt idx="432">
                  <c:v>7.1587026801543434</c:v>
                </c:pt>
                <c:pt idx="433">
                  <c:v>7.1752737511732194</c:v>
                </c:pt>
                <c:pt idx="434">
                  <c:v>7.1918448221920954</c:v>
                </c:pt>
                <c:pt idx="435">
                  <c:v>7.2084158932109714</c:v>
                </c:pt>
                <c:pt idx="436">
                  <c:v>7.2249869642298474</c:v>
                </c:pt>
                <c:pt idx="437">
                  <c:v>7.2415580352487225</c:v>
                </c:pt>
                <c:pt idx="438">
                  <c:v>7.2581291062675986</c:v>
                </c:pt>
                <c:pt idx="439">
                  <c:v>7.2747001772864746</c:v>
                </c:pt>
                <c:pt idx="440">
                  <c:v>7.2912712483053506</c:v>
                </c:pt>
                <c:pt idx="441">
                  <c:v>7.3078423193242257</c:v>
                </c:pt>
                <c:pt idx="442">
                  <c:v>7.3244133903431017</c:v>
                </c:pt>
                <c:pt idx="443">
                  <c:v>7.3409844613619777</c:v>
                </c:pt>
                <c:pt idx="444">
                  <c:v>7.3575555323808537</c:v>
                </c:pt>
                <c:pt idx="445">
                  <c:v>7.3741266033997288</c:v>
                </c:pt>
                <c:pt idx="446">
                  <c:v>7.3906976744186048</c:v>
                </c:pt>
                <c:pt idx="447">
                  <c:v>7.4072687454374808</c:v>
                </c:pt>
                <c:pt idx="448">
                  <c:v>7.4238398164563568</c:v>
                </c:pt>
                <c:pt idx="449">
                  <c:v>7.4404108874752319</c:v>
                </c:pt>
                <c:pt idx="450">
                  <c:v>7.4569819584941079</c:v>
                </c:pt>
                <c:pt idx="451">
                  <c:v>7.4735530295129839</c:v>
                </c:pt>
                <c:pt idx="452">
                  <c:v>7.49012410053186</c:v>
                </c:pt>
                <c:pt idx="453">
                  <c:v>7.506695171550736</c:v>
                </c:pt>
                <c:pt idx="454">
                  <c:v>7.5232662425696111</c:v>
                </c:pt>
                <c:pt idx="455">
                  <c:v>7.5398373135884871</c:v>
                </c:pt>
                <c:pt idx="456">
                  <c:v>7.5564083846073631</c:v>
                </c:pt>
                <c:pt idx="457">
                  <c:v>7.5729794556262391</c:v>
                </c:pt>
                <c:pt idx="458">
                  <c:v>7.5895505266451142</c:v>
                </c:pt>
                <c:pt idx="459">
                  <c:v>7.6061215976639902</c:v>
                </c:pt>
                <c:pt idx="460">
                  <c:v>7.6226926686828662</c:v>
                </c:pt>
                <c:pt idx="461">
                  <c:v>7.6392637397017422</c:v>
                </c:pt>
                <c:pt idx="462">
                  <c:v>7.6558348107206173</c:v>
                </c:pt>
                <c:pt idx="463">
                  <c:v>7.6724058817394933</c:v>
                </c:pt>
                <c:pt idx="464">
                  <c:v>7.6889769527583693</c:v>
                </c:pt>
                <c:pt idx="465">
                  <c:v>7.7055480237772453</c:v>
                </c:pt>
                <c:pt idx="466">
                  <c:v>7.7221190947961205</c:v>
                </c:pt>
                <c:pt idx="467">
                  <c:v>7.7386901658149965</c:v>
                </c:pt>
                <c:pt idx="468">
                  <c:v>7.7552612368338725</c:v>
                </c:pt>
                <c:pt idx="469">
                  <c:v>7.7718323078527485</c:v>
                </c:pt>
                <c:pt idx="470">
                  <c:v>7.7884033788716245</c:v>
                </c:pt>
                <c:pt idx="471">
                  <c:v>7.8049744498904996</c:v>
                </c:pt>
                <c:pt idx="472">
                  <c:v>7.8215455209093756</c:v>
                </c:pt>
                <c:pt idx="473">
                  <c:v>7.8381165919282516</c:v>
                </c:pt>
                <c:pt idx="474">
                  <c:v>7.8546876629471276</c:v>
                </c:pt>
                <c:pt idx="475">
                  <c:v>7.8712587339660027</c:v>
                </c:pt>
                <c:pt idx="476">
                  <c:v>7.8878298049848787</c:v>
                </c:pt>
                <c:pt idx="477">
                  <c:v>7.9044008760037547</c:v>
                </c:pt>
                <c:pt idx="478">
                  <c:v>7.9209719470226307</c:v>
                </c:pt>
                <c:pt idx="479">
                  <c:v>7.9375430180415059</c:v>
                </c:pt>
                <c:pt idx="480">
                  <c:v>7.9541140890603819</c:v>
                </c:pt>
                <c:pt idx="481">
                  <c:v>7.9706851600792579</c:v>
                </c:pt>
                <c:pt idx="482">
                  <c:v>7.9872562310981339</c:v>
                </c:pt>
                <c:pt idx="483">
                  <c:v>8.0038273021170099</c:v>
                </c:pt>
                <c:pt idx="484">
                  <c:v>8.020398373135885</c:v>
                </c:pt>
                <c:pt idx="485">
                  <c:v>8.0369694441547619</c:v>
                </c:pt>
                <c:pt idx="486">
                  <c:v>8.053540515173637</c:v>
                </c:pt>
                <c:pt idx="487">
                  <c:v>8.0701115861925121</c:v>
                </c:pt>
                <c:pt idx="488">
                  <c:v>8.086682657211389</c:v>
                </c:pt>
                <c:pt idx="489">
                  <c:v>8.1032537282302641</c:v>
                </c:pt>
                <c:pt idx="490">
                  <c:v>8.1198247992491392</c:v>
                </c:pt>
                <c:pt idx="491">
                  <c:v>8.1363958702680161</c:v>
                </c:pt>
                <c:pt idx="492">
                  <c:v>8.1529669412868913</c:v>
                </c:pt>
                <c:pt idx="493">
                  <c:v>8.1695380123057681</c:v>
                </c:pt>
                <c:pt idx="494">
                  <c:v>8.1861090833246433</c:v>
                </c:pt>
                <c:pt idx="495">
                  <c:v>8.2026801543435184</c:v>
                </c:pt>
                <c:pt idx="496">
                  <c:v>8.2192512253623953</c:v>
                </c:pt>
                <c:pt idx="497">
                  <c:v>8.2358222963812704</c:v>
                </c:pt>
                <c:pt idx="498">
                  <c:v>8.2523933674001455</c:v>
                </c:pt>
                <c:pt idx="499">
                  <c:v>8.2689644384190224</c:v>
                </c:pt>
                <c:pt idx="500">
                  <c:v>8.2855355094378975</c:v>
                </c:pt>
                <c:pt idx="501">
                  <c:v>8.3021065804567744</c:v>
                </c:pt>
                <c:pt idx="502">
                  <c:v>8.3186776514756495</c:v>
                </c:pt>
                <c:pt idx="503">
                  <c:v>8.3352487224945246</c:v>
                </c:pt>
                <c:pt idx="504">
                  <c:v>8.3518197935134015</c:v>
                </c:pt>
                <c:pt idx="505">
                  <c:v>8.3683908645322767</c:v>
                </c:pt>
                <c:pt idx="506">
                  <c:v>8.3849619355511535</c:v>
                </c:pt>
                <c:pt idx="507">
                  <c:v>8.4015330065700287</c:v>
                </c:pt>
                <c:pt idx="508">
                  <c:v>8.4181040775889038</c:v>
                </c:pt>
                <c:pt idx="509">
                  <c:v>8.4346751486077807</c:v>
                </c:pt>
                <c:pt idx="510">
                  <c:v>8.4512462196266558</c:v>
                </c:pt>
                <c:pt idx="511">
                  <c:v>8.4678172906455309</c:v>
                </c:pt>
                <c:pt idx="512">
                  <c:v>8.4843883616644078</c:v>
                </c:pt>
                <c:pt idx="513">
                  <c:v>8.5009594326832829</c:v>
                </c:pt>
                <c:pt idx="514">
                  <c:v>8.5175305037021598</c:v>
                </c:pt>
                <c:pt idx="515">
                  <c:v>8.5341015747210349</c:v>
                </c:pt>
                <c:pt idx="516">
                  <c:v>8.55067264573991</c:v>
                </c:pt>
                <c:pt idx="517">
                  <c:v>8.5672437167587869</c:v>
                </c:pt>
                <c:pt idx="518">
                  <c:v>8.583814787777662</c:v>
                </c:pt>
                <c:pt idx="519">
                  <c:v>8.6003858587965389</c:v>
                </c:pt>
                <c:pt idx="520">
                  <c:v>8.6169569298154141</c:v>
                </c:pt>
                <c:pt idx="521">
                  <c:v>8.6335280008342892</c:v>
                </c:pt>
                <c:pt idx="522">
                  <c:v>8.6500990718531661</c:v>
                </c:pt>
                <c:pt idx="523">
                  <c:v>8.6666701428720412</c:v>
                </c:pt>
                <c:pt idx="524">
                  <c:v>8.6832412138909163</c:v>
                </c:pt>
                <c:pt idx="525">
                  <c:v>8.6998122849097932</c:v>
                </c:pt>
                <c:pt idx="526">
                  <c:v>8.7163833559286683</c:v>
                </c:pt>
                <c:pt idx="527">
                  <c:v>8.7329544269475452</c:v>
                </c:pt>
                <c:pt idx="528">
                  <c:v>8.7495254979664203</c:v>
                </c:pt>
                <c:pt idx="529">
                  <c:v>8.7660965689852954</c:v>
                </c:pt>
                <c:pt idx="530">
                  <c:v>8.7826676400041723</c:v>
                </c:pt>
                <c:pt idx="531">
                  <c:v>8.7992387110230474</c:v>
                </c:pt>
                <c:pt idx="532">
                  <c:v>8.8158097820419226</c:v>
                </c:pt>
                <c:pt idx="533">
                  <c:v>8.8323808530607995</c:v>
                </c:pt>
                <c:pt idx="534">
                  <c:v>8.8489519240796746</c:v>
                </c:pt>
                <c:pt idx="535">
                  <c:v>8.8655229950985515</c:v>
                </c:pt>
                <c:pt idx="536">
                  <c:v>8.8820940661174266</c:v>
                </c:pt>
                <c:pt idx="537">
                  <c:v>8.8986651371363017</c:v>
                </c:pt>
                <c:pt idx="538">
                  <c:v>8.9152362081551786</c:v>
                </c:pt>
                <c:pt idx="539">
                  <c:v>8.9318072791740537</c:v>
                </c:pt>
                <c:pt idx="540">
                  <c:v>8.9483783501929306</c:v>
                </c:pt>
                <c:pt idx="541">
                  <c:v>8.9649494212118057</c:v>
                </c:pt>
                <c:pt idx="542">
                  <c:v>8.9815204922306808</c:v>
                </c:pt>
                <c:pt idx="543">
                  <c:v>8.9980915632495577</c:v>
                </c:pt>
                <c:pt idx="544">
                  <c:v>9.0146626342684328</c:v>
                </c:pt>
                <c:pt idx="545">
                  <c:v>9.031233705287308</c:v>
                </c:pt>
                <c:pt idx="546">
                  <c:v>9.0478047763061848</c:v>
                </c:pt>
                <c:pt idx="547">
                  <c:v>9.06437584732506</c:v>
                </c:pt>
                <c:pt idx="548">
                  <c:v>9.0809469183439369</c:v>
                </c:pt>
                <c:pt idx="549">
                  <c:v>9.097517989362812</c:v>
                </c:pt>
                <c:pt idx="550">
                  <c:v>9.1140890603816871</c:v>
                </c:pt>
                <c:pt idx="551">
                  <c:v>9.130660131400564</c:v>
                </c:pt>
                <c:pt idx="552">
                  <c:v>9.1472312024194391</c:v>
                </c:pt>
                <c:pt idx="553">
                  <c:v>9.163802273438316</c:v>
                </c:pt>
                <c:pt idx="554">
                  <c:v>9.1803733444571911</c:v>
                </c:pt>
                <c:pt idx="555">
                  <c:v>9.1969444154760662</c:v>
                </c:pt>
                <c:pt idx="556">
                  <c:v>9.2135154864949431</c:v>
                </c:pt>
                <c:pt idx="557">
                  <c:v>9.2300865575138182</c:v>
                </c:pt>
                <c:pt idx="558">
                  <c:v>9.2466576285326934</c:v>
                </c:pt>
                <c:pt idx="559">
                  <c:v>9.2632286995515702</c:v>
                </c:pt>
                <c:pt idx="560">
                  <c:v>9.2797997705704454</c:v>
                </c:pt>
                <c:pt idx="561">
                  <c:v>9.2963708415893223</c:v>
                </c:pt>
                <c:pt idx="562">
                  <c:v>9.3129419126081974</c:v>
                </c:pt>
                <c:pt idx="563">
                  <c:v>9.3295129836270725</c:v>
                </c:pt>
                <c:pt idx="564">
                  <c:v>9.3460840546459494</c:v>
                </c:pt>
                <c:pt idx="565">
                  <c:v>9.3626551256648245</c:v>
                </c:pt>
                <c:pt idx="566">
                  <c:v>9.3792261966836996</c:v>
                </c:pt>
                <c:pt idx="567">
                  <c:v>9.3957972677025765</c:v>
                </c:pt>
                <c:pt idx="568">
                  <c:v>9.4123683387214516</c:v>
                </c:pt>
                <c:pt idx="569">
                  <c:v>9.4289394097403285</c:v>
                </c:pt>
                <c:pt idx="570">
                  <c:v>9.4455104807592036</c:v>
                </c:pt>
                <c:pt idx="571">
                  <c:v>9.4620815517780787</c:v>
                </c:pt>
                <c:pt idx="572">
                  <c:v>9.4786526227969556</c:v>
                </c:pt>
                <c:pt idx="573">
                  <c:v>9.4952236938158308</c:v>
                </c:pt>
                <c:pt idx="574">
                  <c:v>9.5117947648347076</c:v>
                </c:pt>
                <c:pt idx="575">
                  <c:v>9.5283658358535828</c:v>
                </c:pt>
                <c:pt idx="576">
                  <c:v>9.5449369068724579</c:v>
                </c:pt>
                <c:pt idx="577">
                  <c:v>9.5615079778913348</c:v>
                </c:pt>
                <c:pt idx="578">
                  <c:v>9.5780790489102099</c:v>
                </c:pt>
                <c:pt idx="579">
                  <c:v>9.594650119929085</c:v>
                </c:pt>
                <c:pt idx="580">
                  <c:v>9.6112211909479619</c:v>
                </c:pt>
                <c:pt idx="581">
                  <c:v>9.627792261966837</c:v>
                </c:pt>
                <c:pt idx="582">
                  <c:v>9.6443633329857139</c:v>
                </c:pt>
                <c:pt idx="583">
                  <c:v>9.660934404004589</c:v>
                </c:pt>
                <c:pt idx="584">
                  <c:v>9.6775054750234641</c:v>
                </c:pt>
                <c:pt idx="585">
                  <c:v>9.694076546042341</c:v>
                </c:pt>
                <c:pt idx="586">
                  <c:v>9.7106476170612162</c:v>
                </c:pt>
                <c:pt idx="587">
                  <c:v>9.727218688080093</c:v>
                </c:pt>
                <c:pt idx="588">
                  <c:v>9.7437897590989682</c:v>
                </c:pt>
                <c:pt idx="589">
                  <c:v>9.7603608301178433</c:v>
                </c:pt>
                <c:pt idx="590">
                  <c:v>9.7769319011367202</c:v>
                </c:pt>
                <c:pt idx="591">
                  <c:v>9.7935029721555953</c:v>
                </c:pt>
                <c:pt idx="592">
                  <c:v>9.8100740431744704</c:v>
                </c:pt>
                <c:pt idx="593">
                  <c:v>9.8266451141933473</c:v>
                </c:pt>
                <c:pt idx="594">
                  <c:v>9.8432161852122224</c:v>
                </c:pt>
                <c:pt idx="595">
                  <c:v>9.8597872562310993</c:v>
                </c:pt>
                <c:pt idx="596">
                  <c:v>9.8763583272499744</c:v>
                </c:pt>
                <c:pt idx="597">
                  <c:v>9.8929293982688495</c:v>
                </c:pt>
                <c:pt idx="598">
                  <c:v>9.9095004692877264</c:v>
                </c:pt>
                <c:pt idx="599">
                  <c:v>9.9260715403066015</c:v>
                </c:pt>
                <c:pt idx="600">
                  <c:v>9.9426426113254767</c:v>
                </c:pt>
                <c:pt idx="601">
                  <c:v>9.9592136823443536</c:v>
                </c:pt>
                <c:pt idx="602">
                  <c:v>9.9757847533632287</c:v>
                </c:pt>
                <c:pt idx="603">
                  <c:v>9.9923558243821056</c:v>
                </c:pt>
                <c:pt idx="604">
                  <c:v>10.008926895400981</c:v>
                </c:pt>
                <c:pt idx="605">
                  <c:v>10.025497966419856</c:v>
                </c:pt>
                <c:pt idx="606">
                  <c:v>10.042069037438733</c:v>
                </c:pt>
                <c:pt idx="607">
                  <c:v>10.058640108457608</c:v>
                </c:pt>
                <c:pt idx="608">
                  <c:v>10.075211179476485</c:v>
                </c:pt>
                <c:pt idx="609">
                  <c:v>10.09178225049536</c:v>
                </c:pt>
                <c:pt idx="610">
                  <c:v>10.108353321514235</c:v>
                </c:pt>
                <c:pt idx="611">
                  <c:v>10.124924392533112</c:v>
                </c:pt>
                <c:pt idx="612">
                  <c:v>10.141495463551987</c:v>
                </c:pt>
                <c:pt idx="613">
                  <c:v>10.158066534570862</c:v>
                </c:pt>
                <c:pt idx="614">
                  <c:v>10.174637605589739</c:v>
                </c:pt>
                <c:pt idx="615">
                  <c:v>10.191208676608614</c:v>
                </c:pt>
                <c:pt idx="616">
                  <c:v>10.207779747627491</c:v>
                </c:pt>
                <c:pt idx="617">
                  <c:v>10.224350818646366</c:v>
                </c:pt>
                <c:pt idx="618">
                  <c:v>10.240921889665241</c:v>
                </c:pt>
                <c:pt idx="619">
                  <c:v>10.257492960684118</c:v>
                </c:pt>
                <c:pt idx="620">
                  <c:v>10.274064031702993</c:v>
                </c:pt>
                <c:pt idx="621">
                  <c:v>10.29063510272187</c:v>
                </c:pt>
                <c:pt idx="622">
                  <c:v>10.307206173740745</c:v>
                </c:pt>
                <c:pt idx="623">
                  <c:v>10.32377724475962</c:v>
                </c:pt>
                <c:pt idx="624">
                  <c:v>10.340348315778497</c:v>
                </c:pt>
                <c:pt idx="625">
                  <c:v>10.356919386797372</c:v>
                </c:pt>
                <c:pt idx="626">
                  <c:v>10.373490457816247</c:v>
                </c:pt>
                <c:pt idx="627">
                  <c:v>10.390061528835124</c:v>
                </c:pt>
                <c:pt idx="628">
                  <c:v>10.406632599853999</c:v>
                </c:pt>
                <c:pt idx="629">
                  <c:v>10.423203670872876</c:v>
                </c:pt>
                <c:pt idx="630">
                  <c:v>10.439774741891751</c:v>
                </c:pt>
                <c:pt idx="631">
                  <c:v>10.456345812910627</c:v>
                </c:pt>
                <c:pt idx="632">
                  <c:v>10.472916883929503</c:v>
                </c:pt>
                <c:pt idx="633">
                  <c:v>10.489487954948379</c:v>
                </c:pt>
                <c:pt idx="634">
                  <c:v>10.506059025967254</c:v>
                </c:pt>
                <c:pt idx="635">
                  <c:v>10.522630096986131</c:v>
                </c:pt>
                <c:pt idx="636">
                  <c:v>10.539201168005006</c:v>
                </c:pt>
                <c:pt idx="637">
                  <c:v>10.555772239023883</c:v>
                </c:pt>
                <c:pt idx="638">
                  <c:v>10.572343310042758</c:v>
                </c:pt>
                <c:pt idx="639">
                  <c:v>10.588914381061633</c:v>
                </c:pt>
                <c:pt idx="640">
                  <c:v>10.60548545208051</c:v>
                </c:pt>
                <c:pt idx="641">
                  <c:v>10.622056523099385</c:v>
                </c:pt>
                <c:pt idx="642">
                  <c:v>10.638627594118262</c:v>
                </c:pt>
                <c:pt idx="643">
                  <c:v>10.655198665137137</c:v>
                </c:pt>
                <c:pt idx="644">
                  <c:v>10.671769736156012</c:v>
                </c:pt>
                <c:pt idx="645">
                  <c:v>10.688340807174889</c:v>
                </c:pt>
                <c:pt idx="646">
                  <c:v>10.704911878193764</c:v>
                </c:pt>
                <c:pt idx="647">
                  <c:v>10.721482949212639</c:v>
                </c:pt>
                <c:pt idx="648">
                  <c:v>10.738054020231516</c:v>
                </c:pt>
                <c:pt idx="649">
                  <c:v>10.754625091250391</c:v>
                </c:pt>
                <c:pt idx="650">
                  <c:v>10.771196162269268</c:v>
                </c:pt>
                <c:pt idx="651">
                  <c:v>10.787767233288143</c:v>
                </c:pt>
                <c:pt idx="652">
                  <c:v>10.804338304307018</c:v>
                </c:pt>
                <c:pt idx="653">
                  <c:v>10.820909375325895</c:v>
                </c:pt>
                <c:pt idx="654">
                  <c:v>10.83748044634477</c:v>
                </c:pt>
                <c:pt idx="655">
                  <c:v>10.854051517363647</c:v>
                </c:pt>
                <c:pt idx="656">
                  <c:v>10.870622588382522</c:v>
                </c:pt>
                <c:pt idx="657">
                  <c:v>10.887193659401397</c:v>
                </c:pt>
                <c:pt idx="658">
                  <c:v>10.903764730420274</c:v>
                </c:pt>
                <c:pt idx="659">
                  <c:v>10.920335801439149</c:v>
                </c:pt>
                <c:pt idx="660">
                  <c:v>10.936906872458025</c:v>
                </c:pt>
                <c:pt idx="661">
                  <c:v>10.953477943476901</c:v>
                </c:pt>
                <c:pt idx="662">
                  <c:v>10.970049014495777</c:v>
                </c:pt>
                <c:pt idx="663">
                  <c:v>10.986620085514653</c:v>
                </c:pt>
                <c:pt idx="664">
                  <c:v>11.003191156533529</c:v>
                </c:pt>
                <c:pt idx="665">
                  <c:v>11.019762227552404</c:v>
                </c:pt>
                <c:pt idx="666">
                  <c:v>11.036333298571281</c:v>
                </c:pt>
                <c:pt idx="667">
                  <c:v>11.052904369590156</c:v>
                </c:pt>
                <c:pt idx="668">
                  <c:v>11.069475440609031</c:v>
                </c:pt>
                <c:pt idx="669">
                  <c:v>11.086046511627908</c:v>
                </c:pt>
                <c:pt idx="670">
                  <c:v>11.102617582646783</c:v>
                </c:pt>
                <c:pt idx="671">
                  <c:v>11.11918865366566</c:v>
                </c:pt>
                <c:pt idx="672">
                  <c:v>11.135759724684535</c:v>
                </c:pt>
                <c:pt idx="673">
                  <c:v>11.15233079570341</c:v>
                </c:pt>
                <c:pt idx="674">
                  <c:v>11.168901866722287</c:v>
                </c:pt>
                <c:pt idx="675">
                  <c:v>11.185472937741162</c:v>
                </c:pt>
                <c:pt idx="676">
                  <c:v>11.202044008760039</c:v>
                </c:pt>
                <c:pt idx="677">
                  <c:v>11.218615079778914</c:v>
                </c:pt>
                <c:pt idx="678">
                  <c:v>11.235186150797789</c:v>
                </c:pt>
                <c:pt idx="679">
                  <c:v>11.251757221816666</c:v>
                </c:pt>
                <c:pt idx="680">
                  <c:v>11.268328292835541</c:v>
                </c:pt>
                <c:pt idx="681">
                  <c:v>11.284899363854416</c:v>
                </c:pt>
                <c:pt idx="682">
                  <c:v>11.301470434873293</c:v>
                </c:pt>
                <c:pt idx="683">
                  <c:v>11.318041505892168</c:v>
                </c:pt>
                <c:pt idx="684">
                  <c:v>11.334612576911045</c:v>
                </c:pt>
                <c:pt idx="685">
                  <c:v>11.35118364792992</c:v>
                </c:pt>
                <c:pt idx="686">
                  <c:v>11.367754718948795</c:v>
                </c:pt>
                <c:pt idx="687">
                  <c:v>11.384325789967672</c:v>
                </c:pt>
                <c:pt idx="688">
                  <c:v>11.400896860986547</c:v>
                </c:pt>
                <c:pt idx="689">
                  <c:v>11.417467932005424</c:v>
                </c:pt>
                <c:pt idx="690">
                  <c:v>11.434039003024299</c:v>
                </c:pt>
                <c:pt idx="691">
                  <c:v>11.450610074043174</c:v>
                </c:pt>
                <c:pt idx="692">
                  <c:v>11.467181145062051</c:v>
                </c:pt>
                <c:pt idx="693">
                  <c:v>11.483752216080926</c:v>
                </c:pt>
                <c:pt idx="694">
                  <c:v>11.500323287099802</c:v>
                </c:pt>
                <c:pt idx="695">
                  <c:v>11.516894358118678</c:v>
                </c:pt>
                <c:pt idx="696">
                  <c:v>11.533465429137554</c:v>
                </c:pt>
                <c:pt idx="697">
                  <c:v>11.55003650015643</c:v>
                </c:pt>
                <c:pt idx="698">
                  <c:v>11.566607571175306</c:v>
                </c:pt>
                <c:pt idx="699">
                  <c:v>11.583178642194181</c:v>
                </c:pt>
                <c:pt idx="700">
                  <c:v>11.599749713213058</c:v>
                </c:pt>
                <c:pt idx="701">
                  <c:v>11.616320784231933</c:v>
                </c:pt>
                <c:pt idx="702">
                  <c:v>11.63289185525081</c:v>
                </c:pt>
                <c:pt idx="703">
                  <c:v>11.649462926269685</c:v>
                </c:pt>
                <c:pt idx="704">
                  <c:v>11.66603399728856</c:v>
                </c:pt>
                <c:pt idx="705">
                  <c:v>11.682605068307437</c:v>
                </c:pt>
                <c:pt idx="706">
                  <c:v>11.699176139326312</c:v>
                </c:pt>
                <c:pt idx="707">
                  <c:v>11.715747210345187</c:v>
                </c:pt>
                <c:pt idx="708">
                  <c:v>11.732318281364064</c:v>
                </c:pt>
                <c:pt idx="709">
                  <c:v>11.748889352382939</c:v>
                </c:pt>
                <c:pt idx="710">
                  <c:v>11.765460423401816</c:v>
                </c:pt>
                <c:pt idx="711">
                  <c:v>11.782031494420691</c:v>
                </c:pt>
                <c:pt idx="712">
                  <c:v>11.798602565439566</c:v>
                </c:pt>
                <c:pt idx="713">
                  <c:v>11.815173636458443</c:v>
                </c:pt>
                <c:pt idx="714">
                  <c:v>11.831744707477318</c:v>
                </c:pt>
                <c:pt idx="715">
                  <c:v>11.848315778496193</c:v>
                </c:pt>
                <c:pt idx="716">
                  <c:v>11.86488684951507</c:v>
                </c:pt>
                <c:pt idx="717">
                  <c:v>11.881457920533945</c:v>
                </c:pt>
                <c:pt idx="718">
                  <c:v>11.898028991552822</c:v>
                </c:pt>
                <c:pt idx="719">
                  <c:v>11.914600062571697</c:v>
                </c:pt>
                <c:pt idx="720">
                  <c:v>11.931171133590572</c:v>
                </c:pt>
                <c:pt idx="721">
                  <c:v>11.947742204609449</c:v>
                </c:pt>
                <c:pt idx="722">
                  <c:v>11.964313275628324</c:v>
                </c:pt>
                <c:pt idx="723">
                  <c:v>11.980884346647201</c:v>
                </c:pt>
                <c:pt idx="724">
                  <c:v>11.997455417666076</c:v>
                </c:pt>
                <c:pt idx="725">
                  <c:v>12.014026488684951</c:v>
                </c:pt>
                <c:pt idx="726">
                  <c:v>12.030597559703828</c:v>
                </c:pt>
                <c:pt idx="727">
                  <c:v>12.047168630722703</c:v>
                </c:pt>
                <c:pt idx="728">
                  <c:v>12.063739701741579</c:v>
                </c:pt>
                <c:pt idx="729">
                  <c:v>12.080310772760456</c:v>
                </c:pt>
                <c:pt idx="730">
                  <c:v>12.096881843779331</c:v>
                </c:pt>
                <c:pt idx="731">
                  <c:v>12.113452914798208</c:v>
                </c:pt>
                <c:pt idx="732">
                  <c:v>12.130023985817083</c:v>
                </c:pt>
                <c:pt idx="733">
                  <c:v>12.146595056835958</c:v>
                </c:pt>
                <c:pt idx="734">
                  <c:v>12.163166127854835</c:v>
                </c:pt>
                <c:pt idx="735">
                  <c:v>12.17973719887371</c:v>
                </c:pt>
                <c:pt idx="736">
                  <c:v>12.196308269892587</c:v>
                </c:pt>
                <c:pt idx="737">
                  <c:v>12.212879340911462</c:v>
                </c:pt>
                <c:pt idx="738">
                  <c:v>12.229450411930337</c:v>
                </c:pt>
                <c:pt idx="739">
                  <c:v>12.246021482949214</c:v>
                </c:pt>
                <c:pt idx="740">
                  <c:v>12.262592553968089</c:v>
                </c:pt>
                <c:pt idx="741">
                  <c:v>12.279163624986964</c:v>
                </c:pt>
                <c:pt idx="742">
                  <c:v>12.295734696005841</c:v>
                </c:pt>
                <c:pt idx="743">
                  <c:v>12.312305767024716</c:v>
                </c:pt>
                <c:pt idx="744">
                  <c:v>12.328876838043593</c:v>
                </c:pt>
                <c:pt idx="745">
                  <c:v>12.345447909062468</c:v>
                </c:pt>
                <c:pt idx="746">
                  <c:v>12.362018980081343</c:v>
                </c:pt>
                <c:pt idx="747">
                  <c:v>12.37859005110022</c:v>
                </c:pt>
                <c:pt idx="748">
                  <c:v>12.395161122119095</c:v>
                </c:pt>
                <c:pt idx="749">
                  <c:v>12.41173219313797</c:v>
                </c:pt>
                <c:pt idx="750">
                  <c:v>12.428303264156847</c:v>
                </c:pt>
                <c:pt idx="751">
                  <c:v>12.444874335175722</c:v>
                </c:pt>
                <c:pt idx="752">
                  <c:v>12.461445406194599</c:v>
                </c:pt>
                <c:pt idx="753">
                  <c:v>12.478016477213474</c:v>
                </c:pt>
                <c:pt idx="754">
                  <c:v>12.494587548232349</c:v>
                </c:pt>
                <c:pt idx="755">
                  <c:v>12.511158619251226</c:v>
                </c:pt>
                <c:pt idx="756">
                  <c:v>12.527729690270101</c:v>
                </c:pt>
                <c:pt idx="757">
                  <c:v>12.544300761288978</c:v>
                </c:pt>
                <c:pt idx="758">
                  <c:v>12.560871832307853</c:v>
                </c:pt>
                <c:pt idx="759">
                  <c:v>12.577442903326729</c:v>
                </c:pt>
                <c:pt idx="760">
                  <c:v>12.594013974345605</c:v>
                </c:pt>
                <c:pt idx="761">
                  <c:v>12.610585045364481</c:v>
                </c:pt>
                <c:pt idx="762">
                  <c:v>12.627156116383356</c:v>
                </c:pt>
                <c:pt idx="763">
                  <c:v>12.643727187402233</c:v>
                </c:pt>
                <c:pt idx="764">
                  <c:v>12.660298258421108</c:v>
                </c:pt>
                <c:pt idx="765">
                  <c:v>12.676869329439985</c:v>
                </c:pt>
                <c:pt idx="766">
                  <c:v>12.69344040045886</c:v>
                </c:pt>
                <c:pt idx="767">
                  <c:v>12.710011471477735</c:v>
                </c:pt>
                <c:pt idx="768">
                  <c:v>12.726582542496612</c:v>
                </c:pt>
                <c:pt idx="769">
                  <c:v>12.743153613515487</c:v>
                </c:pt>
                <c:pt idx="770">
                  <c:v>12.759724684534364</c:v>
                </c:pt>
                <c:pt idx="771">
                  <c:v>12.776295755553239</c:v>
                </c:pt>
                <c:pt idx="772">
                  <c:v>12.792866826572114</c:v>
                </c:pt>
                <c:pt idx="773">
                  <c:v>12.809437897590991</c:v>
                </c:pt>
                <c:pt idx="774">
                  <c:v>12.826008968609866</c:v>
                </c:pt>
                <c:pt idx="775">
                  <c:v>12.842580039628741</c:v>
                </c:pt>
                <c:pt idx="776">
                  <c:v>12.859151110647618</c:v>
                </c:pt>
                <c:pt idx="777">
                  <c:v>12.875722181666493</c:v>
                </c:pt>
                <c:pt idx="778">
                  <c:v>12.89229325268537</c:v>
                </c:pt>
                <c:pt idx="779">
                  <c:v>12.908864323704245</c:v>
                </c:pt>
                <c:pt idx="780">
                  <c:v>12.92543539472312</c:v>
                </c:pt>
                <c:pt idx="781">
                  <c:v>12.942006465741997</c:v>
                </c:pt>
                <c:pt idx="782">
                  <c:v>12.958577536760872</c:v>
                </c:pt>
                <c:pt idx="783">
                  <c:v>12.975148607779747</c:v>
                </c:pt>
                <c:pt idx="784">
                  <c:v>12.991719678798624</c:v>
                </c:pt>
                <c:pt idx="785">
                  <c:v>13.008290749817499</c:v>
                </c:pt>
                <c:pt idx="786">
                  <c:v>13.024861820836376</c:v>
                </c:pt>
                <c:pt idx="787">
                  <c:v>13.041432891855251</c:v>
                </c:pt>
                <c:pt idx="788">
                  <c:v>13.058003962874126</c:v>
                </c:pt>
                <c:pt idx="789">
                  <c:v>13.074575033893003</c:v>
                </c:pt>
                <c:pt idx="790">
                  <c:v>13.091146104911878</c:v>
                </c:pt>
                <c:pt idx="791">
                  <c:v>13.107717175930755</c:v>
                </c:pt>
                <c:pt idx="792">
                  <c:v>13.12428824694963</c:v>
                </c:pt>
                <c:pt idx="793">
                  <c:v>13.140859317968506</c:v>
                </c:pt>
                <c:pt idx="794">
                  <c:v>13.157430388987382</c:v>
                </c:pt>
                <c:pt idx="795">
                  <c:v>13.174001460006258</c:v>
                </c:pt>
                <c:pt idx="796">
                  <c:v>13.190572531025133</c:v>
                </c:pt>
                <c:pt idx="797">
                  <c:v>13.20714360204401</c:v>
                </c:pt>
                <c:pt idx="798">
                  <c:v>13.223714673062885</c:v>
                </c:pt>
                <c:pt idx="799">
                  <c:v>13.240285744081762</c:v>
                </c:pt>
                <c:pt idx="800">
                  <c:v>13.256856815100637</c:v>
                </c:pt>
                <c:pt idx="801">
                  <c:v>13.273427886119512</c:v>
                </c:pt>
                <c:pt idx="802">
                  <c:v>13.289998957138389</c:v>
                </c:pt>
                <c:pt idx="803">
                  <c:v>13.306570028157264</c:v>
                </c:pt>
                <c:pt idx="804">
                  <c:v>13.323141099176141</c:v>
                </c:pt>
                <c:pt idx="805">
                  <c:v>13.339712170195016</c:v>
                </c:pt>
                <c:pt idx="806">
                  <c:v>13.356283241213891</c:v>
                </c:pt>
                <c:pt idx="807">
                  <c:v>13.372854312232768</c:v>
                </c:pt>
                <c:pt idx="808">
                  <c:v>13.389425383251643</c:v>
                </c:pt>
                <c:pt idx="809">
                  <c:v>13.405996454270518</c:v>
                </c:pt>
                <c:pt idx="810">
                  <c:v>13.422567525289395</c:v>
                </c:pt>
                <c:pt idx="811">
                  <c:v>13.43913859630827</c:v>
                </c:pt>
                <c:pt idx="812">
                  <c:v>13.455709667327147</c:v>
                </c:pt>
                <c:pt idx="813">
                  <c:v>13.472280738346022</c:v>
                </c:pt>
                <c:pt idx="814">
                  <c:v>13.488851809364897</c:v>
                </c:pt>
                <c:pt idx="815">
                  <c:v>13.505422880383774</c:v>
                </c:pt>
                <c:pt idx="816">
                  <c:v>13.521993951402649</c:v>
                </c:pt>
                <c:pt idx="817">
                  <c:v>13.538565022421524</c:v>
                </c:pt>
                <c:pt idx="818">
                  <c:v>13.555136093440401</c:v>
                </c:pt>
                <c:pt idx="819">
                  <c:v>13.571707164459276</c:v>
                </c:pt>
                <c:pt idx="820">
                  <c:v>13.588278235478153</c:v>
                </c:pt>
                <c:pt idx="821">
                  <c:v>13.604849306497028</c:v>
                </c:pt>
                <c:pt idx="822">
                  <c:v>13.621420377515904</c:v>
                </c:pt>
                <c:pt idx="823">
                  <c:v>13.63799144853478</c:v>
                </c:pt>
                <c:pt idx="824">
                  <c:v>13.654562519553656</c:v>
                </c:pt>
                <c:pt idx="825">
                  <c:v>13.671133590572532</c:v>
                </c:pt>
                <c:pt idx="826">
                  <c:v>13.687704661591408</c:v>
                </c:pt>
                <c:pt idx="827">
                  <c:v>13.704275732610283</c:v>
                </c:pt>
                <c:pt idx="828">
                  <c:v>13.72084680362916</c:v>
                </c:pt>
                <c:pt idx="829">
                  <c:v>13.737417874648035</c:v>
                </c:pt>
                <c:pt idx="830">
                  <c:v>13.75398894566691</c:v>
                </c:pt>
                <c:pt idx="831">
                  <c:v>13.770560016685787</c:v>
                </c:pt>
                <c:pt idx="832">
                  <c:v>13.787131087704662</c:v>
                </c:pt>
                <c:pt idx="833">
                  <c:v>13.803702158723539</c:v>
                </c:pt>
                <c:pt idx="834">
                  <c:v>13.820273229742414</c:v>
                </c:pt>
                <c:pt idx="835">
                  <c:v>13.836844300761289</c:v>
                </c:pt>
                <c:pt idx="836">
                  <c:v>13.853415371780166</c:v>
                </c:pt>
                <c:pt idx="837">
                  <c:v>13.869986442799041</c:v>
                </c:pt>
                <c:pt idx="838">
                  <c:v>13.886557513817918</c:v>
                </c:pt>
                <c:pt idx="839">
                  <c:v>13.903128584836793</c:v>
                </c:pt>
                <c:pt idx="840">
                  <c:v>13.919699655855668</c:v>
                </c:pt>
                <c:pt idx="841">
                  <c:v>13.936270726874545</c:v>
                </c:pt>
                <c:pt idx="842">
                  <c:v>13.95284179789342</c:v>
                </c:pt>
                <c:pt idx="843">
                  <c:v>13.969412868912295</c:v>
                </c:pt>
                <c:pt idx="844">
                  <c:v>13.985983939931172</c:v>
                </c:pt>
                <c:pt idx="845">
                  <c:v>14.002555010950047</c:v>
                </c:pt>
                <c:pt idx="846">
                  <c:v>14.019126081968924</c:v>
                </c:pt>
                <c:pt idx="847">
                  <c:v>14.035697152987799</c:v>
                </c:pt>
                <c:pt idx="848">
                  <c:v>14.052268224006674</c:v>
                </c:pt>
                <c:pt idx="849">
                  <c:v>14.068839295025551</c:v>
                </c:pt>
                <c:pt idx="850">
                  <c:v>14.085410366044426</c:v>
                </c:pt>
                <c:pt idx="851">
                  <c:v>14.101981437063301</c:v>
                </c:pt>
                <c:pt idx="852">
                  <c:v>14.118552508082178</c:v>
                </c:pt>
                <c:pt idx="853">
                  <c:v>14.135123579101053</c:v>
                </c:pt>
                <c:pt idx="854">
                  <c:v>14.15169465011993</c:v>
                </c:pt>
                <c:pt idx="855">
                  <c:v>14.168265721138805</c:v>
                </c:pt>
                <c:pt idx="856">
                  <c:v>14.184836792157681</c:v>
                </c:pt>
                <c:pt idx="857">
                  <c:v>14.201407863176557</c:v>
                </c:pt>
                <c:pt idx="858">
                  <c:v>14.217978934195433</c:v>
                </c:pt>
                <c:pt idx="859">
                  <c:v>14.234550005214309</c:v>
                </c:pt>
                <c:pt idx="860">
                  <c:v>14.251121076233185</c:v>
                </c:pt>
                <c:pt idx="861">
                  <c:v>14.26769214725206</c:v>
                </c:pt>
                <c:pt idx="862">
                  <c:v>14.284263218270937</c:v>
                </c:pt>
                <c:pt idx="863">
                  <c:v>14.300834289289812</c:v>
                </c:pt>
                <c:pt idx="864">
                  <c:v>14.317405360308687</c:v>
                </c:pt>
                <c:pt idx="865">
                  <c:v>14.333976431327564</c:v>
                </c:pt>
                <c:pt idx="866">
                  <c:v>14.350547502346439</c:v>
                </c:pt>
                <c:pt idx="867">
                  <c:v>14.367118573365316</c:v>
                </c:pt>
                <c:pt idx="868">
                  <c:v>14.383689644384191</c:v>
                </c:pt>
                <c:pt idx="869">
                  <c:v>14.400260715403066</c:v>
                </c:pt>
                <c:pt idx="870">
                  <c:v>14.416831786421943</c:v>
                </c:pt>
                <c:pt idx="871">
                  <c:v>14.433402857440818</c:v>
                </c:pt>
                <c:pt idx="872">
                  <c:v>14.449973928459695</c:v>
                </c:pt>
                <c:pt idx="873">
                  <c:v>14.46654499947857</c:v>
                </c:pt>
                <c:pt idx="874">
                  <c:v>14.483116070497445</c:v>
                </c:pt>
                <c:pt idx="875">
                  <c:v>14.499687141516322</c:v>
                </c:pt>
                <c:pt idx="876">
                  <c:v>14.516258212535197</c:v>
                </c:pt>
                <c:pt idx="877">
                  <c:v>14.532829283554072</c:v>
                </c:pt>
                <c:pt idx="878">
                  <c:v>14.549400354572949</c:v>
                </c:pt>
                <c:pt idx="879">
                  <c:v>14.565971425591824</c:v>
                </c:pt>
                <c:pt idx="880">
                  <c:v>14.582542496610701</c:v>
                </c:pt>
                <c:pt idx="881">
                  <c:v>14.599113567629576</c:v>
                </c:pt>
                <c:pt idx="882">
                  <c:v>14.615684638648451</c:v>
                </c:pt>
                <c:pt idx="883">
                  <c:v>14.632255709667328</c:v>
                </c:pt>
                <c:pt idx="884">
                  <c:v>14.648826780686203</c:v>
                </c:pt>
                <c:pt idx="885">
                  <c:v>14.665397851705078</c:v>
                </c:pt>
                <c:pt idx="886">
                  <c:v>14.681968922723955</c:v>
                </c:pt>
                <c:pt idx="887">
                  <c:v>14.69853999374283</c:v>
                </c:pt>
                <c:pt idx="888">
                  <c:v>14.715111064761707</c:v>
                </c:pt>
                <c:pt idx="889">
                  <c:v>14.731682135780582</c:v>
                </c:pt>
                <c:pt idx="890">
                  <c:v>14.748253206799458</c:v>
                </c:pt>
                <c:pt idx="891">
                  <c:v>14.764824277818335</c:v>
                </c:pt>
                <c:pt idx="892">
                  <c:v>14.78139534883721</c:v>
                </c:pt>
                <c:pt idx="893">
                  <c:v>14.797966419856087</c:v>
                </c:pt>
                <c:pt idx="894">
                  <c:v>14.814537490874962</c:v>
                </c:pt>
                <c:pt idx="895">
                  <c:v>14.831108561893837</c:v>
                </c:pt>
                <c:pt idx="896">
                  <c:v>14.847679632912714</c:v>
                </c:pt>
                <c:pt idx="897">
                  <c:v>14.864250703931589</c:v>
                </c:pt>
                <c:pt idx="898">
                  <c:v>14.880821774950464</c:v>
                </c:pt>
                <c:pt idx="899">
                  <c:v>14.897392845969341</c:v>
                </c:pt>
                <c:pt idx="900">
                  <c:v>14.913963916988216</c:v>
                </c:pt>
                <c:pt idx="901">
                  <c:v>14.930534988007093</c:v>
                </c:pt>
                <c:pt idx="902">
                  <c:v>14.947106059025968</c:v>
                </c:pt>
                <c:pt idx="903">
                  <c:v>14.963677130044843</c:v>
                </c:pt>
                <c:pt idx="904">
                  <c:v>14.98024820106372</c:v>
                </c:pt>
                <c:pt idx="905">
                  <c:v>14.996819272082595</c:v>
                </c:pt>
                <c:pt idx="906">
                  <c:v>15.013390343101472</c:v>
                </c:pt>
                <c:pt idx="907">
                  <c:v>15.029961414120347</c:v>
                </c:pt>
                <c:pt idx="908">
                  <c:v>15.046532485139222</c:v>
                </c:pt>
                <c:pt idx="909">
                  <c:v>15.063103556158099</c:v>
                </c:pt>
                <c:pt idx="910">
                  <c:v>15.079674627176974</c:v>
                </c:pt>
                <c:pt idx="911">
                  <c:v>15.096245698195849</c:v>
                </c:pt>
                <c:pt idx="912">
                  <c:v>15.112816769214726</c:v>
                </c:pt>
                <c:pt idx="913">
                  <c:v>15.129387840233601</c:v>
                </c:pt>
                <c:pt idx="914">
                  <c:v>15.145958911252478</c:v>
                </c:pt>
                <c:pt idx="915">
                  <c:v>15.162529982271353</c:v>
                </c:pt>
                <c:pt idx="916">
                  <c:v>15.179101053290228</c:v>
                </c:pt>
                <c:pt idx="917">
                  <c:v>15.195672124309105</c:v>
                </c:pt>
                <c:pt idx="918">
                  <c:v>15.21224319532798</c:v>
                </c:pt>
                <c:pt idx="919">
                  <c:v>15.228814266346857</c:v>
                </c:pt>
                <c:pt idx="920">
                  <c:v>15.245385337365732</c:v>
                </c:pt>
                <c:pt idx="921">
                  <c:v>15.261956408384608</c:v>
                </c:pt>
                <c:pt idx="922">
                  <c:v>15.278527479403484</c:v>
                </c:pt>
                <c:pt idx="923">
                  <c:v>15.29509855042236</c:v>
                </c:pt>
                <c:pt idx="924">
                  <c:v>15.311669621441235</c:v>
                </c:pt>
                <c:pt idx="925">
                  <c:v>15.328240692460112</c:v>
                </c:pt>
                <c:pt idx="926">
                  <c:v>15.344811763478987</c:v>
                </c:pt>
                <c:pt idx="927">
                  <c:v>15.361382834497864</c:v>
                </c:pt>
                <c:pt idx="928">
                  <c:v>15.377953905516739</c:v>
                </c:pt>
                <c:pt idx="929">
                  <c:v>15.394524976535614</c:v>
                </c:pt>
                <c:pt idx="930">
                  <c:v>15.411096047554491</c:v>
                </c:pt>
                <c:pt idx="931">
                  <c:v>15.427667118573366</c:v>
                </c:pt>
                <c:pt idx="932">
                  <c:v>15.444238189592241</c:v>
                </c:pt>
                <c:pt idx="933">
                  <c:v>15.460809260611118</c:v>
                </c:pt>
                <c:pt idx="934">
                  <c:v>15.477380331629993</c:v>
                </c:pt>
                <c:pt idx="935">
                  <c:v>15.49395140264887</c:v>
                </c:pt>
                <c:pt idx="936">
                  <c:v>15.510522473667745</c:v>
                </c:pt>
                <c:pt idx="937">
                  <c:v>15.52709354468662</c:v>
                </c:pt>
                <c:pt idx="938">
                  <c:v>15.543664615705497</c:v>
                </c:pt>
                <c:pt idx="939">
                  <c:v>15.560235686724372</c:v>
                </c:pt>
                <c:pt idx="940">
                  <c:v>15.576806757743249</c:v>
                </c:pt>
                <c:pt idx="941">
                  <c:v>15.593377828762124</c:v>
                </c:pt>
                <c:pt idx="942">
                  <c:v>15.609948899780999</c:v>
                </c:pt>
                <c:pt idx="943">
                  <c:v>15.626519970799876</c:v>
                </c:pt>
                <c:pt idx="944">
                  <c:v>15.643091041818751</c:v>
                </c:pt>
                <c:pt idx="945">
                  <c:v>15.659662112837626</c:v>
                </c:pt>
                <c:pt idx="946">
                  <c:v>15.676233183856503</c:v>
                </c:pt>
                <c:pt idx="947">
                  <c:v>15.692804254875378</c:v>
                </c:pt>
                <c:pt idx="948">
                  <c:v>15.709375325894255</c:v>
                </c:pt>
                <c:pt idx="949">
                  <c:v>15.72594639691313</c:v>
                </c:pt>
                <c:pt idx="950">
                  <c:v>15.742517467932005</c:v>
                </c:pt>
                <c:pt idx="951">
                  <c:v>15.759088538950882</c:v>
                </c:pt>
                <c:pt idx="952">
                  <c:v>15.775659609969757</c:v>
                </c:pt>
                <c:pt idx="953">
                  <c:v>15.792230680988634</c:v>
                </c:pt>
                <c:pt idx="954">
                  <c:v>15.808801752007509</c:v>
                </c:pt>
                <c:pt idx="955">
                  <c:v>15.825372823026385</c:v>
                </c:pt>
                <c:pt idx="956">
                  <c:v>15.841943894045261</c:v>
                </c:pt>
                <c:pt idx="957">
                  <c:v>15.858514965064137</c:v>
                </c:pt>
                <c:pt idx="958">
                  <c:v>15.875086036083012</c:v>
                </c:pt>
              </c:numCache>
            </c:numRef>
          </c:xVal>
          <c:yVal>
            <c:numRef>
              <c:f>Curves!$B$4:$B$962</c:f>
              <c:numCache>
                <c:formatCode>###0.00</c:formatCode>
                <c:ptCount val="959"/>
                <c:pt idx="0">
                  <c:v>3.0000000000000001E-3</c:v>
                </c:pt>
                <c:pt idx="1">
                  <c:v>6.0000000000000001E-3</c:v>
                </c:pt>
                <c:pt idx="2">
                  <c:v>1.4999999999999999E-2</c:v>
                </c:pt>
                <c:pt idx="3">
                  <c:v>5.0000000000000001E-3</c:v>
                </c:pt>
                <c:pt idx="4">
                  <c:v>-8.9999999999999993E-3</c:v>
                </c:pt>
                <c:pt idx="5">
                  <c:v>-0.02</c:v>
                </c:pt>
                <c:pt idx="6">
                  <c:v>1.6E-2</c:v>
                </c:pt>
                <c:pt idx="7">
                  <c:v>0.22700000000000001</c:v>
                </c:pt>
                <c:pt idx="8">
                  <c:v>0.57599999999999996</c:v>
                </c:pt>
                <c:pt idx="9">
                  <c:v>0.95199999999999996</c:v>
                </c:pt>
                <c:pt idx="10">
                  <c:v>1.256</c:v>
                </c:pt>
                <c:pt idx="11">
                  <c:v>1.52</c:v>
                </c:pt>
                <c:pt idx="12">
                  <c:v>1.647</c:v>
                </c:pt>
                <c:pt idx="13">
                  <c:v>1.5660000000000001</c:v>
                </c:pt>
                <c:pt idx="14">
                  <c:v>1.3859999999999999</c:v>
                </c:pt>
                <c:pt idx="15">
                  <c:v>1.206</c:v>
                </c:pt>
                <c:pt idx="16">
                  <c:v>1.083</c:v>
                </c:pt>
                <c:pt idx="17">
                  <c:v>1.006</c:v>
                </c:pt>
                <c:pt idx="18">
                  <c:v>0.94899999999999995</c:v>
                </c:pt>
                <c:pt idx="19">
                  <c:v>0.90400000000000003</c:v>
                </c:pt>
                <c:pt idx="20">
                  <c:v>0.86699999999999999</c:v>
                </c:pt>
                <c:pt idx="21">
                  <c:v>0.84399999999999997</c:v>
                </c:pt>
                <c:pt idx="22">
                  <c:v>0.81899999999999995</c:v>
                </c:pt>
                <c:pt idx="23">
                  <c:v>0.80100000000000005</c:v>
                </c:pt>
                <c:pt idx="24">
                  <c:v>0.78300000000000003</c:v>
                </c:pt>
                <c:pt idx="25">
                  <c:v>0.76800000000000002</c:v>
                </c:pt>
                <c:pt idx="26">
                  <c:v>0.75600000000000001</c:v>
                </c:pt>
                <c:pt idx="27">
                  <c:v>0.73699999999999999</c:v>
                </c:pt>
                <c:pt idx="28">
                  <c:v>0.72599999999999998</c:v>
                </c:pt>
                <c:pt idx="29">
                  <c:v>0.71599999999999997</c:v>
                </c:pt>
                <c:pt idx="30">
                  <c:v>0.70799999999999996</c:v>
                </c:pt>
                <c:pt idx="31">
                  <c:v>0.70199999999999996</c:v>
                </c:pt>
                <c:pt idx="32">
                  <c:v>0.69599999999999995</c:v>
                </c:pt>
                <c:pt idx="33">
                  <c:v>0.68600000000000005</c:v>
                </c:pt>
                <c:pt idx="34">
                  <c:v>0.67800000000000005</c:v>
                </c:pt>
                <c:pt idx="35">
                  <c:v>0.67100000000000004</c:v>
                </c:pt>
                <c:pt idx="36">
                  <c:v>0.66600000000000004</c:v>
                </c:pt>
                <c:pt idx="37">
                  <c:v>0.65900000000000003</c:v>
                </c:pt>
                <c:pt idx="38">
                  <c:v>0.65100000000000002</c:v>
                </c:pt>
                <c:pt idx="39">
                  <c:v>0.64900000000000002</c:v>
                </c:pt>
                <c:pt idx="40">
                  <c:v>0.64500000000000002</c:v>
                </c:pt>
                <c:pt idx="41">
                  <c:v>0.64200000000000002</c:v>
                </c:pt>
                <c:pt idx="42">
                  <c:v>0.63800000000000001</c:v>
                </c:pt>
                <c:pt idx="43">
                  <c:v>0.628</c:v>
                </c:pt>
                <c:pt idx="44">
                  <c:v>0.61699999999999999</c:v>
                </c:pt>
                <c:pt idx="45">
                  <c:v>0.60599999999999998</c:v>
                </c:pt>
                <c:pt idx="46">
                  <c:v>0.59399999999999997</c:v>
                </c:pt>
                <c:pt idx="47">
                  <c:v>0.57699999999999996</c:v>
                </c:pt>
                <c:pt idx="48">
                  <c:v>0.56299999999999994</c:v>
                </c:pt>
                <c:pt idx="49">
                  <c:v>0.55400000000000005</c:v>
                </c:pt>
                <c:pt idx="50">
                  <c:v>0.54700000000000004</c:v>
                </c:pt>
                <c:pt idx="51">
                  <c:v>0.53800000000000003</c:v>
                </c:pt>
                <c:pt idx="52">
                  <c:v>0.53100000000000003</c:v>
                </c:pt>
                <c:pt idx="53">
                  <c:v>0.52400000000000002</c:v>
                </c:pt>
                <c:pt idx="54">
                  <c:v>0.52400000000000002</c:v>
                </c:pt>
                <c:pt idx="55">
                  <c:v>0.52400000000000002</c:v>
                </c:pt>
                <c:pt idx="56">
                  <c:v>0.52500000000000002</c:v>
                </c:pt>
                <c:pt idx="57">
                  <c:v>0.52800000000000002</c:v>
                </c:pt>
                <c:pt idx="58">
                  <c:v>0.53400000000000003</c:v>
                </c:pt>
                <c:pt idx="59">
                  <c:v>0.53800000000000003</c:v>
                </c:pt>
                <c:pt idx="60">
                  <c:v>0.53900000000000003</c:v>
                </c:pt>
                <c:pt idx="61">
                  <c:v>0.54</c:v>
                </c:pt>
                <c:pt idx="62">
                  <c:v>0.54200000000000004</c:v>
                </c:pt>
                <c:pt idx="63">
                  <c:v>0.54400000000000004</c:v>
                </c:pt>
                <c:pt idx="64">
                  <c:v>0.54300000000000004</c:v>
                </c:pt>
                <c:pt idx="65">
                  <c:v>0.54300000000000004</c:v>
                </c:pt>
                <c:pt idx="66">
                  <c:v>0.54500000000000004</c:v>
                </c:pt>
                <c:pt idx="67">
                  <c:v>0.54500000000000004</c:v>
                </c:pt>
                <c:pt idx="68">
                  <c:v>0.54400000000000004</c:v>
                </c:pt>
                <c:pt idx="69">
                  <c:v>0.54</c:v>
                </c:pt>
                <c:pt idx="70">
                  <c:v>0.54</c:v>
                </c:pt>
                <c:pt idx="71">
                  <c:v>0.53500000000000003</c:v>
                </c:pt>
                <c:pt idx="72">
                  <c:v>0.53300000000000003</c:v>
                </c:pt>
                <c:pt idx="73">
                  <c:v>0.53</c:v>
                </c:pt>
                <c:pt idx="74">
                  <c:v>0.52200000000000002</c:v>
                </c:pt>
                <c:pt idx="75">
                  <c:v>0.52</c:v>
                </c:pt>
                <c:pt idx="76">
                  <c:v>0.51300000000000001</c:v>
                </c:pt>
                <c:pt idx="77">
                  <c:v>0.505</c:v>
                </c:pt>
                <c:pt idx="78">
                  <c:v>0.5</c:v>
                </c:pt>
                <c:pt idx="79">
                  <c:v>0.496</c:v>
                </c:pt>
                <c:pt idx="80">
                  <c:v>0.497</c:v>
                </c:pt>
                <c:pt idx="81">
                  <c:v>0.49099999999999999</c:v>
                </c:pt>
                <c:pt idx="82">
                  <c:v>0.49399999999999999</c:v>
                </c:pt>
                <c:pt idx="83">
                  <c:v>0.49199999999999999</c:v>
                </c:pt>
                <c:pt idx="84">
                  <c:v>0.49</c:v>
                </c:pt>
                <c:pt idx="85">
                  <c:v>0.48899999999999999</c:v>
                </c:pt>
                <c:pt idx="86">
                  <c:v>0.48099999999999998</c:v>
                </c:pt>
                <c:pt idx="87">
                  <c:v>0.48199999999999998</c:v>
                </c:pt>
                <c:pt idx="88">
                  <c:v>0.48199999999999998</c:v>
                </c:pt>
                <c:pt idx="89">
                  <c:v>0.48099999999999998</c:v>
                </c:pt>
                <c:pt idx="90">
                  <c:v>0.47899999999999998</c:v>
                </c:pt>
                <c:pt idx="91">
                  <c:v>0.47799999999999998</c:v>
                </c:pt>
                <c:pt idx="92">
                  <c:v>0.47799999999999998</c:v>
                </c:pt>
                <c:pt idx="93">
                  <c:v>0.47199999999999998</c:v>
                </c:pt>
                <c:pt idx="94">
                  <c:v>0.47</c:v>
                </c:pt>
                <c:pt idx="95">
                  <c:v>0.46899999999999997</c:v>
                </c:pt>
                <c:pt idx="96">
                  <c:v>0.46800000000000003</c:v>
                </c:pt>
                <c:pt idx="97">
                  <c:v>0.46500000000000002</c:v>
                </c:pt>
                <c:pt idx="98">
                  <c:v>0.46500000000000002</c:v>
                </c:pt>
                <c:pt idx="99">
                  <c:v>0.46300000000000002</c:v>
                </c:pt>
                <c:pt idx="100">
                  <c:v>0.45900000000000002</c:v>
                </c:pt>
                <c:pt idx="101">
                  <c:v>0.45400000000000001</c:v>
                </c:pt>
                <c:pt idx="102">
                  <c:v>0.45200000000000001</c:v>
                </c:pt>
                <c:pt idx="103">
                  <c:v>0.44700000000000001</c:v>
                </c:pt>
                <c:pt idx="104">
                  <c:v>0.44700000000000001</c:v>
                </c:pt>
                <c:pt idx="105">
                  <c:v>0.443</c:v>
                </c:pt>
                <c:pt idx="106">
                  <c:v>0.441</c:v>
                </c:pt>
                <c:pt idx="107">
                  <c:v>0.441</c:v>
                </c:pt>
                <c:pt idx="108">
                  <c:v>0.439</c:v>
                </c:pt>
                <c:pt idx="109">
                  <c:v>0.43099999999999999</c:v>
                </c:pt>
                <c:pt idx="110">
                  <c:v>0.42399999999999999</c:v>
                </c:pt>
                <c:pt idx="111">
                  <c:v>0.41899999999999998</c:v>
                </c:pt>
                <c:pt idx="112">
                  <c:v>0.41099999999999998</c:v>
                </c:pt>
                <c:pt idx="113">
                  <c:v>0.40600000000000003</c:v>
                </c:pt>
                <c:pt idx="114">
                  <c:v>0.40400000000000003</c:v>
                </c:pt>
                <c:pt idx="115">
                  <c:v>0.40400000000000003</c:v>
                </c:pt>
                <c:pt idx="116">
                  <c:v>0.4</c:v>
                </c:pt>
                <c:pt idx="117">
                  <c:v>0.39600000000000002</c:v>
                </c:pt>
                <c:pt idx="118">
                  <c:v>0.39400000000000002</c:v>
                </c:pt>
                <c:pt idx="119">
                  <c:v>0.39200000000000002</c:v>
                </c:pt>
                <c:pt idx="120">
                  <c:v>0.39</c:v>
                </c:pt>
                <c:pt idx="121">
                  <c:v>0.39400000000000002</c:v>
                </c:pt>
                <c:pt idx="122">
                  <c:v>0.39100000000000001</c:v>
                </c:pt>
                <c:pt idx="123">
                  <c:v>0.38700000000000001</c:v>
                </c:pt>
                <c:pt idx="124">
                  <c:v>0.38300000000000001</c:v>
                </c:pt>
                <c:pt idx="125">
                  <c:v>0.38100000000000001</c:v>
                </c:pt>
                <c:pt idx="126">
                  <c:v>0.377</c:v>
                </c:pt>
                <c:pt idx="127">
                  <c:v>0.37</c:v>
                </c:pt>
                <c:pt idx="128">
                  <c:v>0.371</c:v>
                </c:pt>
                <c:pt idx="129">
                  <c:v>0.37</c:v>
                </c:pt>
                <c:pt idx="130">
                  <c:v>0.36899999999999999</c:v>
                </c:pt>
                <c:pt idx="131">
                  <c:v>0.36399999999999999</c:v>
                </c:pt>
                <c:pt idx="132">
                  <c:v>0.36399999999999999</c:v>
                </c:pt>
                <c:pt idx="133">
                  <c:v>0.36099999999999999</c:v>
                </c:pt>
                <c:pt idx="134">
                  <c:v>0.35299999999999998</c:v>
                </c:pt>
                <c:pt idx="135">
                  <c:v>0.35199999999999998</c:v>
                </c:pt>
                <c:pt idx="136">
                  <c:v>0.34899999999999998</c:v>
                </c:pt>
                <c:pt idx="137">
                  <c:v>0.34899999999999998</c:v>
                </c:pt>
                <c:pt idx="138">
                  <c:v>0.34599999999999997</c:v>
                </c:pt>
                <c:pt idx="139">
                  <c:v>0.35199999999999998</c:v>
                </c:pt>
                <c:pt idx="140">
                  <c:v>0.35</c:v>
                </c:pt>
                <c:pt idx="141">
                  <c:v>0.35</c:v>
                </c:pt>
                <c:pt idx="142">
                  <c:v>0.34300000000000003</c:v>
                </c:pt>
                <c:pt idx="143">
                  <c:v>0.34399999999999997</c:v>
                </c:pt>
                <c:pt idx="144">
                  <c:v>0.34</c:v>
                </c:pt>
                <c:pt idx="145">
                  <c:v>0.33800000000000002</c:v>
                </c:pt>
                <c:pt idx="146">
                  <c:v>0.33800000000000002</c:v>
                </c:pt>
                <c:pt idx="147">
                  <c:v>0.33900000000000002</c:v>
                </c:pt>
                <c:pt idx="148">
                  <c:v>0.34100000000000003</c:v>
                </c:pt>
                <c:pt idx="149">
                  <c:v>0.34</c:v>
                </c:pt>
                <c:pt idx="150">
                  <c:v>0.33700000000000002</c:v>
                </c:pt>
                <c:pt idx="151">
                  <c:v>0.33400000000000002</c:v>
                </c:pt>
                <c:pt idx="152">
                  <c:v>0.33100000000000002</c:v>
                </c:pt>
                <c:pt idx="153">
                  <c:v>0.33100000000000002</c:v>
                </c:pt>
                <c:pt idx="154">
                  <c:v>0.32900000000000001</c:v>
                </c:pt>
                <c:pt idx="155">
                  <c:v>0.33100000000000002</c:v>
                </c:pt>
                <c:pt idx="156">
                  <c:v>0.32900000000000001</c:v>
                </c:pt>
                <c:pt idx="157">
                  <c:v>0.32700000000000001</c:v>
                </c:pt>
                <c:pt idx="158">
                  <c:v>0.32300000000000001</c:v>
                </c:pt>
                <c:pt idx="159">
                  <c:v>0.318</c:v>
                </c:pt>
                <c:pt idx="160">
                  <c:v>0.314</c:v>
                </c:pt>
                <c:pt idx="161">
                  <c:v>0.30599999999999999</c:v>
                </c:pt>
                <c:pt idx="162">
                  <c:v>0.30199999999999999</c:v>
                </c:pt>
                <c:pt idx="163">
                  <c:v>0.30099999999999999</c:v>
                </c:pt>
                <c:pt idx="164">
                  <c:v>0.29899999999999999</c:v>
                </c:pt>
                <c:pt idx="165">
                  <c:v>0.29699999999999999</c:v>
                </c:pt>
                <c:pt idx="166">
                  <c:v>0.29899999999999999</c:v>
                </c:pt>
                <c:pt idx="167">
                  <c:v>0.29499999999999998</c:v>
                </c:pt>
                <c:pt idx="168">
                  <c:v>0.29499999999999998</c:v>
                </c:pt>
                <c:pt idx="169">
                  <c:v>0.29199999999999998</c:v>
                </c:pt>
                <c:pt idx="170">
                  <c:v>0.29199999999999998</c:v>
                </c:pt>
                <c:pt idx="171">
                  <c:v>0.28999999999999998</c:v>
                </c:pt>
                <c:pt idx="172">
                  <c:v>0.28699999999999998</c:v>
                </c:pt>
                <c:pt idx="173">
                  <c:v>0.28499999999999998</c:v>
                </c:pt>
                <c:pt idx="174">
                  <c:v>0.28399999999999997</c:v>
                </c:pt>
                <c:pt idx="175">
                  <c:v>0.27800000000000002</c:v>
                </c:pt>
                <c:pt idx="176">
                  <c:v>0.27200000000000002</c:v>
                </c:pt>
                <c:pt idx="177">
                  <c:v>0.26900000000000002</c:v>
                </c:pt>
                <c:pt idx="178">
                  <c:v>0.26500000000000001</c:v>
                </c:pt>
                <c:pt idx="179">
                  <c:v>0.25900000000000001</c:v>
                </c:pt>
                <c:pt idx="180">
                  <c:v>0.255</c:v>
                </c:pt>
                <c:pt idx="181">
                  <c:v>0.253</c:v>
                </c:pt>
                <c:pt idx="182">
                  <c:v>0.254</c:v>
                </c:pt>
                <c:pt idx="183">
                  <c:v>0.253</c:v>
                </c:pt>
                <c:pt idx="184">
                  <c:v>0.25</c:v>
                </c:pt>
                <c:pt idx="185">
                  <c:v>0.25</c:v>
                </c:pt>
                <c:pt idx="186">
                  <c:v>0.246</c:v>
                </c:pt>
                <c:pt idx="187">
                  <c:v>0.246</c:v>
                </c:pt>
                <c:pt idx="188">
                  <c:v>0.24299999999999999</c:v>
                </c:pt>
                <c:pt idx="189">
                  <c:v>0.23699999999999999</c:v>
                </c:pt>
                <c:pt idx="190">
                  <c:v>0.23400000000000001</c:v>
                </c:pt>
                <c:pt idx="191">
                  <c:v>0.22900000000000001</c:v>
                </c:pt>
                <c:pt idx="192">
                  <c:v>0.22600000000000001</c:v>
                </c:pt>
                <c:pt idx="193">
                  <c:v>0.22</c:v>
                </c:pt>
                <c:pt idx="194">
                  <c:v>0.217</c:v>
                </c:pt>
                <c:pt idx="195">
                  <c:v>0.219</c:v>
                </c:pt>
                <c:pt idx="196">
                  <c:v>0.219</c:v>
                </c:pt>
                <c:pt idx="197">
                  <c:v>0.216</c:v>
                </c:pt>
                <c:pt idx="198">
                  <c:v>0.216</c:v>
                </c:pt>
                <c:pt idx="199">
                  <c:v>0.214</c:v>
                </c:pt>
                <c:pt idx="200">
                  <c:v>0.21299999999999999</c:v>
                </c:pt>
                <c:pt idx="201">
                  <c:v>0.215</c:v>
                </c:pt>
                <c:pt idx="202">
                  <c:v>0.21099999999999999</c:v>
                </c:pt>
                <c:pt idx="203">
                  <c:v>0.21099999999999999</c:v>
                </c:pt>
                <c:pt idx="204">
                  <c:v>0.20899999999999999</c:v>
                </c:pt>
                <c:pt idx="205">
                  <c:v>0.20499999999999999</c:v>
                </c:pt>
                <c:pt idx="206">
                  <c:v>0.20300000000000001</c:v>
                </c:pt>
                <c:pt idx="207">
                  <c:v>0.20100000000000001</c:v>
                </c:pt>
                <c:pt idx="208">
                  <c:v>0.19800000000000001</c:v>
                </c:pt>
                <c:pt idx="209">
                  <c:v>0.19600000000000001</c:v>
                </c:pt>
                <c:pt idx="210">
                  <c:v>0.19500000000000001</c:v>
                </c:pt>
                <c:pt idx="211">
                  <c:v>0.19500000000000001</c:v>
                </c:pt>
                <c:pt idx="212">
                  <c:v>0.19</c:v>
                </c:pt>
                <c:pt idx="213">
                  <c:v>0.188</c:v>
                </c:pt>
                <c:pt idx="214">
                  <c:v>0.188</c:v>
                </c:pt>
                <c:pt idx="215">
                  <c:v>0.184</c:v>
                </c:pt>
                <c:pt idx="216">
                  <c:v>0.18099999999999999</c:v>
                </c:pt>
                <c:pt idx="217">
                  <c:v>0.184</c:v>
                </c:pt>
                <c:pt idx="218">
                  <c:v>0.182</c:v>
                </c:pt>
                <c:pt idx="219">
                  <c:v>0.182</c:v>
                </c:pt>
                <c:pt idx="220">
                  <c:v>0.17699999999999999</c:v>
                </c:pt>
                <c:pt idx="221">
                  <c:v>0.17499999999999999</c:v>
                </c:pt>
                <c:pt idx="222">
                  <c:v>0.17299999999999999</c:v>
                </c:pt>
                <c:pt idx="223">
                  <c:v>0.16600000000000001</c:v>
                </c:pt>
                <c:pt idx="224">
                  <c:v>0.16400000000000001</c:v>
                </c:pt>
                <c:pt idx="225">
                  <c:v>0.16200000000000001</c:v>
                </c:pt>
                <c:pt idx="226">
                  <c:v>0.16</c:v>
                </c:pt>
                <c:pt idx="227">
                  <c:v>0.158</c:v>
                </c:pt>
                <c:pt idx="228">
                  <c:v>0.154</c:v>
                </c:pt>
                <c:pt idx="229">
                  <c:v>0.155</c:v>
                </c:pt>
                <c:pt idx="230">
                  <c:v>0.152</c:v>
                </c:pt>
                <c:pt idx="231">
                  <c:v>0.152</c:v>
                </c:pt>
                <c:pt idx="232">
                  <c:v>0.14899999999999999</c:v>
                </c:pt>
                <c:pt idx="233">
                  <c:v>0.14899999999999999</c:v>
                </c:pt>
                <c:pt idx="234">
                  <c:v>0.15</c:v>
                </c:pt>
                <c:pt idx="235">
                  <c:v>0.14899999999999999</c:v>
                </c:pt>
                <c:pt idx="236">
                  <c:v>0.14399999999999999</c:v>
                </c:pt>
                <c:pt idx="237">
                  <c:v>0.14399999999999999</c:v>
                </c:pt>
                <c:pt idx="238">
                  <c:v>0.14399999999999999</c:v>
                </c:pt>
                <c:pt idx="239">
                  <c:v>0.14000000000000001</c:v>
                </c:pt>
                <c:pt idx="240">
                  <c:v>0.13300000000000001</c:v>
                </c:pt>
                <c:pt idx="241">
                  <c:v>0.13100000000000001</c:v>
                </c:pt>
                <c:pt idx="242">
                  <c:v>0.129</c:v>
                </c:pt>
                <c:pt idx="243">
                  <c:v>0.122</c:v>
                </c:pt>
                <c:pt idx="244">
                  <c:v>0.122</c:v>
                </c:pt>
                <c:pt idx="245">
                  <c:v>0.122</c:v>
                </c:pt>
                <c:pt idx="246">
                  <c:v>0.124</c:v>
                </c:pt>
                <c:pt idx="247">
                  <c:v>0.122</c:v>
                </c:pt>
                <c:pt idx="248">
                  <c:v>0.123</c:v>
                </c:pt>
                <c:pt idx="249">
                  <c:v>0.12</c:v>
                </c:pt>
                <c:pt idx="250">
                  <c:v>0.115</c:v>
                </c:pt>
                <c:pt idx="251">
                  <c:v>0.11700000000000001</c:v>
                </c:pt>
                <c:pt idx="252">
                  <c:v>0.11600000000000001</c:v>
                </c:pt>
                <c:pt idx="253">
                  <c:v>0.115</c:v>
                </c:pt>
                <c:pt idx="254">
                  <c:v>0.111</c:v>
                </c:pt>
                <c:pt idx="255">
                  <c:v>0.113</c:v>
                </c:pt>
                <c:pt idx="256">
                  <c:v>0.111</c:v>
                </c:pt>
                <c:pt idx="257">
                  <c:v>0.106</c:v>
                </c:pt>
                <c:pt idx="258">
                  <c:v>0.105</c:v>
                </c:pt>
                <c:pt idx="259">
                  <c:v>0.10100000000000001</c:v>
                </c:pt>
                <c:pt idx="260">
                  <c:v>0.1</c:v>
                </c:pt>
                <c:pt idx="261">
                  <c:v>0.10100000000000001</c:v>
                </c:pt>
                <c:pt idx="262">
                  <c:v>0.10199999999999999</c:v>
                </c:pt>
                <c:pt idx="263">
                  <c:v>9.9000000000000005E-2</c:v>
                </c:pt>
                <c:pt idx="264">
                  <c:v>0.10100000000000001</c:v>
                </c:pt>
                <c:pt idx="265">
                  <c:v>0.10100000000000001</c:v>
                </c:pt>
                <c:pt idx="266">
                  <c:v>0.1</c:v>
                </c:pt>
                <c:pt idx="267">
                  <c:v>9.6000000000000002E-2</c:v>
                </c:pt>
                <c:pt idx="268">
                  <c:v>9.4E-2</c:v>
                </c:pt>
                <c:pt idx="269">
                  <c:v>9.1999999999999998E-2</c:v>
                </c:pt>
                <c:pt idx="270">
                  <c:v>0.09</c:v>
                </c:pt>
                <c:pt idx="271">
                  <c:v>8.7999999999999995E-2</c:v>
                </c:pt>
                <c:pt idx="272">
                  <c:v>8.8999999999999996E-2</c:v>
                </c:pt>
                <c:pt idx="273">
                  <c:v>8.6999999999999994E-2</c:v>
                </c:pt>
                <c:pt idx="274">
                  <c:v>8.5999999999999993E-2</c:v>
                </c:pt>
                <c:pt idx="275">
                  <c:v>8.5000000000000006E-2</c:v>
                </c:pt>
                <c:pt idx="276">
                  <c:v>8.2000000000000003E-2</c:v>
                </c:pt>
                <c:pt idx="277">
                  <c:v>8.2000000000000003E-2</c:v>
                </c:pt>
                <c:pt idx="278">
                  <c:v>7.8E-2</c:v>
                </c:pt>
                <c:pt idx="279">
                  <c:v>7.4999999999999997E-2</c:v>
                </c:pt>
                <c:pt idx="280">
                  <c:v>7.3999999999999996E-2</c:v>
                </c:pt>
                <c:pt idx="281">
                  <c:v>7.0999999999999994E-2</c:v>
                </c:pt>
                <c:pt idx="282">
                  <c:v>7.5999999999999998E-2</c:v>
                </c:pt>
                <c:pt idx="283">
                  <c:v>7.4999999999999997E-2</c:v>
                </c:pt>
                <c:pt idx="284">
                  <c:v>7.5999999999999998E-2</c:v>
                </c:pt>
                <c:pt idx="285">
                  <c:v>7.4999999999999997E-2</c:v>
                </c:pt>
                <c:pt idx="286">
                  <c:v>7.2999999999999995E-2</c:v>
                </c:pt>
                <c:pt idx="287">
                  <c:v>7.1999999999999995E-2</c:v>
                </c:pt>
                <c:pt idx="288">
                  <c:v>6.4000000000000001E-2</c:v>
                </c:pt>
                <c:pt idx="289">
                  <c:v>6.3E-2</c:v>
                </c:pt>
                <c:pt idx="290">
                  <c:v>6.0999999999999999E-2</c:v>
                </c:pt>
                <c:pt idx="291">
                  <c:v>0.06</c:v>
                </c:pt>
                <c:pt idx="292">
                  <c:v>5.6000000000000001E-2</c:v>
                </c:pt>
                <c:pt idx="293">
                  <c:v>5.6000000000000001E-2</c:v>
                </c:pt>
                <c:pt idx="294">
                  <c:v>5.3999999999999999E-2</c:v>
                </c:pt>
                <c:pt idx="295">
                  <c:v>5.1999999999999998E-2</c:v>
                </c:pt>
                <c:pt idx="296">
                  <c:v>5.0999999999999997E-2</c:v>
                </c:pt>
                <c:pt idx="297">
                  <c:v>4.9000000000000002E-2</c:v>
                </c:pt>
                <c:pt idx="298">
                  <c:v>5.1999999999999998E-2</c:v>
                </c:pt>
                <c:pt idx="299">
                  <c:v>0.05</c:v>
                </c:pt>
                <c:pt idx="300">
                  <c:v>4.9000000000000002E-2</c:v>
                </c:pt>
                <c:pt idx="301">
                  <c:v>0.05</c:v>
                </c:pt>
                <c:pt idx="302">
                  <c:v>5.0999999999999997E-2</c:v>
                </c:pt>
                <c:pt idx="303">
                  <c:v>5.2999999999999999E-2</c:v>
                </c:pt>
                <c:pt idx="304">
                  <c:v>5.1999999999999998E-2</c:v>
                </c:pt>
                <c:pt idx="305">
                  <c:v>5.0999999999999997E-2</c:v>
                </c:pt>
                <c:pt idx="306">
                  <c:v>5.0999999999999997E-2</c:v>
                </c:pt>
                <c:pt idx="307">
                  <c:v>4.8000000000000001E-2</c:v>
                </c:pt>
                <c:pt idx="308">
                  <c:v>4.7E-2</c:v>
                </c:pt>
                <c:pt idx="309">
                  <c:v>4.3999999999999997E-2</c:v>
                </c:pt>
                <c:pt idx="310">
                  <c:v>4.4999999999999998E-2</c:v>
                </c:pt>
                <c:pt idx="311">
                  <c:v>4.2000000000000003E-2</c:v>
                </c:pt>
                <c:pt idx="312">
                  <c:v>3.7999999999999999E-2</c:v>
                </c:pt>
                <c:pt idx="313">
                  <c:v>3.7999999999999999E-2</c:v>
                </c:pt>
                <c:pt idx="314">
                  <c:v>3.3000000000000002E-2</c:v>
                </c:pt>
                <c:pt idx="315">
                  <c:v>3.1E-2</c:v>
                </c:pt>
                <c:pt idx="316">
                  <c:v>3.3000000000000002E-2</c:v>
                </c:pt>
                <c:pt idx="317">
                  <c:v>3.1E-2</c:v>
                </c:pt>
                <c:pt idx="318">
                  <c:v>3.5999999999999997E-2</c:v>
                </c:pt>
                <c:pt idx="319">
                  <c:v>3.4000000000000002E-2</c:v>
                </c:pt>
                <c:pt idx="320">
                  <c:v>3.3000000000000002E-2</c:v>
                </c:pt>
                <c:pt idx="321">
                  <c:v>0.03</c:v>
                </c:pt>
                <c:pt idx="322">
                  <c:v>2.7E-2</c:v>
                </c:pt>
                <c:pt idx="323">
                  <c:v>2.5000000000000001E-2</c:v>
                </c:pt>
                <c:pt idx="324">
                  <c:v>0.02</c:v>
                </c:pt>
                <c:pt idx="325">
                  <c:v>2.3E-2</c:v>
                </c:pt>
                <c:pt idx="326">
                  <c:v>2.5000000000000001E-2</c:v>
                </c:pt>
                <c:pt idx="327">
                  <c:v>2.4E-2</c:v>
                </c:pt>
                <c:pt idx="328">
                  <c:v>2.8000000000000001E-2</c:v>
                </c:pt>
                <c:pt idx="329">
                  <c:v>2.8000000000000001E-2</c:v>
                </c:pt>
                <c:pt idx="330">
                  <c:v>2.7E-2</c:v>
                </c:pt>
                <c:pt idx="331">
                  <c:v>2.5999999999999999E-2</c:v>
                </c:pt>
                <c:pt idx="332">
                  <c:v>2.1999999999999999E-2</c:v>
                </c:pt>
                <c:pt idx="333">
                  <c:v>0.02</c:v>
                </c:pt>
                <c:pt idx="334">
                  <c:v>1.7999999999999999E-2</c:v>
                </c:pt>
                <c:pt idx="335">
                  <c:v>1.4E-2</c:v>
                </c:pt>
                <c:pt idx="336">
                  <c:v>8.9999999999999993E-3</c:v>
                </c:pt>
                <c:pt idx="337">
                  <c:v>6.0000000000000001E-3</c:v>
                </c:pt>
                <c:pt idx="338">
                  <c:v>3.0000000000000001E-3</c:v>
                </c:pt>
                <c:pt idx="339">
                  <c:v>0</c:v>
                </c:pt>
                <c:pt idx="340">
                  <c:v>-1E-3</c:v>
                </c:pt>
                <c:pt idx="341">
                  <c:v>-3.0000000000000001E-3</c:v>
                </c:pt>
                <c:pt idx="342">
                  <c:v>-2E-3</c:v>
                </c:pt>
                <c:pt idx="343">
                  <c:v>-3.0000000000000001E-3</c:v>
                </c:pt>
                <c:pt idx="344">
                  <c:v>-5.0000000000000001E-3</c:v>
                </c:pt>
                <c:pt idx="345">
                  <c:v>-0.01</c:v>
                </c:pt>
                <c:pt idx="346">
                  <c:v>-1.2999999999999999E-2</c:v>
                </c:pt>
                <c:pt idx="347">
                  <c:v>-1.2999999999999999E-2</c:v>
                </c:pt>
                <c:pt idx="348">
                  <c:v>-1.2E-2</c:v>
                </c:pt>
                <c:pt idx="349">
                  <c:v>-1.4E-2</c:v>
                </c:pt>
                <c:pt idx="350">
                  <c:v>-1.2E-2</c:v>
                </c:pt>
                <c:pt idx="351">
                  <c:v>-1.0999999999999999E-2</c:v>
                </c:pt>
                <c:pt idx="352">
                  <c:v>-1.2999999999999999E-2</c:v>
                </c:pt>
                <c:pt idx="353">
                  <c:v>-1.2E-2</c:v>
                </c:pt>
                <c:pt idx="354">
                  <c:v>-1.4999999999999999E-2</c:v>
                </c:pt>
                <c:pt idx="355">
                  <c:v>-1.6E-2</c:v>
                </c:pt>
                <c:pt idx="356">
                  <c:v>-1.7999999999999999E-2</c:v>
                </c:pt>
                <c:pt idx="357">
                  <c:v>-0.02</c:v>
                </c:pt>
                <c:pt idx="358">
                  <c:v>-2.3E-2</c:v>
                </c:pt>
                <c:pt idx="359">
                  <c:v>-2.5000000000000001E-2</c:v>
                </c:pt>
                <c:pt idx="360">
                  <c:v>-2.9000000000000001E-2</c:v>
                </c:pt>
                <c:pt idx="361">
                  <c:v>-2.8000000000000001E-2</c:v>
                </c:pt>
                <c:pt idx="362">
                  <c:v>-2.9000000000000001E-2</c:v>
                </c:pt>
                <c:pt idx="363">
                  <c:v>-0.03</c:v>
                </c:pt>
                <c:pt idx="364">
                  <c:v>-3.1E-2</c:v>
                </c:pt>
                <c:pt idx="365">
                  <c:v>-2.9000000000000001E-2</c:v>
                </c:pt>
                <c:pt idx="366">
                  <c:v>-2.8000000000000001E-2</c:v>
                </c:pt>
                <c:pt idx="367">
                  <c:v>-2.7E-2</c:v>
                </c:pt>
                <c:pt idx="368">
                  <c:v>-0.03</c:v>
                </c:pt>
                <c:pt idx="369">
                  <c:v>-3.3000000000000002E-2</c:v>
                </c:pt>
                <c:pt idx="370">
                  <c:v>-3.5000000000000003E-2</c:v>
                </c:pt>
                <c:pt idx="371">
                  <c:v>-0.04</c:v>
                </c:pt>
                <c:pt idx="372">
                  <c:v>-4.3999999999999997E-2</c:v>
                </c:pt>
                <c:pt idx="373">
                  <c:v>-4.8000000000000001E-2</c:v>
                </c:pt>
                <c:pt idx="374">
                  <c:v>-5.1999999999999998E-2</c:v>
                </c:pt>
                <c:pt idx="375">
                  <c:v>-4.9000000000000002E-2</c:v>
                </c:pt>
                <c:pt idx="376">
                  <c:v>-5.0999999999999997E-2</c:v>
                </c:pt>
                <c:pt idx="377">
                  <c:v>-4.8000000000000001E-2</c:v>
                </c:pt>
                <c:pt idx="378">
                  <c:v>-4.8000000000000001E-2</c:v>
                </c:pt>
                <c:pt idx="379">
                  <c:v>-4.7E-2</c:v>
                </c:pt>
                <c:pt idx="380">
                  <c:v>-5.0999999999999997E-2</c:v>
                </c:pt>
                <c:pt idx="381">
                  <c:v>-5.6000000000000001E-2</c:v>
                </c:pt>
                <c:pt idx="382">
                  <c:v>-0.06</c:v>
                </c:pt>
                <c:pt idx="383">
                  <c:v>-6.5000000000000002E-2</c:v>
                </c:pt>
                <c:pt idx="384">
                  <c:v>-6.6000000000000003E-2</c:v>
                </c:pt>
                <c:pt idx="385">
                  <c:v>-6.8000000000000005E-2</c:v>
                </c:pt>
                <c:pt idx="386">
                  <c:v>-6.7000000000000004E-2</c:v>
                </c:pt>
                <c:pt idx="387">
                  <c:v>-6.6000000000000003E-2</c:v>
                </c:pt>
                <c:pt idx="388">
                  <c:v>-6.8000000000000005E-2</c:v>
                </c:pt>
                <c:pt idx="389">
                  <c:v>-6.7000000000000004E-2</c:v>
                </c:pt>
                <c:pt idx="390">
                  <c:v>-7.1999999999999995E-2</c:v>
                </c:pt>
                <c:pt idx="391">
                  <c:v>-7.0999999999999994E-2</c:v>
                </c:pt>
                <c:pt idx="392">
                  <c:v>-7.1999999999999995E-2</c:v>
                </c:pt>
                <c:pt idx="393">
                  <c:v>-7.3999999999999996E-2</c:v>
                </c:pt>
                <c:pt idx="394">
                  <c:v>-7.6999999999999999E-2</c:v>
                </c:pt>
                <c:pt idx="395">
                  <c:v>-7.8E-2</c:v>
                </c:pt>
                <c:pt idx="396">
                  <c:v>-7.4999999999999997E-2</c:v>
                </c:pt>
                <c:pt idx="397">
                  <c:v>-7.4999999999999997E-2</c:v>
                </c:pt>
                <c:pt idx="398">
                  <c:v>-7.4999999999999997E-2</c:v>
                </c:pt>
                <c:pt idx="399">
                  <c:v>-7.3999999999999996E-2</c:v>
                </c:pt>
                <c:pt idx="400">
                  <c:v>-7.0999999999999994E-2</c:v>
                </c:pt>
                <c:pt idx="401">
                  <c:v>-7.3999999999999996E-2</c:v>
                </c:pt>
                <c:pt idx="402">
                  <c:v>-7.9000000000000001E-2</c:v>
                </c:pt>
                <c:pt idx="403">
                  <c:v>-8.2000000000000003E-2</c:v>
                </c:pt>
                <c:pt idx="404">
                  <c:v>-8.5000000000000006E-2</c:v>
                </c:pt>
                <c:pt idx="405">
                  <c:v>-8.6999999999999994E-2</c:v>
                </c:pt>
                <c:pt idx="406">
                  <c:v>-8.5999999999999993E-2</c:v>
                </c:pt>
                <c:pt idx="407">
                  <c:v>-8.5000000000000006E-2</c:v>
                </c:pt>
                <c:pt idx="408">
                  <c:v>-8.5000000000000006E-2</c:v>
                </c:pt>
                <c:pt idx="409">
                  <c:v>-8.5000000000000006E-2</c:v>
                </c:pt>
                <c:pt idx="410">
                  <c:v>-8.8999999999999996E-2</c:v>
                </c:pt>
                <c:pt idx="411">
                  <c:v>-9.4E-2</c:v>
                </c:pt>
                <c:pt idx="412">
                  <c:v>-9.1999999999999998E-2</c:v>
                </c:pt>
                <c:pt idx="413">
                  <c:v>-0.09</c:v>
                </c:pt>
                <c:pt idx="414">
                  <c:v>-8.8999999999999996E-2</c:v>
                </c:pt>
                <c:pt idx="415">
                  <c:v>-9.5000000000000001E-2</c:v>
                </c:pt>
                <c:pt idx="416">
                  <c:v>-9.9000000000000005E-2</c:v>
                </c:pt>
                <c:pt idx="417">
                  <c:v>-9.6000000000000002E-2</c:v>
                </c:pt>
                <c:pt idx="418">
                  <c:v>-0.1</c:v>
                </c:pt>
                <c:pt idx="419">
                  <c:v>-0.106</c:v>
                </c:pt>
                <c:pt idx="420">
                  <c:v>-0.105</c:v>
                </c:pt>
                <c:pt idx="421">
                  <c:v>-9.9000000000000005E-2</c:v>
                </c:pt>
                <c:pt idx="422">
                  <c:v>-9.9000000000000005E-2</c:v>
                </c:pt>
                <c:pt idx="423">
                  <c:v>-0.10199999999999999</c:v>
                </c:pt>
                <c:pt idx="424">
                  <c:v>-0.1</c:v>
                </c:pt>
                <c:pt idx="425">
                  <c:v>-9.7000000000000003E-2</c:v>
                </c:pt>
                <c:pt idx="426">
                  <c:v>-9.5000000000000001E-2</c:v>
                </c:pt>
                <c:pt idx="427">
                  <c:v>-9.4E-2</c:v>
                </c:pt>
                <c:pt idx="428">
                  <c:v>-8.7999999999999995E-2</c:v>
                </c:pt>
                <c:pt idx="429">
                  <c:v>-7.5999999999999998E-2</c:v>
                </c:pt>
                <c:pt idx="430">
                  <c:v>-6.2E-2</c:v>
                </c:pt>
                <c:pt idx="431">
                  <c:v>-0.04</c:v>
                </c:pt>
                <c:pt idx="432">
                  <c:v>-1.2999999999999999E-2</c:v>
                </c:pt>
                <c:pt idx="433">
                  <c:v>2.4E-2</c:v>
                </c:pt>
                <c:pt idx="434">
                  <c:v>7.1999999999999995E-2</c:v>
                </c:pt>
                <c:pt idx="435">
                  <c:v>0.13800000000000001</c:v>
                </c:pt>
                <c:pt idx="436">
                  <c:v>0.22700000000000001</c:v>
                </c:pt>
                <c:pt idx="437">
                  <c:v>0.33400000000000002</c:v>
                </c:pt>
                <c:pt idx="438">
                  <c:v>0.46200000000000002</c:v>
                </c:pt>
                <c:pt idx="439">
                  <c:v>0.628</c:v>
                </c:pt>
                <c:pt idx="440">
                  <c:v>0.83399999999999996</c:v>
                </c:pt>
                <c:pt idx="441">
                  <c:v>1.0720000000000001</c:v>
                </c:pt>
                <c:pt idx="442">
                  <c:v>1.3640000000000001</c:v>
                </c:pt>
                <c:pt idx="443">
                  <c:v>1.73</c:v>
                </c:pt>
                <c:pt idx="444">
                  <c:v>2.161</c:v>
                </c:pt>
                <c:pt idx="445">
                  <c:v>2.665</c:v>
                </c:pt>
                <c:pt idx="446">
                  <c:v>3.262</c:v>
                </c:pt>
                <c:pt idx="447">
                  <c:v>3.9889999999999999</c:v>
                </c:pt>
                <c:pt idx="448">
                  <c:v>4.8029999999999999</c:v>
                </c:pt>
                <c:pt idx="449">
                  <c:v>5.7309999999999999</c:v>
                </c:pt>
                <c:pt idx="450">
                  <c:v>6.88</c:v>
                </c:pt>
                <c:pt idx="451">
                  <c:v>8.16</c:v>
                </c:pt>
                <c:pt idx="452">
                  <c:v>9.6449999999999996</c:v>
                </c:pt>
                <c:pt idx="453">
                  <c:v>11.305999999999999</c:v>
                </c:pt>
                <c:pt idx="454">
                  <c:v>13.154</c:v>
                </c:pt>
                <c:pt idx="455">
                  <c:v>15.211</c:v>
                </c:pt>
                <c:pt idx="456">
                  <c:v>17.611999999999998</c:v>
                </c:pt>
                <c:pt idx="457">
                  <c:v>20.123999999999999</c:v>
                </c:pt>
                <c:pt idx="458">
                  <c:v>22.992999999999999</c:v>
                </c:pt>
                <c:pt idx="459">
                  <c:v>26.327999999999999</c:v>
                </c:pt>
                <c:pt idx="460">
                  <c:v>30.03</c:v>
                </c:pt>
                <c:pt idx="461">
                  <c:v>33.82</c:v>
                </c:pt>
                <c:pt idx="462">
                  <c:v>38.396999999999998</c:v>
                </c:pt>
                <c:pt idx="463">
                  <c:v>43.451999999999998</c:v>
                </c:pt>
                <c:pt idx="464">
                  <c:v>48.804000000000002</c:v>
                </c:pt>
                <c:pt idx="465">
                  <c:v>54.591999999999999</c:v>
                </c:pt>
                <c:pt idx="466">
                  <c:v>61.29</c:v>
                </c:pt>
                <c:pt idx="467">
                  <c:v>68.456000000000003</c:v>
                </c:pt>
                <c:pt idx="468">
                  <c:v>76.227000000000004</c:v>
                </c:pt>
                <c:pt idx="469">
                  <c:v>84.352999999999994</c:v>
                </c:pt>
                <c:pt idx="470">
                  <c:v>93.646000000000001</c:v>
                </c:pt>
                <c:pt idx="471">
                  <c:v>103.226</c:v>
                </c:pt>
                <c:pt idx="472">
                  <c:v>113.837</c:v>
                </c:pt>
                <c:pt idx="473">
                  <c:v>124.78700000000001</c:v>
                </c:pt>
                <c:pt idx="474">
                  <c:v>136.642</c:v>
                </c:pt>
                <c:pt idx="475">
                  <c:v>149.483</c:v>
                </c:pt>
                <c:pt idx="476">
                  <c:v>163.316</c:v>
                </c:pt>
                <c:pt idx="477">
                  <c:v>176.90799999999999</c:v>
                </c:pt>
                <c:pt idx="478">
                  <c:v>191.976</c:v>
                </c:pt>
                <c:pt idx="479">
                  <c:v>208.29</c:v>
                </c:pt>
                <c:pt idx="480">
                  <c:v>224.90299999999999</c:v>
                </c:pt>
                <c:pt idx="481">
                  <c:v>241.65799999999999</c:v>
                </c:pt>
                <c:pt idx="482">
                  <c:v>260.46600000000001</c:v>
                </c:pt>
                <c:pt idx="483">
                  <c:v>279.96199999999999</c:v>
                </c:pt>
                <c:pt idx="484">
                  <c:v>298.61399999999998</c:v>
                </c:pt>
                <c:pt idx="485">
                  <c:v>319.99599999999998</c:v>
                </c:pt>
                <c:pt idx="486">
                  <c:v>342.23500000000001</c:v>
                </c:pt>
                <c:pt idx="487">
                  <c:v>364.30200000000002</c:v>
                </c:pt>
                <c:pt idx="488">
                  <c:v>386.96300000000002</c:v>
                </c:pt>
                <c:pt idx="489">
                  <c:v>411.63799999999998</c:v>
                </c:pt>
                <c:pt idx="490">
                  <c:v>436.50900000000001</c:v>
                </c:pt>
                <c:pt idx="491">
                  <c:v>462.16699999999997</c:v>
                </c:pt>
                <c:pt idx="492">
                  <c:v>487.60300000000001</c:v>
                </c:pt>
                <c:pt idx="493">
                  <c:v>515.09900000000005</c:v>
                </c:pt>
                <c:pt idx="494">
                  <c:v>541.99900000000002</c:v>
                </c:pt>
                <c:pt idx="495">
                  <c:v>570.14800000000002</c:v>
                </c:pt>
                <c:pt idx="496">
                  <c:v>597.899</c:v>
                </c:pt>
                <c:pt idx="497">
                  <c:v>626.00800000000004</c:v>
                </c:pt>
                <c:pt idx="498">
                  <c:v>654.94000000000005</c:v>
                </c:pt>
                <c:pt idx="499">
                  <c:v>684.11400000000003</c:v>
                </c:pt>
                <c:pt idx="500">
                  <c:v>711.26700000000005</c:v>
                </c:pt>
                <c:pt idx="501">
                  <c:v>738.94299999999998</c:v>
                </c:pt>
                <c:pt idx="502">
                  <c:v>767.05600000000004</c:v>
                </c:pt>
                <c:pt idx="503">
                  <c:v>793.32500000000005</c:v>
                </c:pt>
                <c:pt idx="504">
                  <c:v>818.21600000000001</c:v>
                </c:pt>
                <c:pt idx="505">
                  <c:v>843.447</c:v>
                </c:pt>
                <c:pt idx="506">
                  <c:v>867.10599999999999</c:v>
                </c:pt>
                <c:pt idx="507">
                  <c:v>888.79700000000003</c:v>
                </c:pt>
                <c:pt idx="508">
                  <c:v>908.99699999999996</c:v>
                </c:pt>
                <c:pt idx="509">
                  <c:v>928.827</c:v>
                </c:pt>
                <c:pt idx="510">
                  <c:v>946.67700000000002</c:v>
                </c:pt>
                <c:pt idx="511">
                  <c:v>963.48500000000001</c:v>
                </c:pt>
                <c:pt idx="512">
                  <c:v>979.82500000000005</c:v>
                </c:pt>
                <c:pt idx="513">
                  <c:v>995.20899999999995</c:v>
                </c:pt>
                <c:pt idx="514">
                  <c:v>1009.978</c:v>
                </c:pt>
                <c:pt idx="515">
                  <c:v>1024.117</c:v>
                </c:pt>
                <c:pt idx="516">
                  <c:v>1037.5619999999999</c:v>
                </c:pt>
                <c:pt idx="517">
                  <c:v>1050.413</c:v>
                </c:pt>
                <c:pt idx="518">
                  <c:v>1063.239</c:v>
                </c:pt>
                <c:pt idx="519">
                  <c:v>1074.808</c:v>
                </c:pt>
                <c:pt idx="520">
                  <c:v>1085.912</c:v>
                </c:pt>
                <c:pt idx="521">
                  <c:v>1096.585</c:v>
                </c:pt>
                <c:pt idx="522">
                  <c:v>1106.5540000000001</c:v>
                </c:pt>
                <c:pt idx="523">
                  <c:v>1115.019</c:v>
                </c:pt>
                <c:pt idx="524">
                  <c:v>1123.21</c:v>
                </c:pt>
                <c:pt idx="525">
                  <c:v>1130.893</c:v>
                </c:pt>
                <c:pt idx="526">
                  <c:v>1137.665</c:v>
                </c:pt>
                <c:pt idx="527">
                  <c:v>1143.588</c:v>
                </c:pt>
                <c:pt idx="528">
                  <c:v>1149.403</c:v>
                </c:pt>
                <c:pt idx="529">
                  <c:v>1154.587</c:v>
                </c:pt>
                <c:pt idx="530">
                  <c:v>1159.2159999999999</c:v>
                </c:pt>
                <c:pt idx="531">
                  <c:v>1163.3389999999999</c:v>
                </c:pt>
                <c:pt idx="532">
                  <c:v>1167.221</c:v>
                </c:pt>
                <c:pt idx="533">
                  <c:v>1170.645</c:v>
                </c:pt>
                <c:pt idx="534">
                  <c:v>1173.845</c:v>
                </c:pt>
                <c:pt idx="535">
                  <c:v>1176.57</c:v>
                </c:pt>
                <c:pt idx="536">
                  <c:v>1179.105</c:v>
                </c:pt>
                <c:pt idx="537">
                  <c:v>1181.4169999999999</c:v>
                </c:pt>
                <c:pt idx="538">
                  <c:v>1183.492</c:v>
                </c:pt>
                <c:pt idx="539">
                  <c:v>1185.223</c:v>
                </c:pt>
                <c:pt idx="540">
                  <c:v>1186.8030000000001</c:v>
                </c:pt>
                <c:pt idx="541">
                  <c:v>1188.2660000000001</c:v>
                </c:pt>
                <c:pt idx="542">
                  <c:v>1189.511</c:v>
                </c:pt>
                <c:pt idx="543">
                  <c:v>1190.48</c:v>
                </c:pt>
                <c:pt idx="544">
                  <c:v>1191.383</c:v>
                </c:pt>
                <c:pt idx="545">
                  <c:v>1192.164</c:v>
                </c:pt>
                <c:pt idx="546">
                  <c:v>1192.7249999999999</c:v>
                </c:pt>
                <c:pt idx="547">
                  <c:v>1193.1400000000001</c:v>
                </c:pt>
                <c:pt idx="548">
                  <c:v>1193.4880000000001</c:v>
                </c:pt>
                <c:pt idx="549">
                  <c:v>1193.7</c:v>
                </c:pt>
                <c:pt idx="550">
                  <c:v>1193.8</c:v>
                </c:pt>
                <c:pt idx="551">
                  <c:v>1193.827</c:v>
                </c:pt>
                <c:pt idx="552">
                  <c:v>1193.7149999999999</c:v>
                </c:pt>
                <c:pt idx="553">
                  <c:v>1193.498</c:v>
                </c:pt>
                <c:pt idx="554">
                  <c:v>1193.1559999999999</c:v>
                </c:pt>
                <c:pt idx="555">
                  <c:v>1192.739</c:v>
                </c:pt>
                <c:pt idx="556">
                  <c:v>1192.2070000000001</c:v>
                </c:pt>
                <c:pt idx="557">
                  <c:v>1191.5119999999999</c:v>
                </c:pt>
                <c:pt idx="558">
                  <c:v>1190.7380000000001</c:v>
                </c:pt>
                <c:pt idx="559">
                  <c:v>1189.8340000000001</c:v>
                </c:pt>
                <c:pt idx="560">
                  <c:v>1188.778</c:v>
                </c:pt>
                <c:pt idx="561">
                  <c:v>1187.56</c:v>
                </c:pt>
                <c:pt idx="562">
                  <c:v>1186.2529999999999</c:v>
                </c:pt>
                <c:pt idx="563">
                  <c:v>1184.845</c:v>
                </c:pt>
                <c:pt idx="564">
                  <c:v>1183.2</c:v>
                </c:pt>
                <c:pt idx="565">
                  <c:v>1181.442</c:v>
                </c:pt>
                <c:pt idx="566">
                  <c:v>1179.6780000000001</c:v>
                </c:pt>
                <c:pt idx="567">
                  <c:v>1177.623</c:v>
                </c:pt>
                <c:pt idx="568">
                  <c:v>1175.442</c:v>
                </c:pt>
                <c:pt idx="569">
                  <c:v>1173.1610000000001</c:v>
                </c:pt>
                <c:pt idx="570">
                  <c:v>1170.7260000000001</c:v>
                </c:pt>
                <c:pt idx="571">
                  <c:v>1168.1220000000001</c:v>
                </c:pt>
                <c:pt idx="572">
                  <c:v>1165.3910000000001</c:v>
                </c:pt>
                <c:pt idx="573">
                  <c:v>1162.3910000000001</c:v>
                </c:pt>
                <c:pt idx="574">
                  <c:v>1159.377</c:v>
                </c:pt>
                <c:pt idx="575">
                  <c:v>1156.049</c:v>
                </c:pt>
                <c:pt idx="576">
                  <c:v>1152.54</c:v>
                </c:pt>
                <c:pt idx="577">
                  <c:v>1148.79</c:v>
                </c:pt>
                <c:pt idx="578">
                  <c:v>1144.9849999999999</c:v>
                </c:pt>
                <c:pt idx="579">
                  <c:v>1140.9760000000001</c:v>
                </c:pt>
                <c:pt idx="580">
                  <c:v>1136.6099999999999</c:v>
                </c:pt>
                <c:pt idx="581">
                  <c:v>1132.0540000000001</c:v>
                </c:pt>
                <c:pt idx="582">
                  <c:v>1127.7249999999999</c:v>
                </c:pt>
                <c:pt idx="583">
                  <c:v>1122.875</c:v>
                </c:pt>
                <c:pt idx="584">
                  <c:v>1117.7650000000001</c:v>
                </c:pt>
                <c:pt idx="585">
                  <c:v>1112.7750000000001</c:v>
                </c:pt>
                <c:pt idx="586">
                  <c:v>1107.5619999999999</c:v>
                </c:pt>
                <c:pt idx="587">
                  <c:v>1101.877</c:v>
                </c:pt>
                <c:pt idx="588">
                  <c:v>1096.0840000000001</c:v>
                </c:pt>
                <c:pt idx="589">
                  <c:v>1090.1959999999999</c:v>
                </c:pt>
                <c:pt idx="590">
                  <c:v>1084.2170000000001</c:v>
                </c:pt>
                <c:pt idx="591">
                  <c:v>1077.7439999999999</c:v>
                </c:pt>
                <c:pt idx="592">
                  <c:v>1071.2840000000001</c:v>
                </c:pt>
                <c:pt idx="593">
                  <c:v>1064.587</c:v>
                </c:pt>
                <c:pt idx="594">
                  <c:v>1057.528</c:v>
                </c:pt>
                <c:pt idx="595">
                  <c:v>1050.415</c:v>
                </c:pt>
                <c:pt idx="596">
                  <c:v>1042.7639999999999</c:v>
                </c:pt>
                <c:pt idx="597">
                  <c:v>1035.0060000000001</c:v>
                </c:pt>
                <c:pt idx="598">
                  <c:v>1027.4069999999999</c:v>
                </c:pt>
                <c:pt idx="599">
                  <c:v>1019.353</c:v>
                </c:pt>
                <c:pt idx="600">
                  <c:v>1010.937</c:v>
                </c:pt>
                <c:pt idx="601">
                  <c:v>1002.74</c:v>
                </c:pt>
                <c:pt idx="602">
                  <c:v>994.33500000000004</c:v>
                </c:pt>
                <c:pt idx="603">
                  <c:v>985.27599999999995</c:v>
                </c:pt>
                <c:pt idx="604">
                  <c:v>975.93399999999997</c:v>
                </c:pt>
                <c:pt idx="605">
                  <c:v>967.12400000000002</c:v>
                </c:pt>
                <c:pt idx="606">
                  <c:v>957.33100000000002</c:v>
                </c:pt>
                <c:pt idx="607">
                  <c:v>947.12099999999998</c:v>
                </c:pt>
                <c:pt idx="608">
                  <c:v>936.91399999999999</c:v>
                </c:pt>
                <c:pt idx="609">
                  <c:v>926.73299999999995</c:v>
                </c:pt>
                <c:pt idx="610">
                  <c:v>915.54</c:v>
                </c:pt>
                <c:pt idx="611">
                  <c:v>904.31299999999999</c:v>
                </c:pt>
                <c:pt idx="612">
                  <c:v>892.88599999999997</c:v>
                </c:pt>
                <c:pt idx="613">
                  <c:v>881.45299999999997</c:v>
                </c:pt>
                <c:pt idx="614">
                  <c:v>869.46100000000001</c:v>
                </c:pt>
                <c:pt idx="615">
                  <c:v>857.63699999999994</c:v>
                </c:pt>
                <c:pt idx="616">
                  <c:v>845.34699999999998</c:v>
                </c:pt>
                <c:pt idx="617">
                  <c:v>833.65499999999997</c:v>
                </c:pt>
                <c:pt idx="618">
                  <c:v>821.81399999999996</c:v>
                </c:pt>
                <c:pt idx="619">
                  <c:v>809.48500000000001</c:v>
                </c:pt>
                <c:pt idx="620">
                  <c:v>797.47400000000005</c:v>
                </c:pt>
                <c:pt idx="621">
                  <c:v>785.97799999999995</c:v>
                </c:pt>
                <c:pt idx="622">
                  <c:v>774.19399999999996</c:v>
                </c:pt>
                <c:pt idx="623">
                  <c:v>762.38199999999995</c:v>
                </c:pt>
                <c:pt idx="624">
                  <c:v>751.04600000000005</c:v>
                </c:pt>
                <c:pt idx="625">
                  <c:v>740.44399999999996</c:v>
                </c:pt>
                <c:pt idx="626">
                  <c:v>729.21199999999999</c:v>
                </c:pt>
                <c:pt idx="627">
                  <c:v>718.19399999999996</c:v>
                </c:pt>
                <c:pt idx="628">
                  <c:v>708.14700000000005</c:v>
                </c:pt>
                <c:pt idx="629">
                  <c:v>697.60400000000004</c:v>
                </c:pt>
                <c:pt idx="630">
                  <c:v>687.05799999999999</c:v>
                </c:pt>
                <c:pt idx="631">
                  <c:v>677.1</c:v>
                </c:pt>
                <c:pt idx="632">
                  <c:v>667.20699999999999</c:v>
                </c:pt>
                <c:pt idx="633">
                  <c:v>657.63</c:v>
                </c:pt>
                <c:pt idx="634">
                  <c:v>648.13199999999995</c:v>
                </c:pt>
                <c:pt idx="635">
                  <c:v>638.70699999999999</c:v>
                </c:pt>
                <c:pt idx="636">
                  <c:v>629.72400000000005</c:v>
                </c:pt>
                <c:pt idx="637">
                  <c:v>620.59</c:v>
                </c:pt>
                <c:pt idx="638">
                  <c:v>611.72199999999998</c:v>
                </c:pt>
                <c:pt idx="639">
                  <c:v>602.77800000000002</c:v>
                </c:pt>
                <c:pt idx="640">
                  <c:v>594.303</c:v>
                </c:pt>
                <c:pt idx="641">
                  <c:v>586.30700000000002</c:v>
                </c:pt>
                <c:pt idx="642">
                  <c:v>577.90499999999997</c:v>
                </c:pt>
                <c:pt idx="643">
                  <c:v>569.66800000000001</c:v>
                </c:pt>
                <c:pt idx="644">
                  <c:v>562.20100000000002</c:v>
                </c:pt>
                <c:pt idx="645">
                  <c:v>554.38699999999994</c:v>
                </c:pt>
                <c:pt idx="646">
                  <c:v>546.59900000000005</c:v>
                </c:pt>
                <c:pt idx="647">
                  <c:v>539.21</c:v>
                </c:pt>
                <c:pt idx="648">
                  <c:v>532.20899999999995</c:v>
                </c:pt>
                <c:pt idx="649">
                  <c:v>524.84699999999998</c:v>
                </c:pt>
                <c:pt idx="650">
                  <c:v>517.66600000000005</c:v>
                </c:pt>
                <c:pt idx="651">
                  <c:v>510.82900000000001</c:v>
                </c:pt>
                <c:pt idx="652">
                  <c:v>504.19799999999998</c:v>
                </c:pt>
                <c:pt idx="653">
                  <c:v>497.31299999999999</c:v>
                </c:pt>
                <c:pt idx="654">
                  <c:v>490.79199999999997</c:v>
                </c:pt>
                <c:pt idx="655">
                  <c:v>484.327</c:v>
                </c:pt>
                <c:pt idx="656">
                  <c:v>477.98099999999999</c:v>
                </c:pt>
                <c:pt idx="657">
                  <c:v>471.71100000000001</c:v>
                </c:pt>
                <c:pt idx="658">
                  <c:v>465.43299999999999</c:v>
                </c:pt>
                <c:pt idx="659">
                  <c:v>459.15199999999999</c:v>
                </c:pt>
                <c:pt idx="660">
                  <c:v>453.35300000000001</c:v>
                </c:pt>
                <c:pt idx="661">
                  <c:v>447.40600000000001</c:v>
                </c:pt>
                <c:pt idx="662">
                  <c:v>441.41</c:v>
                </c:pt>
                <c:pt idx="663">
                  <c:v>435.76100000000002</c:v>
                </c:pt>
                <c:pt idx="664">
                  <c:v>430.37299999999999</c:v>
                </c:pt>
                <c:pt idx="665">
                  <c:v>424.72699999999998</c:v>
                </c:pt>
                <c:pt idx="666">
                  <c:v>419.185</c:v>
                </c:pt>
                <c:pt idx="667">
                  <c:v>414.01600000000002</c:v>
                </c:pt>
                <c:pt idx="668">
                  <c:v>408.81299999999999</c:v>
                </c:pt>
                <c:pt idx="669">
                  <c:v>403.49</c:v>
                </c:pt>
                <c:pt idx="670">
                  <c:v>398.38099999999997</c:v>
                </c:pt>
                <c:pt idx="671">
                  <c:v>393.54599999999999</c:v>
                </c:pt>
                <c:pt idx="672">
                  <c:v>388.51299999999998</c:v>
                </c:pt>
                <c:pt idx="673">
                  <c:v>383.59500000000003</c:v>
                </c:pt>
                <c:pt idx="674">
                  <c:v>378.86799999999999</c:v>
                </c:pt>
                <c:pt idx="675">
                  <c:v>374.29899999999998</c:v>
                </c:pt>
                <c:pt idx="676">
                  <c:v>369.56599999999997</c:v>
                </c:pt>
                <c:pt idx="677">
                  <c:v>365.07</c:v>
                </c:pt>
                <c:pt idx="678">
                  <c:v>360.48899999999998</c:v>
                </c:pt>
                <c:pt idx="679">
                  <c:v>356.20400000000001</c:v>
                </c:pt>
                <c:pt idx="680">
                  <c:v>351.90600000000001</c:v>
                </c:pt>
                <c:pt idx="681">
                  <c:v>347.55099999999999</c:v>
                </c:pt>
                <c:pt idx="682">
                  <c:v>343.23599999999999</c:v>
                </c:pt>
                <c:pt idx="683">
                  <c:v>339.22199999999998</c:v>
                </c:pt>
                <c:pt idx="684">
                  <c:v>335.16399999999999</c:v>
                </c:pt>
                <c:pt idx="685">
                  <c:v>331.02300000000002</c:v>
                </c:pt>
                <c:pt idx="686">
                  <c:v>327.017</c:v>
                </c:pt>
                <c:pt idx="687">
                  <c:v>323.33699999999999</c:v>
                </c:pt>
                <c:pt idx="688">
                  <c:v>319.39699999999999</c:v>
                </c:pt>
                <c:pt idx="689">
                  <c:v>315.52800000000002</c:v>
                </c:pt>
                <c:pt idx="690">
                  <c:v>311.96100000000001</c:v>
                </c:pt>
                <c:pt idx="691">
                  <c:v>308.31400000000002</c:v>
                </c:pt>
                <c:pt idx="692">
                  <c:v>304.60199999999998</c:v>
                </c:pt>
                <c:pt idx="693">
                  <c:v>301.03300000000002</c:v>
                </c:pt>
                <c:pt idx="694">
                  <c:v>297.65800000000002</c:v>
                </c:pt>
                <c:pt idx="695">
                  <c:v>294.10500000000002</c:v>
                </c:pt>
                <c:pt idx="696">
                  <c:v>290.66000000000003</c:v>
                </c:pt>
                <c:pt idx="697">
                  <c:v>287.30900000000003</c:v>
                </c:pt>
                <c:pt idx="698">
                  <c:v>284.04199999999997</c:v>
                </c:pt>
                <c:pt idx="699">
                  <c:v>280.79399999999998</c:v>
                </c:pt>
                <c:pt idx="700">
                  <c:v>277.62099999999998</c:v>
                </c:pt>
                <c:pt idx="701">
                  <c:v>274.39800000000002</c:v>
                </c:pt>
                <c:pt idx="702">
                  <c:v>271.39299999999997</c:v>
                </c:pt>
                <c:pt idx="703">
                  <c:v>268.39400000000001</c:v>
                </c:pt>
                <c:pt idx="704">
                  <c:v>265.30700000000002</c:v>
                </c:pt>
                <c:pt idx="705">
                  <c:v>262.26299999999998</c:v>
                </c:pt>
                <c:pt idx="706">
                  <c:v>259.48099999999999</c:v>
                </c:pt>
                <c:pt idx="707">
                  <c:v>256.58999999999997</c:v>
                </c:pt>
                <c:pt idx="708">
                  <c:v>253.65700000000001</c:v>
                </c:pt>
                <c:pt idx="709">
                  <c:v>250.834</c:v>
                </c:pt>
                <c:pt idx="710">
                  <c:v>248.22200000000001</c:v>
                </c:pt>
                <c:pt idx="711">
                  <c:v>245.428</c:v>
                </c:pt>
                <c:pt idx="712">
                  <c:v>242.673</c:v>
                </c:pt>
                <c:pt idx="713">
                  <c:v>240.08500000000001</c:v>
                </c:pt>
                <c:pt idx="714">
                  <c:v>237.55600000000001</c:v>
                </c:pt>
                <c:pt idx="715">
                  <c:v>234.91200000000001</c:v>
                </c:pt>
                <c:pt idx="716">
                  <c:v>232.392</c:v>
                </c:pt>
                <c:pt idx="717">
                  <c:v>229.86600000000001</c:v>
                </c:pt>
                <c:pt idx="718">
                  <c:v>227.44399999999999</c:v>
                </c:pt>
                <c:pt idx="719">
                  <c:v>224.99</c:v>
                </c:pt>
                <c:pt idx="720">
                  <c:v>222.58699999999999</c:v>
                </c:pt>
                <c:pt idx="721">
                  <c:v>220.16399999999999</c:v>
                </c:pt>
                <c:pt idx="722">
                  <c:v>217.922</c:v>
                </c:pt>
                <c:pt idx="723">
                  <c:v>215.63900000000001</c:v>
                </c:pt>
                <c:pt idx="724">
                  <c:v>213.31200000000001</c:v>
                </c:pt>
                <c:pt idx="725">
                  <c:v>211.065</c:v>
                </c:pt>
                <c:pt idx="726">
                  <c:v>208.965</c:v>
                </c:pt>
                <c:pt idx="727">
                  <c:v>206.72</c:v>
                </c:pt>
                <c:pt idx="728">
                  <c:v>204.50200000000001</c:v>
                </c:pt>
                <c:pt idx="729">
                  <c:v>202.405</c:v>
                </c:pt>
                <c:pt idx="730">
                  <c:v>200.36199999999999</c:v>
                </c:pt>
                <c:pt idx="731">
                  <c:v>198.23500000000001</c:v>
                </c:pt>
                <c:pt idx="732">
                  <c:v>196.17699999999999</c:v>
                </c:pt>
                <c:pt idx="733">
                  <c:v>194.22800000000001</c:v>
                </c:pt>
                <c:pt idx="734">
                  <c:v>192.23099999999999</c:v>
                </c:pt>
                <c:pt idx="735">
                  <c:v>190.232</c:v>
                </c:pt>
                <c:pt idx="736">
                  <c:v>188.333</c:v>
                </c:pt>
                <c:pt idx="737">
                  <c:v>186.39699999999999</c:v>
                </c:pt>
                <c:pt idx="738">
                  <c:v>184.53299999999999</c:v>
                </c:pt>
                <c:pt idx="739">
                  <c:v>182.68199999999999</c:v>
                </c:pt>
                <c:pt idx="740">
                  <c:v>180.80500000000001</c:v>
                </c:pt>
                <c:pt idx="741">
                  <c:v>179.02099999999999</c:v>
                </c:pt>
                <c:pt idx="742">
                  <c:v>177.23699999999999</c:v>
                </c:pt>
                <c:pt idx="743">
                  <c:v>175.45599999999999</c:v>
                </c:pt>
                <c:pt idx="744">
                  <c:v>173.673</c:v>
                </c:pt>
                <c:pt idx="745">
                  <c:v>171.988</c:v>
                </c:pt>
                <c:pt idx="746">
                  <c:v>170.34</c:v>
                </c:pt>
                <c:pt idx="747">
                  <c:v>168.61799999999999</c:v>
                </c:pt>
                <c:pt idx="748">
                  <c:v>166.946</c:v>
                </c:pt>
                <c:pt idx="749">
                  <c:v>165.417</c:v>
                </c:pt>
                <c:pt idx="750">
                  <c:v>163.761</c:v>
                </c:pt>
                <c:pt idx="751">
                  <c:v>162.12899999999999</c:v>
                </c:pt>
                <c:pt idx="752">
                  <c:v>160.59299999999999</c:v>
                </c:pt>
                <c:pt idx="753">
                  <c:v>159.08000000000001</c:v>
                </c:pt>
                <c:pt idx="754">
                  <c:v>157.53200000000001</c:v>
                </c:pt>
                <c:pt idx="755">
                  <c:v>156.023</c:v>
                </c:pt>
                <c:pt idx="756">
                  <c:v>154.52799999999999</c:v>
                </c:pt>
                <c:pt idx="757">
                  <c:v>153.10599999999999</c:v>
                </c:pt>
                <c:pt idx="758">
                  <c:v>151.62799999999999</c:v>
                </c:pt>
                <c:pt idx="759">
                  <c:v>150.22399999999999</c:v>
                </c:pt>
                <c:pt idx="760">
                  <c:v>148.803</c:v>
                </c:pt>
                <c:pt idx="761">
                  <c:v>147.41300000000001</c:v>
                </c:pt>
                <c:pt idx="762">
                  <c:v>146.04499999999999</c:v>
                </c:pt>
                <c:pt idx="763">
                  <c:v>144.65100000000001</c:v>
                </c:pt>
                <c:pt idx="764">
                  <c:v>143.33199999999999</c:v>
                </c:pt>
                <c:pt idx="765">
                  <c:v>142.00299999999999</c:v>
                </c:pt>
                <c:pt idx="766">
                  <c:v>140.678</c:v>
                </c:pt>
                <c:pt idx="767">
                  <c:v>139.35300000000001</c:v>
                </c:pt>
                <c:pt idx="768">
                  <c:v>138.11500000000001</c:v>
                </c:pt>
                <c:pt idx="769">
                  <c:v>136.88200000000001</c:v>
                </c:pt>
                <c:pt idx="770">
                  <c:v>135.60400000000001</c:v>
                </c:pt>
                <c:pt idx="771">
                  <c:v>134.36000000000001</c:v>
                </c:pt>
                <c:pt idx="772">
                  <c:v>133.21899999999999</c:v>
                </c:pt>
                <c:pt idx="773">
                  <c:v>131.988</c:v>
                </c:pt>
                <c:pt idx="774">
                  <c:v>130.77199999999999</c:v>
                </c:pt>
                <c:pt idx="775">
                  <c:v>129.62200000000001</c:v>
                </c:pt>
                <c:pt idx="776">
                  <c:v>128.49100000000001</c:v>
                </c:pt>
                <c:pt idx="777">
                  <c:v>127.32299999999999</c:v>
                </c:pt>
                <c:pt idx="778">
                  <c:v>126.193</c:v>
                </c:pt>
                <c:pt idx="779">
                  <c:v>125.065</c:v>
                </c:pt>
                <c:pt idx="780">
                  <c:v>123.996</c:v>
                </c:pt>
                <c:pt idx="781">
                  <c:v>122.88500000000001</c:v>
                </c:pt>
                <c:pt idx="782">
                  <c:v>121.82</c:v>
                </c:pt>
                <c:pt idx="783">
                  <c:v>120.73</c:v>
                </c:pt>
                <c:pt idx="784">
                  <c:v>119.709</c:v>
                </c:pt>
                <c:pt idx="785">
                  <c:v>118.678</c:v>
                </c:pt>
                <c:pt idx="786">
                  <c:v>117.617</c:v>
                </c:pt>
                <c:pt idx="787">
                  <c:v>116.577</c:v>
                </c:pt>
                <c:pt idx="788">
                  <c:v>115.621</c:v>
                </c:pt>
                <c:pt idx="789">
                  <c:v>114.602</c:v>
                </c:pt>
                <c:pt idx="790">
                  <c:v>113.593</c:v>
                </c:pt>
                <c:pt idx="791">
                  <c:v>112.626</c:v>
                </c:pt>
                <c:pt idx="792">
                  <c:v>111.70399999999999</c:v>
                </c:pt>
                <c:pt idx="793">
                  <c:v>110.726</c:v>
                </c:pt>
                <c:pt idx="794">
                  <c:v>109.782</c:v>
                </c:pt>
                <c:pt idx="795">
                  <c:v>108.879</c:v>
                </c:pt>
                <c:pt idx="796">
                  <c:v>107.967</c:v>
                </c:pt>
                <c:pt idx="797">
                  <c:v>107.045</c:v>
                </c:pt>
                <c:pt idx="798">
                  <c:v>106.175</c:v>
                </c:pt>
                <c:pt idx="799">
                  <c:v>105.27200000000001</c:v>
                </c:pt>
                <c:pt idx="800">
                  <c:v>104.42400000000001</c:v>
                </c:pt>
                <c:pt idx="801">
                  <c:v>103.55800000000001</c:v>
                </c:pt>
                <c:pt idx="802">
                  <c:v>102.691</c:v>
                </c:pt>
                <c:pt idx="803">
                  <c:v>101.851</c:v>
                </c:pt>
                <c:pt idx="804">
                  <c:v>101.01900000000001</c:v>
                </c:pt>
                <c:pt idx="805">
                  <c:v>100.19799999999999</c:v>
                </c:pt>
                <c:pt idx="806">
                  <c:v>99.36</c:v>
                </c:pt>
                <c:pt idx="807">
                  <c:v>98.546999999999997</c:v>
                </c:pt>
                <c:pt idx="808">
                  <c:v>97.789000000000001</c:v>
                </c:pt>
                <c:pt idx="809">
                  <c:v>96.974000000000004</c:v>
                </c:pt>
                <c:pt idx="810">
                  <c:v>96.164000000000001</c:v>
                </c:pt>
                <c:pt idx="811">
                  <c:v>95.433000000000007</c:v>
                </c:pt>
                <c:pt idx="812">
                  <c:v>94.644999999999996</c:v>
                </c:pt>
                <c:pt idx="813">
                  <c:v>93.863</c:v>
                </c:pt>
                <c:pt idx="814">
                  <c:v>93.114000000000004</c:v>
                </c:pt>
                <c:pt idx="815">
                  <c:v>92.375</c:v>
                </c:pt>
                <c:pt idx="816">
                  <c:v>91.634</c:v>
                </c:pt>
                <c:pt idx="817">
                  <c:v>90.893000000000001</c:v>
                </c:pt>
                <c:pt idx="818">
                  <c:v>90.171999999999997</c:v>
                </c:pt>
                <c:pt idx="819">
                  <c:v>89.483999999999995</c:v>
                </c:pt>
                <c:pt idx="820">
                  <c:v>88.763999999999996</c:v>
                </c:pt>
                <c:pt idx="821">
                  <c:v>88.09</c:v>
                </c:pt>
                <c:pt idx="822">
                  <c:v>87.391999999999996</c:v>
                </c:pt>
                <c:pt idx="823">
                  <c:v>86.733000000000004</c:v>
                </c:pt>
                <c:pt idx="824">
                  <c:v>86.078000000000003</c:v>
                </c:pt>
                <c:pt idx="825">
                  <c:v>85.412000000000006</c:v>
                </c:pt>
                <c:pt idx="826">
                  <c:v>84.74</c:v>
                </c:pt>
                <c:pt idx="827">
                  <c:v>84.126999999999995</c:v>
                </c:pt>
                <c:pt idx="828">
                  <c:v>83.49</c:v>
                </c:pt>
                <c:pt idx="829">
                  <c:v>82.853999999999999</c:v>
                </c:pt>
                <c:pt idx="830">
                  <c:v>82.225999999999999</c:v>
                </c:pt>
                <c:pt idx="831">
                  <c:v>81.644000000000005</c:v>
                </c:pt>
                <c:pt idx="832">
                  <c:v>81.021000000000001</c:v>
                </c:pt>
                <c:pt idx="833">
                  <c:v>80.402000000000001</c:v>
                </c:pt>
                <c:pt idx="834">
                  <c:v>79.804000000000002</c:v>
                </c:pt>
                <c:pt idx="835">
                  <c:v>79.227999999999994</c:v>
                </c:pt>
                <c:pt idx="836">
                  <c:v>78.625</c:v>
                </c:pt>
                <c:pt idx="837">
                  <c:v>78.057000000000002</c:v>
                </c:pt>
                <c:pt idx="838">
                  <c:v>77.488</c:v>
                </c:pt>
                <c:pt idx="839">
                  <c:v>76.918000000000006</c:v>
                </c:pt>
                <c:pt idx="840">
                  <c:v>76.352999999999994</c:v>
                </c:pt>
                <c:pt idx="841">
                  <c:v>75.796999999999997</c:v>
                </c:pt>
                <c:pt idx="842">
                  <c:v>75.244</c:v>
                </c:pt>
                <c:pt idx="843">
                  <c:v>74.712999999999994</c:v>
                </c:pt>
                <c:pt idx="844">
                  <c:v>74.191000000000003</c:v>
                </c:pt>
                <c:pt idx="845">
                  <c:v>73.653000000000006</c:v>
                </c:pt>
                <c:pt idx="846">
                  <c:v>73.146000000000001</c:v>
                </c:pt>
                <c:pt idx="847">
                  <c:v>72.64</c:v>
                </c:pt>
                <c:pt idx="848">
                  <c:v>72.125</c:v>
                </c:pt>
                <c:pt idx="849">
                  <c:v>71.613</c:v>
                </c:pt>
                <c:pt idx="850">
                  <c:v>71.135000000000005</c:v>
                </c:pt>
                <c:pt idx="851">
                  <c:v>70.653999999999996</c:v>
                </c:pt>
                <c:pt idx="852">
                  <c:v>70.156000000000006</c:v>
                </c:pt>
                <c:pt idx="853">
                  <c:v>69.676000000000002</c:v>
                </c:pt>
                <c:pt idx="854">
                  <c:v>69.225999999999999</c:v>
                </c:pt>
                <c:pt idx="855">
                  <c:v>68.748000000000005</c:v>
                </c:pt>
                <c:pt idx="856">
                  <c:v>68.278999999999996</c:v>
                </c:pt>
                <c:pt idx="857">
                  <c:v>67.823999999999998</c:v>
                </c:pt>
                <c:pt idx="858">
                  <c:v>67.382000000000005</c:v>
                </c:pt>
                <c:pt idx="859">
                  <c:v>66.923000000000002</c:v>
                </c:pt>
                <c:pt idx="860">
                  <c:v>66.480999999999995</c:v>
                </c:pt>
                <c:pt idx="861">
                  <c:v>66.034000000000006</c:v>
                </c:pt>
                <c:pt idx="862">
                  <c:v>65.614000000000004</c:v>
                </c:pt>
                <c:pt idx="863">
                  <c:v>65.183999999999997</c:v>
                </c:pt>
                <c:pt idx="864">
                  <c:v>64.760000000000005</c:v>
                </c:pt>
                <c:pt idx="865">
                  <c:v>64.334999999999994</c:v>
                </c:pt>
                <c:pt idx="866">
                  <c:v>63.94</c:v>
                </c:pt>
                <c:pt idx="867">
                  <c:v>63.540999999999997</c:v>
                </c:pt>
                <c:pt idx="868">
                  <c:v>63.131999999999998</c:v>
                </c:pt>
                <c:pt idx="869">
                  <c:v>62.723999999999997</c:v>
                </c:pt>
                <c:pt idx="870">
                  <c:v>62.357999999999997</c:v>
                </c:pt>
                <c:pt idx="871">
                  <c:v>61.965000000000003</c:v>
                </c:pt>
                <c:pt idx="872">
                  <c:v>61.572000000000003</c:v>
                </c:pt>
                <c:pt idx="873">
                  <c:v>61.2</c:v>
                </c:pt>
                <c:pt idx="874">
                  <c:v>60.841999999999999</c:v>
                </c:pt>
                <c:pt idx="875">
                  <c:v>60.47</c:v>
                </c:pt>
                <c:pt idx="876">
                  <c:v>60.115000000000002</c:v>
                </c:pt>
                <c:pt idx="877">
                  <c:v>59.761000000000003</c:v>
                </c:pt>
                <c:pt idx="878">
                  <c:v>59.418999999999997</c:v>
                </c:pt>
                <c:pt idx="879">
                  <c:v>59.069000000000003</c:v>
                </c:pt>
                <c:pt idx="880">
                  <c:v>58.731999999999999</c:v>
                </c:pt>
                <c:pt idx="881">
                  <c:v>58.398000000000003</c:v>
                </c:pt>
                <c:pt idx="882">
                  <c:v>58.055</c:v>
                </c:pt>
                <c:pt idx="883">
                  <c:v>57.726999999999997</c:v>
                </c:pt>
                <c:pt idx="884">
                  <c:v>57.390999999999998</c:v>
                </c:pt>
                <c:pt idx="885">
                  <c:v>57.064999999999998</c:v>
                </c:pt>
                <c:pt idx="886">
                  <c:v>56.752000000000002</c:v>
                </c:pt>
                <c:pt idx="887">
                  <c:v>56.435000000000002</c:v>
                </c:pt>
                <c:pt idx="888">
                  <c:v>56.119</c:v>
                </c:pt>
                <c:pt idx="889">
                  <c:v>55.823</c:v>
                </c:pt>
                <c:pt idx="890">
                  <c:v>55.523000000000003</c:v>
                </c:pt>
                <c:pt idx="891">
                  <c:v>55.216000000000001</c:v>
                </c:pt>
                <c:pt idx="892">
                  <c:v>54.915999999999997</c:v>
                </c:pt>
                <c:pt idx="893">
                  <c:v>54.64</c:v>
                </c:pt>
                <c:pt idx="894">
                  <c:v>54.344000000000001</c:v>
                </c:pt>
                <c:pt idx="895">
                  <c:v>54.051000000000002</c:v>
                </c:pt>
                <c:pt idx="896">
                  <c:v>53.768999999999998</c:v>
                </c:pt>
                <c:pt idx="897">
                  <c:v>53.505000000000003</c:v>
                </c:pt>
                <c:pt idx="898">
                  <c:v>53.225999999999999</c:v>
                </c:pt>
                <c:pt idx="899">
                  <c:v>52.957999999999998</c:v>
                </c:pt>
                <c:pt idx="900">
                  <c:v>52.686</c:v>
                </c:pt>
                <c:pt idx="901">
                  <c:v>52.427999999999997</c:v>
                </c:pt>
                <c:pt idx="902">
                  <c:v>52.164000000000001</c:v>
                </c:pt>
                <c:pt idx="903">
                  <c:v>51.908000000000001</c:v>
                </c:pt>
                <c:pt idx="904">
                  <c:v>51.64</c:v>
                </c:pt>
                <c:pt idx="905">
                  <c:v>51.395000000000003</c:v>
                </c:pt>
                <c:pt idx="906">
                  <c:v>51.143999999999998</c:v>
                </c:pt>
                <c:pt idx="907">
                  <c:v>50.884</c:v>
                </c:pt>
                <c:pt idx="908">
                  <c:v>50.634</c:v>
                </c:pt>
                <c:pt idx="909">
                  <c:v>50.386000000000003</c:v>
                </c:pt>
                <c:pt idx="910">
                  <c:v>50.136000000000003</c:v>
                </c:pt>
                <c:pt idx="911">
                  <c:v>49.884999999999998</c:v>
                </c:pt>
                <c:pt idx="912">
                  <c:v>49.643999999999998</c:v>
                </c:pt>
                <c:pt idx="913">
                  <c:v>49.41</c:v>
                </c:pt>
                <c:pt idx="914">
                  <c:v>49.165999999999997</c:v>
                </c:pt>
                <c:pt idx="915">
                  <c:v>48.920999999999999</c:v>
                </c:pt>
                <c:pt idx="916">
                  <c:v>48.689</c:v>
                </c:pt>
                <c:pt idx="917">
                  <c:v>48.468000000000004</c:v>
                </c:pt>
                <c:pt idx="918">
                  <c:v>48.235999999999997</c:v>
                </c:pt>
                <c:pt idx="919">
                  <c:v>48.017000000000003</c:v>
                </c:pt>
                <c:pt idx="920">
                  <c:v>47.798000000000002</c:v>
                </c:pt>
                <c:pt idx="921">
                  <c:v>47.582000000000001</c:v>
                </c:pt>
                <c:pt idx="922">
                  <c:v>47.366999999999997</c:v>
                </c:pt>
                <c:pt idx="923">
                  <c:v>47.145000000000003</c:v>
                </c:pt>
                <c:pt idx="924">
                  <c:v>46.94</c:v>
                </c:pt>
                <c:pt idx="925">
                  <c:v>46.728000000000002</c:v>
                </c:pt>
                <c:pt idx="926">
                  <c:v>46.518999999999998</c:v>
                </c:pt>
                <c:pt idx="927">
                  <c:v>46.304000000000002</c:v>
                </c:pt>
                <c:pt idx="928">
                  <c:v>46.1</c:v>
                </c:pt>
                <c:pt idx="929">
                  <c:v>45.902000000000001</c:v>
                </c:pt>
                <c:pt idx="930">
                  <c:v>45.686999999999998</c:v>
                </c:pt>
                <c:pt idx="931">
                  <c:v>45.475000000000001</c:v>
                </c:pt>
                <c:pt idx="932">
                  <c:v>45.284999999999997</c:v>
                </c:pt>
                <c:pt idx="933">
                  <c:v>45.079000000000001</c:v>
                </c:pt>
                <c:pt idx="934">
                  <c:v>44.872999999999998</c:v>
                </c:pt>
                <c:pt idx="935">
                  <c:v>44.671999999999997</c:v>
                </c:pt>
                <c:pt idx="936">
                  <c:v>44.485999999999997</c:v>
                </c:pt>
                <c:pt idx="937">
                  <c:v>44.284999999999997</c:v>
                </c:pt>
                <c:pt idx="938">
                  <c:v>44.088999999999999</c:v>
                </c:pt>
                <c:pt idx="939">
                  <c:v>43.9</c:v>
                </c:pt>
                <c:pt idx="940">
                  <c:v>43.718000000000004</c:v>
                </c:pt>
                <c:pt idx="941">
                  <c:v>43.527000000000001</c:v>
                </c:pt>
                <c:pt idx="942">
                  <c:v>43.343000000000004</c:v>
                </c:pt>
                <c:pt idx="943">
                  <c:v>43.155000000000001</c:v>
                </c:pt>
                <c:pt idx="944">
                  <c:v>42.978999999999999</c:v>
                </c:pt>
                <c:pt idx="945">
                  <c:v>42.8</c:v>
                </c:pt>
                <c:pt idx="946">
                  <c:v>42.616999999999997</c:v>
                </c:pt>
                <c:pt idx="947">
                  <c:v>42.439</c:v>
                </c:pt>
                <c:pt idx="948">
                  <c:v>42.265999999999998</c:v>
                </c:pt>
                <c:pt idx="949">
                  <c:v>42.094999999999999</c:v>
                </c:pt>
                <c:pt idx="950">
                  <c:v>41.915999999999997</c:v>
                </c:pt>
                <c:pt idx="951">
                  <c:v>41.746000000000002</c:v>
                </c:pt>
                <c:pt idx="952">
                  <c:v>41.585999999999999</c:v>
                </c:pt>
                <c:pt idx="953">
                  <c:v>41.415999999999997</c:v>
                </c:pt>
                <c:pt idx="954">
                  <c:v>41.244999999999997</c:v>
                </c:pt>
                <c:pt idx="955">
                  <c:v>41.088999999999999</c:v>
                </c:pt>
                <c:pt idx="956">
                  <c:v>40.924999999999997</c:v>
                </c:pt>
                <c:pt idx="957">
                  <c:v>40.76</c:v>
                </c:pt>
                <c:pt idx="958">
                  <c:v>40.634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A84-F547-AA32-26810AA95A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246128"/>
        <c:axId val="253244560"/>
      </c:scatterChart>
      <c:valAx>
        <c:axId val="2532461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Elute Volume, Ve (ml)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crossAx val="253244560"/>
        <c:crosses val="autoZero"/>
        <c:crossBetween val="midCat"/>
      </c:valAx>
      <c:valAx>
        <c:axId val="253244560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UV Absorption (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U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6.6181859805445317E-2"/>
              <c:y val="3.6584403094692422E-2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253246128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577</cdr:x>
      <cdr:y>0.09237</cdr:y>
    </cdr:from>
    <cdr:to>
      <cdr:x>0.12941</cdr:x>
      <cdr:y>0.66115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52437" y="229192"/>
          <a:ext cx="189456" cy="141128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  <cdr:relSizeAnchor xmlns:cdr="http://schemas.openxmlformats.org/drawingml/2006/chartDrawing">
    <cdr:from>
      <cdr:x>0.30677</cdr:x>
      <cdr:y>0.90854</cdr:y>
    </cdr:from>
    <cdr:to>
      <cdr:x>0.69522</cdr:x>
      <cdr:y>0.98476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1466850" y="2838450"/>
          <a:ext cx="1857375" cy="2381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  <cdr:relSizeAnchor xmlns:cdr="http://schemas.openxmlformats.org/drawingml/2006/chartDrawing">
    <cdr:from>
      <cdr:x>0.30571</cdr:x>
      <cdr:y>0.82774</cdr:y>
    </cdr:from>
    <cdr:to>
      <cdr:x>0.97174</cdr:x>
      <cdr:y>1</cdr:y>
    </cdr:to>
    <cdr:sp macro="" textlink="">
      <cdr:nvSpPr>
        <cdr:cNvPr id="6" name="TextBox 5"/>
        <cdr:cNvSpPr txBox="1"/>
      </cdr:nvSpPr>
      <cdr:spPr>
        <a:xfrm xmlns:a="http://schemas.openxmlformats.org/drawingml/2006/main">
          <a:off x="764704" y="1410244"/>
          <a:ext cx="1666018" cy="29348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GB" sz="1200" b="1" dirty="0">
              <a:cs typeface="Arial" panose="020B0604020202020204" pitchFamily="34" charset="0"/>
            </a:rPr>
            <a:t>Elute Volume, </a:t>
          </a:r>
          <a:r>
            <a:rPr lang="en-GB" sz="1200" b="1" dirty="0" err="1">
              <a:cs typeface="Arial" panose="020B0604020202020204" pitchFamily="34" charset="0"/>
            </a:rPr>
            <a:t>V</a:t>
          </a:r>
          <a:r>
            <a:rPr lang="en-GB" sz="1050" b="1" dirty="0" err="1">
              <a:cs typeface="Arial" panose="020B0604020202020204" pitchFamily="34" charset="0"/>
            </a:rPr>
            <a:t>e</a:t>
          </a:r>
          <a:r>
            <a:rPr lang="en-GB" sz="1200" b="1" dirty="0">
              <a:cs typeface="Arial" panose="020B0604020202020204" pitchFamily="34" charset="0"/>
            </a:rPr>
            <a:t> (ml)</a:t>
          </a:r>
        </a:p>
      </cdr:txBody>
    </cdr:sp>
  </cdr:relSizeAnchor>
  <cdr:relSizeAnchor xmlns:cdr="http://schemas.openxmlformats.org/drawingml/2006/chartDrawing">
    <cdr:from>
      <cdr:x>0</cdr:x>
      <cdr:y>0</cdr:y>
    </cdr:from>
    <cdr:to>
      <cdr:x>1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0"/>
          <a:ext cx="2776994" cy="146709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vert="vert270" wrap="square" rtlCol="0"/>
        <a:lstStyle xmlns:a="http://schemas.openxmlformats.org/drawingml/2006/main"/>
        <a:p xmlns:a="http://schemas.openxmlformats.org/drawingml/2006/main">
          <a:pPr algn="ctr"/>
          <a:r>
            <a:rPr lang="en-GB" sz="1000" b="1" dirty="0">
              <a:latin typeface="Arial" panose="020B0604020202020204" pitchFamily="34" charset="0"/>
              <a:cs typeface="Arial" panose="020B0604020202020204" pitchFamily="34" charset="0"/>
            </a:rPr>
            <a:t>UV Absorption </a:t>
          </a:r>
          <a:endParaRPr lang="en-GB" sz="1000" b="1" dirty="0" smtClean="0">
            <a:latin typeface="Arial" panose="020B0604020202020204" pitchFamily="34" charset="0"/>
            <a:cs typeface="Arial" panose="020B0604020202020204" pitchFamily="34" charset="0"/>
          </a:endParaRPr>
        </a:p>
        <a:p xmlns:a="http://schemas.openxmlformats.org/drawingml/2006/main">
          <a:pPr algn="ctr"/>
          <a:r>
            <a:rPr lang="en-GB" sz="1000" b="1" dirty="0" smtClean="0">
              <a:latin typeface="Arial" panose="020B0604020202020204" pitchFamily="34" charset="0"/>
              <a:cs typeface="Arial" panose="020B0604020202020204" pitchFamily="34" charset="0"/>
            </a:rPr>
            <a:t>(</a:t>
          </a:r>
          <a:r>
            <a:rPr lang="en-GB" sz="1000" b="1" dirty="0" err="1" smtClean="0">
              <a:latin typeface="Arial" panose="020B0604020202020204" pitchFamily="34" charset="0"/>
              <a:cs typeface="Arial" panose="020B0604020202020204" pitchFamily="34" charset="0"/>
            </a:rPr>
            <a:t>mAU</a:t>
          </a:r>
          <a:r>
            <a:rPr lang="en-GB" sz="1000" b="1" dirty="0">
              <a:latin typeface="Arial" panose="020B0604020202020204" pitchFamily="34" charset="0"/>
              <a:cs typeface="Arial" panose="020B0604020202020204" pitchFamily="34" charset="0"/>
            </a:rPr>
            <a:t>)</a:t>
          </a:r>
          <a:r>
            <a:rPr lang="en-GB" sz="1000" b="1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endParaRPr lang="en-GB" sz="10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1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0"/>
          <a:ext cx="2902182" cy="13364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vert="vert270" wrap="square" rtlCol="0"/>
        <a:lstStyle xmlns:a="http://schemas.openxmlformats.org/drawingml/2006/main"/>
        <a:p xmlns:a="http://schemas.openxmlformats.org/drawingml/2006/main">
          <a:pPr algn="ctr"/>
          <a:r>
            <a:rPr lang="en-GB" sz="1000" b="1" dirty="0">
              <a:latin typeface="Arial" panose="020B0604020202020204" pitchFamily="34" charset="0"/>
              <a:cs typeface="Arial" panose="020B0604020202020204" pitchFamily="34" charset="0"/>
            </a:rPr>
            <a:t>UV </a:t>
          </a:r>
          <a:r>
            <a:rPr lang="en-GB" sz="1000" b="1" dirty="0" smtClean="0">
              <a:latin typeface="Arial" panose="020B0604020202020204" pitchFamily="34" charset="0"/>
              <a:cs typeface="Arial" panose="020B0604020202020204" pitchFamily="34" charset="0"/>
            </a:rPr>
            <a:t>Absorption (</a:t>
          </a:r>
          <a:r>
            <a:rPr lang="en-GB" sz="1000" b="1" dirty="0" err="1" smtClean="0">
              <a:latin typeface="Arial" panose="020B0604020202020204" pitchFamily="34" charset="0"/>
              <a:cs typeface="Arial" panose="020B0604020202020204" pitchFamily="34" charset="0"/>
            </a:rPr>
            <a:t>mAU</a:t>
          </a:r>
          <a:r>
            <a:rPr lang="en-GB" sz="1000" b="1" dirty="0" smtClean="0">
              <a:latin typeface="Arial" panose="020B0604020202020204" pitchFamily="34" charset="0"/>
              <a:cs typeface="Arial" panose="020B0604020202020204" pitchFamily="34" charset="0"/>
            </a:rPr>
            <a:t>)</a:t>
          </a:r>
          <a:endParaRPr lang="en-GB" sz="10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366</cdr:x>
      <cdr:y>0.11449</cdr:y>
    </cdr:from>
    <cdr:to>
      <cdr:x>0.23903</cdr:x>
      <cdr:y>0.87121</cdr:y>
    </cdr:to>
    <cdr:sp macro="" textlink="">
      <cdr:nvSpPr>
        <cdr:cNvPr id="6" name="TextBox 5"/>
        <cdr:cNvSpPr txBox="1"/>
      </cdr:nvSpPr>
      <cdr:spPr>
        <a:xfrm xmlns:a="http://schemas.openxmlformats.org/drawingml/2006/main" rot="16200000">
          <a:off x="-220540" y="526842"/>
          <a:ext cx="1284348" cy="61930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GB" sz="1000" b="1" dirty="0">
              <a:latin typeface="Arial" panose="020B0604020202020204" pitchFamily="34" charset="0"/>
              <a:cs typeface="Arial" panose="020B0604020202020204" pitchFamily="34" charset="0"/>
            </a:rPr>
            <a:t> UV Absorption (mAU)</a:t>
          </a:r>
        </a:p>
        <a:p xmlns:a="http://schemas.openxmlformats.org/drawingml/2006/main">
          <a:pPr algn="ctr"/>
          <a:endParaRPr lang="en-GB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9404</cdr:x>
      <cdr:y>0.6319</cdr:y>
    </cdr:from>
    <cdr:to>
      <cdr:x>0.89097</cdr:x>
      <cdr:y>0.7239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3249705" y="3462617"/>
          <a:ext cx="2610970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  <cdr:relSizeAnchor xmlns:cdr="http://schemas.openxmlformats.org/drawingml/2006/chartDrawing">
    <cdr:from>
      <cdr:x>0.40886</cdr:x>
      <cdr:y>0.90798</cdr:y>
    </cdr:from>
    <cdr:to>
      <cdr:x>0.49404</cdr:x>
      <cdr:y>0.96933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2689411" y="4975411"/>
          <a:ext cx="560294" cy="3361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  <cdr:relSizeAnchor xmlns:cdr="http://schemas.openxmlformats.org/drawingml/2006/chartDrawing">
    <cdr:from>
      <cdr:x>0.35186</cdr:x>
      <cdr:y>0.84653</cdr:y>
    </cdr:from>
    <cdr:to>
      <cdr:x>0.97028</cdr:x>
      <cdr:y>1</cdr:y>
    </cdr:to>
    <cdr:sp macro="" textlink="">
      <cdr:nvSpPr>
        <cdr:cNvPr id="8" name="TextBox 7"/>
        <cdr:cNvSpPr txBox="1"/>
      </cdr:nvSpPr>
      <cdr:spPr>
        <a:xfrm xmlns:a="http://schemas.openxmlformats.org/drawingml/2006/main">
          <a:off x="1011523" y="1914378"/>
          <a:ext cx="1777815" cy="3470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GB" sz="1200" b="1" dirty="0">
              <a:cs typeface="Arial" panose="020B0604020202020204" pitchFamily="34" charset="0"/>
            </a:rPr>
            <a:t>Elute</a:t>
          </a:r>
          <a:r>
            <a:rPr lang="en-GB" sz="1200" b="1" dirty="0"/>
            <a:t> </a:t>
          </a:r>
          <a:r>
            <a:rPr lang="en-GB" sz="1200" b="1" baseline="0" dirty="0"/>
            <a:t>Volume, </a:t>
          </a:r>
          <a:r>
            <a:rPr lang="en-GB" sz="1200" b="1" baseline="0" dirty="0" err="1"/>
            <a:t>V</a:t>
          </a:r>
          <a:r>
            <a:rPr lang="en-GB" sz="1000" b="1" baseline="0" dirty="0" err="1"/>
            <a:t>e</a:t>
          </a:r>
          <a:r>
            <a:rPr lang="en-GB" sz="1200" b="1" baseline="0" dirty="0"/>
            <a:t> (ml)</a:t>
          </a:r>
          <a:endParaRPr lang="en-GB" sz="1200" b="1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8397C4-8F9F-4E7E-9654-D1E60B6BD9D1}" type="datetimeFigureOut">
              <a:rPr lang="en-GB" smtClean="0"/>
              <a:t>28/02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9775" y="741363"/>
            <a:ext cx="27781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690269"/>
            <a:ext cx="5438140" cy="44434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562483-2D9A-44BA-A35D-FD744E48AA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92629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30C71-19F4-4D2E-A882-CD6AAEB4321C}" type="datetimeFigureOut">
              <a:rPr lang="en-GB" smtClean="0"/>
              <a:t>28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BF65E-B84C-4A29-8616-2F7A9720F8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8173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30C71-19F4-4D2E-A882-CD6AAEB4321C}" type="datetimeFigureOut">
              <a:rPr lang="en-GB" smtClean="0"/>
              <a:t>28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BF65E-B84C-4A29-8616-2F7A9720F8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90583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30C71-19F4-4D2E-A882-CD6AAEB4321C}" type="datetimeFigureOut">
              <a:rPr lang="en-GB" smtClean="0"/>
              <a:t>28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BF65E-B84C-4A29-8616-2F7A9720F8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54159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30C71-19F4-4D2E-A882-CD6AAEB4321C}" type="datetimeFigureOut">
              <a:rPr lang="en-GB" smtClean="0"/>
              <a:t>28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BF65E-B84C-4A29-8616-2F7A9720F8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2158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30C71-19F4-4D2E-A882-CD6AAEB4321C}" type="datetimeFigureOut">
              <a:rPr lang="en-GB" smtClean="0"/>
              <a:t>28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BF65E-B84C-4A29-8616-2F7A9720F8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8552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30C71-19F4-4D2E-A882-CD6AAEB4321C}" type="datetimeFigureOut">
              <a:rPr lang="en-GB" smtClean="0"/>
              <a:t>28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BF65E-B84C-4A29-8616-2F7A9720F8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3502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30C71-19F4-4D2E-A882-CD6AAEB4321C}" type="datetimeFigureOut">
              <a:rPr lang="en-GB" smtClean="0"/>
              <a:t>28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BF65E-B84C-4A29-8616-2F7A9720F8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5234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30C71-19F4-4D2E-A882-CD6AAEB4321C}" type="datetimeFigureOut">
              <a:rPr lang="en-GB" smtClean="0"/>
              <a:t>28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BF65E-B84C-4A29-8616-2F7A9720F8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848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30C71-19F4-4D2E-A882-CD6AAEB4321C}" type="datetimeFigureOut">
              <a:rPr lang="en-GB" smtClean="0"/>
              <a:t>28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BF65E-B84C-4A29-8616-2F7A9720F8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46399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30C71-19F4-4D2E-A882-CD6AAEB4321C}" type="datetimeFigureOut">
              <a:rPr lang="en-GB" smtClean="0"/>
              <a:t>28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BF65E-B84C-4A29-8616-2F7A9720F8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1460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30C71-19F4-4D2E-A882-CD6AAEB4321C}" type="datetimeFigureOut">
              <a:rPr lang="en-GB" smtClean="0"/>
              <a:t>28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BF65E-B84C-4A29-8616-2F7A9720F8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28227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630C71-19F4-4D2E-A882-CD6AAEB4321C}" type="datetimeFigureOut">
              <a:rPr lang="en-GB" smtClean="0"/>
              <a:t>28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6BF65E-B84C-4A29-8616-2F7A9720F8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18226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13" Type="http://schemas.openxmlformats.org/officeDocument/2006/relationships/image" Target="../media/image7.jpeg"/><Relationship Id="rId3" Type="http://schemas.openxmlformats.org/officeDocument/2006/relationships/chart" Target="../charts/chart2.xml"/><Relationship Id="rId7" Type="http://schemas.openxmlformats.org/officeDocument/2006/relationships/image" Target="../media/image4.jpg"/><Relationship Id="rId12" Type="http://schemas.openxmlformats.org/officeDocument/2006/relationships/image" Target="../media/image6.jp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g"/><Relationship Id="rId11" Type="http://schemas.openxmlformats.org/officeDocument/2006/relationships/chart" Target="../charts/chart5.xml"/><Relationship Id="rId5" Type="http://schemas.openxmlformats.org/officeDocument/2006/relationships/image" Target="../media/image2.jpg"/><Relationship Id="rId10" Type="http://schemas.openxmlformats.org/officeDocument/2006/relationships/chart" Target="../charts/chart4.xml"/><Relationship Id="rId4" Type="http://schemas.openxmlformats.org/officeDocument/2006/relationships/image" Target="../media/image1.jpg"/><Relationship Id="rId9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TextBox 172"/>
          <p:cNvSpPr txBox="1"/>
          <p:nvPr/>
        </p:nvSpPr>
        <p:spPr>
          <a:xfrm>
            <a:off x="44663" y="26204"/>
            <a:ext cx="5543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1</a:t>
            </a:r>
            <a:endParaRPr lang="en-GB" dirty="0"/>
          </a:p>
        </p:txBody>
      </p:sp>
      <p:grpSp>
        <p:nvGrpSpPr>
          <p:cNvPr id="5" name="Group 4"/>
          <p:cNvGrpSpPr>
            <a:grpSpLocks noChangeAspect="1"/>
          </p:cNvGrpSpPr>
          <p:nvPr/>
        </p:nvGrpSpPr>
        <p:grpSpPr>
          <a:xfrm>
            <a:off x="404662" y="395536"/>
            <a:ext cx="6263305" cy="7920880"/>
            <a:chOff x="-3398" y="-17197"/>
            <a:chExt cx="5885377" cy="9744433"/>
          </a:xfrm>
        </p:grpSpPr>
        <p:sp>
          <p:nvSpPr>
            <p:cNvPr id="6" name="TextBox 5"/>
            <p:cNvSpPr txBox="1"/>
            <p:nvPr/>
          </p:nvSpPr>
          <p:spPr>
            <a:xfrm>
              <a:off x="0" y="-17197"/>
              <a:ext cx="436280" cy="3407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</a:p>
          </p:txBody>
        </p:sp>
        <p:graphicFrame>
          <p:nvGraphicFramePr>
            <p:cNvPr id="57" name="Chart 5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74538508"/>
                </p:ext>
              </p:extLst>
            </p:nvPr>
          </p:nvGraphicFramePr>
          <p:xfrm>
            <a:off x="63876" y="2066735"/>
            <a:ext cx="2771496" cy="194421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3" name="Chart 4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19025652"/>
                </p:ext>
              </p:extLst>
            </p:nvPr>
          </p:nvGraphicFramePr>
          <p:xfrm>
            <a:off x="179191" y="3977574"/>
            <a:ext cx="2565269" cy="18048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781" t="50879" r="55073"/>
            <a:stretch/>
          </p:blipFill>
          <p:spPr>
            <a:xfrm>
              <a:off x="3650439" y="2337287"/>
              <a:ext cx="509396" cy="150633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230" t="50000" r="72349"/>
            <a:stretch/>
          </p:blipFill>
          <p:spPr>
            <a:xfrm>
              <a:off x="3230806" y="2337286"/>
              <a:ext cx="422017" cy="150720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cxnSp>
          <p:nvCxnSpPr>
            <p:cNvPr id="34" name="Straight Arrow Connector 33"/>
            <p:cNvCxnSpPr/>
            <p:nvPr/>
          </p:nvCxnSpPr>
          <p:spPr>
            <a:xfrm flipH="1">
              <a:off x="4170251" y="2894410"/>
              <a:ext cx="429613" cy="0"/>
            </a:xfrm>
            <a:prstGeom prst="straightConnector1">
              <a:avLst/>
            </a:prstGeom>
            <a:noFill/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0" y="1923371"/>
              <a:ext cx="402896" cy="3407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</a:p>
          </p:txBody>
        </p:sp>
        <p:cxnSp>
          <p:nvCxnSpPr>
            <p:cNvPr id="49" name="Straight Arrow Connector 48"/>
            <p:cNvCxnSpPr/>
            <p:nvPr/>
          </p:nvCxnSpPr>
          <p:spPr>
            <a:xfrm flipH="1">
              <a:off x="4170251" y="4885114"/>
              <a:ext cx="429613" cy="0"/>
            </a:xfrm>
            <a:prstGeom prst="straightConnector1">
              <a:avLst/>
            </a:prstGeom>
            <a:noFill/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pic>
          <p:nvPicPr>
            <p:cNvPr id="44" name="Picture 43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137" t="43647" r="23706" b="2152"/>
            <a:stretch/>
          </p:blipFill>
          <p:spPr>
            <a:xfrm>
              <a:off x="3233197" y="4310742"/>
              <a:ext cx="428794" cy="14377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sp>
          <p:nvSpPr>
            <p:cNvPr id="58" name="TextBox 57"/>
            <p:cNvSpPr txBox="1"/>
            <p:nvPr/>
          </p:nvSpPr>
          <p:spPr>
            <a:xfrm>
              <a:off x="0" y="3832176"/>
              <a:ext cx="368620" cy="3407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.</a:t>
              </a:r>
            </a:p>
          </p:txBody>
        </p:sp>
        <p:sp>
          <p:nvSpPr>
            <p:cNvPr id="3" name="Rectangle 2"/>
            <p:cNvSpPr/>
            <p:nvPr/>
          </p:nvSpPr>
          <p:spPr>
            <a:xfrm>
              <a:off x="4553093" y="2749684"/>
              <a:ext cx="1328886" cy="34077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Bc-CBD</a:t>
              </a:r>
              <a:r>
                <a:rPr lang="en-GB" sz="12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243-1259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Rectangle 3"/>
            <p:cNvSpPr/>
            <p:nvPr/>
          </p:nvSpPr>
          <p:spPr>
            <a:xfrm>
              <a:off x="4569249" y="4725884"/>
              <a:ext cx="1186111" cy="34077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Bc-CBD</a:t>
              </a:r>
              <a:r>
                <a:rPr lang="en-GB" sz="12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41-257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Straight Connector 38"/>
            <p:cNvCxnSpPr/>
            <p:nvPr/>
          </p:nvCxnSpPr>
          <p:spPr>
            <a:xfrm>
              <a:off x="1969886" y="2353875"/>
              <a:ext cx="0" cy="1023812"/>
            </a:xfrm>
            <a:prstGeom prst="line">
              <a:avLst/>
            </a:prstGeom>
            <a:noFill/>
            <a:ln>
              <a:prstDash val="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1323204" y="2138743"/>
              <a:ext cx="676603" cy="321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GB" sz="11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Da</a:t>
              </a:r>
              <a:endParaRPr lang="en-GB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714153" y="2138743"/>
              <a:ext cx="761179" cy="321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70kDa</a:t>
              </a:r>
            </a:p>
          </p:txBody>
        </p:sp>
        <p:pic>
          <p:nvPicPr>
            <p:cNvPr id="86" name="Picture 85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002" t="52056" r="45435" b="1"/>
            <a:stretch/>
          </p:blipFill>
          <p:spPr>
            <a:xfrm>
              <a:off x="3744896" y="6332999"/>
              <a:ext cx="363740" cy="130624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pic>
          <p:nvPicPr>
            <p:cNvPr id="87" name="Picture 86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858" t="51039" r="13398"/>
            <a:stretch/>
          </p:blipFill>
          <p:spPr>
            <a:xfrm>
              <a:off x="3285890" y="6332999"/>
              <a:ext cx="493171" cy="130623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sp>
          <p:nvSpPr>
            <p:cNvPr id="88" name="Rectangle 87"/>
            <p:cNvSpPr/>
            <p:nvPr/>
          </p:nvSpPr>
          <p:spPr>
            <a:xfrm>
              <a:off x="4563866" y="6619188"/>
              <a:ext cx="1307340" cy="27069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Bc-</a:t>
              </a:r>
              <a:r>
                <a:rPr lang="en-GB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SP</a:t>
              </a:r>
              <a:r>
                <a:rPr lang="en-GB" sz="1200" b="1" baseline="-25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3-158</a:t>
              </a:r>
              <a:r>
                <a:rPr lang="en-GB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graphicFrame>
          <p:nvGraphicFramePr>
            <p:cNvPr id="92" name="Content Placeholder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77005593"/>
                </p:ext>
              </p:extLst>
            </p:nvPr>
          </p:nvGraphicFramePr>
          <p:xfrm>
            <a:off x="112738" y="6069243"/>
            <a:ext cx="2727066" cy="16441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93" name="TextBox 92"/>
            <p:cNvSpPr txBox="1"/>
            <p:nvPr/>
          </p:nvSpPr>
          <p:spPr>
            <a:xfrm>
              <a:off x="1329359" y="6162227"/>
              <a:ext cx="580278" cy="321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GB" sz="11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Da</a:t>
              </a:r>
              <a:endParaRPr lang="en-GB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1767235" y="6152500"/>
              <a:ext cx="652812" cy="321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70kDa</a:t>
              </a:r>
            </a:p>
          </p:txBody>
        </p:sp>
        <p:cxnSp>
          <p:nvCxnSpPr>
            <p:cNvPr id="95" name="Straight Connector 94"/>
            <p:cNvCxnSpPr/>
            <p:nvPr/>
          </p:nvCxnSpPr>
          <p:spPr>
            <a:xfrm>
              <a:off x="1630166" y="6315923"/>
              <a:ext cx="0" cy="900000"/>
            </a:xfrm>
            <a:prstGeom prst="line">
              <a:avLst/>
            </a:prstGeom>
            <a:noFill/>
            <a:ln>
              <a:prstDash val="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96" name="Straight Connector 95"/>
            <p:cNvCxnSpPr/>
            <p:nvPr/>
          </p:nvCxnSpPr>
          <p:spPr>
            <a:xfrm>
              <a:off x="2023991" y="6315923"/>
              <a:ext cx="0" cy="900000"/>
            </a:xfrm>
            <a:prstGeom prst="line">
              <a:avLst/>
            </a:prstGeom>
            <a:noFill/>
            <a:ln>
              <a:prstDash val="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pic>
          <p:nvPicPr>
            <p:cNvPr id="106" name="Picture 105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02" t="48129" r="67093" b="7146"/>
            <a:stretch/>
          </p:blipFill>
          <p:spPr>
            <a:xfrm>
              <a:off x="3285890" y="7975199"/>
              <a:ext cx="891054" cy="1472172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sp>
          <p:nvSpPr>
            <p:cNvPr id="107" name="Rectangle 106"/>
            <p:cNvSpPr/>
            <p:nvPr/>
          </p:nvSpPr>
          <p:spPr>
            <a:xfrm>
              <a:off x="4563866" y="8383944"/>
              <a:ext cx="1249409" cy="39241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Bc-</a:t>
              </a:r>
              <a:r>
                <a:rPr lang="en-GB" sz="1200" b="1" dirty="0">
                  <a:solidFill>
                    <a:srgbClr val="000000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CLSP</a:t>
              </a:r>
              <a:r>
                <a:rPr lang="en-GB" sz="1200" b="1" baseline="-25000" dirty="0">
                  <a:solidFill>
                    <a:srgbClr val="000000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398-416</a:t>
              </a:r>
              <a:endPara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05" name="Content Placeholder 6" title="hjh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38179808"/>
                </p:ext>
              </p:extLst>
            </p:nvPr>
          </p:nvGraphicFramePr>
          <p:xfrm>
            <a:off x="-3398" y="7639236"/>
            <a:ext cx="2874770" cy="208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110" name="TextBox 109"/>
            <p:cNvSpPr txBox="1"/>
            <p:nvPr/>
          </p:nvSpPr>
          <p:spPr>
            <a:xfrm>
              <a:off x="1395212" y="7827698"/>
              <a:ext cx="576064" cy="321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GB" sz="11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Da</a:t>
              </a:r>
              <a:endParaRPr lang="en-GB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1827260" y="7827142"/>
              <a:ext cx="648072" cy="321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70kDa</a:t>
              </a:r>
            </a:p>
          </p:txBody>
        </p:sp>
        <p:cxnSp>
          <p:nvCxnSpPr>
            <p:cNvPr id="112" name="Straight Connector 111"/>
            <p:cNvCxnSpPr/>
            <p:nvPr/>
          </p:nvCxnSpPr>
          <p:spPr>
            <a:xfrm>
              <a:off x="2024857" y="8007143"/>
              <a:ext cx="0" cy="1224000"/>
            </a:xfrm>
            <a:prstGeom prst="line">
              <a:avLst/>
            </a:prstGeom>
            <a:noFill/>
            <a:ln>
              <a:prstDash val="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3" name="Straight Connector 112"/>
            <p:cNvCxnSpPr/>
            <p:nvPr/>
          </p:nvCxnSpPr>
          <p:spPr>
            <a:xfrm>
              <a:off x="1662795" y="8007699"/>
              <a:ext cx="0" cy="1224000"/>
            </a:xfrm>
            <a:prstGeom prst="line">
              <a:avLst/>
            </a:prstGeom>
            <a:noFill/>
            <a:ln>
              <a:prstDash val="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6" name="Straight Arrow Connector 115"/>
            <p:cNvCxnSpPr/>
            <p:nvPr/>
          </p:nvCxnSpPr>
          <p:spPr>
            <a:xfrm flipH="1">
              <a:off x="4170251" y="8593037"/>
              <a:ext cx="429613" cy="0"/>
            </a:xfrm>
            <a:prstGeom prst="straightConnector1">
              <a:avLst/>
            </a:prstGeom>
            <a:noFill/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3" name="Straight Connector 132"/>
            <p:cNvCxnSpPr/>
            <p:nvPr/>
          </p:nvCxnSpPr>
          <p:spPr>
            <a:xfrm>
              <a:off x="1611236" y="2340126"/>
              <a:ext cx="0" cy="1023812"/>
            </a:xfrm>
            <a:prstGeom prst="line">
              <a:avLst/>
            </a:prstGeom>
            <a:noFill/>
            <a:ln>
              <a:prstDash val="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134" name="TextBox 133"/>
            <p:cNvSpPr txBox="1"/>
            <p:nvPr/>
          </p:nvSpPr>
          <p:spPr>
            <a:xfrm>
              <a:off x="0" y="5776391"/>
              <a:ext cx="502486" cy="3407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.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0" y="7639237"/>
              <a:ext cx="332621" cy="3407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.</a:t>
              </a:r>
            </a:p>
          </p:txBody>
        </p:sp>
        <p:cxnSp>
          <p:nvCxnSpPr>
            <p:cNvPr id="162" name="Straight Connector 161"/>
            <p:cNvCxnSpPr/>
            <p:nvPr/>
          </p:nvCxnSpPr>
          <p:spPr>
            <a:xfrm>
              <a:off x="1971276" y="4181746"/>
              <a:ext cx="0" cy="1044000"/>
            </a:xfrm>
            <a:prstGeom prst="line">
              <a:avLst/>
            </a:prstGeom>
            <a:noFill/>
            <a:ln>
              <a:prstDash val="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163" name="TextBox 162"/>
            <p:cNvSpPr txBox="1"/>
            <p:nvPr/>
          </p:nvSpPr>
          <p:spPr>
            <a:xfrm>
              <a:off x="1295729" y="3966615"/>
              <a:ext cx="676603" cy="321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GB" sz="11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Da</a:t>
              </a:r>
              <a:endParaRPr lang="en-GB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1715543" y="3966615"/>
              <a:ext cx="761179" cy="321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70kDa</a:t>
              </a:r>
            </a:p>
          </p:txBody>
        </p:sp>
        <p:cxnSp>
          <p:nvCxnSpPr>
            <p:cNvPr id="165" name="Straight Connector 164"/>
            <p:cNvCxnSpPr/>
            <p:nvPr/>
          </p:nvCxnSpPr>
          <p:spPr>
            <a:xfrm>
              <a:off x="1530428" y="4181746"/>
              <a:ext cx="0" cy="1044000"/>
            </a:xfrm>
            <a:prstGeom prst="line">
              <a:avLst/>
            </a:prstGeom>
            <a:noFill/>
            <a:ln>
              <a:prstDash val="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pic>
          <p:nvPicPr>
            <p:cNvPr id="101" name="Picture 100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525" t="43647" r="-800" b="2152"/>
            <a:stretch/>
          </p:blipFill>
          <p:spPr>
            <a:xfrm>
              <a:off x="3661993" y="4310740"/>
              <a:ext cx="542896" cy="14377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sp>
          <p:nvSpPr>
            <p:cNvPr id="143" name="Rectangle 142"/>
            <p:cNvSpPr/>
            <p:nvPr/>
          </p:nvSpPr>
          <p:spPr>
            <a:xfrm>
              <a:off x="4474109" y="973938"/>
              <a:ext cx="1273985" cy="65404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VLP (HBc- Ag) </a:t>
              </a:r>
            </a:p>
          </p:txBody>
        </p:sp>
        <p:graphicFrame>
          <p:nvGraphicFramePr>
            <p:cNvPr id="130" name="Chart 12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1299234"/>
                </p:ext>
              </p:extLst>
            </p:nvPr>
          </p:nvGraphicFramePr>
          <p:xfrm>
            <a:off x="13674" y="177954"/>
            <a:ext cx="2626929" cy="205695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cxnSp>
          <p:nvCxnSpPr>
            <p:cNvPr id="145" name="Straight Connector 144"/>
            <p:cNvCxnSpPr/>
            <p:nvPr/>
          </p:nvCxnSpPr>
          <p:spPr>
            <a:xfrm>
              <a:off x="1937017" y="568640"/>
              <a:ext cx="0" cy="1023812"/>
            </a:xfrm>
            <a:prstGeom prst="line">
              <a:avLst/>
            </a:prstGeom>
            <a:noFill/>
            <a:ln>
              <a:prstDash val="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7" name="Straight Connector 146"/>
            <p:cNvCxnSpPr/>
            <p:nvPr/>
          </p:nvCxnSpPr>
          <p:spPr>
            <a:xfrm>
              <a:off x="1578367" y="554891"/>
              <a:ext cx="0" cy="1023812"/>
            </a:xfrm>
            <a:prstGeom prst="line">
              <a:avLst/>
            </a:prstGeom>
            <a:noFill/>
            <a:ln>
              <a:prstDash val="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148" name="TextBox 147"/>
            <p:cNvSpPr txBox="1"/>
            <p:nvPr/>
          </p:nvSpPr>
          <p:spPr>
            <a:xfrm>
              <a:off x="1191422" y="307031"/>
              <a:ext cx="676603" cy="321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GB" sz="11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Da</a:t>
              </a:r>
              <a:endParaRPr lang="en-GB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1611236" y="307031"/>
              <a:ext cx="761179" cy="321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70kDa</a:t>
              </a:r>
            </a:p>
          </p:txBody>
        </p:sp>
        <p:cxnSp>
          <p:nvCxnSpPr>
            <p:cNvPr id="167" name="Straight Arrow Connector 166"/>
            <p:cNvCxnSpPr/>
            <p:nvPr/>
          </p:nvCxnSpPr>
          <p:spPr>
            <a:xfrm flipH="1">
              <a:off x="4170251" y="1310975"/>
              <a:ext cx="429613" cy="0"/>
            </a:xfrm>
            <a:prstGeom prst="straightConnector1">
              <a:avLst/>
            </a:prstGeom>
            <a:noFill/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2" name="Group 1"/>
            <p:cNvGrpSpPr/>
            <p:nvPr/>
          </p:nvGrpSpPr>
          <p:grpSpPr>
            <a:xfrm>
              <a:off x="3222589" y="441370"/>
              <a:ext cx="958347" cy="1547546"/>
              <a:chOff x="3829682" y="-37546"/>
              <a:chExt cx="958347" cy="1830589"/>
            </a:xfrm>
            <a:noFill/>
          </p:grpSpPr>
          <p:pic>
            <p:nvPicPr>
              <p:cNvPr id="170" name="Picture 169"/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257" t="43254" r="34951" b="-678"/>
              <a:stretch/>
            </p:blipFill>
            <p:spPr>
              <a:xfrm>
                <a:off x="3829682" y="-37545"/>
                <a:ext cx="604354" cy="1830588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</p:pic>
          <p:pic>
            <p:nvPicPr>
              <p:cNvPr id="172" name="Picture 3" descr="C:\Users\mqbpkaz2\Dropbox\2nd year\Proteins purification\SDS PAGE\HBc-Chmotrypsin 4 purification .jpg"/>
              <p:cNvPicPr>
                <a:picLocks noChangeAspect="1" noChangeArrowheads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814" t="43012" r="41291" b="11097"/>
              <a:stretch/>
            </p:blipFill>
            <p:spPr bwMode="auto">
              <a:xfrm>
                <a:off x="4338510" y="-37546"/>
                <a:ext cx="449519" cy="1830589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  <a:extLst/>
            </p:spPr>
          </p:pic>
        </p:grpSp>
        <p:cxnSp>
          <p:nvCxnSpPr>
            <p:cNvPr id="90" name="Straight Arrow Connector 89"/>
            <p:cNvCxnSpPr/>
            <p:nvPr/>
          </p:nvCxnSpPr>
          <p:spPr>
            <a:xfrm flipH="1">
              <a:off x="4170251" y="6780922"/>
              <a:ext cx="429613" cy="0"/>
            </a:xfrm>
            <a:prstGeom prst="straightConnector1">
              <a:avLst/>
            </a:prstGeom>
            <a:noFill/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97" name="Rectangle 96"/>
            <p:cNvSpPr/>
            <p:nvPr/>
          </p:nvSpPr>
          <p:spPr>
            <a:xfrm>
              <a:off x="2780928" y="508333"/>
              <a:ext cx="449601" cy="147979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  <a:p>
              <a:pPr algn="ctr"/>
              <a:endParaRPr lang="en-GB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ctr"/>
              <a:r>
                <a:rPr lang="en-GB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ctr"/>
              <a:endParaRPr lang="en-GB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GB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GB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3441814" y="160837"/>
              <a:ext cx="915223" cy="3407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         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3285389" y="2077259"/>
              <a:ext cx="915223" cy="3407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         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3321449" y="4004469"/>
              <a:ext cx="915223" cy="3407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         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3289666" y="6038924"/>
              <a:ext cx="915223" cy="3407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         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3405737" y="7707907"/>
              <a:ext cx="915223" cy="3407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         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cxnSp>
          <p:nvCxnSpPr>
            <p:cNvPr id="9" name="Straight Connector 8"/>
            <p:cNvCxnSpPr>
              <a:stCxn id="106" idx="0"/>
              <a:endCxn id="106" idx="2"/>
            </p:cNvCxnSpPr>
            <p:nvPr/>
          </p:nvCxnSpPr>
          <p:spPr>
            <a:xfrm>
              <a:off x="3731417" y="7975199"/>
              <a:ext cx="0" cy="1472172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Rectangle 102"/>
            <p:cNvSpPr/>
            <p:nvPr/>
          </p:nvSpPr>
          <p:spPr>
            <a:xfrm>
              <a:off x="2772988" y="2154510"/>
              <a:ext cx="449601" cy="147979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  <a:p>
              <a:pPr algn="ctr"/>
              <a:endParaRPr lang="en-GB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ctr"/>
              <a:r>
                <a:rPr lang="en-GB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ctr"/>
              <a:endParaRPr lang="en-GB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GB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GB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Rectangle 113"/>
            <p:cNvSpPr/>
            <p:nvPr/>
          </p:nvSpPr>
          <p:spPr>
            <a:xfrm>
              <a:off x="2763364" y="4156371"/>
              <a:ext cx="449601" cy="147979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  <a:p>
              <a:pPr algn="ctr"/>
              <a:endParaRPr lang="en-GB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ctr"/>
              <a:r>
                <a:rPr lang="en-GB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ctr"/>
              <a:endParaRPr lang="en-GB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GB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GB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Rectangle 116"/>
            <p:cNvSpPr/>
            <p:nvPr/>
          </p:nvSpPr>
          <p:spPr>
            <a:xfrm>
              <a:off x="2789087" y="5989486"/>
              <a:ext cx="449601" cy="147979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  <a:p>
              <a:pPr algn="ctr"/>
              <a:endParaRPr lang="en-GB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ctr"/>
              <a:r>
                <a:rPr lang="en-GB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ctr"/>
              <a:endParaRPr lang="en-GB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GB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GB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Rectangle 117"/>
            <p:cNvSpPr/>
            <p:nvPr/>
          </p:nvSpPr>
          <p:spPr>
            <a:xfrm>
              <a:off x="2835788" y="7730687"/>
              <a:ext cx="449601" cy="147979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  <a:p>
              <a:pPr algn="ctr"/>
              <a:endParaRPr lang="en-GB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ctr"/>
              <a:r>
                <a:rPr lang="en-GB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ctr"/>
              <a:endParaRPr lang="en-GB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GB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GB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75822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8</TotalTime>
  <Words>118</Words>
  <Application>Microsoft Office PowerPoint</Application>
  <PresentationFormat>On-screen Show (4:3)</PresentationFormat>
  <Paragraphs>6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at Zawawi</dc:creator>
  <cp:lastModifiedBy>Kathryn Else</cp:lastModifiedBy>
  <cp:revision>113</cp:revision>
  <cp:lastPrinted>2019-06-21T14:53:42Z</cp:lastPrinted>
  <dcterms:created xsi:type="dcterms:W3CDTF">2019-06-21T12:44:18Z</dcterms:created>
  <dcterms:modified xsi:type="dcterms:W3CDTF">2020-02-28T10:51:49Z</dcterms:modified>
</cp:coreProperties>
</file>